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283" r:id="rId2"/>
    <p:sldId id="258" r:id="rId3"/>
    <p:sldId id="262" r:id="rId4"/>
    <p:sldId id="275" r:id="rId5"/>
    <p:sldId id="257" r:id="rId6"/>
    <p:sldId id="281" r:id="rId7"/>
    <p:sldId id="277" r:id="rId8"/>
    <p:sldId id="270" r:id="rId9"/>
    <p:sldId id="273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088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208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med1/home/696001/Pillai-Lab/qRT/2018/06142018_SK/06142018_SK%20-%20%20Quantification%20Cq%20Results_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pillai-lab/Lab-Members/ABHISHEK/ms2%20pull%20downwestern/09152021%20akg/admin_2021-09-15%2013-58-05_CT032368%20-%20%20Quantification%20Cq%20Results.xls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med1/home/696001/Pillai-Lab/qRT/2019/02152019_sk/02152019_sk%20-%20%20Quantification%20Cq%20Results_ANALYSIS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/med1/home/696001/Pillai-Lab/qRT/2019/05022019_sk/05022019_sk%20-%20%20Quantification%20Cq%20Results_ANALYSIS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rmas/Downloads/analysis%20for%20western%20blot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med1/home/696001/Pillai-Lab/qRT/2018/01112018_SK/01112018_SK%20-%20%20Quantification%20Cq%20Results_ANALYSI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peg\02132018_SK\02132018_SK%20-%20%20Quantification%20Cq%20Results_ANALYSIS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8-03-08%20-%20Shilpita%20Manoj\2018-03-08%20-%20922control.csv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hilpitakarmakar/Desktop/05252018_SK%20-%20%20Quantification%20Cq%20Results%20ANALYSI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pillai-lab/qRT/2021/11062021%20AKG-1/admin_2021-11-06%2018-58-55_CT032368%20-%20%20Quantification%20Cq%20Results.xls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pillai-lab/qRT/2022/02042022%20AKG/admin_2022-02-04%2014-28-56_CT032368%20-%20%20Quantification%20Cq%20Result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pillai-lab/qRT/2022/02042022%20AKG/admin_2022-02-04%2014-28-56_CT032368%20-%20%20Quantification%20Cq%20Result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pillai-lab/Lab-Members/ABHISHEK/ms2%20pull%20downwestern/09152021%20akg/admin_2021-09-15%2013-58-05_CT032368%20-%20%20Quantification%20Cq%20Results.xls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I2 shRNA clones</a:t>
            </a:r>
          </a:p>
        </c:rich>
      </c:tx>
      <c:layout>
        <c:manualLayout>
          <c:xMode val="edge"/>
          <c:yMode val="edge"/>
          <c:x val="0.38736389237888202"/>
          <c:y val="0.119948686108127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U$9:$U$12</c:f>
                <c:numCache>
                  <c:formatCode>General</c:formatCode>
                  <c:ptCount val="4"/>
                  <c:pt idx="0">
                    <c:v>3.84359500800997E-4</c:v>
                  </c:pt>
                  <c:pt idx="1">
                    <c:v>3.79673322115423E-6</c:v>
                  </c:pt>
                  <c:pt idx="2">
                    <c:v>3.5680291621198297E-5</c:v>
                  </c:pt>
                  <c:pt idx="3">
                    <c:v>6.87302016143384E-6</c:v>
                  </c:pt>
                </c:numCache>
              </c:numRef>
            </c:plus>
            <c:minus>
              <c:numRef>
                <c:f>Sheet1!$U$9:$U$12</c:f>
                <c:numCache>
                  <c:formatCode>General</c:formatCode>
                  <c:ptCount val="4"/>
                  <c:pt idx="0">
                    <c:v>3.84359500800997E-4</c:v>
                  </c:pt>
                  <c:pt idx="1">
                    <c:v>3.79673322115423E-6</c:v>
                  </c:pt>
                  <c:pt idx="2">
                    <c:v>3.5680291621198297E-5</c:v>
                  </c:pt>
                  <c:pt idx="3">
                    <c:v>6.87302016143384E-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R$9:$R$12</c:f>
              <c:strCache>
                <c:ptCount val="4"/>
                <c:pt idx="0">
                  <c:v>sh control</c:v>
                </c:pt>
                <c:pt idx="1">
                  <c:v>sh 9</c:v>
                </c:pt>
                <c:pt idx="2">
                  <c:v>sh11</c:v>
                </c:pt>
                <c:pt idx="3">
                  <c:v>sh12</c:v>
                </c:pt>
              </c:strCache>
            </c:strRef>
          </c:cat>
          <c:val>
            <c:numRef>
              <c:f>Sheet1!$S$9:$S$12</c:f>
              <c:numCache>
                <c:formatCode>General</c:formatCode>
                <c:ptCount val="4"/>
                <c:pt idx="0">
                  <c:v>5.3319292746147199E-3</c:v>
                </c:pt>
                <c:pt idx="1">
                  <c:v>8.8139802524259104E-4</c:v>
                </c:pt>
                <c:pt idx="2">
                  <c:v>7.3115741512646897E-4</c:v>
                </c:pt>
                <c:pt idx="3">
                  <c:v>5.40111530552364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E3-4A93-8489-D5474E6DA6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0068448"/>
        <c:axId val="-2015330768"/>
      </c:barChart>
      <c:catAx>
        <c:axId val="-2000068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15330768"/>
        <c:crosses val="autoZero"/>
        <c:auto val="1"/>
        <c:lblAlgn val="ctr"/>
        <c:lblOffset val="100"/>
        <c:noMultiLvlLbl val="0"/>
      </c:catAx>
      <c:valAx>
        <c:axId val="-2015330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alpha val="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00068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</a:rPr>
              <a:t>IP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B$39:$AB$42</c:f>
                <c:numCache>
                  <c:formatCode>General</c:formatCode>
                  <c:ptCount val="4"/>
                  <c:pt idx="0">
                    <c:v>0.19865285927894444</c:v>
                  </c:pt>
                  <c:pt idx="1">
                    <c:v>2.1537979739114907E-2</c:v>
                  </c:pt>
                  <c:pt idx="2">
                    <c:v>1.6347962629871513</c:v>
                  </c:pt>
                  <c:pt idx="3">
                    <c:v>0.15841540587429004</c:v>
                  </c:pt>
                </c:numCache>
              </c:numRef>
            </c:plus>
            <c:minus>
              <c:numRef>
                <c:f>'0'!$AB$39:$AB$42</c:f>
                <c:numCache>
                  <c:formatCode>General</c:formatCode>
                  <c:ptCount val="4"/>
                  <c:pt idx="0">
                    <c:v>0.19865285927894444</c:v>
                  </c:pt>
                  <c:pt idx="1">
                    <c:v>2.1537979739114907E-2</c:v>
                  </c:pt>
                  <c:pt idx="2">
                    <c:v>1.6347962629871513</c:v>
                  </c:pt>
                  <c:pt idx="3">
                    <c:v>0.15841540587429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AD$28:$AD$31</c:f>
              <c:strCache>
                <c:ptCount val="4"/>
                <c:pt idx="0">
                  <c:v>wt</c:v>
                </c:pt>
                <c:pt idx="1">
                  <c:v>mt</c:v>
                </c:pt>
                <c:pt idx="2">
                  <c:v>cdk6</c:v>
                </c:pt>
                <c:pt idx="3">
                  <c:v>acta1</c:v>
                </c:pt>
              </c:strCache>
            </c:strRef>
          </c:cat>
          <c:val>
            <c:numRef>
              <c:f>'0'!$AE$28:$AE$31</c:f>
              <c:numCache>
                <c:formatCode>General</c:formatCode>
                <c:ptCount val="4"/>
                <c:pt idx="0">
                  <c:v>4.3270869304990107</c:v>
                </c:pt>
                <c:pt idx="1">
                  <c:v>5.2447111378753668</c:v>
                </c:pt>
                <c:pt idx="2">
                  <c:v>5.8694704281218417</c:v>
                </c:pt>
                <c:pt idx="3">
                  <c:v>6.2038535460553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3B-3C4D-A968-F5564F8ED6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8821887"/>
        <c:axId val="1501940191"/>
      </c:barChart>
      <c:catAx>
        <c:axId val="15588218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01940191"/>
        <c:crosses val="autoZero"/>
        <c:auto val="1"/>
        <c:lblAlgn val="ctr"/>
        <c:lblOffset val="100"/>
        <c:noMultiLvlLbl val="0"/>
      </c:catAx>
      <c:valAx>
        <c:axId val="150194019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Luciferase expression relative to MS2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588218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N$1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P$13:$P$15</c:f>
                <c:numCache>
                  <c:formatCode>General</c:formatCode>
                  <c:ptCount val="3"/>
                  <c:pt idx="0">
                    <c:v>7.0586633618932998E-3</c:v>
                  </c:pt>
                  <c:pt idx="1">
                    <c:v>7.9164236101939001E-4</c:v>
                  </c:pt>
                  <c:pt idx="2">
                    <c:v>1.2364007781890301E-3</c:v>
                  </c:pt>
                </c:numCache>
              </c:numRef>
            </c:plus>
            <c:minus>
              <c:numRef>
                <c:f>Sheet1!$P$13:$P$15</c:f>
                <c:numCache>
                  <c:formatCode>General</c:formatCode>
                  <c:ptCount val="3"/>
                  <c:pt idx="0">
                    <c:v>7.0586633618932998E-3</c:v>
                  </c:pt>
                  <c:pt idx="1">
                    <c:v>7.9164236101939001E-4</c:v>
                  </c:pt>
                  <c:pt idx="2">
                    <c:v>1.23640077818903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13:$M$15</c:f>
              <c:strCache>
                <c:ptCount val="3"/>
                <c:pt idx="0">
                  <c:v>sh control</c:v>
                </c:pt>
                <c:pt idx="1">
                  <c:v>sh7</c:v>
                </c:pt>
                <c:pt idx="2">
                  <c:v>sh27</c:v>
                </c:pt>
              </c:strCache>
            </c:strRef>
          </c:cat>
          <c:val>
            <c:numRef>
              <c:f>Sheet1!$N$13:$N$15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91-4454-9085-1B234B6762F3}"/>
            </c:ext>
          </c:extLst>
        </c:ser>
        <c:ser>
          <c:idx val="1"/>
          <c:order val="1"/>
          <c:tx>
            <c:strRef>
              <c:f>Sheet1!$O$12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Q$13:$Q$15</c:f>
                <c:numCache>
                  <c:formatCode>General</c:formatCode>
                  <c:ptCount val="3"/>
                  <c:pt idx="0">
                    <c:v>1.3710373213827E-3</c:v>
                  </c:pt>
                  <c:pt idx="1">
                    <c:v>1.74674195645807E-5</c:v>
                  </c:pt>
                  <c:pt idx="2">
                    <c:v>9.2187208848150003E-4</c:v>
                  </c:pt>
                </c:numCache>
              </c:numRef>
            </c:plus>
            <c:minus>
              <c:numRef>
                <c:f>Sheet1!$Q$13:$Q$15</c:f>
                <c:numCache>
                  <c:formatCode>General</c:formatCode>
                  <c:ptCount val="3"/>
                  <c:pt idx="0">
                    <c:v>1.3710373213827E-3</c:v>
                  </c:pt>
                  <c:pt idx="1">
                    <c:v>1.74674195645807E-5</c:v>
                  </c:pt>
                  <c:pt idx="2">
                    <c:v>9.2187208848150003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13:$M$15</c:f>
              <c:strCache>
                <c:ptCount val="3"/>
                <c:pt idx="0">
                  <c:v>sh control</c:v>
                </c:pt>
                <c:pt idx="1">
                  <c:v>sh7</c:v>
                </c:pt>
                <c:pt idx="2">
                  <c:v>sh27</c:v>
                </c:pt>
              </c:strCache>
            </c:strRef>
          </c:cat>
          <c:val>
            <c:numRef>
              <c:f>Sheet1!$O$13:$O$15</c:f>
              <c:numCache>
                <c:formatCode>General</c:formatCode>
                <c:ptCount val="3"/>
                <c:pt idx="0">
                  <c:v>0.80694284016889395</c:v>
                </c:pt>
                <c:pt idx="1">
                  <c:v>0.14079305976637699</c:v>
                </c:pt>
                <c:pt idx="2">
                  <c:v>0.17614178764992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491-4454-9085-1B234B6762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0653680"/>
        <c:axId val="-1999783632"/>
      </c:barChart>
      <c:catAx>
        <c:axId val="-2000653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999783632"/>
        <c:crosses val="autoZero"/>
        <c:auto val="1"/>
        <c:lblAlgn val="ctr"/>
        <c:lblOffset val="100"/>
        <c:noMultiLvlLbl val="0"/>
      </c:catAx>
      <c:valAx>
        <c:axId val="-19997836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alpha val="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2000653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C$40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E$41:$E$44</c:f>
                <c:numCache>
                  <c:formatCode>General</c:formatCode>
                  <c:ptCount val="4"/>
                  <c:pt idx="0">
                    <c:v>9.8737016589831397E-4</c:v>
                  </c:pt>
                  <c:pt idx="1">
                    <c:v>3.9987309456055503E-3</c:v>
                  </c:pt>
                  <c:pt idx="2">
                    <c:v>6.2311852858527904E-4</c:v>
                  </c:pt>
                  <c:pt idx="3">
                    <c:v>6.6511752406292902E-4</c:v>
                  </c:pt>
                </c:numCache>
              </c:numRef>
            </c:plus>
            <c:minus>
              <c:numRef>
                <c:f>'0'!$E$41:$E$44</c:f>
                <c:numCache>
                  <c:formatCode>General</c:formatCode>
                  <c:ptCount val="4"/>
                  <c:pt idx="0">
                    <c:v>9.8737016589831397E-4</c:v>
                  </c:pt>
                  <c:pt idx="1">
                    <c:v>3.9987309456055503E-3</c:v>
                  </c:pt>
                  <c:pt idx="2">
                    <c:v>6.2311852858527904E-4</c:v>
                  </c:pt>
                  <c:pt idx="3">
                    <c:v>6.6511752406292902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B$41:$B$44</c:f>
              <c:strCache>
                <c:ptCount val="4"/>
                <c:pt idx="0">
                  <c:v>0hr</c:v>
                </c:pt>
                <c:pt idx="1">
                  <c:v>48 hr</c:v>
                </c:pt>
                <c:pt idx="2">
                  <c:v>72 hr</c:v>
                </c:pt>
                <c:pt idx="3">
                  <c:v>96 hr</c:v>
                </c:pt>
              </c:strCache>
            </c:strRef>
          </c:cat>
          <c:val>
            <c:numRef>
              <c:f>'0'!$C$41:$C$44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0A-41C5-9A5C-D62580992776}"/>
            </c:ext>
          </c:extLst>
        </c:ser>
        <c:ser>
          <c:idx val="1"/>
          <c:order val="1"/>
          <c:tx>
            <c:strRef>
              <c:f>'0'!$D$40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F$41:$F$44</c:f>
                <c:numCache>
                  <c:formatCode>General</c:formatCode>
                  <c:ptCount val="4"/>
                  <c:pt idx="0">
                    <c:v>9.7140554543483396E-4</c:v>
                  </c:pt>
                  <c:pt idx="1">
                    <c:v>2.7711735508142998E-4</c:v>
                  </c:pt>
                  <c:pt idx="2">
                    <c:v>3.2083410531144701E-5</c:v>
                  </c:pt>
                  <c:pt idx="3">
                    <c:v>8.3031908103870595E-5</c:v>
                  </c:pt>
                </c:numCache>
              </c:numRef>
            </c:plus>
            <c:minus>
              <c:numRef>
                <c:f>'0'!$F$41:$F$44</c:f>
                <c:numCache>
                  <c:formatCode>General</c:formatCode>
                  <c:ptCount val="4"/>
                  <c:pt idx="0">
                    <c:v>9.7140554543483396E-4</c:v>
                  </c:pt>
                  <c:pt idx="1">
                    <c:v>2.7711735508142998E-4</c:v>
                  </c:pt>
                  <c:pt idx="2">
                    <c:v>3.2083410531144701E-5</c:v>
                  </c:pt>
                  <c:pt idx="3">
                    <c:v>8.3031908103870595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B$41:$B$44</c:f>
              <c:strCache>
                <c:ptCount val="4"/>
                <c:pt idx="0">
                  <c:v>0hr</c:v>
                </c:pt>
                <c:pt idx="1">
                  <c:v>48 hr</c:v>
                </c:pt>
                <c:pt idx="2">
                  <c:v>72 hr</c:v>
                </c:pt>
                <c:pt idx="3">
                  <c:v>96 hr</c:v>
                </c:pt>
              </c:strCache>
            </c:strRef>
          </c:cat>
          <c:val>
            <c:numRef>
              <c:f>'0'!$D$41:$D$44</c:f>
              <c:numCache>
                <c:formatCode>General</c:formatCode>
                <c:ptCount val="4"/>
                <c:pt idx="0">
                  <c:v>1.314035338548172</c:v>
                </c:pt>
                <c:pt idx="1">
                  <c:v>9.6620803409915093E-2</c:v>
                </c:pt>
                <c:pt idx="2">
                  <c:v>0.113950918189668</c:v>
                </c:pt>
                <c:pt idx="3">
                  <c:v>0.105355558776755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20A-41C5-9A5C-D625809927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999796048"/>
        <c:axId val="-1999793728"/>
      </c:barChart>
      <c:catAx>
        <c:axId val="-1999796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999793728"/>
        <c:crosses val="autoZero"/>
        <c:auto val="1"/>
        <c:lblAlgn val="ctr"/>
        <c:lblOffset val="100"/>
        <c:noMultiLvlLbl val="0"/>
      </c:catAx>
      <c:valAx>
        <c:axId val="-19997937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accent1">
                  <a:alpha val="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999796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13</c:f>
              <c:strCache>
                <c:ptCount val="1"/>
                <c:pt idx="0">
                  <c:v>Uninduce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A$14:$A$19</c:f>
              <c:strCache>
                <c:ptCount val="6"/>
                <c:pt idx="0">
                  <c:v>EIF3A</c:v>
                </c:pt>
                <c:pt idx="1">
                  <c:v>USP28</c:v>
                </c:pt>
                <c:pt idx="2">
                  <c:v>RAD21</c:v>
                </c:pt>
                <c:pt idx="3">
                  <c:v>SP1</c:v>
                </c:pt>
                <c:pt idx="4">
                  <c:v>C-MYC</c:v>
                </c:pt>
                <c:pt idx="5">
                  <c:v>CDK6</c:v>
                </c:pt>
              </c:strCache>
            </c:strRef>
          </c:cat>
          <c:val>
            <c:numRef>
              <c:f>Sheet2!$B$14:$B$19</c:f>
              <c:numCache>
                <c:formatCode>General</c:formatCode>
                <c:ptCount val="6"/>
                <c:pt idx="0">
                  <c:v>1.0724509396096187</c:v>
                </c:pt>
                <c:pt idx="1">
                  <c:v>1.0302832745879849</c:v>
                </c:pt>
                <c:pt idx="2">
                  <c:v>0.84077160665584205</c:v>
                </c:pt>
                <c:pt idx="3">
                  <c:v>0.85533337187543779</c:v>
                </c:pt>
                <c:pt idx="4">
                  <c:v>0.82867557961452598</c:v>
                </c:pt>
                <c:pt idx="5">
                  <c:v>1.3825163983090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36-C54D-AC35-B5E32022D477}"/>
            </c:ext>
          </c:extLst>
        </c:ser>
        <c:ser>
          <c:idx val="1"/>
          <c:order val="1"/>
          <c:tx>
            <c:strRef>
              <c:f>Sheet2!$C$13</c:f>
              <c:strCache>
                <c:ptCount val="1"/>
                <c:pt idx="0">
                  <c:v>Induced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A$14:$A$19</c:f>
              <c:strCache>
                <c:ptCount val="6"/>
                <c:pt idx="0">
                  <c:v>EIF3A</c:v>
                </c:pt>
                <c:pt idx="1">
                  <c:v>USP28</c:v>
                </c:pt>
                <c:pt idx="2">
                  <c:v>RAD21</c:v>
                </c:pt>
                <c:pt idx="3">
                  <c:v>SP1</c:v>
                </c:pt>
                <c:pt idx="4">
                  <c:v>C-MYC</c:v>
                </c:pt>
                <c:pt idx="5">
                  <c:v>CDK6</c:v>
                </c:pt>
              </c:strCache>
            </c:strRef>
          </c:cat>
          <c:val>
            <c:numRef>
              <c:f>Sheet2!$C$14:$C$19</c:f>
              <c:numCache>
                <c:formatCode>General</c:formatCode>
                <c:ptCount val="6"/>
                <c:pt idx="0">
                  <c:v>0.16884437571721933</c:v>
                </c:pt>
                <c:pt idx="1">
                  <c:v>0.9818698248758807</c:v>
                </c:pt>
                <c:pt idx="2">
                  <c:v>0.10522270313905835</c:v>
                </c:pt>
                <c:pt idx="3">
                  <c:v>0.35922201402411302</c:v>
                </c:pt>
                <c:pt idx="4">
                  <c:v>0.57234644744503482</c:v>
                </c:pt>
                <c:pt idx="5">
                  <c:v>0.506550422152005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36-C54D-AC35-B5E32022D4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0019712"/>
        <c:axId val="1599959312"/>
      </c:barChart>
      <c:catAx>
        <c:axId val="1600019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99959312"/>
        <c:crosses val="autoZero"/>
        <c:auto val="1"/>
        <c:lblAlgn val="ctr"/>
        <c:lblOffset val="100"/>
        <c:noMultiLvlLbl val="0"/>
      </c:catAx>
      <c:valAx>
        <c:axId val="159995931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00019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2:$D$4</c:f>
                <c:numCache>
                  <c:formatCode>General</c:formatCode>
                  <c:ptCount val="3"/>
                  <c:pt idx="0">
                    <c:v>1.00856022955404E-3</c:v>
                  </c:pt>
                  <c:pt idx="1">
                    <c:v>2.04055897901136E-5</c:v>
                  </c:pt>
                  <c:pt idx="2">
                    <c:v>4.8665076837723102E-4</c:v>
                  </c:pt>
                </c:numCache>
              </c:numRef>
            </c:plus>
            <c:minus>
              <c:numRef>
                <c:f>Sheet1!$D$2:$D$4</c:f>
                <c:numCache>
                  <c:formatCode>General</c:formatCode>
                  <c:ptCount val="3"/>
                  <c:pt idx="0">
                    <c:v>1.00856022955404E-3</c:v>
                  </c:pt>
                  <c:pt idx="1">
                    <c:v>2.04055897901136E-5</c:v>
                  </c:pt>
                  <c:pt idx="2">
                    <c:v>4.8665076837723102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Sh control</c:v>
                </c:pt>
                <c:pt idx="1">
                  <c:v>Sh9</c:v>
                </c:pt>
                <c:pt idx="2">
                  <c:v>Sh12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89-4CA6-AC72-470DE4E22EC2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4</c:f>
                <c:numCache>
                  <c:formatCode>General</c:formatCode>
                  <c:ptCount val="3"/>
                  <c:pt idx="0">
                    <c:v>1.0291921568845301E-3</c:v>
                  </c:pt>
                  <c:pt idx="1">
                    <c:v>6.4376792341122694E-5</c:v>
                  </c:pt>
                  <c:pt idx="2">
                    <c:v>2.24964198738868E-4</c:v>
                  </c:pt>
                </c:numCache>
              </c:numRef>
            </c:plus>
            <c:minus>
              <c:numRef>
                <c:f>Sheet1!$E$2:$E$4</c:f>
                <c:numCache>
                  <c:formatCode>General</c:formatCode>
                  <c:ptCount val="3"/>
                  <c:pt idx="0">
                    <c:v>1.0291921568845301E-3</c:v>
                  </c:pt>
                  <c:pt idx="1">
                    <c:v>6.4376792341122694E-5</c:v>
                  </c:pt>
                  <c:pt idx="2">
                    <c:v>2.24964198738868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Sh control</c:v>
                </c:pt>
                <c:pt idx="1">
                  <c:v>Sh9</c:v>
                </c:pt>
                <c:pt idx="2">
                  <c:v>Sh12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1.188486210875018</c:v>
                </c:pt>
                <c:pt idx="1">
                  <c:v>8.3306857979541404E-2</c:v>
                </c:pt>
                <c:pt idx="2">
                  <c:v>0.1832650796459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89-4CA6-AC72-470DE4E22E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22322528"/>
        <c:axId val="1922603728"/>
      </c:barChart>
      <c:catAx>
        <c:axId val="1922322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22603728"/>
        <c:crosses val="autoZero"/>
        <c:auto val="1"/>
        <c:lblAlgn val="ctr"/>
        <c:lblOffset val="100"/>
        <c:noMultiLvlLbl val="0"/>
      </c:catAx>
      <c:valAx>
        <c:axId val="192260372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22322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0108705161854801E-2"/>
          <c:y val="0.171759259259259"/>
          <c:w val="0.89655796150481204"/>
          <c:h val="0.619567658209390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D$10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G$11:$AG$14</c:f>
                <c:numCache>
                  <c:formatCode>General</c:formatCode>
                  <c:ptCount val="4"/>
                  <c:pt idx="0">
                    <c:v>6.5041491948031403E-4</c:v>
                  </c:pt>
                  <c:pt idx="1">
                    <c:v>6.6940490671796402E-4</c:v>
                  </c:pt>
                  <c:pt idx="2">
                    <c:v>1.39881356159975E-4</c:v>
                  </c:pt>
                  <c:pt idx="3">
                    <c:v>8.3803248018694799E-4</c:v>
                  </c:pt>
                </c:numCache>
              </c:numRef>
            </c:plus>
            <c:minus>
              <c:numRef>
                <c:f>'0'!$AG$11:$AG$14</c:f>
                <c:numCache>
                  <c:formatCode>General</c:formatCode>
                  <c:ptCount val="4"/>
                  <c:pt idx="0">
                    <c:v>6.5041491948031403E-4</c:v>
                  </c:pt>
                  <c:pt idx="1">
                    <c:v>6.6940490671796402E-4</c:v>
                  </c:pt>
                  <c:pt idx="2">
                    <c:v>1.39881356159975E-4</c:v>
                  </c:pt>
                  <c:pt idx="3">
                    <c:v>8.3803248018694799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AC$11:$AC$14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96hr</c:v>
                </c:pt>
              </c:strCache>
            </c:strRef>
          </c:cat>
          <c:val>
            <c:numRef>
              <c:f>'0'!$AD$11:$AD$14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9A-49F8-A656-DC4DADA3388B}"/>
            </c:ext>
          </c:extLst>
        </c:ser>
        <c:ser>
          <c:idx val="1"/>
          <c:order val="1"/>
          <c:tx>
            <c:strRef>
              <c:f>'0'!$AE$10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H$11:$AH$14</c:f>
                <c:numCache>
                  <c:formatCode>General</c:formatCode>
                  <c:ptCount val="4"/>
                  <c:pt idx="0">
                    <c:v>1.2522012713627801E-4</c:v>
                  </c:pt>
                  <c:pt idx="1">
                    <c:v>2.5306394234140498E-4</c:v>
                  </c:pt>
                  <c:pt idx="2">
                    <c:v>4.0537091052789598E-5</c:v>
                  </c:pt>
                  <c:pt idx="3">
                    <c:v>9.4969970913248906E-5</c:v>
                  </c:pt>
                </c:numCache>
              </c:numRef>
            </c:plus>
            <c:minus>
              <c:numRef>
                <c:f>'0'!$AH$11:$AH$14</c:f>
                <c:numCache>
                  <c:formatCode>General</c:formatCode>
                  <c:ptCount val="4"/>
                  <c:pt idx="0">
                    <c:v>1.2522012713627801E-4</c:v>
                  </c:pt>
                  <c:pt idx="1">
                    <c:v>2.5306394234140498E-4</c:v>
                  </c:pt>
                  <c:pt idx="2">
                    <c:v>4.0537091052789598E-5</c:v>
                  </c:pt>
                  <c:pt idx="3">
                    <c:v>9.4969970913248906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AC$11:$AC$14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96hr</c:v>
                </c:pt>
              </c:strCache>
            </c:strRef>
          </c:cat>
          <c:val>
            <c:numRef>
              <c:f>'0'!$AE$11:$AE$14</c:f>
              <c:numCache>
                <c:formatCode>General</c:formatCode>
                <c:ptCount val="4"/>
                <c:pt idx="0">
                  <c:v>1.0942261451566999</c:v>
                </c:pt>
                <c:pt idx="1">
                  <c:v>0.27718554563876202</c:v>
                </c:pt>
                <c:pt idx="2">
                  <c:v>0.122204514729105</c:v>
                </c:pt>
                <c:pt idx="3">
                  <c:v>0.152818263116574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19A-49F8-A656-DC4DADA338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0343664"/>
        <c:axId val="-2000176848"/>
      </c:barChart>
      <c:catAx>
        <c:axId val="-2000343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00176848"/>
        <c:crosses val="autoZero"/>
        <c:auto val="1"/>
        <c:lblAlgn val="ctr"/>
        <c:lblOffset val="100"/>
        <c:noMultiLvlLbl val="0"/>
      </c:catAx>
      <c:valAx>
        <c:axId val="-200017684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00343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en-US" baseline="0" dirty="0">
                <a:latin typeface="Arial" panose="020B0604020202020204" pitchFamily="34" charset="0"/>
                <a:cs typeface="Arial" panose="020B0604020202020204" pitchFamily="34" charset="0"/>
              </a:rPr>
              <a:t> vs Induce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5475303124906"/>
          <c:y val="0.15455131133213801"/>
          <c:w val="0.83349675272914203"/>
          <c:h val="0.72113234249624403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</c:strCache>
            </c:strRef>
          </c:tx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rgbClr val="002060"/>
                </a:solidFill>
              </a:ln>
              <a:effectLst/>
            </c:spPr>
          </c:marker>
          <c:xVal>
            <c:numRef>
              <c:f>Sheet1!$A$2:$A$1739</c:f>
              <c:numCache>
                <c:formatCode>General</c:formatCode>
                <c:ptCount val="1738"/>
                <c:pt idx="0">
                  <c:v>0</c:v>
                </c:pt>
                <c:pt idx="1">
                  <c:v>0.60399999999999998</c:v>
                </c:pt>
                <c:pt idx="2">
                  <c:v>1.208</c:v>
                </c:pt>
                <c:pt idx="3">
                  <c:v>1.8129999999999999</c:v>
                </c:pt>
                <c:pt idx="4">
                  <c:v>2.416999999999998</c:v>
                </c:pt>
                <c:pt idx="5">
                  <c:v>3.0209999999999999</c:v>
                </c:pt>
                <c:pt idx="6">
                  <c:v>3.625</c:v>
                </c:pt>
                <c:pt idx="7">
                  <c:v>4.2290000000000001</c:v>
                </c:pt>
                <c:pt idx="8">
                  <c:v>4.8330000000000002</c:v>
                </c:pt>
                <c:pt idx="9">
                  <c:v>5.4379999999999997</c:v>
                </c:pt>
                <c:pt idx="10">
                  <c:v>6.0419999999999998</c:v>
                </c:pt>
                <c:pt idx="11">
                  <c:v>6.6459999999999981</c:v>
                </c:pt>
                <c:pt idx="12">
                  <c:v>7.25</c:v>
                </c:pt>
                <c:pt idx="13">
                  <c:v>7.8539999999999983</c:v>
                </c:pt>
                <c:pt idx="14">
                  <c:v>8.4580000000000002</c:v>
                </c:pt>
                <c:pt idx="15">
                  <c:v>9.0630000000000006</c:v>
                </c:pt>
                <c:pt idx="16">
                  <c:v>9.6670000000000016</c:v>
                </c:pt>
                <c:pt idx="17">
                  <c:v>10.271000000000001</c:v>
                </c:pt>
                <c:pt idx="18">
                  <c:v>10.875</c:v>
                </c:pt>
                <c:pt idx="19">
                  <c:v>11.478999999999999</c:v>
                </c:pt>
                <c:pt idx="20">
                  <c:v>12.083</c:v>
                </c:pt>
                <c:pt idx="21">
                  <c:v>12.688000000000001</c:v>
                </c:pt>
                <c:pt idx="22">
                  <c:v>13.292</c:v>
                </c:pt>
                <c:pt idx="23">
                  <c:v>13.896000000000001</c:v>
                </c:pt>
                <c:pt idx="24">
                  <c:v>14.5</c:v>
                </c:pt>
                <c:pt idx="25">
                  <c:v>15.103999999999999</c:v>
                </c:pt>
                <c:pt idx="26">
                  <c:v>15.708</c:v>
                </c:pt>
                <c:pt idx="27">
                  <c:v>16.312999999999999</c:v>
                </c:pt>
                <c:pt idx="28">
                  <c:v>16.917000000000009</c:v>
                </c:pt>
                <c:pt idx="29">
                  <c:v>17.521000000000001</c:v>
                </c:pt>
                <c:pt idx="30">
                  <c:v>18.125</c:v>
                </c:pt>
                <c:pt idx="31">
                  <c:v>18.728999999999999</c:v>
                </c:pt>
                <c:pt idx="32">
                  <c:v>19.332999999999991</c:v>
                </c:pt>
                <c:pt idx="33">
                  <c:v>19.937999999999999</c:v>
                </c:pt>
                <c:pt idx="34">
                  <c:v>20.542000000000002</c:v>
                </c:pt>
                <c:pt idx="35">
                  <c:v>21.146000000000001</c:v>
                </c:pt>
                <c:pt idx="36">
                  <c:v>21.75</c:v>
                </c:pt>
                <c:pt idx="37">
                  <c:v>22.353999999999999</c:v>
                </c:pt>
                <c:pt idx="38">
                  <c:v>22.957999999999991</c:v>
                </c:pt>
                <c:pt idx="39">
                  <c:v>23.562999999999999</c:v>
                </c:pt>
                <c:pt idx="40">
                  <c:v>24.167000000000009</c:v>
                </c:pt>
                <c:pt idx="41">
                  <c:v>24.771000000000001</c:v>
                </c:pt>
                <c:pt idx="42">
                  <c:v>25.375</c:v>
                </c:pt>
                <c:pt idx="43">
                  <c:v>25.978999999999999</c:v>
                </c:pt>
                <c:pt idx="44">
                  <c:v>26.582999999999981</c:v>
                </c:pt>
                <c:pt idx="45">
                  <c:v>27.187999999999999</c:v>
                </c:pt>
                <c:pt idx="46">
                  <c:v>27.792000000000002</c:v>
                </c:pt>
                <c:pt idx="47">
                  <c:v>28.396000000000001</c:v>
                </c:pt>
                <c:pt idx="48">
                  <c:v>29</c:v>
                </c:pt>
                <c:pt idx="49">
                  <c:v>29.603999999999999</c:v>
                </c:pt>
                <c:pt idx="50">
                  <c:v>30.207999999999991</c:v>
                </c:pt>
                <c:pt idx="51">
                  <c:v>30.812999999999999</c:v>
                </c:pt>
                <c:pt idx="52">
                  <c:v>31.417000000000009</c:v>
                </c:pt>
                <c:pt idx="53">
                  <c:v>32.021000000000001</c:v>
                </c:pt>
                <c:pt idx="54">
                  <c:v>32.625</c:v>
                </c:pt>
                <c:pt idx="55">
                  <c:v>33.229000000000013</c:v>
                </c:pt>
                <c:pt idx="56">
                  <c:v>33.833000000000013</c:v>
                </c:pt>
                <c:pt idx="57">
                  <c:v>34.438000000000002</c:v>
                </c:pt>
                <c:pt idx="58">
                  <c:v>35.042000000000002</c:v>
                </c:pt>
                <c:pt idx="59">
                  <c:v>35.646000000000001</c:v>
                </c:pt>
                <c:pt idx="60">
                  <c:v>36.25</c:v>
                </c:pt>
                <c:pt idx="61">
                  <c:v>36.853999999999999</c:v>
                </c:pt>
                <c:pt idx="62">
                  <c:v>37.457999999999998</c:v>
                </c:pt>
                <c:pt idx="63">
                  <c:v>38.063000000000002</c:v>
                </c:pt>
                <c:pt idx="64">
                  <c:v>38.667000000000002</c:v>
                </c:pt>
                <c:pt idx="65">
                  <c:v>39.271000000000001</c:v>
                </c:pt>
                <c:pt idx="66">
                  <c:v>39.875</c:v>
                </c:pt>
                <c:pt idx="67">
                  <c:v>40.479000000000013</c:v>
                </c:pt>
                <c:pt idx="68">
                  <c:v>41.083000000000013</c:v>
                </c:pt>
                <c:pt idx="69">
                  <c:v>41.688000000000002</c:v>
                </c:pt>
                <c:pt idx="70">
                  <c:v>42.292000000000002</c:v>
                </c:pt>
                <c:pt idx="71">
                  <c:v>42.896000000000001</c:v>
                </c:pt>
                <c:pt idx="72">
                  <c:v>43.5</c:v>
                </c:pt>
                <c:pt idx="73">
                  <c:v>44.104000000000013</c:v>
                </c:pt>
                <c:pt idx="74">
                  <c:v>44.707999999999998</c:v>
                </c:pt>
                <c:pt idx="75">
                  <c:v>45.313000000000002</c:v>
                </c:pt>
                <c:pt idx="76">
                  <c:v>45.917000000000002</c:v>
                </c:pt>
                <c:pt idx="77">
                  <c:v>46.521000000000001</c:v>
                </c:pt>
                <c:pt idx="78">
                  <c:v>47.125</c:v>
                </c:pt>
                <c:pt idx="79">
                  <c:v>47.729000000000013</c:v>
                </c:pt>
                <c:pt idx="80">
                  <c:v>48.333000000000013</c:v>
                </c:pt>
                <c:pt idx="81">
                  <c:v>48.938000000000002</c:v>
                </c:pt>
                <c:pt idx="82">
                  <c:v>49.542000000000002</c:v>
                </c:pt>
                <c:pt idx="83">
                  <c:v>50.146000000000001</c:v>
                </c:pt>
                <c:pt idx="84">
                  <c:v>50.75</c:v>
                </c:pt>
                <c:pt idx="85">
                  <c:v>51.353999999999999</c:v>
                </c:pt>
                <c:pt idx="86">
                  <c:v>51.957999999999998</c:v>
                </c:pt>
                <c:pt idx="87">
                  <c:v>52.563000000000002</c:v>
                </c:pt>
                <c:pt idx="88">
                  <c:v>53.167000000000002</c:v>
                </c:pt>
                <c:pt idx="89">
                  <c:v>53.771000000000001</c:v>
                </c:pt>
                <c:pt idx="90">
                  <c:v>54.375</c:v>
                </c:pt>
                <c:pt idx="91">
                  <c:v>54.979000000000013</c:v>
                </c:pt>
                <c:pt idx="92">
                  <c:v>55.583000000000013</c:v>
                </c:pt>
                <c:pt idx="93">
                  <c:v>56.188000000000002</c:v>
                </c:pt>
                <c:pt idx="94">
                  <c:v>56.792000000000002</c:v>
                </c:pt>
                <c:pt idx="95">
                  <c:v>57.396000000000001</c:v>
                </c:pt>
                <c:pt idx="96">
                  <c:v>58</c:v>
                </c:pt>
                <c:pt idx="97">
                  <c:v>58.604000000000013</c:v>
                </c:pt>
                <c:pt idx="98">
                  <c:v>59.207999999999998</c:v>
                </c:pt>
                <c:pt idx="99">
                  <c:v>59.813000000000002</c:v>
                </c:pt>
                <c:pt idx="100">
                  <c:v>60.417000000000002</c:v>
                </c:pt>
                <c:pt idx="101">
                  <c:v>61.021000000000001</c:v>
                </c:pt>
                <c:pt idx="102">
                  <c:v>61.625</c:v>
                </c:pt>
                <c:pt idx="103">
                  <c:v>62.229000000000013</c:v>
                </c:pt>
                <c:pt idx="104">
                  <c:v>62.833000000000013</c:v>
                </c:pt>
                <c:pt idx="105">
                  <c:v>63.438000000000002</c:v>
                </c:pt>
                <c:pt idx="106">
                  <c:v>64.042000000000002</c:v>
                </c:pt>
                <c:pt idx="107">
                  <c:v>64.646000000000001</c:v>
                </c:pt>
                <c:pt idx="108">
                  <c:v>65.25</c:v>
                </c:pt>
                <c:pt idx="109">
                  <c:v>65.853999999999999</c:v>
                </c:pt>
                <c:pt idx="110">
                  <c:v>66.458000000000013</c:v>
                </c:pt>
                <c:pt idx="111">
                  <c:v>67.063000000000002</c:v>
                </c:pt>
                <c:pt idx="112">
                  <c:v>67.667000000000002</c:v>
                </c:pt>
                <c:pt idx="113">
                  <c:v>68.271000000000001</c:v>
                </c:pt>
                <c:pt idx="114">
                  <c:v>68.874999999999986</c:v>
                </c:pt>
                <c:pt idx="115">
                  <c:v>69.478999999999999</c:v>
                </c:pt>
                <c:pt idx="116">
                  <c:v>70.082999999999998</c:v>
                </c:pt>
                <c:pt idx="117">
                  <c:v>70.687999999999974</c:v>
                </c:pt>
                <c:pt idx="118">
                  <c:v>71.292000000000002</c:v>
                </c:pt>
                <c:pt idx="119">
                  <c:v>71.896000000000001</c:v>
                </c:pt>
                <c:pt idx="120">
                  <c:v>72.5</c:v>
                </c:pt>
                <c:pt idx="121">
                  <c:v>73.103999999999999</c:v>
                </c:pt>
                <c:pt idx="122">
                  <c:v>73.708000000000013</c:v>
                </c:pt>
                <c:pt idx="123">
                  <c:v>74.313000000000002</c:v>
                </c:pt>
                <c:pt idx="124">
                  <c:v>74.917000000000002</c:v>
                </c:pt>
                <c:pt idx="125">
                  <c:v>75.521000000000001</c:v>
                </c:pt>
                <c:pt idx="126">
                  <c:v>76.124999999999986</c:v>
                </c:pt>
                <c:pt idx="127">
                  <c:v>76.728999999999999</c:v>
                </c:pt>
                <c:pt idx="128">
                  <c:v>77.332999999999998</c:v>
                </c:pt>
                <c:pt idx="129">
                  <c:v>77.938000000000002</c:v>
                </c:pt>
                <c:pt idx="130">
                  <c:v>78.542000000000002</c:v>
                </c:pt>
                <c:pt idx="131">
                  <c:v>79.146000000000001</c:v>
                </c:pt>
                <c:pt idx="132">
                  <c:v>79.75</c:v>
                </c:pt>
                <c:pt idx="133">
                  <c:v>80.353999999999999</c:v>
                </c:pt>
                <c:pt idx="134">
                  <c:v>80.958000000000013</c:v>
                </c:pt>
                <c:pt idx="135">
                  <c:v>81.563000000000002</c:v>
                </c:pt>
                <c:pt idx="136">
                  <c:v>82.167000000000002</c:v>
                </c:pt>
                <c:pt idx="137">
                  <c:v>82.771000000000001</c:v>
                </c:pt>
                <c:pt idx="138">
                  <c:v>83.374999999999986</c:v>
                </c:pt>
                <c:pt idx="139">
                  <c:v>83.978999999999999</c:v>
                </c:pt>
                <c:pt idx="140">
                  <c:v>84.582999999999998</c:v>
                </c:pt>
                <c:pt idx="141">
                  <c:v>85.187999999999974</c:v>
                </c:pt>
                <c:pt idx="142">
                  <c:v>85.792000000000002</c:v>
                </c:pt>
                <c:pt idx="143">
                  <c:v>86.396000000000001</c:v>
                </c:pt>
                <c:pt idx="144">
                  <c:v>87</c:v>
                </c:pt>
                <c:pt idx="145">
                  <c:v>87.603999999999999</c:v>
                </c:pt>
                <c:pt idx="146">
                  <c:v>88.208000000000013</c:v>
                </c:pt>
                <c:pt idx="147">
                  <c:v>88.813000000000002</c:v>
                </c:pt>
                <c:pt idx="148">
                  <c:v>89.417000000000002</c:v>
                </c:pt>
                <c:pt idx="149">
                  <c:v>90.021000000000001</c:v>
                </c:pt>
                <c:pt idx="150">
                  <c:v>90.624999999999986</c:v>
                </c:pt>
                <c:pt idx="151">
                  <c:v>91.228999999999999</c:v>
                </c:pt>
                <c:pt idx="152">
                  <c:v>91.832999999999998</c:v>
                </c:pt>
                <c:pt idx="153">
                  <c:v>92.438000000000002</c:v>
                </c:pt>
                <c:pt idx="154">
                  <c:v>93.042000000000002</c:v>
                </c:pt>
                <c:pt idx="155">
                  <c:v>93.646000000000001</c:v>
                </c:pt>
                <c:pt idx="156">
                  <c:v>94.25</c:v>
                </c:pt>
                <c:pt idx="157">
                  <c:v>94.853999999999999</c:v>
                </c:pt>
                <c:pt idx="158">
                  <c:v>95.458000000000013</c:v>
                </c:pt>
                <c:pt idx="159">
                  <c:v>96.063000000000002</c:v>
                </c:pt>
                <c:pt idx="160">
                  <c:v>96.667000000000002</c:v>
                </c:pt>
                <c:pt idx="161">
                  <c:v>97.271000000000001</c:v>
                </c:pt>
                <c:pt idx="162">
                  <c:v>97.874999999999986</c:v>
                </c:pt>
                <c:pt idx="163">
                  <c:v>98.478999999999999</c:v>
                </c:pt>
                <c:pt idx="164">
                  <c:v>99.082999999999998</c:v>
                </c:pt>
                <c:pt idx="165">
                  <c:v>99.687999999999974</c:v>
                </c:pt>
                <c:pt idx="166">
                  <c:v>100.292</c:v>
                </c:pt>
                <c:pt idx="167">
                  <c:v>100.896</c:v>
                </c:pt>
                <c:pt idx="168">
                  <c:v>101.5</c:v>
                </c:pt>
                <c:pt idx="169">
                  <c:v>102.104</c:v>
                </c:pt>
                <c:pt idx="170">
                  <c:v>102.708</c:v>
                </c:pt>
                <c:pt idx="171">
                  <c:v>103.313</c:v>
                </c:pt>
                <c:pt idx="172">
                  <c:v>103.917</c:v>
                </c:pt>
                <c:pt idx="173">
                  <c:v>104.521</c:v>
                </c:pt>
                <c:pt idx="174">
                  <c:v>105.125</c:v>
                </c:pt>
                <c:pt idx="175">
                  <c:v>105.729</c:v>
                </c:pt>
                <c:pt idx="176">
                  <c:v>106.333</c:v>
                </c:pt>
                <c:pt idx="177">
                  <c:v>106.938</c:v>
                </c:pt>
                <c:pt idx="178">
                  <c:v>107.542</c:v>
                </c:pt>
                <c:pt idx="179">
                  <c:v>108.146</c:v>
                </c:pt>
                <c:pt idx="180">
                  <c:v>108.75</c:v>
                </c:pt>
                <c:pt idx="181">
                  <c:v>109.354</c:v>
                </c:pt>
                <c:pt idx="182">
                  <c:v>109.958</c:v>
                </c:pt>
                <c:pt idx="183">
                  <c:v>110.563</c:v>
                </c:pt>
                <c:pt idx="184">
                  <c:v>111.167</c:v>
                </c:pt>
                <c:pt idx="185">
                  <c:v>111.771</c:v>
                </c:pt>
                <c:pt idx="186">
                  <c:v>112.375</c:v>
                </c:pt>
                <c:pt idx="187">
                  <c:v>112.979</c:v>
                </c:pt>
                <c:pt idx="188">
                  <c:v>113.583</c:v>
                </c:pt>
                <c:pt idx="189">
                  <c:v>114.188</c:v>
                </c:pt>
                <c:pt idx="190">
                  <c:v>114.792</c:v>
                </c:pt>
                <c:pt idx="191">
                  <c:v>115.396</c:v>
                </c:pt>
                <c:pt idx="192">
                  <c:v>116</c:v>
                </c:pt>
                <c:pt idx="193">
                  <c:v>116.604</c:v>
                </c:pt>
                <c:pt idx="194">
                  <c:v>117.208</c:v>
                </c:pt>
                <c:pt idx="195">
                  <c:v>117.813</c:v>
                </c:pt>
                <c:pt idx="196">
                  <c:v>118.417</c:v>
                </c:pt>
                <c:pt idx="197">
                  <c:v>119.021</c:v>
                </c:pt>
                <c:pt idx="198">
                  <c:v>119.625</c:v>
                </c:pt>
                <c:pt idx="199">
                  <c:v>120.229</c:v>
                </c:pt>
                <c:pt idx="200">
                  <c:v>120.833</c:v>
                </c:pt>
                <c:pt idx="201">
                  <c:v>121.438</c:v>
                </c:pt>
                <c:pt idx="202">
                  <c:v>122.042</c:v>
                </c:pt>
                <c:pt idx="203">
                  <c:v>122.646</c:v>
                </c:pt>
                <c:pt idx="204">
                  <c:v>123.25</c:v>
                </c:pt>
                <c:pt idx="205">
                  <c:v>123.854</c:v>
                </c:pt>
                <c:pt idx="206">
                  <c:v>124.458</c:v>
                </c:pt>
                <c:pt idx="207">
                  <c:v>125.063</c:v>
                </c:pt>
                <c:pt idx="208">
                  <c:v>125.667</c:v>
                </c:pt>
                <c:pt idx="209">
                  <c:v>126.271</c:v>
                </c:pt>
                <c:pt idx="210">
                  <c:v>126.875</c:v>
                </c:pt>
                <c:pt idx="211">
                  <c:v>127.479</c:v>
                </c:pt>
                <c:pt idx="212">
                  <c:v>128.083</c:v>
                </c:pt>
                <c:pt idx="213">
                  <c:v>128.68799999999999</c:v>
                </c:pt>
                <c:pt idx="214">
                  <c:v>129.292</c:v>
                </c:pt>
                <c:pt idx="215">
                  <c:v>129.89599999999999</c:v>
                </c:pt>
                <c:pt idx="216">
                  <c:v>130.5</c:v>
                </c:pt>
                <c:pt idx="217">
                  <c:v>131.10400000000001</c:v>
                </c:pt>
                <c:pt idx="218">
                  <c:v>131.708</c:v>
                </c:pt>
                <c:pt idx="219">
                  <c:v>132.31299999999999</c:v>
                </c:pt>
                <c:pt idx="220">
                  <c:v>132.917</c:v>
                </c:pt>
                <c:pt idx="221">
                  <c:v>133.52099999999999</c:v>
                </c:pt>
                <c:pt idx="222">
                  <c:v>134.125</c:v>
                </c:pt>
                <c:pt idx="223">
                  <c:v>134.72900000000001</c:v>
                </c:pt>
                <c:pt idx="224">
                  <c:v>135.333</c:v>
                </c:pt>
                <c:pt idx="225">
                  <c:v>135.93799999999999</c:v>
                </c:pt>
                <c:pt idx="226">
                  <c:v>136.542</c:v>
                </c:pt>
                <c:pt idx="227">
                  <c:v>137.14599999999999</c:v>
                </c:pt>
                <c:pt idx="228">
                  <c:v>137.75</c:v>
                </c:pt>
                <c:pt idx="229">
                  <c:v>138.35400000000001</c:v>
                </c:pt>
                <c:pt idx="230">
                  <c:v>138.958</c:v>
                </c:pt>
                <c:pt idx="231">
                  <c:v>139.56299999999999</c:v>
                </c:pt>
                <c:pt idx="232">
                  <c:v>140.167</c:v>
                </c:pt>
                <c:pt idx="233">
                  <c:v>140.77099999999999</c:v>
                </c:pt>
                <c:pt idx="234">
                  <c:v>141.375</c:v>
                </c:pt>
                <c:pt idx="235">
                  <c:v>141.97900000000001</c:v>
                </c:pt>
                <c:pt idx="236">
                  <c:v>142.583</c:v>
                </c:pt>
                <c:pt idx="237">
                  <c:v>143.18799999999999</c:v>
                </c:pt>
                <c:pt idx="238">
                  <c:v>143.792</c:v>
                </c:pt>
                <c:pt idx="239">
                  <c:v>144.39599999999999</c:v>
                </c:pt>
                <c:pt idx="240">
                  <c:v>145</c:v>
                </c:pt>
                <c:pt idx="241">
                  <c:v>145.60400000000001</c:v>
                </c:pt>
                <c:pt idx="242">
                  <c:v>146.208</c:v>
                </c:pt>
                <c:pt idx="243">
                  <c:v>146.81299999999999</c:v>
                </c:pt>
                <c:pt idx="244">
                  <c:v>147.417</c:v>
                </c:pt>
                <c:pt idx="245">
                  <c:v>148.02099999999999</c:v>
                </c:pt>
                <c:pt idx="246">
                  <c:v>148.625</c:v>
                </c:pt>
                <c:pt idx="247">
                  <c:v>149.22900000000001</c:v>
                </c:pt>
                <c:pt idx="248">
                  <c:v>149.833</c:v>
                </c:pt>
                <c:pt idx="249">
                  <c:v>150.43799999999999</c:v>
                </c:pt>
                <c:pt idx="250">
                  <c:v>151.042</c:v>
                </c:pt>
                <c:pt idx="251">
                  <c:v>151.64599999999999</c:v>
                </c:pt>
                <c:pt idx="252">
                  <c:v>152.25</c:v>
                </c:pt>
                <c:pt idx="253">
                  <c:v>152.85400000000001</c:v>
                </c:pt>
                <c:pt idx="254">
                  <c:v>153.458</c:v>
                </c:pt>
                <c:pt idx="255">
                  <c:v>154.06299999999999</c:v>
                </c:pt>
                <c:pt idx="256">
                  <c:v>154.667</c:v>
                </c:pt>
                <c:pt idx="257">
                  <c:v>155.27099999999999</c:v>
                </c:pt>
                <c:pt idx="258">
                  <c:v>155.875</c:v>
                </c:pt>
                <c:pt idx="259">
                  <c:v>156.47900000000001</c:v>
                </c:pt>
                <c:pt idx="260">
                  <c:v>157.083</c:v>
                </c:pt>
                <c:pt idx="261">
                  <c:v>157.68799999999999</c:v>
                </c:pt>
                <c:pt idx="262">
                  <c:v>158.292</c:v>
                </c:pt>
                <c:pt idx="263">
                  <c:v>158.89599999999999</c:v>
                </c:pt>
                <c:pt idx="264">
                  <c:v>159.5</c:v>
                </c:pt>
                <c:pt idx="265">
                  <c:v>160.10400000000001</c:v>
                </c:pt>
                <c:pt idx="266">
                  <c:v>160.708</c:v>
                </c:pt>
                <c:pt idx="267">
                  <c:v>161.31299999999999</c:v>
                </c:pt>
                <c:pt idx="268">
                  <c:v>161.917</c:v>
                </c:pt>
                <c:pt idx="269">
                  <c:v>162.52099999999999</c:v>
                </c:pt>
                <c:pt idx="270">
                  <c:v>163.125</c:v>
                </c:pt>
                <c:pt idx="271">
                  <c:v>163.72900000000001</c:v>
                </c:pt>
                <c:pt idx="272">
                  <c:v>164.333</c:v>
                </c:pt>
                <c:pt idx="273">
                  <c:v>164.93799999999999</c:v>
                </c:pt>
                <c:pt idx="274">
                  <c:v>165.542</c:v>
                </c:pt>
                <c:pt idx="275">
                  <c:v>166.14599999999999</c:v>
                </c:pt>
                <c:pt idx="276">
                  <c:v>166.75</c:v>
                </c:pt>
                <c:pt idx="277">
                  <c:v>167.35400000000001</c:v>
                </c:pt>
                <c:pt idx="278">
                  <c:v>167.958</c:v>
                </c:pt>
                <c:pt idx="279">
                  <c:v>168.56299999999999</c:v>
                </c:pt>
                <c:pt idx="280">
                  <c:v>169.167</c:v>
                </c:pt>
                <c:pt idx="281">
                  <c:v>169.77099999999999</c:v>
                </c:pt>
                <c:pt idx="282">
                  <c:v>170.375</c:v>
                </c:pt>
                <c:pt idx="283">
                  <c:v>170.97900000000001</c:v>
                </c:pt>
                <c:pt idx="284">
                  <c:v>171.583</c:v>
                </c:pt>
                <c:pt idx="285">
                  <c:v>172.18799999999999</c:v>
                </c:pt>
                <c:pt idx="286">
                  <c:v>172.792</c:v>
                </c:pt>
                <c:pt idx="287">
                  <c:v>173.39599999999999</c:v>
                </c:pt>
                <c:pt idx="288">
                  <c:v>174</c:v>
                </c:pt>
                <c:pt idx="289">
                  <c:v>174.60400000000001</c:v>
                </c:pt>
                <c:pt idx="290">
                  <c:v>175.208</c:v>
                </c:pt>
                <c:pt idx="291">
                  <c:v>175.81299999999999</c:v>
                </c:pt>
                <c:pt idx="292">
                  <c:v>176.417</c:v>
                </c:pt>
                <c:pt idx="293">
                  <c:v>177.02099999999999</c:v>
                </c:pt>
                <c:pt idx="294">
                  <c:v>177.625</c:v>
                </c:pt>
                <c:pt idx="295">
                  <c:v>178.22900000000001</c:v>
                </c:pt>
                <c:pt idx="296">
                  <c:v>178.833</c:v>
                </c:pt>
                <c:pt idx="297">
                  <c:v>179.43799999999999</c:v>
                </c:pt>
                <c:pt idx="298">
                  <c:v>180.042</c:v>
                </c:pt>
                <c:pt idx="299">
                  <c:v>180.64599999999999</c:v>
                </c:pt>
                <c:pt idx="300">
                  <c:v>181.25</c:v>
                </c:pt>
                <c:pt idx="301">
                  <c:v>181.85400000000001</c:v>
                </c:pt>
                <c:pt idx="302">
                  <c:v>182.458</c:v>
                </c:pt>
                <c:pt idx="303">
                  <c:v>183.06299999999999</c:v>
                </c:pt>
                <c:pt idx="304">
                  <c:v>183.667</c:v>
                </c:pt>
                <c:pt idx="305">
                  <c:v>184.27099999999999</c:v>
                </c:pt>
                <c:pt idx="306">
                  <c:v>184.875</c:v>
                </c:pt>
                <c:pt idx="307">
                  <c:v>185.47900000000001</c:v>
                </c:pt>
                <c:pt idx="308">
                  <c:v>186.083</c:v>
                </c:pt>
                <c:pt idx="309">
                  <c:v>186.68799999999999</c:v>
                </c:pt>
                <c:pt idx="310">
                  <c:v>187.292</c:v>
                </c:pt>
                <c:pt idx="311">
                  <c:v>187.89599999999999</c:v>
                </c:pt>
                <c:pt idx="312">
                  <c:v>188.5</c:v>
                </c:pt>
                <c:pt idx="313">
                  <c:v>189.10400000000001</c:v>
                </c:pt>
                <c:pt idx="314">
                  <c:v>189.708</c:v>
                </c:pt>
                <c:pt idx="315">
                  <c:v>190.31299999999999</c:v>
                </c:pt>
                <c:pt idx="316">
                  <c:v>190.917</c:v>
                </c:pt>
                <c:pt idx="317">
                  <c:v>191.52099999999999</c:v>
                </c:pt>
                <c:pt idx="318">
                  <c:v>192.125</c:v>
                </c:pt>
                <c:pt idx="319">
                  <c:v>192.72900000000001</c:v>
                </c:pt>
                <c:pt idx="320">
                  <c:v>193.333</c:v>
                </c:pt>
                <c:pt idx="321">
                  <c:v>193.93799999999999</c:v>
                </c:pt>
                <c:pt idx="322">
                  <c:v>194.542</c:v>
                </c:pt>
                <c:pt idx="323">
                  <c:v>195.14599999999999</c:v>
                </c:pt>
                <c:pt idx="324">
                  <c:v>195.75</c:v>
                </c:pt>
                <c:pt idx="325">
                  <c:v>196.35400000000001</c:v>
                </c:pt>
                <c:pt idx="326">
                  <c:v>196.958</c:v>
                </c:pt>
                <c:pt idx="327">
                  <c:v>197.56299999999999</c:v>
                </c:pt>
                <c:pt idx="328">
                  <c:v>198.167</c:v>
                </c:pt>
                <c:pt idx="329">
                  <c:v>198.77099999999999</c:v>
                </c:pt>
                <c:pt idx="330">
                  <c:v>199.375</c:v>
                </c:pt>
                <c:pt idx="331">
                  <c:v>199.97900000000001</c:v>
                </c:pt>
                <c:pt idx="332">
                  <c:v>200.583</c:v>
                </c:pt>
                <c:pt idx="333">
                  <c:v>201.18799999999999</c:v>
                </c:pt>
                <c:pt idx="334">
                  <c:v>201.792</c:v>
                </c:pt>
                <c:pt idx="335">
                  <c:v>202.39599999999999</c:v>
                </c:pt>
                <c:pt idx="336">
                  <c:v>203</c:v>
                </c:pt>
                <c:pt idx="337">
                  <c:v>203.60400000000001</c:v>
                </c:pt>
                <c:pt idx="338">
                  <c:v>204.208</c:v>
                </c:pt>
                <c:pt idx="339">
                  <c:v>204.81299999999999</c:v>
                </c:pt>
                <c:pt idx="340">
                  <c:v>205.417</c:v>
                </c:pt>
                <c:pt idx="341">
                  <c:v>206.02099999999999</c:v>
                </c:pt>
                <c:pt idx="342">
                  <c:v>206.625</c:v>
                </c:pt>
                <c:pt idx="343">
                  <c:v>207.22900000000001</c:v>
                </c:pt>
                <c:pt idx="344">
                  <c:v>207.833</c:v>
                </c:pt>
                <c:pt idx="345">
                  <c:v>208.43799999999999</c:v>
                </c:pt>
                <c:pt idx="346">
                  <c:v>209.042</c:v>
                </c:pt>
                <c:pt idx="347">
                  <c:v>209.64599999999999</c:v>
                </c:pt>
                <c:pt idx="348">
                  <c:v>210.25</c:v>
                </c:pt>
                <c:pt idx="349">
                  <c:v>210.85400000000001</c:v>
                </c:pt>
                <c:pt idx="350">
                  <c:v>211.458</c:v>
                </c:pt>
                <c:pt idx="351">
                  <c:v>212.06299999999999</c:v>
                </c:pt>
                <c:pt idx="352">
                  <c:v>212.667</c:v>
                </c:pt>
                <c:pt idx="353">
                  <c:v>213.27099999999999</c:v>
                </c:pt>
                <c:pt idx="354">
                  <c:v>213.875</c:v>
                </c:pt>
                <c:pt idx="355">
                  <c:v>214.47900000000001</c:v>
                </c:pt>
                <c:pt idx="356">
                  <c:v>215.083</c:v>
                </c:pt>
                <c:pt idx="357">
                  <c:v>215.68799999999999</c:v>
                </c:pt>
                <c:pt idx="358">
                  <c:v>216.292</c:v>
                </c:pt>
                <c:pt idx="359">
                  <c:v>216.89599999999999</c:v>
                </c:pt>
                <c:pt idx="360">
                  <c:v>217.5</c:v>
                </c:pt>
                <c:pt idx="361">
                  <c:v>218.10400000000001</c:v>
                </c:pt>
                <c:pt idx="362">
                  <c:v>218.708</c:v>
                </c:pt>
                <c:pt idx="363">
                  <c:v>219.31299999999999</c:v>
                </c:pt>
                <c:pt idx="364">
                  <c:v>219.917</c:v>
                </c:pt>
                <c:pt idx="365">
                  <c:v>220.52099999999999</c:v>
                </c:pt>
                <c:pt idx="366">
                  <c:v>221.125</c:v>
                </c:pt>
                <c:pt idx="367">
                  <c:v>221.72900000000001</c:v>
                </c:pt>
                <c:pt idx="368">
                  <c:v>222.333</c:v>
                </c:pt>
                <c:pt idx="369">
                  <c:v>222.93799999999999</c:v>
                </c:pt>
                <c:pt idx="370">
                  <c:v>223.542</c:v>
                </c:pt>
                <c:pt idx="371">
                  <c:v>224.14599999999999</c:v>
                </c:pt>
                <c:pt idx="372">
                  <c:v>224.75</c:v>
                </c:pt>
                <c:pt idx="373">
                  <c:v>225.35400000000001</c:v>
                </c:pt>
                <c:pt idx="374">
                  <c:v>225.958</c:v>
                </c:pt>
                <c:pt idx="375">
                  <c:v>226.56299999999999</c:v>
                </c:pt>
                <c:pt idx="376">
                  <c:v>227.167</c:v>
                </c:pt>
                <c:pt idx="377">
                  <c:v>227.77099999999999</c:v>
                </c:pt>
                <c:pt idx="378">
                  <c:v>228.375</c:v>
                </c:pt>
                <c:pt idx="379">
                  <c:v>228.97900000000001</c:v>
                </c:pt>
                <c:pt idx="380">
                  <c:v>229.583</c:v>
                </c:pt>
                <c:pt idx="381">
                  <c:v>230.18799999999999</c:v>
                </c:pt>
                <c:pt idx="382">
                  <c:v>230.792</c:v>
                </c:pt>
                <c:pt idx="383">
                  <c:v>231.39599999999999</c:v>
                </c:pt>
                <c:pt idx="384">
                  <c:v>232</c:v>
                </c:pt>
                <c:pt idx="385">
                  <c:v>232.60400000000001</c:v>
                </c:pt>
                <c:pt idx="386">
                  <c:v>233.208</c:v>
                </c:pt>
                <c:pt idx="387">
                  <c:v>233.81299999999999</c:v>
                </c:pt>
                <c:pt idx="388">
                  <c:v>234.417</c:v>
                </c:pt>
                <c:pt idx="389">
                  <c:v>235.02099999999999</c:v>
                </c:pt>
                <c:pt idx="390">
                  <c:v>235.625</c:v>
                </c:pt>
                <c:pt idx="391">
                  <c:v>236.22900000000001</c:v>
                </c:pt>
                <c:pt idx="392">
                  <c:v>236.833</c:v>
                </c:pt>
                <c:pt idx="393">
                  <c:v>237.43799999999999</c:v>
                </c:pt>
                <c:pt idx="394">
                  <c:v>238.042</c:v>
                </c:pt>
                <c:pt idx="395">
                  <c:v>238.64599999999999</c:v>
                </c:pt>
                <c:pt idx="396">
                  <c:v>239.25</c:v>
                </c:pt>
                <c:pt idx="397">
                  <c:v>239.85400000000001</c:v>
                </c:pt>
                <c:pt idx="398">
                  <c:v>240.458</c:v>
                </c:pt>
                <c:pt idx="399">
                  <c:v>241.06299999999999</c:v>
                </c:pt>
                <c:pt idx="400">
                  <c:v>241.667</c:v>
                </c:pt>
                <c:pt idx="401">
                  <c:v>242.27099999999999</c:v>
                </c:pt>
                <c:pt idx="402">
                  <c:v>242.875</c:v>
                </c:pt>
                <c:pt idx="403">
                  <c:v>243.47900000000001</c:v>
                </c:pt>
                <c:pt idx="404">
                  <c:v>244.083</c:v>
                </c:pt>
                <c:pt idx="405">
                  <c:v>244.68799999999999</c:v>
                </c:pt>
                <c:pt idx="406">
                  <c:v>245.292</c:v>
                </c:pt>
                <c:pt idx="407">
                  <c:v>245.89599999999999</c:v>
                </c:pt>
                <c:pt idx="408">
                  <c:v>246.5</c:v>
                </c:pt>
                <c:pt idx="409">
                  <c:v>247.10400000000001</c:v>
                </c:pt>
                <c:pt idx="410">
                  <c:v>247.708</c:v>
                </c:pt>
                <c:pt idx="411">
                  <c:v>248.31299999999999</c:v>
                </c:pt>
                <c:pt idx="412">
                  <c:v>248.917</c:v>
                </c:pt>
                <c:pt idx="413">
                  <c:v>249.52099999999999</c:v>
                </c:pt>
                <c:pt idx="414">
                  <c:v>250.125</c:v>
                </c:pt>
                <c:pt idx="415">
                  <c:v>250.72900000000001</c:v>
                </c:pt>
                <c:pt idx="416">
                  <c:v>251.333</c:v>
                </c:pt>
                <c:pt idx="417">
                  <c:v>251.93799999999999</c:v>
                </c:pt>
                <c:pt idx="418">
                  <c:v>252.542</c:v>
                </c:pt>
                <c:pt idx="419">
                  <c:v>253.14599999999999</c:v>
                </c:pt>
                <c:pt idx="420">
                  <c:v>253.75</c:v>
                </c:pt>
                <c:pt idx="421">
                  <c:v>254.35400000000001</c:v>
                </c:pt>
                <c:pt idx="422">
                  <c:v>254.958</c:v>
                </c:pt>
                <c:pt idx="423">
                  <c:v>255.56299999999999</c:v>
                </c:pt>
                <c:pt idx="424">
                  <c:v>256.16699999999992</c:v>
                </c:pt>
                <c:pt idx="425">
                  <c:v>256.77100000000002</c:v>
                </c:pt>
                <c:pt idx="426">
                  <c:v>257.375</c:v>
                </c:pt>
                <c:pt idx="427">
                  <c:v>257.97899999999993</c:v>
                </c:pt>
                <c:pt idx="428">
                  <c:v>258.58300000000003</c:v>
                </c:pt>
                <c:pt idx="429">
                  <c:v>259.18799999999999</c:v>
                </c:pt>
                <c:pt idx="430">
                  <c:v>259.7919999999998</c:v>
                </c:pt>
                <c:pt idx="431">
                  <c:v>260.39600000000002</c:v>
                </c:pt>
                <c:pt idx="432">
                  <c:v>261</c:v>
                </c:pt>
                <c:pt idx="433">
                  <c:v>261.60399999999993</c:v>
                </c:pt>
                <c:pt idx="434">
                  <c:v>262.20800000000003</c:v>
                </c:pt>
                <c:pt idx="435">
                  <c:v>262.81299999999999</c:v>
                </c:pt>
                <c:pt idx="436">
                  <c:v>263.4169999999998</c:v>
                </c:pt>
                <c:pt idx="437">
                  <c:v>264.02100000000002</c:v>
                </c:pt>
                <c:pt idx="438">
                  <c:v>264.625</c:v>
                </c:pt>
                <c:pt idx="439">
                  <c:v>265.22899999999993</c:v>
                </c:pt>
                <c:pt idx="440">
                  <c:v>265.83300000000003</c:v>
                </c:pt>
                <c:pt idx="441">
                  <c:v>266.43799999999982</c:v>
                </c:pt>
                <c:pt idx="442">
                  <c:v>267.04199999999992</c:v>
                </c:pt>
                <c:pt idx="443">
                  <c:v>267.64600000000002</c:v>
                </c:pt>
                <c:pt idx="444">
                  <c:v>268.25</c:v>
                </c:pt>
                <c:pt idx="445">
                  <c:v>268.85399999999993</c:v>
                </c:pt>
                <c:pt idx="446">
                  <c:v>269.45800000000003</c:v>
                </c:pt>
                <c:pt idx="447">
                  <c:v>270.06299999999999</c:v>
                </c:pt>
                <c:pt idx="448">
                  <c:v>270.66699999999992</c:v>
                </c:pt>
                <c:pt idx="449">
                  <c:v>271.27100000000002</c:v>
                </c:pt>
                <c:pt idx="450">
                  <c:v>271.875</c:v>
                </c:pt>
                <c:pt idx="451">
                  <c:v>272.47899999999993</c:v>
                </c:pt>
                <c:pt idx="452">
                  <c:v>273.08300000000003</c:v>
                </c:pt>
                <c:pt idx="453">
                  <c:v>273.68799999999999</c:v>
                </c:pt>
                <c:pt idx="454">
                  <c:v>274.2919999999998</c:v>
                </c:pt>
                <c:pt idx="455">
                  <c:v>274.89600000000002</c:v>
                </c:pt>
                <c:pt idx="456">
                  <c:v>275.5</c:v>
                </c:pt>
                <c:pt idx="457">
                  <c:v>276.10399999999993</c:v>
                </c:pt>
                <c:pt idx="458">
                  <c:v>276.70800000000003</c:v>
                </c:pt>
                <c:pt idx="459">
                  <c:v>277.31299999999999</c:v>
                </c:pt>
                <c:pt idx="460">
                  <c:v>277.9169999999998</c:v>
                </c:pt>
                <c:pt idx="461">
                  <c:v>278.52100000000002</c:v>
                </c:pt>
                <c:pt idx="462">
                  <c:v>279.125</c:v>
                </c:pt>
                <c:pt idx="463">
                  <c:v>279.72899999999993</c:v>
                </c:pt>
                <c:pt idx="464">
                  <c:v>280.33300000000003</c:v>
                </c:pt>
                <c:pt idx="465">
                  <c:v>280.93799999999982</c:v>
                </c:pt>
                <c:pt idx="466">
                  <c:v>281.54199999999992</c:v>
                </c:pt>
                <c:pt idx="467">
                  <c:v>282.14600000000002</c:v>
                </c:pt>
                <c:pt idx="468">
                  <c:v>282.75</c:v>
                </c:pt>
                <c:pt idx="469">
                  <c:v>283.35399999999993</c:v>
                </c:pt>
                <c:pt idx="470">
                  <c:v>283.95800000000003</c:v>
                </c:pt>
                <c:pt idx="471">
                  <c:v>284.56299999999999</c:v>
                </c:pt>
                <c:pt idx="472">
                  <c:v>285.16699999999992</c:v>
                </c:pt>
                <c:pt idx="473">
                  <c:v>285.77100000000002</c:v>
                </c:pt>
                <c:pt idx="474">
                  <c:v>286.375</c:v>
                </c:pt>
                <c:pt idx="475">
                  <c:v>286.97899999999993</c:v>
                </c:pt>
                <c:pt idx="476">
                  <c:v>287.58300000000003</c:v>
                </c:pt>
                <c:pt idx="477">
                  <c:v>288.18799999999999</c:v>
                </c:pt>
                <c:pt idx="478">
                  <c:v>288.7919999999998</c:v>
                </c:pt>
                <c:pt idx="479">
                  <c:v>289.39600000000002</c:v>
                </c:pt>
                <c:pt idx="480">
                  <c:v>290</c:v>
                </c:pt>
                <c:pt idx="481">
                  <c:v>290.60399999999993</c:v>
                </c:pt>
                <c:pt idx="482">
                  <c:v>291.20800000000003</c:v>
                </c:pt>
                <c:pt idx="483">
                  <c:v>291.81299999999999</c:v>
                </c:pt>
                <c:pt idx="484">
                  <c:v>292.4169999999998</c:v>
                </c:pt>
                <c:pt idx="485">
                  <c:v>293.02100000000002</c:v>
                </c:pt>
                <c:pt idx="486">
                  <c:v>293.625</c:v>
                </c:pt>
                <c:pt idx="487">
                  <c:v>294.22899999999993</c:v>
                </c:pt>
                <c:pt idx="488">
                  <c:v>294.83300000000003</c:v>
                </c:pt>
                <c:pt idx="489">
                  <c:v>295.43799999999982</c:v>
                </c:pt>
                <c:pt idx="490">
                  <c:v>296.04199999999992</c:v>
                </c:pt>
                <c:pt idx="491">
                  <c:v>296.64600000000002</c:v>
                </c:pt>
                <c:pt idx="492">
                  <c:v>297.25</c:v>
                </c:pt>
                <c:pt idx="493">
                  <c:v>297.85399999999993</c:v>
                </c:pt>
                <c:pt idx="494">
                  <c:v>298.45800000000003</c:v>
                </c:pt>
                <c:pt idx="495">
                  <c:v>299.06299999999999</c:v>
                </c:pt>
                <c:pt idx="496">
                  <c:v>299.66699999999992</c:v>
                </c:pt>
                <c:pt idx="497">
                  <c:v>300.27100000000002</c:v>
                </c:pt>
                <c:pt idx="498">
                  <c:v>300.875</c:v>
                </c:pt>
                <c:pt idx="499">
                  <c:v>301.47899999999993</c:v>
                </c:pt>
                <c:pt idx="500">
                  <c:v>302.08300000000003</c:v>
                </c:pt>
                <c:pt idx="501">
                  <c:v>302.68799999999999</c:v>
                </c:pt>
                <c:pt idx="502">
                  <c:v>303.2919999999998</c:v>
                </c:pt>
                <c:pt idx="503">
                  <c:v>303.89600000000002</c:v>
                </c:pt>
                <c:pt idx="504">
                  <c:v>304.5</c:v>
                </c:pt>
                <c:pt idx="505">
                  <c:v>305.10399999999993</c:v>
                </c:pt>
                <c:pt idx="506">
                  <c:v>305.70800000000003</c:v>
                </c:pt>
                <c:pt idx="507">
                  <c:v>306.31299999999999</c:v>
                </c:pt>
                <c:pt idx="508">
                  <c:v>306.9169999999998</c:v>
                </c:pt>
                <c:pt idx="509">
                  <c:v>307.52100000000002</c:v>
                </c:pt>
                <c:pt idx="510">
                  <c:v>308.125</c:v>
                </c:pt>
                <c:pt idx="511">
                  <c:v>308.72899999999993</c:v>
                </c:pt>
                <c:pt idx="512">
                  <c:v>309.33300000000003</c:v>
                </c:pt>
                <c:pt idx="513">
                  <c:v>309.93799999999982</c:v>
                </c:pt>
                <c:pt idx="514">
                  <c:v>310.54199999999992</c:v>
                </c:pt>
                <c:pt idx="515">
                  <c:v>311.14600000000002</c:v>
                </c:pt>
                <c:pt idx="516">
                  <c:v>311.75</c:v>
                </c:pt>
                <c:pt idx="517">
                  <c:v>312.35399999999993</c:v>
                </c:pt>
                <c:pt idx="518">
                  <c:v>312.95800000000003</c:v>
                </c:pt>
                <c:pt idx="519">
                  <c:v>313.56299999999999</c:v>
                </c:pt>
                <c:pt idx="520">
                  <c:v>314.16699999999992</c:v>
                </c:pt>
                <c:pt idx="521">
                  <c:v>314.77100000000002</c:v>
                </c:pt>
                <c:pt idx="522">
                  <c:v>315.375</c:v>
                </c:pt>
                <c:pt idx="523">
                  <c:v>315.97899999999993</c:v>
                </c:pt>
                <c:pt idx="524">
                  <c:v>316.58300000000003</c:v>
                </c:pt>
                <c:pt idx="525">
                  <c:v>317.18799999999999</c:v>
                </c:pt>
                <c:pt idx="526">
                  <c:v>317.7919999999998</c:v>
                </c:pt>
                <c:pt idx="527">
                  <c:v>318.39600000000002</c:v>
                </c:pt>
                <c:pt idx="528">
                  <c:v>319</c:v>
                </c:pt>
                <c:pt idx="529">
                  <c:v>319.60399999999993</c:v>
                </c:pt>
                <c:pt idx="530">
                  <c:v>320.20800000000003</c:v>
                </c:pt>
                <c:pt idx="531">
                  <c:v>320.81299999999999</c:v>
                </c:pt>
                <c:pt idx="532">
                  <c:v>321.4169999999998</c:v>
                </c:pt>
                <c:pt idx="533">
                  <c:v>322.02100000000002</c:v>
                </c:pt>
                <c:pt idx="534">
                  <c:v>322.625</c:v>
                </c:pt>
                <c:pt idx="535">
                  <c:v>323.22899999999993</c:v>
                </c:pt>
                <c:pt idx="536">
                  <c:v>323.83300000000003</c:v>
                </c:pt>
                <c:pt idx="537">
                  <c:v>324.43799999999982</c:v>
                </c:pt>
                <c:pt idx="538">
                  <c:v>325.04199999999992</c:v>
                </c:pt>
                <c:pt idx="539">
                  <c:v>325.64600000000002</c:v>
                </c:pt>
                <c:pt idx="540">
                  <c:v>326.25</c:v>
                </c:pt>
                <c:pt idx="541">
                  <c:v>326.85399999999993</c:v>
                </c:pt>
                <c:pt idx="542">
                  <c:v>327.45800000000003</c:v>
                </c:pt>
                <c:pt idx="543">
                  <c:v>328.06299999999999</c:v>
                </c:pt>
                <c:pt idx="544">
                  <c:v>328.66699999999992</c:v>
                </c:pt>
                <c:pt idx="545">
                  <c:v>329.27100000000002</c:v>
                </c:pt>
                <c:pt idx="546">
                  <c:v>329.875</c:v>
                </c:pt>
                <c:pt idx="547">
                  <c:v>330.47899999999993</c:v>
                </c:pt>
                <c:pt idx="548">
                  <c:v>331.08300000000003</c:v>
                </c:pt>
                <c:pt idx="549">
                  <c:v>331.68799999999999</c:v>
                </c:pt>
                <c:pt idx="550">
                  <c:v>332.2919999999998</c:v>
                </c:pt>
                <c:pt idx="551">
                  <c:v>332.89600000000002</c:v>
                </c:pt>
                <c:pt idx="552">
                  <c:v>333.5</c:v>
                </c:pt>
                <c:pt idx="553">
                  <c:v>334.10399999999993</c:v>
                </c:pt>
                <c:pt idx="554">
                  <c:v>334.70800000000003</c:v>
                </c:pt>
                <c:pt idx="555">
                  <c:v>335.31299999999999</c:v>
                </c:pt>
                <c:pt idx="556">
                  <c:v>335.9169999999998</c:v>
                </c:pt>
                <c:pt idx="557">
                  <c:v>336.52100000000002</c:v>
                </c:pt>
                <c:pt idx="558">
                  <c:v>337.125</c:v>
                </c:pt>
                <c:pt idx="559">
                  <c:v>337.72899999999993</c:v>
                </c:pt>
                <c:pt idx="560">
                  <c:v>338.33300000000003</c:v>
                </c:pt>
                <c:pt idx="561">
                  <c:v>338.93799999999982</c:v>
                </c:pt>
                <c:pt idx="562">
                  <c:v>339.54199999999992</c:v>
                </c:pt>
                <c:pt idx="563">
                  <c:v>340.14600000000002</c:v>
                </c:pt>
                <c:pt idx="564">
                  <c:v>340.75</c:v>
                </c:pt>
                <c:pt idx="565">
                  <c:v>341.35399999999993</c:v>
                </c:pt>
                <c:pt idx="566">
                  <c:v>341.95800000000003</c:v>
                </c:pt>
                <c:pt idx="567">
                  <c:v>342.56299999999999</c:v>
                </c:pt>
                <c:pt idx="568">
                  <c:v>343.16699999999992</c:v>
                </c:pt>
                <c:pt idx="569">
                  <c:v>343.77100000000002</c:v>
                </c:pt>
                <c:pt idx="570">
                  <c:v>344.375</c:v>
                </c:pt>
                <c:pt idx="571">
                  <c:v>344.97899999999993</c:v>
                </c:pt>
                <c:pt idx="572">
                  <c:v>345.58300000000003</c:v>
                </c:pt>
                <c:pt idx="573">
                  <c:v>346.18799999999999</c:v>
                </c:pt>
                <c:pt idx="574">
                  <c:v>346.7919999999998</c:v>
                </c:pt>
                <c:pt idx="575">
                  <c:v>347.39600000000002</c:v>
                </c:pt>
                <c:pt idx="576">
                  <c:v>348</c:v>
                </c:pt>
                <c:pt idx="577">
                  <c:v>348.60399999999993</c:v>
                </c:pt>
                <c:pt idx="578">
                  <c:v>349.20800000000003</c:v>
                </c:pt>
                <c:pt idx="579">
                  <c:v>349.81299999999999</c:v>
                </c:pt>
                <c:pt idx="580">
                  <c:v>350.4169999999998</c:v>
                </c:pt>
                <c:pt idx="581">
                  <c:v>351.02100000000002</c:v>
                </c:pt>
                <c:pt idx="582">
                  <c:v>351.625</c:v>
                </c:pt>
                <c:pt idx="583">
                  <c:v>352.22899999999993</c:v>
                </c:pt>
                <c:pt idx="584">
                  <c:v>352.83300000000003</c:v>
                </c:pt>
                <c:pt idx="585">
                  <c:v>353.43799999999982</c:v>
                </c:pt>
                <c:pt idx="586">
                  <c:v>354.04199999999992</c:v>
                </c:pt>
                <c:pt idx="587">
                  <c:v>354.64600000000002</c:v>
                </c:pt>
                <c:pt idx="588">
                  <c:v>355.25</c:v>
                </c:pt>
                <c:pt idx="589">
                  <c:v>355.85399999999993</c:v>
                </c:pt>
                <c:pt idx="590">
                  <c:v>356.45800000000003</c:v>
                </c:pt>
                <c:pt idx="591">
                  <c:v>357.06299999999999</c:v>
                </c:pt>
                <c:pt idx="592">
                  <c:v>357.66699999999992</c:v>
                </c:pt>
                <c:pt idx="593">
                  <c:v>358.27100000000002</c:v>
                </c:pt>
                <c:pt idx="594">
                  <c:v>358.875</c:v>
                </c:pt>
                <c:pt idx="595">
                  <c:v>359.47899999999993</c:v>
                </c:pt>
                <c:pt idx="596">
                  <c:v>360.08300000000003</c:v>
                </c:pt>
                <c:pt idx="597">
                  <c:v>360.68799999999999</c:v>
                </c:pt>
                <c:pt idx="598">
                  <c:v>361.2919999999998</c:v>
                </c:pt>
                <c:pt idx="599">
                  <c:v>361.89600000000002</c:v>
                </c:pt>
                <c:pt idx="600">
                  <c:v>362.5</c:v>
                </c:pt>
                <c:pt idx="601">
                  <c:v>363.10399999999993</c:v>
                </c:pt>
                <c:pt idx="602">
                  <c:v>363.70800000000003</c:v>
                </c:pt>
                <c:pt idx="603">
                  <c:v>364.31299999999999</c:v>
                </c:pt>
                <c:pt idx="604">
                  <c:v>364.9169999999998</c:v>
                </c:pt>
                <c:pt idx="605">
                  <c:v>365.52100000000002</c:v>
                </c:pt>
                <c:pt idx="606">
                  <c:v>366.125</c:v>
                </c:pt>
                <c:pt idx="607">
                  <c:v>366.72899999999993</c:v>
                </c:pt>
                <c:pt idx="608">
                  <c:v>367.33300000000003</c:v>
                </c:pt>
                <c:pt idx="609">
                  <c:v>367.93799999999982</c:v>
                </c:pt>
                <c:pt idx="610">
                  <c:v>368.54199999999992</c:v>
                </c:pt>
                <c:pt idx="611">
                  <c:v>369.14600000000002</c:v>
                </c:pt>
                <c:pt idx="612">
                  <c:v>369.75</c:v>
                </c:pt>
                <c:pt idx="613">
                  <c:v>370.35399999999993</c:v>
                </c:pt>
                <c:pt idx="614">
                  <c:v>370.95800000000003</c:v>
                </c:pt>
                <c:pt idx="615">
                  <c:v>371.56299999999999</c:v>
                </c:pt>
                <c:pt idx="616">
                  <c:v>372.16699999999992</c:v>
                </c:pt>
                <c:pt idx="617">
                  <c:v>372.77100000000002</c:v>
                </c:pt>
                <c:pt idx="618">
                  <c:v>373.375</c:v>
                </c:pt>
                <c:pt idx="619">
                  <c:v>373.97899999999993</c:v>
                </c:pt>
                <c:pt idx="620">
                  <c:v>374.58300000000003</c:v>
                </c:pt>
                <c:pt idx="621">
                  <c:v>375.18799999999999</c:v>
                </c:pt>
                <c:pt idx="622">
                  <c:v>375.7919999999998</c:v>
                </c:pt>
                <c:pt idx="623">
                  <c:v>376.39600000000002</c:v>
                </c:pt>
                <c:pt idx="624">
                  <c:v>377</c:v>
                </c:pt>
                <c:pt idx="625">
                  <c:v>377.60399999999993</c:v>
                </c:pt>
                <c:pt idx="626">
                  <c:v>378.20800000000003</c:v>
                </c:pt>
                <c:pt idx="627">
                  <c:v>378.81299999999999</c:v>
                </c:pt>
                <c:pt idx="628">
                  <c:v>379.4169999999998</c:v>
                </c:pt>
                <c:pt idx="629">
                  <c:v>380.02100000000002</c:v>
                </c:pt>
                <c:pt idx="630">
                  <c:v>380.625</c:v>
                </c:pt>
                <c:pt idx="631">
                  <c:v>381.22899999999993</c:v>
                </c:pt>
                <c:pt idx="632">
                  <c:v>381.83300000000003</c:v>
                </c:pt>
                <c:pt idx="633">
                  <c:v>382.43799999999982</c:v>
                </c:pt>
                <c:pt idx="634">
                  <c:v>383.04199999999992</c:v>
                </c:pt>
                <c:pt idx="635">
                  <c:v>383.64600000000002</c:v>
                </c:pt>
                <c:pt idx="636">
                  <c:v>384.25</c:v>
                </c:pt>
                <c:pt idx="637">
                  <c:v>384.85399999999993</c:v>
                </c:pt>
                <c:pt idx="638">
                  <c:v>385.45800000000003</c:v>
                </c:pt>
                <c:pt idx="639">
                  <c:v>386.06299999999999</c:v>
                </c:pt>
                <c:pt idx="640">
                  <c:v>386.66699999999992</c:v>
                </c:pt>
                <c:pt idx="641">
                  <c:v>387.27100000000002</c:v>
                </c:pt>
                <c:pt idx="642">
                  <c:v>387.875</c:v>
                </c:pt>
                <c:pt idx="643">
                  <c:v>388.47899999999993</c:v>
                </c:pt>
                <c:pt idx="644">
                  <c:v>389.08300000000003</c:v>
                </c:pt>
                <c:pt idx="645">
                  <c:v>389.68799999999999</c:v>
                </c:pt>
                <c:pt idx="646">
                  <c:v>390.2919999999998</c:v>
                </c:pt>
                <c:pt idx="647">
                  <c:v>390.89600000000002</c:v>
                </c:pt>
                <c:pt idx="648">
                  <c:v>391.5</c:v>
                </c:pt>
                <c:pt idx="649">
                  <c:v>392.10399999999993</c:v>
                </c:pt>
                <c:pt idx="650">
                  <c:v>392.70800000000003</c:v>
                </c:pt>
                <c:pt idx="651">
                  <c:v>393.31299999999999</c:v>
                </c:pt>
                <c:pt idx="652">
                  <c:v>393.9169999999998</c:v>
                </c:pt>
                <c:pt idx="653">
                  <c:v>394.52100000000002</c:v>
                </c:pt>
                <c:pt idx="654">
                  <c:v>395.125</c:v>
                </c:pt>
                <c:pt idx="655">
                  <c:v>395.72899999999993</c:v>
                </c:pt>
                <c:pt idx="656">
                  <c:v>396.33300000000003</c:v>
                </c:pt>
                <c:pt idx="657">
                  <c:v>396.93799999999982</c:v>
                </c:pt>
                <c:pt idx="658">
                  <c:v>397.54199999999992</c:v>
                </c:pt>
                <c:pt idx="659">
                  <c:v>398.14600000000002</c:v>
                </c:pt>
                <c:pt idx="660">
                  <c:v>398.75</c:v>
                </c:pt>
                <c:pt idx="661">
                  <c:v>399.35399999999993</c:v>
                </c:pt>
                <c:pt idx="662">
                  <c:v>399.95800000000003</c:v>
                </c:pt>
                <c:pt idx="663">
                  <c:v>400.56299999999999</c:v>
                </c:pt>
                <c:pt idx="664">
                  <c:v>401.16699999999992</c:v>
                </c:pt>
                <c:pt idx="665">
                  <c:v>401.77100000000002</c:v>
                </c:pt>
                <c:pt idx="666">
                  <c:v>402.375</c:v>
                </c:pt>
                <c:pt idx="667">
                  <c:v>402.97899999999993</c:v>
                </c:pt>
                <c:pt idx="668">
                  <c:v>403.58300000000003</c:v>
                </c:pt>
                <c:pt idx="669">
                  <c:v>404.18799999999999</c:v>
                </c:pt>
                <c:pt idx="670">
                  <c:v>404.7919999999998</c:v>
                </c:pt>
                <c:pt idx="671">
                  <c:v>405.39600000000002</c:v>
                </c:pt>
                <c:pt idx="672">
                  <c:v>406</c:v>
                </c:pt>
                <c:pt idx="673">
                  <c:v>406.60399999999993</c:v>
                </c:pt>
                <c:pt idx="674">
                  <c:v>407.20800000000003</c:v>
                </c:pt>
                <c:pt idx="675">
                  <c:v>407.81299999999999</c:v>
                </c:pt>
                <c:pt idx="676">
                  <c:v>408.4169999999998</c:v>
                </c:pt>
                <c:pt idx="677">
                  <c:v>409.02100000000002</c:v>
                </c:pt>
                <c:pt idx="678">
                  <c:v>409.625</c:v>
                </c:pt>
                <c:pt idx="679">
                  <c:v>410.22899999999993</c:v>
                </c:pt>
                <c:pt idx="680">
                  <c:v>410.83300000000003</c:v>
                </c:pt>
                <c:pt idx="681">
                  <c:v>411.43799999999982</c:v>
                </c:pt>
                <c:pt idx="682">
                  <c:v>412.04199999999992</c:v>
                </c:pt>
                <c:pt idx="683">
                  <c:v>412.64600000000002</c:v>
                </c:pt>
                <c:pt idx="684">
                  <c:v>413.25</c:v>
                </c:pt>
                <c:pt idx="685">
                  <c:v>413.85399999999993</c:v>
                </c:pt>
                <c:pt idx="686">
                  <c:v>414.45800000000003</c:v>
                </c:pt>
                <c:pt idx="687">
                  <c:v>415.06299999999999</c:v>
                </c:pt>
                <c:pt idx="688">
                  <c:v>415.66699999999992</c:v>
                </c:pt>
                <c:pt idx="689">
                  <c:v>416.27100000000002</c:v>
                </c:pt>
                <c:pt idx="690">
                  <c:v>416.875</c:v>
                </c:pt>
                <c:pt idx="691">
                  <c:v>417.47899999999993</c:v>
                </c:pt>
                <c:pt idx="692">
                  <c:v>418.08300000000003</c:v>
                </c:pt>
                <c:pt idx="693">
                  <c:v>418.68799999999999</c:v>
                </c:pt>
                <c:pt idx="694">
                  <c:v>419.2919999999998</c:v>
                </c:pt>
                <c:pt idx="695">
                  <c:v>419.89600000000002</c:v>
                </c:pt>
                <c:pt idx="696">
                  <c:v>420.5</c:v>
                </c:pt>
                <c:pt idx="697">
                  <c:v>421.10399999999993</c:v>
                </c:pt>
                <c:pt idx="698">
                  <c:v>421.70800000000003</c:v>
                </c:pt>
                <c:pt idx="699">
                  <c:v>422.31299999999999</c:v>
                </c:pt>
                <c:pt idx="700">
                  <c:v>422.9169999999998</c:v>
                </c:pt>
                <c:pt idx="701">
                  <c:v>423.52100000000002</c:v>
                </c:pt>
                <c:pt idx="702">
                  <c:v>424.125</c:v>
                </c:pt>
                <c:pt idx="703">
                  <c:v>424.72899999999993</c:v>
                </c:pt>
                <c:pt idx="704">
                  <c:v>425.33300000000003</c:v>
                </c:pt>
                <c:pt idx="705">
                  <c:v>425.93799999999982</c:v>
                </c:pt>
                <c:pt idx="706">
                  <c:v>426.54199999999992</c:v>
                </c:pt>
                <c:pt idx="707">
                  <c:v>427.14600000000002</c:v>
                </c:pt>
                <c:pt idx="708">
                  <c:v>427.75</c:v>
                </c:pt>
                <c:pt idx="709">
                  <c:v>428.35399999999993</c:v>
                </c:pt>
                <c:pt idx="710">
                  <c:v>428.95800000000003</c:v>
                </c:pt>
                <c:pt idx="711">
                  <c:v>429.56299999999999</c:v>
                </c:pt>
                <c:pt idx="712">
                  <c:v>430.16699999999992</c:v>
                </c:pt>
                <c:pt idx="713">
                  <c:v>430.77100000000002</c:v>
                </c:pt>
                <c:pt idx="714">
                  <c:v>431.375</c:v>
                </c:pt>
                <c:pt idx="715">
                  <c:v>431.97899999999993</c:v>
                </c:pt>
                <c:pt idx="716">
                  <c:v>432.58300000000003</c:v>
                </c:pt>
                <c:pt idx="717">
                  <c:v>433.18799999999999</c:v>
                </c:pt>
                <c:pt idx="718">
                  <c:v>433.7919999999998</c:v>
                </c:pt>
                <c:pt idx="719">
                  <c:v>434.39600000000002</c:v>
                </c:pt>
                <c:pt idx="720">
                  <c:v>435</c:v>
                </c:pt>
                <c:pt idx="721">
                  <c:v>435.60399999999993</c:v>
                </c:pt>
                <c:pt idx="722">
                  <c:v>436.20800000000003</c:v>
                </c:pt>
                <c:pt idx="723">
                  <c:v>436.81299999999999</c:v>
                </c:pt>
                <c:pt idx="724">
                  <c:v>437.4169999999998</c:v>
                </c:pt>
                <c:pt idx="725">
                  <c:v>438.02100000000002</c:v>
                </c:pt>
                <c:pt idx="726">
                  <c:v>438.625</c:v>
                </c:pt>
                <c:pt idx="727">
                  <c:v>439.22899999999993</c:v>
                </c:pt>
                <c:pt idx="728">
                  <c:v>439.83300000000003</c:v>
                </c:pt>
                <c:pt idx="729">
                  <c:v>440.43799999999982</c:v>
                </c:pt>
                <c:pt idx="730">
                  <c:v>441.04199999999992</c:v>
                </c:pt>
                <c:pt idx="731">
                  <c:v>441.64600000000002</c:v>
                </c:pt>
                <c:pt idx="732">
                  <c:v>442.25</c:v>
                </c:pt>
                <c:pt idx="733">
                  <c:v>442.85399999999993</c:v>
                </c:pt>
                <c:pt idx="734">
                  <c:v>443.45800000000003</c:v>
                </c:pt>
                <c:pt idx="735">
                  <c:v>444.06299999999999</c:v>
                </c:pt>
                <c:pt idx="736">
                  <c:v>444.66699999999992</c:v>
                </c:pt>
                <c:pt idx="737">
                  <c:v>445.27100000000002</c:v>
                </c:pt>
                <c:pt idx="738">
                  <c:v>445.875</c:v>
                </c:pt>
                <c:pt idx="739">
                  <c:v>446.47899999999993</c:v>
                </c:pt>
                <c:pt idx="740">
                  <c:v>447.08300000000003</c:v>
                </c:pt>
                <c:pt idx="741">
                  <c:v>447.68799999999999</c:v>
                </c:pt>
                <c:pt idx="742">
                  <c:v>448.2919999999998</c:v>
                </c:pt>
                <c:pt idx="743">
                  <c:v>448.89600000000002</c:v>
                </c:pt>
                <c:pt idx="744">
                  <c:v>449.5</c:v>
                </c:pt>
                <c:pt idx="745">
                  <c:v>450.10399999999993</c:v>
                </c:pt>
                <c:pt idx="746">
                  <c:v>450.70800000000003</c:v>
                </c:pt>
                <c:pt idx="747">
                  <c:v>451.31299999999999</c:v>
                </c:pt>
                <c:pt idx="748">
                  <c:v>451.9169999999998</c:v>
                </c:pt>
                <c:pt idx="749">
                  <c:v>452.52100000000002</c:v>
                </c:pt>
                <c:pt idx="750">
                  <c:v>453.125</c:v>
                </c:pt>
                <c:pt idx="751">
                  <c:v>453.72899999999993</c:v>
                </c:pt>
                <c:pt idx="752">
                  <c:v>454.33300000000003</c:v>
                </c:pt>
                <c:pt idx="753">
                  <c:v>454.93799999999982</c:v>
                </c:pt>
                <c:pt idx="754">
                  <c:v>455.54199999999992</c:v>
                </c:pt>
                <c:pt idx="755">
                  <c:v>456.14600000000002</c:v>
                </c:pt>
                <c:pt idx="756">
                  <c:v>456.75</c:v>
                </c:pt>
                <c:pt idx="757">
                  <c:v>457.35399999999993</c:v>
                </c:pt>
                <c:pt idx="758">
                  <c:v>457.95800000000003</c:v>
                </c:pt>
                <c:pt idx="759">
                  <c:v>458.56299999999999</c:v>
                </c:pt>
                <c:pt idx="760">
                  <c:v>459.16699999999992</c:v>
                </c:pt>
                <c:pt idx="761">
                  <c:v>459.77100000000002</c:v>
                </c:pt>
                <c:pt idx="762">
                  <c:v>460.375</c:v>
                </c:pt>
                <c:pt idx="763">
                  <c:v>460.97899999999993</c:v>
                </c:pt>
                <c:pt idx="764">
                  <c:v>461.58300000000003</c:v>
                </c:pt>
                <c:pt idx="765">
                  <c:v>462.18799999999999</c:v>
                </c:pt>
                <c:pt idx="766">
                  <c:v>462.7919999999998</c:v>
                </c:pt>
                <c:pt idx="767">
                  <c:v>463.39600000000002</c:v>
                </c:pt>
                <c:pt idx="768">
                  <c:v>464</c:v>
                </c:pt>
                <c:pt idx="769">
                  <c:v>464.60399999999993</c:v>
                </c:pt>
                <c:pt idx="770">
                  <c:v>465.20800000000003</c:v>
                </c:pt>
                <c:pt idx="771">
                  <c:v>465.81299999999999</c:v>
                </c:pt>
                <c:pt idx="772">
                  <c:v>466.4169999999998</c:v>
                </c:pt>
                <c:pt idx="773">
                  <c:v>467.02100000000002</c:v>
                </c:pt>
                <c:pt idx="774">
                  <c:v>467.625</c:v>
                </c:pt>
                <c:pt idx="775">
                  <c:v>468.22899999999993</c:v>
                </c:pt>
                <c:pt idx="776">
                  <c:v>468.83300000000003</c:v>
                </c:pt>
                <c:pt idx="777">
                  <c:v>469.43799999999982</c:v>
                </c:pt>
                <c:pt idx="778">
                  <c:v>470.04199999999992</c:v>
                </c:pt>
                <c:pt idx="779">
                  <c:v>470.64600000000002</c:v>
                </c:pt>
                <c:pt idx="780">
                  <c:v>471.25</c:v>
                </c:pt>
                <c:pt idx="781">
                  <c:v>471.85399999999993</c:v>
                </c:pt>
                <c:pt idx="782">
                  <c:v>472.45800000000003</c:v>
                </c:pt>
                <c:pt idx="783">
                  <c:v>473.06299999999999</c:v>
                </c:pt>
                <c:pt idx="784">
                  <c:v>473.66699999999992</c:v>
                </c:pt>
                <c:pt idx="785">
                  <c:v>474.27100000000002</c:v>
                </c:pt>
                <c:pt idx="786">
                  <c:v>474.875</c:v>
                </c:pt>
                <c:pt idx="787">
                  <c:v>475.47899999999993</c:v>
                </c:pt>
                <c:pt idx="788">
                  <c:v>476.08300000000003</c:v>
                </c:pt>
                <c:pt idx="789">
                  <c:v>476.68799999999999</c:v>
                </c:pt>
                <c:pt idx="790">
                  <c:v>477.2919999999998</c:v>
                </c:pt>
                <c:pt idx="791">
                  <c:v>477.89600000000002</c:v>
                </c:pt>
                <c:pt idx="792">
                  <c:v>478.5</c:v>
                </c:pt>
                <c:pt idx="793">
                  <c:v>479.10399999999993</c:v>
                </c:pt>
                <c:pt idx="794">
                  <c:v>479.70800000000003</c:v>
                </c:pt>
                <c:pt idx="795">
                  <c:v>480.31299999999999</c:v>
                </c:pt>
                <c:pt idx="796">
                  <c:v>480.9169999999998</c:v>
                </c:pt>
                <c:pt idx="797">
                  <c:v>481.52100000000002</c:v>
                </c:pt>
                <c:pt idx="798">
                  <c:v>482.125</c:v>
                </c:pt>
                <c:pt idx="799">
                  <c:v>482.72899999999993</c:v>
                </c:pt>
                <c:pt idx="800">
                  <c:v>483.33300000000003</c:v>
                </c:pt>
                <c:pt idx="801">
                  <c:v>483.93799999999982</c:v>
                </c:pt>
                <c:pt idx="802">
                  <c:v>484.54199999999992</c:v>
                </c:pt>
                <c:pt idx="803">
                  <c:v>485.14600000000002</c:v>
                </c:pt>
                <c:pt idx="804">
                  <c:v>485.75</c:v>
                </c:pt>
                <c:pt idx="805">
                  <c:v>486.35399999999993</c:v>
                </c:pt>
                <c:pt idx="806">
                  <c:v>486.95800000000003</c:v>
                </c:pt>
                <c:pt idx="807">
                  <c:v>487.56299999999999</c:v>
                </c:pt>
                <c:pt idx="808">
                  <c:v>488.16699999999992</c:v>
                </c:pt>
                <c:pt idx="809">
                  <c:v>488.77100000000002</c:v>
                </c:pt>
                <c:pt idx="810">
                  <c:v>489.375</c:v>
                </c:pt>
                <c:pt idx="811">
                  <c:v>489.97899999999993</c:v>
                </c:pt>
                <c:pt idx="812">
                  <c:v>490.58300000000003</c:v>
                </c:pt>
                <c:pt idx="813">
                  <c:v>491.18799999999999</c:v>
                </c:pt>
                <c:pt idx="814">
                  <c:v>491.7919999999998</c:v>
                </c:pt>
                <c:pt idx="815">
                  <c:v>492.39600000000002</c:v>
                </c:pt>
                <c:pt idx="816">
                  <c:v>493</c:v>
                </c:pt>
                <c:pt idx="817">
                  <c:v>493.60399999999993</c:v>
                </c:pt>
                <c:pt idx="818">
                  <c:v>494.20800000000003</c:v>
                </c:pt>
                <c:pt idx="819">
                  <c:v>494.81299999999999</c:v>
                </c:pt>
                <c:pt idx="820">
                  <c:v>495.4169999999998</c:v>
                </c:pt>
                <c:pt idx="821">
                  <c:v>496.02100000000002</c:v>
                </c:pt>
                <c:pt idx="822">
                  <c:v>496.625</c:v>
                </c:pt>
                <c:pt idx="823">
                  <c:v>497.22899999999993</c:v>
                </c:pt>
                <c:pt idx="824">
                  <c:v>497.83300000000003</c:v>
                </c:pt>
                <c:pt idx="825">
                  <c:v>498.43799999999982</c:v>
                </c:pt>
                <c:pt idx="826">
                  <c:v>499.04199999999992</c:v>
                </c:pt>
                <c:pt idx="827">
                  <c:v>499.64600000000002</c:v>
                </c:pt>
                <c:pt idx="828">
                  <c:v>500.25</c:v>
                </c:pt>
                <c:pt idx="829">
                  <c:v>500.85399999999993</c:v>
                </c:pt>
                <c:pt idx="830">
                  <c:v>501.45800000000003</c:v>
                </c:pt>
                <c:pt idx="831">
                  <c:v>502.06299999999999</c:v>
                </c:pt>
                <c:pt idx="832">
                  <c:v>502.66699999999992</c:v>
                </c:pt>
                <c:pt idx="833">
                  <c:v>503.27100000000002</c:v>
                </c:pt>
                <c:pt idx="834">
                  <c:v>503.875</c:v>
                </c:pt>
                <c:pt idx="835">
                  <c:v>504.47899999999993</c:v>
                </c:pt>
                <c:pt idx="836">
                  <c:v>505.08300000000003</c:v>
                </c:pt>
                <c:pt idx="837">
                  <c:v>505.68799999999999</c:v>
                </c:pt>
                <c:pt idx="838">
                  <c:v>506.2919999999998</c:v>
                </c:pt>
                <c:pt idx="839">
                  <c:v>506.89600000000002</c:v>
                </c:pt>
                <c:pt idx="840">
                  <c:v>507.5</c:v>
                </c:pt>
                <c:pt idx="841">
                  <c:v>508.10399999999993</c:v>
                </c:pt>
                <c:pt idx="842">
                  <c:v>508.70800000000003</c:v>
                </c:pt>
                <c:pt idx="843">
                  <c:v>509.31299999999999</c:v>
                </c:pt>
                <c:pt idx="844">
                  <c:v>509.9169999999998</c:v>
                </c:pt>
                <c:pt idx="845">
                  <c:v>510.52100000000002</c:v>
                </c:pt>
                <c:pt idx="846">
                  <c:v>511.125</c:v>
                </c:pt>
                <c:pt idx="847">
                  <c:v>511.72899999999993</c:v>
                </c:pt>
                <c:pt idx="848">
                  <c:v>512.33299999999974</c:v>
                </c:pt>
                <c:pt idx="849">
                  <c:v>512.93799999999976</c:v>
                </c:pt>
                <c:pt idx="850">
                  <c:v>513.5419999999998</c:v>
                </c:pt>
                <c:pt idx="851">
                  <c:v>514.14599999999996</c:v>
                </c:pt>
                <c:pt idx="852">
                  <c:v>514.75</c:v>
                </c:pt>
                <c:pt idx="853">
                  <c:v>515.35399999999981</c:v>
                </c:pt>
                <c:pt idx="854">
                  <c:v>515.95799999999974</c:v>
                </c:pt>
                <c:pt idx="855">
                  <c:v>516.56299999999976</c:v>
                </c:pt>
                <c:pt idx="856">
                  <c:v>517.1669999999998</c:v>
                </c:pt>
                <c:pt idx="857">
                  <c:v>517.77099999999996</c:v>
                </c:pt>
                <c:pt idx="858">
                  <c:v>518.375</c:v>
                </c:pt>
                <c:pt idx="859">
                  <c:v>518.97900000000004</c:v>
                </c:pt>
                <c:pt idx="860">
                  <c:v>519.58299999999997</c:v>
                </c:pt>
                <c:pt idx="861">
                  <c:v>520.18799999999999</c:v>
                </c:pt>
                <c:pt idx="862">
                  <c:v>520.79200000000003</c:v>
                </c:pt>
                <c:pt idx="863">
                  <c:v>521.39599999999996</c:v>
                </c:pt>
                <c:pt idx="864">
                  <c:v>522</c:v>
                </c:pt>
                <c:pt idx="865">
                  <c:v>522.60400000000004</c:v>
                </c:pt>
                <c:pt idx="866">
                  <c:v>523.20799999999997</c:v>
                </c:pt>
                <c:pt idx="867">
                  <c:v>523.81299999999976</c:v>
                </c:pt>
                <c:pt idx="868">
                  <c:v>524.4169999999998</c:v>
                </c:pt>
                <c:pt idx="869">
                  <c:v>525.02099999999996</c:v>
                </c:pt>
                <c:pt idx="870">
                  <c:v>525.625</c:v>
                </c:pt>
                <c:pt idx="871">
                  <c:v>526.22900000000004</c:v>
                </c:pt>
                <c:pt idx="872">
                  <c:v>526.83299999999974</c:v>
                </c:pt>
                <c:pt idx="873">
                  <c:v>527.43799999999976</c:v>
                </c:pt>
                <c:pt idx="874">
                  <c:v>528.0419999999998</c:v>
                </c:pt>
                <c:pt idx="875">
                  <c:v>528.64599999999996</c:v>
                </c:pt>
                <c:pt idx="876">
                  <c:v>529.25</c:v>
                </c:pt>
                <c:pt idx="877">
                  <c:v>529.85399999999981</c:v>
                </c:pt>
                <c:pt idx="878">
                  <c:v>530.45799999999974</c:v>
                </c:pt>
                <c:pt idx="879">
                  <c:v>531.06299999999976</c:v>
                </c:pt>
                <c:pt idx="880">
                  <c:v>531.6669999999998</c:v>
                </c:pt>
                <c:pt idx="881">
                  <c:v>532.27099999999996</c:v>
                </c:pt>
                <c:pt idx="882">
                  <c:v>532.875</c:v>
                </c:pt>
                <c:pt idx="883">
                  <c:v>533.47900000000004</c:v>
                </c:pt>
                <c:pt idx="884">
                  <c:v>534.08299999999997</c:v>
                </c:pt>
                <c:pt idx="885">
                  <c:v>534.68799999999999</c:v>
                </c:pt>
                <c:pt idx="886">
                  <c:v>535.29200000000003</c:v>
                </c:pt>
                <c:pt idx="887">
                  <c:v>535.89599999999996</c:v>
                </c:pt>
                <c:pt idx="888">
                  <c:v>536.5</c:v>
                </c:pt>
                <c:pt idx="889">
                  <c:v>537.10400000000004</c:v>
                </c:pt>
                <c:pt idx="890">
                  <c:v>537.70799999999997</c:v>
                </c:pt>
                <c:pt idx="891">
                  <c:v>538.31299999999976</c:v>
                </c:pt>
                <c:pt idx="892">
                  <c:v>538.9169999999998</c:v>
                </c:pt>
                <c:pt idx="893">
                  <c:v>539.52099999999996</c:v>
                </c:pt>
                <c:pt idx="894">
                  <c:v>540.125</c:v>
                </c:pt>
                <c:pt idx="895">
                  <c:v>540.72900000000004</c:v>
                </c:pt>
                <c:pt idx="896">
                  <c:v>541.33299999999974</c:v>
                </c:pt>
                <c:pt idx="897">
                  <c:v>541.93799999999976</c:v>
                </c:pt>
                <c:pt idx="898">
                  <c:v>542.5419999999998</c:v>
                </c:pt>
                <c:pt idx="899">
                  <c:v>543.14599999999996</c:v>
                </c:pt>
                <c:pt idx="900">
                  <c:v>543.75</c:v>
                </c:pt>
                <c:pt idx="901">
                  <c:v>544.35399999999981</c:v>
                </c:pt>
                <c:pt idx="902">
                  <c:v>544.95799999999974</c:v>
                </c:pt>
                <c:pt idx="903">
                  <c:v>545.56299999999976</c:v>
                </c:pt>
                <c:pt idx="904">
                  <c:v>546.1669999999998</c:v>
                </c:pt>
                <c:pt idx="905">
                  <c:v>546.77099999999996</c:v>
                </c:pt>
                <c:pt idx="906">
                  <c:v>547.375</c:v>
                </c:pt>
                <c:pt idx="907">
                  <c:v>547.97900000000004</c:v>
                </c:pt>
                <c:pt idx="908">
                  <c:v>548.58299999999997</c:v>
                </c:pt>
                <c:pt idx="909">
                  <c:v>549.18799999999999</c:v>
                </c:pt>
                <c:pt idx="910">
                  <c:v>549.79200000000003</c:v>
                </c:pt>
                <c:pt idx="911">
                  <c:v>550.39599999999996</c:v>
                </c:pt>
                <c:pt idx="912">
                  <c:v>551</c:v>
                </c:pt>
                <c:pt idx="913">
                  <c:v>551.60400000000004</c:v>
                </c:pt>
                <c:pt idx="914">
                  <c:v>552.20799999999997</c:v>
                </c:pt>
                <c:pt idx="915">
                  <c:v>552.81299999999976</c:v>
                </c:pt>
                <c:pt idx="916">
                  <c:v>553.4169999999998</c:v>
                </c:pt>
                <c:pt idx="917">
                  <c:v>554.02099999999996</c:v>
                </c:pt>
                <c:pt idx="918">
                  <c:v>554.625</c:v>
                </c:pt>
                <c:pt idx="919">
                  <c:v>555.22900000000004</c:v>
                </c:pt>
                <c:pt idx="920">
                  <c:v>555.83299999999974</c:v>
                </c:pt>
                <c:pt idx="921">
                  <c:v>556.43799999999976</c:v>
                </c:pt>
                <c:pt idx="922">
                  <c:v>557.0419999999998</c:v>
                </c:pt>
                <c:pt idx="923">
                  <c:v>557.64599999999996</c:v>
                </c:pt>
                <c:pt idx="924">
                  <c:v>558.25</c:v>
                </c:pt>
                <c:pt idx="925">
                  <c:v>558.85399999999981</c:v>
                </c:pt>
                <c:pt idx="926">
                  <c:v>559.45799999999974</c:v>
                </c:pt>
                <c:pt idx="927">
                  <c:v>560.06299999999976</c:v>
                </c:pt>
                <c:pt idx="928">
                  <c:v>560.6669999999998</c:v>
                </c:pt>
                <c:pt idx="929">
                  <c:v>561.27099999999996</c:v>
                </c:pt>
                <c:pt idx="930">
                  <c:v>561.875</c:v>
                </c:pt>
                <c:pt idx="931">
                  <c:v>562.47900000000004</c:v>
                </c:pt>
                <c:pt idx="932">
                  <c:v>563.08299999999997</c:v>
                </c:pt>
                <c:pt idx="933">
                  <c:v>563.68799999999999</c:v>
                </c:pt>
                <c:pt idx="934">
                  <c:v>564.29200000000003</c:v>
                </c:pt>
                <c:pt idx="935">
                  <c:v>564.89599999999996</c:v>
                </c:pt>
                <c:pt idx="936">
                  <c:v>565.5</c:v>
                </c:pt>
                <c:pt idx="937">
                  <c:v>566.10400000000004</c:v>
                </c:pt>
                <c:pt idx="938">
                  <c:v>566.70799999999997</c:v>
                </c:pt>
                <c:pt idx="939">
                  <c:v>567.31299999999976</c:v>
                </c:pt>
                <c:pt idx="940">
                  <c:v>567.9169999999998</c:v>
                </c:pt>
                <c:pt idx="941">
                  <c:v>568.52099999999996</c:v>
                </c:pt>
                <c:pt idx="942">
                  <c:v>569.125</c:v>
                </c:pt>
                <c:pt idx="943">
                  <c:v>569.72900000000004</c:v>
                </c:pt>
                <c:pt idx="944">
                  <c:v>570.33299999999974</c:v>
                </c:pt>
                <c:pt idx="945">
                  <c:v>570.93799999999976</c:v>
                </c:pt>
                <c:pt idx="946">
                  <c:v>571.5419999999998</c:v>
                </c:pt>
                <c:pt idx="947">
                  <c:v>572.14599999999996</c:v>
                </c:pt>
                <c:pt idx="948">
                  <c:v>572.75</c:v>
                </c:pt>
                <c:pt idx="949">
                  <c:v>573.35399999999981</c:v>
                </c:pt>
                <c:pt idx="950">
                  <c:v>573.95799999999974</c:v>
                </c:pt>
                <c:pt idx="951">
                  <c:v>574.56299999999976</c:v>
                </c:pt>
                <c:pt idx="952">
                  <c:v>575.1669999999998</c:v>
                </c:pt>
                <c:pt idx="953">
                  <c:v>575.77099999999996</c:v>
                </c:pt>
                <c:pt idx="954">
                  <c:v>576.375</c:v>
                </c:pt>
                <c:pt idx="955">
                  <c:v>576.97900000000004</c:v>
                </c:pt>
                <c:pt idx="956">
                  <c:v>577.58299999999997</c:v>
                </c:pt>
                <c:pt idx="957">
                  <c:v>578.18799999999999</c:v>
                </c:pt>
                <c:pt idx="958">
                  <c:v>578.79200000000003</c:v>
                </c:pt>
                <c:pt idx="959">
                  <c:v>579.39599999999996</c:v>
                </c:pt>
                <c:pt idx="960">
                  <c:v>580</c:v>
                </c:pt>
                <c:pt idx="961">
                  <c:v>580.60400000000004</c:v>
                </c:pt>
                <c:pt idx="962">
                  <c:v>581.20799999999997</c:v>
                </c:pt>
                <c:pt idx="963">
                  <c:v>581.81299999999976</c:v>
                </c:pt>
                <c:pt idx="964">
                  <c:v>582.4169999999998</c:v>
                </c:pt>
                <c:pt idx="965">
                  <c:v>583.02099999999996</c:v>
                </c:pt>
                <c:pt idx="966">
                  <c:v>583.625</c:v>
                </c:pt>
                <c:pt idx="967">
                  <c:v>584.22900000000004</c:v>
                </c:pt>
                <c:pt idx="968">
                  <c:v>584.83299999999974</c:v>
                </c:pt>
                <c:pt idx="969">
                  <c:v>585.43799999999976</c:v>
                </c:pt>
                <c:pt idx="970">
                  <c:v>586.0419999999998</c:v>
                </c:pt>
                <c:pt idx="971">
                  <c:v>586.64599999999996</c:v>
                </c:pt>
                <c:pt idx="972">
                  <c:v>587.25</c:v>
                </c:pt>
                <c:pt idx="973">
                  <c:v>587.85399999999981</c:v>
                </c:pt>
                <c:pt idx="974">
                  <c:v>588.45799999999974</c:v>
                </c:pt>
                <c:pt idx="975">
                  <c:v>589.06299999999976</c:v>
                </c:pt>
                <c:pt idx="976">
                  <c:v>589.6669999999998</c:v>
                </c:pt>
                <c:pt idx="977">
                  <c:v>590.27099999999996</c:v>
                </c:pt>
                <c:pt idx="978">
                  <c:v>590.875</c:v>
                </c:pt>
                <c:pt idx="979">
                  <c:v>591.47900000000004</c:v>
                </c:pt>
                <c:pt idx="980">
                  <c:v>592.08299999999997</c:v>
                </c:pt>
                <c:pt idx="981">
                  <c:v>592.68799999999999</c:v>
                </c:pt>
                <c:pt idx="982">
                  <c:v>593.29200000000003</c:v>
                </c:pt>
                <c:pt idx="983">
                  <c:v>593.89599999999996</c:v>
                </c:pt>
                <c:pt idx="984">
                  <c:v>594.5</c:v>
                </c:pt>
                <c:pt idx="985">
                  <c:v>595.10400000000004</c:v>
                </c:pt>
                <c:pt idx="986">
                  <c:v>595.70799999999997</c:v>
                </c:pt>
                <c:pt idx="987">
                  <c:v>596.31299999999976</c:v>
                </c:pt>
                <c:pt idx="988">
                  <c:v>596.9169999999998</c:v>
                </c:pt>
                <c:pt idx="989">
                  <c:v>597.52099999999996</c:v>
                </c:pt>
                <c:pt idx="990">
                  <c:v>598.125</c:v>
                </c:pt>
                <c:pt idx="991">
                  <c:v>598.72900000000004</c:v>
                </c:pt>
                <c:pt idx="992">
                  <c:v>599.33299999999974</c:v>
                </c:pt>
                <c:pt idx="993">
                  <c:v>599.93799999999976</c:v>
                </c:pt>
                <c:pt idx="994">
                  <c:v>600.5419999999998</c:v>
                </c:pt>
                <c:pt idx="995">
                  <c:v>601.14599999999996</c:v>
                </c:pt>
                <c:pt idx="996">
                  <c:v>601.75</c:v>
                </c:pt>
                <c:pt idx="997">
                  <c:v>602.35399999999981</c:v>
                </c:pt>
                <c:pt idx="998">
                  <c:v>602.95799999999974</c:v>
                </c:pt>
                <c:pt idx="999">
                  <c:v>603.56299999999976</c:v>
                </c:pt>
                <c:pt idx="1000">
                  <c:v>604.1669999999998</c:v>
                </c:pt>
                <c:pt idx="1001">
                  <c:v>604.77099999999996</c:v>
                </c:pt>
                <c:pt idx="1002">
                  <c:v>605.375</c:v>
                </c:pt>
                <c:pt idx="1003">
                  <c:v>605.97900000000004</c:v>
                </c:pt>
                <c:pt idx="1004">
                  <c:v>606.58299999999997</c:v>
                </c:pt>
                <c:pt idx="1005">
                  <c:v>607.18799999999999</c:v>
                </c:pt>
                <c:pt idx="1006">
                  <c:v>607.79200000000003</c:v>
                </c:pt>
                <c:pt idx="1007">
                  <c:v>608.39599999999996</c:v>
                </c:pt>
                <c:pt idx="1008">
                  <c:v>609</c:v>
                </c:pt>
                <c:pt idx="1009">
                  <c:v>609.60400000000004</c:v>
                </c:pt>
                <c:pt idx="1010">
                  <c:v>610.20799999999997</c:v>
                </c:pt>
                <c:pt idx="1011">
                  <c:v>610.81299999999976</c:v>
                </c:pt>
                <c:pt idx="1012">
                  <c:v>611.4169999999998</c:v>
                </c:pt>
                <c:pt idx="1013">
                  <c:v>612.02099999999996</c:v>
                </c:pt>
                <c:pt idx="1014">
                  <c:v>612.625</c:v>
                </c:pt>
                <c:pt idx="1015">
                  <c:v>613.22900000000004</c:v>
                </c:pt>
                <c:pt idx="1016">
                  <c:v>613.83299999999974</c:v>
                </c:pt>
                <c:pt idx="1017">
                  <c:v>614.43799999999976</c:v>
                </c:pt>
                <c:pt idx="1018">
                  <c:v>615.0419999999998</c:v>
                </c:pt>
                <c:pt idx="1019">
                  <c:v>615.64599999999996</c:v>
                </c:pt>
                <c:pt idx="1020">
                  <c:v>616.25</c:v>
                </c:pt>
                <c:pt idx="1021">
                  <c:v>616.85399999999981</c:v>
                </c:pt>
                <c:pt idx="1022">
                  <c:v>617.45799999999974</c:v>
                </c:pt>
                <c:pt idx="1023">
                  <c:v>618.06299999999976</c:v>
                </c:pt>
                <c:pt idx="1024">
                  <c:v>618.6669999999998</c:v>
                </c:pt>
                <c:pt idx="1025">
                  <c:v>619.27099999999996</c:v>
                </c:pt>
                <c:pt idx="1026">
                  <c:v>619.875</c:v>
                </c:pt>
                <c:pt idx="1027">
                  <c:v>620.47900000000004</c:v>
                </c:pt>
                <c:pt idx="1028">
                  <c:v>621.08299999999997</c:v>
                </c:pt>
                <c:pt idx="1029">
                  <c:v>621.68799999999999</c:v>
                </c:pt>
                <c:pt idx="1030">
                  <c:v>622.29200000000003</c:v>
                </c:pt>
                <c:pt idx="1031">
                  <c:v>622.89599999999996</c:v>
                </c:pt>
                <c:pt idx="1032">
                  <c:v>623.5</c:v>
                </c:pt>
                <c:pt idx="1033">
                  <c:v>624.10400000000004</c:v>
                </c:pt>
                <c:pt idx="1034">
                  <c:v>624.70799999999997</c:v>
                </c:pt>
                <c:pt idx="1035">
                  <c:v>625.31299999999976</c:v>
                </c:pt>
                <c:pt idx="1036">
                  <c:v>625.9169999999998</c:v>
                </c:pt>
                <c:pt idx="1037">
                  <c:v>626.52099999999996</c:v>
                </c:pt>
                <c:pt idx="1038">
                  <c:v>627.125</c:v>
                </c:pt>
                <c:pt idx="1039">
                  <c:v>627.72900000000004</c:v>
                </c:pt>
                <c:pt idx="1040">
                  <c:v>628.33299999999974</c:v>
                </c:pt>
                <c:pt idx="1041">
                  <c:v>628.93799999999976</c:v>
                </c:pt>
                <c:pt idx="1042">
                  <c:v>629.5419999999998</c:v>
                </c:pt>
                <c:pt idx="1043">
                  <c:v>630.14599999999996</c:v>
                </c:pt>
                <c:pt idx="1044">
                  <c:v>630.75</c:v>
                </c:pt>
                <c:pt idx="1045">
                  <c:v>631.35399999999981</c:v>
                </c:pt>
                <c:pt idx="1046">
                  <c:v>631.95799999999974</c:v>
                </c:pt>
                <c:pt idx="1047">
                  <c:v>632.56299999999976</c:v>
                </c:pt>
                <c:pt idx="1048">
                  <c:v>633.1669999999998</c:v>
                </c:pt>
                <c:pt idx="1049">
                  <c:v>633.77099999999996</c:v>
                </c:pt>
                <c:pt idx="1050">
                  <c:v>634.375</c:v>
                </c:pt>
                <c:pt idx="1051">
                  <c:v>634.97900000000004</c:v>
                </c:pt>
                <c:pt idx="1052">
                  <c:v>635.58299999999997</c:v>
                </c:pt>
                <c:pt idx="1053">
                  <c:v>636.18799999999999</c:v>
                </c:pt>
                <c:pt idx="1054">
                  <c:v>636.79200000000003</c:v>
                </c:pt>
                <c:pt idx="1055">
                  <c:v>637.39599999999996</c:v>
                </c:pt>
                <c:pt idx="1056">
                  <c:v>638</c:v>
                </c:pt>
                <c:pt idx="1057">
                  <c:v>638.60400000000004</c:v>
                </c:pt>
                <c:pt idx="1058">
                  <c:v>639.20799999999997</c:v>
                </c:pt>
                <c:pt idx="1059">
                  <c:v>639.81299999999976</c:v>
                </c:pt>
                <c:pt idx="1060">
                  <c:v>640.4169999999998</c:v>
                </c:pt>
                <c:pt idx="1061">
                  <c:v>641.02099999999996</c:v>
                </c:pt>
                <c:pt idx="1062">
                  <c:v>641.625</c:v>
                </c:pt>
                <c:pt idx="1063">
                  <c:v>642.22900000000004</c:v>
                </c:pt>
                <c:pt idx="1064">
                  <c:v>642.83299999999974</c:v>
                </c:pt>
                <c:pt idx="1065">
                  <c:v>643.43799999999976</c:v>
                </c:pt>
                <c:pt idx="1066">
                  <c:v>644.0419999999998</c:v>
                </c:pt>
                <c:pt idx="1067">
                  <c:v>644.64599999999996</c:v>
                </c:pt>
                <c:pt idx="1068">
                  <c:v>645.25</c:v>
                </c:pt>
                <c:pt idx="1069">
                  <c:v>645.85399999999981</c:v>
                </c:pt>
                <c:pt idx="1070">
                  <c:v>646.45799999999974</c:v>
                </c:pt>
                <c:pt idx="1071">
                  <c:v>647.06299999999976</c:v>
                </c:pt>
                <c:pt idx="1072">
                  <c:v>647.6669999999998</c:v>
                </c:pt>
                <c:pt idx="1073">
                  <c:v>648.27099999999996</c:v>
                </c:pt>
                <c:pt idx="1074">
                  <c:v>648.875</c:v>
                </c:pt>
                <c:pt idx="1075">
                  <c:v>649.47900000000004</c:v>
                </c:pt>
                <c:pt idx="1076">
                  <c:v>650.08299999999997</c:v>
                </c:pt>
                <c:pt idx="1077">
                  <c:v>650.68799999999999</c:v>
                </c:pt>
                <c:pt idx="1078">
                  <c:v>651.29200000000003</c:v>
                </c:pt>
                <c:pt idx="1079">
                  <c:v>651.89599999999996</c:v>
                </c:pt>
                <c:pt idx="1080">
                  <c:v>652.5</c:v>
                </c:pt>
                <c:pt idx="1081">
                  <c:v>653.10400000000004</c:v>
                </c:pt>
                <c:pt idx="1082">
                  <c:v>653.70799999999997</c:v>
                </c:pt>
                <c:pt idx="1083">
                  <c:v>654.31299999999976</c:v>
                </c:pt>
                <c:pt idx="1084">
                  <c:v>654.9169999999998</c:v>
                </c:pt>
                <c:pt idx="1085">
                  <c:v>655.52099999999996</c:v>
                </c:pt>
                <c:pt idx="1086">
                  <c:v>656.125</c:v>
                </c:pt>
                <c:pt idx="1087">
                  <c:v>656.72900000000004</c:v>
                </c:pt>
                <c:pt idx="1088">
                  <c:v>657.33299999999974</c:v>
                </c:pt>
                <c:pt idx="1089">
                  <c:v>657.93799999999976</c:v>
                </c:pt>
                <c:pt idx="1090">
                  <c:v>658.5419999999998</c:v>
                </c:pt>
                <c:pt idx="1091">
                  <c:v>659.14599999999996</c:v>
                </c:pt>
                <c:pt idx="1092">
                  <c:v>659.75</c:v>
                </c:pt>
                <c:pt idx="1093">
                  <c:v>660.35399999999981</c:v>
                </c:pt>
                <c:pt idx="1094">
                  <c:v>660.95799999999974</c:v>
                </c:pt>
                <c:pt idx="1095">
                  <c:v>661.56299999999976</c:v>
                </c:pt>
                <c:pt idx="1096">
                  <c:v>662.1669999999998</c:v>
                </c:pt>
                <c:pt idx="1097">
                  <c:v>662.77099999999996</c:v>
                </c:pt>
                <c:pt idx="1098">
                  <c:v>663.375</c:v>
                </c:pt>
                <c:pt idx="1099">
                  <c:v>663.97900000000004</c:v>
                </c:pt>
                <c:pt idx="1100">
                  <c:v>664.58299999999997</c:v>
                </c:pt>
                <c:pt idx="1101">
                  <c:v>665.18799999999999</c:v>
                </c:pt>
                <c:pt idx="1102">
                  <c:v>665.79200000000003</c:v>
                </c:pt>
                <c:pt idx="1103">
                  <c:v>666.39599999999996</c:v>
                </c:pt>
                <c:pt idx="1104">
                  <c:v>667</c:v>
                </c:pt>
                <c:pt idx="1105">
                  <c:v>667.60400000000004</c:v>
                </c:pt>
                <c:pt idx="1106">
                  <c:v>668.20799999999997</c:v>
                </c:pt>
                <c:pt idx="1107">
                  <c:v>668.81299999999976</c:v>
                </c:pt>
                <c:pt idx="1108">
                  <c:v>669.4169999999998</c:v>
                </c:pt>
                <c:pt idx="1109">
                  <c:v>670.02099999999996</c:v>
                </c:pt>
                <c:pt idx="1110">
                  <c:v>670.625</c:v>
                </c:pt>
                <c:pt idx="1111">
                  <c:v>671.22900000000004</c:v>
                </c:pt>
                <c:pt idx="1112">
                  <c:v>671.83299999999974</c:v>
                </c:pt>
                <c:pt idx="1113">
                  <c:v>672.43799999999976</c:v>
                </c:pt>
                <c:pt idx="1114">
                  <c:v>673.0419999999998</c:v>
                </c:pt>
                <c:pt idx="1115">
                  <c:v>673.64599999999996</c:v>
                </c:pt>
                <c:pt idx="1116">
                  <c:v>674.25</c:v>
                </c:pt>
                <c:pt idx="1117">
                  <c:v>674.85399999999981</c:v>
                </c:pt>
                <c:pt idx="1118">
                  <c:v>675.45799999999974</c:v>
                </c:pt>
                <c:pt idx="1119">
                  <c:v>676.06299999999976</c:v>
                </c:pt>
                <c:pt idx="1120">
                  <c:v>676.6669999999998</c:v>
                </c:pt>
                <c:pt idx="1121">
                  <c:v>677.27099999999996</c:v>
                </c:pt>
                <c:pt idx="1122">
                  <c:v>677.875</c:v>
                </c:pt>
                <c:pt idx="1123">
                  <c:v>678.47900000000004</c:v>
                </c:pt>
                <c:pt idx="1124">
                  <c:v>679.08299999999997</c:v>
                </c:pt>
                <c:pt idx="1125">
                  <c:v>679.68799999999999</c:v>
                </c:pt>
                <c:pt idx="1126">
                  <c:v>680.29200000000003</c:v>
                </c:pt>
                <c:pt idx="1127">
                  <c:v>680.89599999999996</c:v>
                </c:pt>
                <c:pt idx="1128">
                  <c:v>681.5</c:v>
                </c:pt>
                <c:pt idx="1129">
                  <c:v>682.10400000000004</c:v>
                </c:pt>
                <c:pt idx="1130">
                  <c:v>682.70799999999997</c:v>
                </c:pt>
                <c:pt idx="1131">
                  <c:v>683.31299999999976</c:v>
                </c:pt>
                <c:pt idx="1132">
                  <c:v>683.9169999999998</c:v>
                </c:pt>
                <c:pt idx="1133">
                  <c:v>684.52099999999996</c:v>
                </c:pt>
                <c:pt idx="1134">
                  <c:v>685.125</c:v>
                </c:pt>
                <c:pt idx="1135">
                  <c:v>685.72900000000004</c:v>
                </c:pt>
                <c:pt idx="1136">
                  <c:v>686.33299999999974</c:v>
                </c:pt>
                <c:pt idx="1137">
                  <c:v>686.93799999999976</c:v>
                </c:pt>
                <c:pt idx="1138">
                  <c:v>687.5419999999998</c:v>
                </c:pt>
                <c:pt idx="1139">
                  <c:v>688.14599999999996</c:v>
                </c:pt>
                <c:pt idx="1140">
                  <c:v>688.75</c:v>
                </c:pt>
                <c:pt idx="1141">
                  <c:v>689.35399999999981</c:v>
                </c:pt>
                <c:pt idx="1142">
                  <c:v>689.95799999999974</c:v>
                </c:pt>
                <c:pt idx="1143">
                  <c:v>690.56299999999976</c:v>
                </c:pt>
                <c:pt idx="1144">
                  <c:v>691.1669999999998</c:v>
                </c:pt>
                <c:pt idx="1145">
                  <c:v>691.77099999999996</c:v>
                </c:pt>
                <c:pt idx="1146">
                  <c:v>692.375</c:v>
                </c:pt>
                <c:pt idx="1147">
                  <c:v>692.97900000000004</c:v>
                </c:pt>
                <c:pt idx="1148">
                  <c:v>693.58299999999997</c:v>
                </c:pt>
                <c:pt idx="1149">
                  <c:v>694.18799999999999</c:v>
                </c:pt>
                <c:pt idx="1150">
                  <c:v>694.79200000000003</c:v>
                </c:pt>
                <c:pt idx="1151">
                  <c:v>695.39599999999996</c:v>
                </c:pt>
                <c:pt idx="1152">
                  <c:v>696</c:v>
                </c:pt>
                <c:pt idx="1153">
                  <c:v>696.60400000000004</c:v>
                </c:pt>
                <c:pt idx="1154">
                  <c:v>697.20799999999997</c:v>
                </c:pt>
                <c:pt idx="1155">
                  <c:v>697.81299999999976</c:v>
                </c:pt>
                <c:pt idx="1156">
                  <c:v>698.4169999999998</c:v>
                </c:pt>
                <c:pt idx="1157">
                  <c:v>699.02099999999996</c:v>
                </c:pt>
                <c:pt idx="1158">
                  <c:v>699.625</c:v>
                </c:pt>
                <c:pt idx="1159">
                  <c:v>700.22900000000004</c:v>
                </c:pt>
                <c:pt idx="1160">
                  <c:v>700.83299999999974</c:v>
                </c:pt>
                <c:pt idx="1161">
                  <c:v>701.43799999999976</c:v>
                </c:pt>
                <c:pt idx="1162">
                  <c:v>702.0419999999998</c:v>
                </c:pt>
                <c:pt idx="1163">
                  <c:v>702.64599999999996</c:v>
                </c:pt>
                <c:pt idx="1164">
                  <c:v>703.25</c:v>
                </c:pt>
                <c:pt idx="1165">
                  <c:v>703.85399999999981</c:v>
                </c:pt>
                <c:pt idx="1166">
                  <c:v>704.45799999999974</c:v>
                </c:pt>
                <c:pt idx="1167">
                  <c:v>705.06299999999976</c:v>
                </c:pt>
                <c:pt idx="1168">
                  <c:v>705.6669999999998</c:v>
                </c:pt>
                <c:pt idx="1169">
                  <c:v>706.27099999999996</c:v>
                </c:pt>
                <c:pt idx="1170">
                  <c:v>706.875</c:v>
                </c:pt>
                <c:pt idx="1171">
                  <c:v>707.47900000000004</c:v>
                </c:pt>
                <c:pt idx="1172">
                  <c:v>708.08299999999997</c:v>
                </c:pt>
                <c:pt idx="1173">
                  <c:v>708.68799999999999</c:v>
                </c:pt>
                <c:pt idx="1174">
                  <c:v>709.29200000000003</c:v>
                </c:pt>
                <c:pt idx="1175">
                  <c:v>709.89599999999996</c:v>
                </c:pt>
                <c:pt idx="1176">
                  <c:v>710.5</c:v>
                </c:pt>
                <c:pt idx="1177">
                  <c:v>711.10400000000004</c:v>
                </c:pt>
                <c:pt idx="1178">
                  <c:v>711.70799999999997</c:v>
                </c:pt>
                <c:pt idx="1179">
                  <c:v>712.31299999999976</c:v>
                </c:pt>
                <c:pt idx="1180">
                  <c:v>712.9169999999998</c:v>
                </c:pt>
                <c:pt idx="1181">
                  <c:v>713.52099999999996</c:v>
                </c:pt>
                <c:pt idx="1182">
                  <c:v>714.125</c:v>
                </c:pt>
                <c:pt idx="1183">
                  <c:v>714.72900000000004</c:v>
                </c:pt>
                <c:pt idx="1184">
                  <c:v>715.33299999999974</c:v>
                </c:pt>
                <c:pt idx="1185">
                  <c:v>715.93799999999976</c:v>
                </c:pt>
                <c:pt idx="1186">
                  <c:v>716.5419999999998</c:v>
                </c:pt>
                <c:pt idx="1187">
                  <c:v>717.14599999999996</c:v>
                </c:pt>
                <c:pt idx="1188">
                  <c:v>717.75</c:v>
                </c:pt>
                <c:pt idx="1189">
                  <c:v>718.35399999999981</c:v>
                </c:pt>
                <c:pt idx="1190">
                  <c:v>718.95799999999974</c:v>
                </c:pt>
                <c:pt idx="1191">
                  <c:v>719.56299999999976</c:v>
                </c:pt>
                <c:pt idx="1192">
                  <c:v>720.1669999999998</c:v>
                </c:pt>
                <c:pt idx="1193">
                  <c:v>720.77099999999996</c:v>
                </c:pt>
                <c:pt idx="1194">
                  <c:v>721.375</c:v>
                </c:pt>
                <c:pt idx="1195">
                  <c:v>721.97900000000004</c:v>
                </c:pt>
                <c:pt idx="1196">
                  <c:v>722.58299999999997</c:v>
                </c:pt>
                <c:pt idx="1197">
                  <c:v>723.18799999999999</c:v>
                </c:pt>
                <c:pt idx="1198">
                  <c:v>723.79200000000003</c:v>
                </c:pt>
                <c:pt idx="1199">
                  <c:v>724.39599999999996</c:v>
                </c:pt>
                <c:pt idx="1200">
                  <c:v>725</c:v>
                </c:pt>
                <c:pt idx="1201">
                  <c:v>725.60400000000004</c:v>
                </c:pt>
                <c:pt idx="1202">
                  <c:v>726.20799999999997</c:v>
                </c:pt>
                <c:pt idx="1203">
                  <c:v>726.81299999999976</c:v>
                </c:pt>
                <c:pt idx="1204">
                  <c:v>727.4169999999998</c:v>
                </c:pt>
                <c:pt idx="1205">
                  <c:v>728.02099999999996</c:v>
                </c:pt>
                <c:pt idx="1206">
                  <c:v>728.625</c:v>
                </c:pt>
                <c:pt idx="1207">
                  <c:v>729.22900000000004</c:v>
                </c:pt>
                <c:pt idx="1208">
                  <c:v>729.83299999999974</c:v>
                </c:pt>
                <c:pt idx="1209">
                  <c:v>730.43799999999976</c:v>
                </c:pt>
                <c:pt idx="1210">
                  <c:v>731.0419999999998</c:v>
                </c:pt>
                <c:pt idx="1211">
                  <c:v>731.64599999999996</c:v>
                </c:pt>
                <c:pt idx="1212">
                  <c:v>732.25</c:v>
                </c:pt>
                <c:pt idx="1213">
                  <c:v>732.85399999999981</c:v>
                </c:pt>
                <c:pt idx="1214">
                  <c:v>733.45799999999974</c:v>
                </c:pt>
                <c:pt idx="1215">
                  <c:v>734.06299999999976</c:v>
                </c:pt>
                <c:pt idx="1216">
                  <c:v>734.6669999999998</c:v>
                </c:pt>
                <c:pt idx="1217">
                  <c:v>735.27099999999996</c:v>
                </c:pt>
                <c:pt idx="1218">
                  <c:v>735.875</c:v>
                </c:pt>
                <c:pt idx="1219">
                  <c:v>736.47900000000004</c:v>
                </c:pt>
                <c:pt idx="1220">
                  <c:v>737.08299999999997</c:v>
                </c:pt>
                <c:pt idx="1221">
                  <c:v>737.68799999999999</c:v>
                </c:pt>
                <c:pt idx="1222">
                  <c:v>738.29200000000003</c:v>
                </c:pt>
                <c:pt idx="1223">
                  <c:v>738.89599999999996</c:v>
                </c:pt>
                <c:pt idx="1224">
                  <c:v>739.5</c:v>
                </c:pt>
                <c:pt idx="1225">
                  <c:v>740.10400000000004</c:v>
                </c:pt>
                <c:pt idx="1226">
                  <c:v>740.70799999999997</c:v>
                </c:pt>
                <c:pt idx="1227">
                  <c:v>741.31299999999976</c:v>
                </c:pt>
                <c:pt idx="1228">
                  <c:v>741.9169999999998</c:v>
                </c:pt>
                <c:pt idx="1229">
                  <c:v>742.52099999999996</c:v>
                </c:pt>
                <c:pt idx="1230">
                  <c:v>743.125</c:v>
                </c:pt>
                <c:pt idx="1231">
                  <c:v>743.72900000000004</c:v>
                </c:pt>
                <c:pt idx="1232">
                  <c:v>744.33299999999974</c:v>
                </c:pt>
                <c:pt idx="1233">
                  <c:v>744.93799999999976</c:v>
                </c:pt>
                <c:pt idx="1234">
                  <c:v>745.5419999999998</c:v>
                </c:pt>
                <c:pt idx="1235">
                  <c:v>746.14599999999996</c:v>
                </c:pt>
                <c:pt idx="1236">
                  <c:v>746.75</c:v>
                </c:pt>
                <c:pt idx="1237">
                  <c:v>747.35399999999981</c:v>
                </c:pt>
                <c:pt idx="1238">
                  <c:v>747.95799999999974</c:v>
                </c:pt>
                <c:pt idx="1239">
                  <c:v>748.56299999999976</c:v>
                </c:pt>
                <c:pt idx="1240">
                  <c:v>749.1669999999998</c:v>
                </c:pt>
                <c:pt idx="1241">
                  <c:v>749.77099999999996</c:v>
                </c:pt>
                <c:pt idx="1242">
                  <c:v>750.375</c:v>
                </c:pt>
                <c:pt idx="1243">
                  <c:v>750.97900000000004</c:v>
                </c:pt>
                <c:pt idx="1244">
                  <c:v>751.58299999999997</c:v>
                </c:pt>
                <c:pt idx="1245">
                  <c:v>752.18799999999999</c:v>
                </c:pt>
                <c:pt idx="1246">
                  <c:v>752.79200000000003</c:v>
                </c:pt>
                <c:pt idx="1247">
                  <c:v>753.39599999999996</c:v>
                </c:pt>
                <c:pt idx="1248">
                  <c:v>754</c:v>
                </c:pt>
                <c:pt idx="1249">
                  <c:v>754.60400000000004</c:v>
                </c:pt>
                <c:pt idx="1250">
                  <c:v>755.20799999999997</c:v>
                </c:pt>
                <c:pt idx="1251">
                  <c:v>755.81299999999976</c:v>
                </c:pt>
                <c:pt idx="1252">
                  <c:v>756.4169999999998</c:v>
                </c:pt>
                <c:pt idx="1253">
                  <c:v>757.02099999999996</c:v>
                </c:pt>
                <c:pt idx="1254">
                  <c:v>757.625</c:v>
                </c:pt>
                <c:pt idx="1255">
                  <c:v>758.22900000000004</c:v>
                </c:pt>
                <c:pt idx="1256">
                  <c:v>758.83299999999974</c:v>
                </c:pt>
                <c:pt idx="1257">
                  <c:v>759.43799999999976</c:v>
                </c:pt>
                <c:pt idx="1258">
                  <c:v>760.0419999999998</c:v>
                </c:pt>
                <c:pt idx="1259">
                  <c:v>760.64599999999996</c:v>
                </c:pt>
                <c:pt idx="1260">
                  <c:v>761.25</c:v>
                </c:pt>
                <c:pt idx="1261">
                  <c:v>761.85399999999981</c:v>
                </c:pt>
                <c:pt idx="1262">
                  <c:v>762.45799999999974</c:v>
                </c:pt>
                <c:pt idx="1263">
                  <c:v>763.06299999999976</c:v>
                </c:pt>
                <c:pt idx="1264">
                  <c:v>763.6669999999998</c:v>
                </c:pt>
                <c:pt idx="1265">
                  <c:v>764.27099999999996</c:v>
                </c:pt>
                <c:pt idx="1266">
                  <c:v>764.875</c:v>
                </c:pt>
                <c:pt idx="1267">
                  <c:v>765.47900000000004</c:v>
                </c:pt>
                <c:pt idx="1268">
                  <c:v>766.08299999999997</c:v>
                </c:pt>
                <c:pt idx="1269">
                  <c:v>766.68799999999999</c:v>
                </c:pt>
                <c:pt idx="1270">
                  <c:v>767.29200000000003</c:v>
                </c:pt>
                <c:pt idx="1271">
                  <c:v>767.89599999999996</c:v>
                </c:pt>
                <c:pt idx="1272">
                  <c:v>768.5</c:v>
                </c:pt>
                <c:pt idx="1273">
                  <c:v>769.10400000000004</c:v>
                </c:pt>
                <c:pt idx="1274">
                  <c:v>769.70799999999997</c:v>
                </c:pt>
                <c:pt idx="1275">
                  <c:v>770.31299999999976</c:v>
                </c:pt>
                <c:pt idx="1276">
                  <c:v>770.9169999999998</c:v>
                </c:pt>
                <c:pt idx="1277">
                  <c:v>771.52099999999996</c:v>
                </c:pt>
                <c:pt idx="1278">
                  <c:v>772.125</c:v>
                </c:pt>
                <c:pt idx="1279">
                  <c:v>772.72900000000004</c:v>
                </c:pt>
                <c:pt idx="1280">
                  <c:v>773.33299999999974</c:v>
                </c:pt>
                <c:pt idx="1281">
                  <c:v>773.93799999999976</c:v>
                </c:pt>
                <c:pt idx="1282">
                  <c:v>774.5419999999998</c:v>
                </c:pt>
                <c:pt idx="1283">
                  <c:v>775.14599999999996</c:v>
                </c:pt>
                <c:pt idx="1284">
                  <c:v>775.75</c:v>
                </c:pt>
                <c:pt idx="1285">
                  <c:v>776.35399999999981</c:v>
                </c:pt>
                <c:pt idx="1286">
                  <c:v>776.95799999999974</c:v>
                </c:pt>
                <c:pt idx="1287">
                  <c:v>777.56299999999976</c:v>
                </c:pt>
                <c:pt idx="1288">
                  <c:v>778.1669999999998</c:v>
                </c:pt>
                <c:pt idx="1289">
                  <c:v>778.77099999999996</c:v>
                </c:pt>
                <c:pt idx="1290">
                  <c:v>779.375</c:v>
                </c:pt>
                <c:pt idx="1291">
                  <c:v>779.97900000000004</c:v>
                </c:pt>
                <c:pt idx="1292">
                  <c:v>780.58299999999997</c:v>
                </c:pt>
                <c:pt idx="1293">
                  <c:v>781.18799999999999</c:v>
                </c:pt>
                <c:pt idx="1294">
                  <c:v>781.79200000000003</c:v>
                </c:pt>
                <c:pt idx="1295">
                  <c:v>782.39599999999996</c:v>
                </c:pt>
                <c:pt idx="1296">
                  <c:v>783</c:v>
                </c:pt>
                <c:pt idx="1297">
                  <c:v>783.60400000000004</c:v>
                </c:pt>
                <c:pt idx="1298">
                  <c:v>784.20799999999997</c:v>
                </c:pt>
                <c:pt idx="1299">
                  <c:v>784.81299999999976</c:v>
                </c:pt>
                <c:pt idx="1300">
                  <c:v>785.4169999999998</c:v>
                </c:pt>
                <c:pt idx="1301">
                  <c:v>786.02099999999996</c:v>
                </c:pt>
                <c:pt idx="1302">
                  <c:v>786.625</c:v>
                </c:pt>
                <c:pt idx="1303">
                  <c:v>787.22900000000004</c:v>
                </c:pt>
                <c:pt idx="1304">
                  <c:v>787.83299999999974</c:v>
                </c:pt>
                <c:pt idx="1305">
                  <c:v>788.43799999999976</c:v>
                </c:pt>
                <c:pt idx="1306">
                  <c:v>789.0419999999998</c:v>
                </c:pt>
                <c:pt idx="1307">
                  <c:v>789.64599999999996</c:v>
                </c:pt>
                <c:pt idx="1308">
                  <c:v>790.25</c:v>
                </c:pt>
                <c:pt idx="1309">
                  <c:v>790.85399999999981</c:v>
                </c:pt>
                <c:pt idx="1310">
                  <c:v>791.45799999999974</c:v>
                </c:pt>
                <c:pt idx="1311">
                  <c:v>792.06299999999976</c:v>
                </c:pt>
                <c:pt idx="1312">
                  <c:v>792.6669999999998</c:v>
                </c:pt>
                <c:pt idx="1313">
                  <c:v>793.27099999999996</c:v>
                </c:pt>
                <c:pt idx="1314">
                  <c:v>793.875</c:v>
                </c:pt>
                <c:pt idx="1315">
                  <c:v>794.47900000000004</c:v>
                </c:pt>
                <c:pt idx="1316">
                  <c:v>795.08299999999997</c:v>
                </c:pt>
                <c:pt idx="1317">
                  <c:v>795.68799999999999</c:v>
                </c:pt>
                <c:pt idx="1318">
                  <c:v>796.29200000000003</c:v>
                </c:pt>
                <c:pt idx="1319">
                  <c:v>796.89599999999996</c:v>
                </c:pt>
                <c:pt idx="1320">
                  <c:v>797.5</c:v>
                </c:pt>
                <c:pt idx="1321">
                  <c:v>798.10400000000004</c:v>
                </c:pt>
                <c:pt idx="1322">
                  <c:v>798.70799999999997</c:v>
                </c:pt>
                <c:pt idx="1323">
                  <c:v>799.31299999999976</c:v>
                </c:pt>
                <c:pt idx="1324">
                  <c:v>799.9169999999998</c:v>
                </c:pt>
                <c:pt idx="1325">
                  <c:v>800.52099999999996</c:v>
                </c:pt>
                <c:pt idx="1326">
                  <c:v>801.125</c:v>
                </c:pt>
                <c:pt idx="1327">
                  <c:v>801.72900000000004</c:v>
                </c:pt>
                <c:pt idx="1328">
                  <c:v>802.33299999999974</c:v>
                </c:pt>
                <c:pt idx="1329">
                  <c:v>802.93799999999976</c:v>
                </c:pt>
                <c:pt idx="1330">
                  <c:v>803.5419999999998</c:v>
                </c:pt>
                <c:pt idx="1331">
                  <c:v>804.14599999999996</c:v>
                </c:pt>
                <c:pt idx="1332">
                  <c:v>804.75</c:v>
                </c:pt>
                <c:pt idx="1333">
                  <c:v>805.35399999999981</c:v>
                </c:pt>
                <c:pt idx="1334">
                  <c:v>805.95799999999974</c:v>
                </c:pt>
                <c:pt idx="1335">
                  <c:v>806.56299999999976</c:v>
                </c:pt>
                <c:pt idx="1336">
                  <c:v>807.1669999999998</c:v>
                </c:pt>
                <c:pt idx="1337">
                  <c:v>807.77099999999996</c:v>
                </c:pt>
                <c:pt idx="1338">
                  <c:v>808.375</c:v>
                </c:pt>
                <c:pt idx="1339">
                  <c:v>808.97900000000004</c:v>
                </c:pt>
                <c:pt idx="1340">
                  <c:v>809.58299999999997</c:v>
                </c:pt>
                <c:pt idx="1341">
                  <c:v>810.18799999999999</c:v>
                </c:pt>
                <c:pt idx="1342">
                  <c:v>810.79200000000003</c:v>
                </c:pt>
                <c:pt idx="1343">
                  <c:v>811.39599999999996</c:v>
                </c:pt>
                <c:pt idx="1344">
                  <c:v>812</c:v>
                </c:pt>
                <c:pt idx="1345">
                  <c:v>812.60400000000004</c:v>
                </c:pt>
                <c:pt idx="1346">
                  <c:v>813.20799999999997</c:v>
                </c:pt>
                <c:pt idx="1347">
                  <c:v>813.81299999999976</c:v>
                </c:pt>
                <c:pt idx="1348">
                  <c:v>814.4169999999998</c:v>
                </c:pt>
                <c:pt idx="1349">
                  <c:v>815.02099999999996</c:v>
                </c:pt>
                <c:pt idx="1350">
                  <c:v>815.625</c:v>
                </c:pt>
                <c:pt idx="1351">
                  <c:v>816.22900000000004</c:v>
                </c:pt>
                <c:pt idx="1352">
                  <c:v>816.83299999999974</c:v>
                </c:pt>
                <c:pt idx="1353">
                  <c:v>817.43799999999976</c:v>
                </c:pt>
                <c:pt idx="1354">
                  <c:v>818.0419999999998</c:v>
                </c:pt>
                <c:pt idx="1355">
                  <c:v>818.64599999999996</c:v>
                </c:pt>
                <c:pt idx="1356">
                  <c:v>819.25</c:v>
                </c:pt>
                <c:pt idx="1357">
                  <c:v>819.85399999999981</c:v>
                </c:pt>
                <c:pt idx="1358">
                  <c:v>820.45799999999974</c:v>
                </c:pt>
                <c:pt idx="1359">
                  <c:v>821.06299999999976</c:v>
                </c:pt>
                <c:pt idx="1360">
                  <c:v>821.6669999999998</c:v>
                </c:pt>
                <c:pt idx="1361">
                  <c:v>822.27099999999996</c:v>
                </c:pt>
                <c:pt idx="1362">
                  <c:v>822.875</c:v>
                </c:pt>
                <c:pt idx="1363">
                  <c:v>823.47900000000004</c:v>
                </c:pt>
                <c:pt idx="1364">
                  <c:v>824.08299999999997</c:v>
                </c:pt>
                <c:pt idx="1365">
                  <c:v>824.68799999999999</c:v>
                </c:pt>
                <c:pt idx="1366">
                  <c:v>825.29200000000003</c:v>
                </c:pt>
                <c:pt idx="1367">
                  <c:v>825.89599999999996</c:v>
                </c:pt>
                <c:pt idx="1368">
                  <c:v>826.5</c:v>
                </c:pt>
                <c:pt idx="1369">
                  <c:v>827.10400000000004</c:v>
                </c:pt>
                <c:pt idx="1370">
                  <c:v>827.70799999999997</c:v>
                </c:pt>
                <c:pt idx="1371">
                  <c:v>828.31299999999976</c:v>
                </c:pt>
                <c:pt idx="1372">
                  <c:v>828.9169999999998</c:v>
                </c:pt>
                <c:pt idx="1373">
                  <c:v>829.52099999999996</c:v>
                </c:pt>
                <c:pt idx="1374">
                  <c:v>830.125</c:v>
                </c:pt>
                <c:pt idx="1375">
                  <c:v>830.72900000000004</c:v>
                </c:pt>
                <c:pt idx="1376">
                  <c:v>831.33299999999974</c:v>
                </c:pt>
                <c:pt idx="1377">
                  <c:v>831.93799999999976</c:v>
                </c:pt>
                <c:pt idx="1378">
                  <c:v>832.5419999999998</c:v>
                </c:pt>
                <c:pt idx="1379">
                  <c:v>833.14599999999996</c:v>
                </c:pt>
                <c:pt idx="1380">
                  <c:v>833.75</c:v>
                </c:pt>
                <c:pt idx="1381">
                  <c:v>834.35399999999981</c:v>
                </c:pt>
                <c:pt idx="1382">
                  <c:v>834.95799999999974</c:v>
                </c:pt>
                <c:pt idx="1383">
                  <c:v>835.56299999999976</c:v>
                </c:pt>
                <c:pt idx="1384">
                  <c:v>836.1669999999998</c:v>
                </c:pt>
                <c:pt idx="1385">
                  <c:v>836.77099999999996</c:v>
                </c:pt>
                <c:pt idx="1386">
                  <c:v>837.375</c:v>
                </c:pt>
                <c:pt idx="1387">
                  <c:v>837.97900000000004</c:v>
                </c:pt>
                <c:pt idx="1388">
                  <c:v>838.58299999999997</c:v>
                </c:pt>
                <c:pt idx="1389">
                  <c:v>839.18799999999999</c:v>
                </c:pt>
                <c:pt idx="1390">
                  <c:v>839.79200000000003</c:v>
                </c:pt>
                <c:pt idx="1391">
                  <c:v>840.39599999999996</c:v>
                </c:pt>
                <c:pt idx="1392">
                  <c:v>841</c:v>
                </c:pt>
                <c:pt idx="1393">
                  <c:v>841.60400000000004</c:v>
                </c:pt>
                <c:pt idx="1394">
                  <c:v>842.20799999999997</c:v>
                </c:pt>
                <c:pt idx="1395">
                  <c:v>842.81299999999976</c:v>
                </c:pt>
                <c:pt idx="1396">
                  <c:v>843.4169999999998</c:v>
                </c:pt>
                <c:pt idx="1397">
                  <c:v>844.02099999999996</c:v>
                </c:pt>
                <c:pt idx="1398">
                  <c:v>844.625</c:v>
                </c:pt>
                <c:pt idx="1399">
                  <c:v>845.22900000000004</c:v>
                </c:pt>
                <c:pt idx="1400">
                  <c:v>845.83299999999974</c:v>
                </c:pt>
                <c:pt idx="1401">
                  <c:v>846.43799999999976</c:v>
                </c:pt>
                <c:pt idx="1402">
                  <c:v>847.0419999999998</c:v>
                </c:pt>
                <c:pt idx="1403">
                  <c:v>847.64599999999996</c:v>
                </c:pt>
                <c:pt idx="1404">
                  <c:v>848.25</c:v>
                </c:pt>
                <c:pt idx="1405">
                  <c:v>848.85399999999981</c:v>
                </c:pt>
                <c:pt idx="1406">
                  <c:v>849.45799999999974</c:v>
                </c:pt>
                <c:pt idx="1407">
                  <c:v>850.06299999999976</c:v>
                </c:pt>
                <c:pt idx="1408">
                  <c:v>850.6669999999998</c:v>
                </c:pt>
                <c:pt idx="1409">
                  <c:v>851.27099999999996</c:v>
                </c:pt>
                <c:pt idx="1410">
                  <c:v>851.875</c:v>
                </c:pt>
                <c:pt idx="1411">
                  <c:v>852.47900000000004</c:v>
                </c:pt>
                <c:pt idx="1412">
                  <c:v>853.08299999999997</c:v>
                </c:pt>
                <c:pt idx="1413">
                  <c:v>853.68799999999999</c:v>
                </c:pt>
                <c:pt idx="1414">
                  <c:v>854.29200000000003</c:v>
                </c:pt>
                <c:pt idx="1415">
                  <c:v>854.89599999999996</c:v>
                </c:pt>
                <c:pt idx="1416">
                  <c:v>855.5</c:v>
                </c:pt>
                <c:pt idx="1417">
                  <c:v>856.10400000000004</c:v>
                </c:pt>
                <c:pt idx="1418">
                  <c:v>856.70799999999997</c:v>
                </c:pt>
                <c:pt idx="1419">
                  <c:v>857.31299999999976</c:v>
                </c:pt>
                <c:pt idx="1420">
                  <c:v>857.9169999999998</c:v>
                </c:pt>
                <c:pt idx="1421">
                  <c:v>858.52099999999996</c:v>
                </c:pt>
                <c:pt idx="1422">
                  <c:v>859.125</c:v>
                </c:pt>
                <c:pt idx="1423">
                  <c:v>859.72900000000004</c:v>
                </c:pt>
                <c:pt idx="1424">
                  <c:v>860.33299999999974</c:v>
                </c:pt>
                <c:pt idx="1425">
                  <c:v>860.93799999999976</c:v>
                </c:pt>
                <c:pt idx="1426">
                  <c:v>861.5419999999998</c:v>
                </c:pt>
                <c:pt idx="1427">
                  <c:v>862.14599999999996</c:v>
                </c:pt>
                <c:pt idx="1428">
                  <c:v>862.75</c:v>
                </c:pt>
                <c:pt idx="1429">
                  <c:v>863.35399999999981</c:v>
                </c:pt>
                <c:pt idx="1430">
                  <c:v>863.95799999999974</c:v>
                </c:pt>
                <c:pt idx="1431">
                  <c:v>864.56299999999976</c:v>
                </c:pt>
                <c:pt idx="1432">
                  <c:v>865.1669999999998</c:v>
                </c:pt>
                <c:pt idx="1433">
                  <c:v>865.77099999999996</c:v>
                </c:pt>
                <c:pt idx="1434">
                  <c:v>866.375</c:v>
                </c:pt>
                <c:pt idx="1435">
                  <c:v>866.97900000000004</c:v>
                </c:pt>
                <c:pt idx="1436">
                  <c:v>867.58299999999997</c:v>
                </c:pt>
                <c:pt idx="1437">
                  <c:v>868.18799999999999</c:v>
                </c:pt>
                <c:pt idx="1438">
                  <c:v>868.79200000000003</c:v>
                </c:pt>
                <c:pt idx="1439">
                  <c:v>869.39599999999996</c:v>
                </c:pt>
                <c:pt idx="1440">
                  <c:v>870</c:v>
                </c:pt>
                <c:pt idx="1441">
                  <c:v>870.60400000000004</c:v>
                </c:pt>
                <c:pt idx="1442">
                  <c:v>871.20799999999997</c:v>
                </c:pt>
                <c:pt idx="1443">
                  <c:v>871.81299999999976</c:v>
                </c:pt>
                <c:pt idx="1444">
                  <c:v>872.4169999999998</c:v>
                </c:pt>
                <c:pt idx="1445">
                  <c:v>873.02099999999996</c:v>
                </c:pt>
                <c:pt idx="1446">
                  <c:v>873.625</c:v>
                </c:pt>
                <c:pt idx="1447">
                  <c:v>874.22900000000004</c:v>
                </c:pt>
                <c:pt idx="1448">
                  <c:v>874.83299999999974</c:v>
                </c:pt>
                <c:pt idx="1449">
                  <c:v>875.43799999999976</c:v>
                </c:pt>
                <c:pt idx="1450">
                  <c:v>876.0419999999998</c:v>
                </c:pt>
                <c:pt idx="1451">
                  <c:v>876.64599999999996</c:v>
                </c:pt>
                <c:pt idx="1452">
                  <c:v>877.25</c:v>
                </c:pt>
                <c:pt idx="1453">
                  <c:v>877.85399999999981</c:v>
                </c:pt>
                <c:pt idx="1454">
                  <c:v>878.45799999999974</c:v>
                </c:pt>
                <c:pt idx="1455">
                  <c:v>879.06299999999976</c:v>
                </c:pt>
                <c:pt idx="1456">
                  <c:v>879.6669999999998</c:v>
                </c:pt>
                <c:pt idx="1457">
                  <c:v>880.27099999999996</c:v>
                </c:pt>
                <c:pt idx="1458">
                  <c:v>880.875</c:v>
                </c:pt>
                <c:pt idx="1459">
                  <c:v>881.47900000000004</c:v>
                </c:pt>
                <c:pt idx="1460">
                  <c:v>882.08299999999997</c:v>
                </c:pt>
                <c:pt idx="1461">
                  <c:v>882.68799999999999</c:v>
                </c:pt>
                <c:pt idx="1462">
                  <c:v>883.29200000000003</c:v>
                </c:pt>
                <c:pt idx="1463">
                  <c:v>883.89599999999996</c:v>
                </c:pt>
                <c:pt idx="1464">
                  <c:v>884.5</c:v>
                </c:pt>
                <c:pt idx="1465">
                  <c:v>885.10400000000004</c:v>
                </c:pt>
                <c:pt idx="1466">
                  <c:v>885.70799999999997</c:v>
                </c:pt>
                <c:pt idx="1467">
                  <c:v>886.31299999999976</c:v>
                </c:pt>
                <c:pt idx="1468">
                  <c:v>886.9169999999998</c:v>
                </c:pt>
                <c:pt idx="1469">
                  <c:v>887.52099999999996</c:v>
                </c:pt>
                <c:pt idx="1470">
                  <c:v>888.125</c:v>
                </c:pt>
                <c:pt idx="1471">
                  <c:v>888.72900000000004</c:v>
                </c:pt>
                <c:pt idx="1472">
                  <c:v>889.33299999999974</c:v>
                </c:pt>
                <c:pt idx="1473">
                  <c:v>889.93799999999976</c:v>
                </c:pt>
                <c:pt idx="1474">
                  <c:v>890.5419999999998</c:v>
                </c:pt>
                <c:pt idx="1475">
                  <c:v>891.14599999999996</c:v>
                </c:pt>
                <c:pt idx="1476">
                  <c:v>891.75</c:v>
                </c:pt>
                <c:pt idx="1477">
                  <c:v>892.35399999999981</c:v>
                </c:pt>
                <c:pt idx="1478">
                  <c:v>892.95799999999974</c:v>
                </c:pt>
                <c:pt idx="1479">
                  <c:v>893.56299999999976</c:v>
                </c:pt>
                <c:pt idx="1480">
                  <c:v>894.1669999999998</c:v>
                </c:pt>
                <c:pt idx="1481">
                  <c:v>894.77099999999996</c:v>
                </c:pt>
                <c:pt idx="1482">
                  <c:v>895.375</c:v>
                </c:pt>
                <c:pt idx="1483">
                  <c:v>895.97900000000004</c:v>
                </c:pt>
                <c:pt idx="1484">
                  <c:v>896.58299999999997</c:v>
                </c:pt>
                <c:pt idx="1485">
                  <c:v>897.18799999999999</c:v>
                </c:pt>
                <c:pt idx="1486">
                  <c:v>897.79200000000003</c:v>
                </c:pt>
                <c:pt idx="1487">
                  <c:v>898.39599999999996</c:v>
                </c:pt>
                <c:pt idx="1488">
                  <c:v>899</c:v>
                </c:pt>
                <c:pt idx="1489">
                  <c:v>899.60400000000004</c:v>
                </c:pt>
                <c:pt idx="1490">
                  <c:v>900.20799999999997</c:v>
                </c:pt>
                <c:pt idx="1491">
                  <c:v>900.81299999999976</c:v>
                </c:pt>
                <c:pt idx="1492">
                  <c:v>901.4169999999998</c:v>
                </c:pt>
                <c:pt idx="1493">
                  <c:v>902.02099999999996</c:v>
                </c:pt>
                <c:pt idx="1494">
                  <c:v>902.625</c:v>
                </c:pt>
                <c:pt idx="1495">
                  <c:v>903.22900000000004</c:v>
                </c:pt>
                <c:pt idx="1496">
                  <c:v>903.83299999999974</c:v>
                </c:pt>
                <c:pt idx="1497">
                  <c:v>904.43799999999976</c:v>
                </c:pt>
                <c:pt idx="1498">
                  <c:v>905.0419999999998</c:v>
                </c:pt>
                <c:pt idx="1499">
                  <c:v>905.64599999999996</c:v>
                </c:pt>
                <c:pt idx="1500">
                  <c:v>906.25</c:v>
                </c:pt>
                <c:pt idx="1501">
                  <c:v>906.85399999999981</c:v>
                </c:pt>
                <c:pt idx="1502">
                  <c:v>907.45799999999974</c:v>
                </c:pt>
                <c:pt idx="1503">
                  <c:v>908.06299999999976</c:v>
                </c:pt>
                <c:pt idx="1504">
                  <c:v>908.6669999999998</c:v>
                </c:pt>
                <c:pt idx="1505">
                  <c:v>909.27099999999996</c:v>
                </c:pt>
                <c:pt idx="1506">
                  <c:v>909.875</c:v>
                </c:pt>
                <c:pt idx="1507">
                  <c:v>910.47900000000004</c:v>
                </c:pt>
                <c:pt idx="1508">
                  <c:v>911.08299999999997</c:v>
                </c:pt>
                <c:pt idx="1509">
                  <c:v>911.68799999999999</c:v>
                </c:pt>
                <c:pt idx="1510">
                  <c:v>912.29200000000003</c:v>
                </c:pt>
                <c:pt idx="1511">
                  <c:v>912.89599999999996</c:v>
                </c:pt>
                <c:pt idx="1512">
                  <c:v>913.5</c:v>
                </c:pt>
                <c:pt idx="1513">
                  <c:v>914.10400000000004</c:v>
                </c:pt>
                <c:pt idx="1514">
                  <c:v>914.70799999999997</c:v>
                </c:pt>
                <c:pt idx="1515">
                  <c:v>915.31299999999976</c:v>
                </c:pt>
                <c:pt idx="1516">
                  <c:v>915.9169999999998</c:v>
                </c:pt>
                <c:pt idx="1517">
                  <c:v>916.52099999999996</c:v>
                </c:pt>
                <c:pt idx="1518">
                  <c:v>917.125</c:v>
                </c:pt>
                <c:pt idx="1519">
                  <c:v>917.72900000000004</c:v>
                </c:pt>
                <c:pt idx="1520">
                  <c:v>918.33299999999974</c:v>
                </c:pt>
                <c:pt idx="1521">
                  <c:v>918.93799999999976</c:v>
                </c:pt>
                <c:pt idx="1522">
                  <c:v>919.5419999999998</c:v>
                </c:pt>
                <c:pt idx="1523">
                  <c:v>920.14599999999996</c:v>
                </c:pt>
                <c:pt idx="1524">
                  <c:v>920.75</c:v>
                </c:pt>
                <c:pt idx="1525">
                  <c:v>921.35399999999981</c:v>
                </c:pt>
                <c:pt idx="1526">
                  <c:v>921.95799999999974</c:v>
                </c:pt>
                <c:pt idx="1527">
                  <c:v>922.56299999999976</c:v>
                </c:pt>
                <c:pt idx="1528">
                  <c:v>923.1669999999998</c:v>
                </c:pt>
                <c:pt idx="1529">
                  <c:v>923.77099999999996</c:v>
                </c:pt>
                <c:pt idx="1530">
                  <c:v>924.375</c:v>
                </c:pt>
                <c:pt idx="1531">
                  <c:v>924.97900000000004</c:v>
                </c:pt>
                <c:pt idx="1532">
                  <c:v>925.58299999999997</c:v>
                </c:pt>
                <c:pt idx="1533">
                  <c:v>926.18799999999999</c:v>
                </c:pt>
                <c:pt idx="1534">
                  <c:v>926.79200000000003</c:v>
                </c:pt>
                <c:pt idx="1535">
                  <c:v>927.39599999999996</c:v>
                </c:pt>
                <c:pt idx="1536">
                  <c:v>928</c:v>
                </c:pt>
                <c:pt idx="1537">
                  <c:v>928.60400000000004</c:v>
                </c:pt>
                <c:pt idx="1538">
                  <c:v>929.20799999999997</c:v>
                </c:pt>
                <c:pt idx="1539">
                  <c:v>929.81299999999976</c:v>
                </c:pt>
                <c:pt idx="1540">
                  <c:v>930.4169999999998</c:v>
                </c:pt>
                <c:pt idx="1541">
                  <c:v>931.02099999999996</c:v>
                </c:pt>
                <c:pt idx="1542">
                  <c:v>931.625</c:v>
                </c:pt>
                <c:pt idx="1543">
                  <c:v>932.22900000000004</c:v>
                </c:pt>
                <c:pt idx="1544">
                  <c:v>932.83299999999974</c:v>
                </c:pt>
                <c:pt idx="1545">
                  <c:v>933.43799999999976</c:v>
                </c:pt>
                <c:pt idx="1546">
                  <c:v>934.0419999999998</c:v>
                </c:pt>
                <c:pt idx="1547">
                  <c:v>934.64599999999996</c:v>
                </c:pt>
                <c:pt idx="1548">
                  <c:v>935.25</c:v>
                </c:pt>
                <c:pt idx="1549">
                  <c:v>935.85399999999981</c:v>
                </c:pt>
                <c:pt idx="1550">
                  <c:v>936.45799999999974</c:v>
                </c:pt>
                <c:pt idx="1551">
                  <c:v>937.06299999999976</c:v>
                </c:pt>
                <c:pt idx="1552">
                  <c:v>937.6669999999998</c:v>
                </c:pt>
                <c:pt idx="1553">
                  <c:v>938.27099999999996</c:v>
                </c:pt>
                <c:pt idx="1554">
                  <c:v>938.875</c:v>
                </c:pt>
                <c:pt idx="1555">
                  <c:v>939.47900000000004</c:v>
                </c:pt>
                <c:pt idx="1556">
                  <c:v>940.08299999999997</c:v>
                </c:pt>
                <c:pt idx="1557">
                  <c:v>940.68799999999999</c:v>
                </c:pt>
                <c:pt idx="1558">
                  <c:v>941.29200000000003</c:v>
                </c:pt>
                <c:pt idx="1559">
                  <c:v>941.89599999999996</c:v>
                </c:pt>
                <c:pt idx="1560">
                  <c:v>942.5</c:v>
                </c:pt>
                <c:pt idx="1561">
                  <c:v>943.10400000000004</c:v>
                </c:pt>
                <c:pt idx="1562">
                  <c:v>943.70799999999997</c:v>
                </c:pt>
                <c:pt idx="1563">
                  <c:v>944.31299999999976</c:v>
                </c:pt>
                <c:pt idx="1564">
                  <c:v>944.9169999999998</c:v>
                </c:pt>
                <c:pt idx="1565">
                  <c:v>945.52099999999996</c:v>
                </c:pt>
                <c:pt idx="1566">
                  <c:v>946.125</c:v>
                </c:pt>
                <c:pt idx="1567">
                  <c:v>946.72900000000004</c:v>
                </c:pt>
                <c:pt idx="1568">
                  <c:v>947.33299999999974</c:v>
                </c:pt>
                <c:pt idx="1569">
                  <c:v>947.93799999999976</c:v>
                </c:pt>
                <c:pt idx="1570">
                  <c:v>948.5419999999998</c:v>
                </c:pt>
                <c:pt idx="1571">
                  <c:v>949.14599999999996</c:v>
                </c:pt>
                <c:pt idx="1572">
                  <c:v>949.75</c:v>
                </c:pt>
                <c:pt idx="1573">
                  <c:v>950.35399999999981</c:v>
                </c:pt>
                <c:pt idx="1574">
                  <c:v>950.95799999999974</c:v>
                </c:pt>
                <c:pt idx="1575">
                  <c:v>951.56299999999976</c:v>
                </c:pt>
                <c:pt idx="1576">
                  <c:v>952.1669999999998</c:v>
                </c:pt>
                <c:pt idx="1577">
                  <c:v>952.77099999999996</c:v>
                </c:pt>
                <c:pt idx="1578">
                  <c:v>953.375</c:v>
                </c:pt>
                <c:pt idx="1579">
                  <c:v>953.97900000000004</c:v>
                </c:pt>
                <c:pt idx="1580">
                  <c:v>954.58299999999997</c:v>
                </c:pt>
                <c:pt idx="1581">
                  <c:v>955.18799999999999</c:v>
                </c:pt>
                <c:pt idx="1582">
                  <c:v>955.79200000000003</c:v>
                </c:pt>
                <c:pt idx="1583">
                  <c:v>956.39599999999996</c:v>
                </c:pt>
                <c:pt idx="1584">
                  <c:v>957</c:v>
                </c:pt>
                <c:pt idx="1585">
                  <c:v>957.60400000000004</c:v>
                </c:pt>
                <c:pt idx="1586">
                  <c:v>958.20799999999997</c:v>
                </c:pt>
                <c:pt idx="1587">
                  <c:v>958.81299999999976</c:v>
                </c:pt>
                <c:pt idx="1588">
                  <c:v>959.4169999999998</c:v>
                </c:pt>
                <c:pt idx="1589">
                  <c:v>960.02099999999996</c:v>
                </c:pt>
                <c:pt idx="1590">
                  <c:v>960.625</c:v>
                </c:pt>
                <c:pt idx="1591">
                  <c:v>961.22900000000004</c:v>
                </c:pt>
                <c:pt idx="1592">
                  <c:v>961.83299999999974</c:v>
                </c:pt>
                <c:pt idx="1593">
                  <c:v>962.43799999999976</c:v>
                </c:pt>
                <c:pt idx="1594">
                  <c:v>963.0419999999998</c:v>
                </c:pt>
                <c:pt idx="1595">
                  <c:v>963.64599999999996</c:v>
                </c:pt>
                <c:pt idx="1596">
                  <c:v>964.25</c:v>
                </c:pt>
                <c:pt idx="1597">
                  <c:v>964.85399999999981</c:v>
                </c:pt>
                <c:pt idx="1598">
                  <c:v>965.45799999999974</c:v>
                </c:pt>
                <c:pt idx="1599">
                  <c:v>966.06299999999976</c:v>
                </c:pt>
                <c:pt idx="1600">
                  <c:v>966.6669999999998</c:v>
                </c:pt>
                <c:pt idx="1601">
                  <c:v>967.27099999999996</c:v>
                </c:pt>
                <c:pt idx="1602">
                  <c:v>967.875</c:v>
                </c:pt>
                <c:pt idx="1603">
                  <c:v>968.47900000000004</c:v>
                </c:pt>
                <c:pt idx="1604">
                  <c:v>969.08299999999997</c:v>
                </c:pt>
                <c:pt idx="1605">
                  <c:v>969.68799999999999</c:v>
                </c:pt>
                <c:pt idx="1606">
                  <c:v>970.29200000000003</c:v>
                </c:pt>
                <c:pt idx="1607">
                  <c:v>970.89599999999996</c:v>
                </c:pt>
                <c:pt idx="1608">
                  <c:v>971.5</c:v>
                </c:pt>
                <c:pt idx="1609">
                  <c:v>972.10400000000004</c:v>
                </c:pt>
                <c:pt idx="1610">
                  <c:v>972.70799999999997</c:v>
                </c:pt>
                <c:pt idx="1611">
                  <c:v>973.31299999999976</c:v>
                </c:pt>
                <c:pt idx="1612">
                  <c:v>973.9169999999998</c:v>
                </c:pt>
                <c:pt idx="1613">
                  <c:v>974.52099999999996</c:v>
                </c:pt>
                <c:pt idx="1614">
                  <c:v>975.125</c:v>
                </c:pt>
                <c:pt idx="1615">
                  <c:v>975.72900000000004</c:v>
                </c:pt>
                <c:pt idx="1616">
                  <c:v>976.33299999999974</c:v>
                </c:pt>
                <c:pt idx="1617">
                  <c:v>976.93799999999976</c:v>
                </c:pt>
                <c:pt idx="1618">
                  <c:v>977.5419999999998</c:v>
                </c:pt>
                <c:pt idx="1619">
                  <c:v>978.14599999999996</c:v>
                </c:pt>
                <c:pt idx="1620">
                  <c:v>978.75</c:v>
                </c:pt>
                <c:pt idx="1621">
                  <c:v>979.35399999999981</c:v>
                </c:pt>
                <c:pt idx="1622">
                  <c:v>979.95799999999974</c:v>
                </c:pt>
                <c:pt idx="1623">
                  <c:v>980.56299999999976</c:v>
                </c:pt>
                <c:pt idx="1624">
                  <c:v>981.1669999999998</c:v>
                </c:pt>
                <c:pt idx="1625">
                  <c:v>981.77099999999996</c:v>
                </c:pt>
                <c:pt idx="1626">
                  <c:v>982.375</c:v>
                </c:pt>
                <c:pt idx="1627">
                  <c:v>982.97900000000004</c:v>
                </c:pt>
                <c:pt idx="1628">
                  <c:v>983.58299999999997</c:v>
                </c:pt>
                <c:pt idx="1629">
                  <c:v>984.18799999999999</c:v>
                </c:pt>
                <c:pt idx="1630">
                  <c:v>984.79200000000003</c:v>
                </c:pt>
                <c:pt idx="1631">
                  <c:v>985.39599999999996</c:v>
                </c:pt>
                <c:pt idx="1632">
                  <c:v>986</c:v>
                </c:pt>
                <c:pt idx="1633">
                  <c:v>986.60400000000004</c:v>
                </c:pt>
                <c:pt idx="1634">
                  <c:v>987.20799999999997</c:v>
                </c:pt>
                <c:pt idx="1635">
                  <c:v>987.81299999999976</c:v>
                </c:pt>
                <c:pt idx="1636">
                  <c:v>988.4169999999998</c:v>
                </c:pt>
                <c:pt idx="1637">
                  <c:v>989.02099999999996</c:v>
                </c:pt>
                <c:pt idx="1638">
                  <c:v>989.625</c:v>
                </c:pt>
                <c:pt idx="1639">
                  <c:v>990.22900000000004</c:v>
                </c:pt>
                <c:pt idx="1640">
                  <c:v>990.83299999999974</c:v>
                </c:pt>
                <c:pt idx="1641">
                  <c:v>991.43799999999976</c:v>
                </c:pt>
                <c:pt idx="1642">
                  <c:v>992.0419999999998</c:v>
                </c:pt>
                <c:pt idx="1643">
                  <c:v>992.64599999999996</c:v>
                </c:pt>
                <c:pt idx="1644">
                  <c:v>993.25</c:v>
                </c:pt>
                <c:pt idx="1645">
                  <c:v>993.85399999999981</c:v>
                </c:pt>
                <c:pt idx="1646">
                  <c:v>994.45799999999974</c:v>
                </c:pt>
                <c:pt idx="1647">
                  <c:v>995.06299999999976</c:v>
                </c:pt>
                <c:pt idx="1648">
                  <c:v>995.6669999999998</c:v>
                </c:pt>
                <c:pt idx="1649">
                  <c:v>996.27099999999996</c:v>
                </c:pt>
                <c:pt idx="1650">
                  <c:v>996.875</c:v>
                </c:pt>
                <c:pt idx="1651">
                  <c:v>997.47900000000004</c:v>
                </c:pt>
                <c:pt idx="1652">
                  <c:v>998.08299999999997</c:v>
                </c:pt>
                <c:pt idx="1653">
                  <c:v>998.68799999999999</c:v>
                </c:pt>
                <c:pt idx="1654">
                  <c:v>999.29200000000003</c:v>
                </c:pt>
                <c:pt idx="1655">
                  <c:v>999.89599999999996</c:v>
                </c:pt>
                <c:pt idx="1656">
                  <c:v>1000.5</c:v>
                </c:pt>
                <c:pt idx="1657">
                  <c:v>1001.104</c:v>
                </c:pt>
                <c:pt idx="1658">
                  <c:v>1001.708</c:v>
                </c:pt>
                <c:pt idx="1659">
                  <c:v>1002.313</c:v>
                </c:pt>
                <c:pt idx="1660">
                  <c:v>1002.917</c:v>
                </c:pt>
                <c:pt idx="1661">
                  <c:v>1003.521</c:v>
                </c:pt>
                <c:pt idx="1662">
                  <c:v>1004.125</c:v>
                </c:pt>
                <c:pt idx="1663">
                  <c:v>1004.729</c:v>
                </c:pt>
                <c:pt idx="1664">
                  <c:v>1005.333</c:v>
                </c:pt>
                <c:pt idx="1665">
                  <c:v>1005.938</c:v>
                </c:pt>
                <c:pt idx="1666">
                  <c:v>1006.542</c:v>
                </c:pt>
                <c:pt idx="1667">
                  <c:v>1007.146</c:v>
                </c:pt>
                <c:pt idx="1668">
                  <c:v>1007.75</c:v>
                </c:pt>
                <c:pt idx="1669">
                  <c:v>1008.354</c:v>
                </c:pt>
                <c:pt idx="1670">
                  <c:v>1008.958</c:v>
                </c:pt>
                <c:pt idx="1671">
                  <c:v>1009.563</c:v>
                </c:pt>
                <c:pt idx="1672">
                  <c:v>1010.167</c:v>
                </c:pt>
                <c:pt idx="1673">
                  <c:v>1010.771</c:v>
                </c:pt>
                <c:pt idx="1674">
                  <c:v>1011.375</c:v>
                </c:pt>
                <c:pt idx="1675">
                  <c:v>1011.979</c:v>
                </c:pt>
                <c:pt idx="1676">
                  <c:v>1012.583</c:v>
                </c:pt>
                <c:pt idx="1677">
                  <c:v>1013.188</c:v>
                </c:pt>
                <c:pt idx="1678">
                  <c:v>1013.792</c:v>
                </c:pt>
                <c:pt idx="1679">
                  <c:v>1014.396</c:v>
                </c:pt>
                <c:pt idx="1680">
                  <c:v>1015</c:v>
                </c:pt>
                <c:pt idx="1681">
                  <c:v>1015.604</c:v>
                </c:pt>
                <c:pt idx="1682">
                  <c:v>1016.208</c:v>
                </c:pt>
                <c:pt idx="1683">
                  <c:v>1016.813</c:v>
                </c:pt>
                <c:pt idx="1684">
                  <c:v>1017.417</c:v>
                </c:pt>
                <c:pt idx="1685">
                  <c:v>1018.021</c:v>
                </c:pt>
                <c:pt idx="1686">
                  <c:v>1018.625</c:v>
                </c:pt>
                <c:pt idx="1687">
                  <c:v>1019.229</c:v>
                </c:pt>
                <c:pt idx="1688">
                  <c:v>1019.833</c:v>
                </c:pt>
                <c:pt idx="1689">
                  <c:v>1020.438</c:v>
                </c:pt>
                <c:pt idx="1690">
                  <c:v>1021.042</c:v>
                </c:pt>
                <c:pt idx="1691">
                  <c:v>1021.646</c:v>
                </c:pt>
                <c:pt idx="1692">
                  <c:v>1022.25</c:v>
                </c:pt>
                <c:pt idx="1693">
                  <c:v>1022.854</c:v>
                </c:pt>
                <c:pt idx="1694">
                  <c:v>1023.458</c:v>
                </c:pt>
                <c:pt idx="1695">
                  <c:v>1024.0630000000001</c:v>
                </c:pt>
                <c:pt idx="1696">
                  <c:v>1024.6669999999999</c:v>
                </c:pt>
                <c:pt idx="1697">
                  <c:v>1025.271</c:v>
                </c:pt>
                <c:pt idx="1698">
                  <c:v>1025.875</c:v>
                </c:pt>
                <c:pt idx="1699">
                  <c:v>1026.479</c:v>
                </c:pt>
                <c:pt idx="1700">
                  <c:v>1027.0830000000001</c:v>
                </c:pt>
                <c:pt idx="1701">
                  <c:v>1027.6880000000001</c:v>
                </c:pt>
                <c:pt idx="1702">
                  <c:v>1028.2919999999999</c:v>
                </c:pt>
                <c:pt idx="1703">
                  <c:v>1028.896</c:v>
                </c:pt>
                <c:pt idx="1704">
                  <c:v>1029.5</c:v>
                </c:pt>
                <c:pt idx="1705">
                  <c:v>1030.104</c:v>
                </c:pt>
                <c:pt idx="1706">
                  <c:v>1030.7080000000001</c:v>
                </c:pt>
                <c:pt idx="1707">
                  <c:v>1031.3130000000001</c:v>
                </c:pt>
                <c:pt idx="1708">
                  <c:v>1031.9169999999999</c:v>
                </c:pt>
                <c:pt idx="1709">
                  <c:v>1032.521</c:v>
                </c:pt>
                <c:pt idx="1710">
                  <c:v>1033.125</c:v>
                </c:pt>
                <c:pt idx="1711">
                  <c:v>1033.729</c:v>
                </c:pt>
                <c:pt idx="1712">
                  <c:v>1034.3330000000001</c:v>
                </c:pt>
                <c:pt idx="1713">
                  <c:v>1034.9380000000001</c:v>
                </c:pt>
                <c:pt idx="1714">
                  <c:v>1035.5419999999999</c:v>
                </c:pt>
                <c:pt idx="1715">
                  <c:v>1036.146</c:v>
                </c:pt>
                <c:pt idx="1716">
                  <c:v>1036.75</c:v>
                </c:pt>
                <c:pt idx="1717">
                  <c:v>1037.354</c:v>
                </c:pt>
                <c:pt idx="1718">
                  <c:v>1037.9580000000001</c:v>
                </c:pt>
                <c:pt idx="1719">
                  <c:v>1038.5630000000001</c:v>
                </c:pt>
                <c:pt idx="1720">
                  <c:v>1039.1669999999999</c:v>
                </c:pt>
                <c:pt idx="1721">
                  <c:v>1039.771</c:v>
                </c:pt>
                <c:pt idx="1722">
                  <c:v>1040.375</c:v>
                </c:pt>
                <c:pt idx="1723">
                  <c:v>1040.979</c:v>
                </c:pt>
                <c:pt idx="1724">
                  <c:v>1041.5830000000001</c:v>
                </c:pt>
                <c:pt idx="1725">
                  <c:v>1042.1880000000001</c:v>
                </c:pt>
                <c:pt idx="1726">
                  <c:v>1042.7919999999999</c:v>
                </c:pt>
                <c:pt idx="1727">
                  <c:v>1043.396</c:v>
                </c:pt>
                <c:pt idx="1728">
                  <c:v>1044</c:v>
                </c:pt>
                <c:pt idx="1729">
                  <c:v>1044.604</c:v>
                </c:pt>
                <c:pt idx="1730">
                  <c:v>1045.2080000000001</c:v>
                </c:pt>
                <c:pt idx="1731">
                  <c:v>1045.8130000000001</c:v>
                </c:pt>
                <c:pt idx="1732">
                  <c:v>1046.4169999999999</c:v>
                </c:pt>
                <c:pt idx="1733">
                  <c:v>1047.021</c:v>
                </c:pt>
              </c:numCache>
            </c:numRef>
          </c:xVal>
          <c:yVal>
            <c:numRef>
              <c:f>Sheet1!$B$2:$B$1739</c:f>
              <c:numCache>
                <c:formatCode>0.00E+00</c:formatCode>
                <c:ptCount val="1738"/>
                <c:pt idx="0">
                  <c:v>0.76200000000000001</c:v>
                </c:pt>
                <c:pt idx="1">
                  <c:v>0.76200000000000001</c:v>
                </c:pt>
                <c:pt idx="2">
                  <c:v>0.76200000000000001</c:v>
                </c:pt>
                <c:pt idx="3">
                  <c:v>0.76200000000000001</c:v>
                </c:pt>
                <c:pt idx="4">
                  <c:v>0.76200000000000001</c:v>
                </c:pt>
                <c:pt idx="5">
                  <c:v>0.76200000000000001</c:v>
                </c:pt>
                <c:pt idx="6">
                  <c:v>0.76200000000000001</c:v>
                </c:pt>
                <c:pt idx="7">
                  <c:v>0.76200000000000001</c:v>
                </c:pt>
                <c:pt idx="8">
                  <c:v>0.76200000000000001</c:v>
                </c:pt>
                <c:pt idx="9">
                  <c:v>0.76200000000000001</c:v>
                </c:pt>
                <c:pt idx="10">
                  <c:v>0.76200000000000001</c:v>
                </c:pt>
                <c:pt idx="11">
                  <c:v>0.76200000000000001</c:v>
                </c:pt>
                <c:pt idx="12">
                  <c:v>0.76100000000000001</c:v>
                </c:pt>
                <c:pt idx="13">
                  <c:v>0.76200000000000001</c:v>
                </c:pt>
                <c:pt idx="14">
                  <c:v>0.76100000000000001</c:v>
                </c:pt>
                <c:pt idx="15">
                  <c:v>0.76100000000000001</c:v>
                </c:pt>
                <c:pt idx="16">
                  <c:v>0.76100000000000001</c:v>
                </c:pt>
                <c:pt idx="17">
                  <c:v>0.76100000000000001</c:v>
                </c:pt>
                <c:pt idx="18">
                  <c:v>0.76100000000000001</c:v>
                </c:pt>
                <c:pt idx="19">
                  <c:v>0.76100000000000001</c:v>
                </c:pt>
                <c:pt idx="20">
                  <c:v>0.76100000000000001</c:v>
                </c:pt>
                <c:pt idx="21">
                  <c:v>0.76200000000000001</c:v>
                </c:pt>
                <c:pt idx="22">
                  <c:v>0.76200000000000001</c:v>
                </c:pt>
                <c:pt idx="23">
                  <c:v>0.76200000000000001</c:v>
                </c:pt>
                <c:pt idx="24">
                  <c:v>0.76200000000000001</c:v>
                </c:pt>
                <c:pt idx="25">
                  <c:v>0.76200000000000001</c:v>
                </c:pt>
                <c:pt idx="26">
                  <c:v>0.76200000000000001</c:v>
                </c:pt>
                <c:pt idx="27">
                  <c:v>0.76200000000000001</c:v>
                </c:pt>
                <c:pt idx="28">
                  <c:v>0.76200000000000001</c:v>
                </c:pt>
                <c:pt idx="29">
                  <c:v>0.76200000000000001</c:v>
                </c:pt>
                <c:pt idx="30">
                  <c:v>0.76200000000000001</c:v>
                </c:pt>
                <c:pt idx="31">
                  <c:v>0.76200000000000001</c:v>
                </c:pt>
                <c:pt idx="32">
                  <c:v>0.76200000000000001</c:v>
                </c:pt>
                <c:pt idx="33">
                  <c:v>0.76200000000000001</c:v>
                </c:pt>
                <c:pt idx="34">
                  <c:v>0.76200000000000001</c:v>
                </c:pt>
                <c:pt idx="35">
                  <c:v>0.76100000000000001</c:v>
                </c:pt>
                <c:pt idx="36">
                  <c:v>0.76200000000000001</c:v>
                </c:pt>
                <c:pt idx="37">
                  <c:v>0.76200000000000001</c:v>
                </c:pt>
                <c:pt idx="38">
                  <c:v>0.76200000000000001</c:v>
                </c:pt>
                <c:pt idx="39">
                  <c:v>0.76200000000000001</c:v>
                </c:pt>
                <c:pt idx="40">
                  <c:v>0.76200000000000001</c:v>
                </c:pt>
                <c:pt idx="41">
                  <c:v>0.76200000000000001</c:v>
                </c:pt>
                <c:pt idx="42">
                  <c:v>0.76200000000000001</c:v>
                </c:pt>
                <c:pt idx="43">
                  <c:v>0.76200000000000001</c:v>
                </c:pt>
                <c:pt idx="44">
                  <c:v>0.76200000000000001</c:v>
                </c:pt>
                <c:pt idx="45">
                  <c:v>0.76200000000000001</c:v>
                </c:pt>
                <c:pt idx="46">
                  <c:v>0.76200000000000001</c:v>
                </c:pt>
                <c:pt idx="47">
                  <c:v>0.76200000000000001</c:v>
                </c:pt>
                <c:pt idx="48">
                  <c:v>0.76200000000000001</c:v>
                </c:pt>
                <c:pt idx="49">
                  <c:v>0.76200000000000001</c:v>
                </c:pt>
                <c:pt idx="50">
                  <c:v>0.76200000000000001</c:v>
                </c:pt>
                <c:pt idx="51">
                  <c:v>0.76200000000000001</c:v>
                </c:pt>
                <c:pt idx="52">
                  <c:v>0.76200000000000001</c:v>
                </c:pt>
                <c:pt idx="53">
                  <c:v>0.76200000000000001</c:v>
                </c:pt>
                <c:pt idx="54">
                  <c:v>0.76200000000000001</c:v>
                </c:pt>
                <c:pt idx="55">
                  <c:v>0.76200000000000001</c:v>
                </c:pt>
                <c:pt idx="56">
                  <c:v>0.76200000000000001</c:v>
                </c:pt>
                <c:pt idx="57">
                  <c:v>0.76200000000000001</c:v>
                </c:pt>
                <c:pt idx="58">
                  <c:v>0.76200000000000001</c:v>
                </c:pt>
                <c:pt idx="59">
                  <c:v>0.76200000000000001</c:v>
                </c:pt>
                <c:pt idx="60">
                  <c:v>0.76300000000000001</c:v>
                </c:pt>
                <c:pt idx="61">
                  <c:v>0.76200000000000001</c:v>
                </c:pt>
                <c:pt idx="62">
                  <c:v>0.76200000000000001</c:v>
                </c:pt>
                <c:pt idx="63">
                  <c:v>0.76300000000000001</c:v>
                </c:pt>
                <c:pt idx="64">
                  <c:v>0.76300000000000001</c:v>
                </c:pt>
                <c:pt idx="65">
                  <c:v>0.76300000000000001</c:v>
                </c:pt>
                <c:pt idx="66">
                  <c:v>0.76300000000000001</c:v>
                </c:pt>
                <c:pt idx="67">
                  <c:v>0.76300000000000001</c:v>
                </c:pt>
                <c:pt idx="68">
                  <c:v>0.76300000000000001</c:v>
                </c:pt>
                <c:pt idx="69">
                  <c:v>0.76300000000000001</c:v>
                </c:pt>
                <c:pt idx="70">
                  <c:v>0.76300000000000001</c:v>
                </c:pt>
                <c:pt idx="71">
                  <c:v>0.76300000000000001</c:v>
                </c:pt>
                <c:pt idx="72">
                  <c:v>0.76300000000000001</c:v>
                </c:pt>
                <c:pt idx="73">
                  <c:v>0.76300000000000001</c:v>
                </c:pt>
                <c:pt idx="74">
                  <c:v>0.76300000000000001</c:v>
                </c:pt>
                <c:pt idx="75">
                  <c:v>0.76200000000000001</c:v>
                </c:pt>
                <c:pt idx="76">
                  <c:v>0.76200000000000001</c:v>
                </c:pt>
                <c:pt idx="77">
                  <c:v>0.76200000000000001</c:v>
                </c:pt>
                <c:pt idx="78">
                  <c:v>0.76300000000000001</c:v>
                </c:pt>
                <c:pt idx="79">
                  <c:v>0.76300000000000001</c:v>
                </c:pt>
                <c:pt idx="80">
                  <c:v>0.76300000000000001</c:v>
                </c:pt>
                <c:pt idx="81">
                  <c:v>0.76200000000000001</c:v>
                </c:pt>
                <c:pt idx="82">
                  <c:v>0.76300000000000001</c:v>
                </c:pt>
                <c:pt idx="83">
                  <c:v>0.76300000000000001</c:v>
                </c:pt>
                <c:pt idx="84">
                  <c:v>0.76300000000000001</c:v>
                </c:pt>
                <c:pt idx="85">
                  <c:v>0.76300000000000001</c:v>
                </c:pt>
                <c:pt idx="86">
                  <c:v>0.76300000000000001</c:v>
                </c:pt>
                <c:pt idx="87">
                  <c:v>0.76200000000000001</c:v>
                </c:pt>
                <c:pt idx="88">
                  <c:v>0.76300000000000001</c:v>
                </c:pt>
                <c:pt idx="89">
                  <c:v>0.76300000000000001</c:v>
                </c:pt>
                <c:pt idx="90">
                  <c:v>0.76300000000000001</c:v>
                </c:pt>
                <c:pt idx="91">
                  <c:v>0.76300000000000001</c:v>
                </c:pt>
                <c:pt idx="92">
                  <c:v>0.76300000000000001</c:v>
                </c:pt>
                <c:pt idx="93">
                  <c:v>0.76300000000000001</c:v>
                </c:pt>
                <c:pt idx="94">
                  <c:v>0.76300000000000001</c:v>
                </c:pt>
                <c:pt idx="95">
                  <c:v>0.76300000000000001</c:v>
                </c:pt>
                <c:pt idx="96">
                  <c:v>0.76200000000000001</c:v>
                </c:pt>
                <c:pt idx="97">
                  <c:v>0.76300000000000001</c:v>
                </c:pt>
                <c:pt idx="98">
                  <c:v>0.76300000000000001</c:v>
                </c:pt>
                <c:pt idx="99">
                  <c:v>0.76300000000000001</c:v>
                </c:pt>
                <c:pt idx="100">
                  <c:v>0.76200000000000001</c:v>
                </c:pt>
                <c:pt idx="101">
                  <c:v>0.76300000000000001</c:v>
                </c:pt>
                <c:pt idx="102">
                  <c:v>0.76300000000000001</c:v>
                </c:pt>
                <c:pt idx="103">
                  <c:v>0.76300000000000001</c:v>
                </c:pt>
                <c:pt idx="104">
                  <c:v>0.76200000000000001</c:v>
                </c:pt>
                <c:pt idx="105">
                  <c:v>0.76300000000000001</c:v>
                </c:pt>
                <c:pt idx="106">
                  <c:v>0.76300000000000001</c:v>
                </c:pt>
                <c:pt idx="107">
                  <c:v>0.76200000000000001</c:v>
                </c:pt>
                <c:pt idx="108">
                  <c:v>0.76200000000000001</c:v>
                </c:pt>
                <c:pt idx="109">
                  <c:v>0.76200000000000001</c:v>
                </c:pt>
                <c:pt idx="110">
                  <c:v>0.76300000000000001</c:v>
                </c:pt>
                <c:pt idx="111">
                  <c:v>0.76300000000000001</c:v>
                </c:pt>
                <c:pt idx="112">
                  <c:v>0.76200000000000001</c:v>
                </c:pt>
                <c:pt idx="113">
                  <c:v>0.76300000000000001</c:v>
                </c:pt>
                <c:pt idx="114">
                  <c:v>0.76300000000000001</c:v>
                </c:pt>
                <c:pt idx="115">
                  <c:v>0.76300000000000001</c:v>
                </c:pt>
                <c:pt idx="116">
                  <c:v>0.76300000000000001</c:v>
                </c:pt>
                <c:pt idx="117">
                  <c:v>0.76300000000000001</c:v>
                </c:pt>
                <c:pt idx="118">
                  <c:v>0.76300000000000001</c:v>
                </c:pt>
                <c:pt idx="119">
                  <c:v>0.76300000000000001</c:v>
                </c:pt>
                <c:pt idx="120">
                  <c:v>0.76300000000000001</c:v>
                </c:pt>
                <c:pt idx="121">
                  <c:v>0.76300000000000001</c:v>
                </c:pt>
                <c:pt idx="122">
                  <c:v>0.76300000000000001</c:v>
                </c:pt>
                <c:pt idx="123">
                  <c:v>0.76300000000000001</c:v>
                </c:pt>
                <c:pt idx="124">
                  <c:v>0.76300000000000001</c:v>
                </c:pt>
                <c:pt idx="125">
                  <c:v>0.76300000000000001</c:v>
                </c:pt>
                <c:pt idx="126">
                  <c:v>0.76300000000000001</c:v>
                </c:pt>
                <c:pt idx="127">
                  <c:v>0.76300000000000001</c:v>
                </c:pt>
                <c:pt idx="128">
                  <c:v>0.76300000000000001</c:v>
                </c:pt>
                <c:pt idx="129">
                  <c:v>0.76300000000000001</c:v>
                </c:pt>
                <c:pt idx="130">
                  <c:v>0.76300000000000001</c:v>
                </c:pt>
                <c:pt idx="131">
                  <c:v>0.76300000000000001</c:v>
                </c:pt>
                <c:pt idx="132">
                  <c:v>0.76300000000000001</c:v>
                </c:pt>
                <c:pt idx="133">
                  <c:v>0.76300000000000001</c:v>
                </c:pt>
                <c:pt idx="134">
                  <c:v>0.76300000000000001</c:v>
                </c:pt>
                <c:pt idx="135">
                  <c:v>0.76300000000000001</c:v>
                </c:pt>
                <c:pt idx="136">
                  <c:v>0.76300000000000001</c:v>
                </c:pt>
                <c:pt idx="137">
                  <c:v>0.76300000000000001</c:v>
                </c:pt>
                <c:pt idx="138">
                  <c:v>0.76300000000000001</c:v>
                </c:pt>
                <c:pt idx="139">
                  <c:v>0.76200000000000001</c:v>
                </c:pt>
                <c:pt idx="140">
                  <c:v>0.76300000000000001</c:v>
                </c:pt>
                <c:pt idx="141">
                  <c:v>0.76300000000000001</c:v>
                </c:pt>
                <c:pt idx="142">
                  <c:v>0.76300000000000001</c:v>
                </c:pt>
                <c:pt idx="143">
                  <c:v>0.76300000000000001</c:v>
                </c:pt>
                <c:pt idx="144">
                  <c:v>0.76300000000000001</c:v>
                </c:pt>
                <c:pt idx="145">
                  <c:v>0.76300000000000001</c:v>
                </c:pt>
                <c:pt idx="146">
                  <c:v>0.76300000000000001</c:v>
                </c:pt>
                <c:pt idx="147">
                  <c:v>0.76300000000000001</c:v>
                </c:pt>
                <c:pt idx="148">
                  <c:v>0.76300000000000001</c:v>
                </c:pt>
                <c:pt idx="149">
                  <c:v>0.76300000000000001</c:v>
                </c:pt>
                <c:pt idx="150">
                  <c:v>0.76300000000000001</c:v>
                </c:pt>
                <c:pt idx="151">
                  <c:v>0.76300000000000001</c:v>
                </c:pt>
                <c:pt idx="152">
                  <c:v>0.76300000000000001</c:v>
                </c:pt>
                <c:pt idx="153">
                  <c:v>0.76300000000000001</c:v>
                </c:pt>
                <c:pt idx="154">
                  <c:v>0.76300000000000001</c:v>
                </c:pt>
                <c:pt idx="155">
                  <c:v>0.76300000000000001</c:v>
                </c:pt>
                <c:pt idx="156">
                  <c:v>0.76300000000000001</c:v>
                </c:pt>
                <c:pt idx="157">
                  <c:v>0.76300000000000001</c:v>
                </c:pt>
                <c:pt idx="158">
                  <c:v>0.76300000000000001</c:v>
                </c:pt>
                <c:pt idx="159">
                  <c:v>0.76300000000000001</c:v>
                </c:pt>
                <c:pt idx="160">
                  <c:v>0.76300000000000001</c:v>
                </c:pt>
                <c:pt idx="161">
                  <c:v>0.76300000000000001</c:v>
                </c:pt>
                <c:pt idx="162">
                  <c:v>0.76300000000000001</c:v>
                </c:pt>
                <c:pt idx="163">
                  <c:v>0.76300000000000001</c:v>
                </c:pt>
                <c:pt idx="164">
                  <c:v>0.76300000000000001</c:v>
                </c:pt>
                <c:pt idx="165">
                  <c:v>0.76300000000000001</c:v>
                </c:pt>
                <c:pt idx="166">
                  <c:v>0.76300000000000001</c:v>
                </c:pt>
                <c:pt idx="167">
                  <c:v>0.76300000000000001</c:v>
                </c:pt>
                <c:pt idx="168">
                  <c:v>0.76300000000000001</c:v>
                </c:pt>
                <c:pt idx="169">
                  <c:v>0.76300000000000001</c:v>
                </c:pt>
                <c:pt idx="170">
                  <c:v>0.76300000000000001</c:v>
                </c:pt>
                <c:pt idx="171">
                  <c:v>0.76300000000000001</c:v>
                </c:pt>
                <c:pt idx="172">
                  <c:v>0.76300000000000001</c:v>
                </c:pt>
                <c:pt idx="173">
                  <c:v>0.76300000000000001</c:v>
                </c:pt>
                <c:pt idx="174">
                  <c:v>0.76300000000000001</c:v>
                </c:pt>
                <c:pt idx="175">
                  <c:v>0.76300000000000001</c:v>
                </c:pt>
                <c:pt idx="176">
                  <c:v>0.76300000000000001</c:v>
                </c:pt>
                <c:pt idx="177">
                  <c:v>0.76300000000000001</c:v>
                </c:pt>
                <c:pt idx="178">
                  <c:v>0.76300000000000001</c:v>
                </c:pt>
                <c:pt idx="179">
                  <c:v>0.76300000000000001</c:v>
                </c:pt>
                <c:pt idx="180">
                  <c:v>0.76300000000000001</c:v>
                </c:pt>
                <c:pt idx="181">
                  <c:v>0.76300000000000001</c:v>
                </c:pt>
                <c:pt idx="182">
                  <c:v>0.76300000000000001</c:v>
                </c:pt>
                <c:pt idx="183">
                  <c:v>0.76300000000000001</c:v>
                </c:pt>
                <c:pt idx="184">
                  <c:v>0.76300000000000001</c:v>
                </c:pt>
                <c:pt idx="185">
                  <c:v>0.76300000000000001</c:v>
                </c:pt>
                <c:pt idx="186">
                  <c:v>0.76300000000000001</c:v>
                </c:pt>
                <c:pt idx="187">
                  <c:v>0.76300000000000001</c:v>
                </c:pt>
                <c:pt idx="188">
                  <c:v>0.76200000000000001</c:v>
                </c:pt>
                <c:pt idx="189">
                  <c:v>0.76300000000000001</c:v>
                </c:pt>
                <c:pt idx="190">
                  <c:v>0.76300000000000001</c:v>
                </c:pt>
                <c:pt idx="191">
                  <c:v>0.76300000000000001</c:v>
                </c:pt>
                <c:pt idx="192">
                  <c:v>0.76300000000000001</c:v>
                </c:pt>
                <c:pt idx="193">
                  <c:v>0.76200000000000001</c:v>
                </c:pt>
                <c:pt idx="194">
                  <c:v>0.76300000000000001</c:v>
                </c:pt>
                <c:pt idx="195">
                  <c:v>0.76300000000000001</c:v>
                </c:pt>
                <c:pt idx="196">
                  <c:v>0.76300000000000001</c:v>
                </c:pt>
                <c:pt idx="197">
                  <c:v>0.76300000000000001</c:v>
                </c:pt>
                <c:pt idx="198">
                  <c:v>0.76300000000000001</c:v>
                </c:pt>
                <c:pt idx="199">
                  <c:v>0.76300000000000001</c:v>
                </c:pt>
                <c:pt idx="200">
                  <c:v>0.76300000000000001</c:v>
                </c:pt>
                <c:pt idx="201">
                  <c:v>0.76200000000000001</c:v>
                </c:pt>
                <c:pt idx="202">
                  <c:v>0.76200000000000001</c:v>
                </c:pt>
                <c:pt idx="203">
                  <c:v>0.76200000000000001</c:v>
                </c:pt>
                <c:pt idx="204">
                  <c:v>0.76200000000000001</c:v>
                </c:pt>
                <c:pt idx="205">
                  <c:v>0.76200000000000001</c:v>
                </c:pt>
                <c:pt idx="206">
                  <c:v>0.76300000000000001</c:v>
                </c:pt>
                <c:pt idx="207">
                  <c:v>0.76300000000000001</c:v>
                </c:pt>
                <c:pt idx="208">
                  <c:v>0.76300000000000001</c:v>
                </c:pt>
                <c:pt idx="209">
                  <c:v>0.76300000000000001</c:v>
                </c:pt>
                <c:pt idx="210">
                  <c:v>0.76400000000000001</c:v>
                </c:pt>
                <c:pt idx="211">
                  <c:v>0.76400000000000001</c:v>
                </c:pt>
                <c:pt idx="212">
                  <c:v>0.76400000000000001</c:v>
                </c:pt>
                <c:pt idx="213">
                  <c:v>0.76400000000000001</c:v>
                </c:pt>
                <c:pt idx="214">
                  <c:v>0.76400000000000001</c:v>
                </c:pt>
                <c:pt idx="215">
                  <c:v>0.76400000000000001</c:v>
                </c:pt>
                <c:pt idx="216">
                  <c:v>0.76400000000000001</c:v>
                </c:pt>
                <c:pt idx="217">
                  <c:v>0.76400000000000001</c:v>
                </c:pt>
                <c:pt idx="218">
                  <c:v>0.76400000000000001</c:v>
                </c:pt>
                <c:pt idx="219">
                  <c:v>0.76400000000000001</c:v>
                </c:pt>
                <c:pt idx="220">
                  <c:v>0.76400000000000001</c:v>
                </c:pt>
                <c:pt idx="221">
                  <c:v>0.76400000000000001</c:v>
                </c:pt>
                <c:pt idx="222">
                  <c:v>0.76300000000000001</c:v>
                </c:pt>
                <c:pt idx="223">
                  <c:v>0.76300000000000001</c:v>
                </c:pt>
                <c:pt idx="224">
                  <c:v>0.76400000000000001</c:v>
                </c:pt>
                <c:pt idx="225">
                  <c:v>0.76500000000000001</c:v>
                </c:pt>
                <c:pt idx="226">
                  <c:v>0.76700000000000002</c:v>
                </c:pt>
                <c:pt idx="227">
                  <c:v>0.78600000000000003</c:v>
                </c:pt>
                <c:pt idx="228">
                  <c:v>0.85199999999999998</c:v>
                </c:pt>
                <c:pt idx="229">
                  <c:v>0.94199999999999995</c:v>
                </c:pt>
                <c:pt idx="230">
                  <c:v>1.03</c:v>
                </c:pt>
                <c:pt idx="231">
                  <c:v>1.1100000000000001</c:v>
                </c:pt>
                <c:pt idx="232">
                  <c:v>1.1599999999999999</c:v>
                </c:pt>
                <c:pt idx="233">
                  <c:v>1.21</c:v>
                </c:pt>
                <c:pt idx="234">
                  <c:v>1.25</c:v>
                </c:pt>
                <c:pt idx="235">
                  <c:v>1.28</c:v>
                </c:pt>
                <c:pt idx="236">
                  <c:v>1.31</c:v>
                </c:pt>
                <c:pt idx="237">
                  <c:v>1.33</c:v>
                </c:pt>
                <c:pt idx="238">
                  <c:v>1.36</c:v>
                </c:pt>
                <c:pt idx="239">
                  <c:v>1.38</c:v>
                </c:pt>
                <c:pt idx="240">
                  <c:v>1.39</c:v>
                </c:pt>
                <c:pt idx="241">
                  <c:v>1.41</c:v>
                </c:pt>
                <c:pt idx="242">
                  <c:v>1.42</c:v>
                </c:pt>
                <c:pt idx="243">
                  <c:v>1.43</c:v>
                </c:pt>
                <c:pt idx="244">
                  <c:v>1.45</c:v>
                </c:pt>
                <c:pt idx="245">
                  <c:v>1.46</c:v>
                </c:pt>
                <c:pt idx="246">
                  <c:v>1.47</c:v>
                </c:pt>
                <c:pt idx="247">
                  <c:v>1.48</c:v>
                </c:pt>
                <c:pt idx="248">
                  <c:v>1.49</c:v>
                </c:pt>
                <c:pt idx="249">
                  <c:v>1.5</c:v>
                </c:pt>
                <c:pt idx="250">
                  <c:v>1.51</c:v>
                </c:pt>
                <c:pt idx="251">
                  <c:v>1.51</c:v>
                </c:pt>
                <c:pt idx="252">
                  <c:v>1.52</c:v>
                </c:pt>
                <c:pt idx="253">
                  <c:v>1.53</c:v>
                </c:pt>
                <c:pt idx="254">
                  <c:v>1.54</c:v>
                </c:pt>
                <c:pt idx="255">
                  <c:v>1.54</c:v>
                </c:pt>
                <c:pt idx="256">
                  <c:v>1.55</c:v>
                </c:pt>
                <c:pt idx="257">
                  <c:v>1.56</c:v>
                </c:pt>
                <c:pt idx="258">
                  <c:v>1.56</c:v>
                </c:pt>
                <c:pt idx="259">
                  <c:v>1.57</c:v>
                </c:pt>
                <c:pt idx="260">
                  <c:v>1.58</c:v>
                </c:pt>
                <c:pt idx="261">
                  <c:v>1.58</c:v>
                </c:pt>
                <c:pt idx="262">
                  <c:v>1.59</c:v>
                </c:pt>
                <c:pt idx="263">
                  <c:v>1.59</c:v>
                </c:pt>
                <c:pt idx="264">
                  <c:v>1.6</c:v>
                </c:pt>
                <c:pt idx="265">
                  <c:v>1.61</c:v>
                </c:pt>
                <c:pt idx="266">
                  <c:v>1.61</c:v>
                </c:pt>
                <c:pt idx="267">
                  <c:v>1.62</c:v>
                </c:pt>
                <c:pt idx="268">
                  <c:v>1.62</c:v>
                </c:pt>
                <c:pt idx="269">
                  <c:v>1.62</c:v>
                </c:pt>
                <c:pt idx="270">
                  <c:v>1.63</c:v>
                </c:pt>
                <c:pt idx="271">
                  <c:v>1.63</c:v>
                </c:pt>
                <c:pt idx="272">
                  <c:v>1.64</c:v>
                </c:pt>
                <c:pt idx="273">
                  <c:v>1.64</c:v>
                </c:pt>
                <c:pt idx="274">
                  <c:v>1.65</c:v>
                </c:pt>
                <c:pt idx="275">
                  <c:v>1.65</c:v>
                </c:pt>
                <c:pt idx="276">
                  <c:v>1.66</c:v>
                </c:pt>
                <c:pt idx="277">
                  <c:v>1.66</c:v>
                </c:pt>
                <c:pt idx="278">
                  <c:v>1.66</c:v>
                </c:pt>
                <c:pt idx="279">
                  <c:v>1.67</c:v>
                </c:pt>
                <c:pt idx="280">
                  <c:v>1.67</c:v>
                </c:pt>
                <c:pt idx="281">
                  <c:v>1.68</c:v>
                </c:pt>
                <c:pt idx="282">
                  <c:v>1.68</c:v>
                </c:pt>
                <c:pt idx="283">
                  <c:v>1.68</c:v>
                </c:pt>
                <c:pt idx="284">
                  <c:v>1.69</c:v>
                </c:pt>
                <c:pt idx="285">
                  <c:v>1.69</c:v>
                </c:pt>
                <c:pt idx="286">
                  <c:v>1.69</c:v>
                </c:pt>
                <c:pt idx="287">
                  <c:v>1.7</c:v>
                </c:pt>
                <c:pt idx="288">
                  <c:v>1.7</c:v>
                </c:pt>
                <c:pt idx="289">
                  <c:v>1.7</c:v>
                </c:pt>
                <c:pt idx="290">
                  <c:v>1.71</c:v>
                </c:pt>
                <c:pt idx="291">
                  <c:v>1.71</c:v>
                </c:pt>
                <c:pt idx="292">
                  <c:v>1.71</c:v>
                </c:pt>
                <c:pt idx="293">
                  <c:v>1.72</c:v>
                </c:pt>
                <c:pt idx="294">
                  <c:v>1.72</c:v>
                </c:pt>
                <c:pt idx="295">
                  <c:v>1.72</c:v>
                </c:pt>
                <c:pt idx="296">
                  <c:v>1.72</c:v>
                </c:pt>
                <c:pt idx="297">
                  <c:v>1.73</c:v>
                </c:pt>
                <c:pt idx="298">
                  <c:v>1.73</c:v>
                </c:pt>
                <c:pt idx="299">
                  <c:v>1.73</c:v>
                </c:pt>
                <c:pt idx="300">
                  <c:v>1.74</c:v>
                </c:pt>
                <c:pt idx="301">
                  <c:v>1.74</c:v>
                </c:pt>
                <c:pt idx="302">
                  <c:v>1.74</c:v>
                </c:pt>
                <c:pt idx="303">
                  <c:v>1.74</c:v>
                </c:pt>
                <c:pt idx="304">
                  <c:v>1.74</c:v>
                </c:pt>
                <c:pt idx="305">
                  <c:v>1.75</c:v>
                </c:pt>
                <c:pt idx="306">
                  <c:v>1.75</c:v>
                </c:pt>
                <c:pt idx="307">
                  <c:v>1.75</c:v>
                </c:pt>
                <c:pt idx="308">
                  <c:v>1.75</c:v>
                </c:pt>
                <c:pt idx="309">
                  <c:v>1.76</c:v>
                </c:pt>
                <c:pt idx="310">
                  <c:v>1.76</c:v>
                </c:pt>
                <c:pt idx="311">
                  <c:v>1.76</c:v>
                </c:pt>
                <c:pt idx="312">
                  <c:v>1.76</c:v>
                </c:pt>
                <c:pt idx="313">
                  <c:v>1.77</c:v>
                </c:pt>
                <c:pt idx="314">
                  <c:v>1.77</c:v>
                </c:pt>
                <c:pt idx="315">
                  <c:v>1.77</c:v>
                </c:pt>
                <c:pt idx="316">
                  <c:v>1.77</c:v>
                </c:pt>
                <c:pt idx="317">
                  <c:v>1.77</c:v>
                </c:pt>
                <c:pt idx="318">
                  <c:v>1.77</c:v>
                </c:pt>
                <c:pt idx="319">
                  <c:v>1.77</c:v>
                </c:pt>
                <c:pt idx="320">
                  <c:v>1.78</c:v>
                </c:pt>
                <c:pt idx="321">
                  <c:v>1.78</c:v>
                </c:pt>
                <c:pt idx="322">
                  <c:v>1.78</c:v>
                </c:pt>
                <c:pt idx="323">
                  <c:v>1.78</c:v>
                </c:pt>
                <c:pt idx="324">
                  <c:v>1.78</c:v>
                </c:pt>
                <c:pt idx="325">
                  <c:v>1.79</c:v>
                </c:pt>
                <c:pt idx="326">
                  <c:v>1.79</c:v>
                </c:pt>
                <c:pt idx="327">
                  <c:v>1.79</c:v>
                </c:pt>
                <c:pt idx="328">
                  <c:v>1.79</c:v>
                </c:pt>
                <c:pt idx="329">
                  <c:v>1.79</c:v>
                </c:pt>
                <c:pt idx="330">
                  <c:v>1.79</c:v>
                </c:pt>
                <c:pt idx="331">
                  <c:v>1.79</c:v>
                </c:pt>
                <c:pt idx="332">
                  <c:v>1.8</c:v>
                </c:pt>
                <c:pt idx="333">
                  <c:v>1.8</c:v>
                </c:pt>
                <c:pt idx="334">
                  <c:v>1.8</c:v>
                </c:pt>
                <c:pt idx="335">
                  <c:v>1.8</c:v>
                </c:pt>
                <c:pt idx="336">
                  <c:v>1.81</c:v>
                </c:pt>
                <c:pt idx="337">
                  <c:v>1.81</c:v>
                </c:pt>
                <c:pt idx="338">
                  <c:v>1.81</c:v>
                </c:pt>
                <c:pt idx="339">
                  <c:v>1.81</c:v>
                </c:pt>
                <c:pt idx="340">
                  <c:v>1.81</c:v>
                </c:pt>
                <c:pt idx="341">
                  <c:v>1.81</c:v>
                </c:pt>
                <c:pt idx="342">
                  <c:v>1.81</c:v>
                </c:pt>
                <c:pt idx="343">
                  <c:v>1.81</c:v>
                </c:pt>
                <c:pt idx="344">
                  <c:v>1.81</c:v>
                </c:pt>
                <c:pt idx="345">
                  <c:v>1.81</c:v>
                </c:pt>
                <c:pt idx="346">
                  <c:v>1.81</c:v>
                </c:pt>
                <c:pt idx="347">
                  <c:v>1.81</c:v>
                </c:pt>
                <c:pt idx="348">
                  <c:v>1.81</c:v>
                </c:pt>
                <c:pt idx="349">
                  <c:v>1.81</c:v>
                </c:pt>
                <c:pt idx="350">
                  <c:v>1.81</c:v>
                </c:pt>
                <c:pt idx="351">
                  <c:v>1.81</c:v>
                </c:pt>
                <c:pt idx="352">
                  <c:v>1.8</c:v>
                </c:pt>
                <c:pt idx="353">
                  <c:v>1.8</c:v>
                </c:pt>
                <c:pt idx="354">
                  <c:v>1.8</c:v>
                </c:pt>
                <c:pt idx="355">
                  <c:v>1.8</c:v>
                </c:pt>
                <c:pt idx="356">
                  <c:v>1.8</c:v>
                </c:pt>
                <c:pt idx="357">
                  <c:v>1.8</c:v>
                </c:pt>
                <c:pt idx="358">
                  <c:v>1.79</c:v>
                </c:pt>
                <c:pt idx="359">
                  <c:v>1.79</c:v>
                </c:pt>
                <c:pt idx="360">
                  <c:v>1.79</c:v>
                </c:pt>
                <c:pt idx="361">
                  <c:v>1.79</c:v>
                </c:pt>
                <c:pt idx="362">
                  <c:v>1.78</c:v>
                </c:pt>
                <c:pt idx="363">
                  <c:v>1.77</c:v>
                </c:pt>
                <c:pt idx="364">
                  <c:v>1.77</c:v>
                </c:pt>
                <c:pt idx="365">
                  <c:v>1.76</c:v>
                </c:pt>
                <c:pt idx="366">
                  <c:v>1.75</c:v>
                </c:pt>
                <c:pt idx="367">
                  <c:v>1.74</c:v>
                </c:pt>
                <c:pt idx="368">
                  <c:v>1.72</c:v>
                </c:pt>
                <c:pt idx="369">
                  <c:v>1.71</c:v>
                </c:pt>
                <c:pt idx="370">
                  <c:v>1.69</c:v>
                </c:pt>
                <c:pt idx="371">
                  <c:v>1.67</c:v>
                </c:pt>
                <c:pt idx="372">
                  <c:v>1.66</c:v>
                </c:pt>
                <c:pt idx="373">
                  <c:v>1.64</c:v>
                </c:pt>
                <c:pt idx="374">
                  <c:v>1.63</c:v>
                </c:pt>
                <c:pt idx="375">
                  <c:v>1.61</c:v>
                </c:pt>
                <c:pt idx="376">
                  <c:v>1.6</c:v>
                </c:pt>
                <c:pt idx="377">
                  <c:v>1.59</c:v>
                </c:pt>
                <c:pt idx="378">
                  <c:v>1.58</c:v>
                </c:pt>
                <c:pt idx="379">
                  <c:v>1.56</c:v>
                </c:pt>
                <c:pt idx="380">
                  <c:v>1.54</c:v>
                </c:pt>
                <c:pt idx="381">
                  <c:v>1.52</c:v>
                </c:pt>
                <c:pt idx="382">
                  <c:v>1.5</c:v>
                </c:pt>
                <c:pt idx="383">
                  <c:v>1.48</c:v>
                </c:pt>
                <c:pt idx="384">
                  <c:v>1.45</c:v>
                </c:pt>
                <c:pt idx="385">
                  <c:v>1.42</c:v>
                </c:pt>
                <c:pt idx="386">
                  <c:v>1.39</c:v>
                </c:pt>
                <c:pt idx="387">
                  <c:v>1.36</c:v>
                </c:pt>
                <c:pt idx="388">
                  <c:v>1.34</c:v>
                </c:pt>
                <c:pt idx="389">
                  <c:v>1.31</c:v>
                </c:pt>
                <c:pt idx="390">
                  <c:v>1.29</c:v>
                </c:pt>
                <c:pt idx="391">
                  <c:v>1.26</c:v>
                </c:pt>
                <c:pt idx="392">
                  <c:v>1.24</c:v>
                </c:pt>
                <c:pt idx="393">
                  <c:v>1.22</c:v>
                </c:pt>
                <c:pt idx="394">
                  <c:v>1.21</c:v>
                </c:pt>
                <c:pt idx="395">
                  <c:v>1.2</c:v>
                </c:pt>
                <c:pt idx="396">
                  <c:v>1.19</c:v>
                </c:pt>
                <c:pt idx="397">
                  <c:v>1.18</c:v>
                </c:pt>
                <c:pt idx="398">
                  <c:v>1.17</c:v>
                </c:pt>
                <c:pt idx="399">
                  <c:v>1.1599999999999999</c:v>
                </c:pt>
                <c:pt idx="400">
                  <c:v>1.1499999999999999</c:v>
                </c:pt>
                <c:pt idx="401">
                  <c:v>1.1399999999999999</c:v>
                </c:pt>
                <c:pt idx="402">
                  <c:v>1.1200000000000001</c:v>
                </c:pt>
                <c:pt idx="403">
                  <c:v>1.1000000000000001</c:v>
                </c:pt>
                <c:pt idx="404">
                  <c:v>1.0900000000000001</c:v>
                </c:pt>
                <c:pt idx="405">
                  <c:v>1.07</c:v>
                </c:pt>
                <c:pt idx="406">
                  <c:v>1.05</c:v>
                </c:pt>
                <c:pt idx="407">
                  <c:v>1.04</c:v>
                </c:pt>
                <c:pt idx="408">
                  <c:v>1.02</c:v>
                </c:pt>
                <c:pt idx="409">
                  <c:v>1.01</c:v>
                </c:pt>
                <c:pt idx="410">
                  <c:v>1</c:v>
                </c:pt>
                <c:pt idx="411">
                  <c:v>0.98899999999999999</c:v>
                </c:pt>
                <c:pt idx="412">
                  <c:v>0.97399999999999998</c:v>
                </c:pt>
                <c:pt idx="413">
                  <c:v>0.96599999999999997</c:v>
                </c:pt>
                <c:pt idx="414">
                  <c:v>0.95599999999999996</c:v>
                </c:pt>
                <c:pt idx="415">
                  <c:v>0.94799999999999995</c:v>
                </c:pt>
                <c:pt idx="416">
                  <c:v>0.94399999999999995</c:v>
                </c:pt>
                <c:pt idx="417">
                  <c:v>0.93899999999999995</c:v>
                </c:pt>
                <c:pt idx="418">
                  <c:v>0.93500000000000005</c:v>
                </c:pt>
                <c:pt idx="419">
                  <c:v>0.93300000000000005</c:v>
                </c:pt>
                <c:pt idx="420">
                  <c:v>0.93</c:v>
                </c:pt>
                <c:pt idx="421">
                  <c:v>0.93</c:v>
                </c:pt>
                <c:pt idx="422">
                  <c:v>0.93</c:v>
                </c:pt>
                <c:pt idx="423">
                  <c:v>0.92800000000000005</c:v>
                </c:pt>
                <c:pt idx="424">
                  <c:v>0.92200000000000004</c:v>
                </c:pt>
                <c:pt idx="425">
                  <c:v>0.91300000000000003</c:v>
                </c:pt>
                <c:pt idx="426">
                  <c:v>0.90300000000000002</c:v>
                </c:pt>
                <c:pt idx="427">
                  <c:v>0.89200000000000002</c:v>
                </c:pt>
                <c:pt idx="428">
                  <c:v>0.88400000000000001</c:v>
                </c:pt>
                <c:pt idx="429">
                  <c:v>0.875</c:v>
                </c:pt>
                <c:pt idx="430">
                  <c:v>0.86499999999999999</c:v>
                </c:pt>
                <c:pt idx="431">
                  <c:v>0.85699999999999998</c:v>
                </c:pt>
                <c:pt idx="432">
                  <c:v>0.85</c:v>
                </c:pt>
                <c:pt idx="433">
                  <c:v>0.84199999999999997</c:v>
                </c:pt>
                <c:pt idx="434">
                  <c:v>0.83499999999999996</c:v>
                </c:pt>
                <c:pt idx="435">
                  <c:v>0.83</c:v>
                </c:pt>
                <c:pt idx="436">
                  <c:v>0.82399999999999995</c:v>
                </c:pt>
                <c:pt idx="437">
                  <c:v>0.81799999999999995</c:v>
                </c:pt>
                <c:pt idx="438">
                  <c:v>0.81299999999999994</c:v>
                </c:pt>
                <c:pt idx="439">
                  <c:v>0.80900000000000005</c:v>
                </c:pt>
                <c:pt idx="440">
                  <c:v>0.80700000000000005</c:v>
                </c:pt>
                <c:pt idx="441">
                  <c:v>0.80600000000000005</c:v>
                </c:pt>
                <c:pt idx="442">
                  <c:v>0.80300000000000005</c:v>
                </c:pt>
                <c:pt idx="443">
                  <c:v>0.80200000000000005</c:v>
                </c:pt>
                <c:pt idx="444">
                  <c:v>0.8</c:v>
                </c:pt>
                <c:pt idx="445">
                  <c:v>0.79600000000000004</c:v>
                </c:pt>
                <c:pt idx="446">
                  <c:v>0.79</c:v>
                </c:pt>
                <c:pt idx="447">
                  <c:v>0.78100000000000003</c:v>
                </c:pt>
                <c:pt idx="448">
                  <c:v>0.77400000000000002</c:v>
                </c:pt>
                <c:pt idx="449">
                  <c:v>0.76700000000000002</c:v>
                </c:pt>
                <c:pt idx="450">
                  <c:v>0.76100000000000001</c:v>
                </c:pt>
                <c:pt idx="451">
                  <c:v>0.754</c:v>
                </c:pt>
                <c:pt idx="452">
                  <c:v>0.748</c:v>
                </c:pt>
                <c:pt idx="453">
                  <c:v>0.74199999999999999</c:v>
                </c:pt>
                <c:pt idx="454">
                  <c:v>0.73599999999999999</c:v>
                </c:pt>
                <c:pt idx="455">
                  <c:v>0.73099999999999998</c:v>
                </c:pt>
                <c:pt idx="456">
                  <c:v>0.72799999999999998</c:v>
                </c:pt>
                <c:pt idx="457">
                  <c:v>0.72399999999999998</c:v>
                </c:pt>
                <c:pt idx="458">
                  <c:v>0.72099999999999997</c:v>
                </c:pt>
                <c:pt idx="459">
                  <c:v>0.71799999999999997</c:v>
                </c:pt>
                <c:pt idx="460">
                  <c:v>0.71499999999999997</c:v>
                </c:pt>
                <c:pt idx="461">
                  <c:v>0.71399999999999997</c:v>
                </c:pt>
                <c:pt idx="462">
                  <c:v>0.71299999999999997</c:v>
                </c:pt>
                <c:pt idx="463">
                  <c:v>0.71399999999999997</c:v>
                </c:pt>
                <c:pt idx="464">
                  <c:v>0.71399999999999997</c:v>
                </c:pt>
                <c:pt idx="465">
                  <c:v>0.71299999999999997</c:v>
                </c:pt>
                <c:pt idx="466">
                  <c:v>0.71</c:v>
                </c:pt>
                <c:pt idx="467">
                  <c:v>0.70599999999999996</c:v>
                </c:pt>
                <c:pt idx="468">
                  <c:v>0.70099999999999996</c:v>
                </c:pt>
                <c:pt idx="469">
                  <c:v>0.69599999999999995</c:v>
                </c:pt>
                <c:pt idx="470">
                  <c:v>0.69099999999999995</c:v>
                </c:pt>
                <c:pt idx="471">
                  <c:v>0.68600000000000005</c:v>
                </c:pt>
                <c:pt idx="472">
                  <c:v>0.68200000000000005</c:v>
                </c:pt>
                <c:pt idx="473">
                  <c:v>0.67900000000000005</c:v>
                </c:pt>
                <c:pt idx="474">
                  <c:v>0.67500000000000004</c:v>
                </c:pt>
                <c:pt idx="475">
                  <c:v>0.67300000000000004</c:v>
                </c:pt>
                <c:pt idx="476">
                  <c:v>0.67</c:v>
                </c:pt>
                <c:pt idx="477">
                  <c:v>0.66800000000000004</c:v>
                </c:pt>
                <c:pt idx="478">
                  <c:v>0.66700000000000004</c:v>
                </c:pt>
                <c:pt idx="479">
                  <c:v>0.66500000000000004</c:v>
                </c:pt>
                <c:pt idx="480">
                  <c:v>0.66400000000000003</c:v>
                </c:pt>
                <c:pt idx="481">
                  <c:v>0.66200000000000003</c:v>
                </c:pt>
                <c:pt idx="482">
                  <c:v>0.66</c:v>
                </c:pt>
                <c:pt idx="483">
                  <c:v>0.65900000000000003</c:v>
                </c:pt>
                <c:pt idx="484">
                  <c:v>0.66300000000000003</c:v>
                </c:pt>
                <c:pt idx="485">
                  <c:v>0.66300000000000003</c:v>
                </c:pt>
                <c:pt idx="486">
                  <c:v>0.66300000000000003</c:v>
                </c:pt>
                <c:pt idx="487">
                  <c:v>0.66200000000000003</c:v>
                </c:pt>
                <c:pt idx="488">
                  <c:v>0.65700000000000003</c:v>
                </c:pt>
                <c:pt idx="489">
                  <c:v>0.65200000000000002</c:v>
                </c:pt>
                <c:pt idx="490">
                  <c:v>0.64800000000000002</c:v>
                </c:pt>
                <c:pt idx="491">
                  <c:v>0.64500000000000002</c:v>
                </c:pt>
                <c:pt idx="492">
                  <c:v>0.64200000000000002</c:v>
                </c:pt>
                <c:pt idx="493">
                  <c:v>0.64</c:v>
                </c:pt>
                <c:pt idx="494">
                  <c:v>0.63800000000000001</c:v>
                </c:pt>
                <c:pt idx="495">
                  <c:v>0.63700000000000001</c:v>
                </c:pt>
                <c:pt idx="496">
                  <c:v>0.63600000000000001</c:v>
                </c:pt>
                <c:pt idx="497">
                  <c:v>0.63600000000000001</c:v>
                </c:pt>
                <c:pt idx="498">
                  <c:v>0.63600000000000001</c:v>
                </c:pt>
                <c:pt idx="499">
                  <c:v>0.63700000000000001</c:v>
                </c:pt>
                <c:pt idx="500">
                  <c:v>0.63800000000000001</c:v>
                </c:pt>
                <c:pt idx="501">
                  <c:v>0.63800000000000001</c:v>
                </c:pt>
                <c:pt idx="502">
                  <c:v>0.63600000000000001</c:v>
                </c:pt>
                <c:pt idx="503">
                  <c:v>0.63400000000000001</c:v>
                </c:pt>
                <c:pt idx="504">
                  <c:v>0.63200000000000001</c:v>
                </c:pt>
                <c:pt idx="505">
                  <c:v>0.63</c:v>
                </c:pt>
                <c:pt idx="506">
                  <c:v>0.63</c:v>
                </c:pt>
                <c:pt idx="507">
                  <c:v>0.63</c:v>
                </c:pt>
                <c:pt idx="508">
                  <c:v>0.63200000000000001</c:v>
                </c:pt>
                <c:pt idx="509">
                  <c:v>0.63400000000000001</c:v>
                </c:pt>
                <c:pt idx="510">
                  <c:v>0.63400000000000001</c:v>
                </c:pt>
                <c:pt idx="511">
                  <c:v>0.63200000000000001</c:v>
                </c:pt>
                <c:pt idx="512">
                  <c:v>0.63</c:v>
                </c:pt>
                <c:pt idx="513">
                  <c:v>0.627</c:v>
                </c:pt>
                <c:pt idx="514">
                  <c:v>0.625</c:v>
                </c:pt>
                <c:pt idx="515">
                  <c:v>0.623</c:v>
                </c:pt>
                <c:pt idx="516">
                  <c:v>0.621</c:v>
                </c:pt>
                <c:pt idx="517">
                  <c:v>0.62</c:v>
                </c:pt>
                <c:pt idx="518">
                  <c:v>0.61899999999999999</c:v>
                </c:pt>
                <c:pt idx="519">
                  <c:v>0.61799999999999999</c:v>
                </c:pt>
                <c:pt idx="520">
                  <c:v>0.61799999999999999</c:v>
                </c:pt>
                <c:pt idx="521">
                  <c:v>0.61799999999999999</c:v>
                </c:pt>
                <c:pt idx="522">
                  <c:v>0.61899999999999999</c:v>
                </c:pt>
                <c:pt idx="523">
                  <c:v>0.61899999999999999</c:v>
                </c:pt>
                <c:pt idx="524">
                  <c:v>0.61899999999999999</c:v>
                </c:pt>
                <c:pt idx="525">
                  <c:v>0.61899999999999999</c:v>
                </c:pt>
                <c:pt idx="526">
                  <c:v>0.61799999999999999</c:v>
                </c:pt>
                <c:pt idx="527">
                  <c:v>0.61799999999999999</c:v>
                </c:pt>
                <c:pt idx="528">
                  <c:v>0.61799999999999999</c:v>
                </c:pt>
                <c:pt idx="529">
                  <c:v>0.62</c:v>
                </c:pt>
                <c:pt idx="530">
                  <c:v>0.623</c:v>
                </c:pt>
                <c:pt idx="531">
                  <c:v>0.624</c:v>
                </c:pt>
                <c:pt idx="532">
                  <c:v>0.623</c:v>
                </c:pt>
                <c:pt idx="533">
                  <c:v>0.62</c:v>
                </c:pt>
                <c:pt idx="534">
                  <c:v>0.61799999999999999</c:v>
                </c:pt>
                <c:pt idx="535">
                  <c:v>0.61799999999999999</c:v>
                </c:pt>
                <c:pt idx="536">
                  <c:v>0.61599999999999999</c:v>
                </c:pt>
                <c:pt idx="537">
                  <c:v>0.61599999999999999</c:v>
                </c:pt>
                <c:pt idx="538">
                  <c:v>0.61599999999999999</c:v>
                </c:pt>
                <c:pt idx="539">
                  <c:v>0.61599999999999999</c:v>
                </c:pt>
                <c:pt idx="540">
                  <c:v>0.61799999999999999</c:v>
                </c:pt>
                <c:pt idx="541">
                  <c:v>0.62</c:v>
                </c:pt>
                <c:pt idx="542">
                  <c:v>0.623</c:v>
                </c:pt>
                <c:pt idx="543">
                  <c:v>0.624</c:v>
                </c:pt>
                <c:pt idx="544">
                  <c:v>0.625</c:v>
                </c:pt>
                <c:pt idx="545">
                  <c:v>0.625</c:v>
                </c:pt>
                <c:pt idx="546">
                  <c:v>0.626</c:v>
                </c:pt>
                <c:pt idx="547">
                  <c:v>0.626</c:v>
                </c:pt>
                <c:pt idx="548">
                  <c:v>0.625</c:v>
                </c:pt>
                <c:pt idx="549">
                  <c:v>0.627</c:v>
                </c:pt>
                <c:pt idx="550">
                  <c:v>0.63100000000000001</c:v>
                </c:pt>
                <c:pt idx="551">
                  <c:v>0.63200000000000001</c:v>
                </c:pt>
                <c:pt idx="552">
                  <c:v>0.63400000000000001</c:v>
                </c:pt>
                <c:pt idx="553">
                  <c:v>0.63200000000000001</c:v>
                </c:pt>
                <c:pt idx="554">
                  <c:v>0.63200000000000001</c:v>
                </c:pt>
                <c:pt idx="555">
                  <c:v>0.63200000000000001</c:v>
                </c:pt>
                <c:pt idx="556">
                  <c:v>0.63200000000000001</c:v>
                </c:pt>
                <c:pt idx="557">
                  <c:v>0.63400000000000001</c:v>
                </c:pt>
                <c:pt idx="558">
                  <c:v>0.63600000000000001</c:v>
                </c:pt>
                <c:pt idx="559">
                  <c:v>0.63700000000000001</c:v>
                </c:pt>
                <c:pt idx="560">
                  <c:v>0.64</c:v>
                </c:pt>
                <c:pt idx="561">
                  <c:v>0.64300000000000002</c:v>
                </c:pt>
                <c:pt idx="562">
                  <c:v>0.64700000000000002</c:v>
                </c:pt>
                <c:pt idx="563">
                  <c:v>0.65100000000000002</c:v>
                </c:pt>
                <c:pt idx="564">
                  <c:v>0.65400000000000003</c:v>
                </c:pt>
                <c:pt idx="565">
                  <c:v>0.65700000000000003</c:v>
                </c:pt>
                <c:pt idx="566">
                  <c:v>0.65800000000000003</c:v>
                </c:pt>
                <c:pt idx="567">
                  <c:v>0.65800000000000003</c:v>
                </c:pt>
                <c:pt idx="568">
                  <c:v>0.65800000000000003</c:v>
                </c:pt>
                <c:pt idx="569">
                  <c:v>0.65800000000000003</c:v>
                </c:pt>
                <c:pt idx="570">
                  <c:v>0.66</c:v>
                </c:pt>
                <c:pt idx="571">
                  <c:v>0.66500000000000004</c:v>
                </c:pt>
                <c:pt idx="572">
                  <c:v>0.66800000000000004</c:v>
                </c:pt>
                <c:pt idx="573">
                  <c:v>0.66800000000000004</c:v>
                </c:pt>
                <c:pt idx="574">
                  <c:v>0.66800000000000004</c:v>
                </c:pt>
                <c:pt idx="575">
                  <c:v>0.66800000000000004</c:v>
                </c:pt>
                <c:pt idx="576">
                  <c:v>0.66800000000000004</c:v>
                </c:pt>
                <c:pt idx="577">
                  <c:v>0.66900000000000004</c:v>
                </c:pt>
                <c:pt idx="578">
                  <c:v>0.67</c:v>
                </c:pt>
                <c:pt idx="579">
                  <c:v>0.67300000000000004</c:v>
                </c:pt>
                <c:pt idx="580">
                  <c:v>0.67500000000000004</c:v>
                </c:pt>
                <c:pt idx="581">
                  <c:v>0.67900000000000005</c:v>
                </c:pt>
                <c:pt idx="582">
                  <c:v>0.68200000000000005</c:v>
                </c:pt>
                <c:pt idx="583">
                  <c:v>0.68600000000000005</c:v>
                </c:pt>
                <c:pt idx="584">
                  <c:v>0.68799999999999994</c:v>
                </c:pt>
                <c:pt idx="585">
                  <c:v>0.69299999999999995</c:v>
                </c:pt>
                <c:pt idx="586">
                  <c:v>0.69799999999999995</c:v>
                </c:pt>
                <c:pt idx="587">
                  <c:v>0.70199999999999996</c:v>
                </c:pt>
                <c:pt idx="588">
                  <c:v>0.70299999999999996</c:v>
                </c:pt>
                <c:pt idx="589">
                  <c:v>0.70399999999999996</c:v>
                </c:pt>
                <c:pt idx="590">
                  <c:v>0.70699999999999996</c:v>
                </c:pt>
                <c:pt idx="591">
                  <c:v>0.70699999999999996</c:v>
                </c:pt>
                <c:pt idx="592">
                  <c:v>0.70699999999999996</c:v>
                </c:pt>
                <c:pt idx="593">
                  <c:v>0.70799999999999996</c:v>
                </c:pt>
                <c:pt idx="594">
                  <c:v>0.71</c:v>
                </c:pt>
                <c:pt idx="595">
                  <c:v>0.71499999999999997</c:v>
                </c:pt>
                <c:pt idx="596">
                  <c:v>0.71699999999999997</c:v>
                </c:pt>
                <c:pt idx="597">
                  <c:v>0.71899999999999997</c:v>
                </c:pt>
                <c:pt idx="598">
                  <c:v>0.72</c:v>
                </c:pt>
                <c:pt idx="599">
                  <c:v>0.72099999999999997</c:v>
                </c:pt>
                <c:pt idx="600">
                  <c:v>0.72299999999999998</c:v>
                </c:pt>
                <c:pt idx="601">
                  <c:v>0.72399999999999998</c:v>
                </c:pt>
                <c:pt idx="602">
                  <c:v>0.72799999999999998</c:v>
                </c:pt>
                <c:pt idx="603">
                  <c:v>0.72899999999999998</c:v>
                </c:pt>
                <c:pt idx="604">
                  <c:v>0.73099999999999998</c:v>
                </c:pt>
                <c:pt idx="605">
                  <c:v>0.73399999999999999</c:v>
                </c:pt>
                <c:pt idx="606">
                  <c:v>0.73599999999999999</c:v>
                </c:pt>
                <c:pt idx="607">
                  <c:v>0.73699999999999999</c:v>
                </c:pt>
                <c:pt idx="608">
                  <c:v>0.74</c:v>
                </c:pt>
                <c:pt idx="609">
                  <c:v>0.74099999999999999</c:v>
                </c:pt>
                <c:pt idx="610">
                  <c:v>0.74199999999999999</c:v>
                </c:pt>
                <c:pt idx="611">
                  <c:v>0.74199999999999999</c:v>
                </c:pt>
                <c:pt idx="612">
                  <c:v>0.74199999999999999</c:v>
                </c:pt>
                <c:pt idx="613">
                  <c:v>0.74199999999999999</c:v>
                </c:pt>
                <c:pt idx="614">
                  <c:v>0.74199999999999999</c:v>
                </c:pt>
                <c:pt idx="615">
                  <c:v>0.74299999999999999</c:v>
                </c:pt>
                <c:pt idx="616">
                  <c:v>0.745</c:v>
                </c:pt>
                <c:pt idx="617">
                  <c:v>0.746</c:v>
                </c:pt>
                <c:pt idx="618">
                  <c:v>0.746</c:v>
                </c:pt>
                <c:pt idx="619">
                  <c:v>0.746</c:v>
                </c:pt>
                <c:pt idx="620">
                  <c:v>0.745</c:v>
                </c:pt>
                <c:pt idx="621">
                  <c:v>0.74299999999999999</c:v>
                </c:pt>
                <c:pt idx="622">
                  <c:v>0.74299999999999999</c:v>
                </c:pt>
                <c:pt idx="623">
                  <c:v>0.74199999999999999</c:v>
                </c:pt>
                <c:pt idx="624">
                  <c:v>0.74</c:v>
                </c:pt>
                <c:pt idx="625">
                  <c:v>0.73899999999999999</c:v>
                </c:pt>
                <c:pt idx="626">
                  <c:v>0.73599999999999999</c:v>
                </c:pt>
                <c:pt idx="627">
                  <c:v>0.73499999999999999</c:v>
                </c:pt>
                <c:pt idx="628">
                  <c:v>0.73099999999999998</c:v>
                </c:pt>
                <c:pt idx="629">
                  <c:v>0.72899999999999998</c:v>
                </c:pt>
                <c:pt idx="630">
                  <c:v>0.72599999999999998</c:v>
                </c:pt>
                <c:pt idx="631">
                  <c:v>0.72499999999999998</c:v>
                </c:pt>
                <c:pt idx="632">
                  <c:v>0.72299999999999998</c:v>
                </c:pt>
                <c:pt idx="633">
                  <c:v>0.72099999999999997</c:v>
                </c:pt>
                <c:pt idx="634">
                  <c:v>0.72</c:v>
                </c:pt>
                <c:pt idx="635">
                  <c:v>0.72</c:v>
                </c:pt>
                <c:pt idx="636">
                  <c:v>0.72</c:v>
                </c:pt>
                <c:pt idx="637">
                  <c:v>0.72</c:v>
                </c:pt>
                <c:pt idx="638">
                  <c:v>0.71899999999999997</c:v>
                </c:pt>
                <c:pt idx="639">
                  <c:v>0.71699999999999997</c:v>
                </c:pt>
                <c:pt idx="640">
                  <c:v>0.71399999999999997</c:v>
                </c:pt>
                <c:pt idx="641">
                  <c:v>0.71199999999999997</c:v>
                </c:pt>
                <c:pt idx="642">
                  <c:v>0.70699999999999996</c:v>
                </c:pt>
                <c:pt idx="643">
                  <c:v>0.70299999999999996</c:v>
                </c:pt>
                <c:pt idx="644">
                  <c:v>0.69899999999999995</c:v>
                </c:pt>
                <c:pt idx="645">
                  <c:v>0.69499999999999995</c:v>
                </c:pt>
                <c:pt idx="646">
                  <c:v>0.69099999999999995</c:v>
                </c:pt>
                <c:pt idx="647">
                  <c:v>0.68700000000000006</c:v>
                </c:pt>
                <c:pt idx="648">
                  <c:v>0.68400000000000005</c:v>
                </c:pt>
                <c:pt idx="649">
                  <c:v>0.68</c:v>
                </c:pt>
                <c:pt idx="650">
                  <c:v>0.67500000000000004</c:v>
                </c:pt>
                <c:pt idx="651">
                  <c:v>0.67300000000000004</c:v>
                </c:pt>
                <c:pt idx="652">
                  <c:v>0.66900000000000004</c:v>
                </c:pt>
                <c:pt idx="653">
                  <c:v>0.66800000000000004</c:v>
                </c:pt>
                <c:pt idx="654">
                  <c:v>0.66500000000000004</c:v>
                </c:pt>
                <c:pt idx="655">
                  <c:v>0.66400000000000003</c:v>
                </c:pt>
                <c:pt idx="656">
                  <c:v>0.66300000000000003</c:v>
                </c:pt>
                <c:pt idx="657">
                  <c:v>0.66300000000000003</c:v>
                </c:pt>
                <c:pt idx="658">
                  <c:v>0.66400000000000003</c:v>
                </c:pt>
                <c:pt idx="659">
                  <c:v>0.66400000000000003</c:v>
                </c:pt>
                <c:pt idx="660">
                  <c:v>0.66400000000000003</c:v>
                </c:pt>
                <c:pt idx="661">
                  <c:v>0.66400000000000003</c:v>
                </c:pt>
                <c:pt idx="662">
                  <c:v>0.66400000000000003</c:v>
                </c:pt>
                <c:pt idx="663">
                  <c:v>0.66200000000000003</c:v>
                </c:pt>
                <c:pt idx="664">
                  <c:v>0.65900000000000003</c:v>
                </c:pt>
                <c:pt idx="665">
                  <c:v>0.65400000000000003</c:v>
                </c:pt>
                <c:pt idx="666">
                  <c:v>0.64800000000000002</c:v>
                </c:pt>
                <c:pt idx="667">
                  <c:v>0.64500000000000002</c:v>
                </c:pt>
                <c:pt idx="668">
                  <c:v>0.64100000000000001</c:v>
                </c:pt>
                <c:pt idx="669">
                  <c:v>0.63600000000000001</c:v>
                </c:pt>
                <c:pt idx="670">
                  <c:v>0.63200000000000001</c:v>
                </c:pt>
                <c:pt idx="671">
                  <c:v>0.63</c:v>
                </c:pt>
                <c:pt idx="672">
                  <c:v>0.626</c:v>
                </c:pt>
                <c:pt idx="673">
                  <c:v>0.624</c:v>
                </c:pt>
                <c:pt idx="674">
                  <c:v>0.62</c:v>
                </c:pt>
                <c:pt idx="675">
                  <c:v>0.61799999999999999</c:v>
                </c:pt>
                <c:pt idx="676">
                  <c:v>0.61599999999999999</c:v>
                </c:pt>
                <c:pt idx="677">
                  <c:v>0.61499999999999999</c:v>
                </c:pt>
                <c:pt idx="678">
                  <c:v>0.61299999999999999</c:v>
                </c:pt>
                <c:pt idx="679">
                  <c:v>0.61199999999999999</c:v>
                </c:pt>
                <c:pt idx="680">
                  <c:v>0.61199999999999999</c:v>
                </c:pt>
                <c:pt idx="681">
                  <c:v>0.61299999999999999</c:v>
                </c:pt>
                <c:pt idx="682">
                  <c:v>0.61299999999999999</c:v>
                </c:pt>
                <c:pt idx="683">
                  <c:v>0.61199999999999999</c:v>
                </c:pt>
                <c:pt idx="684">
                  <c:v>0.60899999999999999</c:v>
                </c:pt>
                <c:pt idx="685">
                  <c:v>0.60699999999999998</c:v>
                </c:pt>
                <c:pt idx="686">
                  <c:v>0.60299999999999998</c:v>
                </c:pt>
                <c:pt idx="687">
                  <c:v>0.59899999999999998</c:v>
                </c:pt>
                <c:pt idx="688">
                  <c:v>0.59599999999999997</c:v>
                </c:pt>
                <c:pt idx="689">
                  <c:v>0.59299999999999997</c:v>
                </c:pt>
                <c:pt idx="690">
                  <c:v>0.59099999999999997</c:v>
                </c:pt>
                <c:pt idx="691">
                  <c:v>0.59</c:v>
                </c:pt>
                <c:pt idx="692">
                  <c:v>0.58799999999999997</c:v>
                </c:pt>
                <c:pt idx="693">
                  <c:v>0.58799999999999997</c:v>
                </c:pt>
                <c:pt idx="694">
                  <c:v>0.58799999999999997</c:v>
                </c:pt>
                <c:pt idx="695">
                  <c:v>0.59</c:v>
                </c:pt>
                <c:pt idx="696">
                  <c:v>0.59099999999999997</c:v>
                </c:pt>
                <c:pt idx="697">
                  <c:v>0.59099999999999997</c:v>
                </c:pt>
                <c:pt idx="698">
                  <c:v>0.59099999999999997</c:v>
                </c:pt>
                <c:pt idx="699">
                  <c:v>0.59099999999999997</c:v>
                </c:pt>
                <c:pt idx="700">
                  <c:v>0.59199999999999997</c:v>
                </c:pt>
                <c:pt idx="701">
                  <c:v>0.59199999999999997</c:v>
                </c:pt>
                <c:pt idx="702">
                  <c:v>0.59399999999999997</c:v>
                </c:pt>
                <c:pt idx="703">
                  <c:v>0.59699999999999998</c:v>
                </c:pt>
                <c:pt idx="704">
                  <c:v>0.59699999999999998</c:v>
                </c:pt>
                <c:pt idx="705">
                  <c:v>0.59699999999999998</c:v>
                </c:pt>
                <c:pt idx="706">
                  <c:v>0.59599999999999997</c:v>
                </c:pt>
                <c:pt idx="707">
                  <c:v>0.59699999999999998</c:v>
                </c:pt>
                <c:pt idx="708">
                  <c:v>0.59799999999999998</c:v>
                </c:pt>
                <c:pt idx="709">
                  <c:v>0.60099999999999998</c:v>
                </c:pt>
                <c:pt idx="710">
                  <c:v>0.60399999999999998</c:v>
                </c:pt>
                <c:pt idx="711">
                  <c:v>0.60899999999999999</c:v>
                </c:pt>
                <c:pt idx="712">
                  <c:v>0.61399999999999999</c:v>
                </c:pt>
                <c:pt idx="713">
                  <c:v>0.61899999999999999</c:v>
                </c:pt>
                <c:pt idx="714">
                  <c:v>0.626</c:v>
                </c:pt>
                <c:pt idx="715">
                  <c:v>0.63400000000000001</c:v>
                </c:pt>
                <c:pt idx="716">
                  <c:v>0.64200000000000002</c:v>
                </c:pt>
                <c:pt idx="717">
                  <c:v>0.64800000000000002</c:v>
                </c:pt>
                <c:pt idx="718">
                  <c:v>0.65300000000000002</c:v>
                </c:pt>
                <c:pt idx="719">
                  <c:v>0.65400000000000003</c:v>
                </c:pt>
                <c:pt idx="720">
                  <c:v>0.65600000000000003</c:v>
                </c:pt>
                <c:pt idx="721">
                  <c:v>0.65700000000000003</c:v>
                </c:pt>
                <c:pt idx="722">
                  <c:v>0.65900000000000003</c:v>
                </c:pt>
                <c:pt idx="723">
                  <c:v>0.66500000000000004</c:v>
                </c:pt>
                <c:pt idx="724">
                  <c:v>0.66900000000000004</c:v>
                </c:pt>
                <c:pt idx="725">
                  <c:v>0.67500000000000004</c:v>
                </c:pt>
                <c:pt idx="726">
                  <c:v>0.68</c:v>
                </c:pt>
                <c:pt idx="727">
                  <c:v>0.68600000000000005</c:v>
                </c:pt>
                <c:pt idx="728">
                  <c:v>0.69199999999999995</c:v>
                </c:pt>
                <c:pt idx="729">
                  <c:v>0.69899999999999995</c:v>
                </c:pt>
                <c:pt idx="730">
                  <c:v>0.70699999999999996</c:v>
                </c:pt>
                <c:pt idx="731">
                  <c:v>0.71399999999999997</c:v>
                </c:pt>
                <c:pt idx="732">
                  <c:v>0.71899999999999997</c:v>
                </c:pt>
                <c:pt idx="733">
                  <c:v>0.72399999999999998</c:v>
                </c:pt>
                <c:pt idx="734">
                  <c:v>0.72899999999999998</c:v>
                </c:pt>
                <c:pt idx="735">
                  <c:v>0.73399999999999999</c:v>
                </c:pt>
                <c:pt idx="736">
                  <c:v>0.74</c:v>
                </c:pt>
                <c:pt idx="737">
                  <c:v>0.747</c:v>
                </c:pt>
                <c:pt idx="738">
                  <c:v>0.754</c:v>
                </c:pt>
                <c:pt idx="739">
                  <c:v>0.76100000000000001</c:v>
                </c:pt>
                <c:pt idx="740">
                  <c:v>0.76400000000000001</c:v>
                </c:pt>
                <c:pt idx="741">
                  <c:v>0.76800000000000002</c:v>
                </c:pt>
                <c:pt idx="742">
                  <c:v>0.77</c:v>
                </c:pt>
                <c:pt idx="743">
                  <c:v>0.77100000000000002</c:v>
                </c:pt>
                <c:pt idx="744">
                  <c:v>0.77400000000000002</c:v>
                </c:pt>
                <c:pt idx="745">
                  <c:v>0.77500000000000002</c:v>
                </c:pt>
                <c:pt idx="746">
                  <c:v>0.77600000000000002</c:v>
                </c:pt>
                <c:pt idx="747">
                  <c:v>0.78</c:v>
                </c:pt>
                <c:pt idx="748">
                  <c:v>0.78500000000000003</c:v>
                </c:pt>
                <c:pt idx="749">
                  <c:v>0.78900000000000003</c:v>
                </c:pt>
                <c:pt idx="750">
                  <c:v>0.79100000000000004</c:v>
                </c:pt>
                <c:pt idx="751">
                  <c:v>0.79500000000000004</c:v>
                </c:pt>
                <c:pt idx="752">
                  <c:v>0.79700000000000004</c:v>
                </c:pt>
                <c:pt idx="753">
                  <c:v>0.8</c:v>
                </c:pt>
                <c:pt idx="754">
                  <c:v>0.80300000000000005</c:v>
                </c:pt>
                <c:pt idx="755">
                  <c:v>0.80700000000000005</c:v>
                </c:pt>
                <c:pt idx="756">
                  <c:v>0.80900000000000005</c:v>
                </c:pt>
                <c:pt idx="757">
                  <c:v>0.81299999999999994</c:v>
                </c:pt>
                <c:pt idx="758">
                  <c:v>0.81499999999999995</c:v>
                </c:pt>
                <c:pt idx="759">
                  <c:v>0.81899999999999995</c:v>
                </c:pt>
                <c:pt idx="760">
                  <c:v>0.82299999999999995</c:v>
                </c:pt>
                <c:pt idx="761">
                  <c:v>0.82499999999999996</c:v>
                </c:pt>
                <c:pt idx="762">
                  <c:v>0.82799999999999996</c:v>
                </c:pt>
                <c:pt idx="763">
                  <c:v>0.83099999999999996</c:v>
                </c:pt>
                <c:pt idx="764">
                  <c:v>0.83299999999999996</c:v>
                </c:pt>
                <c:pt idx="765">
                  <c:v>0.83399999999999996</c:v>
                </c:pt>
                <c:pt idx="766">
                  <c:v>0.83499999999999996</c:v>
                </c:pt>
                <c:pt idx="767">
                  <c:v>0.83699999999999997</c:v>
                </c:pt>
                <c:pt idx="768">
                  <c:v>0.84</c:v>
                </c:pt>
                <c:pt idx="769">
                  <c:v>0.84399999999999997</c:v>
                </c:pt>
                <c:pt idx="770">
                  <c:v>0.84499999999999997</c:v>
                </c:pt>
                <c:pt idx="771">
                  <c:v>0.84499999999999997</c:v>
                </c:pt>
                <c:pt idx="772">
                  <c:v>0.84499999999999997</c:v>
                </c:pt>
                <c:pt idx="773">
                  <c:v>0.84399999999999997</c:v>
                </c:pt>
                <c:pt idx="774">
                  <c:v>0.84199999999999997</c:v>
                </c:pt>
                <c:pt idx="775">
                  <c:v>0.84199999999999997</c:v>
                </c:pt>
                <c:pt idx="776">
                  <c:v>0.84099999999999997</c:v>
                </c:pt>
                <c:pt idx="777">
                  <c:v>0.84099999999999997</c:v>
                </c:pt>
                <c:pt idx="778">
                  <c:v>0.84099999999999997</c:v>
                </c:pt>
                <c:pt idx="779">
                  <c:v>0.84099999999999997</c:v>
                </c:pt>
                <c:pt idx="780">
                  <c:v>0.84199999999999997</c:v>
                </c:pt>
                <c:pt idx="781">
                  <c:v>0.84399999999999997</c:v>
                </c:pt>
                <c:pt idx="782">
                  <c:v>0.84599999999999997</c:v>
                </c:pt>
                <c:pt idx="783">
                  <c:v>0.84699999999999998</c:v>
                </c:pt>
                <c:pt idx="784">
                  <c:v>0.85</c:v>
                </c:pt>
                <c:pt idx="785">
                  <c:v>0.85099999999999998</c:v>
                </c:pt>
                <c:pt idx="786">
                  <c:v>0.85199999999999998</c:v>
                </c:pt>
                <c:pt idx="787">
                  <c:v>0.85299999999999998</c:v>
                </c:pt>
                <c:pt idx="788">
                  <c:v>0.85599999999999998</c:v>
                </c:pt>
                <c:pt idx="789">
                  <c:v>0.85899999999999999</c:v>
                </c:pt>
                <c:pt idx="790">
                  <c:v>0.86199999999999999</c:v>
                </c:pt>
                <c:pt idx="791">
                  <c:v>0.86399999999999999</c:v>
                </c:pt>
                <c:pt idx="792">
                  <c:v>0.86399999999999999</c:v>
                </c:pt>
                <c:pt idx="793">
                  <c:v>0.86199999999999999</c:v>
                </c:pt>
                <c:pt idx="794">
                  <c:v>0.85899999999999999</c:v>
                </c:pt>
                <c:pt idx="795">
                  <c:v>0.85599999999999998</c:v>
                </c:pt>
                <c:pt idx="796">
                  <c:v>0.85299999999999998</c:v>
                </c:pt>
                <c:pt idx="797">
                  <c:v>0.85199999999999998</c:v>
                </c:pt>
                <c:pt idx="798">
                  <c:v>0.85099999999999998</c:v>
                </c:pt>
                <c:pt idx="799">
                  <c:v>0.85099999999999998</c:v>
                </c:pt>
                <c:pt idx="800">
                  <c:v>0.85199999999999998</c:v>
                </c:pt>
                <c:pt idx="801">
                  <c:v>0.85599999999999998</c:v>
                </c:pt>
                <c:pt idx="802">
                  <c:v>0.85899999999999999</c:v>
                </c:pt>
                <c:pt idx="803">
                  <c:v>0.86499999999999999</c:v>
                </c:pt>
                <c:pt idx="804">
                  <c:v>0.872</c:v>
                </c:pt>
                <c:pt idx="805">
                  <c:v>0.876</c:v>
                </c:pt>
                <c:pt idx="806">
                  <c:v>0.879</c:v>
                </c:pt>
                <c:pt idx="807">
                  <c:v>0.88</c:v>
                </c:pt>
                <c:pt idx="808">
                  <c:v>0.88100000000000001</c:v>
                </c:pt>
                <c:pt idx="809">
                  <c:v>0.88500000000000001</c:v>
                </c:pt>
                <c:pt idx="810">
                  <c:v>0.89100000000000001</c:v>
                </c:pt>
                <c:pt idx="811">
                  <c:v>0.89800000000000002</c:v>
                </c:pt>
                <c:pt idx="812">
                  <c:v>0.90500000000000003</c:v>
                </c:pt>
                <c:pt idx="813">
                  <c:v>0.90600000000000003</c:v>
                </c:pt>
                <c:pt idx="814">
                  <c:v>0.90700000000000003</c:v>
                </c:pt>
                <c:pt idx="815">
                  <c:v>0.90800000000000003</c:v>
                </c:pt>
                <c:pt idx="816">
                  <c:v>0.91100000000000003</c:v>
                </c:pt>
                <c:pt idx="817">
                  <c:v>0.91400000000000003</c:v>
                </c:pt>
                <c:pt idx="818">
                  <c:v>0.92300000000000004</c:v>
                </c:pt>
                <c:pt idx="819">
                  <c:v>0.93400000000000005</c:v>
                </c:pt>
                <c:pt idx="820">
                  <c:v>0.95</c:v>
                </c:pt>
                <c:pt idx="821">
                  <c:v>0.96699999999999997</c:v>
                </c:pt>
                <c:pt idx="822">
                  <c:v>0.98899999999999999</c:v>
                </c:pt>
                <c:pt idx="823">
                  <c:v>1.01</c:v>
                </c:pt>
                <c:pt idx="824">
                  <c:v>1.04</c:v>
                </c:pt>
                <c:pt idx="825">
                  <c:v>1.07</c:v>
                </c:pt>
                <c:pt idx="826">
                  <c:v>1.0900000000000001</c:v>
                </c:pt>
                <c:pt idx="827">
                  <c:v>1.1200000000000001</c:v>
                </c:pt>
                <c:pt idx="828">
                  <c:v>1.1399999999999999</c:v>
                </c:pt>
                <c:pt idx="829">
                  <c:v>1.1599999999999999</c:v>
                </c:pt>
                <c:pt idx="830">
                  <c:v>1.17</c:v>
                </c:pt>
                <c:pt idx="831">
                  <c:v>1.18</c:v>
                </c:pt>
                <c:pt idx="832">
                  <c:v>1.19</c:v>
                </c:pt>
                <c:pt idx="833">
                  <c:v>1.2</c:v>
                </c:pt>
                <c:pt idx="834">
                  <c:v>1.22</c:v>
                </c:pt>
                <c:pt idx="835">
                  <c:v>1.23</c:v>
                </c:pt>
                <c:pt idx="836">
                  <c:v>1.25</c:v>
                </c:pt>
                <c:pt idx="837">
                  <c:v>1.26</c:v>
                </c:pt>
                <c:pt idx="838">
                  <c:v>1.28</c:v>
                </c:pt>
                <c:pt idx="839">
                  <c:v>1.29</c:v>
                </c:pt>
                <c:pt idx="840">
                  <c:v>1.31</c:v>
                </c:pt>
                <c:pt idx="841">
                  <c:v>1.32</c:v>
                </c:pt>
                <c:pt idx="842">
                  <c:v>1.34</c:v>
                </c:pt>
                <c:pt idx="843">
                  <c:v>1.35</c:v>
                </c:pt>
                <c:pt idx="844">
                  <c:v>1.36</c:v>
                </c:pt>
                <c:pt idx="845">
                  <c:v>1.37</c:v>
                </c:pt>
                <c:pt idx="846">
                  <c:v>1.38</c:v>
                </c:pt>
                <c:pt idx="847">
                  <c:v>1.39</c:v>
                </c:pt>
                <c:pt idx="848">
                  <c:v>1.4</c:v>
                </c:pt>
                <c:pt idx="849">
                  <c:v>1.41</c:v>
                </c:pt>
                <c:pt idx="850">
                  <c:v>1.42</c:v>
                </c:pt>
                <c:pt idx="851">
                  <c:v>1.42</c:v>
                </c:pt>
                <c:pt idx="852">
                  <c:v>1.43</c:v>
                </c:pt>
                <c:pt idx="853">
                  <c:v>1.43</c:v>
                </c:pt>
                <c:pt idx="854">
                  <c:v>1.44</c:v>
                </c:pt>
                <c:pt idx="855">
                  <c:v>1.45</c:v>
                </c:pt>
                <c:pt idx="856">
                  <c:v>1.45</c:v>
                </c:pt>
                <c:pt idx="857">
                  <c:v>1.45</c:v>
                </c:pt>
                <c:pt idx="858">
                  <c:v>1.46</c:v>
                </c:pt>
                <c:pt idx="859">
                  <c:v>1.46</c:v>
                </c:pt>
                <c:pt idx="860">
                  <c:v>1.47</c:v>
                </c:pt>
                <c:pt idx="861">
                  <c:v>1.47</c:v>
                </c:pt>
                <c:pt idx="862">
                  <c:v>1.47</c:v>
                </c:pt>
                <c:pt idx="863">
                  <c:v>1.47</c:v>
                </c:pt>
                <c:pt idx="864">
                  <c:v>1.48</c:v>
                </c:pt>
                <c:pt idx="865">
                  <c:v>1.48</c:v>
                </c:pt>
                <c:pt idx="866">
                  <c:v>1.48</c:v>
                </c:pt>
                <c:pt idx="867">
                  <c:v>1.48</c:v>
                </c:pt>
                <c:pt idx="868">
                  <c:v>1.48</c:v>
                </c:pt>
                <c:pt idx="869">
                  <c:v>1.48</c:v>
                </c:pt>
                <c:pt idx="870">
                  <c:v>1.48</c:v>
                </c:pt>
                <c:pt idx="871">
                  <c:v>1.48</c:v>
                </c:pt>
                <c:pt idx="872">
                  <c:v>1.48</c:v>
                </c:pt>
                <c:pt idx="873">
                  <c:v>1.48</c:v>
                </c:pt>
                <c:pt idx="874">
                  <c:v>1.48</c:v>
                </c:pt>
                <c:pt idx="875">
                  <c:v>1.48</c:v>
                </c:pt>
                <c:pt idx="876">
                  <c:v>1.48</c:v>
                </c:pt>
                <c:pt idx="877">
                  <c:v>1.48</c:v>
                </c:pt>
                <c:pt idx="878">
                  <c:v>1.48</c:v>
                </c:pt>
                <c:pt idx="879">
                  <c:v>1.48</c:v>
                </c:pt>
                <c:pt idx="880">
                  <c:v>1.48</c:v>
                </c:pt>
                <c:pt idx="881">
                  <c:v>1.48</c:v>
                </c:pt>
                <c:pt idx="882">
                  <c:v>1.48</c:v>
                </c:pt>
                <c:pt idx="883">
                  <c:v>1.48</c:v>
                </c:pt>
                <c:pt idx="884">
                  <c:v>1.47</c:v>
                </c:pt>
                <c:pt idx="885">
                  <c:v>1.47</c:v>
                </c:pt>
                <c:pt idx="886">
                  <c:v>1.47</c:v>
                </c:pt>
                <c:pt idx="887">
                  <c:v>1.46</c:v>
                </c:pt>
                <c:pt idx="888">
                  <c:v>1.46</c:v>
                </c:pt>
                <c:pt idx="889">
                  <c:v>1.45</c:v>
                </c:pt>
                <c:pt idx="890">
                  <c:v>1.45</c:v>
                </c:pt>
                <c:pt idx="891">
                  <c:v>1.44</c:v>
                </c:pt>
                <c:pt idx="892">
                  <c:v>1.44</c:v>
                </c:pt>
                <c:pt idx="893">
                  <c:v>1.43</c:v>
                </c:pt>
                <c:pt idx="894">
                  <c:v>1.43</c:v>
                </c:pt>
                <c:pt idx="895">
                  <c:v>1.42</c:v>
                </c:pt>
                <c:pt idx="896">
                  <c:v>1.42</c:v>
                </c:pt>
                <c:pt idx="897">
                  <c:v>1.41</c:v>
                </c:pt>
                <c:pt idx="898">
                  <c:v>1.41</c:v>
                </c:pt>
                <c:pt idx="899">
                  <c:v>1.41</c:v>
                </c:pt>
                <c:pt idx="900">
                  <c:v>1.41</c:v>
                </c:pt>
                <c:pt idx="901">
                  <c:v>1.4</c:v>
                </c:pt>
                <c:pt idx="902">
                  <c:v>1.4</c:v>
                </c:pt>
                <c:pt idx="903">
                  <c:v>1.4</c:v>
                </c:pt>
                <c:pt idx="904">
                  <c:v>1.39</c:v>
                </c:pt>
                <c:pt idx="905">
                  <c:v>1.39</c:v>
                </c:pt>
                <c:pt idx="906">
                  <c:v>1.38</c:v>
                </c:pt>
                <c:pt idx="907">
                  <c:v>1.38</c:v>
                </c:pt>
                <c:pt idx="908">
                  <c:v>1.37</c:v>
                </c:pt>
                <c:pt idx="909">
                  <c:v>1.36</c:v>
                </c:pt>
                <c:pt idx="910">
                  <c:v>1.35</c:v>
                </c:pt>
                <c:pt idx="911">
                  <c:v>1.34</c:v>
                </c:pt>
                <c:pt idx="912">
                  <c:v>1.33</c:v>
                </c:pt>
                <c:pt idx="913">
                  <c:v>1.32</c:v>
                </c:pt>
                <c:pt idx="914">
                  <c:v>1.31</c:v>
                </c:pt>
                <c:pt idx="915">
                  <c:v>1.3</c:v>
                </c:pt>
                <c:pt idx="916">
                  <c:v>1.29</c:v>
                </c:pt>
                <c:pt idx="917">
                  <c:v>1.29</c:v>
                </c:pt>
                <c:pt idx="918">
                  <c:v>1.28</c:v>
                </c:pt>
                <c:pt idx="919">
                  <c:v>1.27</c:v>
                </c:pt>
                <c:pt idx="920">
                  <c:v>1.27</c:v>
                </c:pt>
                <c:pt idx="921">
                  <c:v>1.26</c:v>
                </c:pt>
                <c:pt idx="922">
                  <c:v>1.26</c:v>
                </c:pt>
                <c:pt idx="923">
                  <c:v>1.25</c:v>
                </c:pt>
                <c:pt idx="924">
                  <c:v>1.25</c:v>
                </c:pt>
                <c:pt idx="925">
                  <c:v>1.24</c:v>
                </c:pt>
                <c:pt idx="926">
                  <c:v>1.23</c:v>
                </c:pt>
                <c:pt idx="927">
                  <c:v>1.22</c:v>
                </c:pt>
                <c:pt idx="928">
                  <c:v>1.22</c:v>
                </c:pt>
                <c:pt idx="929">
                  <c:v>1.21</c:v>
                </c:pt>
                <c:pt idx="930">
                  <c:v>1.2</c:v>
                </c:pt>
                <c:pt idx="931">
                  <c:v>1.19</c:v>
                </c:pt>
                <c:pt idx="932">
                  <c:v>1.18</c:v>
                </c:pt>
                <c:pt idx="933">
                  <c:v>1.17</c:v>
                </c:pt>
                <c:pt idx="934">
                  <c:v>1.1599999999999999</c:v>
                </c:pt>
                <c:pt idx="935">
                  <c:v>1.1399999999999999</c:v>
                </c:pt>
                <c:pt idx="936">
                  <c:v>1.1299999999999999</c:v>
                </c:pt>
                <c:pt idx="937">
                  <c:v>1.1200000000000001</c:v>
                </c:pt>
                <c:pt idx="938">
                  <c:v>1.1200000000000001</c:v>
                </c:pt>
                <c:pt idx="939">
                  <c:v>1.1100000000000001</c:v>
                </c:pt>
                <c:pt idx="940">
                  <c:v>1.1100000000000001</c:v>
                </c:pt>
                <c:pt idx="941">
                  <c:v>1.1000000000000001</c:v>
                </c:pt>
                <c:pt idx="942">
                  <c:v>1.1000000000000001</c:v>
                </c:pt>
                <c:pt idx="943">
                  <c:v>1.0900000000000001</c:v>
                </c:pt>
                <c:pt idx="944">
                  <c:v>1.0900000000000001</c:v>
                </c:pt>
                <c:pt idx="945">
                  <c:v>1.08</c:v>
                </c:pt>
                <c:pt idx="946">
                  <c:v>1.08</c:v>
                </c:pt>
                <c:pt idx="947">
                  <c:v>1.07</c:v>
                </c:pt>
                <c:pt idx="948">
                  <c:v>1.06</c:v>
                </c:pt>
                <c:pt idx="949">
                  <c:v>1.05</c:v>
                </c:pt>
                <c:pt idx="950">
                  <c:v>1.05</c:v>
                </c:pt>
                <c:pt idx="951">
                  <c:v>1.04</c:v>
                </c:pt>
                <c:pt idx="952">
                  <c:v>1.03</c:v>
                </c:pt>
                <c:pt idx="953">
                  <c:v>1.02</c:v>
                </c:pt>
                <c:pt idx="954">
                  <c:v>1.01</c:v>
                </c:pt>
                <c:pt idx="955">
                  <c:v>1</c:v>
                </c:pt>
                <c:pt idx="956">
                  <c:v>0.996</c:v>
                </c:pt>
                <c:pt idx="957">
                  <c:v>0.98899999999999999</c:v>
                </c:pt>
                <c:pt idx="958">
                  <c:v>0.98</c:v>
                </c:pt>
                <c:pt idx="959">
                  <c:v>0.97399999999999998</c:v>
                </c:pt>
                <c:pt idx="960">
                  <c:v>0.97199999999999998</c:v>
                </c:pt>
                <c:pt idx="961">
                  <c:v>0.96799999999999997</c:v>
                </c:pt>
                <c:pt idx="962">
                  <c:v>0.96399999999999997</c:v>
                </c:pt>
                <c:pt idx="963">
                  <c:v>0.96199999999999997</c:v>
                </c:pt>
                <c:pt idx="964">
                  <c:v>0.95699999999999996</c:v>
                </c:pt>
                <c:pt idx="965">
                  <c:v>0.95199999999999996</c:v>
                </c:pt>
                <c:pt idx="966">
                  <c:v>0.94799999999999995</c:v>
                </c:pt>
                <c:pt idx="967">
                  <c:v>0.94399999999999995</c:v>
                </c:pt>
                <c:pt idx="968">
                  <c:v>0.93899999999999995</c:v>
                </c:pt>
                <c:pt idx="969">
                  <c:v>0.93300000000000005</c:v>
                </c:pt>
                <c:pt idx="970">
                  <c:v>0.92800000000000005</c:v>
                </c:pt>
                <c:pt idx="971">
                  <c:v>0.92300000000000004</c:v>
                </c:pt>
                <c:pt idx="972">
                  <c:v>0.91800000000000004</c:v>
                </c:pt>
                <c:pt idx="973">
                  <c:v>0.91400000000000003</c:v>
                </c:pt>
                <c:pt idx="974">
                  <c:v>0.91100000000000003</c:v>
                </c:pt>
                <c:pt idx="975">
                  <c:v>0.90600000000000003</c:v>
                </c:pt>
                <c:pt idx="976">
                  <c:v>0.9</c:v>
                </c:pt>
                <c:pt idx="977">
                  <c:v>0.89500000000000002</c:v>
                </c:pt>
                <c:pt idx="978">
                  <c:v>0.89</c:v>
                </c:pt>
                <c:pt idx="979">
                  <c:v>0.88500000000000001</c:v>
                </c:pt>
                <c:pt idx="980">
                  <c:v>0.88</c:v>
                </c:pt>
                <c:pt idx="981">
                  <c:v>0.875</c:v>
                </c:pt>
                <c:pt idx="982">
                  <c:v>0.872</c:v>
                </c:pt>
                <c:pt idx="983">
                  <c:v>0.86899999999999999</c:v>
                </c:pt>
                <c:pt idx="984">
                  <c:v>0.86799999999999999</c:v>
                </c:pt>
                <c:pt idx="985">
                  <c:v>0.86499999999999999</c:v>
                </c:pt>
                <c:pt idx="986">
                  <c:v>0.86399999999999999</c:v>
                </c:pt>
                <c:pt idx="987">
                  <c:v>0.86199999999999999</c:v>
                </c:pt>
                <c:pt idx="988">
                  <c:v>0.85899999999999999</c:v>
                </c:pt>
                <c:pt idx="989">
                  <c:v>0.85399999999999998</c:v>
                </c:pt>
                <c:pt idx="990">
                  <c:v>0.85099999999999998</c:v>
                </c:pt>
                <c:pt idx="991">
                  <c:v>0.84699999999999998</c:v>
                </c:pt>
                <c:pt idx="992">
                  <c:v>0.84199999999999997</c:v>
                </c:pt>
                <c:pt idx="993">
                  <c:v>0.83699999999999997</c:v>
                </c:pt>
                <c:pt idx="994">
                  <c:v>0.83099999999999996</c:v>
                </c:pt>
                <c:pt idx="995">
                  <c:v>0.82499999999999996</c:v>
                </c:pt>
                <c:pt idx="996">
                  <c:v>0.82199999999999995</c:v>
                </c:pt>
                <c:pt idx="997">
                  <c:v>0.81399999999999995</c:v>
                </c:pt>
                <c:pt idx="998">
                  <c:v>0.80900000000000005</c:v>
                </c:pt>
                <c:pt idx="999">
                  <c:v>0.80400000000000005</c:v>
                </c:pt>
                <c:pt idx="1000">
                  <c:v>0.8</c:v>
                </c:pt>
                <c:pt idx="1001">
                  <c:v>0.79500000000000004</c:v>
                </c:pt>
                <c:pt idx="1002">
                  <c:v>0.79</c:v>
                </c:pt>
                <c:pt idx="1003">
                  <c:v>0.78600000000000003</c:v>
                </c:pt>
                <c:pt idx="1004">
                  <c:v>0.78500000000000003</c:v>
                </c:pt>
                <c:pt idx="1005">
                  <c:v>0.78400000000000003</c:v>
                </c:pt>
                <c:pt idx="1006">
                  <c:v>0.78100000000000003</c:v>
                </c:pt>
                <c:pt idx="1007">
                  <c:v>0.78</c:v>
                </c:pt>
                <c:pt idx="1008">
                  <c:v>0.77900000000000003</c:v>
                </c:pt>
                <c:pt idx="1009">
                  <c:v>0.77600000000000002</c:v>
                </c:pt>
                <c:pt idx="1010">
                  <c:v>0.77400000000000002</c:v>
                </c:pt>
                <c:pt idx="1011">
                  <c:v>0.77</c:v>
                </c:pt>
                <c:pt idx="1012">
                  <c:v>0.76700000000000002</c:v>
                </c:pt>
                <c:pt idx="1013">
                  <c:v>0.76300000000000001</c:v>
                </c:pt>
                <c:pt idx="1014">
                  <c:v>0.75900000000000001</c:v>
                </c:pt>
                <c:pt idx="1015">
                  <c:v>0.754</c:v>
                </c:pt>
                <c:pt idx="1016">
                  <c:v>0.75</c:v>
                </c:pt>
                <c:pt idx="1017">
                  <c:v>0.746</c:v>
                </c:pt>
                <c:pt idx="1018">
                  <c:v>0.74199999999999999</c:v>
                </c:pt>
                <c:pt idx="1019">
                  <c:v>0.73699999999999999</c:v>
                </c:pt>
                <c:pt idx="1020">
                  <c:v>0.73399999999999999</c:v>
                </c:pt>
                <c:pt idx="1021">
                  <c:v>0.72899999999999998</c:v>
                </c:pt>
                <c:pt idx="1022">
                  <c:v>0.72499999999999998</c:v>
                </c:pt>
                <c:pt idx="1023">
                  <c:v>0.72299999999999998</c:v>
                </c:pt>
                <c:pt idx="1024">
                  <c:v>0.72</c:v>
                </c:pt>
                <c:pt idx="1025">
                  <c:v>0.71899999999999997</c:v>
                </c:pt>
                <c:pt idx="1026">
                  <c:v>0.71699999999999997</c:v>
                </c:pt>
                <c:pt idx="1027">
                  <c:v>0.71699999999999997</c:v>
                </c:pt>
                <c:pt idx="1028">
                  <c:v>0.71499999999999997</c:v>
                </c:pt>
                <c:pt idx="1029">
                  <c:v>0.71399999999999997</c:v>
                </c:pt>
                <c:pt idx="1030">
                  <c:v>0.71299999999999997</c:v>
                </c:pt>
                <c:pt idx="1031">
                  <c:v>0.71</c:v>
                </c:pt>
                <c:pt idx="1032">
                  <c:v>0.70799999999999996</c:v>
                </c:pt>
                <c:pt idx="1033">
                  <c:v>0.70599999999999996</c:v>
                </c:pt>
                <c:pt idx="1034">
                  <c:v>0.70199999999999996</c:v>
                </c:pt>
                <c:pt idx="1035">
                  <c:v>0.69899999999999995</c:v>
                </c:pt>
                <c:pt idx="1036">
                  <c:v>0.69599999999999995</c:v>
                </c:pt>
                <c:pt idx="1037">
                  <c:v>0.69299999999999995</c:v>
                </c:pt>
                <c:pt idx="1038">
                  <c:v>0.69099999999999995</c:v>
                </c:pt>
                <c:pt idx="1039">
                  <c:v>0.68799999999999994</c:v>
                </c:pt>
                <c:pt idx="1040">
                  <c:v>0.68600000000000005</c:v>
                </c:pt>
                <c:pt idx="1041">
                  <c:v>0.68400000000000005</c:v>
                </c:pt>
                <c:pt idx="1042">
                  <c:v>0.68200000000000005</c:v>
                </c:pt>
                <c:pt idx="1043">
                  <c:v>0.68</c:v>
                </c:pt>
                <c:pt idx="1044">
                  <c:v>0.67900000000000005</c:v>
                </c:pt>
                <c:pt idx="1045">
                  <c:v>0.67700000000000005</c:v>
                </c:pt>
                <c:pt idx="1046">
                  <c:v>0.67700000000000005</c:v>
                </c:pt>
                <c:pt idx="1047">
                  <c:v>0.67500000000000004</c:v>
                </c:pt>
                <c:pt idx="1048">
                  <c:v>0.67500000000000004</c:v>
                </c:pt>
                <c:pt idx="1049">
                  <c:v>0.67500000000000004</c:v>
                </c:pt>
                <c:pt idx="1050">
                  <c:v>0.67500000000000004</c:v>
                </c:pt>
                <c:pt idx="1051">
                  <c:v>0.67600000000000005</c:v>
                </c:pt>
                <c:pt idx="1052">
                  <c:v>0.67600000000000005</c:v>
                </c:pt>
                <c:pt idx="1053">
                  <c:v>0.67500000000000004</c:v>
                </c:pt>
                <c:pt idx="1054">
                  <c:v>0.67400000000000004</c:v>
                </c:pt>
                <c:pt idx="1055">
                  <c:v>0.67100000000000004</c:v>
                </c:pt>
                <c:pt idx="1056">
                  <c:v>0.67</c:v>
                </c:pt>
                <c:pt idx="1057">
                  <c:v>0.66800000000000004</c:v>
                </c:pt>
                <c:pt idx="1058">
                  <c:v>0.66700000000000004</c:v>
                </c:pt>
                <c:pt idx="1059">
                  <c:v>0.66700000000000004</c:v>
                </c:pt>
                <c:pt idx="1060">
                  <c:v>0.66700000000000004</c:v>
                </c:pt>
                <c:pt idx="1061">
                  <c:v>0.66700000000000004</c:v>
                </c:pt>
                <c:pt idx="1062">
                  <c:v>0.66800000000000004</c:v>
                </c:pt>
                <c:pt idx="1063">
                  <c:v>0.66800000000000004</c:v>
                </c:pt>
                <c:pt idx="1064">
                  <c:v>0.67</c:v>
                </c:pt>
                <c:pt idx="1065">
                  <c:v>0.67100000000000004</c:v>
                </c:pt>
                <c:pt idx="1066">
                  <c:v>0.67400000000000004</c:v>
                </c:pt>
                <c:pt idx="1067">
                  <c:v>0.67500000000000004</c:v>
                </c:pt>
                <c:pt idx="1068">
                  <c:v>0.67600000000000005</c:v>
                </c:pt>
                <c:pt idx="1069">
                  <c:v>0.67600000000000005</c:v>
                </c:pt>
                <c:pt idx="1070">
                  <c:v>0.67700000000000005</c:v>
                </c:pt>
                <c:pt idx="1071">
                  <c:v>0.67700000000000005</c:v>
                </c:pt>
                <c:pt idx="1072">
                  <c:v>0.67900000000000005</c:v>
                </c:pt>
                <c:pt idx="1073">
                  <c:v>0.68</c:v>
                </c:pt>
                <c:pt idx="1074">
                  <c:v>0.68200000000000005</c:v>
                </c:pt>
                <c:pt idx="1075">
                  <c:v>0.68400000000000005</c:v>
                </c:pt>
                <c:pt idx="1076">
                  <c:v>0.68500000000000005</c:v>
                </c:pt>
                <c:pt idx="1077">
                  <c:v>0.68600000000000005</c:v>
                </c:pt>
                <c:pt idx="1078">
                  <c:v>0.68700000000000006</c:v>
                </c:pt>
                <c:pt idx="1079">
                  <c:v>0.69</c:v>
                </c:pt>
                <c:pt idx="1080">
                  <c:v>0.69199999999999995</c:v>
                </c:pt>
                <c:pt idx="1081">
                  <c:v>0.69499999999999995</c:v>
                </c:pt>
                <c:pt idx="1082">
                  <c:v>0.69799999999999995</c:v>
                </c:pt>
                <c:pt idx="1083">
                  <c:v>0.70099999999999996</c:v>
                </c:pt>
                <c:pt idx="1084">
                  <c:v>0.70299999999999996</c:v>
                </c:pt>
                <c:pt idx="1085">
                  <c:v>0.70599999999999996</c:v>
                </c:pt>
                <c:pt idx="1086">
                  <c:v>0.70799999999999996</c:v>
                </c:pt>
                <c:pt idx="1087">
                  <c:v>0.70899999999999996</c:v>
                </c:pt>
                <c:pt idx="1088">
                  <c:v>0.71199999999999997</c:v>
                </c:pt>
                <c:pt idx="1089">
                  <c:v>0.71299999999999997</c:v>
                </c:pt>
                <c:pt idx="1090">
                  <c:v>0.71299999999999997</c:v>
                </c:pt>
                <c:pt idx="1091">
                  <c:v>0.71399999999999997</c:v>
                </c:pt>
                <c:pt idx="1092">
                  <c:v>0.71399999999999997</c:v>
                </c:pt>
                <c:pt idx="1093">
                  <c:v>0.71399999999999997</c:v>
                </c:pt>
                <c:pt idx="1094">
                  <c:v>0.71499999999999997</c:v>
                </c:pt>
                <c:pt idx="1095">
                  <c:v>0.71699999999999997</c:v>
                </c:pt>
                <c:pt idx="1096">
                  <c:v>0.71799999999999997</c:v>
                </c:pt>
                <c:pt idx="1097">
                  <c:v>0.71799999999999997</c:v>
                </c:pt>
                <c:pt idx="1098">
                  <c:v>0.71799999999999997</c:v>
                </c:pt>
                <c:pt idx="1099">
                  <c:v>0.71899999999999997</c:v>
                </c:pt>
                <c:pt idx="1100">
                  <c:v>0.71899999999999997</c:v>
                </c:pt>
                <c:pt idx="1101">
                  <c:v>0.72</c:v>
                </c:pt>
                <c:pt idx="1102">
                  <c:v>0.72</c:v>
                </c:pt>
                <c:pt idx="1103">
                  <c:v>0.72</c:v>
                </c:pt>
                <c:pt idx="1104">
                  <c:v>0.72</c:v>
                </c:pt>
                <c:pt idx="1105">
                  <c:v>0.72</c:v>
                </c:pt>
                <c:pt idx="1106">
                  <c:v>0.71899999999999997</c:v>
                </c:pt>
                <c:pt idx="1107">
                  <c:v>0.71899999999999997</c:v>
                </c:pt>
                <c:pt idx="1108">
                  <c:v>0.71799999999999997</c:v>
                </c:pt>
                <c:pt idx="1109">
                  <c:v>0.71699999999999997</c:v>
                </c:pt>
                <c:pt idx="1110">
                  <c:v>0.71699999999999997</c:v>
                </c:pt>
                <c:pt idx="1111">
                  <c:v>0.71499999999999997</c:v>
                </c:pt>
                <c:pt idx="1112">
                  <c:v>0.71499999999999997</c:v>
                </c:pt>
                <c:pt idx="1113">
                  <c:v>0.71499999999999997</c:v>
                </c:pt>
                <c:pt idx="1114">
                  <c:v>0.71499999999999997</c:v>
                </c:pt>
                <c:pt idx="1115">
                  <c:v>0.71399999999999997</c:v>
                </c:pt>
                <c:pt idx="1116">
                  <c:v>0.71399999999999997</c:v>
                </c:pt>
                <c:pt idx="1117">
                  <c:v>0.71299999999999997</c:v>
                </c:pt>
                <c:pt idx="1118">
                  <c:v>0.71199999999999997</c:v>
                </c:pt>
                <c:pt idx="1119">
                  <c:v>0.71</c:v>
                </c:pt>
                <c:pt idx="1120">
                  <c:v>0.70799999999999996</c:v>
                </c:pt>
                <c:pt idx="1121">
                  <c:v>0.70699999999999996</c:v>
                </c:pt>
                <c:pt idx="1122">
                  <c:v>0.70399999999999996</c:v>
                </c:pt>
                <c:pt idx="1123">
                  <c:v>0.70199999999999996</c:v>
                </c:pt>
                <c:pt idx="1124">
                  <c:v>0.69899999999999995</c:v>
                </c:pt>
                <c:pt idx="1125">
                  <c:v>0.69699999999999995</c:v>
                </c:pt>
                <c:pt idx="1126">
                  <c:v>0.69499999999999995</c:v>
                </c:pt>
                <c:pt idx="1127">
                  <c:v>0.69199999999999995</c:v>
                </c:pt>
                <c:pt idx="1128">
                  <c:v>0.69</c:v>
                </c:pt>
                <c:pt idx="1129">
                  <c:v>0.68700000000000006</c:v>
                </c:pt>
                <c:pt idx="1130">
                  <c:v>0.68500000000000005</c:v>
                </c:pt>
                <c:pt idx="1131">
                  <c:v>0.68400000000000005</c:v>
                </c:pt>
                <c:pt idx="1132">
                  <c:v>0.68200000000000005</c:v>
                </c:pt>
                <c:pt idx="1133">
                  <c:v>0.68</c:v>
                </c:pt>
                <c:pt idx="1134">
                  <c:v>0.67900000000000005</c:v>
                </c:pt>
                <c:pt idx="1135">
                  <c:v>0.67900000000000005</c:v>
                </c:pt>
                <c:pt idx="1136">
                  <c:v>0.67700000000000005</c:v>
                </c:pt>
                <c:pt idx="1137">
                  <c:v>0.67700000000000005</c:v>
                </c:pt>
                <c:pt idx="1138">
                  <c:v>0.67600000000000005</c:v>
                </c:pt>
                <c:pt idx="1139">
                  <c:v>0.67600000000000005</c:v>
                </c:pt>
                <c:pt idx="1140">
                  <c:v>0.67500000000000004</c:v>
                </c:pt>
                <c:pt idx="1141">
                  <c:v>0.67400000000000004</c:v>
                </c:pt>
                <c:pt idx="1142">
                  <c:v>0.67400000000000004</c:v>
                </c:pt>
                <c:pt idx="1143">
                  <c:v>0.67100000000000004</c:v>
                </c:pt>
                <c:pt idx="1144">
                  <c:v>0.66900000000000004</c:v>
                </c:pt>
                <c:pt idx="1145">
                  <c:v>0.66500000000000004</c:v>
                </c:pt>
                <c:pt idx="1146">
                  <c:v>0.66300000000000003</c:v>
                </c:pt>
                <c:pt idx="1147">
                  <c:v>0.65800000000000003</c:v>
                </c:pt>
                <c:pt idx="1148">
                  <c:v>0.65400000000000003</c:v>
                </c:pt>
                <c:pt idx="1149">
                  <c:v>0.65100000000000002</c:v>
                </c:pt>
                <c:pt idx="1150">
                  <c:v>0.64700000000000002</c:v>
                </c:pt>
                <c:pt idx="1151">
                  <c:v>0.64500000000000002</c:v>
                </c:pt>
                <c:pt idx="1152">
                  <c:v>0.64200000000000002</c:v>
                </c:pt>
                <c:pt idx="1153">
                  <c:v>0.63800000000000001</c:v>
                </c:pt>
                <c:pt idx="1154">
                  <c:v>0.63600000000000001</c:v>
                </c:pt>
                <c:pt idx="1155">
                  <c:v>0.63400000000000001</c:v>
                </c:pt>
                <c:pt idx="1156">
                  <c:v>0.63200000000000001</c:v>
                </c:pt>
                <c:pt idx="1157">
                  <c:v>0.63100000000000001</c:v>
                </c:pt>
                <c:pt idx="1158">
                  <c:v>0.63</c:v>
                </c:pt>
                <c:pt idx="1159">
                  <c:v>0.63</c:v>
                </c:pt>
                <c:pt idx="1160">
                  <c:v>0.629</c:v>
                </c:pt>
                <c:pt idx="1161">
                  <c:v>0.627</c:v>
                </c:pt>
                <c:pt idx="1162">
                  <c:v>0.626</c:v>
                </c:pt>
                <c:pt idx="1163">
                  <c:v>0.625</c:v>
                </c:pt>
                <c:pt idx="1164">
                  <c:v>0.623</c:v>
                </c:pt>
                <c:pt idx="1165">
                  <c:v>0.62</c:v>
                </c:pt>
                <c:pt idx="1166">
                  <c:v>0.61599999999999999</c:v>
                </c:pt>
                <c:pt idx="1167">
                  <c:v>0.61399999999999999</c:v>
                </c:pt>
                <c:pt idx="1168">
                  <c:v>0.61199999999999999</c:v>
                </c:pt>
                <c:pt idx="1169">
                  <c:v>0.60899999999999999</c:v>
                </c:pt>
                <c:pt idx="1170">
                  <c:v>0.60699999999999998</c:v>
                </c:pt>
                <c:pt idx="1171">
                  <c:v>0.60399999999999998</c:v>
                </c:pt>
                <c:pt idx="1172">
                  <c:v>0.60199999999999998</c:v>
                </c:pt>
                <c:pt idx="1173">
                  <c:v>0.60099999999999998</c:v>
                </c:pt>
                <c:pt idx="1174">
                  <c:v>0.59799999999999998</c:v>
                </c:pt>
                <c:pt idx="1175">
                  <c:v>0.59699999999999998</c:v>
                </c:pt>
                <c:pt idx="1176">
                  <c:v>0.59599999999999997</c:v>
                </c:pt>
                <c:pt idx="1177">
                  <c:v>0.59399999999999997</c:v>
                </c:pt>
                <c:pt idx="1178">
                  <c:v>0.59299999999999997</c:v>
                </c:pt>
                <c:pt idx="1179">
                  <c:v>0.59199999999999997</c:v>
                </c:pt>
                <c:pt idx="1180">
                  <c:v>0.59099999999999997</c:v>
                </c:pt>
                <c:pt idx="1181">
                  <c:v>0.59099999999999997</c:v>
                </c:pt>
                <c:pt idx="1182">
                  <c:v>0.59099999999999997</c:v>
                </c:pt>
                <c:pt idx="1183">
                  <c:v>0.59099999999999997</c:v>
                </c:pt>
                <c:pt idx="1184">
                  <c:v>0.59</c:v>
                </c:pt>
                <c:pt idx="1185">
                  <c:v>0.58599999999999997</c:v>
                </c:pt>
                <c:pt idx="1186">
                  <c:v>0.58399999999999996</c:v>
                </c:pt>
                <c:pt idx="1187">
                  <c:v>0.58199999999999996</c:v>
                </c:pt>
                <c:pt idx="1188">
                  <c:v>0.57999999999999996</c:v>
                </c:pt>
                <c:pt idx="1189">
                  <c:v>0.57899999999999996</c:v>
                </c:pt>
                <c:pt idx="1190">
                  <c:v>0.57699999999999996</c:v>
                </c:pt>
                <c:pt idx="1191">
                  <c:v>0.57599999999999996</c:v>
                </c:pt>
                <c:pt idx="1192">
                  <c:v>0.57499999999999996</c:v>
                </c:pt>
                <c:pt idx="1193">
                  <c:v>0.57499999999999996</c:v>
                </c:pt>
                <c:pt idx="1194">
                  <c:v>0.57399999999999995</c:v>
                </c:pt>
                <c:pt idx="1195">
                  <c:v>0.57399999999999995</c:v>
                </c:pt>
                <c:pt idx="1196">
                  <c:v>0.57399999999999995</c:v>
                </c:pt>
                <c:pt idx="1197">
                  <c:v>0.57499999999999996</c:v>
                </c:pt>
                <c:pt idx="1198">
                  <c:v>0.57499999999999996</c:v>
                </c:pt>
                <c:pt idx="1199">
                  <c:v>0.57499999999999996</c:v>
                </c:pt>
                <c:pt idx="1200">
                  <c:v>0.57499999999999996</c:v>
                </c:pt>
                <c:pt idx="1201">
                  <c:v>0.57399999999999995</c:v>
                </c:pt>
                <c:pt idx="1202">
                  <c:v>0.57599999999999996</c:v>
                </c:pt>
                <c:pt idx="1203">
                  <c:v>0.57899999999999996</c:v>
                </c:pt>
                <c:pt idx="1204">
                  <c:v>0.57899999999999996</c:v>
                </c:pt>
                <c:pt idx="1205">
                  <c:v>0.57999999999999996</c:v>
                </c:pt>
                <c:pt idx="1206">
                  <c:v>0.58099999999999996</c:v>
                </c:pt>
                <c:pt idx="1207">
                  <c:v>0.58399999999999996</c:v>
                </c:pt>
                <c:pt idx="1208">
                  <c:v>0.58599999999999997</c:v>
                </c:pt>
                <c:pt idx="1209">
                  <c:v>0.58799999999999997</c:v>
                </c:pt>
                <c:pt idx="1210">
                  <c:v>0.59</c:v>
                </c:pt>
                <c:pt idx="1211">
                  <c:v>0.59199999999999997</c:v>
                </c:pt>
                <c:pt idx="1212">
                  <c:v>0.59599999999999997</c:v>
                </c:pt>
                <c:pt idx="1213">
                  <c:v>0.59799999999999998</c:v>
                </c:pt>
                <c:pt idx="1214">
                  <c:v>0.60199999999999998</c:v>
                </c:pt>
                <c:pt idx="1215">
                  <c:v>0.60699999999999998</c:v>
                </c:pt>
                <c:pt idx="1216">
                  <c:v>0.61299999999999999</c:v>
                </c:pt>
                <c:pt idx="1217">
                  <c:v>0.61799999999999999</c:v>
                </c:pt>
                <c:pt idx="1218">
                  <c:v>0.624</c:v>
                </c:pt>
                <c:pt idx="1219">
                  <c:v>0.629</c:v>
                </c:pt>
                <c:pt idx="1220">
                  <c:v>0.63400000000000001</c:v>
                </c:pt>
                <c:pt idx="1221">
                  <c:v>0.63700000000000001</c:v>
                </c:pt>
                <c:pt idx="1222">
                  <c:v>0.64</c:v>
                </c:pt>
                <c:pt idx="1223">
                  <c:v>0.64200000000000002</c:v>
                </c:pt>
                <c:pt idx="1224">
                  <c:v>0.64500000000000002</c:v>
                </c:pt>
                <c:pt idx="1225">
                  <c:v>0.64600000000000002</c:v>
                </c:pt>
                <c:pt idx="1226">
                  <c:v>0.64800000000000002</c:v>
                </c:pt>
                <c:pt idx="1227">
                  <c:v>0.65300000000000002</c:v>
                </c:pt>
                <c:pt idx="1228">
                  <c:v>0.65800000000000003</c:v>
                </c:pt>
                <c:pt idx="1229">
                  <c:v>0.66300000000000003</c:v>
                </c:pt>
                <c:pt idx="1230">
                  <c:v>0.66700000000000004</c:v>
                </c:pt>
                <c:pt idx="1231">
                  <c:v>0.67100000000000004</c:v>
                </c:pt>
                <c:pt idx="1232">
                  <c:v>0.67500000000000004</c:v>
                </c:pt>
                <c:pt idx="1233">
                  <c:v>0.68</c:v>
                </c:pt>
                <c:pt idx="1234">
                  <c:v>0.68500000000000005</c:v>
                </c:pt>
                <c:pt idx="1235">
                  <c:v>0.68799999999999994</c:v>
                </c:pt>
                <c:pt idx="1236">
                  <c:v>0.69199999999999995</c:v>
                </c:pt>
                <c:pt idx="1237">
                  <c:v>0.69499999999999995</c:v>
                </c:pt>
                <c:pt idx="1238">
                  <c:v>0.69699999999999995</c:v>
                </c:pt>
                <c:pt idx="1239">
                  <c:v>0.69899999999999995</c:v>
                </c:pt>
                <c:pt idx="1240">
                  <c:v>0.70099999999999996</c:v>
                </c:pt>
                <c:pt idx="1241">
                  <c:v>0.70199999999999996</c:v>
                </c:pt>
                <c:pt idx="1242">
                  <c:v>0.70299999999999996</c:v>
                </c:pt>
                <c:pt idx="1243">
                  <c:v>0.70299999999999996</c:v>
                </c:pt>
                <c:pt idx="1244">
                  <c:v>0.70399999999999996</c:v>
                </c:pt>
                <c:pt idx="1245">
                  <c:v>0.70399999999999996</c:v>
                </c:pt>
                <c:pt idx="1246">
                  <c:v>0.70399999999999996</c:v>
                </c:pt>
                <c:pt idx="1247">
                  <c:v>0.70399999999999996</c:v>
                </c:pt>
                <c:pt idx="1248">
                  <c:v>0.70599999999999996</c:v>
                </c:pt>
                <c:pt idx="1249">
                  <c:v>0.70599999999999996</c:v>
                </c:pt>
                <c:pt idx="1250">
                  <c:v>0.70599999999999996</c:v>
                </c:pt>
                <c:pt idx="1251">
                  <c:v>0.70399999999999996</c:v>
                </c:pt>
                <c:pt idx="1252">
                  <c:v>0.70299999999999996</c:v>
                </c:pt>
                <c:pt idx="1253">
                  <c:v>0.70199999999999996</c:v>
                </c:pt>
                <c:pt idx="1254">
                  <c:v>0.70099999999999996</c:v>
                </c:pt>
                <c:pt idx="1255">
                  <c:v>0.69899999999999995</c:v>
                </c:pt>
                <c:pt idx="1256">
                  <c:v>0.69699999999999995</c:v>
                </c:pt>
                <c:pt idx="1257">
                  <c:v>0.69499999999999995</c:v>
                </c:pt>
                <c:pt idx="1258">
                  <c:v>0.69199999999999995</c:v>
                </c:pt>
                <c:pt idx="1259">
                  <c:v>0.68799999999999994</c:v>
                </c:pt>
                <c:pt idx="1260">
                  <c:v>0.68500000000000005</c:v>
                </c:pt>
                <c:pt idx="1261">
                  <c:v>0.68100000000000005</c:v>
                </c:pt>
                <c:pt idx="1262">
                  <c:v>0.68</c:v>
                </c:pt>
                <c:pt idx="1263">
                  <c:v>0.67500000000000004</c:v>
                </c:pt>
                <c:pt idx="1264">
                  <c:v>0.67400000000000004</c:v>
                </c:pt>
                <c:pt idx="1265">
                  <c:v>0.67300000000000004</c:v>
                </c:pt>
                <c:pt idx="1266">
                  <c:v>0.67100000000000004</c:v>
                </c:pt>
                <c:pt idx="1267">
                  <c:v>0.67</c:v>
                </c:pt>
                <c:pt idx="1268">
                  <c:v>0.66900000000000004</c:v>
                </c:pt>
                <c:pt idx="1269">
                  <c:v>0.66800000000000004</c:v>
                </c:pt>
                <c:pt idx="1270">
                  <c:v>0.66500000000000004</c:v>
                </c:pt>
                <c:pt idx="1271">
                  <c:v>0.66300000000000003</c:v>
                </c:pt>
                <c:pt idx="1272">
                  <c:v>0.66</c:v>
                </c:pt>
                <c:pt idx="1273">
                  <c:v>0.65600000000000003</c:v>
                </c:pt>
                <c:pt idx="1274">
                  <c:v>0.65200000000000002</c:v>
                </c:pt>
                <c:pt idx="1275">
                  <c:v>0.64700000000000002</c:v>
                </c:pt>
                <c:pt idx="1276">
                  <c:v>0.64300000000000002</c:v>
                </c:pt>
                <c:pt idx="1277">
                  <c:v>0.64</c:v>
                </c:pt>
                <c:pt idx="1278">
                  <c:v>0.63600000000000001</c:v>
                </c:pt>
                <c:pt idx="1279">
                  <c:v>0.63200000000000001</c:v>
                </c:pt>
                <c:pt idx="1280">
                  <c:v>0.627</c:v>
                </c:pt>
                <c:pt idx="1281">
                  <c:v>0.624</c:v>
                </c:pt>
                <c:pt idx="1282">
                  <c:v>0.621</c:v>
                </c:pt>
                <c:pt idx="1283">
                  <c:v>0.61899999999999999</c:v>
                </c:pt>
                <c:pt idx="1284">
                  <c:v>0.61599999999999999</c:v>
                </c:pt>
                <c:pt idx="1285">
                  <c:v>0.61499999999999999</c:v>
                </c:pt>
                <c:pt idx="1286">
                  <c:v>0.61399999999999999</c:v>
                </c:pt>
                <c:pt idx="1287">
                  <c:v>0.61299999999999999</c:v>
                </c:pt>
                <c:pt idx="1288">
                  <c:v>0.61199999999999999</c:v>
                </c:pt>
                <c:pt idx="1289">
                  <c:v>0.61199999999999999</c:v>
                </c:pt>
                <c:pt idx="1290">
                  <c:v>0.61</c:v>
                </c:pt>
                <c:pt idx="1291">
                  <c:v>0.61</c:v>
                </c:pt>
                <c:pt idx="1292">
                  <c:v>0.61199999999999999</c:v>
                </c:pt>
                <c:pt idx="1293">
                  <c:v>0.61</c:v>
                </c:pt>
                <c:pt idx="1294">
                  <c:v>0.60899999999999999</c:v>
                </c:pt>
                <c:pt idx="1295">
                  <c:v>0.60699999999999998</c:v>
                </c:pt>
                <c:pt idx="1296">
                  <c:v>0.60299999999999998</c:v>
                </c:pt>
                <c:pt idx="1297">
                  <c:v>0.60199999999999998</c:v>
                </c:pt>
                <c:pt idx="1298">
                  <c:v>0.59699999999999998</c:v>
                </c:pt>
                <c:pt idx="1299">
                  <c:v>0.59399999999999997</c:v>
                </c:pt>
                <c:pt idx="1300">
                  <c:v>0.59199999999999997</c:v>
                </c:pt>
                <c:pt idx="1301">
                  <c:v>0.59</c:v>
                </c:pt>
                <c:pt idx="1302">
                  <c:v>0.58799999999999997</c:v>
                </c:pt>
                <c:pt idx="1303">
                  <c:v>0.58699999999999997</c:v>
                </c:pt>
                <c:pt idx="1304">
                  <c:v>0.58499999999999996</c:v>
                </c:pt>
                <c:pt idx="1305">
                  <c:v>0.58499999999999996</c:v>
                </c:pt>
                <c:pt idx="1306">
                  <c:v>0.58399999999999996</c:v>
                </c:pt>
                <c:pt idx="1307">
                  <c:v>0.58399999999999996</c:v>
                </c:pt>
                <c:pt idx="1308">
                  <c:v>0.58399999999999996</c:v>
                </c:pt>
                <c:pt idx="1309">
                  <c:v>0.58199999999999996</c:v>
                </c:pt>
                <c:pt idx="1310">
                  <c:v>0.58199999999999996</c:v>
                </c:pt>
                <c:pt idx="1311">
                  <c:v>0.58199999999999996</c:v>
                </c:pt>
                <c:pt idx="1312">
                  <c:v>0.58199999999999996</c:v>
                </c:pt>
                <c:pt idx="1313">
                  <c:v>0.58099999999999996</c:v>
                </c:pt>
                <c:pt idx="1314">
                  <c:v>0.58199999999999996</c:v>
                </c:pt>
                <c:pt idx="1315">
                  <c:v>0.58399999999999996</c:v>
                </c:pt>
                <c:pt idx="1316">
                  <c:v>0.58399999999999996</c:v>
                </c:pt>
                <c:pt idx="1317">
                  <c:v>0.58399999999999996</c:v>
                </c:pt>
                <c:pt idx="1318">
                  <c:v>0.58399999999999996</c:v>
                </c:pt>
                <c:pt idx="1319">
                  <c:v>0.58499999999999996</c:v>
                </c:pt>
                <c:pt idx="1320">
                  <c:v>0.58699999999999997</c:v>
                </c:pt>
                <c:pt idx="1321">
                  <c:v>0.59099999999999997</c:v>
                </c:pt>
                <c:pt idx="1322">
                  <c:v>0.59599999999999997</c:v>
                </c:pt>
                <c:pt idx="1323">
                  <c:v>0.60199999999999998</c:v>
                </c:pt>
                <c:pt idx="1324">
                  <c:v>0.60799999999999998</c:v>
                </c:pt>
                <c:pt idx="1325">
                  <c:v>0.61399999999999999</c:v>
                </c:pt>
                <c:pt idx="1326">
                  <c:v>0.62</c:v>
                </c:pt>
                <c:pt idx="1327">
                  <c:v>0.626</c:v>
                </c:pt>
                <c:pt idx="1328">
                  <c:v>0.63100000000000001</c:v>
                </c:pt>
                <c:pt idx="1329">
                  <c:v>0.63400000000000001</c:v>
                </c:pt>
                <c:pt idx="1330">
                  <c:v>0.63700000000000001</c:v>
                </c:pt>
                <c:pt idx="1331">
                  <c:v>0.63800000000000001</c:v>
                </c:pt>
                <c:pt idx="1332">
                  <c:v>0.64100000000000001</c:v>
                </c:pt>
                <c:pt idx="1333">
                  <c:v>0.64500000000000002</c:v>
                </c:pt>
                <c:pt idx="1334">
                  <c:v>0.64700000000000002</c:v>
                </c:pt>
                <c:pt idx="1335">
                  <c:v>0.65300000000000002</c:v>
                </c:pt>
                <c:pt idx="1336">
                  <c:v>0.66</c:v>
                </c:pt>
                <c:pt idx="1337">
                  <c:v>0.66700000000000004</c:v>
                </c:pt>
                <c:pt idx="1338">
                  <c:v>0.67100000000000004</c:v>
                </c:pt>
                <c:pt idx="1339">
                  <c:v>0.67900000000000005</c:v>
                </c:pt>
                <c:pt idx="1340">
                  <c:v>0.68500000000000005</c:v>
                </c:pt>
                <c:pt idx="1341">
                  <c:v>0.69</c:v>
                </c:pt>
                <c:pt idx="1342">
                  <c:v>0.69599999999999995</c:v>
                </c:pt>
                <c:pt idx="1343">
                  <c:v>0.70099999999999996</c:v>
                </c:pt>
                <c:pt idx="1344">
                  <c:v>0.70699999999999996</c:v>
                </c:pt>
                <c:pt idx="1345">
                  <c:v>0.70899999999999996</c:v>
                </c:pt>
                <c:pt idx="1346">
                  <c:v>0.71199999999999997</c:v>
                </c:pt>
                <c:pt idx="1347">
                  <c:v>0.71499999999999997</c:v>
                </c:pt>
                <c:pt idx="1348">
                  <c:v>0.71499999999999997</c:v>
                </c:pt>
                <c:pt idx="1349">
                  <c:v>0.71699999999999997</c:v>
                </c:pt>
                <c:pt idx="1350">
                  <c:v>0.71799999999999997</c:v>
                </c:pt>
                <c:pt idx="1351">
                  <c:v>0.71899999999999997</c:v>
                </c:pt>
                <c:pt idx="1352">
                  <c:v>0.72</c:v>
                </c:pt>
                <c:pt idx="1353">
                  <c:v>0.72</c:v>
                </c:pt>
                <c:pt idx="1354">
                  <c:v>0.72099999999999997</c:v>
                </c:pt>
                <c:pt idx="1355">
                  <c:v>0.72099999999999997</c:v>
                </c:pt>
                <c:pt idx="1356">
                  <c:v>0.72099999999999997</c:v>
                </c:pt>
                <c:pt idx="1357">
                  <c:v>0.72099999999999997</c:v>
                </c:pt>
                <c:pt idx="1358">
                  <c:v>0.72099999999999997</c:v>
                </c:pt>
                <c:pt idx="1359">
                  <c:v>0.72099999999999997</c:v>
                </c:pt>
                <c:pt idx="1360">
                  <c:v>0.72</c:v>
                </c:pt>
                <c:pt idx="1361">
                  <c:v>0.71899999999999997</c:v>
                </c:pt>
                <c:pt idx="1362">
                  <c:v>0.71699999999999997</c:v>
                </c:pt>
                <c:pt idx="1363">
                  <c:v>0.71299999999999997</c:v>
                </c:pt>
                <c:pt idx="1364">
                  <c:v>0.71</c:v>
                </c:pt>
                <c:pt idx="1365">
                  <c:v>0.70699999999999996</c:v>
                </c:pt>
                <c:pt idx="1366">
                  <c:v>0.70299999999999996</c:v>
                </c:pt>
                <c:pt idx="1367">
                  <c:v>0.69899999999999995</c:v>
                </c:pt>
                <c:pt idx="1368">
                  <c:v>0.69599999999999995</c:v>
                </c:pt>
                <c:pt idx="1369">
                  <c:v>0.69199999999999995</c:v>
                </c:pt>
                <c:pt idx="1370">
                  <c:v>0.69</c:v>
                </c:pt>
                <c:pt idx="1371">
                  <c:v>0.68799999999999994</c:v>
                </c:pt>
                <c:pt idx="1372">
                  <c:v>0.68600000000000005</c:v>
                </c:pt>
                <c:pt idx="1373">
                  <c:v>0.68500000000000005</c:v>
                </c:pt>
                <c:pt idx="1374">
                  <c:v>0.68500000000000005</c:v>
                </c:pt>
                <c:pt idx="1375">
                  <c:v>0.70099999999999996</c:v>
                </c:pt>
                <c:pt idx="1376">
                  <c:v>0.70699999999999996</c:v>
                </c:pt>
                <c:pt idx="1377">
                  <c:v>0.70699999999999996</c:v>
                </c:pt>
                <c:pt idx="1378">
                  <c:v>0.70399999999999996</c:v>
                </c:pt>
                <c:pt idx="1379">
                  <c:v>0.70099999999999996</c:v>
                </c:pt>
                <c:pt idx="1380">
                  <c:v>0.69599999999999995</c:v>
                </c:pt>
                <c:pt idx="1381">
                  <c:v>0.69299999999999995</c:v>
                </c:pt>
                <c:pt idx="1382">
                  <c:v>0.69</c:v>
                </c:pt>
                <c:pt idx="1383">
                  <c:v>0.68600000000000005</c:v>
                </c:pt>
                <c:pt idx="1384">
                  <c:v>0.68200000000000005</c:v>
                </c:pt>
                <c:pt idx="1385">
                  <c:v>0.67700000000000005</c:v>
                </c:pt>
                <c:pt idx="1386">
                  <c:v>0.67</c:v>
                </c:pt>
                <c:pt idx="1387">
                  <c:v>0.66400000000000003</c:v>
                </c:pt>
                <c:pt idx="1388">
                  <c:v>0.65900000000000003</c:v>
                </c:pt>
                <c:pt idx="1389">
                  <c:v>0.65300000000000002</c:v>
                </c:pt>
                <c:pt idx="1390">
                  <c:v>0.64900000000000002</c:v>
                </c:pt>
                <c:pt idx="1391">
                  <c:v>0.64800000000000002</c:v>
                </c:pt>
                <c:pt idx="1392">
                  <c:v>0.64800000000000002</c:v>
                </c:pt>
                <c:pt idx="1393">
                  <c:v>0.64900000000000002</c:v>
                </c:pt>
                <c:pt idx="1394">
                  <c:v>0.64900000000000002</c:v>
                </c:pt>
                <c:pt idx="1395">
                  <c:v>0.64900000000000002</c:v>
                </c:pt>
                <c:pt idx="1396">
                  <c:v>0.64800000000000002</c:v>
                </c:pt>
                <c:pt idx="1397">
                  <c:v>0.64900000000000002</c:v>
                </c:pt>
                <c:pt idx="1398">
                  <c:v>0.64900000000000002</c:v>
                </c:pt>
                <c:pt idx="1399">
                  <c:v>0.64900000000000002</c:v>
                </c:pt>
                <c:pt idx="1400">
                  <c:v>0.64900000000000002</c:v>
                </c:pt>
                <c:pt idx="1401">
                  <c:v>0.64900000000000002</c:v>
                </c:pt>
                <c:pt idx="1402">
                  <c:v>0.64800000000000002</c:v>
                </c:pt>
                <c:pt idx="1403">
                  <c:v>0.64500000000000002</c:v>
                </c:pt>
                <c:pt idx="1404">
                  <c:v>0.64</c:v>
                </c:pt>
                <c:pt idx="1405">
                  <c:v>0.63700000000000001</c:v>
                </c:pt>
                <c:pt idx="1406">
                  <c:v>0.63600000000000001</c:v>
                </c:pt>
                <c:pt idx="1407">
                  <c:v>0.63600000000000001</c:v>
                </c:pt>
                <c:pt idx="1408">
                  <c:v>0.63500000000000001</c:v>
                </c:pt>
                <c:pt idx="1409">
                  <c:v>0.63400000000000001</c:v>
                </c:pt>
                <c:pt idx="1410">
                  <c:v>0.63200000000000001</c:v>
                </c:pt>
                <c:pt idx="1411">
                  <c:v>0.63400000000000001</c:v>
                </c:pt>
                <c:pt idx="1412">
                  <c:v>0.63500000000000001</c:v>
                </c:pt>
                <c:pt idx="1413">
                  <c:v>0.63600000000000001</c:v>
                </c:pt>
                <c:pt idx="1414">
                  <c:v>0.64</c:v>
                </c:pt>
                <c:pt idx="1415">
                  <c:v>0.64200000000000002</c:v>
                </c:pt>
                <c:pt idx="1416">
                  <c:v>0.64500000000000002</c:v>
                </c:pt>
                <c:pt idx="1417">
                  <c:v>0.64600000000000002</c:v>
                </c:pt>
                <c:pt idx="1418">
                  <c:v>0.64700000000000002</c:v>
                </c:pt>
                <c:pt idx="1419">
                  <c:v>0.64800000000000002</c:v>
                </c:pt>
                <c:pt idx="1420">
                  <c:v>0.65200000000000002</c:v>
                </c:pt>
                <c:pt idx="1421">
                  <c:v>0.65700000000000003</c:v>
                </c:pt>
                <c:pt idx="1422">
                  <c:v>0.66300000000000003</c:v>
                </c:pt>
                <c:pt idx="1423">
                  <c:v>0.66700000000000004</c:v>
                </c:pt>
                <c:pt idx="1424">
                  <c:v>0.67</c:v>
                </c:pt>
                <c:pt idx="1425">
                  <c:v>0.67300000000000004</c:v>
                </c:pt>
                <c:pt idx="1426">
                  <c:v>0.67600000000000005</c:v>
                </c:pt>
                <c:pt idx="1427">
                  <c:v>0.67900000000000005</c:v>
                </c:pt>
                <c:pt idx="1428">
                  <c:v>0.68200000000000005</c:v>
                </c:pt>
                <c:pt idx="1429">
                  <c:v>0.68600000000000005</c:v>
                </c:pt>
                <c:pt idx="1430">
                  <c:v>0.69</c:v>
                </c:pt>
                <c:pt idx="1431">
                  <c:v>0.69599999999999995</c:v>
                </c:pt>
                <c:pt idx="1432">
                  <c:v>0.69899999999999995</c:v>
                </c:pt>
                <c:pt idx="1433">
                  <c:v>0.70399999999999996</c:v>
                </c:pt>
                <c:pt idx="1434">
                  <c:v>0.70699999999999996</c:v>
                </c:pt>
                <c:pt idx="1435">
                  <c:v>0.70799999999999996</c:v>
                </c:pt>
                <c:pt idx="1436">
                  <c:v>0.70899999999999996</c:v>
                </c:pt>
                <c:pt idx="1437">
                  <c:v>0.71</c:v>
                </c:pt>
                <c:pt idx="1438">
                  <c:v>0.71</c:v>
                </c:pt>
                <c:pt idx="1439">
                  <c:v>0.71199999999999997</c:v>
                </c:pt>
                <c:pt idx="1440">
                  <c:v>0.71199999999999997</c:v>
                </c:pt>
                <c:pt idx="1441">
                  <c:v>0.71199999999999997</c:v>
                </c:pt>
                <c:pt idx="1442">
                  <c:v>0.71299999999999997</c:v>
                </c:pt>
                <c:pt idx="1443">
                  <c:v>0.71399999999999997</c:v>
                </c:pt>
                <c:pt idx="1444">
                  <c:v>0.71399999999999997</c:v>
                </c:pt>
                <c:pt idx="1445">
                  <c:v>0.71299999999999997</c:v>
                </c:pt>
                <c:pt idx="1446">
                  <c:v>0.71299999999999997</c:v>
                </c:pt>
                <c:pt idx="1447">
                  <c:v>0.71299999999999997</c:v>
                </c:pt>
                <c:pt idx="1448">
                  <c:v>0.71299999999999997</c:v>
                </c:pt>
                <c:pt idx="1449">
                  <c:v>0.71299999999999997</c:v>
                </c:pt>
                <c:pt idx="1450">
                  <c:v>0.71299999999999997</c:v>
                </c:pt>
                <c:pt idx="1451">
                  <c:v>0.71199999999999997</c:v>
                </c:pt>
                <c:pt idx="1452">
                  <c:v>0.71</c:v>
                </c:pt>
                <c:pt idx="1453">
                  <c:v>0.71</c:v>
                </c:pt>
                <c:pt idx="1454">
                  <c:v>0.70899999999999996</c:v>
                </c:pt>
                <c:pt idx="1455">
                  <c:v>0.70899999999999996</c:v>
                </c:pt>
                <c:pt idx="1456">
                  <c:v>0.70899999999999996</c:v>
                </c:pt>
                <c:pt idx="1457">
                  <c:v>0.71</c:v>
                </c:pt>
                <c:pt idx="1458">
                  <c:v>0.71</c:v>
                </c:pt>
                <c:pt idx="1459">
                  <c:v>0.71199999999999997</c:v>
                </c:pt>
                <c:pt idx="1460">
                  <c:v>0.71199999999999997</c:v>
                </c:pt>
                <c:pt idx="1461">
                  <c:v>0.71199999999999997</c:v>
                </c:pt>
                <c:pt idx="1462">
                  <c:v>0.71199999999999997</c:v>
                </c:pt>
                <c:pt idx="1463">
                  <c:v>0.71</c:v>
                </c:pt>
                <c:pt idx="1464">
                  <c:v>0.71</c:v>
                </c:pt>
                <c:pt idx="1465">
                  <c:v>0.71</c:v>
                </c:pt>
                <c:pt idx="1466">
                  <c:v>0.71199999999999997</c:v>
                </c:pt>
                <c:pt idx="1467">
                  <c:v>0.71499999999999997</c:v>
                </c:pt>
                <c:pt idx="1468">
                  <c:v>0.71699999999999997</c:v>
                </c:pt>
                <c:pt idx="1469">
                  <c:v>0.71699999999999997</c:v>
                </c:pt>
                <c:pt idx="1470">
                  <c:v>0.71399999999999997</c:v>
                </c:pt>
                <c:pt idx="1471">
                  <c:v>0.71199999999999997</c:v>
                </c:pt>
                <c:pt idx="1472">
                  <c:v>0.71199999999999997</c:v>
                </c:pt>
                <c:pt idx="1473">
                  <c:v>0.71499999999999997</c:v>
                </c:pt>
                <c:pt idx="1474">
                  <c:v>0.71899999999999997</c:v>
                </c:pt>
                <c:pt idx="1475">
                  <c:v>0.72399999999999998</c:v>
                </c:pt>
                <c:pt idx="1476">
                  <c:v>0.72799999999999998</c:v>
                </c:pt>
                <c:pt idx="1477">
                  <c:v>0.73399999999999999</c:v>
                </c:pt>
                <c:pt idx="1478">
                  <c:v>0.74199999999999999</c:v>
                </c:pt>
                <c:pt idx="1479">
                  <c:v>0.748</c:v>
                </c:pt>
                <c:pt idx="1480">
                  <c:v>0.753</c:v>
                </c:pt>
                <c:pt idx="1481">
                  <c:v>0.75700000000000001</c:v>
                </c:pt>
                <c:pt idx="1482">
                  <c:v>0.76100000000000001</c:v>
                </c:pt>
                <c:pt idx="1483">
                  <c:v>0.76300000000000001</c:v>
                </c:pt>
                <c:pt idx="1484">
                  <c:v>0.76400000000000001</c:v>
                </c:pt>
                <c:pt idx="1485">
                  <c:v>0.76400000000000001</c:v>
                </c:pt>
                <c:pt idx="1486">
                  <c:v>0.76200000000000001</c:v>
                </c:pt>
                <c:pt idx="1487">
                  <c:v>0.75900000000000001</c:v>
                </c:pt>
                <c:pt idx="1488">
                  <c:v>0.75900000000000001</c:v>
                </c:pt>
                <c:pt idx="1489">
                  <c:v>0.75900000000000001</c:v>
                </c:pt>
                <c:pt idx="1490">
                  <c:v>0.75600000000000001</c:v>
                </c:pt>
                <c:pt idx="1491">
                  <c:v>0.75700000000000001</c:v>
                </c:pt>
                <c:pt idx="1492">
                  <c:v>0.75900000000000001</c:v>
                </c:pt>
                <c:pt idx="1493">
                  <c:v>0.75900000000000001</c:v>
                </c:pt>
                <c:pt idx="1494">
                  <c:v>0.75700000000000001</c:v>
                </c:pt>
                <c:pt idx="1495">
                  <c:v>0.75700000000000001</c:v>
                </c:pt>
                <c:pt idx="1496">
                  <c:v>0.75800000000000001</c:v>
                </c:pt>
                <c:pt idx="1497">
                  <c:v>0.76100000000000001</c:v>
                </c:pt>
                <c:pt idx="1498">
                  <c:v>0.76700000000000002</c:v>
                </c:pt>
                <c:pt idx="1499">
                  <c:v>0.77300000000000002</c:v>
                </c:pt>
                <c:pt idx="1500">
                  <c:v>0.77600000000000002</c:v>
                </c:pt>
                <c:pt idx="1501">
                  <c:v>0.78</c:v>
                </c:pt>
                <c:pt idx="1502">
                  <c:v>0.78200000000000003</c:v>
                </c:pt>
                <c:pt idx="1503">
                  <c:v>0.78400000000000003</c:v>
                </c:pt>
                <c:pt idx="1504">
                  <c:v>0.78400000000000003</c:v>
                </c:pt>
                <c:pt idx="1505">
                  <c:v>0.78500000000000003</c:v>
                </c:pt>
                <c:pt idx="1506">
                  <c:v>0.78500000000000003</c:v>
                </c:pt>
                <c:pt idx="1507">
                  <c:v>0.78500000000000003</c:v>
                </c:pt>
                <c:pt idx="1508">
                  <c:v>0.78900000000000003</c:v>
                </c:pt>
                <c:pt idx="1509">
                  <c:v>0.79100000000000004</c:v>
                </c:pt>
                <c:pt idx="1510">
                  <c:v>0.79200000000000004</c:v>
                </c:pt>
                <c:pt idx="1511">
                  <c:v>0.78900000000000003</c:v>
                </c:pt>
                <c:pt idx="1512">
                  <c:v>0.78400000000000003</c:v>
                </c:pt>
                <c:pt idx="1513">
                  <c:v>0.78</c:v>
                </c:pt>
                <c:pt idx="1514">
                  <c:v>0.77900000000000003</c:v>
                </c:pt>
                <c:pt idx="1515">
                  <c:v>0.77900000000000003</c:v>
                </c:pt>
                <c:pt idx="1516">
                  <c:v>0.78100000000000003</c:v>
                </c:pt>
                <c:pt idx="1517">
                  <c:v>0.78900000000000003</c:v>
                </c:pt>
                <c:pt idx="1518">
                  <c:v>0.79300000000000004</c:v>
                </c:pt>
                <c:pt idx="1519">
                  <c:v>0.79700000000000004</c:v>
                </c:pt>
                <c:pt idx="1520">
                  <c:v>0.79800000000000004</c:v>
                </c:pt>
                <c:pt idx="1521">
                  <c:v>0.8</c:v>
                </c:pt>
                <c:pt idx="1522">
                  <c:v>0.80100000000000005</c:v>
                </c:pt>
                <c:pt idx="1523">
                  <c:v>0.80200000000000005</c:v>
                </c:pt>
                <c:pt idx="1524">
                  <c:v>0.80800000000000005</c:v>
                </c:pt>
                <c:pt idx="1525">
                  <c:v>0.81299999999999994</c:v>
                </c:pt>
                <c:pt idx="1526">
                  <c:v>0.81699999999999995</c:v>
                </c:pt>
                <c:pt idx="1527">
                  <c:v>0.81899999999999995</c:v>
                </c:pt>
                <c:pt idx="1528">
                  <c:v>0.82499999999999996</c:v>
                </c:pt>
                <c:pt idx="1529">
                  <c:v>0.83299999999999996</c:v>
                </c:pt>
                <c:pt idx="1530">
                  <c:v>0.84099999999999997</c:v>
                </c:pt>
                <c:pt idx="1531">
                  <c:v>0.84599999999999997</c:v>
                </c:pt>
                <c:pt idx="1532">
                  <c:v>0.85099999999999998</c:v>
                </c:pt>
                <c:pt idx="1533">
                  <c:v>0.85899999999999999</c:v>
                </c:pt>
                <c:pt idx="1534">
                  <c:v>0.86199999999999999</c:v>
                </c:pt>
                <c:pt idx="1535">
                  <c:v>0.86199999999999999</c:v>
                </c:pt>
                <c:pt idx="1536">
                  <c:v>0.88300000000000001</c:v>
                </c:pt>
                <c:pt idx="1537">
                  <c:v>0.91900000000000004</c:v>
                </c:pt>
                <c:pt idx="1538">
                  <c:v>0.92</c:v>
                </c:pt>
                <c:pt idx="1539">
                  <c:v>0.88300000000000001</c:v>
                </c:pt>
                <c:pt idx="1540">
                  <c:v>0.78200000000000003</c:v>
                </c:pt>
                <c:pt idx="1541">
                  <c:v>0.67100000000000004</c:v>
                </c:pt>
                <c:pt idx="1542">
                  <c:v>0.58199999999999996</c:v>
                </c:pt>
                <c:pt idx="1543">
                  <c:v>0.52600000000000002</c:v>
                </c:pt>
                <c:pt idx="1544">
                  <c:v>0.49399999999999999</c:v>
                </c:pt>
                <c:pt idx="1545">
                  <c:v>0.47499999999999998</c:v>
                </c:pt>
                <c:pt idx="1546">
                  <c:v>0.46500000000000002</c:v>
                </c:pt>
                <c:pt idx="1547">
                  <c:v>0.45900000000000002</c:v>
                </c:pt>
                <c:pt idx="1548">
                  <c:v>0.45400000000000001</c:v>
                </c:pt>
                <c:pt idx="1549">
                  <c:v>0.45</c:v>
                </c:pt>
                <c:pt idx="1550">
                  <c:v>0.44700000000000001</c:v>
                </c:pt>
                <c:pt idx="1551">
                  <c:v>0.443</c:v>
                </c:pt>
                <c:pt idx="1552">
                  <c:v>0.441</c:v>
                </c:pt>
                <c:pt idx="1553">
                  <c:v>0.437</c:v>
                </c:pt>
                <c:pt idx="1554">
                  <c:v>0.436</c:v>
                </c:pt>
                <c:pt idx="1555">
                  <c:v>0.432</c:v>
                </c:pt>
                <c:pt idx="1556">
                  <c:v>0.43099999999999999</c:v>
                </c:pt>
                <c:pt idx="1557">
                  <c:v>0.43</c:v>
                </c:pt>
                <c:pt idx="1558">
                  <c:v>0.42799999999999999</c:v>
                </c:pt>
                <c:pt idx="1559">
                  <c:v>0.42599999999999999</c:v>
                </c:pt>
                <c:pt idx="1560">
                  <c:v>0.42499999999999999</c:v>
                </c:pt>
                <c:pt idx="1561">
                  <c:v>0.42399999999999999</c:v>
                </c:pt>
                <c:pt idx="1562">
                  <c:v>0.42199999999999999</c:v>
                </c:pt>
                <c:pt idx="1563">
                  <c:v>0.42099999999999999</c:v>
                </c:pt>
                <c:pt idx="1564">
                  <c:v>0.42099999999999999</c:v>
                </c:pt>
                <c:pt idx="1565">
                  <c:v>0.42</c:v>
                </c:pt>
                <c:pt idx="1566">
                  <c:v>0.42</c:v>
                </c:pt>
                <c:pt idx="1567">
                  <c:v>0.42</c:v>
                </c:pt>
                <c:pt idx="1568">
                  <c:v>0.42099999999999999</c:v>
                </c:pt>
                <c:pt idx="1569">
                  <c:v>0.42099999999999999</c:v>
                </c:pt>
                <c:pt idx="1570">
                  <c:v>0.42099999999999999</c:v>
                </c:pt>
                <c:pt idx="1571">
                  <c:v>0.42</c:v>
                </c:pt>
                <c:pt idx="1572">
                  <c:v>0.42</c:v>
                </c:pt>
                <c:pt idx="1573">
                  <c:v>0.41899999999999998</c:v>
                </c:pt>
                <c:pt idx="1574">
                  <c:v>0.41699999999999998</c:v>
                </c:pt>
                <c:pt idx="1575">
                  <c:v>0.41599999999999998</c:v>
                </c:pt>
                <c:pt idx="1576">
                  <c:v>0.41599999999999998</c:v>
                </c:pt>
                <c:pt idx="1577">
                  <c:v>0.41499999999999998</c:v>
                </c:pt>
                <c:pt idx="1578">
                  <c:v>0.41399999999999998</c:v>
                </c:pt>
                <c:pt idx="1579">
                  <c:v>0.41399999999999998</c:v>
                </c:pt>
                <c:pt idx="1580">
                  <c:v>0.41299999999999998</c:v>
                </c:pt>
                <c:pt idx="1581">
                  <c:v>0.41299999999999998</c:v>
                </c:pt>
                <c:pt idx="1582">
                  <c:v>0.41099999999999998</c:v>
                </c:pt>
                <c:pt idx="1583">
                  <c:v>0.41099999999999998</c:v>
                </c:pt>
                <c:pt idx="1584">
                  <c:v>0.41099999999999998</c:v>
                </c:pt>
                <c:pt idx="1585">
                  <c:v>0.41</c:v>
                </c:pt>
                <c:pt idx="1586">
                  <c:v>0.41</c:v>
                </c:pt>
                <c:pt idx="1587">
                  <c:v>0.41099999999999998</c:v>
                </c:pt>
                <c:pt idx="1588">
                  <c:v>0.41099999999999998</c:v>
                </c:pt>
                <c:pt idx="1589">
                  <c:v>0.41299999999999998</c:v>
                </c:pt>
                <c:pt idx="1590">
                  <c:v>0.41399999999999998</c:v>
                </c:pt>
                <c:pt idx="1591">
                  <c:v>0.41399999999999998</c:v>
                </c:pt>
                <c:pt idx="1592">
                  <c:v>0.41399999999999998</c:v>
                </c:pt>
                <c:pt idx="1593">
                  <c:v>0.41299999999999998</c:v>
                </c:pt>
                <c:pt idx="1594">
                  <c:v>0.41099999999999998</c:v>
                </c:pt>
                <c:pt idx="1595">
                  <c:v>0.41</c:v>
                </c:pt>
                <c:pt idx="1596">
                  <c:v>0.41</c:v>
                </c:pt>
                <c:pt idx="1597">
                  <c:v>0.40899999999999997</c:v>
                </c:pt>
                <c:pt idx="1598">
                  <c:v>0.40899999999999997</c:v>
                </c:pt>
                <c:pt idx="1599">
                  <c:v>0.40799999999999997</c:v>
                </c:pt>
                <c:pt idx="1600">
                  <c:v>0.40799999999999997</c:v>
                </c:pt>
                <c:pt idx="1601">
                  <c:v>0.40799999999999997</c:v>
                </c:pt>
                <c:pt idx="1602">
                  <c:v>0.40600000000000003</c:v>
                </c:pt>
                <c:pt idx="1603">
                  <c:v>0.40500000000000003</c:v>
                </c:pt>
                <c:pt idx="1604">
                  <c:v>0.40600000000000003</c:v>
                </c:pt>
                <c:pt idx="1605">
                  <c:v>0.40600000000000003</c:v>
                </c:pt>
                <c:pt idx="1606">
                  <c:v>0.40799999999999997</c:v>
                </c:pt>
                <c:pt idx="1607">
                  <c:v>0.40799999999999997</c:v>
                </c:pt>
                <c:pt idx="1608">
                  <c:v>0.40899999999999997</c:v>
                </c:pt>
                <c:pt idx="1609">
                  <c:v>0.40899999999999997</c:v>
                </c:pt>
                <c:pt idx="1610">
                  <c:v>0.40799999999999997</c:v>
                </c:pt>
                <c:pt idx="1611">
                  <c:v>0.40799999999999997</c:v>
                </c:pt>
                <c:pt idx="1612">
                  <c:v>0.40799999999999997</c:v>
                </c:pt>
                <c:pt idx="1613">
                  <c:v>0.40899999999999997</c:v>
                </c:pt>
                <c:pt idx="1614">
                  <c:v>0.40899999999999997</c:v>
                </c:pt>
                <c:pt idx="1615">
                  <c:v>0.40899999999999997</c:v>
                </c:pt>
                <c:pt idx="1616">
                  <c:v>0.40899999999999997</c:v>
                </c:pt>
                <c:pt idx="1617">
                  <c:v>0.40899999999999997</c:v>
                </c:pt>
                <c:pt idx="1618">
                  <c:v>0.40799999999999997</c:v>
                </c:pt>
                <c:pt idx="1619">
                  <c:v>0.40799999999999997</c:v>
                </c:pt>
                <c:pt idx="1620">
                  <c:v>0.40600000000000003</c:v>
                </c:pt>
                <c:pt idx="1621">
                  <c:v>0.40500000000000003</c:v>
                </c:pt>
                <c:pt idx="1622">
                  <c:v>0.40500000000000003</c:v>
                </c:pt>
                <c:pt idx="1623">
                  <c:v>0.40500000000000003</c:v>
                </c:pt>
                <c:pt idx="1624">
                  <c:v>0.40500000000000003</c:v>
                </c:pt>
                <c:pt idx="1625">
                  <c:v>0.40400000000000003</c:v>
                </c:pt>
                <c:pt idx="1626">
                  <c:v>0.40400000000000003</c:v>
                </c:pt>
                <c:pt idx="1627">
                  <c:v>0.40400000000000003</c:v>
                </c:pt>
                <c:pt idx="1628">
                  <c:v>0.40400000000000003</c:v>
                </c:pt>
                <c:pt idx="1629">
                  <c:v>0.40300000000000002</c:v>
                </c:pt>
                <c:pt idx="1630">
                  <c:v>0.40300000000000002</c:v>
                </c:pt>
                <c:pt idx="1631">
                  <c:v>0.40400000000000003</c:v>
                </c:pt>
                <c:pt idx="1632">
                  <c:v>0.40300000000000002</c:v>
                </c:pt>
                <c:pt idx="1633">
                  <c:v>0.40500000000000003</c:v>
                </c:pt>
                <c:pt idx="1634">
                  <c:v>0.40600000000000003</c:v>
                </c:pt>
                <c:pt idx="1635">
                  <c:v>0.40600000000000003</c:v>
                </c:pt>
                <c:pt idx="1636">
                  <c:v>0.40799999999999997</c:v>
                </c:pt>
                <c:pt idx="1637">
                  <c:v>0.40600000000000003</c:v>
                </c:pt>
                <c:pt idx="1638">
                  <c:v>0.40600000000000003</c:v>
                </c:pt>
                <c:pt idx="1639">
                  <c:v>0.40500000000000003</c:v>
                </c:pt>
                <c:pt idx="1640">
                  <c:v>0.40400000000000003</c:v>
                </c:pt>
                <c:pt idx="1641">
                  <c:v>0.40400000000000003</c:v>
                </c:pt>
                <c:pt idx="1642">
                  <c:v>0.40300000000000002</c:v>
                </c:pt>
                <c:pt idx="1643">
                  <c:v>0.40300000000000002</c:v>
                </c:pt>
                <c:pt idx="1644">
                  <c:v>0.40300000000000002</c:v>
                </c:pt>
                <c:pt idx="1645">
                  <c:v>0.40300000000000002</c:v>
                </c:pt>
                <c:pt idx="1646">
                  <c:v>0.40300000000000002</c:v>
                </c:pt>
                <c:pt idx="1647">
                  <c:v>0.40300000000000002</c:v>
                </c:pt>
                <c:pt idx="1648">
                  <c:v>0.40300000000000002</c:v>
                </c:pt>
                <c:pt idx="1649">
                  <c:v>0.40200000000000002</c:v>
                </c:pt>
                <c:pt idx="1650">
                  <c:v>0.40200000000000002</c:v>
                </c:pt>
                <c:pt idx="1651">
                  <c:v>0.40200000000000002</c:v>
                </c:pt>
                <c:pt idx="1652">
                  <c:v>0.40200000000000002</c:v>
                </c:pt>
                <c:pt idx="1653">
                  <c:v>0.40300000000000002</c:v>
                </c:pt>
                <c:pt idx="1654">
                  <c:v>0.40400000000000003</c:v>
                </c:pt>
                <c:pt idx="1655">
                  <c:v>0.40500000000000003</c:v>
                </c:pt>
                <c:pt idx="1656">
                  <c:v>0.40500000000000003</c:v>
                </c:pt>
                <c:pt idx="1657">
                  <c:v>0.40500000000000003</c:v>
                </c:pt>
                <c:pt idx="1658">
                  <c:v>0.40500000000000003</c:v>
                </c:pt>
                <c:pt idx="1659">
                  <c:v>0.40400000000000003</c:v>
                </c:pt>
                <c:pt idx="1660">
                  <c:v>0.40400000000000003</c:v>
                </c:pt>
                <c:pt idx="1661">
                  <c:v>0.40300000000000002</c:v>
                </c:pt>
                <c:pt idx="1662">
                  <c:v>0.40300000000000002</c:v>
                </c:pt>
                <c:pt idx="1663">
                  <c:v>0.40200000000000002</c:v>
                </c:pt>
                <c:pt idx="1664">
                  <c:v>0.40200000000000002</c:v>
                </c:pt>
                <c:pt idx="1665">
                  <c:v>0.40200000000000002</c:v>
                </c:pt>
                <c:pt idx="1666">
                  <c:v>0.40200000000000002</c:v>
                </c:pt>
                <c:pt idx="1667">
                  <c:v>0.40200000000000002</c:v>
                </c:pt>
                <c:pt idx="1668">
                  <c:v>0.4</c:v>
                </c:pt>
                <c:pt idx="1669">
                  <c:v>0.40200000000000002</c:v>
                </c:pt>
                <c:pt idx="1670">
                  <c:v>0.4</c:v>
                </c:pt>
                <c:pt idx="1671">
                  <c:v>0.4</c:v>
                </c:pt>
                <c:pt idx="1672">
                  <c:v>0.40200000000000002</c:v>
                </c:pt>
                <c:pt idx="1673">
                  <c:v>0.4</c:v>
                </c:pt>
                <c:pt idx="1674">
                  <c:v>0.40200000000000002</c:v>
                </c:pt>
                <c:pt idx="1675">
                  <c:v>0.40300000000000002</c:v>
                </c:pt>
                <c:pt idx="1676">
                  <c:v>0.40400000000000003</c:v>
                </c:pt>
                <c:pt idx="1677">
                  <c:v>0.40400000000000003</c:v>
                </c:pt>
                <c:pt idx="1678">
                  <c:v>0.40400000000000003</c:v>
                </c:pt>
                <c:pt idx="1679">
                  <c:v>0.40400000000000003</c:v>
                </c:pt>
                <c:pt idx="1680">
                  <c:v>0.40300000000000002</c:v>
                </c:pt>
                <c:pt idx="1681">
                  <c:v>0.40300000000000002</c:v>
                </c:pt>
                <c:pt idx="1682">
                  <c:v>0.40200000000000002</c:v>
                </c:pt>
                <c:pt idx="1683">
                  <c:v>0.40200000000000002</c:v>
                </c:pt>
                <c:pt idx="1684">
                  <c:v>0.40200000000000002</c:v>
                </c:pt>
                <c:pt idx="1685">
                  <c:v>0.40200000000000002</c:v>
                </c:pt>
                <c:pt idx="1686">
                  <c:v>0.40200000000000002</c:v>
                </c:pt>
                <c:pt idx="1687">
                  <c:v>0.40200000000000002</c:v>
                </c:pt>
                <c:pt idx="1688">
                  <c:v>0.40200000000000002</c:v>
                </c:pt>
                <c:pt idx="1689">
                  <c:v>0.40200000000000002</c:v>
                </c:pt>
                <c:pt idx="1690">
                  <c:v>0.40200000000000002</c:v>
                </c:pt>
                <c:pt idx="1691">
                  <c:v>0.4</c:v>
                </c:pt>
                <c:pt idx="1692">
                  <c:v>0.4</c:v>
                </c:pt>
                <c:pt idx="1693">
                  <c:v>0.4</c:v>
                </c:pt>
                <c:pt idx="1694">
                  <c:v>0.39900000000000002</c:v>
                </c:pt>
                <c:pt idx="1695">
                  <c:v>0.39900000000000002</c:v>
                </c:pt>
                <c:pt idx="1696">
                  <c:v>0.39900000000000002</c:v>
                </c:pt>
                <c:pt idx="1697">
                  <c:v>0.4</c:v>
                </c:pt>
                <c:pt idx="1698">
                  <c:v>0.4</c:v>
                </c:pt>
                <c:pt idx="1699">
                  <c:v>0.40200000000000002</c:v>
                </c:pt>
                <c:pt idx="1700">
                  <c:v>0.40300000000000002</c:v>
                </c:pt>
                <c:pt idx="1701">
                  <c:v>0.40400000000000003</c:v>
                </c:pt>
                <c:pt idx="1702">
                  <c:v>0.40400000000000003</c:v>
                </c:pt>
                <c:pt idx="1703">
                  <c:v>0.40400000000000003</c:v>
                </c:pt>
                <c:pt idx="1704">
                  <c:v>0.40300000000000002</c:v>
                </c:pt>
                <c:pt idx="1705">
                  <c:v>0.40200000000000002</c:v>
                </c:pt>
                <c:pt idx="1706">
                  <c:v>0.40200000000000002</c:v>
                </c:pt>
                <c:pt idx="1707">
                  <c:v>0.4</c:v>
                </c:pt>
                <c:pt idx="1708">
                  <c:v>0.4</c:v>
                </c:pt>
                <c:pt idx="1709">
                  <c:v>0.4</c:v>
                </c:pt>
                <c:pt idx="1710">
                  <c:v>0.4</c:v>
                </c:pt>
                <c:pt idx="1711">
                  <c:v>0.39900000000000002</c:v>
                </c:pt>
                <c:pt idx="1712">
                  <c:v>0.39900000000000002</c:v>
                </c:pt>
                <c:pt idx="1713">
                  <c:v>0.39900000000000002</c:v>
                </c:pt>
                <c:pt idx="1714">
                  <c:v>0.39900000000000002</c:v>
                </c:pt>
                <c:pt idx="1715">
                  <c:v>0.4</c:v>
                </c:pt>
                <c:pt idx="1716">
                  <c:v>0.39900000000000002</c:v>
                </c:pt>
                <c:pt idx="1717">
                  <c:v>0.39900000000000002</c:v>
                </c:pt>
                <c:pt idx="1718">
                  <c:v>0.39900000000000002</c:v>
                </c:pt>
                <c:pt idx="1719">
                  <c:v>0.4</c:v>
                </c:pt>
                <c:pt idx="1720">
                  <c:v>0.40200000000000002</c:v>
                </c:pt>
                <c:pt idx="1721">
                  <c:v>0.40300000000000002</c:v>
                </c:pt>
                <c:pt idx="1722">
                  <c:v>0.40300000000000002</c:v>
                </c:pt>
                <c:pt idx="1723">
                  <c:v>0.40400000000000003</c:v>
                </c:pt>
                <c:pt idx="1724">
                  <c:v>0.40300000000000002</c:v>
                </c:pt>
                <c:pt idx="1725">
                  <c:v>0.40200000000000002</c:v>
                </c:pt>
                <c:pt idx="1726">
                  <c:v>0.4</c:v>
                </c:pt>
                <c:pt idx="1727">
                  <c:v>0.4</c:v>
                </c:pt>
                <c:pt idx="1728">
                  <c:v>0.4</c:v>
                </c:pt>
                <c:pt idx="1729">
                  <c:v>0.39900000000000002</c:v>
                </c:pt>
                <c:pt idx="1730">
                  <c:v>0.39900000000000002</c:v>
                </c:pt>
                <c:pt idx="1731">
                  <c:v>0.39900000000000002</c:v>
                </c:pt>
                <c:pt idx="1732">
                  <c:v>0.39900000000000002</c:v>
                </c:pt>
                <c:pt idx="1733">
                  <c:v>0.399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7B9-41DC-99AD-7E807C8A9F89}"/>
            </c:ext>
          </c:extLst>
        </c:ser>
        <c:ser>
          <c:idx val="1"/>
          <c:order val="1"/>
          <c:tx>
            <c:strRef>
              <c:f>Sheet1!$D$1</c:f>
              <c:strCache>
                <c:ptCount val="1"/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1!$C$2:$C$1739</c:f>
              <c:numCache>
                <c:formatCode>General</c:formatCode>
                <c:ptCount val="1738"/>
                <c:pt idx="0">
                  <c:v>0</c:v>
                </c:pt>
                <c:pt idx="1">
                  <c:v>0.60799999999999998</c:v>
                </c:pt>
                <c:pt idx="2">
                  <c:v>1.2170000000000001</c:v>
                </c:pt>
                <c:pt idx="3">
                  <c:v>1.825</c:v>
                </c:pt>
                <c:pt idx="4">
                  <c:v>2.4329999999999981</c:v>
                </c:pt>
                <c:pt idx="5">
                  <c:v>3.0419999999999998</c:v>
                </c:pt>
                <c:pt idx="6">
                  <c:v>3.65</c:v>
                </c:pt>
                <c:pt idx="7">
                  <c:v>4.258</c:v>
                </c:pt>
                <c:pt idx="8">
                  <c:v>4.8669999999999982</c:v>
                </c:pt>
                <c:pt idx="9">
                  <c:v>5.4749999999999996</c:v>
                </c:pt>
                <c:pt idx="10">
                  <c:v>6.0830000000000002</c:v>
                </c:pt>
                <c:pt idx="11">
                  <c:v>6.6919999999999984</c:v>
                </c:pt>
                <c:pt idx="12">
                  <c:v>7.3</c:v>
                </c:pt>
                <c:pt idx="13">
                  <c:v>7.9080000000000004</c:v>
                </c:pt>
                <c:pt idx="14">
                  <c:v>8.5170000000000012</c:v>
                </c:pt>
                <c:pt idx="15">
                  <c:v>9.125</c:v>
                </c:pt>
                <c:pt idx="16">
                  <c:v>9.7330000000000005</c:v>
                </c:pt>
                <c:pt idx="17">
                  <c:v>10.342000000000001</c:v>
                </c:pt>
                <c:pt idx="18">
                  <c:v>10.95</c:v>
                </c:pt>
                <c:pt idx="19">
                  <c:v>11.558</c:v>
                </c:pt>
                <c:pt idx="20">
                  <c:v>12.167</c:v>
                </c:pt>
                <c:pt idx="21">
                  <c:v>12.775</c:v>
                </c:pt>
                <c:pt idx="22">
                  <c:v>13.382999999999999</c:v>
                </c:pt>
                <c:pt idx="23">
                  <c:v>13.992000000000001</c:v>
                </c:pt>
                <c:pt idx="24">
                  <c:v>14.6</c:v>
                </c:pt>
                <c:pt idx="25">
                  <c:v>15.208</c:v>
                </c:pt>
                <c:pt idx="26">
                  <c:v>15.817</c:v>
                </c:pt>
                <c:pt idx="27">
                  <c:v>16.425000000000001</c:v>
                </c:pt>
                <c:pt idx="28">
                  <c:v>17.033000000000001</c:v>
                </c:pt>
                <c:pt idx="29">
                  <c:v>17.641999999999999</c:v>
                </c:pt>
                <c:pt idx="30">
                  <c:v>18.25</c:v>
                </c:pt>
                <c:pt idx="31">
                  <c:v>18.858000000000001</c:v>
                </c:pt>
                <c:pt idx="32">
                  <c:v>19.466999999999999</c:v>
                </c:pt>
                <c:pt idx="33">
                  <c:v>20.074999999999999</c:v>
                </c:pt>
                <c:pt idx="34">
                  <c:v>20.683</c:v>
                </c:pt>
                <c:pt idx="35">
                  <c:v>21.292000000000002</c:v>
                </c:pt>
                <c:pt idx="36">
                  <c:v>21.9</c:v>
                </c:pt>
                <c:pt idx="37">
                  <c:v>22.507999999999999</c:v>
                </c:pt>
                <c:pt idx="38">
                  <c:v>23.117000000000001</c:v>
                </c:pt>
                <c:pt idx="39">
                  <c:v>23.725000000000001</c:v>
                </c:pt>
                <c:pt idx="40">
                  <c:v>24.332999999999991</c:v>
                </c:pt>
                <c:pt idx="41">
                  <c:v>24.942</c:v>
                </c:pt>
                <c:pt idx="42">
                  <c:v>25.55</c:v>
                </c:pt>
                <c:pt idx="43">
                  <c:v>26.158000000000001</c:v>
                </c:pt>
                <c:pt idx="44">
                  <c:v>26.766999999999999</c:v>
                </c:pt>
                <c:pt idx="45">
                  <c:v>27.375</c:v>
                </c:pt>
                <c:pt idx="46">
                  <c:v>27.983000000000001</c:v>
                </c:pt>
                <c:pt idx="47">
                  <c:v>28.591999999999999</c:v>
                </c:pt>
                <c:pt idx="48">
                  <c:v>29.2</c:v>
                </c:pt>
                <c:pt idx="49">
                  <c:v>29.808</c:v>
                </c:pt>
                <c:pt idx="50">
                  <c:v>30.417000000000009</c:v>
                </c:pt>
                <c:pt idx="51">
                  <c:v>31.024999999999999</c:v>
                </c:pt>
                <c:pt idx="52">
                  <c:v>31.632999999999999</c:v>
                </c:pt>
                <c:pt idx="53">
                  <c:v>32.241999999999997</c:v>
                </c:pt>
                <c:pt idx="54">
                  <c:v>32.85</c:v>
                </c:pt>
                <c:pt idx="55">
                  <c:v>33.457999999999998</c:v>
                </c:pt>
                <c:pt idx="56">
                  <c:v>34.067</c:v>
                </c:pt>
                <c:pt idx="57">
                  <c:v>34.674999999999997</c:v>
                </c:pt>
                <c:pt idx="58">
                  <c:v>35.283000000000001</c:v>
                </c:pt>
                <c:pt idx="59">
                  <c:v>35.892000000000003</c:v>
                </c:pt>
                <c:pt idx="60">
                  <c:v>36.5</c:v>
                </c:pt>
                <c:pt idx="61">
                  <c:v>37.107999999999997</c:v>
                </c:pt>
                <c:pt idx="62">
                  <c:v>37.717000000000013</c:v>
                </c:pt>
                <c:pt idx="63">
                  <c:v>38.325000000000003</c:v>
                </c:pt>
                <c:pt idx="64">
                  <c:v>38.933</c:v>
                </c:pt>
                <c:pt idx="65">
                  <c:v>39.542000000000002</c:v>
                </c:pt>
                <c:pt idx="66">
                  <c:v>40.15</c:v>
                </c:pt>
                <c:pt idx="67">
                  <c:v>40.758000000000003</c:v>
                </c:pt>
                <c:pt idx="68">
                  <c:v>41.366999999999997</c:v>
                </c:pt>
                <c:pt idx="69">
                  <c:v>41.975000000000001</c:v>
                </c:pt>
                <c:pt idx="70">
                  <c:v>42.583000000000013</c:v>
                </c:pt>
                <c:pt idx="71">
                  <c:v>43.192</c:v>
                </c:pt>
                <c:pt idx="72">
                  <c:v>43.8</c:v>
                </c:pt>
                <c:pt idx="73">
                  <c:v>44.408000000000001</c:v>
                </c:pt>
                <c:pt idx="74">
                  <c:v>45.017000000000003</c:v>
                </c:pt>
                <c:pt idx="75">
                  <c:v>45.625</c:v>
                </c:pt>
                <c:pt idx="76">
                  <c:v>46.233000000000011</c:v>
                </c:pt>
                <c:pt idx="77">
                  <c:v>46.841999999999999</c:v>
                </c:pt>
                <c:pt idx="78">
                  <c:v>47.45</c:v>
                </c:pt>
                <c:pt idx="79">
                  <c:v>48.058</c:v>
                </c:pt>
                <c:pt idx="80">
                  <c:v>48.667000000000002</c:v>
                </c:pt>
                <c:pt idx="81">
                  <c:v>49.274999999999999</c:v>
                </c:pt>
                <c:pt idx="82">
                  <c:v>49.883000000000003</c:v>
                </c:pt>
                <c:pt idx="83">
                  <c:v>50.491999999999997</c:v>
                </c:pt>
                <c:pt idx="84">
                  <c:v>51.1</c:v>
                </c:pt>
                <c:pt idx="85">
                  <c:v>51.707999999999998</c:v>
                </c:pt>
                <c:pt idx="86">
                  <c:v>52.317</c:v>
                </c:pt>
                <c:pt idx="87">
                  <c:v>52.924999999999997</c:v>
                </c:pt>
                <c:pt idx="88">
                  <c:v>53.533000000000001</c:v>
                </c:pt>
                <c:pt idx="89">
                  <c:v>54.142000000000003</c:v>
                </c:pt>
                <c:pt idx="90">
                  <c:v>54.75</c:v>
                </c:pt>
                <c:pt idx="91">
                  <c:v>55.357999999999997</c:v>
                </c:pt>
                <c:pt idx="92">
                  <c:v>55.967000000000013</c:v>
                </c:pt>
                <c:pt idx="93">
                  <c:v>56.575000000000003</c:v>
                </c:pt>
                <c:pt idx="94">
                  <c:v>57.183</c:v>
                </c:pt>
                <c:pt idx="95">
                  <c:v>57.792000000000002</c:v>
                </c:pt>
                <c:pt idx="96">
                  <c:v>58.4</c:v>
                </c:pt>
                <c:pt idx="97">
                  <c:v>59.008000000000003</c:v>
                </c:pt>
                <c:pt idx="98">
                  <c:v>59.616999999999997</c:v>
                </c:pt>
                <c:pt idx="99">
                  <c:v>60.225000000000001</c:v>
                </c:pt>
                <c:pt idx="100">
                  <c:v>60.833000000000013</c:v>
                </c:pt>
                <c:pt idx="101">
                  <c:v>61.442</c:v>
                </c:pt>
                <c:pt idx="102">
                  <c:v>62.05</c:v>
                </c:pt>
                <c:pt idx="103">
                  <c:v>62.658000000000001</c:v>
                </c:pt>
                <c:pt idx="104">
                  <c:v>63.267000000000003</c:v>
                </c:pt>
                <c:pt idx="105">
                  <c:v>63.875</c:v>
                </c:pt>
                <c:pt idx="106">
                  <c:v>64.483000000000004</c:v>
                </c:pt>
                <c:pt idx="107">
                  <c:v>65.092000000000013</c:v>
                </c:pt>
                <c:pt idx="108">
                  <c:v>65.7</c:v>
                </c:pt>
                <c:pt idx="109">
                  <c:v>66.308000000000007</c:v>
                </c:pt>
                <c:pt idx="110">
                  <c:v>66.917000000000002</c:v>
                </c:pt>
                <c:pt idx="111">
                  <c:v>67.525000000000006</c:v>
                </c:pt>
                <c:pt idx="112">
                  <c:v>68.132999999999981</c:v>
                </c:pt>
                <c:pt idx="113">
                  <c:v>68.742000000000004</c:v>
                </c:pt>
                <c:pt idx="114">
                  <c:v>69.349999999999994</c:v>
                </c:pt>
                <c:pt idx="115">
                  <c:v>69.958000000000013</c:v>
                </c:pt>
                <c:pt idx="116">
                  <c:v>70.566999999999993</c:v>
                </c:pt>
                <c:pt idx="117">
                  <c:v>71.174999999999983</c:v>
                </c:pt>
                <c:pt idx="118">
                  <c:v>71.783000000000001</c:v>
                </c:pt>
                <c:pt idx="119">
                  <c:v>72.391999999999996</c:v>
                </c:pt>
                <c:pt idx="120">
                  <c:v>73</c:v>
                </c:pt>
                <c:pt idx="121">
                  <c:v>73.607999999999976</c:v>
                </c:pt>
                <c:pt idx="122">
                  <c:v>74.216999999999999</c:v>
                </c:pt>
                <c:pt idx="123">
                  <c:v>74.824999999999974</c:v>
                </c:pt>
                <c:pt idx="124">
                  <c:v>75.433000000000007</c:v>
                </c:pt>
                <c:pt idx="125">
                  <c:v>76.042000000000002</c:v>
                </c:pt>
                <c:pt idx="126">
                  <c:v>76.650000000000006</c:v>
                </c:pt>
                <c:pt idx="127">
                  <c:v>77.257999999999996</c:v>
                </c:pt>
                <c:pt idx="128">
                  <c:v>77.867000000000004</c:v>
                </c:pt>
                <c:pt idx="129">
                  <c:v>78.474999999999994</c:v>
                </c:pt>
                <c:pt idx="130">
                  <c:v>79.082999999999998</c:v>
                </c:pt>
                <c:pt idx="131">
                  <c:v>79.691999999999993</c:v>
                </c:pt>
                <c:pt idx="132">
                  <c:v>80.3</c:v>
                </c:pt>
                <c:pt idx="133">
                  <c:v>80.908000000000001</c:v>
                </c:pt>
                <c:pt idx="134">
                  <c:v>81.516999999999996</c:v>
                </c:pt>
                <c:pt idx="135">
                  <c:v>82.124999999999986</c:v>
                </c:pt>
                <c:pt idx="136">
                  <c:v>82.733000000000004</c:v>
                </c:pt>
                <c:pt idx="137">
                  <c:v>83.342000000000013</c:v>
                </c:pt>
                <c:pt idx="138">
                  <c:v>83.95</c:v>
                </c:pt>
                <c:pt idx="139">
                  <c:v>84.558000000000007</c:v>
                </c:pt>
                <c:pt idx="140">
                  <c:v>85.167000000000002</c:v>
                </c:pt>
                <c:pt idx="141">
                  <c:v>85.775000000000006</c:v>
                </c:pt>
                <c:pt idx="142">
                  <c:v>86.382999999999981</c:v>
                </c:pt>
                <c:pt idx="143">
                  <c:v>86.992000000000004</c:v>
                </c:pt>
                <c:pt idx="144">
                  <c:v>87.6</c:v>
                </c:pt>
                <c:pt idx="145">
                  <c:v>88.208000000000013</c:v>
                </c:pt>
                <c:pt idx="146">
                  <c:v>88.816999999999993</c:v>
                </c:pt>
                <c:pt idx="147">
                  <c:v>89.424999999999997</c:v>
                </c:pt>
                <c:pt idx="148">
                  <c:v>90.033000000000001</c:v>
                </c:pt>
                <c:pt idx="149">
                  <c:v>90.641999999999996</c:v>
                </c:pt>
                <c:pt idx="150">
                  <c:v>91.25</c:v>
                </c:pt>
                <c:pt idx="151">
                  <c:v>91.857999999999976</c:v>
                </c:pt>
                <c:pt idx="152">
                  <c:v>92.466999999999999</c:v>
                </c:pt>
                <c:pt idx="153">
                  <c:v>93.074999999999974</c:v>
                </c:pt>
                <c:pt idx="154">
                  <c:v>93.682999999999979</c:v>
                </c:pt>
                <c:pt idx="155">
                  <c:v>94.292000000000002</c:v>
                </c:pt>
                <c:pt idx="156">
                  <c:v>94.9</c:v>
                </c:pt>
                <c:pt idx="157">
                  <c:v>95.507999999999996</c:v>
                </c:pt>
                <c:pt idx="158">
                  <c:v>96.117000000000004</c:v>
                </c:pt>
                <c:pt idx="159">
                  <c:v>96.724999999999994</c:v>
                </c:pt>
                <c:pt idx="160">
                  <c:v>97.332999999999998</c:v>
                </c:pt>
                <c:pt idx="161">
                  <c:v>97.941999999999993</c:v>
                </c:pt>
                <c:pt idx="162">
                  <c:v>98.55</c:v>
                </c:pt>
                <c:pt idx="163">
                  <c:v>99.157999999999987</c:v>
                </c:pt>
                <c:pt idx="164">
                  <c:v>99.766999999999996</c:v>
                </c:pt>
                <c:pt idx="165">
                  <c:v>100.375</c:v>
                </c:pt>
                <c:pt idx="166">
                  <c:v>100.983</c:v>
                </c:pt>
                <c:pt idx="167">
                  <c:v>101.592</c:v>
                </c:pt>
                <c:pt idx="168">
                  <c:v>102.2</c:v>
                </c:pt>
                <c:pt idx="169">
                  <c:v>102.80800000000001</c:v>
                </c:pt>
                <c:pt idx="170">
                  <c:v>103.417</c:v>
                </c:pt>
                <c:pt idx="171">
                  <c:v>104.02500000000001</c:v>
                </c:pt>
                <c:pt idx="172">
                  <c:v>104.633</c:v>
                </c:pt>
                <c:pt idx="173">
                  <c:v>105.242</c:v>
                </c:pt>
                <c:pt idx="174">
                  <c:v>105.85</c:v>
                </c:pt>
                <c:pt idx="175">
                  <c:v>106.458</c:v>
                </c:pt>
                <c:pt idx="176">
                  <c:v>107.06699999999999</c:v>
                </c:pt>
                <c:pt idx="177">
                  <c:v>107.675</c:v>
                </c:pt>
                <c:pt idx="178">
                  <c:v>108.283</c:v>
                </c:pt>
                <c:pt idx="179">
                  <c:v>108.892</c:v>
                </c:pt>
                <c:pt idx="180">
                  <c:v>109.5</c:v>
                </c:pt>
                <c:pt idx="181">
                  <c:v>110.108</c:v>
                </c:pt>
                <c:pt idx="182">
                  <c:v>110.717</c:v>
                </c:pt>
                <c:pt idx="183">
                  <c:v>111.325</c:v>
                </c:pt>
                <c:pt idx="184">
                  <c:v>111.93300000000001</c:v>
                </c:pt>
                <c:pt idx="185">
                  <c:v>112.542</c:v>
                </c:pt>
                <c:pt idx="186">
                  <c:v>113.15</c:v>
                </c:pt>
                <c:pt idx="187">
                  <c:v>113.758</c:v>
                </c:pt>
                <c:pt idx="188">
                  <c:v>114.367</c:v>
                </c:pt>
                <c:pt idx="189">
                  <c:v>114.97499999999999</c:v>
                </c:pt>
                <c:pt idx="190">
                  <c:v>115.583</c:v>
                </c:pt>
                <c:pt idx="191">
                  <c:v>116.19199999999999</c:v>
                </c:pt>
                <c:pt idx="192">
                  <c:v>116.8</c:v>
                </c:pt>
                <c:pt idx="193">
                  <c:v>117.408</c:v>
                </c:pt>
                <c:pt idx="194">
                  <c:v>118.017</c:v>
                </c:pt>
                <c:pt idx="195">
                  <c:v>118.625</c:v>
                </c:pt>
                <c:pt idx="196">
                  <c:v>119.233</c:v>
                </c:pt>
                <c:pt idx="197">
                  <c:v>119.842</c:v>
                </c:pt>
                <c:pt idx="198">
                  <c:v>120.45</c:v>
                </c:pt>
                <c:pt idx="199">
                  <c:v>121.05800000000001</c:v>
                </c:pt>
                <c:pt idx="200">
                  <c:v>121.667</c:v>
                </c:pt>
                <c:pt idx="201">
                  <c:v>122.27500000000001</c:v>
                </c:pt>
                <c:pt idx="202">
                  <c:v>122.883</c:v>
                </c:pt>
                <c:pt idx="203">
                  <c:v>123.492</c:v>
                </c:pt>
                <c:pt idx="204">
                  <c:v>124.1</c:v>
                </c:pt>
                <c:pt idx="205">
                  <c:v>124.708</c:v>
                </c:pt>
                <c:pt idx="206">
                  <c:v>125.31699999999999</c:v>
                </c:pt>
                <c:pt idx="207">
                  <c:v>125.925</c:v>
                </c:pt>
                <c:pt idx="208">
                  <c:v>126.533</c:v>
                </c:pt>
                <c:pt idx="209">
                  <c:v>127.142</c:v>
                </c:pt>
                <c:pt idx="210">
                  <c:v>127.75</c:v>
                </c:pt>
                <c:pt idx="211">
                  <c:v>128.358</c:v>
                </c:pt>
                <c:pt idx="212">
                  <c:v>128.96700000000001</c:v>
                </c:pt>
                <c:pt idx="213">
                  <c:v>129.57499999999999</c:v>
                </c:pt>
                <c:pt idx="214">
                  <c:v>130.18299999999999</c:v>
                </c:pt>
                <c:pt idx="215">
                  <c:v>130.792</c:v>
                </c:pt>
                <c:pt idx="216">
                  <c:v>131.4</c:v>
                </c:pt>
                <c:pt idx="217">
                  <c:v>132.00800000000001</c:v>
                </c:pt>
                <c:pt idx="218">
                  <c:v>132.61699999999999</c:v>
                </c:pt>
                <c:pt idx="219">
                  <c:v>133.22499999999999</c:v>
                </c:pt>
                <c:pt idx="220">
                  <c:v>133.833</c:v>
                </c:pt>
                <c:pt idx="221">
                  <c:v>134.44200000000001</c:v>
                </c:pt>
                <c:pt idx="222">
                  <c:v>135.05000000000001</c:v>
                </c:pt>
                <c:pt idx="223">
                  <c:v>135.65799999999999</c:v>
                </c:pt>
                <c:pt idx="224">
                  <c:v>136.267</c:v>
                </c:pt>
                <c:pt idx="225">
                  <c:v>136.875</c:v>
                </c:pt>
                <c:pt idx="226">
                  <c:v>137.483</c:v>
                </c:pt>
                <c:pt idx="227">
                  <c:v>138.09200000000001</c:v>
                </c:pt>
                <c:pt idx="228">
                  <c:v>138.69999999999999</c:v>
                </c:pt>
                <c:pt idx="229">
                  <c:v>139.30799999999999</c:v>
                </c:pt>
                <c:pt idx="230">
                  <c:v>139.917</c:v>
                </c:pt>
                <c:pt idx="231">
                  <c:v>140.52500000000001</c:v>
                </c:pt>
                <c:pt idx="232">
                  <c:v>141.13300000000001</c:v>
                </c:pt>
                <c:pt idx="233">
                  <c:v>141.74199999999999</c:v>
                </c:pt>
                <c:pt idx="234">
                  <c:v>142.35</c:v>
                </c:pt>
                <c:pt idx="235">
                  <c:v>142.958</c:v>
                </c:pt>
                <c:pt idx="236">
                  <c:v>143.56700000000001</c:v>
                </c:pt>
                <c:pt idx="237">
                  <c:v>144.17500000000001</c:v>
                </c:pt>
                <c:pt idx="238">
                  <c:v>144.78299999999999</c:v>
                </c:pt>
                <c:pt idx="239">
                  <c:v>145.392</c:v>
                </c:pt>
                <c:pt idx="240">
                  <c:v>146</c:v>
                </c:pt>
                <c:pt idx="241">
                  <c:v>146.608</c:v>
                </c:pt>
                <c:pt idx="242">
                  <c:v>147.21700000000001</c:v>
                </c:pt>
                <c:pt idx="243">
                  <c:v>147.82499999999999</c:v>
                </c:pt>
                <c:pt idx="244">
                  <c:v>148.43299999999999</c:v>
                </c:pt>
                <c:pt idx="245">
                  <c:v>149.042</c:v>
                </c:pt>
                <c:pt idx="246">
                  <c:v>149.65</c:v>
                </c:pt>
                <c:pt idx="247">
                  <c:v>150.25800000000001</c:v>
                </c:pt>
                <c:pt idx="248">
                  <c:v>150.86699999999999</c:v>
                </c:pt>
                <c:pt idx="249">
                  <c:v>151.47499999999999</c:v>
                </c:pt>
                <c:pt idx="250">
                  <c:v>152.083</c:v>
                </c:pt>
                <c:pt idx="251">
                  <c:v>152.69200000000001</c:v>
                </c:pt>
                <c:pt idx="252">
                  <c:v>153.30000000000001</c:v>
                </c:pt>
                <c:pt idx="253">
                  <c:v>153.90799999999999</c:v>
                </c:pt>
                <c:pt idx="254">
                  <c:v>154.517</c:v>
                </c:pt>
                <c:pt idx="255">
                  <c:v>155.125</c:v>
                </c:pt>
                <c:pt idx="256">
                  <c:v>155.733</c:v>
                </c:pt>
                <c:pt idx="257">
                  <c:v>156.34200000000001</c:v>
                </c:pt>
                <c:pt idx="258">
                  <c:v>156.94999999999999</c:v>
                </c:pt>
                <c:pt idx="259">
                  <c:v>157.55799999999999</c:v>
                </c:pt>
                <c:pt idx="260">
                  <c:v>158.167</c:v>
                </c:pt>
                <c:pt idx="261">
                  <c:v>158.77500000000001</c:v>
                </c:pt>
                <c:pt idx="262">
                  <c:v>159.38300000000001</c:v>
                </c:pt>
                <c:pt idx="263">
                  <c:v>159.99199999999999</c:v>
                </c:pt>
                <c:pt idx="264">
                  <c:v>160.6</c:v>
                </c:pt>
                <c:pt idx="265">
                  <c:v>161.208</c:v>
                </c:pt>
                <c:pt idx="266">
                  <c:v>161.81700000000001</c:v>
                </c:pt>
                <c:pt idx="267">
                  <c:v>162.42500000000001</c:v>
                </c:pt>
                <c:pt idx="268">
                  <c:v>163.03299999999999</c:v>
                </c:pt>
                <c:pt idx="269">
                  <c:v>163.642</c:v>
                </c:pt>
                <c:pt idx="270">
                  <c:v>164.25</c:v>
                </c:pt>
                <c:pt idx="271">
                  <c:v>164.858</c:v>
                </c:pt>
                <c:pt idx="272">
                  <c:v>165.46700000000001</c:v>
                </c:pt>
                <c:pt idx="273">
                  <c:v>166.07499999999999</c:v>
                </c:pt>
                <c:pt idx="274">
                  <c:v>166.68299999999999</c:v>
                </c:pt>
                <c:pt idx="275">
                  <c:v>167.292</c:v>
                </c:pt>
                <c:pt idx="276">
                  <c:v>167.9</c:v>
                </c:pt>
                <c:pt idx="277">
                  <c:v>168.50800000000001</c:v>
                </c:pt>
                <c:pt idx="278">
                  <c:v>169.11699999999999</c:v>
                </c:pt>
                <c:pt idx="279">
                  <c:v>169.72499999999999</c:v>
                </c:pt>
                <c:pt idx="280">
                  <c:v>170.333</c:v>
                </c:pt>
                <c:pt idx="281">
                  <c:v>170.94200000000001</c:v>
                </c:pt>
                <c:pt idx="282">
                  <c:v>171.55</c:v>
                </c:pt>
                <c:pt idx="283">
                  <c:v>172.15799999999999</c:v>
                </c:pt>
                <c:pt idx="284">
                  <c:v>172.767</c:v>
                </c:pt>
                <c:pt idx="285">
                  <c:v>173.375</c:v>
                </c:pt>
                <c:pt idx="286">
                  <c:v>173.983</c:v>
                </c:pt>
                <c:pt idx="287">
                  <c:v>174.59200000000001</c:v>
                </c:pt>
                <c:pt idx="288">
                  <c:v>175.2</c:v>
                </c:pt>
                <c:pt idx="289">
                  <c:v>175.80799999999999</c:v>
                </c:pt>
                <c:pt idx="290">
                  <c:v>176.417</c:v>
                </c:pt>
                <c:pt idx="291">
                  <c:v>177.02500000000001</c:v>
                </c:pt>
                <c:pt idx="292">
                  <c:v>177.63300000000001</c:v>
                </c:pt>
                <c:pt idx="293">
                  <c:v>178.24199999999999</c:v>
                </c:pt>
                <c:pt idx="294">
                  <c:v>178.85</c:v>
                </c:pt>
                <c:pt idx="295">
                  <c:v>179.458</c:v>
                </c:pt>
                <c:pt idx="296">
                  <c:v>180.06700000000001</c:v>
                </c:pt>
                <c:pt idx="297">
                  <c:v>180.67500000000001</c:v>
                </c:pt>
                <c:pt idx="298">
                  <c:v>181.28299999999999</c:v>
                </c:pt>
                <c:pt idx="299">
                  <c:v>181.892</c:v>
                </c:pt>
                <c:pt idx="300">
                  <c:v>182.5</c:v>
                </c:pt>
                <c:pt idx="301">
                  <c:v>183.108</c:v>
                </c:pt>
                <c:pt idx="302">
                  <c:v>183.71700000000001</c:v>
                </c:pt>
                <c:pt idx="303">
                  <c:v>184.32499999999999</c:v>
                </c:pt>
                <c:pt idx="304">
                  <c:v>184.93299999999999</c:v>
                </c:pt>
                <c:pt idx="305">
                  <c:v>185.542</c:v>
                </c:pt>
                <c:pt idx="306">
                  <c:v>186.15</c:v>
                </c:pt>
                <c:pt idx="307">
                  <c:v>186.75800000000001</c:v>
                </c:pt>
                <c:pt idx="308">
                  <c:v>187.36699999999999</c:v>
                </c:pt>
                <c:pt idx="309">
                  <c:v>187.97499999999999</c:v>
                </c:pt>
                <c:pt idx="310">
                  <c:v>188.583</c:v>
                </c:pt>
                <c:pt idx="311">
                  <c:v>189.19200000000001</c:v>
                </c:pt>
                <c:pt idx="312">
                  <c:v>189.8</c:v>
                </c:pt>
                <c:pt idx="313">
                  <c:v>190.40799999999999</c:v>
                </c:pt>
                <c:pt idx="314">
                  <c:v>191.017</c:v>
                </c:pt>
                <c:pt idx="315">
                  <c:v>191.625</c:v>
                </c:pt>
                <c:pt idx="316">
                  <c:v>192.233</c:v>
                </c:pt>
                <c:pt idx="317">
                  <c:v>192.84200000000001</c:v>
                </c:pt>
                <c:pt idx="318">
                  <c:v>193.45</c:v>
                </c:pt>
                <c:pt idx="319">
                  <c:v>194.05799999999999</c:v>
                </c:pt>
                <c:pt idx="320">
                  <c:v>194.667</c:v>
                </c:pt>
                <c:pt idx="321">
                  <c:v>195.27500000000001</c:v>
                </c:pt>
                <c:pt idx="322">
                  <c:v>195.88300000000001</c:v>
                </c:pt>
                <c:pt idx="323">
                  <c:v>196.49199999999999</c:v>
                </c:pt>
                <c:pt idx="324">
                  <c:v>197.1</c:v>
                </c:pt>
                <c:pt idx="325">
                  <c:v>197.708</c:v>
                </c:pt>
                <c:pt idx="326">
                  <c:v>198.31700000000001</c:v>
                </c:pt>
                <c:pt idx="327">
                  <c:v>198.92500000000001</c:v>
                </c:pt>
                <c:pt idx="328">
                  <c:v>199.53299999999999</c:v>
                </c:pt>
                <c:pt idx="329">
                  <c:v>200.142</c:v>
                </c:pt>
                <c:pt idx="330">
                  <c:v>200.75</c:v>
                </c:pt>
                <c:pt idx="331">
                  <c:v>201.358</c:v>
                </c:pt>
                <c:pt idx="332">
                  <c:v>201.96700000000001</c:v>
                </c:pt>
                <c:pt idx="333">
                  <c:v>202.57499999999999</c:v>
                </c:pt>
                <c:pt idx="334">
                  <c:v>203.18299999999999</c:v>
                </c:pt>
                <c:pt idx="335">
                  <c:v>203.792</c:v>
                </c:pt>
                <c:pt idx="336">
                  <c:v>204.4</c:v>
                </c:pt>
                <c:pt idx="337">
                  <c:v>205.00800000000001</c:v>
                </c:pt>
                <c:pt idx="338">
                  <c:v>205.61699999999999</c:v>
                </c:pt>
                <c:pt idx="339">
                  <c:v>206.22499999999999</c:v>
                </c:pt>
                <c:pt idx="340">
                  <c:v>206.833</c:v>
                </c:pt>
                <c:pt idx="341">
                  <c:v>207.44200000000001</c:v>
                </c:pt>
                <c:pt idx="342">
                  <c:v>208.05</c:v>
                </c:pt>
                <c:pt idx="343">
                  <c:v>208.65799999999999</c:v>
                </c:pt>
                <c:pt idx="344">
                  <c:v>209.267</c:v>
                </c:pt>
                <c:pt idx="345">
                  <c:v>209.875</c:v>
                </c:pt>
                <c:pt idx="346">
                  <c:v>210.483</c:v>
                </c:pt>
                <c:pt idx="347">
                  <c:v>211.09200000000001</c:v>
                </c:pt>
                <c:pt idx="348">
                  <c:v>211.7</c:v>
                </c:pt>
                <c:pt idx="349">
                  <c:v>212.30799999999999</c:v>
                </c:pt>
                <c:pt idx="350">
                  <c:v>212.917</c:v>
                </c:pt>
                <c:pt idx="351">
                  <c:v>213.52500000000001</c:v>
                </c:pt>
                <c:pt idx="352">
                  <c:v>214.13300000000001</c:v>
                </c:pt>
                <c:pt idx="353">
                  <c:v>214.74199999999999</c:v>
                </c:pt>
                <c:pt idx="354">
                  <c:v>215.35</c:v>
                </c:pt>
                <c:pt idx="355">
                  <c:v>215.958</c:v>
                </c:pt>
                <c:pt idx="356">
                  <c:v>216.56700000000001</c:v>
                </c:pt>
                <c:pt idx="357">
                  <c:v>217.17500000000001</c:v>
                </c:pt>
                <c:pt idx="358">
                  <c:v>217.78299999999999</c:v>
                </c:pt>
                <c:pt idx="359">
                  <c:v>218.392</c:v>
                </c:pt>
                <c:pt idx="360">
                  <c:v>219</c:v>
                </c:pt>
                <c:pt idx="361">
                  <c:v>219.608</c:v>
                </c:pt>
                <c:pt idx="362">
                  <c:v>220.21700000000001</c:v>
                </c:pt>
                <c:pt idx="363">
                  <c:v>220.82499999999999</c:v>
                </c:pt>
                <c:pt idx="364">
                  <c:v>221.43299999999999</c:v>
                </c:pt>
                <c:pt idx="365">
                  <c:v>222.042</c:v>
                </c:pt>
                <c:pt idx="366">
                  <c:v>222.65</c:v>
                </c:pt>
                <c:pt idx="367">
                  <c:v>223.25800000000001</c:v>
                </c:pt>
                <c:pt idx="368">
                  <c:v>223.86699999999999</c:v>
                </c:pt>
                <c:pt idx="369">
                  <c:v>224.47499999999999</c:v>
                </c:pt>
                <c:pt idx="370">
                  <c:v>225.083</c:v>
                </c:pt>
                <c:pt idx="371">
                  <c:v>225.69200000000001</c:v>
                </c:pt>
                <c:pt idx="372">
                  <c:v>226.3</c:v>
                </c:pt>
                <c:pt idx="373">
                  <c:v>226.90799999999999</c:v>
                </c:pt>
                <c:pt idx="374">
                  <c:v>227.517</c:v>
                </c:pt>
                <c:pt idx="375">
                  <c:v>228.125</c:v>
                </c:pt>
                <c:pt idx="376">
                  <c:v>228.733</c:v>
                </c:pt>
                <c:pt idx="377">
                  <c:v>229.34200000000001</c:v>
                </c:pt>
                <c:pt idx="378">
                  <c:v>229.95</c:v>
                </c:pt>
                <c:pt idx="379">
                  <c:v>230.55799999999999</c:v>
                </c:pt>
                <c:pt idx="380">
                  <c:v>231.167</c:v>
                </c:pt>
                <c:pt idx="381">
                  <c:v>231.77500000000001</c:v>
                </c:pt>
                <c:pt idx="382">
                  <c:v>232.38300000000001</c:v>
                </c:pt>
                <c:pt idx="383">
                  <c:v>232.99199999999999</c:v>
                </c:pt>
                <c:pt idx="384">
                  <c:v>233.6</c:v>
                </c:pt>
                <c:pt idx="385">
                  <c:v>234.208</c:v>
                </c:pt>
                <c:pt idx="386">
                  <c:v>234.81700000000001</c:v>
                </c:pt>
                <c:pt idx="387">
                  <c:v>235.42500000000001</c:v>
                </c:pt>
                <c:pt idx="388">
                  <c:v>236.03299999999999</c:v>
                </c:pt>
                <c:pt idx="389">
                  <c:v>236.642</c:v>
                </c:pt>
                <c:pt idx="390">
                  <c:v>237.25</c:v>
                </c:pt>
                <c:pt idx="391">
                  <c:v>237.858</c:v>
                </c:pt>
                <c:pt idx="392">
                  <c:v>238.46700000000001</c:v>
                </c:pt>
                <c:pt idx="393">
                  <c:v>239.07499999999999</c:v>
                </c:pt>
                <c:pt idx="394">
                  <c:v>239.68299999999999</c:v>
                </c:pt>
                <c:pt idx="395">
                  <c:v>240.292</c:v>
                </c:pt>
                <c:pt idx="396">
                  <c:v>240.9</c:v>
                </c:pt>
                <c:pt idx="397">
                  <c:v>241.50800000000001</c:v>
                </c:pt>
                <c:pt idx="398">
                  <c:v>242.11699999999999</c:v>
                </c:pt>
                <c:pt idx="399">
                  <c:v>242.72499999999999</c:v>
                </c:pt>
                <c:pt idx="400">
                  <c:v>243.333</c:v>
                </c:pt>
                <c:pt idx="401">
                  <c:v>243.94200000000001</c:v>
                </c:pt>
                <c:pt idx="402">
                  <c:v>244.55</c:v>
                </c:pt>
                <c:pt idx="403">
                  <c:v>245.15799999999999</c:v>
                </c:pt>
                <c:pt idx="404">
                  <c:v>245.767</c:v>
                </c:pt>
                <c:pt idx="405">
                  <c:v>246.375</c:v>
                </c:pt>
                <c:pt idx="406">
                  <c:v>246.983</c:v>
                </c:pt>
                <c:pt idx="407">
                  <c:v>247.59200000000001</c:v>
                </c:pt>
                <c:pt idx="408">
                  <c:v>248.2</c:v>
                </c:pt>
                <c:pt idx="409">
                  <c:v>248.80799999999999</c:v>
                </c:pt>
                <c:pt idx="410">
                  <c:v>249.417</c:v>
                </c:pt>
                <c:pt idx="411">
                  <c:v>250.02500000000001</c:v>
                </c:pt>
                <c:pt idx="412">
                  <c:v>250.63300000000001</c:v>
                </c:pt>
                <c:pt idx="413">
                  <c:v>251.24199999999999</c:v>
                </c:pt>
                <c:pt idx="414">
                  <c:v>251.85</c:v>
                </c:pt>
                <c:pt idx="415">
                  <c:v>252.458</c:v>
                </c:pt>
                <c:pt idx="416">
                  <c:v>253.06700000000001</c:v>
                </c:pt>
                <c:pt idx="417">
                  <c:v>253.67500000000001</c:v>
                </c:pt>
                <c:pt idx="418">
                  <c:v>254.28299999999999</c:v>
                </c:pt>
                <c:pt idx="419">
                  <c:v>254.892</c:v>
                </c:pt>
                <c:pt idx="420">
                  <c:v>255.5</c:v>
                </c:pt>
                <c:pt idx="421">
                  <c:v>256.108</c:v>
                </c:pt>
                <c:pt idx="422">
                  <c:v>256.71699999999993</c:v>
                </c:pt>
                <c:pt idx="423">
                  <c:v>257.32499999999999</c:v>
                </c:pt>
                <c:pt idx="424">
                  <c:v>257.93299999999982</c:v>
                </c:pt>
                <c:pt idx="425">
                  <c:v>258.54199999999992</c:v>
                </c:pt>
                <c:pt idx="426">
                  <c:v>259.14999999999998</c:v>
                </c:pt>
                <c:pt idx="427">
                  <c:v>259.75799999999992</c:v>
                </c:pt>
                <c:pt idx="428">
                  <c:v>260.36700000000002</c:v>
                </c:pt>
                <c:pt idx="429">
                  <c:v>260.97500000000002</c:v>
                </c:pt>
                <c:pt idx="430">
                  <c:v>261.58300000000003</c:v>
                </c:pt>
                <c:pt idx="431">
                  <c:v>262.19200000000001</c:v>
                </c:pt>
                <c:pt idx="432">
                  <c:v>262.8</c:v>
                </c:pt>
                <c:pt idx="433">
                  <c:v>263.40800000000002</c:v>
                </c:pt>
                <c:pt idx="434">
                  <c:v>264.017</c:v>
                </c:pt>
                <c:pt idx="435">
                  <c:v>264.625</c:v>
                </c:pt>
                <c:pt idx="436">
                  <c:v>265.23299999999978</c:v>
                </c:pt>
                <c:pt idx="437">
                  <c:v>265.84199999999993</c:v>
                </c:pt>
                <c:pt idx="438">
                  <c:v>266.45</c:v>
                </c:pt>
                <c:pt idx="439">
                  <c:v>267.05799999999999</c:v>
                </c:pt>
                <c:pt idx="440">
                  <c:v>267.66699999999992</c:v>
                </c:pt>
                <c:pt idx="441">
                  <c:v>268.27499999999992</c:v>
                </c:pt>
                <c:pt idx="442">
                  <c:v>268.88299999999992</c:v>
                </c:pt>
                <c:pt idx="443">
                  <c:v>269.49200000000002</c:v>
                </c:pt>
                <c:pt idx="444">
                  <c:v>270.10000000000002</c:v>
                </c:pt>
                <c:pt idx="445">
                  <c:v>270.70800000000003</c:v>
                </c:pt>
                <c:pt idx="446">
                  <c:v>271.31700000000001</c:v>
                </c:pt>
                <c:pt idx="447">
                  <c:v>271.92500000000001</c:v>
                </c:pt>
                <c:pt idx="448">
                  <c:v>272.53300000000002</c:v>
                </c:pt>
                <c:pt idx="449">
                  <c:v>273.142</c:v>
                </c:pt>
                <c:pt idx="450">
                  <c:v>273.75</c:v>
                </c:pt>
                <c:pt idx="451">
                  <c:v>274.358</c:v>
                </c:pt>
                <c:pt idx="452">
                  <c:v>274.96699999999993</c:v>
                </c:pt>
                <c:pt idx="453">
                  <c:v>275.57499999999999</c:v>
                </c:pt>
                <c:pt idx="454">
                  <c:v>276.18299999999999</c:v>
                </c:pt>
                <c:pt idx="455">
                  <c:v>276.7919999999998</c:v>
                </c:pt>
                <c:pt idx="456">
                  <c:v>277.39999999999992</c:v>
                </c:pt>
                <c:pt idx="457">
                  <c:v>278.00799999999992</c:v>
                </c:pt>
                <c:pt idx="458">
                  <c:v>278.61700000000002</c:v>
                </c:pt>
                <c:pt idx="459">
                  <c:v>279.22500000000002</c:v>
                </c:pt>
                <c:pt idx="460">
                  <c:v>279.83300000000003</c:v>
                </c:pt>
                <c:pt idx="461">
                  <c:v>280.44200000000001</c:v>
                </c:pt>
                <c:pt idx="462">
                  <c:v>281.05</c:v>
                </c:pt>
                <c:pt idx="463">
                  <c:v>281.65800000000002</c:v>
                </c:pt>
                <c:pt idx="464">
                  <c:v>282.267</c:v>
                </c:pt>
                <c:pt idx="465">
                  <c:v>282.875</c:v>
                </c:pt>
                <c:pt idx="466">
                  <c:v>283.48299999999978</c:v>
                </c:pt>
                <c:pt idx="467">
                  <c:v>284.09199999999993</c:v>
                </c:pt>
                <c:pt idx="468">
                  <c:v>284.7</c:v>
                </c:pt>
                <c:pt idx="469">
                  <c:v>285.30799999999999</c:v>
                </c:pt>
                <c:pt idx="470">
                  <c:v>285.9169999999998</c:v>
                </c:pt>
                <c:pt idx="471">
                  <c:v>286.52499999999992</c:v>
                </c:pt>
                <c:pt idx="472">
                  <c:v>287.13299999999992</c:v>
                </c:pt>
                <c:pt idx="473">
                  <c:v>287.74200000000002</c:v>
                </c:pt>
                <c:pt idx="474">
                  <c:v>288.35000000000002</c:v>
                </c:pt>
                <c:pt idx="475">
                  <c:v>288.95800000000003</c:v>
                </c:pt>
                <c:pt idx="476">
                  <c:v>289.56700000000001</c:v>
                </c:pt>
                <c:pt idx="477">
                  <c:v>290.17500000000001</c:v>
                </c:pt>
                <c:pt idx="478">
                  <c:v>290.78300000000002</c:v>
                </c:pt>
                <c:pt idx="479">
                  <c:v>291.392</c:v>
                </c:pt>
                <c:pt idx="480">
                  <c:v>292</c:v>
                </c:pt>
                <c:pt idx="481">
                  <c:v>292.608</c:v>
                </c:pt>
                <c:pt idx="482">
                  <c:v>293.21699999999993</c:v>
                </c:pt>
                <c:pt idx="483">
                  <c:v>293.82499999999999</c:v>
                </c:pt>
                <c:pt idx="484">
                  <c:v>294.43299999999982</c:v>
                </c:pt>
                <c:pt idx="485">
                  <c:v>295.04199999999992</c:v>
                </c:pt>
                <c:pt idx="486">
                  <c:v>295.64999999999998</c:v>
                </c:pt>
                <c:pt idx="487">
                  <c:v>296.25799999999992</c:v>
                </c:pt>
                <c:pt idx="488">
                  <c:v>296.86700000000002</c:v>
                </c:pt>
                <c:pt idx="489">
                  <c:v>297.47500000000002</c:v>
                </c:pt>
                <c:pt idx="490">
                  <c:v>298.08300000000003</c:v>
                </c:pt>
                <c:pt idx="491">
                  <c:v>298.69200000000001</c:v>
                </c:pt>
                <c:pt idx="492">
                  <c:v>299.3</c:v>
                </c:pt>
                <c:pt idx="493">
                  <c:v>299.90800000000002</c:v>
                </c:pt>
                <c:pt idx="494">
                  <c:v>300.517</c:v>
                </c:pt>
                <c:pt idx="495">
                  <c:v>301.125</c:v>
                </c:pt>
                <c:pt idx="496">
                  <c:v>301.73299999999978</c:v>
                </c:pt>
                <c:pt idx="497">
                  <c:v>302.34199999999993</c:v>
                </c:pt>
                <c:pt idx="498">
                  <c:v>302.95</c:v>
                </c:pt>
                <c:pt idx="499">
                  <c:v>303.55799999999999</c:v>
                </c:pt>
                <c:pt idx="500">
                  <c:v>304.16699999999992</c:v>
                </c:pt>
                <c:pt idx="501">
                  <c:v>304.77499999999992</c:v>
                </c:pt>
                <c:pt idx="502">
                  <c:v>305.38299999999992</c:v>
                </c:pt>
                <c:pt idx="503">
                  <c:v>305.99200000000002</c:v>
                </c:pt>
                <c:pt idx="504">
                  <c:v>306.60000000000002</c:v>
                </c:pt>
                <c:pt idx="505">
                  <c:v>307.20800000000003</c:v>
                </c:pt>
                <c:pt idx="506">
                  <c:v>307.81700000000001</c:v>
                </c:pt>
                <c:pt idx="507">
                  <c:v>308.42500000000001</c:v>
                </c:pt>
                <c:pt idx="508">
                  <c:v>309.03300000000002</c:v>
                </c:pt>
                <c:pt idx="509">
                  <c:v>309.642</c:v>
                </c:pt>
                <c:pt idx="510">
                  <c:v>310.25</c:v>
                </c:pt>
                <c:pt idx="511">
                  <c:v>310.858</c:v>
                </c:pt>
                <c:pt idx="512">
                  <c:v>311.46699999999993</c:v>
                </c:pt>
                <c:pt idx="513">
                  <c:v>312.07499999999999</c:v>
                </c:pt>
                <c:pt idx="514">
                  <c:v>312.68299999999999</c:v>
                </c:pt>
                <c:pt idx="515">
                  <c:v>313.2919999999998</c:v>
                </c:pt>
                <c:pt idx="516">
                  <c:v>313.89999999999992</c:v>
                </c:pt>
                <c:pt idx="517">
                  <c:v>314.50799999999992</c:v>
                </c:pt>
                <c:pt idx="518">
                  <c:v>315.11700000000002</c:v>
                </c:pt>
                <c:pt idx="519">
                  <c:v>315.72500000000002</c:v>
                </c:pt>
                <c:pt idx="520">
                  <c:v>316.33300000000003</c:v>
                </c:pt>
                <c:pt idx="521">
                  <c:v>316.94200000000001</c:v>
                </c:pt>
                <c:pt idx="522">
                  <c:v>317.55</c:v>
                </c:pt>
                <c:pt idx="523">
                  <c:v>318.15800000000002</c:v>
                </c:pt>
                <c:pt idx="524">
                  <c:v>318.767</c:v>
                </c:pt>
                <c:pt idx="525">
                  <c:v>319.375</c:v>
                </c:pt>
                <c:pt idx="526">
                  <c:v>319.98299999999978</c:v>
                </c:pt>
                <c:pt idx="527">
                  <c:v>320.59199999999993</c:v>
                </c:pt>
                <c:pt idx="528">
                  <c:v>321.2</c:v>
                </c:pt>
                <c:pt idx="529">
                  <c:v>321.80799999999999</c:v>
                </c:pt>
                <c:pt idx="530">
                  <c:v>322.4169999999998</c:v>
                </c:pt>
                <c:pt idx="531">
                  <c:v>323.02499999999992</c:v>
                </c:pt>
                <c:pt idx="532">
                  <c:v>323.63299999999992</c:v>
                </c:pt>
                <c:pt idx="533">
                  <c:v>324.24200000000002</c:v>
                </c:pt>
                <c:pt idx="534">
                  <c:v>324.85000000000002</c:v>
                </c:pt>
                <c:pt idx="535">
                  <c:v>325.45800000000003</c:v>
                </c:pt>
                <c:pt idx="536">
                  <c:v>326.06700000000001</c:v>
                </c:pt>
                <c:pt idx="537">
                  <c:v>326.67500000000001</c:v>
                </c:pt>
                <c:pt idx="538">
                  <c:v>327.28300000000002</c:v>
                </c:pt>
                <c:pt idx="539">
                  <c:v>327.892</c:v>
                </c:pt>
                <c:pt idx="540">
                  <c:v>328.5</c:v>
                </c:pt>
                <c:pt idx="541">
                  <c:v>329.108</c:v>
                </c:pt>
                <c:pt idx="542">
                  <c:v>329.71699999999993</c:v>
                </c:pt>
                <c:pt idx="543">
                  <c:v>330.32499999999999</c:v>
                </c:pt>
                <c:pt idx="544">
                  <c:v>330.93299999999982</c:v>
                </c:pt>
                <c:pt idx="545">
                  <c:v>331.54199999999992</c:v>
                </c:pt>
                <c:pt idx="546">
                  <c:v>332.15</c:v>
                </c:pt>
                <c:pt idx="547">
                  <c:v>332.75799999999992</c:v>
                </c:pt>
                <c:pt idx="548">
                  <c:v>333.36700000000002</c:v>
                </c:pt>
                <c:pt idx="549">
                  <c:v>333.97500000000002</c:v>
                </c:pt>
                <c:pt idx="550">
                  <c:v>334.58300000000003</c:v>
                </c:pt>
                <c:pt idx="551">
                  <c:v>335.19200000000001</c:v>
                </c:pt>
                <c:pt idx="552">
                  <c:v>335.8</c:v>
                </c:pt>
                <c:pt idx="553">
                  <c:v>336.40800000000002</c:v>
                </c:pt>
                <c:pt idx="554">
                  <c:v>337.017</c:v>
                </c:pt>
                <c:pt idx="555">
                  <c:v>337.625</c:v>
                </c:pt>
                <c:pt idx="556">
                  <c:v>338.23299999999978</c:v>
                </c:pt>
                <c:pt idx="557">
                  <c:v>338.84199999999993</c:v>
                </c:pt>
                <c:pt idx="558">
                  <c:v>339.45</c:v>
                </c:pt>
                <c:pt idx="559">
                  <c:v>340.05799999999999</c:v>
                </c:pt>
                <c:pt idx="560">
                  <c:v>340.66699999999992</c:v>
                </c:pt>
                <c:pt idx="561">
                  <c:v>341.27499999999992</c:v>
                </c:pt>
                <c:pt idx="562">
                  <c:v>341.88299999999992</c:v>
                </c:pt>
                <c:pt idx="563">
                  <c:v>342.49200000000002</c:v>
                </c:pt>
                <c:pt idx="564">
                  <c:v>343.1</c:v>
                </c:pt>
                <c:pt idx="565">
                  <c:v>343.70800000000003</c:v>
                </c:pt>
                <c:pt idx="566">
                  <c:v>344.31700000000001</c:v>
                </c:pt>
                <c:pt idx="567">
                  <c:v>344.92500000000001</c:v>
                </c:pt>
                <c:pt idx="568">
                  <c:v>345.53300000000002</c:v>
                </c:pt>
                <c:pt idx="569">
                  <c:v>346.142</c:v>
                </c:pt>
                <c:pt idx="570">
                  <c:v>346.75</c:v>
                </c:pt>
                <c:pt idx="571">
                  <c:v>347.358</c:v>
                </c:pt>
                <c:pt idx="572">
                  <c:v>347.96699999999993</c:v>
                </c:pt>
                <c:pt idx="573">
                  <c:v>348.57499999999999</c:v>
                </c:pt>
                <c:pt idx="574">
                  <c:v>349.18299999999999</c:v>
                </c:pt>
                <c:pt idx="575">
                  <c:v>349.7919999999998</c:v>
                </c:pt>
                <c:pt idx="576">
                  <c:v>350.4</c:v>
                </c:pt>
                <c:pt idx="577">
                  <c:v>351.00799999999992</c:v>
                </c:pt>
                <c:pt idx="578">
                  <c:v>351.61700000000002</c:v>
                </c:pt>
                <c:pt idx="579">
                  <c:v>352.22500000000002</c:v>
                </c:pt>
                <c:pt idx="580">
                  <c:v>352.83300000000003</c:v>
                </c:pt>
                <c:pt idx="581">
                  <c:v>353.44200000000001</c:v>
                </c:pt>
                <c:pt idx="582">
                  <c:v>354.05</c:v>
                </c:pt>
                <c:pt idx="583">
                  <c:v>354.65800000000002</c:v>
                </c:pt>
                <c:pt idx="584">
                  <c:v>355.267</c:v>
                </c:pt>
                <c:pt idx="585">
                  <c:v>355.875</c:v>
                </c:pt>
                <c:pt idx="586">
                  <c:v>356.48299999999978</c:v>
                </c:pt>
                <c:pt idx="587">
                  <c:v>357.09199999999993</c:v>
                </c:pt>
                <c:pt idx="588">
                  <c:v>357.7</c:v>
                </c:pt>
                <c:pt idx="589">
                  <c:v>358.30799999999999</c:v>
                </c:pt>
                <c:pt idx="590">
                  <c:v>358.9169999999998</c:v>
                </c:pt>
                <c:pt idx="591">
                  <c:v>359.52499999999992</c:v>
                </c:pt>
                <c:pt idx="592">
                  <c:v>360.13299999999992</c:v>
                </c:pt>
                <c:pt idx="593">
                  <c:v>360.74200000000002</c:v>
                </c:pt>
                <c:pt idx="594">
                  <c:v>361.35</c:v>
                </c:pt>
                <c:pt idx="595">
                  <c:v>361.95800000000003</c:v>
                </c:pt>
                <c:pt idx="596">
                  <c:v>362.56700000000001</c:v>
                </c:pt>
                <c:pt idx="597">
                  <c:v>363.17500000000001</c:v>
                </c:pt>
                <c:pt idx="598">
                  <c:v>363.78300000000002</c:v>
                </c:pt>
                <c:pt idx="599">
                  <c:v>364.392</c:v>
                </c:pt>
                <c:pt idx="600">
                  <c:v>365</c:v>
                </c:pt>
                <c:pt idx="601">
                  <c:v>365.608</c:v>
                </c:pt>
                <c:pt idx="602">
                  <c:v>366.21699999999993</c:v>
                </c:pt>
                <c:pt idx="603">
                  <c:v>366.82499999999999</c:v>
                </c:pt>
                <c:pt idx="604">
                  <c:v>367.43299999999982</c:v>
                </c:pt>
                <c:pt idx="605">
                  <c:v>368.04199999999992</c:v>
                </c:pt>
                <c:pt idx="606">
                  <c:v>368.65</c:v>
                </c:pt>
                <c:pt idx="607">
                  <c:v>369.25799999999992</c:v>
                </c:pt>
                <c:pt idx="608">
                  <c:v>369.86700000000002</c:v>
                </c:pt>
                <c:pt idx="609">
                  <c:v>370.47500000000002</c:v>
                </c:pt>
                <c:pt idx="610">
                  <c:v>371.08300000000003</c:v>
                </c:pt>
                <c:pt idx="611">
                  <c:v>371.69200000000001</c:v>
                </c:pt>
                <c:pt idx="612">
                  <c:v>372.3</c:v>
                </c:pt>
                <c:pt idx="613">
                  <c:v>372.90800000000002</c:v>
                </c:pt>
                <c:pt idx="614">
                  <c:v>373.517</c:v>
                </c:pt>
                <c:pt idx="615">
                  <c:v>374.125</c:v>
                </c:pt>
                <c:pt idx="616">
                  <c:v>374.73299999999978</c:v>
                </c:pt>
                <c:pt idx="617">
                  <c:v>375.34199999999993</c:v>
                </c:pt>
                <c:pt idx="618">
                  <c:v>375.95</c:v>
                </c:pt>
                <c:pt idx="619">
                  <c:v>376.55799999999999</c:v>
                </c:pt>
                <c:pt idx="620">
                  <c:v>377.16699999999992</c:v>
                </c:pt>
                <c:pt idx="621">
                  <c:v>377.77499999999992</c:v>
                </c:pt>
                <c:pt idx="622">
                  <c:v>378.38299999999992</c:v>
                </c:pt>
                <c:pt idx="623">
                  <c:v>378.99200000000002</c:v>
                </c:pt>
                <c:pt idx="624">
                  <c:v>379.6</c:v>
                </c:pt>
                <c:pt idx="625">
                  <c:v>380.20800000000003</c:v>
                </c:pt>
                <c:pt idx="626">
                  <c:v>380.81700000000001</c:v>
                </c:pt>
                <c:pt idx="627">
                  <c:v>381.42500000000001</c:v>
                </c:pt>
                <c:pt idx="628">
                  <c:v>382.03300000000002</c:v>
                </c:pt>
                <c:pt idx="629">
                  <c:v>382.642</c:v>
                </c:pt>
                <c:pt idx="630">
                  <c:v>383.25</c:v>
                </c:pt>
                <c:pt idx="631">
                  <c:v>383.858</c:v>
                </c:pt>
                <c:pt idx="632">
                  <c:v>384.46699999999993</c:v>
                </c:pt>
                <c:pt idx="633">
                  <c:v>385.07499999999999</c:v>
                </c:pt>
                <c:pt idx="634">
                  <c:v>385.68299999999999</c:v>
                </c:pt>
                <c:pt idx="635">
                  <c:v>386.2919999999998</c:v>
                </c:pt>
                <c:pt idx="636">
                  <c:v>386.9</c:v>
                </c:pt>
                <c:pt idx="637">
                  <c:v>387.50799999999992</c:v>
                </c:pt>
                <c:pt idx="638">
                  <c:v>388.11700000000002</c:v>
                </c:pt>
                <c:pt idx="639">
                  <c:v>388.72500000000002</c:v>
                </c:pt>
                <c:pt idx="640">
                  <c:v>389.33300000000003</c:v>
                </c:pt>
                <c:pt idx="641">
                  <c:v>389.94200000000001</c:v>
                </c:pt>
                <c:pt idx="642">
                  <c:v>390.55</c:v>
                </c:pt>
                <c:pt idx="643">
                  <c:v>391.15800000000002</c:v>
                </c:pt>
                <c:pt idx="644">
                  <c:v>391.767</c:v>
                </c:pt>
                <c:pt idx="645">
                  <c:v>392.375</c:v>
                </c:pt>
                <c:pt idx="646">
                  <c:v>392.98299999999978</c:v>
                </c:pt>
                <c:pt idx="647">
                  <c:v>393.59199999999993</c:v>
                </c:pt>
                <c:pt idx="648">
                  <c:v>394.2</c:v>
                </c:pt>
                <c:pt idx="649">
                  <c:v>394.80799999999999</c:v>
                </c:pt>
                <c:pt idx="650">
                  <c:v>395.4169999999998</c:v>
                </c:pt>
                <c:pt idx="651">
                  <c:v>396.02499999999992</c:v>
                </c:pt>
                <c:pt idx="652">
                  <c:v>396.63299999999992</c:v>
                </c:pt>
                <c:pt idx="653">
                  <c:v>397.24200000000002</c:v>
                </c:pt>
                <c:pt idx="654">
                  <c:v>397.85</c:v>
                </c:pt>
                <c:pt idx="655">
                  <c:v>398.45800000000003</c:v>
                </c:pt>
                <c:pt idx="656">
                  <c:v>399.06700000000001</c:v>
                </c:pt>
                <c:pt idx="657">
                  <c:v>399.67500000000001</c:v>
                </c:pt>
                <c:pt idx="658">
                  <c:v>400.28300000000002</c:v>
                </c:pt>
                <c:pt idx="659">
                  <c:v>400.892</c:v>
                </c:pt>
                <c:pt idx="660">
                  <c:v>401.5</c:v>
                </c:pt>
                <c:pt idx="661">
                  <c:v>402.108</c:v>
                </c:pt>
                <c:pt idx="662">
                  <c:v>402.71699999999993</c:v>
                </c:pt>
                <c:pt idx="663">
                  <c:v>403.32499999999999</c:v>
                </c:pt>
                <c:pt idx="664">
                  <c:v>403.93299999999982</c:v>
                </c:pt>
                <c:pt idx="665">
                  <c:v>404.54199999999992</c:v>
                </c:pt>
                <c:pt idx="666">
                  <c:v>405.15</c:v>
                </c:pt>
                <c:pt idx="667">
                  <c:v>405.75799999999992</c:v>
                </c:pt>
                <c:pt idx="668">
                  <c:v>406.36700000000002</c:v>
                </c:pt>
                <c:pt idx="669">
                  <c:v>406.97500000000002</c:v>
                </c:pt>
                <c:pt idx="670">
                  <c:v>407.58300000000003</c:v>
                </c:pt>
                <c:pt idx="671">
                  <c:v>408.19200000000001</c:v>
                </c:pt>
                <c:pt idx="672">
                  <c:v>408.8</c:v>
                </c:pt>
                <c:pt idx="673">
                  <c:v>409.40800000000002</c:v>
                </c:pt>
                <c:pt idx="674">
                  <c:v>410.017</c:v>
                </c:pt>
                <c:pt idx="675">
                  <c:v>410.625</c:v>
                </c:pt>
                <c:pt idx="676">
                  <c:v>411.23299999999978</c:v>
                </c:pt>
                <c:pt idx="677">
                  <c:v>411.84199999999993</c:v>
                </c:pt>
                <c:pt idx="678">
                  <c:v>412.45</c:v>
                </c:pt>
                <c:pt idx="679">
                  <c:v>413.05799999999999</c:v>
                </c:pt>
                <c:pt idx="680">
                  <c:v>413.66699999999992</c:v>
                </c:pt>
                <c:pt idx="681">
                  <c:v>414.27499999999992</c:v>
                </c:pt>
                <c:pt idx="682">
                  <c:v>414.88299999999992</c:v>
                </c:pt>
                <c:pt idx="683">
                  <c:v>415.49200000000002</c:v>
                </c:pt>
                <c:pt idx="684">
                  <c:v>416.1</c:v>
                </c:pt>
                <c:pt idx="685">
                  <c:v>416.70800000000003</c:v>
                </c:pt>
                <c:pt idx="686">
                  <c:v>417.31700000000001</c:v>
                </c:pt>
                <c:pt idx="687">
                  <c:v>417.92500000000001</c:v>
                </c:pt>
                <c:pt idx="688">
                  <c:v>418.53300000000002</c:v>
                </c:pt>
                <c:pt idx="689">
                  <c:v>419.142</c:v>
                </c:pt>
                <c:pt idx="690">
                  <c:v>419.75</c:v>
                </c:pt>
                <c:pt idx="691">
                  <c:v>420.358</c:v>
                </c:pt>
                <c:pt idx="692">
                  <c:v>420.96699999999993</c:v>
                </c:pt>
                <c:pt idx="693">
                  <c:v>421.57499999999999</c:v>
                </c:pt>
                <c:pt idx="694">
                  <c:v>422.18299999999999</c:v>
                </c:pt>
                <c:pt idx="695">
                  <c:v>422.7919999999998</c:v>
                </c:pt>
                <c:pt idx="696">
                  <c:v>423.4</c:v>
                </c:pt>
                <c:pt idx="697">
                  <c:v>424.00799999999992</c:v>
                </c:pt>
                <c:pt idx="698">
                  <c:v>424.61700000000002</c:v>
                </c:pt>
                <c:pt idx="699">
                  <c:v>425.22500000000002</c:v>
                </c:pt>
                <c:pt idx="700">
                  <c:v>425.83300000000003</c:v>
                </c:pt>
                <c:pt idx="701">
                  <c:v>426.44200000000001</c:v>
                </c:pt>
                <c:pt idx="702">
                  <c:v>427.05</c:v>
                </c:pt>
                <c:pt idx="703">
                  <c:v>427.65800000000002</c:v>
                </c:pt>
                <c:pt idx="704">
                  <c:v>428.267</c:v>
                </c:pt>
                <c:pt idx="705">
                  <c:v>428.875</c:v>
                </c:pt>
                <c:pt idx="706">
                  <c:v>429.48299999999978</c:v>
                </c:pt>
                <c:pt idx="707">
                  <c:v>430.09199999999993</c:v>
                </c:pt>
                <c:pt idx="708">
                  <c:v>430.7</c:v>
                </c:pt>
                <c:pt idx="709">
                  <c:v>431.30799999999999</c:v>
                </c:pt>
                <c:pt idx="710">
                  <c:v>431.9169999999998</c:v>
                </c:pt>
                <c:pt idx="711">
                  <c:v>432.52499999999992</c:v>
                </c:pt>
                <c:pt idx="712">
                  <c:v>433.13299999999992</c:v>
                </c:pt>
                <c:pt idx="713">
                  <c:v>433.74200000000002</c:v>
                </c:pt>
                <c:pt idx="714">
                  <c:v>434.35</c:v>
                </c:pt>
                <c:pt idx="715">
                  <c:v>434.95800000000003</c:v>
                </c:pt>
                <c:pt idx="716">
                  <c:v>435.56700000000001</c:v>
                </c:pt>
                <c:pt idx="717">
                  <c:v>436.17500000000001</c:v>
                </c:pt>
                <c:pt idx="718">
                  <c:v>436.78300000000002</c:v>
                </c:pt>
                <c:pt idx="719">
                  <c:v>437.392</c:v>
                </c:pt>
                <c:pt idx="720">
                  <c:v>438</c:v>
                </c:pt>
                <c:pt idx="721">
                  <c:v>438.608</c:v>
                </c:pt>
                <c:pt idx="722">
                  <c:v>439.21699999999993</c:v>
                </c:pt>
                <c:pt idx="723">
                  <c:v>439.82499999999999</c:v>
                </c:pt>
                <c:pt idx="724">
                  <c:v>440.43299999999982</c:v>
                </c:pt>
                <c:pt idx="725">
                  <c:v>441.04199999999992</c:v>
                </c:pt>
                <c:pt idx="726">
                  <c:v>441.65</c:v>
                </c:pt>
                <c:pt idx="727">
                  <c:v>442.25799999999992</c:v>
                </c:pt>
                <c:pt idx="728">
                  <c:v>442.86700000000002</c:v>
                </c:pt>
                <c:pt idx="729">
                  <c:v>443.47500000000002</c:v>
                </c:pt>
                <c:pt idx="730">
                  <c:v>444.08300000000003</c:v>
                </c:pt>
                <c:pt idx="731">
                  <c:v>444.69200000000001</c:v>
                </c:pt>
                <c:pt idx="732">
                  <c:v>445.3</c:v>
                </c:pt>
                <c:pt idx="733">
                  <c:v>445.90800000000002</c:v>
                </c:pt>
                <c:pt idx="734">
                  <c:v>446.517</c:v>
                </c:pt>
                <c:pt idx="735">
                  <c:v>447.125</c:v>
                </c:pt>
                <c:pt idx="736">
                  <c:v>447.73299999999978</c:v>
                </c:pt>
                <c:pt idx="737">
                  <c:v>448.34199999999993</c:v>
                </c:pt>
                <c:pt idx="738">
                  <c:v>448.95</c:v>
                </c:pt>
                <c:pt idx="739">
                  <c:v>449.55799999999999</c:v>
                </c:pt>
                <c:pt idx="740">
                  <c:v>450.16699999999992</c:v>
                </c:pt>
                <c:pt idx="741">
                  <c:v>450.77499999999992</c:v>
                </c:pt>
                <c:pt idx="742">
                  <c:v>451.38299999999992</c:v>
                </c:pt>
                <c:pt idx="743">
                  <c:v>451.99200000000002</c:v>
                </c:pt>
                <c:pt idx="744">
                  <c:v>452.6</c:v>
                </c:pt>
                <c:pt idx="745">
                  <c:v>453.20800000000003</c:v>
                </c:pt>
                <c:pt idx="746">
                  <c:v>453.81700000000001</c:v>
                </c:pt>
                <c:pt idx="747">
                  <c:v>454.42500000000001</c:v>
                </c:pt>
                <c:pt idx="748">
                  <c:v>455.03300000000002</c:v>
                </c:pt>
                <c:pt idx="749">
                  <c:v>455.642</c:v>
                </c:pt>
                <c:pt idx="750">
                  <c:v>456.25</c:v>
                </c:pt>
                <c:pt idx="751">
                  <c:v>456.858</c:v>
                </c:pt>
                <c:pt idx="752">
                  <c:v>457.46699999999993</c:v>
                </c:pt>
                <c:pt idx="753">
                  <c:v>458.07499999999999</c:v>
                </c:pt>
                <c:pt idx="754">
                  <c:v>458.68299999999999</c:v>
                </c:pt>
                <c:pt idx="755">
                  <c:v>459.2919999999998</c:v>
                </c:pt>
                <c:pt idx="756">
                  <c:v>459.9</c:v>
                </c:pt>
                <c:pt idx="757">
                  <c:v>460.50799999999992</c:v>
                </c:pt>
                <c:pt idx="758">
                  <c:v>461.11700000000002</c:v>
                </c:pt>
                <c:pt idx="759">
                  <c:v>461.72500000000002</c:v>
                </c:pt>
                <c:pt idx="760">
                  <c:v>462.33300000000003</c:v>
                </c:pt>
                <c:pt idx="761">
                  <c:v>462.94200000000001</c:v>
                </c:pt>
                <c:pt idx="762">
                  <c:v>463.55</c:v>
                </c:pt>
                <c:pt idx="763">
                  <c:v>464.15800000000002</c:v>
                </c:pt>
                <c:pt idx="764">
                  <c:v>464.767</c:v>
                </c:pt>
                <c:pt idx="765">
                  <c:v>465.375</c:v>
                </c:pt>
                <c:pt idx="766">
                  <c:v>465.98299999999978</c:v>
                </c:pt>
                <c:pt idx="767">
                  <c:v>466.59199999999993</c:v>
                </c:pt>
                <c:pt idx="768">
                  <c:v>467.2</c:v>
                </c:pt>
                <c:pt idx="769">
                  <c:v>467.80799999999999</c:v>
                </c:pt>
                <c:pt idx="770">
                  <c:v>468.4169999999998</c:v>
                </c:pt>
                <c:pt idx="771">
                  <c:v>469.02499999999992</c:v>
                </c:pt>
                <c:pt idx="772">
                  <c:v>469.63299999999992</c:v>
                </c:pt>
                <c:pt idx="773">
                  <c:v>470.24200000000002</c:v>
                </c:pt>
                <c:pt idx="774">
                  <c:v>470.85</c:v>
                </c:pt>
                <c:pt idx="775">
                  <c:v>471.45800000000003</c:v>
                </c:pt>
                <c:pt idx="776">
                  <c:v>472.06700000000001</c:v>
                </c:pt>
                <c:pt idx="777">
                  <c:v>472.67500000000001</c:v>
                </c:pt>
                <c:pt idx="778">
                  <c:v>473.28300000000002</c:v>
                </c:pt>
                <c:pt idx="779">
                  <c:v>473.892</c:v>
                </c:pt>
                <c:pt idx="780">
                  <c:v>474.5</c:v>
                </c:pt>
                <c:pt idx="781">
                  <c:v>475.108</c:v>
                </c:pt>
                <c:pt idx="782">
                  <c:v>475.71699999999993</c:v>
                </c:pt>
                <c:pt idx="783">
                  <c:v>476.32499999999999</c:v>
                </c:pt>
                <c:pt idx="784">
                  <c:v>476.93299999999982</c:v>
                </c:pt>
                <c:pt idx="785">
                  <c:v>477.54199999999992</c:v>
                </c:pt>
                <c:pt idx="786">
                  <c:v>478.15</c:v>
                </c:pt>
                <c:pt idx="787">
                  <c:v>478.75799999999992</c:v>
                </c:pt>
                <c:pt idx="788">
                  <c:v>479.36700000000002</c:v>
                </c:pt>
                <c:pt idx="789">
                  <c:v>479.97500000000002</c:v>
                </c:pt>
                <c:pt idx="790">
                  <c:v>480.58300000000003</c:v>
                </c:pt>
                <c:pt idx="791">
                  <c:v>481.19200000000001</c:v>
                </c:pt>
                <c:pt idx="792">
                  <c:v>481.8</c:v>
                </c:pt>
                <c:pt idx="793">
                  <c:v>482.40800000000002</c:v>
                </c:pt>
                <c:pt idx="794">
                  <c:v>483.017</c:v>
                </c:pt>
                <c:pt idx="795">
                  <c:v>483.625</c:v>
                </c:pt>
                <c:pt idx="796">
                  <c:v>484.23299999999978</c:v>
                </c:pt>
                <c:pt idx="797">
                  <c:v>484.84199999999993</c:v>
                </c:pt>
                <c:pt idx="798">
                  <c:v>485.45</c:v>
                </c:pt>
                <c:pt idx="799">
                  <c:v>486.05799999999999</c:v>
                </c:pt>
                <c:pt idx="800">
                  <c:v>486.66699999999992</c:v>
                </c:pt>
                <c:pt idx="801">
                  <c:v>487.27499999999992</c:v>
                </c:pt>
                <c:pt idx="802">
                  <c:v>487.88299999999992</c:v>
                </c:pt>
                <c:pt idx="803">
                  <c:v>488.49200000000002</c:v>
                </c:pt>
                <c:pt idx="804">
                  <c:v>489.1</c:v>
                </c:pt>
                <c:pt idx="805">
                  <c:v>489.70800000000003</c:v>
                </c:pt>
                <c:pt idx="806">
                  <c:v>490.31700000000001</c:v>
                </c:pt>
                <c:pt idx="807">
                  <c:v>490.92500000000001</c:v>
                </c:pt>
                <c:pt idx="808">
                  <c:v>491.53300000000002</c:v>
                </c:pt>
                <c:pt idx="809">
                  <c:v>492.142</c:v>
                </c:pt>
                <c:pt idx="810">
                  <c:v>492.75</c:v>
                </c:pt>
                <c:pt idx="811">
                  <c:v>493.358</c:v>
                </c:pt>
                <c:pt idx="812">
                  <c:v>493.96699999999993</c:v>
                </c:pt>
                <c:pt idx="813">
                  <c:v>494.57499999999999</c:v>
                </c:pt>
                <c:pt idx="814">
                  <c:v>495.18299999999999</c:v>
                </c:pt>
                <c:pt idx="815">
                  <c:v>495.7919999999998</c:v>
                </c:pt>
                <c:pt idx="816">
                  <c:v>496.4</c:v>
                </c:pt>
                <c:pt idx="817">
                  <c:v>497.00799999999992</c:v>
                </c:pt>
                <c:pt idx="818">
                  <c:v>497.61700000000002</c:v>
                </c:pt>
                <c:pt idx="819">
                  <c:v>498.22500000000002</c:v>
                </c:pt>
                <c:pt idx="820">
                  <c:v>498.83300000000003</c:v>
                </c:pt>
                <c:pt idx="821">
                  <c:v>499.44200000000001</c:v>
                </c:pt>
                <c:pt idx="822">
                  <c:v>500.05</c:v>
                </c:pt>
                <c:pt idx="823">
                  <c:v>500.65800000000002</c:v>
                </c:pt>
                <c:pt idx="824">
                  <c:v>501.267</c:v>
                </c:pt>
                <c:pt idx="825">
                  <c:v>501.875</c:v>
                </c:pt>
                <c:pt idx="826">
                  <c:v>502.48299999999978</c:v>
                </c:pt>
                <c:pt idx="827">
                  <c:v>503.09199999999993</c:v>
                </c:pt>
                <c:pt idx="828">
                  <c:v>503.7</c:v>
                </c:pt>
                <c:pt idx="829">
                  <c:v>504.30799999999999</c:v>
                </c:pt>
                <c:pt idx="830">
                  <c:v>504.9169999999998</c:v>
                </c:pt>
                <c:pt idx="831">
                  <c:v>505.52499999999992</c:v>
                </c:pt>
                <c:pt idx="832">
                  <c:v>506.13299999999992</c:v>
                </c:pt>
                <c:pt idx="833">
                  <c:v>506.74200000000002</c:v>
                </c:pt>
                <c:pt idx="834">
                  <c:v>507.35</c:v>
                </c:pt>
                <c:pt idx="835">
                  <c:v>507.95800000000003</c:v>
                </c:pt>
                <c:pt idx="836">
                  <c:v>508.56700000000001</c:v>
                </c:pt>
                <c:pt idx="837">
                  <c:v>509.17500000000001</c:v>
                </c:pt>
                <c:pt idx="838">
                  <c:v>509.78300000000002</c:v>
                </c:pt>
                <c:pt idx="839">
                  <c:v>510.392</c:v>
                </c:pt>
                <c:pt idx="840">
                  <c:v>511</c:v>
                </c:pt>
                <c:pt idx="841">
                  <c:v>511.608</c:v>
                </c:pt>
                <c:pt idx="842">
                  <c:v>512.21699999999998</c:v>
                </c:pt>
                <c:pt idx="843">
                  <c:v>512.82499999999982</c:v>
                </c:pt>
                <c:pt idx="844">
                  <c:v>513.43299999999977</c:v>
                </c:pt>
                <c:pt idx="845">
                  <c:v>514.0419999999998</c:v>
                </c:pt>
                <c:pt idx="846">
                  <c:v>514.65</c:v>
                </c:pt>
                <c:pt idx="847">
                  <c:v>515.25800000000004</c:v>
                </c:pt>
                <c:pt idx="848">
                  <c:v>515.86699999999962</c:v>
                </c:pt>
                <c:pt idx="849">
                  <c:v>516.47500000000002</c:v>
                </c:pt>
                <c:pt idx="850">
                  <c:v>517.08299999999997</c:v>
                </c:pt>
                <c:pt idx="851">
                  <c:v>517.69200000000001</c:v>
                </c:pt>
                <c:pt idx="852">
                  <c:v>518.29999999999995</c:v>
                </c:pt>
                <c:pt idx="853">
                  <c:v>518.90800000000002</c:v>
                </c:pt>
                <c:pt idx="854">
                  <c:v>519.51699999999983</c:v>
                </c:pt>
                <c:pt idx="855">
                  <c:v>520.125</c:v>
                </c:pt>
                <c:pt idx="856">
                  <c:v>520.73299999999972</c:v>
                </c:pt>
                <c:pt idx="857">
                  <c:v>521.34199999999976</c:v>
                </c:pt>
                <c:pt idx="858">
                  <c:v>521.94999999999982</c:v>
                </c:pt>
                <c:pt idx="859">
                  <c:v>522.55799999999977</c:v>
                </c:pt>
                <c:pt idx="860">
                  <c:v>523.1669999999998</c:v>
                </c:pt>
                <c:pt idx="861">
                  <c:v>523.77499999999998</c:v>
                </c:pt>
                <c:pt idx="862">
                  <c:v>524.38300000000004</c:v>
                </c:pt>
                <c:pt idx="863">
                  <c:v>524.99199999999996</c:v>
                </c:pt>
                <c:pt idx="864">
                  <c:v>525.6</c:v>
                </c:pt>
                <c:pt idx="865">
                  <c:v>526.20799999999997</c:v>
                </c:pt>
                <c:pt idx="866">
                  <c:v>526.81699999999978</c:v>
                </c:pt>
                <c:pt idx="867">
                  <c:v>527.42499999999973</c:v>
                </c:pt>
                <c:pt idx="868">
                  <c:v>528.03300000000002</c:v>
                </c:pt>
                <c:pt idx="869">
                  <c:v>528.64199999999983</c:v>
                </c:pt>
                <c:pt idx="870">
                  <c:v>529.25</c:v>
                </c:pt>
                <c:pt idx="871">
                  <c:v>529.85799999999949</c:v>
                </c:pt>
                <c:pt idx="872">
                  <c:v>530.46699999999976</c:v>
                </c:pt>
                <c:pt idx="873">
                  <c:v>531.07500000000005</c:v>
                </c:pt>
                <c:pt idx="874">
                  <c:v>531.68299999999999</c:v>
                </c:pt>
                <c:pt idx="875">
                  <c:v>532.29200000000003</c:v>
                </c:pt>
                <c:pt idx="876">
                  <c:v>532.9</c:v>
                </c:pt>
                <c:pt idx="877">
                  <c:v>533.50800000000004</c:v>
                </c:pt>
                <c:pt idx="878">
                  <c:v>534.11699999999996</c:v>
                </c:pt>
                <c:pt idx="879">
                  <c:v>534.72500000000002</c:v>
                </c:pt>
                <c:pt idx="880">
                  <c:v>535.33299999999974</c:v>
                </c:pt>
                <c:pt idx="881">
                  <c:v>535.94199999999978</c:v>
                </c:pt>
                <c:pt idx="882">
                  <c:v>536.54999999999973</c:v>
                </c:pt>
                <c:pt idx="883">
                  <c:v>537.15800000000002</c:v>
                </c:pt>
                <c:pt idx="884">
                  <c:v>537.76699999999983</c:v>
                </c:pt>
                <c:pt idx="885">
                  <c:v>538.375</c:v>
                </c:pt>
                <c:pt idx="886">
                  <c:v>538.98299999999972</c:v>
                </c:pt>
                <c:pt idx="887">
                  <c:v>539.59199999999998</c:v>
                </c:pt>
                <c:pt idx="888">
                  <c:v>540.20000000000005</c:v>
                </c:pt>
                <c:pt idx="889">
                  <c:v>540.80799999999977</c:v>
                </c:pt>
                <c:pt idx="890">
                  <c:v>541.4169999999998</c:v>
                </c:pt>
                <c:pt idx="891">
                  <c:v>542.02499999999998</c:v>
                </c:pt>
                <c:pt idx="892">
                  <c:v>542.63300000000004</c:v>
                </c:pt>
                <c:pt idx="893">
                  <c:v>543.24199999999996</c:v>
                </c:pt>
                <c:pt idx="894">
                  <c:v>543.8499999999998</c:v>
                </c:pt>
                <c:pt idx="895">
                  <c:v>544.45799999999974</c:v>
                </c:pt>
                <c:pt idx="896">
                  <c:v>545.06699999999978</c:v>
                </c:pt>
                <c:pt idx="897">
                  <c:v>545.67499999999995</c:v>
                </c:pt>
                <c:pt idx="898">
                  <c:v>546.28300000000002</c:v>
                </c:pt>
                <c:pt idx="899">
                  <c:v>546.89199999999983</c:v>
                </c:pt>
                <c:pt idx="900">
                  <c:v>547.5</c:v>
                </c:pt>
                <c:pt idx="901">
                  <c:v>548.10799999999972</c:v>
                </c:pt>
                <c:pt idx="902">
                  <c:v>548.71699999999998</c:v>
                </c:pt>
                <c:pt idx="903">
                  <c:v>549.32499999999982</c:v>
                </c:pt>
                <c:pt idx="904">
                  <c:v>549.93299999999977</c:v>
                </c:pt>
                <c:pt idx="905">
                  <c:v>550.5419999999998</c:v>
                </c:pt>
                <c:pt idx="906">
                  <c:v>551.15</c:v>
                </c:pt>
                <c:pt idx="907">
                  <c:v>551.75800000000004</c:v>
                </c:pt>
                <c:pt idx="908">
                  <c:v>552.36699999999962</c:v>
                </c:pt>
                <c:pt idx="909">
                  <c:v>552.97500000000002</c:v>
                </c:pt>
                <c:pt idx="910">
                  <c:v>553.58299999999997</c:v>
                </c:pt>
                <c:pt idx="911">
                  <c:v>554.19200000000001</c:v>
                </c:pt>
                <c:pt idx="912">
                  <c:v>554.79999999999995</c:v>
                </c:pt>
                <c:pt idx="913">
                  <c:v>555.40800000000002</c:v>
                </c:pt>
                <c:pt idx="914">
                  <c:v>556.01699999999983</c:v>
                </c:pt>
                <c:pt idx="915">
                  <c:v>556.625</c:v>
                </c:pt>
                <c:pt idx="916">
                  <c:v>557.23299999999972</c:v>
                </c:pt>
                <c:pt idx="917">
                  <c:v>557.84199999999976</c:v>
                </c:pt>
                <c:pt idx="918">
                  <c:v>558.44999999999982</c:v>
                </c:pt>
                <c:pt idx="919">
                  <c:v>559.05799999999977</c:v>
                </c:pt>
                <c:pt idx="920">
                  <c:v>559.6669999999998</c:v>
                </c:pt>
                <c:pt idx="921">
                  <c:v>560.27499999999998</c:v>
                </c:pt>
                <c:pt idx="922">
                  <c:v>560.88300000000004</c:v>
                </c:pt>
                <c:pt idx="923">
                  <c:v>561.49199999999996</c:v>
                </c:pt>
                <c:pt idx="924">
                  <c:v>562.1</c:v>
                </c:pt>
                <c:pt idx="925">
                  <c:v>562.70799999999997</c:v>
                </c:pt>
                <c:pt idx="926">
                  <c:v>563.31699999999978</c:v>
                </c:pt>
                <c:pt idx="927">
                  <c:v>563.92499999999973</c:v>
                </c:pt>
                <c:pt idx="928">
                  <c:v>564.53300000000002</c:v>
                </c:pt>
                <c:pt idx="929">
                  <c:v>565.14199999999983</c:v>
                </c:pt>
                <c:pt idx="930">
                  <c:v>565.75</c:v>
                </c:pt>
                <c:pt idx="931">
                  <c:v>566.35799999999949</c:v>
                </c:pt>
                <c:pt idx="932">
                  <c:v>566.96699999999976</c:v>
                </c:pt>
                <c:pt idx="933">
                  <c:v>567.57500000000005</c:v>
                </c:pt>
                <c:pt idx="934">
                  <c:v>568.18299999999999</c:v>
                </c:pt>
                <c:pt idx="935">
                  <c:v>568.79200000000003</c:v>
                </c:pt>
                <c:pt idx="936">
                  <c:v>569.4</c:v>
                </c:pt>
                <c:pt idx="937">
                  <c:v>570.00800000000004</c:v>
                </c:pt>
                <c:pt idx="938">
                  <c:v>570.61699999999996</c:v>
                </c:pt>
                <c:pt idx="939">
                  <c:v>571.22500000000002</c:v>
                </c:pt>
                <c:pt idx="940">
                  <c:v>571.83299999999974</c:v>
                </c:pt>
                <c:pt idx="941">
                  <c:v>572.44199999999978</c:v>
                </c:pt>
                <c:pt idx="942">
                  <c:v>573.04999999999973</c:v>
                </c:pt>
                <c:pt idx="943">
                  <c:v>573.65800000000002</c:v>
                </c:pt>
                <c:pt idx="944">
                  <c:v>574.26699999999983</c:v>
                </c:pt>
                <c:pt idx="945">
                  <c:v>574.875</c:v>
                </c:pt>
                <c:pt idx="946">
                  <c:v>575.48299999999972</c:v>
                </c:pt>
                <c:pt idx="947">
                  <c:v>576.09199999999998</c:v>
                </c:pt>
                <c:pt idx="948">
                  <c:v>576.70000000000005</c:v>
                </c:pt>
                <c:pt idx="949">
                  <c:v>577.30799999999977</c:v>
                </c:pt>
                <c:pt idx="950">
                  <c:v>577.9169999999998</c:v>
                </c:pt>
                <c:pt idx="951">
                  <c:v>578.52499999999998</c:v>
                </c:pt>
                <c:pt idx="952">
                  <c:v>579.13300000000004</c:v>
                </c:pt>
                <c:pt idx="953">
                  <c:v>579.74199999999996</c:v>
                </c:pt>
                <c:pt idx="954">
                  <c:v>580.3499999999998</c:v>
                </c:pt>
                <c:pt idx="955">
                  <c:v>580.95799999999974</c:v>
                </c:pt>
                <c:pt idx="956">
                  <c:v>581.56699999999978</c:v>
                </c:pt>
                <c:pt idx="957">
                  <c:v>582.17499999999995</c:v>
                </c:pt>
                <c:pt idx="958">
                  <c:v>582.78300000000002</c:v>
                </c:pt>
                <c:pt idx="959">
                  <c:v>583.39199999999983</c:v>
                </c:pt>
                <c:pt idx="960">
                  <c:v>584</c:v>
                </c:pt>
                <c:pt idx="961">
                  <c:v>584.60799999999972</c:v>
                </c:pt>
                <c:pt idx="962">
                  <c:v>585.21699999999998</c:v>
                </c:pt>
                <c:pt idx="963">
                  <c:v>585.82499999999982</c:v>
                </c:pt>
                <c:pt idx="964">
                  <c:v>586.43299999999977</c:v>
                </c:pt>
                <c:pt idx="965">
                  <c:v>587.0419999999998</c:v>
                </c:pt>
                <c:pt idx="966">
                  <c:v>587.65</c:v>
                </c:pt>
                <c:pt idx="967">
                  <c:v>588.25800000000004</c:v>
                </c:pt>
                <c:pt idx="968">
                  <c:v>588.86699999999962</c:v>
                </c:pt>
                <c:pt idx="969">
                  <c:v>589.47500000000002</c:v>
                </c:pt>
                <c:pt idx="970">
                  <c:v>590.08299999999997</c:v>
                </c:pt>
                <c:pt idx="971">
                  <c:v>590.69200000000001</c:v>
                </c:pt>
                <c:pt idx="972">
                  <c:v>591.29999999999995</c:v>
                </c:pt>
                <c:pt idx="973">
                  <c:v>591.90800000000002</c:v>
                </c:pt>
                <c:pt idx="974">
                  <c:v>592.51699999999983</c:v>
                </c:pt>
                <c:pt idx="975">
                  <c:v>593.125</c:v>
                </c:pt>
                <c:pt idx="976">
                  <c:v>593.73299999999972</c:v>
                </c:pt>
                <c:pt idx="977">
                  <c:v>594.34199999999976</c:v>
                </c:pt>
                <c:pt idx="978">
                  <c:v>594.94999999999982</c:v>
                </c:pt>
                <c:pt idx="979">
                  <c:v>595.55799999999977</c:v>
                </c:pt>
                <c:pt idx="980">
                  <c:v>596.1669999999998</c:v>
                </c:pt>
                <c:pt idx="981">
                  <c:v>596.77499999999998</c:v>
                </c:pt>
                <c:pt idx="982">
                  <c:v>597.38300000000004</c:v>
                </c:pt>
                <c:pt idx="983">
                  <c:v>597.99199999999996</c:v>
                </c:pt>
                <c:pt idx="984">
                  <c:v>598.6</c:v>
                </c:pt>
                <c:pt idx="985">
                  <c:v>599.20799999999997</c:v>
                </c:pt>
                <c:pt idx="986">
                  <c:v>599.81699999999978</c:v>
                </c:pt>
                <c:pt idx="987">
                  <c:v>600.42499999999973</c:v>
                </c:pt>
                <c:pt idx="988">
                  <c:v>601.03300000000002</c:v>
                </c:pt>
                <c:pt idx="989">
                  <c:v>601.64199999999983</c:v>
                </c:pt>
                <c:pt idx="990">
                  <c:v>602.25</c:v>
                </c:pt>
                <c:pt idx="991">
                  <c:v>602.85799999999949</c:v>
                </c:pt>
                <c:pt idx="992">
                  <c:v>603.46699999999976</c:v>
                </c:pt>
                <c:pt idx="993">
                  <c:v>604.07500000000005</c:v>
                </c:pt>
                <c:pt idx="994">
                  <c:v>604.68299999999999</c:v>
                </c:pt>
                <c:pt idx="995">
                  <c:v>605.29200000000003</c:v>
                </c:pt>
                <c:pt idx="996">
                  <c:v>605.9</c:v>
                </c:pt>
                <c:pt idx="997">
                  <c:v>606.50800000000004</c:v>
                </c:pt>
                <c:pt idx="998">
                  <c:v>607.11699999999996</c:v>
                </c:pt>
                <c:pt idx="999">
                  <c:v>607.72500000000002</c:v>
                </c:pt>
                <c:pt idx="1000">
                  <c:v>608.33299999999974</c:v>
                </c:pt>
                <c:pt idx="1001">
                  <c:v>608.94199999999978</c:v>
                </c:pt>
                <c:pt idx="1002">
                  <c:v>609.54999999999973</c:v>
                </c:pt>
                <c:pt idx="1003">
                  <c:v>610.15800000000002</c:v>
                </c:pt>
                <c:pt idx="1004">
                  <c:v>610.76699999999983</c:v>
                </c:pt>
                <c:pt idx="1005">
                  <c:v>611.375</c:v>
                </c:pt>
                <c:pt idx="1006">
                  <c:v>611.98299999999972</c:v>
                </c:pt>
                <c:pt idx="1007">
                  <c:v>612.59199999999998</c:v>
                </c:pt>
                <c:pt idx="1008">
                  <c:v>613.20000000000005</c:v>
                </c:pt>
                <c:pt idx="1009">
                  <c:v>613.80799999999977</c:v>
                </c:pt>
                <c:pt idx="1010">
                  <c:v>614.4169999999998</c:v>
                </c:pt>
                <c:pt idx="1011">
                  <c:v>615.02499999999998</c:v>
                </c:pt>
                <c:pt idx="1012">
                  <c:v>615.63300000000004</c:v>
                </c:pt>
                <c:pt idx="1013">
                  <c:v>616.24199999999996</c:v>
                </c:pt>
                <c:pt idx="1014">
                  <c:v>616.8499999999998</c:v>
                </c:pt>
                <c:pt idx="1015">
                  <c:v>617.45799999999974</c:v>
                </c:pt>
                <c:pt idx="1016">
                  <c:v>618.06699999999978</c:v>
                </c:pt>
                <c:pt idx="1017">
                  <c:v>618.67499999999995</c:v>
                </c:pt>
                <c:pt idx="1018">
                  <c:v>619.28300000000002</c:v>
                </c:pt>
                <c:pt idx="1019">
                  <c:v>619.89199999999983</c:v>
                </c:pt>
                <c:pt idx="1020">
                  <c:v>620.5</c:v>
                </c:pt>
                <c:pt idx="1021">
                  <c:v>621.10799999999972</c:v>
                </c:pt>
                <c:pt idx="1022">
                  <c:v>621.71699999999998</c:v>
                </c:pt>
                <c:pt idx="1023">
                  <c:v>622.32499999999982</c:v>
                </c:pt>
                <c:pt idx="1024">
                  <c:v>622.93299999999977</c:v>
                </c:pt>
                <c:pt idx="1025">
                  <c:v>623.5419999999998</c:v>
                </c:pt>
                <c:pt idx="1026">
                  <c:v>624.15</c:v>
                </c:pt>
                <c:pt idx="1027">
                  <c:v>624.75800000000004</c:v>
                </c:pt>
                <c:pt idx="1028">
                  <c:v>625.36699999999962</c:v>
                </c:pt>
                <c:pt idx="1029">
                  <c:v>625.97500000000002</c:v>
                </c:pt>
                <c:pt idx="1030">
                  <c:v>626.58299999999997</c:v>
                </c:pt>
                <c:pt idx="1031">
                  <c:v>627.19200000000001</c:v>
                </c:pt>
                <c:pt idx="1032">
                  <c:v>627.79999999999995</c:v>
                </c:pt>
                <c:pt idx="1033">
                  <c:v>628.40800000000002</c:v>
                </c:pt>
                <c:pt idx="1034">
                  <c:v>629.01699999999983</c:v>
                </c:pt>
                <c:pt idx="1035">
                  <c:v>629.625</c:v>
                </c:pt>
                <c:pt idx="1036">
                  <c:v>630.23299999999972</c:v>
                </c:pt>
                <c:pt idx="1037">
                  <c:v>630.84199999999976</c:v>
                </c:pt>
                <c:pt idx="1038">
                  <c:v>631.44999999999982</c:v>
                </c:pt>
                <c:pt idx="1039">
                  <c:v>632.05799999999977</c:v>
                </c:pt>
                <c:pt idx="1040">
                  <c:v>632.6669999999998</c:v>
                </c:pt>
                <c:pt idx="1041">
                  <c:v>633.27499999999998</c:v>
                </c:pt>
                <c:pt idx="1042">
                  <c:v>633.88300000000004</c:v>
                </c:pt>
                <c:pt idx="1043">
                  <c:v>634.49199999999996</c:v>
                </c:pt>
                <c:pt idx="1044">
                  <c:v>635.1</c:v>
                </c:pt>
                <c:pt idx="1045">
                  <c:v>635.70799999999997</c:v>
                </c:pt>
                <c:pt idx="1046">
                  <c:v>636.31699999999978</c:v>
                </c:pt>
                <c:pt idx="1047">
                  <c:v>636.92499999999973</c:v>
                </c:pt>
                <c:pt idx="1048">
                  <c:v>637.53300000000002</c:v>
                </c:pt>
                <c:pt idx="1049">
                  <c:v>638.14199999999983</c:v>
                </c:pt>
                <c:pt idx="1050">
                  <c:v>638.75</c:v>
                </c:pt>
                <c:pt idx="1051">
                  <c:v>639.35799999999949</c:v>
                </c:pt>
                <c:pt idx="1052">
                  <c:v>639.96699999999976</c:v>
                </c:pt>
                <c:pt idx="1053">
                  <c:v>640.57500000000005</c:v>
                </c:pt>
                <c:pt idx="1054">
                  <c:v>641.18299999999999</c:v>
                </c:pt>
                <c:pt idx="1055">
                  <c:v>641.79200000000003</c:v>
                </c:pt>
                <c:pt idx="1056">
                  <c:v>642.4</c:v>
                </c:pt>
                <c:pt idx="1057">
                  <c:v>643.00800000000004</c:v>
                </c:pt>
                <c:pt idx="1058">
                  <c:v>643.61699999999996</c:v>
                </c:pt>
                <c:pt idx="1059">
                  <c:v>644.22500000000002</c:v>
                </c:pt>
                <c:pt idx="1060">
                  <c:v>644.83299999999974</c:v>
                </c:pt>
                <c:pt idx="1061">
                  <c:v>645.44199999999978</c:v>
                </c:pt>
                <c:pt idx="1062">
                  <c:v>646.04999999999973</c:v>
                </c:pt>
                <c:pt idx="1063">
                  <c:v>646.65800000000002</c:v>
                </c:pt>
                <c:pt idx="1064">
                  <c:v>647.26699999999983</c:v>
                </c:pt>
                <c:pt idx="1065">
                  <c:v>647.875</c:v>
                </c:pt>
                <c:pt idx="1066">
                  <c:v>648.48299999999972</c:v>
                </c:pt>
                <c:pt idx="1067">
                  <c:v>649.09199999999998</c:v>
                </c:pt>
                <c:pt idx="1068">
                  <c:v>649.70000000000005</c:v>
                </c:pt>
                <c:pt idx="1069">
                  <c:v>650.30799999999977</c:v>
                </c:pt>
                <c:pt idx="1070">
                  <c:v>650.9169999999998</c:v>
                </c:pt>
                <c:pt idx="1071">
                  <c:v>651.52499999999998</c:v>
                </c:pt>
                <c:pt idx="1072">
                  <c:v>652.13300000000004</c:v>
                </c:pt>
                <c:pt idx="1073">
                  <c:v>652.74199999999996</c:v>
                </c:pt>
                <c:pt idx="1074">
                  <c:v>653.3499999999998</c:v>
                </c:pt>
                <c:pt idx="1075">
                  <c:v>653.95799999999974</c:v>
                </c:pt>
                <c:pt idx="1076">
                  <c:v>654.56699999999978</c:v>
                </c:pt>
                <c:pt idx="1077">
                  <c:v>655.17499999999995</c:v>
                </c:pt>
                <c:pt idx="1078">
                  <c:v>655.78300000000002</c:v>
                </c:pt>
                <c:pt idx="1079">
                  <c:v>656.39199999999983</c:v>
                </c:pt>
                <c:pt idx="1080">
                  <c:v>657</c:v>
                </c:pt>
                <c:pt idx="1081">
                  <c:v>657.60799999999972</c:v>
                </c:pt>
                <c:pt idx="1082">
                  <c:v>658.21699999999998</c:v>
                </c:pt>
                <c:pt idx="1083">
                  <c:v>658.82499999999982</c:v>
                </c:pt>
                <c:pt idx="1084">
                  <c:v>659.43299999999977</c:v>
                </c:pt>
                <c:pt idx="1085">
                  <c:v>660.0419999999998</c:v>
                </c:pt>
                <c:pt idx="1086">
                  <c:v>660.65</c:v>
                </c:pt>
                <c:pt idx="1087">
                  <c:v>661.25800000000004</c:v>
                </c:pt>
                <c:pt idx="1088">
                  <c:v>661.86699999999962</c:v>
                </c:pt>
                <c:pt idx="1089">
                  <c:v>662.47500000000002</c:v>
                </c:pt>
                <c:pt idx="1090">
                  <c:v>663.08299999999997</c:v>
                </c:pt>
                <c:pt idx="1091">
                  <c:v>663.69200000000001</c:v>
                </c:pt>
                <c:pt idx="1092">
                  <c:v>664.3</c:v>
                </c:pt>
                <c:pt idx="1093">
                  <c:v>664.90800000000002</c:v>
                </c:pt>
                <c:pt idx="1094">
                  <c:v>665.51699999999983</c:v>
                </c:pt>
                <c:pt idx="1095">
                  <c:v>666.125</c:v>
                </c:pt>
                <c:pt idx="1096">
                  <c:v>666.73299999999972</c:v>
                </c:pt>
                <c:pt idx="1097">
                  <c:v>667.34199999999976</c:v>
                </c:pt>
                <c:pt idx="1098">
                  <c:v>667.94999999999982</c:v>
                </c:pt>
                <c:pt idx="1099">
                  <c:v>668.55799999999977</c:v>
                </c:pt>
                <c:pt idx="1100">
                  <c:v>669.1669999999998</c:v>
                </c:pt>
                <c:pt idx="1101">
                  <c:v>669.77499999999998</c:v>
                </c:pt>
                <c:pt idx="1102">
                  <c:v>670.38300000000004</c:v>
                </c:pt>
                <c:pt idx="1103">
                  <c:v>670.99199999999996</c:v>
                </c:pt>
                <c:pt idx="1104">
                  <c:v>671.6</c:v>
                </c:pt>
                <c:pt idx="1105">
                  <c:v>672.20799999999997</c:v>
                </c:pt>
                <c:pt idx="1106">
                  <c:v>672.81699999999978</c:v>
                </c:pt>
                <c:pt idx="1107">
                  <c:v>673.42499999999973</c:v>
                </c:pt>
                <c:pt idx="1108">
                  <c:v>674.03300000000002</c:v>
                </c:pt>
                <c:pt idx="1109">
                  <c:v>674.64199999999983</c:v>
                </c:pt>
                <c:pt idx="1110">
                  <c:v>675.25</c:v>
                </c:pt>
                <c:pt idx="1111">
                  <c:v>675.85799999999949</c:v>
                </c:pt>
                <c:pt idx="1112">
                  <c:v>676.46699999999976</c:v>
                </c:pt>
                <c:pt idx="1113">
                  <c:v>677.07500000000005</c:v>
                </c:pt>
                <c:pt idx="1114">
                  <c:v>677.68299999999999</c:v>
                </c:pt>
                <c:pt idx="1115">
                  <c:v>678.29200000000003</c:v>
                </c:pt>
                <c:pt idx="1116">
                  <c:v>678.9</c:v>
                </c:pt>
                <c:pt idx="1117">
                  <c:v>679.50800000000004</c:v>
                </c:pt>
                <c:pt idx="1118">
                  <c:v>680.11699999999996</c:v>
                </c:pt>
                <c:pt idx="1119">
                  <c:v>680.72500000000002</c:v>
                </c:pt>
                <c:pt idx="1120">
                  <c:v>681.33299999999974</c:v>
                </c:pt>
                <c:pt idx="1121">
                  <c:v>681.94199999999978</c:v>
                </c:pt>
                <c:pt idx="1122">
                  <c:v>682.55</c:v>
                </c:pt>
                <c:pt idx="1123">
                  <c:v>683.15800000000002</c:v>
                </c:pt>
                <c:pt idx="1124">
                  <c:v>683.76699999999983</c:v>
                </c:pt>
                <c:pt idx="1125">
                  <c:v>684.375</c:v>
                </c:pt>
                <c:pt idx="1126">
                  <c:v>684.98299999999972</c:v>
                </c:pt>
                <c:pt idx="1127">
                  <c:v>685.59199999999998</c:v>
                </c:pt>
                <c:pt idx="1128">
                  <c:v>686.2</c:v>
                </c:pt>
                <c:pt idx="1129">
                  <c:v>686.80799999999977</c:v>
                </c:pt>
                <c:pt idx="1130">
                  <c:v>687.4169999999998</c:v>
                </c:pt>
                <c:pt idx="1131">
                  <c:v>688.02499999999998</c:v>
                </c:pt>
                <c:pt idx="1132">
                  <c:v>688.63300000000004</c:v>
                </c:pt>
                <c:pt idx="1133">
                  <c:v>689.24199999999996</c:v>
                </c:pt>
                <c:pt idx="1134">
                  <c:v>689.8499999999998</c:v>
                </c:pt>
                <c:pt idx="1135">
                  <c:v>690.45799999999974</c:v>
                </c:pt>
                <c:pt idx="1136">
                  <c:v>691.06699999999978</c:v>
                </c:pt>
                <c:pt idx="1137">
                  <c:v>691.67499999999995</c:v>
                </c:pt>
                <c:pt idx="1138">
                  <c:v>692.28300000000002</c:v>
                </c:pt>
                <c:pt idx="1139">
                  <c:v>692.89199999999983</c:v>
                </c:pt>
                <c:pt idx="1140">
                  <c:v>693.5</c:v>
                </c:pt>
                <c:pt idx="1141">
                  <c:v>694.10799999999972</c:v>
                </c:pt>
                <c:pt idx="1142">
                  <c:v>694.71699999999998</c:v>
                </c:pt>
                <c:pt idx="1143">
                  <c:v>695.32499999999982</c:v>
                </c:pt>
                <c:pt idx="1144">
                  <c:v>695.93299999999977</c:v>
                </c:pt>
                <c:pt idx="1145">
                  <c:v>696.5419999999998</c:v>
                </c:pt>
                <c:pt idx="1146">
                  <c:v>697.15</c:v>
                </c:pt>
                <c:pt idx="1147">
                  <c:v>697.75800000000004</c:v>
                </c:pt>
                <c:pt idx="1148">
                  <c:v>698.36699999999962</c:v>
                </c:pt>
                <c:pt idx="1149">
                  <c:v>698.97500000000002</c:v>
                </c:pt>
                <c:pt idx="1150">
                  <c:v>699.58299999999997</c:v>
                </c:pt>
                <c:pt idx="1151">
                  <c:v>700.19200000000001</c:v>
                </c:pt>
                <c:pt idx="1152">
                  <c:v>700.8</c:v>
                </c:pt>
                <c:pt idx="1153">
                  <c:v>701.40800000000002</c:v>
                </c:pt>
                <c:pt idx="1154">
                  <c:v>702.01699999999983</c:v>
                </c:pt>
                <c:pt idx="1155">
                  <c:v>702.625</c:v>
                </c:pt>
                <c:pt idx="1156">
                  <c:v>703.23299999999972</c:v>
                </c:pt>
                <c:pt idx="1157">
                  <c:v>703.84199999999976</c:v>
                </c:pt>
                <c:pt idx="1158">
                  <c:v>704.44999999999982</c:v>
                </c:pt>
                <c:pt idx="1159">
                  <c:v>705.05799999999977</c:v>
                </c:pt>
                <c:pt idx="1160">
                  <c:v>705.6669999999998</c:v>
                </c:pt>
                <c:pt idx="1161">
                  <c:v>706.27499999999998</c:v>
                </c:pt>
                <c:pt idx="1162">
                  <c:v>706.88300000000004</c:v>
                </c:pt>
                <c:pt idx="1163">
                  <c:v>707.49199999999996</c:v>
                </c:pt>
                <c:pt idx="1164">
                  <c:v>708.1</c:v>
                </c:pt>
                <c:pt idx="1165">
                  <c:v>708.70799999999997</c:v>
                </c:pt>
                <c:pt idx="1166">
                  <c:v>709.31699999999978</c:v>
                </c:pt>
                <c:pt idx="1167">
                  <c:v>709.92499999999973</c:v>
                </c:pt>
                <c:pt idx="1168">
                  <c:v>710.53300000000002</c:v>
                </c:pt>
                <c:pt idx="1169">
                  <c:v>711.14199999999983</c:v>
                </c:pt>
                <c:pt idx="1170">
                  <c:v>711.75</c:v>
                </c:pt>
                <c:pt idx="1171">
                  <c:v>712.35799999999949</c:v>
                </c:pt>
                <c:pt idx="1172">
                  <c:v>712.96699999999976</c:v>
                </c:pt>
                <c:pt idx="1173">
                  <c:v>713.57500000000005</c:v>
                </c:pt>
                <c:pt idx="1174">
                  <c:v>714.18299999999999</c:v>
                </c:pt>
                <c:pt idx="1175">
                  <c:v>714.79200000000003</c:v>
                </c:pt>
                <c:pt idx="1176">
                  <c:v>715.4</c:v>
                </c:pt>
                <c:pt idx="1177">
                  <c:v>716.00800000000004</c:v>
                </c:pt>
                <c:pt idx="1178">
                  <c:v>716.61699999999996</c:v>
                </c:pt>
                <c:pt idx="1179">
                  <c:v>717.22500000000002</c:v>
                </c:pt>
                <c:pt idx="1180">
                  <c:v>717.83299999999974</c:v>
                </c:pt>
                <c:pt idx="1181">
                  <c:v>718.44199999999978</c:v>
                </c:pt>
                <c:pt idx="1182">
                  <c:v>719.05</c:v>
                </c:pt>
                <c:pt idx="1183">
                  <c:v>719.65800000000002</c:v>
                </c:pt>
                <c:pt idx="1184">
                  <c:v>720.26699999999983</c:v>
                </c:pt>
                <c:pt idx="1185">
                  <c:v>720.875</c:v>
                </c:pt>
                <c:pt idx="1186">
                  <c:v>721.48299999999972</c:v>
                </c:pt>
                <c:pt idx="1187">
                  <c:v>722.09199999999998</c:v>
                </c:pt>
                <c:pt idx="1188">
                  <c:v>722.7</c:v>
                </c:pt>
                <c:pt idx="1189">
                  <c:v>723.30799999999977</c:v>
                </c:pt>
                <c:pt idx="1190">
                  <c:v>723.9169999999998</c:v>
                </c:pt>
                <c:pt idx="1191">
                  <c:v>724.52499999999998</c:v>
                </c:pt>
                <c:pt idx="1192">
                  <c:v>725.13300000000004</c:v>
                </c:pt>
                <c:pt idx="1193">
                  <c:v>725.74199999999996</c:v>
                </c:pt>
                <c:pt idx="1194">
                  <c:v>726.3499999999998</c:v>
                </c:pt>
                <c:pt idx="1195">
                  <c:v>726.95799999999974</c:v>
                </c:pt>
                <c:pt idx="1196">
                  <c:v>727.56699999999978</c:v>
                </c:pt>
                <c:pt idx="1197">
                  <c:v>728.17499999999995</c:v>
                </c:pt>
                <c:pt idx="1198">
                  <c:v>728.78300000000002</c:v>
                </c:pt>
                <c:pt idx="1199">
                  <c:v>729.39199999999983</c:v>
                </c:pt>
                <c:pt idx="1200">
                  <c:v>730</c:v>
                </c:pt>
                <c:pt idx="1201">
                  <c:v>730.60799999999972</c:v>
                </c:pt>
                <c:pt idx="1202">
                  <c:v>731.21699999999998</c:v>
                </c:pt>
                <c:pt idx="1203">
                  <c:v>731.82499999999982</c:v>
                </c:pt>
                <c:pt idx="1204">
                  <c:v>732.43299999999977</c:v>
                </c:pt>
                <c:pt idx="1205">
                  <c:v>733.0419999999998</c:v>
                </c:pt>
                <c:pt idx="1206">
                  <c:v>733.65</c:v>
                </c:pt>
                <c:pt idx="1207">
                  <c:v>734.25800000000004</c:v>
                </c:pt>
                <c:pt idx="1208">
                  <c:v>734.86699999999962</c:v>
                </c:pt>
                <c:pt idx="1209">
                  <c:v>735.47500000000002</c:v>
                </c:pt>
                <c:pt idx="1210">
                  <c:v>736.08299999999997</c:v>
                </c:pt>
                <c:pt idx="1211">
                  <c:v>736.69200000000001</c:v>
                </c:pt>
                <c:pt idx="1212">
                  <c:v>737.3</c:v>
                </c:pt>
                <c:pt idx="1213">
                  <c:v>737.90800000000002</c:v>
                </c:pt>
                <c:pt idx="1214">
                  <c:v>738.51699999999983</c:v>
                </c:pt>
                <c:pt idx="1215">
                  <c:v>739.125</c:v>
                </c:pt>
                <c:pt idx="1216">
                  <c:v>739.73299999999972</c:v>
                </c:pt>
                <c:pt idx="1217">
                  <c:v>740.34199999999976</c:v>
                </c:pt>
                <c:pt idx="1218">
                  <c:v>740.94999999999982</c:v>
                </c:pt>
                <c:pt idx="1219">
                  <c:v>741.55799999999977</c:v>
                </c:pt>
                <c:pt idx="1220">
                  <c:v>742.1669999999998</c:v>
                </c:pt>
                <c:pt idx="1221">
                  <c:v>742.77499999999998</c:v>
                </c:pt>
                <c:pt idx="1222">
                  <c:v>743.38300000000004</c:v>
                </c:pt>
                <c:pt idx="1223">
                  <c:v>743.99199999999996</c:v>
                </c:pt>
                <c:pt idx="1224">
                  <c:v>744.6</c:v>
                </c:pt>
                <c:pt idx="1225">
                  <c:v>745.20799999999997</c:v>
                </c:pt>
                <c:pt idx="1226">
                  <c:v>745.81699999999978</c:v>
                </c:pt>
                <c:pt idx="1227">
                  <c:v>746.42499999999973</c:v>
                </c:pt>
                <c:pt idx="1228">
                  <c:v>747.03300000000002</c:v>
                </c:pt>
                <c:pt idx="1229">
                  <c:v>747.64199999999983</c:v>
                </c:pt>
                <c:pt idx="1230">
                  <c:v>748.25</c:v>
                </c:pt>
                <c:pt idx="1231">
                  <c:v>748.85799999999949</c:v>
                </c:pt>
                <c:pt idx="1232">
                  <c:v>749.46699999999976</c:v>
                </c:pt>
                <c:pt idx="1233">
                  <c:v>750.07500000000005</c:v>
                </c:pt>
                <c:pt idx="1234">
                  <c:v>750.68299999999999</c:v>
                </c:pt>
                <c:pt idx="1235">
                  <c:v>751.29200000000003</c:v>
                </c:pt>
                <c:pt idx="1236">
                  <c:v>751.9</c:v>
                </c:pt>
                <c:pt idx="1237">
                  <c:v>752.50800000000004</c:v>
                </c:pt>
                <c:pt idx="1238">
                  <c:v>753.11699999999996</c:v>
                </c:pt>
                <c:pt idx="1239">
                  <c:v>753.72500000000002</c:v>
                </c:pt>
                <c:pt idx="1240">
                  <c:v>754.33299999999974</c:v>
                </c:pt>
                <c:pt idx="1241">
                  <c:v>754.94199999999978</c:v>
                </c:pt>
                <c:pt idx="1242">
                  <c:v>755.55</c:v>
                </c:pt>
                <c:pt idx="1243">
                  <c:v>756.15800000000002</c:v>
                </c:pt>
                <c:pt idx="1244">
                  <c:v>756.76699999999983</c:v>
                </c:pt>
                <c:pt idx="1245">
                  <c:v>757.375</c:v>
                </c:pt>
                <c:pt idx="1246">
                  <c:v>757.98299999999972</c:v>
                </c:pt>
                <c:pt idx="1247">
                  <c:v>758.59199999999998</c:v>
                </c:pt>
                <c:pt idx="1248">
                  <c:v>759.2</c:v>
                </c:pt>
                <c:pt idx="1249">
                  <c:v>759.80799999999977</c:v>
                </c:pt>
                <c:pt idx="1250">
                  <c:v>760.4169999999998</c:v>
                </c:pt>
                <c:pt idx="1251">
                  <c:v>761.02499999999998</c:v>
                </c:pt>
                <c:pt idx="1252">
                  <c:v>761.63300000000004</c:v>
                </c:pt>
                <c:pt idx="1253">
                  <c:v>762.24199999999996</c:v>
                </c:pt>
                <c:pt idx="1254">
                  <c:v>762.8499999999998</c:v>
                </c:pt>
                <c:pt idx="1255">
                  <c:v>763.45799999999974</c:v>
                </c:pt>
                <c:pt idx="1256">
                  <c:v>764.06699999999978</c:v>
                </c:pt>
                <c:pt idx="1257">
                  <c:v>764.67499999999995</c:v>
                </c:pt>
                <c:pt idx="1258">
                  <c:v>765.28300000000002</c:v>
                </c:pt>
                <c:pt idx="1259">
                  <c:v>765.89199999999983</c:v>
                </c:pt>
                <c:pt idx="1260">
                  <c:v>766.5</c:v>
                </c:pt>
                <c:pt idx="1261">
                  <c:v>767.10799999999972</c:v>
                </c:pt>
                <c:pt idx="1262">
                  <c:v>767.71699999999998</c:v>
                </c:pt>
                <c:pt idx="1263">
                  <c:v>768.32499999999982</c:v>
                </c:pt>
                <c:pt idx="1264">
                  <c:v>768.93299999999977</c:v>
                </c:pt>
                <c:pt idx="1265">
                  <c:v>769.5419999999998</c:v>
                </c:pt>
                <c:pt idx="1266">
                  <c:v>770.15</c:v>
                </c:pt>
                <c:pt idx="1267">
                  <c:v>770.75800000000004</c:v>
                </c:pt>
                <c:pt idx="1268">
                  <c:v>771.36699999999962</c:v>
                </c:pt>
                <c:pt idx="1269">
                  <c:v>771.97500000000002</c:v>
                </c:pt>
                <c:pt idx="1270">
                  <c:v>772.58299999999997</c:v>
                </c:pt>
                <c:pt idx="1271">
                  <c:v>773.19200000000001</c:v>
                </c:pt>
                <c:pt idx="1272">
                  <c:v>773.8</c:v>
                </c:pt>
                <c:pt idx="1273">
                  <c:v>774.40800000000002</c:v>
                </c:pt>
                <c:pt idx="1274">
                  <c:v>775.01699999999983</c:v>
                </c:pt>
                <c:pt idx="1275">
                  <c:v>775.625</c:v>
                </c:pt>
                <c:pt idx="1276">
                  <c:v>776.23299999999972</c:v>
                </c:pt>
                <c:pt idx="1277">
                  <c:v>776.84199999999976</c:v>
                </c:pt>
                <c:pt idx="1278">
                  <c:v>777.44999999999982</c:v>
                </c:pt>
                <c:pt idx="1279">
                  <c:v>778.05799999999977</c:v>
                </c:pt>
                <c:pt idx="1280">
                  <c:v>778.6669999999998</c:v>
                </c:pt>
                <c:pt idx="1281">
                  <c:v>779.27499999999998</c:v>
                </c:pt>
                <c:pt idx="1282">
                  <c:v>779.88300000000004</c:v>
                </c:pt>
                <c:pt idx="1283">
                  <c:v>780.49199999999996</c:v>
                </c:pt>
                <c:pt idx="1284">
                  <c:v>781.1</c:v>
                </c:pt>
                <c:pt idx="1285">
                  <c:v>781.70799999999997</c:v>
                </c:pt>
                <c:pt idx="1286">
                  <c:v>782.31699999999978</c:v>
                </c:pt>
                <c:pt idx="1287">
                  <c:v>782.92499999999973</c:v>
                </c:pt>
                <c:pt idx="1288">
                  <c:v>783.53300000000002</c:v>
                </c:pt>
                <c:pt idx="1289">
                  <c:v>784.14199999999983</c:v>
                </c:pt>
                <c:pt idx="1290">
                  <c:v>784.75</c:v>
                </c:pt>
                <c:pt idx="1291">
                  <c:v>785.35799999999949</c:v>
                </c:pt>
                <c:pt idx="1292">
                  <c:v>785.96699999999976</c:v>
                </c:pt>
                <c:pt idx="1293">
                  <c:v>786.57500000000005</c:v>
                </c:pt>
                <c:pt idx="1294">
                  <c:v>787.18299999999999</c:v>
                </c:pt>
                <c:pt idx="1295">
                  <c:v>787.79200000000003</c:v>
                </c:pt>
                <c:pt idx="1296">
                  <c:v>788.4</c:v>
                </c:pt>
                <c:pt idx="1297">
                  <c:v>789.00800000000004</c:v>
                </c:pt>
                <c:pt idx="1298">
                  <c:v>789.61699999999996</c:v>
                </c:pt>
                <c:pt idx="1299">
                  <c:v>790.22500000000002</c:v>
                </c:pt>
                <c:pt idx="1300">
                  <c:v>790.83299999999974</c:v>
                </c:pt>
                <c:pt idx="1301">
                  <c:v>791.44199999999978</c:v>
                </c:pt>
                <c:pt idx="1302">
                  <c:v>792.05</c:v>
                </c:pt>
                <c:pt idx="1303">
                  <c:v>792.65800000000002</c:v>
                </c:pt>
                <c:pt idx="1304">
                  <c:v>793.26699999999983</c:v>
                </c:pt>
                <c:pt idx="1305">
                  <c:v>793.875</c:v>
                </c:pt>
                <c:pt idx="1306">
                  <c:v>794.48299999999972</c:v>
                </c:pt>
                <c:pt idx="1307">
                  <c:v>795.09199999999998</c:v>
                </c:pt>
                <c:pt idx="1308">
                  <c:v>795.7</c:v>
                </c:pt>
                <c:pt idx="1309">
                  <c:v>796.30799999999977</c:v>
                </c:pt>
                <c:pt idx="1310">
                  <c:v>796.9169999999998</c:v>
                </c:pt>
                <c:pt idx="1311">
                  <c:v>797.52499999999998</c:v>
                </c:pt>
                <c:pt idx="1312">
                  <c:v>798.13300000000004</c:v>
                </c:pt>
                <c:pt idx="1313">
                  <c:v>798.74199999999996</c:v>
                </c:pt>
                <c:pt idx="1314">
                  <c:v>799.3499999999998</c:v>
                </c:pt>
                <c:pt idx="1315">
                  <c:v>799.95799999999974</c:v>
                </c:pt>
                <c:pt idx="1316">
                  <c:v>800.56699999999978</c:v>
                </c:pt>
                <c:pt idx="1317">
                  <c:v>801.17499999999995</c:v>
                </c:pt>
                <c:pt idx="1318">
                  <c:v>801.78300000000002</c:v>
                </c:pt>
                <c:pt idx="1319">
                  <c:v>802.39199999999983</c:v>
                </c:pt>
                <c:pt idx="1320">
                  <c:v>803</c:v>
                </c:pt>
                <c:pt idx="1321">
                  <c:v>803.60799999999972</c:v>
                </c:pt>
                <c:pt idx="1322">
                  <c:v>804.21699999999998</c:v>
                </c:pt>
                <c:pt idx="1323">
                  <c:v>804.82499999999982</c:v>
                </c:pt>
                <c:pt idx="1324">
                  <c:v>805.43299999999977</c:v>
                </c:pt>
                <c:pt idx="1325">
                  <c:v>806.0419999999998</c:v>
                </c:pt>
                <c:pt idx="1326">
                  <c:v>806.65</c:v>
                </c:pt>
                <c:pt idx="1327">
                  <c:v>807.25800000000004</c:v>
                </c:pt>
                <c:pt idx="1328">
                  <c:v>807.86699999999962</c:v>
                </c:pt>
                <c:pt idx="1329">
                  <c:v>808.47500000000002</c:v>
                </c:pt>
                <c:pt idx="1330">
                  <c:v>809.08299999999997</c:v>
                </c:pt>
                <c:pt idx="1331">
                  <c:v>809.69200000000001</c:v>
                </c:pt>
                <c:pt idx="1332">
                  <c:v>810.3</c:v>
                </c:pt>
                <c:pt idx="1333">
                  <c:v>810.90800000000002</c:v>
                </c:pt>
                <c:pt idx="1334">
                  <c:v>811.51699999999983</c:v>
                </c:pt>
                <c:pt idx="1335">
                  <c:v>812.125</c:v>
                </c:pt>
                <c:pt idx="1336">
                  <c:v>812.73299999999972</c:v>
                </c:pt>
                <c:pt idx="1337">
                  <c:v>813.34199999999976</c:v>
                </c:pt>
                <c:pt idx="1338">
                  <c:v>813.94999999999982</c:v>
                </c:pt>
                <c:pt idx="1339">
                  <c:v>814.55799999999977</c:v>
                </c:pt>
                <c:pt idx="1340">
                  <c:v>815.1669999999998</c:v>
                </c:pt>
                <c:pt idx="1341">
                  <c:v>815.77499999999998</c:v>
                </c:pt>
                <c:pt idx="1342">
                  <c:v>816.38300000000004</c:v>
                </c:pt>
                <c:pt idx="1343">
                  <c:v>816.99199999999996</c:v>
                </c:pt>
                <c:pt idx="1344">
                  <c:v>817.6</c:v>
                </c:pt>
                <c:pt idx="1345">
                  <c:v>818.20799999999997</c:v>
                </c:pt>
                <c:pt idx="1346">
                  <c:v>818.81699999999978</c:v>
                </c:pt>
                <c:pt idx="1347">
                  <c:v>819.42499999999973</c:v>
                </c:pt>
                <c:pt idx="1348">
                  <c:v>820.03300000000002</c:v>
                </c:pt>
                <c:pt idx="1349">
                  <c:v>820.64199999999983</c:v>
                </c:pt>
                <c:pt idx="1350">
                  <c:v>821.25</c:v>
                </c:pt>
                <c:pt idx="1351">
                  <c:v>821.85799999999949</c:v>
                </c:pt>
                <c:pt idx="1352">
                  <c:v>822.46699999999976</c:v>
                </c:pt>
                <c:pt idx="1353">
                  <c:v>823.07500000000005</c:v>
                </c:pt>
                <c:pt idx="1354">
                  <c:v>823.68299999999999</c:v>
                </c:pt>
                <c:pt idx="1355">
                  <c:v>824.29200000000003</c:v>
                </c:pt>
                <c:pt idx="1356">
                  <c:v>824.9</c:v>
                </c:pt>
                <c:pt idx="1357">
                  <c:v>825.50800000000004</c:v>
                </c:pt>
                <c:pt idx="1358">
                  <c:v>826.11699999999996</c:v>
                </c:pt>
                <c:pt idx="1359">
                  <c:v>826.72500000000002</c:v>
                </c:pt>
                <c:pt idx="1360">
                  <c:v>827.33299999999974</c:v>
                </c:pt>
                <c:pt idx="1361">
                  <c:v>827.94199999999978</c:v>
                </c:pt>
                <c:pt idx="1362">
                  <c:v>828.55</c:v>
                </c:pt>
                <c:pt idx="1363">
                  <c:v>829.15800000000002</c:v>
                </c:pt>
                <c:pt idx="1364">
                  <c:v>829.76699999999983</c:v>
                </c:pt>
                <c:pt idx="1365">
                  <c:v>830.375</c:v>
                </c:pt>
                <c:pt idx="1366">
                  <c:v>830.98299999999972</c:v>
                </c:pt>
                <c:pt idx="1367">
                  <c:v>831.59199999999998</c:v>
                </c:pt>
                <c:pt idx="1368">
                  <c:v>832.2</c:v>
                </c:pt>
                <c:pt idx="1369">
                  <c:v>832.80799999999977</c:v>
                </c:pt>
                <c:pt idx="1370">
                  <c:v>833.4169999999998</c:v>
                </c:pt>
                <c:pt idx="1371">
                  <c:v>834.02499999999998</c:v>
                </c:pt>
                <c:pt idx="1372">
                  <c:v>834.63300000000004</c:v>
                </c:pt>
                <c:pt idx="1373">
                  <c:v>835.24199999999996</c:v>
                </c:pt>
                <c:pt idx="1374">
                  <c:v>835.8499999999998</c:v>
                </c:pt>
                <c:pt idx="1375">
                  <c:v>836.45799999999974</c:v>
                </c:pt>
                <c:pt idx="1376">
                  <c:v>837.06699999999978</c:v>
                </c:pt>
                <c:pt idx="1377">
                  <c:v>837.67499999999995</c:v>
                </c:pt>
                <c:pt idx="1378">
                  <c:v>838.28300000000002</c:v>
                </c:pt>
                <c:pt idx="1379">
                  <c:v>838.89199999999983</c:v>
                </c:pt>
                <c:pt idx="1380">
                  <c:v>839.5</c:v>
                </c:pt>
                <c:pt idx="1381">
                  <c:v>840.10799999999972</c:v>
                </c:pt>
                <c:pt idx="1382">
                  <c:v>840.71699999999998</c:v>
                </c:pt>
                <c:pt idx="1383">
                  <c:v>841.32499999999982</c:v>
                </c:pt>
                <c:pt idx="1384">
                  <c:v>841.93299999999977</c:v>
                </c:pt>
                <c:pt idx="1385">
                  <c:v>842.5419999999998</c:v>
                </c:pt>
                <c:pt idx="1386">
                  <c:v>843.15</c:v>
                </c:pt>
                <c:pt idx="1387">
                  <c:v>843.75800000000004</c:v>
                </c:pt>
                <c:pt idx="1388">
                  <c:v>844.36699999999962</c:v>
                </c:pt>
                <c:pt idx="1389">
                  <c:v>844.97500000000002</c:v>
                </c:pt>
                <c:pt idx="1390">
                  <c:v>845.58299999999997</c:v>
                </c:pt>
                <c:pt idx="1391">
                  <c:v>846.19200000000001</c:v>
                </c:pt>
                <c:pt idx="1392">
                  <c:v>846.8</c:v>
                </c:pt>
                <c:pt idx="1393">
                  <c:v>847.40800000000002</c:v>
                </c:pt>
                <c:pt idx="1394">
                  <c:v>848.01699999999983</c:v>
                </c:pt>
                <c:pt idx="1395">
                  <c:v>848.625</c:v>
                </c:pt>
                <c:pt idx="1396">
                  <c:v>849.23299999999972</c:v>
                </c:pt>
                <c:pt idx="1397">
                  <c:v>849.84199999999976</c:v>
                </c:pt>
                <c:pt idx="1398">
                  <c:v>850.44999999999982</c:v>
                </c:pt>
                <c:pt idx="1399">
                  <c:v>851.05799999999977</c:v>
                </c:pt>
                <c:pt idx="1400">
                  <c:v>851.6669999999998</c:v>
                </c:pt>
                <c:pt idx="1401">
                  <c:v>852.27499999999998</c:v>
                </c:pt>
                <c:pt idx="1402">
                  <c:v>852.88300000000004</c:v>
                </c:pt>
                <c:pt idx="1403">
                  <c:v>853.49199999999996</c:v>
                </c:pt>
                <c:pt idx="1404">
                  <c:v>854.1</c:v>
                </c:pt>
                <c:pt idx="1405">
                  <c:v>854.70799999999997</c:v>
                </c:pt>
                <c:pt idx="1406">
                  <c:v>855.31699999999978</c:v>
                </c:pt>
                <c:pt idx="1407">
                  <c:v>855.92499999999973</c:v>
                </c:pt>
                <c:pt idx="1408">
                  <c:v>856.53300000000002</c:v>
                </c:pt>
                <c:pt idx="1409">
                  <c:v>857.14199999999983</c:v>
                </c:pt>
                <c:pt idx="1410">
                  <c:v>857.75</c:v>
                </c:pt>
                <c:pt idx="1411">
                  <c:v>858.35799999999949</c:v>
                </c:pt>
                <c:pt idx="1412">
                  <c:v>858.96699999999976</c:v>
                </c:pt>
                <c:pt idx="1413">
                  <c:v>859.57500000000005</c:v>
                </c:pt>
                <c:pt idx="1414">
                  <c:v>860.18299999999999</c:v>
                </c:pt>
                <c:pt idx="1415">
                  <c:v>860.79200000000003</c:v>
                </c:pt>
                <c:pt idx="1416">
                  <c:v>861.4</c:v>
                </c:pt>
                <c:pt idx="1417">
                  <c:v>862.00800000000004</c:v>
                </c:pt>
                <c:pt idx="1418">
                  <c:v>862.61699999999996</c:v>
                </c:pt>
                <c:pt idx="1419">
                  <c:v>863.22500000000002</c:v>
                </c:pt>
                <c:pt idx="1420">
                  <c:v>863.83299999999974</c:v>
                </c:pt>
                <c:pt idx="1421">
                  <c:v>864.44199999999978</c:v>
                </c:pt>
                <c:pt idx="1422">
                  <c:v>865.05</c:v>
                </c:pt>
                <c:pt idx="1423">
                  <c:v>865.65800000000002</c:v>
                </c:pt>
                <c:pt idx="1424">
                  <c:v>866.26699999999983</c:v>
                </c:pt>
                <c:pt idx="1425">
                  <c:v>866.875</c:v>
                </c:pt>
                <c:pt idx="1426">
                  <c:v>867.48299999999972</c:v>
                </c:pt>
                <c:pt idx="1427">
                  <c:v>868.09199999999998</c:v>
                </c:pt>
                <c:pt idx="1428">
                  <c:v>868.7</c:v>
                </c:pt>
                <c:pt idx="1429">
                  <c:v>869.30799999999977</c:v>
                </c:pt>
                <c:pt idx="1430">
                  <c:v>869.9169999999998</c:v>
                </c:pt>
                <c:pt idx="1431">
                  <c:v>870.52499999999998</c:v>
                </c:pt>
                <c:pt idx="1432">
                  <c:v>871.13300000000004</c:v>
                </c:pt>
                <c:pt idx="1433">
                  <c:v>871.74199999999996</c:v>
                </c:pt>
                <c:pt idx="1434">
                  <c:v>872.3499999999998</c:v>
                </c:pt>
                <c:pt idx="1435">
                  <c:v>872.95799999999974</c:v>
                </c:pt>
                <c:pt idx="1436">
                  <c:v>873.56699999999978</c:v>
                </c:pt>
                <c:pt idx="1437">
                  <c:v>874.17499999999995</c:v>
                </c:pt>
                <c:pt idx="1438">
                  <c:v>874.78300000000002</c:v>
                </c:pt>
                <c:pt idx="1439">
                  <c:v>875.39199999999983</c:v>
                </c:pt>
                <c:pt idx="1440">
                  <c:v>876</c:v>
                </c:pt>
                <c:pt idx="1441">
                  <c:v>876.60799999999972</c:v>
                </c:pt>
                <c:pt idx="1442">
                  <c:v>877.21699999999998</c:v>
                </c:pt>
                <c:pt idx="1443">
                  <c:v>877.82499999999982</c:v>
                </c:pt>
                <c:pt idx="1444">
                  <c:v>878.43299999999977</c:v>
                </c:pt>
                <c:pt idx="1445">
                  <c:v>879.0419999999998</c:v>
                </c:pt>
                <c:pt idx="1446">
                  <c:v>879.65</c:v>
                </c:pt>
                <c:pt idx="1447">
                  <c:v>880.25800000000004</c:v>
                </c:pt>
                <c:pt idx="1448">
                  <c:v>880.86699999999962</c:v>
                </c:pt>
                <c:pt idx="1449">
                  <c:v>881.47500000000002</c:v>
                </c:pt>
                <c:pt idx="1450">
                  <c:v>882.08299999999997</c:v>
                </c:pt>
                <c:pt idx="1451">
                  <c:v>882.69200000000001</c:v>
                </c:pt>
                <c:pt idx="1452">
                  <c:v>883.3</c:v>
                </c:pt>
                <c:pt idx="1453">
                  <c:v>883.90800000000002</c:v>
                </c:pt>
                <c:pt idx="1454">
                  <c:v>884.51699999999983</c:v>
                </c:pt>
                <c:pt idx="1455">
                  <c:v>885.125</c:v>
                </c:pt>
                <c:pt idx="1456">
                  <c:v>885.73299999999972</c:v>
                </c:pt>
                <c:pt idx="1457">
                  <c:v>886.34199999999976</c:v>
                </c:pt>
                <c:pt idx="1458">
                  <c:v>886.94999999999982</c:v>
                </c:pt>
                <c:pt idx="1459">
                  <c:v>887.55799999999977</c:v>
                </c:pt>
                <c:pt idx="1460">
                  <c:v>888.1669999999998</c:v>
                </c:pt>
                <c:pt idx="1461">
                  <c:v>888.77499999999998</c:v>
                </c:pt>
                <c:pt idx="1462">
                  <c:v>889.38300000000004</c:v>
                </c:pt>
                <c:pt idx="1463">
                  <c:v>889.99199999999996</c:v>
                </c:pt>
                <c:pt idx="1464">
                  <c:v>890.6</c:v>
                </c:pt>
                <c:pt idx="1465">
                  <c:v>891.20799999999997</c:v>
                </c:pt>
                <c:pt idx="1466">
                  <c:v>891.81699999999978</c:v>
                </c:pt>
                <c:pt idx="1467">
                  <c:v>892.42499999999973</c:v>
                </c:pt>
                <c:pt idx="1468">
                  <c:v>893.03300000000002</c:v>
                </c:pt>
                <c:pt idx="1469">
                  <c:v>893.64199999999983</c:v>
                </c:pt>
                <c:pt idx="1470">
                  <c:v>894.25</c:v>
                </c:pt>
                <c:pt idx="1471">
                  <c:v>894.85799999999949</c:v>
                </c:pt>
                <c:pt idx="1472">
                  <c:v>895.46699999999976</c:v>
                </c:pt>
                <c:pt idx="1473">
                  <c:v>896.07500000000005</c:v>
                </c:pt>
                <c:pt idx="1474">
                  <c:v>896.68299999999999</c:v>
                </c:pt>
                <c:pt idx="1475">
                  <c:v>897.29200000000003</c:v>
                </c:pt>
                <c:pt idx="1476">
                  <c:v>897.9</c:v>
                </c:pt>
                <c:pt idx="1477">
                  <c:v>898.50800000000004</c:v>
                </c:pt>
                <c:pt idx="1478">
                  <c:v>899.11699999999996</c:v>
                </c:pt>
                <c:pt idx="1479">
                  <c:v>899.72500000000002</c:v>
                </c:pt>
                <c:pt idx="1480">
                  <c:v>900.33299999999974</c:v>
                </c:pt>
                <c:pt idx="1481">
                  <c:v>900.94199999999978</c:v>
                </c:pt>
                <c:pt idx="1482">
                  <c:v>901.55</c:v>
                </c:pt>
                <c:pt idx="1483">
                  <c:v>902.15800000000002</c:v>
                </c:pt>
                <c:pt idx="1484">
                  <c:v>902.76699999999983</c:v>
                </c:pt>
                <c:pt idx="1485">
                  <c:v>903.375</c:v>
                </c:pt>
                <c:pt idx="1486">
                  <c:v>903.98299999999972</c:v>
                </c:pt>
                <c:pt idx="1487">
                  <c:v>904.59199999999998</c:v>
                </c:pt>
                <c:pt idx="1488">
                  <c:v>905.2</c:v>
                </c:pt>
                <c:pt idx="1489">
                  <c:v>905.80799999999977</c:v>
                </c:pt>
                <c:pt idx="1490">
                  <c:v>906.4169999999998</c:v>
                </c:pt>
                <c:pt idx="1491">
                  <c:v>907.02499999999998</c:v>
                </c:pt>
                <c:pt idx="1492">
                  <c:v>907.63300000000004</c:v>
                </c:pt>
                <c:pt idx="1493">
                  <c:v>908.24199999999996</c:v>
                </c:pt>
                <c:pt idx="1494">
                  <c:v>908.8499999999998</c:v>
                </c:pt>
                <c:pt idx="1495">
                  <c:v>909.45799999999974</c:v>
                </c:pt>
                <c:pt idx="1496">
                  <c:v>910.06699999999978</c:v>
                </c:pt>
                <c:pt idx="1497">
                  <c:v>910.67499999999995</c:v>
                </c:pt>
                <c:pt idx="1498">
                  <c:v>911.28300000000002</c:v>
                </c:pt>
                <c:pt idx="1499">
                  <c:v>911.89199999999983</c:v>
                </c:pt>
                <c:pt idx="1500">
                  <c:v>912.5</c:v>
                </c:pt>
                <c:pt idx="1501">
                  <c:v>913.10799999999972</c:v>
                </c:pt>
                <c:pt idx="1502">
                  <c:v>913.71699999999998</c:v>
                </c:pt>
                <c:pt idx="1503">
                  <c:v>914.32499999999982</c:v>
                </c:pt>
                <c:pt idx="1504">
                  <c:v>914.93299999999977</c:v>
                </c:pt>
                <c:pt idx="1505">
                  <c:v>915.5419999999998</c:v>
                </c:pt>
                <c:pt idx="1506">
                  <c:v>916.15</c:v>
                </c:pt>
                <c:pt idx="1507">
                  <c:v>916.75800000000004</c:v>
                </c:pt>
                <c:pt idx="1508">
                  <c:v>917.36699999999962</c:v>
                </c:pt>
                <c:pt idx="1509">
                  <c:v>917.97500000000002</c:v>
                </c:pt>
                <c:pt idx="1510">
                  <c:v>918.58299999999997</c:v>
                </c:pt>
                <c:pt idx="1511">
                  <c:v>919.19200000000001</c:v>
                </c:pt>
                <c:pt idx="1512">
                  <c:v>919.8</c:v>
                </c:pt>
                <c:pt idx="1513">
                  <c:v>920.40800000000002</c:v>
                </c:pt>
                <c:pt idx="1514">
                  <c:v>921.01699999999983</c:v>
                </c:pt>
                <c:pt idx="1515">
                  <c:v>921.625</c:v>
                </c:pt>
                <c:pt idx="1516">
                  <c:v>922.23299999999972</c:v>
                </c:pt>
                <c:pt idx="1517">
                  <c:v>922.84199999999976</c:v>
                </c:pt>
                <c:pt idx="1518">
                  <c:v>923.44999999999982</c:v>
                </c:pt>
                <c:pt idx="1519">
                  <c:v>924.05799999999977</c:v>
                </c:pt>
                <c:pt idx="1520">
                  <c:v>924.6669999999998</c:v>
                </c:pt>
                <c:pt idx="1521">
                  <c:v>925.27499999999998</c:v>
                </c:pt>
                <c:pt idx="1522">
                  <c:v>925.88300000000004</c:v>
                </c:pt>
                <c:pt idx="1523">
                  <c:v>926.49199999999996</c:v>
                </c:pt>
                <c:pt idx="1524">
                  <c:v>927.1</c:v>
                </c:pt>
                <c:pt idx="1525">
                  <c:v>927.70799999999997</c:v>
                </c:pt>
                <c:pt idx="1526">
                  <c:v>928.31699999999978</c:v>
                </c:pt>
                <c:pt idx="1527">
                  <c:v>928.92499999999973</c:v>
                </c:pt>
                <c:pt idx="1528">
                  <c:v>929.53300000000002</c:v>
                </c:pt>
                <c:pt idx="1529">
                  <c:v>930.14199999999983</c:v>
                </c:pt>
                <c:pt idx="1530">
                  <c:v>930.75</c:v>
                </c:pt>
                <c:pt idx="1531">
                  <c:v>931.35799999999949</c:v>
                </c:pt>
                <c:pt idx="1532">
                  <c:v>931.96699999999976</c:v>
                </c:pt>
                <c:pt idx="1533">
                  <c:v>932.57500000000005</c:v>
                </c:pt>
                <c:pt idx="1534">
                  <c:v>933.18299999999999</c:v>
                </c:pt>
                <c:pt idx="1535">
                  <c:v>933.79200000000003</c:v>
                </c:pt>
                <c:pt idx="1536">
                  <c:v>934.4</c:v>
                </c:pt>
                <c:pt idx="1537">
                  <c:v>935.00800000000004</c:v>
                </c:pt>
                <c:pt idx="1538">
                  <c:v>935.61699999999996</c:v>
                </c:pt>
                <c:pt idx="1539">
                  <c:v>936.22500000000002</c:v>
                </c:pt>
                <c:pt idx="1540">
                  <c:v>936.83299999999974</c:v>
                </c:pt>
                <c:pt idx="1541">
                  <c:v>937.44199999999978</c:v>
                </c:pt>
                <c:pt idx="1542">
                  <c:v>938.05</c:v>
                </c:pt>
                <c:pt idx="1543">
                  <c:v>938.65800000000002</c:v>
                </c:pt>
                <c:pt idx="1544">
                  <c:v>939.26699999999983</c:v>
                </c:pt>
                <c:pt idx="1545">
                  <c:v>939.875</c:v>
                </c:pt>
                <c:pt idx="1546">
                  <c:v>940.48299999999972</c:v>
                </c:pt>
                <c:pt idx="1547">
                  <c:v>941.09199999999998</c:v>
                </c:pt>
                <c:pt idx="1548">
                  <c:v>941.7</c:v>
                </c:pt>
                <c:pt idx="1549">
                  <c:v>942.30799999999977</c:v>
                </c:pt>
                <c:pt idx="1550">
                  <c:v>942.9169999999998</c:v>
                </c:pt>
                <c:pt idx="1551">
                  <c:v>943.52499999999998</c:v>
                </c:pt>
                <c:pt idx="1552">
                  <c:v>944.13300000000004</c:v>
                </c:pt>
                <c:pt idx="1553">
                  <c:v>944.74199999999996</c:v>
                </c:pt>
                <c:pt idx="1554">
                  <c:v>945.3499999999998</c:v>
                </c:pt>
                <c:pt idx="1555">
                  <c:v>945.95799999999974</c:v>
                </c:pt>
                <c:pt idx="1556">
                  <c:v>946.56699999999978</c:v>
                </c:pt>
                <c:pt idx="1557">
                  <c:v>947.17499999999995</c:v>
                </c:pt>
                <c:pt idx="1558">
                  <c:v>947.78300000000002</c:v>
                </c:pt>
                <c:pt idx="1559">
                  <c:v>948.39199999999983</c:v>
                </c:pt>
                <c:pt idx="1560">
                  <c:v>949</c:v>
                </c:pt>
                <c:pt idx="1561">
                  <c:v>949.60799999999972</c:v>
                </c:pt>
                <c:pt idx="1562">
                  <c:v>950.21699999999998</c:v>
                </c:pt>
                <c:pt idx="1563">
                  <c:v>950.82499999999982</c:v>
                </c:pt>
                <c:pt idx="1564">
                  <c:v>951.43299999999977</c:v>
                </c:pt>
                <c:pt idx="1565">
                  <c:v>952.0419999999998</c:v>
                </c:pt>
                <c:pt idx="1566">
                  <c:v>952.65</c:v>
                </c:pt>
                <c:pt idx="1567">
                  <c:v>953.25800000000004</c:v>
                </c:pt>
                <c:pt idx="1568">
                  <c:v>953.86699999999962</c:v>
                </c:pt>
                <c:pt idx="1569">
                  <c:v>954.47500000000002</c:v>
                </c:pt>
                <c:pt idx="1570">
                  <c:v>955.08299999999997</c:v>
                </c:pt>
                <c:pt idx="1571">
                  <c:v>955.69200000000001</c:v>
                </c:pt>
                <c:pt idx="1572">
                  <c:v>956.3</c:v>
                </c:pt>
                <c:pt idx="1573">
                  <c:v>956.90800000000002</c:v>
                </c:pt>
                <c:pt idx="1574">
                  <c:v>957.51699999999983</c:v>
                </c:pt>
                <c:pt idx="1575">
                  <c:v>958.125</c:v>
                </c:pt>
                <c:pt idx="1576">
                  <c:v>958.73299999999972</c:v>
                </c:pt>
                <c:pt idx="1577">
                  <c:v>959.34199999999976</c:v>
                </c:pt>
                <c:pt idx="1578">
                  <c:v>959.94999999999982</c:v>
                </c:pt>
                <c:pt idx="1579">
                  <c:v>960.55799999999977</c:v>
                </c:pt>
                <c:pt idx="1580">
                  <c:v>961.1669999999998</c:v>
                </c:pt>
                <c:pt idx="1581">
                  <c:v>961.77499999999998</c:v>
                </c:pt>
                <c:pt idx="1582">
                  <c:v>962.38300000000004</c:v>
                </c:pt>
                <c:pt idx="1583">
                  <c:v>962.99199999999996</c:v>
                </c:pt>
                <c:pt idx="1584">
                  <c:v>963.6</c:v>
                </c:pt>
                <c:pt idx="1585">
                  <c:v>964.20799999999997</c:v>
                </c:pt>
                <c:pt idx="1586">
                  <c:v>964.81699999999978</c:v>
                </c:pt>
                <c:pt idx="1587">
                  <c:v>965.42499999999973</c:v>
                </c:pt>
                <c:pt idx="1588">
                  <c:v>966.03300000000002</c:v>
                </c:pt>
                <c:pt idx="1589">
                  <c:v>966.64199999999983</c:v>
                </c:pt>
                <c:pt idx="1590">
                  <c:v>967.25</c:v>
                </c:pt>
                <c:pt idx="1591">
                  <c:v>967.85799999999949</c:v>
                </c:pt>
                <c:pt idx="1592">
                  <c:v>968.46699999999976</c:v>
                </c:pt>
                <c:pt idx="1593">
                  <c:v>969.07500000000005</c:v>
                </c:pt>
                <c:pt idx="1594">
                  <c:v>969.68299999999999</c:v>
                </c:pt>
                <c:pt idx="1595">
                  <c:v>970.29200000000003</c:v>
                </c:pt>
                <c:pt idx="1596">
                  <c:v>970.9</c:v>
                </c:pt>
                <c:pt idx="1597">
                  <c:v>971.50800000000004</c:v>
                </c:pt>
                <c:pt idx="1598">
                  <c:v>972.11699999999996</c:v>
                </c:pt>
                <c:pt idx="1599">
                  <c:v>972.72500000000002</c:v>
                </c:pt>
                <c:pt idx="1600">
                  <c:v>973.33299999999974</c:v>
                </c:pt>
                <c:pt idx="1601">
                  <c:v>973.94199999999978</c:v>
                </c:pt>
                <c:pt idx="1602">
                  <c:v>974.55</c:v>
                </c:pt>
                <c:pt idx="1603">
                  <c:v>975.15800000000002</c:v>
                </c:pt>
                <c:pt idx="1604">
                  <c:v>975.76699999999983</c:v>
                </c:pt>
                <c:pt idx="1605">
                  <c:v>976.375</c:v>
                </c:pt>
                <c:pt idx="1606">
                  <c:v>976.98299999999972</c:v>
                </c:pt>
                <c:pt idx="1607">
                  <c:v>977.59199999999998</c:v>
                </c:pt>
                <c:pt idx="1608">
                  <c:v>978.2</c:v>
                </c:pt>
                <c:pt idx="1609">
                  <c:v>978.80799999999977</c:v>
                </c:pt>
                <c:pt idx="1610">
                  <c:v>979.4169999999998</c:v>
                </c:pt>
                <c:pt idx="1611">
                  <c:v>980.02499999999998</c:v>
                </c:pt>
                <c:pt idx="1612">
                  <c:v>980.63300000000004</c:v>
                </c:pt>
                <c:pt idx="1613">
                  <c:v>981.24199999999996</c:v>
                </c:pt>
                <c:pt idx="1614">
                  <c:v>981.8499999999998</c:v>
                </c:pt>
                <c:pt idx="1615">
                  <c:v>982.45799999999974</c:v>
                </c:pt>
                <c:pt idx="1616">
                  <c:v>983.06699999999978</c:v>
                </c:pt>
                <c:pt idx="1617">
                  <c:v>983.67499999999995</c:v>
                </c:pt>
                <c:pt idx="1618">
                  <c:v>984.28300000000002</c:v>
                </c:pt>
                <c:pt idx="1619">
                  <c:v>984.89199999999983</c:v>
                </c:pt>
                <c:pt idx="1620">
                  <c:v>985.5</c:v>
                </c:pt>
                <c:pt idx="1621">
                  <c:v>986.10799999999972</c:v>
                </c:pt>
                <c:pt idx="1622">
                  <c:v>986.71699999999998</c:v>
                </c:pt>
                <c:pt idx="1623">
                  <c:v>987.32499999999982</c:v>
                </c:pt>
                <c:pt idx="1624">
                  <c:v>987.93299999999977</c:v>
                </c:pt>
                <c:pt idx="1625">
                  <c:v>988.5419999999998</c:v>
                </c:pt>
                <c:pt idx="1626">
                  <c:v>989.15</c:v>
                </c:pt>
                <c:pt idx="1627">
                  <c:v>989.75800000000004</c:v>
                </c:pt>
                <c:pt idx="1628">
                  <c:v>990.36699999999962</c:v>
                </c:pt>
                <c:pt idx="1629">
                  <c:v>990.97500000000002</c:v>
                </c:pt>
                <c:pt idx="1630">
                  <c:v>991.58299999999997</c:v>
                </c:pt>
                <c:pt idx="1631">
                  <c:v>992.19200000000001</c:v>
                </c:pt>
                <c:pt idx="1632">
                  <c:v>992.8</c:v>
                </c:pt>
                <c:pt idx="1633">
                  <c:v>993.40800000000002</c:v>
                </c:pt>
                <c:pt idx="1634">
                  <c:v>994.01699999999983</c:v>
                </c:pt>
                <c:pt idx="1635">
                  <c:v>994.625</c:v>
                </c:pt>
                <c:pt idx="1636">
                  <c:v>995.23299999999972</c:v>
                </c:pt>
                <c:pt idx="1637">
                  <c:v>995.84199999999976</c:v>
                </c:pt>
                <c:pt idx="1638">
                  <c:v>996.44999999999982</c:v>
                </c:pt>
                <c:pt idx="1639">
                  <c:v>997.05799999999977</c:v>
                </c:pt>
                <c:pt idx="1640">
                  <c:v>997.6669999999998</c:v>
                </c:pt>
                <c:pt idx="1641">
                  <c:v>998.27499999999998</c:v>
                </c:pt>
                <c:pt idx="1642">
                  <c:v>998.88300000000004</c:v>
                </c:pt>
                <c:pt idx="1643">
                  <c:v>999.49199999999996</c:v>
                </c:pt>
                <c:pt idx="1644">
                  <c:v>1000.1</c:v>
                </c:pt>
                <c:pt idx="1645">
                  <c:v>1000.708</c:v>
                </c:pt>
                <c:pt idx="1646">
                  <c:v>1001.317</c:v>
                </c:pt>
                <c:pt idx="1647">
                  <c:v>1001.925</c:v>
                </c:pt>
                <c:pt idx="1648">
                  <c:v>1002.533</c:v>
                </c:pt>
                <c:pt idx="1649">
                  <c:v>1003.1420000000001</c:v>
                </c:pt>
                <c:pt idx="1650">
                  <c:v>1003.75</c:v>
                </c:pt>
                <c:pt idx="1651">
                  <c:v>1004.3579999999999</c:v>
                </c:pt>
                <c:pt idx="1652">
                  <c:v>1004.967</c:v>
                </c:pt>
                <c:pt idx="1653">
                  <c:v>1005.575</c:v>
                </c:pt>
                <c:pt idx="1654">
                  <c:v>1006.183</c:v>
                </c:pt>
                <c:pt idx="1655">
                  <c:v>1006.792</c:v>
                </c:pt>
                <c:pt idx="1656">
                  <c:v>1007.4</c:v>
                </c:pt>
                <c:pt idx="1657">
                  <c:v>1008.008</c:v>
                </c:pt>
                <c:pt idx="1658">
                  <c:v>1008.617</c:v>
                </c:pt>
                <c:pt idx="1659">
                  <c:v>1009.225</c:v>
                </c:pt>
                <c:pt idx="1660">
                  <c:v>1009.833</c:v>
                </c:pt>
                <c:pt idx="1661">
                  <c:v>1010.442</c:v>
                </c:pt>
                <c:pt idx="1662">
                  <c:v>1011.05</c:v>
                </c:pt>
                <c:pt idx="1663">
                  <c:v>1011.658</c:v>
                </c:pt>
                <c:pt idx="1664">
                  <c:v>1012.2670000000001</c:v>
                </c:pt>
                <c:pt idx="1665">
                  <c:v>1012.875</c:v>
                </c:pt>
                <c:pt idx="1666">
                  <c:v>1013.4829999999999</c:v>
                </c:pt>
                <c:pt idx="1667">
                  <c:v>1014.092</c:v>
                </c:pt>
                <c:pt idx="1668">
                  <c:v>1014.7</c:v>
                </c:pt>
                <c:pt idx="1669">
                  <c:v>1015.308</c:v>
                </c:pt>
                <c:pt idx="1670">
                  <c:v>1015.917</c:v>
                </c:pt>
                <c:pt idx="1671">
                  <c:v>1016.525</c:v>
                </c:pt>
                <c:pt idx="1672">
                  <c:v>1017.133</c:v>
                </c:pt>
                <c:pt idx="1673">
                  <c:v>1017.742</c:v>
                </c:pt>
                <c:pt idx="1674">
                  <c:v>1018.35</c:v>
                </c:pt>
                <c:pt idx="1675">
                  <c:v>1018.958</c:v>
                </c:pt>
                <c:pt idx="1676">
                  <c:v>1019.567</c:v>
                </c:pt>
                <c:pt idx="1677">
                  <c:v>1020.175</c:v>
                </c:pt>
                <c:pt idx="1678">
                  <c:v>1020.783</c:v>
                </c:pt>
                <c:pt idx="1679">
                  <c:v>1021.3920000000001</c:v>
                </c:pt>
                <c:pt idx="1680">
                  <c:v>1022</c:v>
                </c:pt>
                <c:pt idx="1681">
                  <c:v>1022.6079999999999</c:v>
                </c:pt>
                <c:pt idx="1682">
                  <c:v>1023.217</c:v>
                </c:pt>
                <c:pt idx="1683">
                  <c:v>1023.825</c:v>
                </c:pt>
                <c:pt idx="1684">
                  <c:v>1024.433</c:v>
                </c:pt>
                <c:pt idx="1685">
                  <c:v>1025.0419999999999</c:v>
                </c:pt>
                <c:pt idx="1686">
                  <c:v>1025.6500000000001</c:v>
                </c:pt>
                <c:pt idx="1687">
                  <c:v>1026.258</c:v>
                </c:pt>
                <c:pt idx="1688">
                  <c:v>1026.867</c:v>
                </c:pt>
                <c:pt idx="1689">
                  <c:v>1027.4749999999999</c:v>
                </c:pt>
                <c:pt idx="1690">
                  <c:v>1028.0830000000001</c:v>
                </c:pt>
                <c:pt idx="1691">
                  <c:v>1028.692</c:v>
                </c:pt>
                <c:pt idx="1692">
                  <c:v>1029.3</c:v>
                </c:pt>
                <c:pt idx="1693">
                  <c:v>1029.9079999999999</c:v>
                </c:pt>
                <c:pt idx="1694">
                  <c:v>1030.5170000000001</c:v>
                </c:pt>
                <c:pt idx="1695">
                  <c:v>1031.125</c:v>
                </c:pt>
                <c:pt idx="1696">
                  <c:v>1031.7329999999999</c:v>
                </c:pt>
                <c:pt idx="1697">
                  <c:v>1032.3420000000001</c:v>
                </c:pt>
                <c:pt idx="1698">
                  <c:v>1032.95</c:v>
                </c:pt>
                <c:pt idx="1699">
                  <c:v>1033.558</c:v>
                </c:pt>
                <c:pt idx="1700">
                  <c:v>1034.1669999999999</c:v>
                </c:pt>
                <c:pt idx="1701">
                  <c:v>1034.7750000000001</c:v>
                </c:pt>
                <c:pt idx="1702">
                  <c:v>1035.383</c:v>
                </c:pt>
                <c:pt idx="1703">
                  <c:v>1035.992</c:v>
                </c:pt>
                <c:pt idx="1704">
                  <c:v>1036.5999999999999</c:v>
                </c:pt>
                <c:pt idx="1705">
                  <c:v>1037.2080000000001</c:v>
                </c:pt>
                <c:pt idx="1706">
                  <c:v>1037.817</c:v>
                </c:pt>
                <c:pt idx="1707">
                  <c:v>1038.425</c:v>
                </c:pt>
                <c:pt idx="1708">
                  <c:v>1039.0329999999999</c:v>
                </c:pt>
                <c:pt idx="1709">
                  <c:v>1039.6420000000001</c:v>
                </c:pt>
                <c:pt idx="1710">
                  <c:v>1040.25</c:v>
                </c:pt>
                <c:pt idx="1711">
                  <c:v>1040.8579999999999</c:v>
                </c:pt>
                <c:pt idx="1712">
                  <c:v>1041.4670000000001</c:v>
                </c:pt>
                <c:pt idx="1713">
                  <c:v>1042.075</c:v>
                </c:pt>
                <c:pt idx="1714">
                  <c:v>1042.683</c:v>
                </c:pt>
                <c:pt idx="1715">
                  <c:v>1043.2919999999999</c:v>
                </c:pt>
                <c:pt idx="1716">
                  <c:v>1043.9000000000001</c:v>
                </c:pt>
                <c:pt idx="1717">
                  <c:v>1044.508</c:v>
                </c:pt>
                <c:pt idx="1718">
                  <c:v>1045.117</c:v>
                </c:pt>
                <c:pt idx="1719">
                  <c:v>1045.7249999999999</c:v>
                </c:pt>
                <c:pt idx="1720">
                  <c:v>1046.3330000000001</c:v>
                </c:pt>
                <c:pt idx="1721">
                  <c:v>1046.942</c:v>
                </c:pt>
                <c:pt idx="1722">
                  <c:v>1047.55</c:v>
                </c:pt>
                <c:pt idx="1723">
                  <c:v>1048.1579999999999</c:v>
                </c:pt>
                <c:pt idx="1724">
                  <c:v>1048.7670000000001</c:v>
                </c:pt>
                <c:pt idx="1725">
                  <c:v>1049.375</c:v>
                </c:pt>
                <c:pt idx="1726">
                  <c:v>1049.9829999999999</c:v>
                </c:pt>
                <c:pt idx="1727">
                  <c:v>1050.5920000000001</c:v>
                </c:pt>
                <c:pt idx="1728">
                  <c:v>1051.2</c:v>
                </c:pt>
                <c:pt idx="1729">
                  <c:v>1051.808</c:v>
                </c:pt>
                <c:pt idx="1730">
                  <c:v>1052.4169999999999</c:v>
                </c:pt>
                <c:pt idx="1731">
                  <c:v>1053.0250000000001</c:v>
                </c:pt>
                <c:pt idx="1732">
                  <c:v>1053.633</c:v>
                </c:pt>
                <c:pt idx="1733">
                  <c:v>1054.242</c:v>
                </c:pt>
                <c:pt idx="1734">
                  <c:v>1054.8499999999999</c:v>
                </c:pt>
                <c:pt idx="1735">
                  <c:v>1055.4580000000001</c:v>
                </c:pt>
                <c:pt idx="1736">
                  <c:v>1056.067</c:v>
                </c:pt>
                <c:pt idx="1737">
                  <c:v>1056.675</c:v>
                </c:pt>
              </c:numCache>
            </c:numRef>
          </c:xVal>
          <c:yVal>
            <c:numRef>
              <c:f>Sheet1!$D$2:$D$1739</c:f>
              <c:numCache>
                <c:formatCode>0.00E+00</c:formatCode>
                <c:ptCount val="1738"/>
                <c:pt idx="0">
                  <c:v>0.50658999999999998</c:v>
                </c:pt>
                <c:pt idx="1">
                  <c:v>0.50658999999999998</c:v>
                </c:pt>
                <c:pt idx="2">
                  <c:v>0.50658999999999998</c:v>
                </c:pt>
                <c:pt idx="3">
                  <c:v>0.50658999999999998</c:v>
                </c:pt>
                <c:pt idx="4">
                  <c:v>0.50658999999999998</c:v>
                </c:pt>
                <c:pt idx="5">
                  <c:v>0.50780999999999998</c:v>
                </c:pt>
                <c:pt idx="6">
                  <c:v>0.50780999999999998</c:v>
                </c:pt>
                <c:pt idx="7">
                  <c:v>0.50780999999999998</c:v>
                </c:pt>
                <c:pt idx="8">
                  <c:v>0.50658999999999998</c:v>
                </c:pt>
                <c:pt idx="9">
                  <c:v>0.50658999999999998</c:v>
                </c:pt>
                <c:pt idx="10">
                  <c:v>0.50658999999999998</c:v>
                </c:pt>
                <c:pt idx="11">
                  <c:v>0.50658999999999998</c:v>
                </c:pt>
                <c:pt idx="12">
                  <c:v>0.50658999999999998</c:v>
                </c:pt>
                <c:pt idx="13">
                  <c:v>0.50658999999999998</c:v>
                </c:pt>
                <c:pt idx="14">
                  <c:v>0.50658999999999998</c:v>
                </c:pt>
                <c:pt idx="15">
                  <c:v>0.50658999999999998</c:v>
                </c:pt>
                <c:pt idx="16">
                  <c:v>0.50658999999999998</c:v>
                </c:pt>
                <c:pt idx="17">
                  <c:v>0.50658999999999998</c:v>
                </c:pt>
                <c:pt idx="18">
                  <c:v>0.50658999999999998</c:v>
                </c:pt>
                <c:pt idx="19">
                  <c:v>0.50658999999999998</c:v>
                </c:pt>
                <c:pt idx="20">
                  <c:v>0.50536999999999999</c:v>
                </c:pt>
                <c:pt idx="21">
                  <c:v>0.50658999999999998</c:v>
                </c:pt>
                <c:pt idx="22">
                  <c:v>0.50536999999999999</c:v>
                </c:pt>
                <c:pt idx="23">
                  <c:v>0.50536999999999999</c:v>
                </c:pt>
                <c:pt idx="24">
                  <c:v>0.50536999999999999</c:v>
                </c:pt>
                <c:pt idx="25">
                  <c:v>0.50536999999999999</c:v>
                </c:pt>
                <c:pt idx="26">
                  <c:v>0.50536999999999999</c:v>
                </c:pt>
                <c:pt idx="27">
                  <c:v>0.50536999999999999</c:v>
                </c:pt>
                <c:pt idx="28">
                  <c:v>0.50536999999999999</c:v>
                </c:pt>
                <c:pt idx="29">
                  <c:v>0.50536999999999999</c:v>
                </c:pt>
                <c:pt idx="30">
                  <c:v>0.50658999999999998</c:v>
                </c:pt>
                <c:pt idx="31">
                  <c:v>0.50536999999999999</c:v>
                </c:pt>
                <c:pt idx="32">
                  <c:v>0.50658999999999998</c:v>
                </c:pt>
                <c:pt idx="33">
                  <c:v>0.50658999999999998</c:v>
                </c:pt>
                <c:pt idx="34">
                  <c:v>0.50658999999999998</c:v>
                </c:pt>
                <c:pt idx="35">
                  <c:v>0.50536999999999999</c:v>
                </c:pt>
                <c:pt idx="36">
                  <c:v>0.50536999999999999</c:v>
                </c:pt>
                <c:pt idx="37">
                  <c:v>0.50536999999999999</c:v>
                </c:pt>
                <c:pt idx="38">
                  <c:v>0.50536999999999999</c:v>
                </c:pt>
                <c:pt idx="39">
                  <c:v>0.50536999999999999</c:v>
                </c:pt>
                <c:pt idx="40">
                  <c:v>0.50536999999999999</c:v>
                </c:pt>
                <c:pt idx="41">
                  <c:v>0.50536999999999999</c:v>
                </c:pt>
                <c:pt idx="42">
                  <c:v>0.50536999999999999</c:v>
                </c:pt>
                <c:pt idx="43">
                  <c:v>0.50536999999999999</c:v>
                </c:pt>
                <c:pt idx="44">
                  <c:v>0.50536999999999999</c:v>
                </c:pt>
                <c:pt idx="45">
                  <c:v>0.50536999999999999</c:v>
                </c:pt>
                <c:pt idx="46">
                  <c:v>0.50536999999999999</c:v>
                </c:pt>
                <c:pt idx="47">
                  <c:v>0.50536999999999999</c:v>
                </c:pt>
                <c:pt idx="48">
                  <c:v>0.50536999999999999</c:v>
                </c:pt>
                <c:pt idx="49">
                  <c:v>0.50536999999999999</c:v>
                </c:pt>
                <c:pt idx="50">
                  <c:v>0.50536999999999999</c:v>
                </c:pt>
                <c:pt idx="51">
                  <c:v>0.50414999999999999</c:v>
                </c:pt>
                <c:pt idx="52">
                  <c:v>0.50536999999999999</c:v>
                </c:pt>
                <c:pt idx="53">
                  <c:v>0.50536999999999999</c:v>
                </c:pt>
                <c:pt idx="54">
                  <c:v>0.50536999999999999</c:v>
                </c:pt>
                <c:pt idx="55">
                  <c:v>0.50536999999999999</c:v>
                </c:pt>
                <c:pt idx="56">
                  <c:v>0.50536999999999999</c:v>
                </c:pt>
                <c:pt idx="57">
                  <c:v>0.50414999999999999</c:v>
                </c:pt>
                <c:pt idx="58">
                  <c:v>0.50536999999999999</c:v>
                </c:pt>
                <c:pt idx="59">
                  <c:v>0.50536999999999999</c:v>
                </c:pt>
                <c:pt idx="60">
                  <c:v>0.50414999999999999</c:v>
                </c:pt>
                <c:pt idx="61">
                  <c:v>0.50414999999999999</c:v>
                </c:pt>
                <c:pt idx="62">
                  <c:v>0.50414999999999999</c:v>
                </c:pt>
                <c:pt idx="63">
                  <c:v>0.50536999999999999</c:v>
                </c:pt>
                <c:pt idx="64">
                  <c:v>0.50414999999999999</c:v>
                </c:pt>
                <c:pt idx="65">
                  <c:v>0.50414999999999999</c:v>
                </c:pt>
                <c:pt idx="66">
                  <c:v>0.50414999999999999</c:v>
                </c:pt>
                <c:pt idx="67">
                  <c:v>0.50414999999999999</c:v>
                </c:pt>
                <c:pt idx="68">
                  <c:v>0.50414999999999999</c:v>
                </c:pt>
                <c:pt idx="69">
                  <c:v>0.50414999999999999</c:v>
                </c:pt>
                <c:pt idx="70">
                  <c:v>0.50414999999999999</c:v>
                </c:pt>
                <c:pt idx="71">
                  <c:v>0.50414999999999999</c:v>
                </c:pt>
                <c:pt idx="72">
                  <c:v>0.50414999999999999</c:v>
                </c:pt>
                <c:pt idx="73">
                  <c:v>0.50414999999999999</c:v>
                </c:pt>
                <c:pt idx="74">
                  <c:v>0.50414999999999999</c:v>
                </c:pt>
                <c:pt idx="75">
                  <c:v>0.50536999999999999</c:v>
                </c:pt>
                <c:pt idx="76">
                  <c:v>0.50414999999999999</c:v>
                </c:pt>
                <c:pt idx="77">
                  <c:v>0.50414999999999999</c:v>
                </c:pt>
                <c:pt idx="78">
                  <c:v>0.50414999999999999</c:v>
                </c:pt>
                <c:pt idx="79">
                  <c:v>0.50414999999999999</c:v>
                </c:pt>
                <c:pt idx="80">
                  <c:v>0.50414999999999999</c:v>
                </c:pt>
                <c:pt idx="81">
                  <c:v>0.50414999999999999</c:v>
                </c:pt>
                <c:pt idx="82">
                  <c:v>0.50414999999999999</c:v>
                </c:pt>
                <c:pt idx="83">
                  <c:v>0.50414999999999999</c:v>
                </c:pt>
                <c:pt idx="84">
                  <c:v>0.50292999999999999</c:v>
                </c:pt>
                <c:pt idx="85">
                  <c:v>0.50414999999999999</c:v>
                </c:pt>
                <c:pt idx="86">
                  <c:v>0.50414999999999999</c:v>
                </c:pt>
                <c:pt idx="87">
                  <c:v>0.50292999999999999</c:v>
                </c:pt>
                <c:pt idx="88">
                  <c:v>0.50414999999999999</c:v>
                </c:pt>
                <c:pt idx="89">
                  <c:v>0.50414999999999999</c:v>
                </c:pt>
                <c:pt idx="90">
                  <c:v>0.50292999999999999</c:v>
                </c:pt>
                <c:pt idx="91">
                  <c:v>0.50414999999999999</c:v>
                </c:pt>
                <c:pt idx="92">
                  <c:v>0.50292999999999999</c:v>
                </c:pt>
                <c:pt idx="93">
                  <c:v>0.50414999999999999</c:v>
                </c:pt>
                <c:pt idx="94">
                  <c:v>0.50414999999999999</c:v>
                </c:pt>
                <c:pt idx="95">
                  <c:v>0.50414999999999999</c:v>
                </c:pt>
                <c:pt idx="96">
                  <c:v>0.50414999999999999</c:v>
                </c:pt>
                <c:pt idx="97">
                  <c:v>0.50292999999999999</c:v>
                </c:pt>
                <c:pt idx="98">
                  <c:v>0.50414999999999999</c:v>
                </c:pt>
                <c:pt idx="99">
                  <c:v>0.50414999999999999</c:v>
                </c:pt>
                <c:pt idx="100">
                  <c:v>0.50414999999999999</c:v>
                </c:pt>
                <c:pt idx="101">
                  <c:v>0.50414999999999999</c:v>
                </c:pt>
                <c:pt idx="102">
                  <c:v>0.50414999999999999</c:v>
                </c:pt>
                <c:pt idx="103">
                  <c:v>0.50414999999999999</c:v>
                </c:pt>
                <c:pt idx="104">
                  <c:v>0.50414999999999999</c:v>
                </c:pt>
                <c:pt idx="105">
                  <c:v>0.50292999999999999</c:v>
                </c:pt>
                <c:pt idx="106">
                  <c:v>0.50292999999999999</c:v>
                </c:pt>
                <c:pt idx="107">
                  <c:v>0.50292999999999999</c:v>
                </c:pt>
                <c:pt idx="108">
                  <c:v>0.50292999999999999</c:v>
                </c:pt>
                <c:pt idx="109">
                  <c:v>0.50414999999999999</c:v>
                </c:pt>
                <c:pt idx="110">
                  <c:v>0.50292999999999999</c:v>
                </c:pt>
                <c:pt idx="111">
                  <c:v>0.50292999999999999</c:v>
                </c:pt>
                <c:pt idx="112">
                  <c:v>0.50414999999999999</c:v>
                </c:pt>
                <c:pt idx="113">
                  <c:v>0.50414999999999999</c:v>
                </c:pt>
                <c:pt idx="114">
                  <c:v>0.50536999999999999</c:v>
                </c:pt>
                <c:pt idx="115">
                  <c:v>0.50414999999999999</c:v>
                </c:pt>
                <c:pt idx="116">
                  <c:v>0.50414999999999999</c:v>
                </c:pt>
                <c:pt idx="117">
                  <c:v>0.50414999999999999</c:v>
                </c:pt>
                <c:pt idx="118">
                  <c:v>0.50292999999999999</c:v>
                </c:pt>
                <c:pt idx="119">
                  <c:v>0.50414999999999999</c:v>
                </c:pt>
                <c:pt idx="120">
                  <c:v>0.50292999999999999</c:v>
                </c:pt>
                <c:pt idx="121">
                  <c:v>0.50292999999999999</c:v>
                </c:pt>
                <c:pt idx="122">
                  <c:v>0.50292999999999999</c:v>
                </c:pt>
                <c:pt idx="123">
                  <c:v>0.50414999999999999</c:v>
                </c:pt>
                <c:pt idx="124">
                  <c:v>0.50414999999999999</c:v>
                </c:pt>
                <c:pt idx="125">
                  <c:v>0.50414999999999999</c:v>
                </c:pt>
                <c:pt idx="126">
                  <c:v>0.50414999999999999</c:v>
                </c:pt>
                <c:pt idx="127">
                  <c:v>0.50292999999999999</c:v>
                </c:pt>
                <c:pt idx="128">
                  <c:v>0.50414999999999999</c:v>
                </c:pt>
                <c:pt idx="129">
                  <c:v>0.50414999999999999</c:v>
                </c:pt>
                <c:pt idx="130">
                  <c:v>0.50414999999999999</c:v>
                </c:pt>
                <c:pt idx="131">
                  <c:v>0.50414999999999999</c:v>
                </c:pt>
                <c:pt idx="132">
                  <c:v>0.50414999999999999</c:v>
                </c:pt>
                <c:pt idx="133">
                  <c:v>0.50414999999999999</c:v>
                </c:pt>
                <c:pt idx="134">
                  <c:v>0.50414999999999999</c:v>
                </c:pt>
                <c:pt idx="135">
                  <c:v>0.50414999999999999</c:v>
                </c:pt>
                <c:pt idx="136">
                  <c:v>0.50414999999999999</c:v>
                </c:pt>
                <c:pt idx="137">
                  <c:v>0.50414999999999999</c:v>
                </c:pt>
                <c:pt idx="138">
                  <c:v>0.50414999999999999</c:v>
                </c:pt>
                <c:pt idx="139">
                  <c:v>0.50414999999999999</c:v>
                </c:pt>
                <c:pt idx="140">
                  <c:v>0.50414999999999999</c:v>
                </c:pt>
                <c:pt idx="141">
                  <c:v>0.50414999999999999</c:v>
                </c:pt>
                <c:pt idx="142">
                  <c:v>0.50414999999999999</c:v>
                </c:pt>
                <c:pt idx="143">
                  <c:v>0.50536999999999999</c:v>
                </c:pt>
                <c:pt idx="144">
                  <c:v>0.50414999999999999</c:v>
                </c:pt>
                <c:pt idx="145">
                  <c:v>0.50414999999999999</c:v>
                </c:pt>
                <c:pt idx="146">
                  <c:v>0.50536999999999999</c:v>
                </c:pt>
                <c:pt idx="147">
                  <c:v>0.50536999999999999</c:v>
                </c:pt>
                <c:pt idx="148">
                  <c:v>0.50536999999999999</c:v>
                </c:pt>
                <c:pt idx="149">
                  <c:v>0.50536999999999999</c:v>
                </c:pt>
                <c:pt idx="150">
                  <c:v>0.50536999999999999</c:v>
                </c:pt>
                <c:pt idx="151">
                  <c:v>0.50536999999999999</c:v>
                </c:pt>
                <c:pt idx="152">
                  <c:v>0.50536999999999999</c:v>
                </c:pt>
                <c:pt idx="153">
                  <c:v>0.50536999999999999</c:v>
                </c:pt>
                <c:pt idx="154">
                  <c:v>0.50536999999999999</c:v>
                </c:pt>
                <c:pt idx="155">
                  <c:v>0.50536999999999999</c:v>
                </c:pt>
                <c:pt idx="156">
                  <c:v>0.50536999999999999</c:v>
                </c:pt>
                <c:pt idx="157">
                  <c:v>0.50536999999999999</c:v>
                </c:pt>
                <c:pt idx="158">
                  <c:v>0.50536999999999999</c:v>
                </c:pt>
                <c:pt idx="159">
                  <c:v>0.50536999999999999</c:v>
                </c:pt>
                <c:pt idx="160">
                  <c:v>0.50536999999999999</c:v>
                </c:pt>
                <c:pt idx="161">
                  <c:v>0.50536999999999999</c:v>
                </c:pt>
                <c:pt idx="162">
                  <c:v>0.50536999999999999</c:v>
                </c:pt>
                <c:pt idx="163">
                  <c:v>0.50536999999999999</c:v>
                </c:pt>
                <c:pt idx="164">
                  <c:v>0.50658999999999998</c:v>
                </c:pt>
                <c:pt idx="165">
                  <c:v>0.50536999999999999</c:v>
                </c:pt>
                <c:pt idx="166">
                  <c:v>0.50536999999999999</c:v>
                </c:pt>
                <c:pt idx="167">
                  <c:v>0.50536999999999999</c:v>
                </c:pt>
                <c:pt idx="168">
                  <c:v>0.50536999999999999</c:v>
                </c:pt>
                <c:pt idx="169">
                  <c:v>0.50536999999999999</c:v>
                </c:pt>
                <c:pt idx="170">
                  <c:v>0.50536999999999999</c:v>
                </c:pt>
                <c:pt idx="171">
                  <c:v>0.50536999999999999</c:v>
                </c:pt>
                <c:pt idx="172">
                  <c:v>0.50536999999999999</c:v>
                </c:pt>
                <c:pt idx="173">
                  <c:v>0.50536999999999999</c:v>
                </c:pt>
                <c:pt idx="174">
                  <c:v>0.50536999999999999</c:v>
                </c:pt>
                <c:pt idx="175">
                  <c:v>0.50536999999999999</c:v>
                </c:pt>
                <c:pt idx="176">
                  <c:v>0.50536999999999999</c:v>
                </c:pt>
                <c:pt idx="177">
                  <c:v>0.50536999999999999</c:v>
                </c:pt>
                <c:pt idx="178">
                  <c:v>0.50658999999999998</c:v>
                </c:pt>
                <c:pt idx="179">
                  <c:v>0.50536999999999999</c:v>
                </c:pt>
                <c:pt idx="180">
                  <c:v>0.50658999999999998</c:v>
                </c:pt>
                <c:pt idx="181">
                  <c:v>0.50536999999999999</c:v>
                </c:pt>
                <c:pt idx="182">
                  <c:v>0.50536999999999999</c:v>
                </c:pt>
                <c:pt idx="183">
                  <c:v>0.50536999999999999</c:v>
                </c:pt>
                <c:pt idx="184">
                  <c:v>0.50658999999999998</c:v>
                </c:pt>
                <c:pt idx="185">
                  <c:v>0.50536999999999999</c:v>
                </c:pt>
                <c:pt idx="186">
                  <c:v>0.50658999999999998</c:v>
                </c:pt>
                <c:pt idx="187">
                  <c:v>0.50658999999999998</c:v>
                </c:pt>
                <c:pt idx="188">
                  <c:v>0.50536999999999999</c:v>
                </c:pt>
                <c:pt idx="189">
                  <c:v>0.50658999999999998</c:v>
                </c:pt>
                <c:pt idx="190">
                  <c:v>0.50658999999999998</c:v>
                </c:pt>
                <c:pt idx="191">
                  <c:v>0.50658999999999998</c:v>
                </c:pt>
                <c:pt idx="192">
                  <c:v>0.50658999999999998</c:v>
                </c:pt>
                <c:pt idx="193">
                  <c:v>0.50658999999999998</c:v>
                </c:pt>
                <c:pt idx="194">
                  <c:v>0.50658999999999998</c:v>
                </c:pt>
                <c:pt idx="195">
                  <c:v>0.50658999999999998</c:v>
                </c:pt>
                <c:pt idx="196">
                  <c:v>0.50658999999999998</c:v>
                </c:pt>
                <c:pt idx="197">
                  <c:v>0.50658999999999998</c:v>
                </c:pt>
                <c:pt idx="198">
                  <c:v>0.50658999999999998</c:v>
                </c:pt>
                <c:pt idx="199">
                  <c:v>0.50780999999999998</c:v>
                </c:pt>
                <c:pt idx="200">
                  <c:v>0.50780999999999998</c:v>
                </c:pt>
                <c:pt idx="201">
                  <c:v>0.50658999999999998</c:v>
                </c:pt>
                <c:pt idx="202">
                  <c:v>0.50658999999999998</c:v>
                </c:pt>
                <c:pt idx="203">
                  <c:v>0.50780999999999998</c:v>
                </c:pt>
                <c:pt idx="204">
                  <c:v>0.50658999999999998</c:v>
                </c:pt>
                <c:pt idx="205">
                  <c:v>0.50780999999999998</c:v>
                </c:pt>
                <c:pt idx="206">
                  <c:v>0.50658999999999998</c:v>
                </c:pt>
                <c:pt idx="207">
                  <c:v>0.50658999999999998</c:v>
                </c:pt>
                <c:pt idx="208">
                  <c:v>0.50780999999999998</c:v>
                </c:pt>
                <c:pt idx="209">
                  <c:v>0.50780999999999998</c:v>
                </c:pt>
                <c:pt idx="210">
                  <c:v>0.50780999999999998</c:v>
                </c:pt>
                <c:pt idx="211">
                  <c:v>0.50902999999999998</c:v>
                </c:pt>
                <c:pt idx="212">
                  <c:v>0.50902999999999998</c:v>
                </c:pt>
                <c:pt idx="213">
                  <c:v>0.51024999999999998</c:v>
                </c:pt>
                <c:pt idx="214">
                  <c:v>0.51146999999999998</c:v>
                </c:pt>
                <c:pt idx="215">
                  <c:v>0.51146999999999998</c:v>
                </c:pt>
                <c:pt idx="216">
                  <c:v>0.51146999999999998</c:v>
                </c:pt>
                <c:pt idx="217">
                  <c:v>0.51270000000000004</c:v>
                </c:pt>
                <c:pt idx="218">
                  <c:v>0.51270000000000004</c:v>
                </c:pt>
                <c:pt idx="219">
                  <c:v>0.51270000000000004</c:v>
                </c:pt>
                <c:pt idx="220">
                  <c:v>0.51146999999999998</c:v>
                </c:pt>
                <c:pt idx="221">
                  <c:v>0.51146999999999998</c:v>
                </c:pt>
                <c:pt idx="222">
                  <c:v>0.51270000000000004</c:v>
                </c:pt>
                <c:pt idx="223">
                  <c:v>0.51514000000000004</c:v>
                </c:pt>
                <c:pt idx="224">
                  <c:v>0.52002000000000004</c:v>
                </c:pt>
                <c:pt idx="225">
                  <c:v>0.52612000000000003</c:v>
                </c:pt>
                <c:pt idx="226">
                  <c:v>0.53466999999999998</c:v>
                </c:pt>
                <c:pt idx="227">
                  <c:v>0.54076999999999997</c:v>
                </c:pt>
                <c:pt idx="228">
                  <c:v>0.54320999999999997</c:v>
                </c:pt>
                <c:pt idx="229">
                  <c:v>0.54564999999999997</c:v>
                </c:pt>
                <c:pt idx="230">
                  <c:v>0.55176000000000003</c:v>
                </c:pt>
                <c:pt idx="231">
                  <c:v>0.56640999999999997</c:v>
                </c:pt>
                <c:pt idx="232">
                  <c:v>0.62134</c:v>
                </c:pt>
                <c:pt idx="233">
                  <c:v>0.72875999999999996</c:v>
                </c:pt>
                <c:pt idx="234">
                  <c:v>0.84838999999999998</c:v>
                </c:pt>
                <c:pt idx="235">
                  <c:v>0.95215000000000005</c:v>
                </c:pt>
                <c:pt idx="236">
                  <c:v>1.0339</c:v>
                </c:pt>
                <c:pt idx="237">
                  <c:v>1.0973999999999999</c:v>
                </c:pt>
                <c:pt idx="238">
                  <c:v>1.1462000000000001</c:v>
                </c:pt>
                <c:pt idx="239">
                  <c:v>1.1853</c:v>
                </c:pt>
                <c:pt idx="240">
                  <c:v>1.2182999999999999</c:v>
                </c:pt>
                <c:pt idx="241">
                  <c:v>1.2487999999999999</c:v>
                </c:pt>
                <c:pt idx="242">
                  <c:v>1.2744</c:v>
                </c:pt>
                <c:pt idx="243">
                  <c:v>1.2976000000000001</c:v>
                </c:pt>
                <c:pt idx="244">
                  <c:v>1.3208</c:v>
                </c:pt>
                <c:pt idx="245">
                  <c:v>1.3306</c:v>
                </c:pt>
                <c:pt idx="246">
                  <c:v>1.3586</c:v>
                </c:pt>
                <c:pt idx="247">
                  <c:v>1.3745000000000001</c:v>
                </c:pt>
                <c:pt idx="248">
                  <c:v>1.3915999999999999</c:v>
                </c:pt>
                <c:pt idx="249">
                  <c:v>1.4075</c:v>
                </c:pt>
                <c:pt idx="250">
                  <c:v>1.4209000000000001</c:v>
                </c:pt>
                <c:pt idx="251">
                  <c:v>1.4342999999999999</c:v>
                </c:pt>
                <c:pt idx="252">
                  <c:v>1.4453</c:v>
                </c:pt>
                <c:pt idx="253">
                  <c:v>1.4575</c:v>
                </c:pt>
                <c:pt idx="254">
                  <c:v>1.4684999999999999</c:v>
                </c:pt>
                <c:pt idx="255">
                  <c:v>1.4795</c:v>
                </c:pt>
                <c:pt idx="256">
                  <c:v>1.4893000000000001</c:v>
                </c:pt>
                <c:pt idx="257">
                  <c:v>1.5002</c:v>
                </c:pt>
                <c:pt idx="258">
                  <c:v>1.5087999999999999</c:v>
                </c:pt>
                <c:pt idx="259">
                  <c:v>1.5173000000000001</c:v>
                </c:pt>
                <c:pt idx="260">
                  <c:v>1.5259</c:v>
                </c:pt>
                <c:pt idx="261">
                  <c:v>1.5344</c:v>
                </c:pt>
                <c:pt idx="262">
                  <c:v>1.5417000000000001</c:v>
                </c:pt>
                <c:pt idx="263">
                  <c:v>1.5503</c:v>
                </c:pt>
                <c:pt idx="264">
                  <c:v>1.5588</c:v>
                </c:pt>
                <c:pt idx="265">
                  <c:v>1.5649</c:v>
                </c:pt>
                <c:pt idx="266">
                  <c:v>1.5723</c:v>
                </c:pt>
                <c:pt idx="267">
                  <c:v>1.5784</c:v>
                </c:pt>
                <c:pt idx="268">
                  <c:v>1.5845</c:v>
                </c:pt>
                <c:pt idx="269">
                  <c:v>1.5906</c:v>
                </c:pt>
                <c:pt idx="270">
                  <c:v>1.5967</c:v>
                </c:pt>
                <c:pt idx="271">
                  <c:v>1.6015999999999999</c:v>
                </c:pt>
                <c:pt idx="272">
                  <c:v>1.6076999999999999</c:v>
                </c:pt>
                <c:pt idx="273">
                  <c:v>1.6137999999999999</c:v>
                </c:pt>
                <c:pt idx="274">
                  <c:v>1.6187</c:v>
                </c:pt>
                <c:pt idx="275">
                  <c:v>1.6248</c:v>
                </c:pt>
                <c:pt idx="276">
                  <c:v>1.6284000000000001</c:v>
                </c:pt>
                <c:pt idx="277">
                  <c:v>1.6333</c:v>
                </c:pt>
                <c:pt idx="278">
                  <c:v>1.6382000000000001</c:v>
                </c:pt>
                <c:pt idx="279">
                  <c:v>1.6431</c:v>
                </c:pt>
                <c:pt idx="280">
                  <c:v>1.6467000000000001</c:v>
                </c:pt>
                <c:pt idx="281">
                  <c:v>1.6516</c:v>
                </c:pt>
                <c:pt idx="282">
                  <c:v>1.6553</c:v>
                </c:pt>
                <c:pt idx="283">
                  <c:v>1.6589</c:v>
                </c:pt>
                <c:pt idx="284">
                  <c:v>1.6626000000000001</c:v>
                </c:pt>
                <c:pt idx="285">
                  <c:v>1.6662999999999999</c:v>
                </c:pt>
                <c:pt idx="286">
                  <c:v>1.6698999999999999</c:v>
                </c:pt>
                <c:pt idx="287">
                  <c:v>1.6736</c:v>
                </c:pt>
                <c:pt idx="288">
                  <c:v>1.6785000000000001</c:v>
                </c:pt>
                <c:pt idx="289">
                  <c:v>1.6820999999999999</c:v>
                </c:pt>
                <c:pt idx="290">
                  <c:v>1.6858</c:v>
                </c:pt>
                <c:pt idx="291">
                  <c:v>1.6881999999999999</c:v>
                </c:pt>
                <c:pt idx="292">
                  <c:v>1.6919</c:v>
                </c:pt>
                <c:pt idx="293">
                  <c:v>1.6956</c:v>
                </c:pt>
                <c:pt idx="294">
                  <c:v>1.698</c:v>
                </c:pt>
                <c:pt idx="295">
                  <c:v>1.7017</c:v>
                </c:pt>
                <c:pt idx="296">
                  <c:v>1.7040999999999999</c:v>
                </c:pt>
                <c:pt idx="297">
                  <c:v>1.7078</c:v>
                </c:pt>
                <c:pt idx="298">
                  <c:v>1.7101999999999999</c:v>
                </c:pt>
                <c:pt idx="299">
                  <c:v>1.7125999999999999</c:v>
                </c:pt>
                <c:pt idx="300">
                  <c:v>1.7162999999999999</c:v>
                </c:pt>
                <c:pt idx="301">
                  <c:v>1.7188000000000001</c:v>
                </c:pt>
                <c:pt idx="302">
                  <c:v>1.7212000000000001</c:v>
                </c:pt>
                <c:pt idx="303">
                  <c:v>1.7236</c:v>
                </c:pt>
                <c:pt idx="304">
                  <c:v>1.7261</c:v>
                </c:pt>
                <c:pt idx="305">
                  <c:v>1.7284999999999999</c:v>
                </c:pt>
                <c:pt idx="306">
                  <c:v>1.7310000000000001</c:v>
                </c:pt>
                <c:pt idx="307">
                  <c:v>1.7334000000000001</c:v>
                </c:pt>
                <c:pt idx="308">
                  <c:v>1.7358</c:v>
                </c:pt>
                <c:pt idx="309">
                  <c:v>1.7371000000000001</c:v>
                </c:pt>
                <c:pt idx="310">
                  <c:v>1.7395</c:v>
                </c:pt>
                <c:pt idx="311">
                  <c:v>1.7419</c:v>
                </c:pt>
                <c:pt idx="312">
                  <c:v>1.7444</c:v>
                </c:pt>
                <c:pt idx="313">
                  <c:v>1.7467999999999999</c:v>
                </c:pt>
                <c:pt idx="314">
                  <c:v>1.748</c:v>
                </c:pt>
                <c:pt idx="315">
                  <c:v>1.7493000000000001</c:v>
                </c:pt>
                <c:pt idx="316">
                  <c:v>1.7504999999999999</c:v>
                </c:pt>
                <c:pt idx="317">
                  <c:v>1.7517</c:v>
                </c:pt>
                <c:pt idx="318">
                  <c:v>1.7528999999999999</c:v>
                </c:pt>
                <c:pt idx="319">
                  <c:v>1.7542</c:v>
                </c:pt>
                <c:pt idx="320">
                  <c:v>1.7542</c:v>
                </c:pt>
                <c:pt idx="321">
                  <c:v>1.7554000000000001</c:v>
                </c:pt>
                <c:pt idx="322">
                  <c:v>1.7565999999999999</c:v>
                </c:pt>
                <c:pt idx="323">
                  <c:v>1.7565999999999999</c:v>
                </c:pt>
                <c:pt idx="324">
                  <c:v>1.7578</c:v>
                </c:pt>
                <c:pt idx="325">
                  <c:v>1.7578</c:v>
                </c:pt>
                <c:pt idx="326">
                  <c:v>1.7603</c:v>
                </c:pt>
                <c:pt idx="327">
                  <c:v>1.7603</c:v>
                </c:pt>
                <c:pt idx="328">
                  <c:v>1.7615000000000001</c:v>
                </c:pt>
                <c:pt idx="329">
                  <c:v>1.7626999999999999</c:v>
                </c:pt>
                <c:pt idx="330">
                  <c:v>1.7626999999999999</c:v>
                </c:pt>
                <c:pt idx="331">
                  <c:v>1.7639</c:v>
                </c:pt>
                <c:pt idx="332">
                  <c:v>1.7650999999999999</c:v>
                </c:pt>
                <c:pt idx="333">
                  <c:v>1.7650999999999999</c:v>
                </c:pt>
                <c:pt idx="334">
                  <c:v>1.7664</c:v>
                </c:pt>
                <c:pt idx="335">
                  <c:v>1.7676000000000001</c:v>
                </c:pt>
                <c:pt idx="336">
                  <c:v>1.7687999999999999</c:v>
                </c:pt>
                <c:pt idx="337">
                  <c:v>1.7687999999999999</c:v>
                </c:pt>
                <c:pt idx="338">
                  <c:v>1.77</c:v>
                </c:pt>
                <c:pt idx="339">
                  <c:v>1.7725</c:v>
                </c:pt>
                <c:pt idx="340">
                  <c:v>1.7725</c:v>
                </c:pt>
                <c:pt idx="341">
                  <c:v>1.7737000000000001</c:v>
                </c:pt>
                <c:pt idx="342">
                  <c:v>1.7737000000000001</c:v>
                </c:pt>
                <c:pt idx="343">
                  <c:v>1.7748999999999999</c:v>
                </c:pt>
                <c:pt idx="344">
                  <c:v>1.7761</c:v>
                </c:pt>
                <c:pt idx="345">
                  <c:v>1.7761</c:v>
                </c:pt>
                <c:pt idx="346">
                  <c:v>1.7773000000000001</c:v>
                </c:pt>
                <c:pt idx="347">
                  <c:v>1.7773000000000001</c:v>
                </c:pt>
                <c:pt idx="348">
                  <c:v>1.7786</c:v>
                </c:pt>
                <c:pt idx="349">
                  <c:v>1.7798</c:v>
                </c:pt>
                <c:pt idx="350">
                  <c:v>1.7798</c:v>
                </c:pt>
                <c:pt idx="351">
                  <c:v>1.7809999999999999</c:v>
                </c:pt>
                <c:pt idx="352">
                  <c:v>1.7809999999999999</c:v>
                </c:pt>
                <c:pt idx="353">
                  <c:v>1.7822</c:v>
                </c:pt>
                <c:pt idx="354">
                  <c:v>1.7822</c:v>
                </c:pt>
                <c:pt idx="355">
                  <c:v>1.7834000000000001</c:v>
                </c:pt>
                <c:pt idx="356">
                  <c:v>1.7834000000000001</c:v>
                </c:pt>
                <c:pt idx="357">
                  <c:v>1.7847</c:v>
                </c:pt>
                <c:pt idx="358">
                  <c:v>1.7847</c:v>
                </c:pt>
                <c:pt idx="359">
                  <c:v>1.7859</c:v>
                </c:pt>
                <c:pt idx="360">
                  <c:v>1.7859</c:v>
                </c:pt>
                <c:pt idx="361">
                  <c:v>1.7870999999999999</c:v>
                </c:pt>
                <c:pt idx="362">
                  <c:v>1.7870999999999999</c:v>
                </c:pt>
                <c:pt idx="363">
                  <c:v>1.7870999999999999</c:v>
                </c:pt>
                <c:pt idx="364">
                  <c:v>1.7883</c:v>
                </c:pt>
                <c:pt idx="365">
                  <c:v>1.7870999999999999</c:v>
                </c:pt>
                <c:pt idx="366">
                  <c:v>1.7883</c:v>
                </c:pt>
                <c:pt idx="367">
                  <c:v>1.7883</c:v>
                </c:pt>
                <c:pt idx="368">
                  <c:v>1.7883</c:v>
                </c:pt>
                <c:pt idx="369">
                  <c:v>1.7883</c:v>
                </c:pt>
                <c:pt idx="370">
                  <c:v>1.7870999999999999</c:v>
                </c:pt>
                <c:pt idx="371">
                  <c:v>1.7870999999999999</c:v>
                </c:pt>
                <c:pt idx="372">
                  <c:v>1.7870999999999999</c:v>
                </c:pt>
                <c:pt idx="373">
                  <c:v>1.7859</c:v>
                </c:pt>
                <c:pt idx="374">
                  <c:v>1.7859</c:v>
                </c:pt>
                <c:pt idx="375">
                  <c:v>1.7859</c:v>
                </c:pt>
                <c:pt idx="376">
                  <c:v>1.7847</c:v>
                </c:pt>
                <c:pt idx="377">
                  <c:v>1.7847</c:v>
                </c:pt>
                <c:pt idx="378">
                  <c:v>1.7847</c:v>
                </c:pt>
                <c:pt idx="379">
                  <c:v>1.7847</c:v>
                </c:pt>
                <c:pt idx="380">
                  <c:v>1.7834000000000001</c:v>
                </c:pt>
                <c:pt idx="381">
                  <c:v>1.7834000000000001</c:v>
                </c:pt>
                <c:pt idx="382">
                  <c:v>1.7822</c:v>
                </c:pt>
                <c:pt idx="383">
                  <c:v>1.7809999999999999</c:v>
                </c:pt>
                <c:pt idx="384">
                  <c:v>1.7798</c:v>
                </c:pt>
                <c:pt idx="385">
                  <c:v>1.7798</c:v>
                </c:pt>
                <c:pt idx="386">
                  <c:v>1.7773000000000001</c:v>
                </c:pt>
                <c:pt idx="387">
                  <c:v>1.7748999999999999</c:v>
                </c:pt>
                <c:pt idx="388">
                  <c:v>1.7725</c:v>
                </c:pt>
                <c:pt idx="389">
                  <c:v>1.7687999999999999</c:v>
                </c:pt>
                <c:pt idx="390">
                  <c:v>1.7650999999999999</c:v>
                </c:pt>
                <c:pt idx="391">
                  <c:v>1.7603</c:v>
                </c:pt>
                <c:pt idx="392">
                  <c:v>1.7528999999999999</c:v>
                </c:pt>
                <c:pt idx="393">
                  <c:v>1.7467999999999999</c:v>
                </c:pt>
                <c:pt idx="394">
                  <c:v>1.7395</c:v>
                </c:pt>
                <c:pt idx="395">
                  <c:v>1.7310000000000001</c:v>
                </c:pt>
                <c:pt idx="396">
                  <c:v>1.7223999999999999</c:v>
                </c:pt>
                <c:pt idx="397">
                  <c:v>1.7139</c:v>
                </c:pt>
                <c:pt idx="398">
                  <c:v>1.7078</c:v>
                </c:pt>
                <c:pt idx="399">
                  <c:v>1.7017</c:v>
                </c:pt>
                <c:pt idx="400">
                  <c:v>1.6942999999999999</c:v>
                </c:pt>
                <c:pt idx="401">
                  <c:v>1.6881999999999999</c:v>
                </c:pt>
                <c:pt idx="402">
                  <c:v>1.6809000000000001</c:v>
                </c:pt>
                <c:pt idx="403">
                  <c:v>1.6724000000000001</c:v>
                </c:pt>
                <c:pt idx="404">
                  <c:v>1.6626000000000001</c:v>
                </c:pt>
                <c:pt idx="405">
                  <c:v>1.6504000000000001</c:v>
                </c:pt>
                <c:pt idx="406">
                  <c:v>1.637</c:v>
                </c:pt>
                <c:pt idx="407">
                  <c:v>1.6211</c:v>
                </c:pt>
                <c:pt idx="408">
                  <c:v>1.6040000000000001</c:v>
                </c:pt>
                <c:pt idx="409">
                  <c:v>1.5845</c:v>
                </c:pt>
                <c:pt idx="410">
                  <c:v>1.5625</c:v>
                </c:pt>
                <c:pt idx="411">
                  <c:v>1.5381</c:v>
                </c:pt>
                <c:pt idx="412">
                  <c:v>1.5161</c:v>
                </c:pt>
                <c:pt idx="413">
                  <c:v>1.4965999999999999</c:v>
                </c:pt>
                <c:pt idx="414">
                  <c:v>1.4771000000000001</c:v>
                </c:pt>
                <c:pt idx="415">
                  <c:v>1.46</c:v>
                </c:pt>
                <c:pt idx="416">
                  <c:v>1.4403999999999999</c:v>
                </c:pt>
                <c:pt idx="417">
                  <c:v>1.4220999999999999</c:v>
                </c:pt>
                <c:pt idx="418">
                  <c:v>1.403799999999999</c:v>
                </c:pt>
                <c:pt idx="419">
                  <c:v>1.3831</c:v>
                </c:pt>
                <c:pt idx="420">
                  <c:v>1.3660000000000001</c:v>
                </c:pt>
                <c:pt idx="421">
                  <c:v>1.3512999999999999</c:v>
                </c:pt>
                <c:pt idx="422">
                  <c:v>1.3391</c:v>
                </c:pt>
                <c:pt idx="423">
                  <c:v>1.3292999999999999</c:v>
                </c:pt>
                <c:pt idx="424">
                  <c:v>1.3184</c:v>
                </c:pt>
                <c:pt idx="425">
                  <c:v>1.3073999999999999</c:v>
                </c:pt>
                <c:pt idx="426">
                  <c:v>1.2951999999999999</c:v>
                </c:pt>
                <c:pt idx="427">
                  <c:v>1.2781</c:v>
                </c:pt>
                <c:pt idx="428">
                  <c:v>1.2573000000000001</c:v>
                </c:pt>
                <c:pt idx="429">
                  <c:v>1.2365999999999999</c:v>
                </c:pt>
                <c:pt idx="430">
                  <c:v>1.2145999999999999</c:v>
                </c:pt>
                <c:pt idx="431">
                  <c:v>1.1926000000000001</c:v>
                </c:pt>
                <c:pt idx="432">
                  <c:v>1.1694</c:v>
                </c:pt>
                <c:pt idx="433">
                  <c:v>1.1437999999999999</c:v>
                </c:pt>
                <c:pt idx="434">
                  <c:v>1.1182000000000001</c:v>
                </c:pt>
                <c:pt idx="435">
                  <c:v>1.0925</c:v>
                </c:pt>
                <c:pt idx="436">
                  <c:v>1.0645</c:v>
                </c:pt>
                <c:pt idx="437">
                  <c:v>1.0315000000000001</c:v>
                </c:pt>
                <c:pt idx="438">
                  <c:v>1.0022</c:v>
                </c:pt>
                <c:pt idx="439">
                  <c:v>0.97289999999999999</c:v>
                </c:pt>
                <c:pt idx="440">
                  <c:v>0.95093000000000005</c:v>
                </c:pt>
                <c:pt idx="441">
                  <c:v>0.93628</c:v>
                </c:pt>
                <c:pt idx="442">
                  <c:v>0.92406999999999995</c:v>
                </c:pt>
                <c:pt idx="443">
                  <c:v>0.91430999999999996</c:v>
                </c:pt>
                <c:pt idx="444">
                  <c:v>0.90698000000000001</c:v>
                </c:pt>
                <c:pt idx="445">
                  <c:v>0.89722000000000002</c:v>
                </c:pt>
                <c:pt idx="446">
                  <c:v>0.89110999999999996</c:v>
                </c:pt>
                <c:pt idx="447">
                  <c:v>0.88256999999999997</c:v>
                </c:pt>
                <c:pt idx="448">
                  <c:v>0.87402000000000002</c:v>
                </c:pt>
                <c:pt idx="449">
                  <c:v>0.86548000000000003</c:v>
                </c:pt>
                <c:pt idx="450">
                  <c:v>0.85570999999999997</c:v>
                </c:pt>
                <c:pt idx="451">
                  <c:v>0.84716999999999998</c:v>
                </c:pt>
                <c:pt idx="452">
                  <c:v>0.83862000000000003</c:v>
                </c:pt>
                <c:pt idx="453">
                  <c:v>0.83008000000000004</c:v>
                </c:pt>
                <c:pt idx="454">
                  <c:v>0.82520000000000004</c:v>
                </c:pt>
                <c:pt idx="455">
                  <c:v>0.81908999999999998</c:v>
                </c:pt>
                <c:pt idx="456">
                  <c:v>0.81420999999999999</c:v>
                </c:pt>
                <c:pt idx="457">
                  <c:v>0.80932999999999999</c:v>
                </c:pt>
                <c:pt idx="458">
                  <c:v>0.80566000000000004</c:v>
                </c:pt>
                <c:pt idx="459">
                  <c:v>0.80078000000000005</c:v>
                </c:pt>
                <c:pt idx="460">
                  <c:v>0.79834000000000005</c:v>
                </c:pt>
                <c:pt idx="461">
                  <c:v>0.79712000000000005</c:v>
                </c:pt>
                <c:pt idx="462">
                  <c:v>0.79468000000000005</c:v>
                </c:pt>
                <c:pt idx="463">
                  <c:v>0.79101999999999995</c:v>
                </c:pt>
                <c:pt idx="464">
                  <c:v>0.78978999999999999</c:v>
                </c:pt>
                <c:pt idx="465">
                  <c:v>0.78734999999999999</c:v>
                </c:pt>
                <c:pt idx="466">
                  <c:v>0.78491</c:v>
                </c:pt>
                <c:pt idx="467">
                  <c:v>0.78247</c:v>
                </c:pt>
                <c:pt idx="468">
                  <c:v>0.78003</c:v>
                </c:pt>
                <c:pt idx="469">
                  <c:v>0.77759</c:v>
                </c:pt>
                <c:pt idx="470">
                  <c:v>0.77515000000000001</c:v>
                </c:pt>
                <c:pt idx="471">
                  <c:v>0.77148000000000005</c:v>
                </c:pt>
                <c:pt idx="472">
                  <c:v>0.77025999999999994</c:v>
                </c:pt>
                <c:pt idx="473">
                  <c:v>0.76659999999999995</c:v>
                </c:pt>
                <c:pt idx="474">
                  <c:v>0.76537999999999995</c:v>
                </c:pt>
                <c:pt idx="475">
                  <c:v>0.76293999999999995</c:v>
                </c:pt>
                <c:pt idx="476">
                  <c:v>0.76049999999999995</c:v>
                </c:pt>
                <c:pt idx="477">
                  <c:v>0.75683999999999996</c:v>
                </c:pt>
                <c:pt idx="478">
                  <c:v>0.75561999999999996</c:v>
                </c:pt>
                <c:pt idx="479">
                  <c:v>0.75317000000000001</c:v>
                </c:pt>
                <c:pt idx="480">
                  <c:v>0.75317000000000001</c:v>
                </c:pt>
                <c:pt idx="481">
                  <c:v>0.75439000000000001</c:v>
                </c:pt>
                <c:pt idx="482">
                  <c:v>0.75439000000000001</c:v>
                </c:pt>
                <c:pt idx="483">
                  <c:v>0.75317000000000001</c:v>
                </c:pt>
                <c:pt idx="484">
                  <c:v>0.75195000000000001</c:v>
                </c:pt>
                <c:pt idx="485">
                  <c:v>0.75195000000000001</c:v>
                </c:pt>
                <c:pt idx="486">
                  <c:v>0.75073000000000001</c:v>
                </c:pt>
                <c:pt idx="487">
                  <c:v>0.75073000000000001</c:v>
                </c:pt>
                <c:pt idx="488">
                  <c:v>0.75073000000000001</c:v>
                </c:pt>
                <c:pt idx="489">
                  <c:v>0.74951000000000001</c:v>
                </c:pt>
                <c:pt idx="490">
                  <c:v>0.74829000000000001</c:v>
                </c:pt>
                <c:pt idx="491">
                  <c:v>0.74707000000000001</c:v>
                </c:pt>
                <c:pt idx="492">
                  <c:v>0.74585000000000001</c:v>
                </c:pt>
                <c:pt idx="493">
                  <c:v>0.74463000000000001</c:v>
                </c:pt>
                <c:pt idx="494">
                  <c:v>0.74341000000000002</c:v>
                </c:pt>
                <c:pt idx="495">
                  <c:v>0.74219000000000002</c:v>
                </c:pt>
                <c:pt idx="496">
                  <c:v>0.74097000000000002</c:v>
                </c:pt>
                <c:pt idx="497">
                  <c:v>0.73975000000000002</c:v>
                </c:pt>
                <c:pt idx="498">
                  <c:v>0.73729999999999996</c:v>
                </c:pt>
                <c:pt idx="499">
                  <c:v>0.73607999999999996</c:v>
                </c:pt>
                <c:pt idx="500">
                  <c:v>0.73485999999999996</c:v>
                </c:pt>
                <c:pt idx="501">
                  <c:v>0.73363999999999996</c:v>
                </c:pt>
                <c:pt idx="502">
                  <c:v>0.73241999999999996</c:v>
                </c:pt>
                <c:pt idx="503">
                  <c:v>0.73119999999999996</c:v>
                </c:pt>
                <c:pt idx="504">
                  <c:v>0.72997999999999996</c:v>
                </c:pt>
                <c:pt idx="505">
                  <c:v>0.72997999999999996</c:v>
                </c:pt>
                <c:pt idx="506">
                  <c:v>0.72997999999999996</c:v>
                </c:pt>
                <c:pt idx="507">
                  <c:v>0.72875999999999996</c:v>
                </c:pt>
                <c:pt idx="508">
                  <c:v>0.72997999999999996</c:v>
                </c:pt>
                <c:pt idx="509">
                  <c:v>0.72875999999999996</c:v>
                </c:pt>
                <c:pt idx="510">
                  <c:v>0.72753999999999996</c:v>
                </c:pt>
                <c:pt idx="511">
                  <c:v>0.72875999999999996</c:v>
                </c:pt>
                <c:pt idx="512">
                  <c:v>0.72753999999999996</c:v>
                </c:pt>
                <c:pt idx="513">
                  <c:v>0.72631999999999997</c:v>
                </c:pt>
                <c:pt idx="514">
                  <c:v>0.72631999999999997</c:v>
                </c:pt>
                <c:pt idx="515">
                  <c:v>0.72509999999999997</c:v>
                </c:pt>
                <c:pt idx="516">
                  <c:v>0.72387999999999997</c:v>
                </c:pt>
                <c:pt idx="517">
                  <c:v>0.72387999999999997</c:v>
                </c:pt>
                <c:pt idx="518">
                  <c:v>0.72387999999999997</c:v>
                </c:pt>
                <c:pt idx="519">
                  <c:v>0.72143999999999997</c:v>
                </c:pt>
                <c:pt idx="520">
                  <c:v>0.72021000000000002</c:v>
                </c:pt>
                <c:pt idx="521">
                  <c:v>0.71899000000000002</c:v>
                </c:pt>
                <c:pt idx="522">
                  <c:v>0.71899000000000002</c:v>
                </c:pt>
                <c:pt idx="523">
                  <c:v>0.71899000000000002</c:v>
                </c:pt>
                <c:pt idx="524">
                  <c:v>0.71899000000000002</c:v>
                </c:pt>
                <c:pt idx="525">
                  <c:v>0.72021000000000002</c:v>
                </c:pt>
                <c:pt idx="526">
                  <c:v>0.72021000000000002</c:v>
                </c:pt>
                <c:pt idx="527">
                  <c:v>0.72021000000000002</c:v>
                </c:pt>
                <c:pt idx="528">
                  <c:v>0.72021000000000002</c:v>
                </c:pt>
                <c:pt idx="529">
                  <c:v>0.72021000000000002</c:v>
                </c:pt>
                <c:pt idx="530">
                  <c:v>0.71899000000000002</c:v>
                </c:pt>
                <c:pt idx="531">
                  <c:v>0.71899000000000002</c:v>
                </c:pt>
                <c:pt idx="532">
                  <c:v>0.72021000000000002</c:v>
                </c:pt>
                <c:pt idx="533">
                  <c:v>0.71899000000000002</c:v>
                </c:pt>
                <c:pt idx="534">
                  <c:v>0.71899000000000002</c:v>
                </c:pt>
                <c:pt idx="535">
                  <c:v>0.71777000000000002</c:v>
                </c:pt>
                <c:pt idx="536">
                  <c:v>0.71655000000000002</c:v>
                </c:pt>
                <c:pt idx="537">
                  <c:v>0.71655000000000002</c:v>
                </c:pt>
                <c:pt idx="538">
                  <c:v>0.71777000000000002</c:v>
                </c:pt>
                <c:pt idx="539">
                  <c:v>0.71899000000000002</c:v>
                </c:pt>
                <c:pt idx="540">
                  <c:v>0.71899000000000002</c:v>
                </c:pt>
                <c:pt idx="541">
                  <c:v>0.71777000000000002</c:v>
                </c:pt>
                <c:pt idx="542">
                  <c:v>0.71777000000000002</c:v>
                </c:pt>
                <c:pt idx="543">
                  <c:v>0.71777000000000002</c:v>
                </c:pt>
                <c:pt idx="544">
                  <c:v>0.71777000000000002</c:v>
                </c:pt>
                <c:pt idx="545">
                  <c:v>0.71899000000000002</c:v>
                </c:pt>
                <c:pt idx="546">
                  <c:v>0.72021000000000002</c:v>
                </c:pt>
                <c:pt idx="547">
                  <c:v>0.72021000000000002</c:v>
                </c:pt>
                <c:pt idx="548">
                  <c:v>0.72021000000000002</c:v>
                </c:pt>
                <c:pt idx="549">
                  <c:v>0.72021000000000002</c:v>
                </c:pt>
                <c:pt idx="550">
                  <c:v>0.72021000000000002</c:v>
                </c:pt>
                <c:pt idx="551">
                  <c:v>0.72021000000000002</c:v>
                </c:pt>
                <c:pt idx="552">
                  <c:v>0.72021000000000002</c:v>
                </c:pt>
                <c:pt idx="553">
                  <c:v>0.72021000000000002</c:v>
                </c:pt>
                <c:pt idx="554">
                  <c:v>0.71899000000000002</c:v>
                </c:pt>
                <c:pt idx="555">
                  <c:v>0.71899000000000002</c:v>
                </c:pt>
                <c:pt idx="556">
                  <c:v>0.71777000000000002</c:v>
                </c:pt>
                <c:pt idx="557">
                  <c:v>0.71655000000000002</c:v>
                </c:pt>
                <c:pt idx="558">
                  <c:v>0.71655000000000002</c:v>
                </c:pt>
                <c:pt idx="559">
                  <c:v>0.71533000000000002</c:v>
                </c:pt>
                <c:pt idx="560">
                  <c:v>0.71533000000000002</c:v>
                </c:pt>
                <c:pt idx="561">
                  <c:v>0.71655000000000002</c:v>
                </c:pt>
                <c:pt idx="562">
                  <c:v>0.71533000000000002</c:v>
                </c:pt>
                <c:pt idx="563">
                  <c:v>0.71533000000000002</c:v>
                </c:pt>
                <c:pt idx="564">
                  <c:v>0.71533000000000002</c:v>
                </c:pt>
                <c:pt idx="565">
                  <c:v>0.71533000000000002</c:v>
                </c:pt>
                <c:pt idx="566">
                  <c:v>0.71533000000000002</c:v>
                </c:pt>
                <c:pt idx="567">
                  <c:v>0.71655000000000002</c:v>
                </c:pt>
                <c:pt idx="568">
                  <c:v>0.71655000000000002</c:v>
                </c:pt>
                <c:pt idx="569">
                  <c:v>0.71655000000000002</c:v>
                </c:pt>
                <c:pt idx="570">
                  <c:v>0.71655000000000002</c:v>
                </c:pt>
                <c:pt idx="571">
                  <c:v>0.71655000000000002</c:v>
                </c:pt>
                <c:pt idx="572">
                  <c:v>0.71533000000000002</c:v>
                </c:pt>
                <c:pt idx="573">
                  <c:v>0.71533000000000002</c:v>
                </c:pt>
                <c:pt idx="574">
                  <c:v>0.71533000000000002</c:v>
                </c:pt>
                <c:pt idx="575">
                  <c:v>0.71533000000000002</c:v>
                </c:pt>
                <c:pt idx="576">
                  <c:v>0.71655000000000002</c:v>
                </c:pt>
                <c:pt idx="577">
                  <c:v>0.71777000000000002</c:v>
                </c:pt>
                <c:pt idx="578">
                  <c:v>0.71899000000000002</c:v>
                </c:pt>
                <c:pt idx="579">
                  <c:v>0.71899000000000002</c:v>
                </c:pt>
                <c:pt idx="580">
                  <c:v>0.71777000000000002</c:v>
                </c:pt>
                <c:pt idx="581">
                  <c:v>0.71655000000000002</c:v>
                </c:pt>
                <c:pt idx="582">
                  <c:v>0.71533000000000002</c:v>
                </c:pt>
                <c:pt idx="583">
                  <c:v>0.71411000000000002</c:v>
                </c:pt>
                <c:pt idx="584">
                  <c:v>0.71289000000000002</c:v>
                </c:pt>
                <c:pt idx="585">
                  <c:v>0.71289000000000002</c:v>
                </c:pt>
                <c:pt idx="586">
                  <c:v>0.71167000000000002</c:v>
                </c:pt>
                <c:pt idx="587">
                  <c:v>0.71167000000000002</c:v>
                </c:pt>
                <c:pt idx="588">
                  <c:v>0.71289000000000002</c:v>
                </c:pt>
                <c:pt idx="589">
                  <c:v>0.71289000000000002</c:v>
                </c:pt>
                <c:pt idx="590">
                  <c:v>0.71411000000000002</c:v>
                </c:pt>
                <c:pt idx="591">
                  <c:v>0.71411000000000002</c:v>
                </c:pt>
                <c:pt idx="592">
                  <c:v>0.71411000000000002</c:v>
                </c:pt>
                <c:pt idx="593">
                  <c:v>0.71411000000000002</c:v>
                </c:pt>
                <c:pt idx="594">
                  <c:v>0.71411000000000002</c:v>
                </c:pt>
                <c:pt idx="595">
                  <c:v>0.71289000000000002</c:v>
                </c:pt>
                <c:pt idx="596">
                  <c:v>0.71289000000000002</c:v>
                </c:pt>
                <c:pt idx="597">
                  <c:v>0.71289000000000002</c:v>
                </c:pt>
                <c:pt idx="598">
                  <c:v>0.71289000000000002</c:v>
                </c:pt>
                <c:pt idx="599">
                  <c:v>0.71289000000000002</c:v>
                </c:pt>
                <c:pt idx="600">
                  <c:v>0.71167000000000002</c:v>
                </c:pt>
                <c:pt idx="601">
                  <c:v>0.71045000000000003</c:v>
                </c:pt>
                <c:pt idx="602">
                  <c:v>0.71045000000000003</c:v>
                </c:pt>
                <c:pt idx="603">
                  <c:v>0.70923000000000003</c:v>
                </c:pt>
                <c:pt idx="604">
                  <c:v>0.70923000000000003</c:v>
                </c:pt>
                <c:pt idx="605">
                  <c:v>0.70923000000000003</c:v>
                </c:pt>
                <c:pt idx="606">
                  <c:v>0.70801000000000003</c:v>
                </c:pt>
                <c:pt idx="607">
                  <c:v>0.70679000000000003</c:v>
                </c:pt>
                <c:pt idx="608">
                  <c:v>0.70679000000000003</c:v>
                </c:pt>
                <c:pt idx="609">
                  <c:v>0.70679000000000003</c:v>
                </c:pt>
                <c:pt idx="610">
                  <c:v>0.70679000000000003</c:v>
                </c:pt>
                <c:pt idx="611">
                  <c:v>0.70801000000000003</c:v>
                </c:pt>
                <c:pt idx="612">
                  <c:v>0.70801000000000003</c:v>
                </c:pt>
                <c:pt idx="613">
                  <c:v>0.70679000000000003</c:v>
                </c:pt>
                <c:pt idx="614">
                  <c:v>0.70801000000000003</c:v>
                </c:pt>
                <c:pt idx="615">
                  <c:v>0.70679000000000003</c:v>
                </c:pt>
                <c:pt idx="616">
                  <c:v>0.70679000000000003</c:v>
                </c:pt>
                <c:pt idx="617">
                  <c:v>0.70679000000000003</c:v>
                </c:pt>
                <c:pt idx="618">
                  <c:v>0.70679000000000003</c:v>
                </c:pt>
                <c:pt idx="619">
                  <c:v>0.70679000000000003</c:v>
                </c:pt>
                <c:pt idx="620">
                  <c:v>0.70557000000000003</c:v>
                </c:pt>
                <c:pt idx="621">
                  <c:v>0.70557000000000003</c:v>
                </c:pt>
                <c:pt idx="622">
                  <c:v>0.70557000000000003</c:v>
                </c:pt>
                <c:pt idx="623">
                  <c:v>0.70435000000000003</c:v>
                </c:pt>
                <c:pt idx="624">
                  <c:v>0.70313000000000003</c:v>
                </c:pt>
                <c:pt idx="625">
                  <c:v>0.70313000000000003</c:v>
                </c:pt>
                <c:pt idx="626">
                  <c:v>0.70189999999999997</c:v>
                </c:pt>
                <c:pt idx="627">
                  <c:v>0.70189999999999997</c:v>
                </c:pt>
                <c:pt idx="628">
                  <c:v>0.70067999999999997</c:v>
                </c:pt>
                <c:pt idx="629">
                  <c:v>0.69945999999999997</c:v>
                </c:pt>
                <c:pt idx="630">
                  <c:v>0.69823999999999997</c:v>
                </c:pt>
                <c:pt idx="631">
                  <c:v>0.69823999999999997</c:v>
                </c:pt>
                <c:pt idx="632">
                  <c:v>0.69823999999999997</c:v>
                </c:pt>
                <c:pt idx="633">
                  <c:v>0.69701999999999997</c:v>
                </c:pt>
                <c:pt idx="634">
                  <c:v>0.69701999999999997</c:v>
                </c:pt>
                <c:pt idx="635">
                  <c:v>0.69701999999999997</c:v>
                </c:pt>
                <c:pt idx="636">
                  <c:v>0.69579999999999997</c:v>
                </c:pt>
                <c:pt idx="637">
                  <c:v>0.69579999999999997</c:v>
                </c:pt>
                <c:pt idx="638">
                  <c:v>0.69701999999999997</c:v>
                </c:pt>
                <c:pt idx="639">
                  <c:v>0.69579999999999997</c:v>
                </c:pt>
                <c:pt idx="640">
                  <c:v>0.69579999999999997</c:v>
                </c:pt>
                <c:pt idx="641">
                  <c:v>0.69579999999999997</c:v>
                </c:pt>
                <c:pt idx="642">
                  <c:v>0.69457999999999998</c:v>
                </c:pt>
                <c:pt idx="643">
                  <c:v>0.69457999999999998</c:v>
                </c:pt>
                <c:pt idx="644">
                  <c:v>0.69335999999999998</c:v>
                </c:pt>
                <c:pt idx="645">
                  <c:v>0.69213999999999998</c:v>
                </c:pt>
                <c:pt idx="646">
                  <c:v>0.69213999999999998</c:v>
                </c:pt>
                <c:pt idx="647">
                  <c:v>0.69091999999999998</c:v>
                </c:pt>
                <c:pt idx="648">
                  <c:v>0.69091999999999998</c:v>
                </c:pt>
                <c:pt idx="649">
                  <c:v>0.68969999999999998</c:v>
                </c:pt>
                <c:pt idx="650">
                  <c:v>0.68969999999999998</c:v>
                </c:pt>
                <c:pt idx="651">
                  <c:v>0.68969999999999998</c:v>
                </c:pt>
                <c:pt idx="652">
                  <c:v>0.68847999999999998</c:v>
                </c:pt>
                <c:pt idx="653">
                  <c:v>0.68847999999999998</c:v>
                </c:pt>
                <c:pt idx="654">
                  <c:v>0.68725999999999998</c:v>
                </c:pt>
                <c:pt idx="655">
                  <c:v>0.68725999999999998</c:v>
                </c:pt>
                <c:pt idx="656">
                  <c:v>0.68725999999999998</c:v>
                </c:pt>
                <c:pt idx="657">
                  <c:v>0.68725999999999998</c:v>
                </c:pt>
                <c:pt idx="658">
                  <c:v>0.68725999999999998</c:v>
                </c:pt>
                <c:pt idx="659">
                  <c:v>0.68725999999999998</c:v>
                </c:pt>
                <c:pt idx="660">
                  <c:v>0.68603999999999998</c:v>
                </c:pt>
                <c:pt idx="661">
                  <c:v>0.68725999999999998</c:v>
                </c:pt>
                <c:pt idx="662">
                  <c:v>0.68725999999999998</c:v>
                </c:pt>
                <c:pt idx="663">
                  <c:v>0.68725999999999998</c:v>
                </c:pt>
                <c:pt idx="664">
                  <c:v>0.68603999999999998</c:v>
                </c:pt>
                <c:pt idx="665">
                  <c:v>0.68603999999999998</c:v>
                </c:pt>
                <c:pt idx="666">
                  <c:v>0.68603999999999998</c:v>
                </c:pt>
                <c:pt idx="667">
                  <c:v>0.68481000000000003</c:v>
                </c:pt>
                <c:pt idx="668">
                  <c:v>0.68359000000000003</c:v>
                </c:pt>
                <c:pt idx="669">
                  <c:v>0.68237000000000003</c:v>
                </c:pt>
                <c:pt idx="670">
                  <c:v>0.68115000000000003</c:v>
                </c:pt>
                <c:pt idx="671">
                  <c:v>0.67993000000000003</c:v>
                </c:pt>
                <c:pt idx="672">
                  <c:v>0.67993000000000003</c:v>
                </c:pt>
                <c:pt idx="673">
                  <c:v>0.67749000000000004</c:v>
                </c:pt>
                <c:pt idx="674">
                  <c:v>0.67627000000000004</c:v>
                </c:pt>
                <c:pt idx="675">
                  <c:v>0.67505000000000004</c:v>
                </c:pt>
                <c:pt idx="676">
                  <c:v>0.67383000000000004</c:v>
                </c:pt>
                <c:pt idx="677">
                  <c:v>0.67383000000000004</c:v>
                </c:pt>
                <c:pt idx="678">
                  <c:v>0.67383000000000004</c:v>
                </c:pt>
                <c:pt idx="679">
                  <c:v>0.67383000000000004</c:v>
                </c:pt>
                <c:pt idx="680">
                  <c:v>0.67383000000000004</c:v>
                </c:pt>
                <c:pt idx="681">
                  <c:v>0.67383000000000004</c:v>
                </c:pt>
                <c:pt idx="682">
                  <c:v>0.67383000000000004</c:v>
                </c:pt>
                <c:pt idx="683">
                  <c:v>0.67383000000000004</c:v>
                </c:pt>
                <c:pt idx="684">
                  <c:v>0.67383000000000004</c:v>
                </c:pt>
                <c:pt idx="685">
                  <c:v>0.67383000000000004</c:v>
                </c:pt>
                <c:pt idx="686">
                  <c:v>0.67383000000000004</c:v>
                </c:pt>
                <c:pt idx="687">
                  <c:v>0.67383000000000004</c:v>
                </c:pt>
                <c:pt idx="688">
                  <c:v>0.67261000000000004</c:v>
                </c:pt>
                <c:pt idx="689">
                  <c:v>0.67139000000000004</c:v>
                </c:pt>
                <c:pt idx="690">
                  <c:v>0.67017000000000004</c:v>
                </c:pt>
                <c:pt idx="691">
                  <c:v>0.66895000000000004</c:v>
                </c:pt>
                <c:pt idx="692">
                  <c:v>0.66771999999999998</c:v>
                </c:pt>
                <c:pt idx="693">
                  <c:v>0.66771999999999998</c:v>
                </c:pt>
                <c:pt idx="694">
                  <c:v>0.66649999999999998</c:v>
                </c:pt>
                <c:pt idx="695">
                  <c:v>0.66527999999999998</c:v>
                </c:pt>
                <c:pt idx="696">
                  <c:v>0.66405999999999998</c:v>
                </c:pt>
                <c:pt idx="697">
                  <c:v>0.66283999999999998</c:v>
                </c:pt>
                <c:pt idx="698">
                  <c:v>0.66283999999999998</c:v>
                </c:pt>
                <c:pt idx="699">
                  <c:v>0.66283999999999998</c:v>
                </c:pt>
                <c:pt idx="700">
                  <c:v>0.66283999999999998</c:v>
                </c:pt>
                <c:pt idx="701">
                  <c:v>0.66283999999999998</c:v>
                </c:pt>
                <c:pt idx="702">
                  <c:v>0.66283999999999998</c:v>
                </c:pt>
                <c:pt idx="703">
                  <c:v>0.66405999999999998</c:v>
                </c:pt>
                <c:pt idx="704">
                  <c:v>0.66283999999999998</c:v>
                </c:pt>
                <c:pt idx="705">
                  <c:v>0.66283999999999998</c:v>
                </c:pt>
                <c:pt idx="706">
                  <c:v>0.66283999999999998</c:v>
                </c:pt>
                <c:pt idx="707">
                  <c:v>0.66161999999999999</c:v>
                </c:pt>
                <c:pt idx="708">
                  <c:v>0.66039999999999999</c:v>
                </c:pt>
                <c:pt idx="709">
                  <c:v>0.65917999999999999</c:v>
                </c:pt>
                <c:pt idx="710">
                  <c:v>0.65795999999999999</c:v>
                </c:pt>
                <c:pt idx="711">
                  <c:v>0.65673999999999999</c:v>
                </c:pt>
                <c:pt idx="712">
                  <c:v>0.65551999999999999</c:v>
                </c:pt>
                <c:pt idx="713">
                  <c:v>0.65551999999999999</c:v>
                </c:pt>
                <c:pt idx="714">
                  <c:v>0.65307999999999999</c:v>
                </c:pt>
                <c:pt idx="715">
                  <c:v>0.65185999999999999</c:v>
                </c:pt>
                <c:pt idx="716">
                  <c:v>0.65063000000000004</c:v>
                </c:pt>
                <c:pt idx="717">
                  <c:v>0.64941000000000004</c:v>
                </c:pt>
                <c:pt idx="718">
                  <c:v>0.65063000000000004</c:v>
                </c:pt>
                <c:pt idx="719">
                  <c:v>0.65063000000000004</c:v>
                </c:pt>
                <c:pt idx="720">
                  <c:v>0.65185999999999999</c:v>
                </c:pt>
                <c:pt idx="721">
                  <c:v>0.65185999999999999</c:v>
                </c:pt>
                <c:pt idx="722">
                  <c:v>0.65185999999999999</c:v>
                </c:pt>
                <c:pt idx="723">
                  <c:v>0.65307999999999999</c:v>
                </c:pt>
                <c:pt idx="724">
                  <c:v>0.65307999999999999</c:v>
                </c:pt>
                <c:pt idx="725">
                  <c:v>0.65307999999999999</c:v>
                </c:pt>
                <c:pt idx="726">
                  <c:v>0.65307999999999999</c:v>
                </c:pt>
                <c:pt idx="727">
                  <c:v>0.65185999999999999</c:v>
                </c:pt>
                <c:pt idx="728">
                  <c:v>0.65185999999999999</c:v>
                </c:pt>
                <c:pt idx="729">
                  <c:v>0.65063000000000004</c:v>
                </c:pt>
                <c:pt idx="730">
                  <c:v>0.64941000000000004</c:v>
                </c:pt>
                <c:pt idx="731">
                  <c:v>0.64941000000000004</c:v>
                </c:pt>
                <c:pt idx="732">
                  <c:v>0.64941000000000004</c:v>
                </c:pt>
                <c:pt idx="733">
                  <c:v>0.64941000000000004</c:v>
                </c:pt>
                <c:pt idx="734">
                  <c:v>0.64941000000000004</c:v>
                </c:pt>
                <c:pt idx="735">
                  <c:v>0.64819000000000004</c:v>
                </c:pt>
                <c:pt idx="736">
                  <c:v>0.64819000000000004</c:v>
                </c:pt>
                <c:pt idx="737">
                  <c:v>0.64819000000000004</c:v>
                </c:pt>
                <c:pt idx="738">
                  <c:v>0.64697000000000005</c:v>
                </c:pt>
                <c:pt idx="739">
                  <c:v>0.64697000000000005</c:v>
                </c:pt>
                <c:pt idx="740">
                  <c:v>0.64819000000000004</c:v>
                </c:pt>
                <c:pt idx="741">
                  <c:v>0.64819000000000004</c:v>
                </c:pt>
                <c:pt idx="742">
                  <c:v>0.64941000000000004</c:v>
                </c:pt>
                <c:pt idx="743">
                  <c:v>0.64941000000000004</c:v>
                </c:pt>
                <c:pt idx="744">
                  <c:v>0.64941000000000004</c:v>
                </c:pt>
                <c:pt idx="745">
                  <c:v>0.64941000000000004</c:v>
                </c:pt>
                <c:pt idx="746">
                  <c:v>0.64941000000000004</c:v>
                </c:pt>
                <c:pt idx="747">
                  <c:v>0.64941000000000004</c:v>
                </c:pt>
                <c:pt idx="748">
                  <c:v>0.64819000000000004</c:v>
                </c:pt>
                <c:pt idx="749">
                  <c:v>0.64941000000000004</c:v>
                </c:pt>
                <c:pt idx="750">
                  <c:v>0.64819000000000004</c:v>
                </c:pt>
                <c:pt idx="751">
                  <c:v>0.64941000000000004</c:v>
                </c:pt>
                <c:pt idx="752">
                  <c:v>0.65063000000000004</c:v>
                </c:pt>
                <c:pt idx="753">
                  <c:v>0.65185999999999999</c:v>
                </c:pt>
                <c:pt idx="754">
                  <c:v>0.65185999999999999</c:v>
                </c:pt>
                <c:pt idx="755">
                  <c:v>0.65307999999999999</c:v>
                </c:pt>
                <c:pt idx="756">
                  <c:v>0.65307999999999999</c:v>
                </c:pt>
                <c:pt idx="757">
                  <c:v>0.65429999999999999</c:v>
                </c:pt>
                <c:pt idx="758">
                  <c:v>0.65429999999999999</c:v>
                </c:pt>
                <c:pt idx="759">
                  <c:v>0.65673999999999999</c:v>
                </c:pt>
                <c:pt idx="760">
                  <c:v>0.65795999999999999</c:v>
                </c:pt>
                <c:pt idx="761">
                  <c:v>0.66161999999999999</c:v>
                </c:pt>
                <c:pt idx="762">
                  <c:v>0.66405999999999998</c:v>
                </c:pt>
                <c:pt idx="763">
                  <c:v>0.66527999999999998</c:v>
                </c:pt>
                <c:pt idx="764">
                  <c:v>0.66649999999999998</c:v>
                </c:pt>
                <c:pt idx="765">
                  <c:v>0.66649999999999998</c:v>
                </c:pt>
                <c:pt idx="766">
                  <c:v>0.66649999999999998</c:v>
                </c:pt>
                <c:pt idx="767">
                  <c:v>0.66649999999999998</c:v>
                </c:pt>
                <c:pt idx="768">
                  <c:v>0.66771999999999998</c:v>
                </c:pt>
                <c:pt idx="769">
                  <c:v>0.66895000000000004</c:v>
                </c:pt>
                <c:pt idx="770">
                  <c:v>0.66895000000000004</c:v>
                </c:pt>
                <c:pt idx="771">
                  <c:v>0.67017000000000004</c:v>
                </c:pt>
                <c:pt idx="772">
                  <c:v>0.67139000000000004</c:v>
                </c:pt>
                <c:pt idx="773">
                  <c:v>0.67139000000000004</c:v>
                </c:pt>
                <c:pt idx="774">
                  <c:v>0.67261000000000004</c:v>
                </c:pt>
                <c:pt idx="775">
                  <c:v>0.67505000000000004</c:v>
                </c:pt>
                <c:pt idx="776">
                  <c:v>0.67627000000000004</c:v>
                </c:pt>
                <c:pt idx="777">
                  <c:v>0.67871000000000004</c:v>
                </c:pt>
                <c:pt idx="778">
                  <c:v>0.68115000000000003</c:v>
                </c:pt>
                <c:pt idx="779">
                  <c:v>0.68359000000000003</c:v>
                </c:pt>
                <c:pt idx="780">
                  <c:v>0.68603999999999998</c:v>
                </c:pt>
                <c:pt idx="781">
                  <c:v>0.68847999999999998</c:v>
                </c:pt>
                <c:pt idx="782">
                  <c:v>0.69091999999999998</c:v>
                </c:pt>
                <c:pt idx="783">
                  <c:v>0.69335999999999998</c:v>
                </c:pt>
                <c:pt idx="784">
                  <c:v>0.69457999999999998</c:v>
                </c:pt>
                <c:pt idx="785">
                  <c:v>0.69579999999999997</c:v>
                </c:pt>
                <c:pt idx="786">
                  <c:v>0.69579999999999997</c:v>
                </c:pt>
                <c:pt idx="787">
                  <c:v>0.69579999999999997</c:v>
                </c:pt>
                <c:pt idx="788">
                  <c:v>0.69701999999999997</c:v>
                </c:pt>
                <c:pt idx="789">
                  <c:v>0.69823999999999997</c:v>
                </c:pt>
                <c:pt idx="790">
                  <c:v>0.69945999999999997</c:v>
                </c:pt>
                <c:pt idx="791">
                  <c:v>0.70067999999999997</c:v>
                </c:pt>
                <c:pt idx="792">
                  <c:v>0.70313000000000003</c:v>
                </c:pt>
                <c:pt idx="793">
                  <c:v>0.70435000000000003</c:v>
                </c:pt>
                <c:pt idx="794">
                  <c:v>0.70557000000000003</c:v>
                </c:pt>
                <c:pt idx="795">
                  <c:v>0.70679000000000003</c:v>
                </c:pt>
                <c:pt idx="796">
                  <c:v>0.70923000000000003</c:v>
                </c:pt>
                <c:pt idx="797">
                  <c:v>0.71045000000000003</c:v>
                </c:pt>
                <c:pt idx="798">
                  <c:v>0.71167000000000002</c:v>
                </c:pt>
                <c:pt idx="799">
                  <c:v>0.71411000000000002</c:v>
                </c:pt>
                <c:pt idx="800">
                  <c:v>0.71533000000000002</c:v>
                </c:pt>
                <c:pt idx="801">
                  <c:v>0.71655000000000002</c:v>
                </c:pt>
                <c:pt idx="802">
                  <c:v>0.72021000000000002</c:v>
                </c:pt>
                <c:pt idx="803">
                  <c:v>0.72387999999999997</c:v>
                </c:pt>
                <c:pt idx="804">
                  <c:v>0.72509999999999997</c:v>
                </c:pt>
                <c:pt idx="805">
                  <c:v>0.72753999999999996</c:v>
                </c:pt>
                <c:pt idx="806">
                  <c:v>0.72875999999999996</c:v>
                </c:pt>
                <c:pt idx="807">
                  <c:v>0.72875999999999996</c:v>
                </c:pt>
                <c:pt idx="808">
                  <c:v>0.72997999999999996</c:v>
                </c:pt>
                <c:pt idx="809">
                  <c:v>0.72997999999999996</c:v>
                </c:pt>
                <c:pt idx="810">
                  <c:v>0.73119999999999996</c:v>
                </c:pt>
                <c:pt idx="811">
                  <c:v>0.73241999999999996</c:v>
                </c:pt>
                <c:pt idx="812">
                  <c:v>0.73363999999999996</c:v>
                </c:pt>
                <c:pt idx="813">
                  <c:v>0.73485999999999996</c:v>
                </c:pt>
                <c:pt idx="814">
                  <c:v>0.73607999999999996</c:v>
                </c:pt>
                <c:pt idx="815">
                  <c:v>0.73607999999999996</c:v>
                </c:pt>
                <c:pt idx="816">
                  <c:v>0.73729999999999996</c:v>
                </c:pt>
                <c:pt idx="817">
                  <c:v>0.73607999999999996</c:v>
                </c:pt>
                <c:pt idx="818">
                  <c:v>0.73729999999999996</c:v>
                </c:pt>
                <c:pt idx="819">
                  <c:v>0.73853000000000002</c:v>
                </c:pt>
                <c:pt idx="820">
                  <c:v>0.74097000000000002</c:v>
                </c:pt>
                <c:pt idx="821">
                  <c:v>0.74219000000000002</c:v>
                </c:pt>
                <c:pt idx="822">
                  <c:v>0.74341000000000002</c:v>
                </c:pt>
                <c:pt idx="823">
                  <c:v>0.74463000000000001</c:v>
                </c:pt>
                <c:pt idx="824">
                  <c:v>0.74707000000000001</c:v>
                </c:pt>
                <c:pt idx="825">
                  <c:v>0.75073000000000001</c:v>
                </c:pt>
                <c:pt idx="826">
                  <c:v>0.75317000000000001</c:v>
                </c:pt>
                <c:pt idx="827">
                  <c:v>0.75683999999999996</c:v>
                </c:pt>
                <c:pt idx="828">
                  <c:v>0.75927999999999995</c:v>
                </c:pt>
                <c:pt idx="829">
                  <c:v>0.76049999999999995</c:v>
                </c:pt>
                <c:pt idx="830">
                  <c:v>0.76171999999999995</c:v>
                </c:pt>
                <c:pt idx="831">
                  <c:v>0.76293999999999995</c:v>
                </c:pt>
                <c:pt idx="832">
                  <c:v>0.76415999999999995</c:v>
                </c:pt>
                <c:pt idx="833">
                  <c:v>0.76537999999999995</c:v>
                </c:pt>
                <c:pt idx="834">
                  <c:v>0.76659999999999995</c:v>
                </c:pt>
                <c:pt idx="835">
                  <c:v>0.76659999999999995</c:v>
                </c:pt>
                <c:pt idx="836">
                  <c:v>0.76781999999999995</c:v>
                </c:pt>
                <c:pt idx="837">
                  <c:v>0.76781999999999995</c:v>
                </c:pt>
                <c:pt idx="838">
                  <c:v>0.76781999999999995</c:v>
                </c:pt>
                <c:pt idx="839">
                  <c:v>0.76781999999999995</c:v>
                </c:pt>
                <c:pt idx="840">
                  <c:v>0.76903999999999995</c:v>
                </c:pt>
                <c:pt idx="841">
                  <c:v>0.77025999999999994</c:v>
                </c:pt>
                <c:pt idx="842">
                  <c:v>0.77271000000000001</c:v>
                </c:pt>
                <c:pt idx="843">
                  <c:v>0.77515000000000001</c:v>
                </c:pt>
                <c:pt idx="844">
                  <c:v>0.77637</c:v>
                </c:pt>
                <c:pt idx="845">
                  <c:v>0.78003</c:v>
                </c:pt>
                <c:pt idx="846">
                  <c:v>0.78491</c:v>
                </c:pt>
                <c:pt idx="847">
                  <c:v>0.79101999999999995</c:v>
                </c:pt>
                <c:pt idx="848">
                  <c:v>0.79590000000000005</c:v>
                </c:pt>
                <c:pt idx="849">
                  <c:v>0.79956000000000005</c:v>
                </c:pt>
                <c:pt idx="850">
                  <c:v>0.80322000000000005</c:v>
                </c:pt>
                <c:pt idx="851">
                  <c:v>0.80566000000000004</c:v>
                </c:pt>
                <c:pt idx="852">
                  <c:v>0.80688000000000004</c:v>
                </c:pt>
                <c:pt idx="853">
                  <c:v>0.80932999999999999</c:v>
                </c:pt>
                <c:pt idx="854">
                  <c:v>0.81176999999999999</c:v>
                </c:pt>
                <c:pt idx="855">
                  <c:v>0.81542999999999999</c:v>
                </c:pt>
                <c:pt idx="856">
                  <c:v>0.81786999999999999</c:v>
                </c:pt>
                <c:pt idx="857">
                  <c:v>0.82030999999999998</c:v>
                </c:pt>
                <c:pt idx="858">
                  <c:v>0.82396999999999998</c:v>
                </c:pt>
                <c:pt idx="859">
                  <c:v>0.82764000000000004</c:v>
                </c:pt>
                <c:pt idx="860">
                  <c:v>0.83252000000000004</c:v>
                </c:pt>
                <c:pt idx="861">
                  <c:v>0.83984000000000003</c:v>
                </c:pt>
                <c:pt idx="862">
                  <c:v>0.84838999999999998</c:v>
                </c:pt>
                <c:pt idx="863">
                  <c:v>0.85570999999999997</c:v>
                </c:pt>
                <c:pt idx="864">
                  <c:v>0.86548000000000003</c:v>
                </c:pt>
                <c:pt idx="865">
                  <c:v>0.87524000000000002</c:v>
                </c:pt>
                <c:pt idx="866">
                  <c:v>0.88744999999999996</c:v>
                </c:pt>
                <c:pt idx="867">
                  <c:v>0.89966000000000002</c:v>
                </c:pt>
                <c:pt idx="868">
                  <c:v>0.91308999999999996</c:v>
                </c:pt>
                <c:pt idx="869">
                  <c:v>0.92284999999999995</c:v>
                </c:pt>
                <c:pt idx="870">
                  <c:v>0.93018000000000001</c:v>
                </c:pt>
                <c:pt idx="871">
                  <c:v>0.93384</c:v>
                </c:pt>
                <c:pt idx="872">
                  <c:v>0.9375</c:v>
                </c:pt>
                <c:pt idx="873">
                  <c:v>0.93994</c:v>
                </c:pt>
                <c:pt idx="874">
                  <c:v>0.94359999999999999</c:v>
                </c:pt>
                <c:pt idx="875">
                  <c:v>0.94971000000000005</c:v>
                </c:pt>
                <c:pt idx="876">
                  <c:v>0.95703000000000005</c:v>
                </c:pt>
                <c:pt idx="877">
                  <c:v>0.96435999999999999</c:v>
                </c:pt>
                <c:pt idx="878">
                  <c:v>0.97289999999999999</c:v>
                </c:pt>
                <c:pt idx="879">
                  <c:v>0.98389000000000004</c:v>
                </c:pt>
                <c:pt idx="880">
                  <c:v>0.99609000000000003</c:v>
                </c:pt>
                <c:pt idx="881">
                  <c:v>1.0022</c:v>
                </c:pt>
                <c:pt idx="882">
                  <c:v>1.0144</c:v>
                </c:pt>
                <c:pt idx="883">
                  <c:v>1.0254000000000001</c:v>
                </c:pt>
                <c:pt idx="884">
                  <c:v>1.0339</c:v>
                </c:pt>
                <c:pt idx="885">
                  <c:v>1.0412999999999999</c:v>
                </c:pt>
                <c:pt idx="886">
                  <c:v>1.0486</c:v>
                </c:pt>
                <c:pt idx="887">
                  <c:v>1.0547</c:v>
                </c:pt>
                <c:pt idx="888">
                  <c:v>1.0608</c:v>
                </c:pt>
                <c:pt idx="889">
                  <c:v>1.0681</c:v>
                </c:pt>
                <c:pt idx="890">
                  <c:v>1.0742</c:v>
                </c:pt>
                <c:pt idx="891">
                  <c:v>1.0803</c:v>
                </c:pt>
                <c:pt idx="892">
                  <c:v>1.0864</c:v>
                </c:pt>
                <c:pt idx="893">
                  <c:v>1.0901000000000001</c:v>
                </c:pt>
                <c:pt idx="894">
                  <c:v>1.0938000000000001</c:v>
                </c:pt>
                <c:pt idx="895">
                  <c:v>1.0973999999999999</c:v>
                </c:pt>
                <c:pt idx="896">
                  <c:v>1.0999000000000001</c:v>
                </c:pt>
                <c:pt idx="897">
                  <c:v>1.1034999999999999</c:v>
                </c:pt>
                <c:pt idx="898">
                  <c:v>1.1072</c:v>
                </c:pt>
                <c:pt idx="899">
                  <c:v>1.1108</c:v>
                </c:pt>
                <c:pt idx="900">
                  <c:v>1.1145</c:v>
                </c:pt>
                <c:pt idx="901">
                  <c:v>1.1169</c:v>
                </c:pt>
                <c:pt idx="902">
                  <c:v>1.1217999999999999</c:v>
                </c:pt>
                <c:pt idx="903">
                  <c:v>1.1254999999999999</c:v>
                </c:pt>
                <c:pt idx="904">
                  <c:v>1.1304000000000001</c:v>
                </c:pt>
                <c:pt idx="905">
                  <c:v>1.1339999999999999</c:v>
                </c:pt>
                <c:pt idx="906">
                  <c:v>1.1376999999999999</c:v>
                </c:pt>
                <c:pt idx="907">
                  <c:v>1.1400999999999999</c:v>
                </c:pt>
                <c:pt idx="908">
                  <c:v>1.1426000000000001</c:v>
                </c:pt>
                <c:pt idx="909">
                  <c:v>1.1462000000000001</c:v>
                </c:pt>
                <c:pt idx="910">
                  <c:v>1.1498999999999999</c:v>
                </c:pt>
                <c:pt idx="911">
                  <c:v>1.1523000000000001</c:v>
                </c:pt>
                <c:pt idx="912">
                  <c:v>1.1536</c:v>
                </c:pt>
                <c:pt idx="913">
                  <c:v>1.1548</c:v>
                </c:pt>
                <c:pt idx="914">
                  <c:v>1.1559999999999999</c:v>
                </c:pt>
                <c:pt idx="915">
                  <c:v>1.1559999999999999</c:v>
                </c:pt>
                <c:pt idx="916">
                  <c:v>1.1572</c:v>
                </c:pt>
                <c:pt idx="917">
                  <c:v>1.1584000000000001</c:v>
                </c:pt>
                <c:pt idx="918">
                  <c:v>1.1597</c:v>
                </c:pt>
                <c:pt idx="919">
                  <c:v>1.1620999999999999</c:v>
                </c:pt>
                <c:pt idx="920">
                  <c:v>1.1609</c:v>
                </c:pt>
                <c:pt idx="921">
                  <c:v>1.1609</c:v>
                </c:pt>
                <c:pt idx="922">
                  <c:v>1.1620999999999999</c:v>
                </c:pt>
                <c:pt idx="923">
                  <c:v>1.1633</c:v>
                </c:pt>
                <c:pt idx="924">
                  <c:v>1.1657999999999999</c:v>
                </c:pt>
                <c:pt idx="925">
                  <c:v>1.167</c:v>
                </c:pt>
                <c:pt idx="926">
                  <c:v>1.167</c:v>
                </c:pt>
                <c:pt idx="927">
                  <c:v>1.1657999999999999</c:v>
                </c:pt>
                <c:pt idx="928">
                  <c:v>1.1646000000000001</c:v>
                </c:pt>
                <c:pt idx="929">
                  <c:v>1.1620999999999999</c:v>
                </c:pt>
                <c:pt idx="930">
                  <c:v>1.1584000000000001</c:v>
                </c:pt>
                <c:pt idx="931">
                  <c:v>1.1559999999999999</c:v>
                </c:pt>
                <c:pt idx="932">
                  <c:v>1.1523000000000001</c:v>
                </c:pt>
                <c:pt idx="933">
                  <c:v>1.1475</c:v>
                </c:pt>
                <c:pt idx="934">
                  <c:v>1.1426000000000001</c:v>
                </c:pt>
                <c:pt idx="935">
                  <c:v>1.1365000000000001</c:v>
                </c:pt>
                <c:pt idx="936">
                  <c:v>1.1328</c:v>
                </c:pt>
                <c:pt idx="937">
                  <c:v>1.1315999999999999</c:v>
                </c:pt>
                <c:pt idx="938">
                  <c:v>1.1304000000000001</c:v>
                </c:pt>
                <c:pt idx="939">
                  <c:v>1.1292</c:v>
                </c:pt>
                <c:pt idx="940">
                  <c:v>1.1267</c:v>
                </c:pt>
                <c:pt idx="941">
                  <c:v>1.1243000000000001</c:v>
                </c:pt>
                <c:pt idx="942">
                  <c:v>1.1217999999999999</c:v>
                </c:pt>
                <c:pt idx="943">
                  <c:v>1.1182000000000001</c:v>
                </c:pt>
                <c:pt idx="944">
                  <c:v>1.1145</c:v>
                </c:pt>
                <c:pt idx="945">
                  <c:v>1.1121000000000001</c:v>
                </c:pt>
                <c:pt idx="946">
                  <c:v>1.1072</c:v>
                </c:pt>
                <c:pt idx="947">
                  <c:v>1.1034999999999999</c:v>
                </c:pt>
                <c:pt idx="948">
                  <c:v>1.0986</c:v>
                </c:pt>
                <c:pt idx="949">
                  <c:v>1.0938000000000001</c:v>
                </c:pt>
                <c:pt idx="950">
                  <c:v>1.0875999999999999</c:v>
                </c:pt>
                <c:pt idx="951">
                  <c:v>1.0814999999999999</c:v>
                </c:pt>
                <c:pt idx="952">
                  <c:v>1.0753999999999999</c:v>
                </c:pt>
                <c:pt idx="953">
                  <c:v>1.0669</c:v>
                </c:pt>
                <c:pt idx="954">
                  <c:v>1.0596000000000001</c:v>
                </c:pt>
                <c:pt idx="955">
                  <c:v>1.0522</c:v>
                </c:pt>
                <c:pt idx="956">
                  <c:v>1.0474000000000001</c:v>
                </c:pt>
                <c:pt idx="957">
                  <c:v>1.0437000000000001</c:v>
                </c:pt>
                <c:pt idx="958">
                  <c:v>1.04</c:v>
                </c:pt>
                <c:pt idx="959">
                  <c:v>1.0376000000000001</c:v>
                </c:pt>
                <c:pt idx="960">
                  <c:v>1.0364</c:v>
                </c:pt>
                <c:pt idx="961">
                  <c:v>1.0339</c:v>
                </c:pt>
                <c:pt idx="962">
                  <c:v>1.0303</c:v>
                </c:pt>
                <c:pt idx="963">
                  <c:v>1.0278</c:v>
                </c:pt>
                <c:pt idx="964">
                  <c:v>1.0242</c:v>
                </c:pt>
                <c:pt idx="965">
                  <c:v>1.0217000000000001</c:v>
                </c:pt>
                <c:pt idx="966">
                  <c:v>1.0205</c:v>
                </c:pt>
                <c:pt idx="967">
                  <c:v>1.0181</c:v>
                </c:pt>
                <c:pt idx="968">
                  <c:v>1.0167999999999999</c:v>
                </c:pt>
                <c:pt idx="969">
                  <c:v>1.0132000000000001</c:v>
                </c:pt>
                <c:pt idx="970">
                  <c:v>1.0095000000000001</c:v>
                </c:pt>
                <c:pt idx="971">
                  <c:v>1.0045999999999999</c:v>
                </c:pt>
                <c:pt idx="972">
                  <c:v>0.99975999999999998</c:v>
                </c:pt>
                <c:pt idx="973">
                  <c:v>0.99487000000000003</c:v>
                </c:pt>
                <c:pt idx="974">
                  <c:v>0.98999000000000004</c:v>
                </c:pt>
                <c:pt idx="975">
                  <c:v>0.98267000000000004</c:v>
                </c:pt>
                <c:pt idx="976">
                  <c:v>0.97411999999999999</c:v>
                </c:pt>
                <c:pt idx="977">
                  <c:v>0.96679999999999999</c:v>
                </c:pt>
                <c:pt idx="978">
                  <c:v>0.96191000000000004</c:v>
                </c:pt>
                <c:pt idx="979">
                  <c:v>0.95581000000000005</c:v>
                </c:pt>
                <c:pt idx="980">
                  <c:v>0.95093000000000005</c:v>
                </c:pt>
                <c:pt idx="981">
                  <c:v>0.94726999999999995</c:v>
                </c:pt>
                <c:pt idx="982">
                  <c:v>0.94481999999999999</c:v>
                </c:pt>
                <c:pt idx="983">
                  <c:v>0.94238</c:v>
                </c:pt>
                <c:pt idx="984">
                  <c:v>0.93994</c:v>
                </c:pt>
                <c:pt idx="985">
                  <c:v>0.93628</c:v>
                </c:pt>
                <c:pt idx="986">
                  <c:v>0.93140000000000001</c:v>
                </c:pt>
                <c:pt idx="987">
                  <c:v>0.92650999999999994</c:v>
                </c:pt>
                <c:pt idx="988">
                  <c:v>0.92284999999999995</c:v>
                </c:pt>
                <c:pt idx="989">
                  <c:v>0.91918999999999995</c:v>
                </c:pt>
                <c:pt idx="990">
                  <c:v>0.91552999999999995</c:v>
                </c:pt>
                <c:pt idx="991">
                  <c:v>0.91064000000000001</c:v>
                </c:pt>
                <c:pt idx="992">
                  <c:v>0.90576000000000001</c:v>
                </c:pt>
                <c:pt idx="993">
                  <c:v>0.89966000000000002</c:v>
                </c:pt>
                <c:pt idx="994">
                  <c:v>0.89232999999999996</c:v>
                </c:pt>
                <c:pt idx="995">
                  <c:v>0.88744999999999996</c:v>
                </c:pt>
                <c:pt idx="996">
                  <c:v>0.88134999999999997</c:v>
                </c:pt>
                <c:pt idx="997">
                  <c:v>0.87402000000000002</c:v>
                </c:pt>
                <c:pt idx="998">
                  <c:v>0.86792000000000002</c:v>
                </c:pt>
                <c:pt idx="999">
                  <c:v>0.86304000000000003</c:v>
                </c:pt>
                <c:pt idx="1000">
                  <c:v>0.85692999999999997</c:v>
                </c:pt>
                <c:pt idx="1001">
                  <c:v>0.85326999999999997</c:v>
                </c:pt>
                <c:pt idx="1002">
                  <c:v>0.85082999999999998</c:v>
                </c:pt>
                <c:pt idx="1003">
                  <c:v>0.84838999999999998</c:v>
                </c:pt>
                <c:pt idx="1004">
                  <c:v>0.84716999999999998</c:v>
                </c:pt>
                <c:pt idx="1005">
                  <c:v>0.84472999999999998</c:v>
                </c:pt>
                <c:pt idx="1006">
                  <c:v>0.84228999999999998</c:v>
                </c:pt>
                <c:pt idx="1007">
                  <c:v>0.83862000000000003</c:v>
                </c:pt>
                <c:pt idx="1008">
                  <c:v>0.83496000000000004</c:v>
                </c:pt>
                <c:pt idx="1009">
                  <c:v>0.83130000000000004</c:v>
                </c:pt>
                <c:pt idx="1010">
                  <c:v>0.82764000000000004</c:v>
                </c:pt>
                <c:pt idx="1011">
                  <c:v>0.82520000000000004</c:v>
                </c:pt>
                <c:pt idx="1012">
                  <c:v>0.82030999999999998</c:v>
                </c:pt>
                <c:pt idx="1013">
                  <c:v>0.81542999999999999</c:v>
                </c:pt>
                <c:pt idx="1014">
                  <c:v>0.81054999999999999</c:v>
                </c:pt>
                <c:pt idx="1015">
                  <c:v>0.80688000000000004</c:v>
                </c:pt>
                <c:pt idx="1016">
                  <c:v>0.80200000000000005</c:v>
                </c:pt>
                <c:pt idx="1017">
                  <c:v>0.79712000000000005</c:v>
                </c:pt>
                <c:pt idx="1018">
                  <c:v>0.79224000000000006</c:v>
                </c:pt>
                <c:pt idx="1019">
                  <c:v>0.78734999999999999</c:v>
                </c:pt>
                <c:pt idx="1020">
                  <c:v>0.78369</c:v>
                </c:pt>
                <c:pt idx="1021">
                  <c:v>0.78003</c:v>
                </c:pt>
                <c:pt idx="1022">
                  <c:v>0.77759</c:v>
                </c:pt>
                <c:pt idx="1023">
                  <c:v>0.77515000000000001</c:v>
                </c:pt>
                <c:pt idx="1024">
                  <c:v>0.77515000000000001</c:v>
                </c:pt>
                <c:pt idx="1025">
                  <c:v>0.77393000000000001</c:v>
                </c:pt>
                <c:pt idx="1026">
                  <c:v>0.77271000000000001</c:v>
                </c:pt>
                <c:pt idx="1027">
                  <c:v>0.77025999999999994</c:v>
                </c:pt>
                <c:pt idx="1028">
                  <c:v>0.76781999999999995</c:v>
                </c:pt>
                <c:pt idx="1029">
                  <c:v>0.76415999999999995</c:v>
                </c:pt>
                <c:pt idx="1030">
                  <c:v>0.76171999999999995</c:v>
                </c:pt>
                <c:pt idx="1031">
                  <c:v>0.75927999999999995</c:v>
                </c:pt>
                <c:pt idx="1032">
                  <c:v>0.75683999999999996</c:v>
                </c:pt>
                <c:pt idx="1033">
                  <c:v>0.75317000000000001</c:v>
                </c:pt>
                <c:pt idx="1034">
                  <c:v>0.74829000000000001</c:v>
                </c:pt>
                <c:pt idx="1035">
                  <c:v>0.74341000000000002</c:v>
                </c:pt>
                <c:pt idx="1036">
                  <c:v>0.73729999999999996</c:v>
                </c:pt>
                <c:pt idx="1037">
                  <c:v>0.73363999999999996</c:v>
                </c:pt>
                <c:pt idx="1038">
                  <c:v>0.72875999999999996</c:v>
                </c:pt>
                <c:pt idx="1039">
                  <c:v>0.72387999999999997</c:v>
                </c:pt>
                <c:pt idx="1040">
                  <c:v>0.72021000000000002</c:v>
                </c:pt>
                <c:pt idx="1041">
                  <c:v>0.71655000000000002</c:v>
                </c:pt>
                <c:pt idx="1042">
                  <c:v>0.71411000000000002</c:v>
                </c:pt>
                <c:pt idx="1043">
                  <c:v>0.71167000000000002</c:v>
                </c:pt>
                <c:pt idx="1044">
                  <c:v>0.71045000000000003</c:v>
                </c:pt>
                <c:pt idx="1045">
                  <c:v>0.71045000000000003</c:v>
                </c:pt>
                <c:pt idx="1046">
                  <c:v>0.70801000000000003</c:v>
                </c:pt>
                <c:pt idx="1047">
                  <c:v>0.70801000000000003</c:v>
                </c:pt>
                <c:pt idx="1048">
                  <c:v>0.70679000000000003</c:v>
                </c:pt>
                <c:pt idx="1049">
                  <c:v>0.70557000000000003</c:v>
                </c:pt>
                <c:pt idx="1050">
                  <c:v>0.70557000000000003</c:v>
                </c:pt>
                <c:pt idx="1051">
                  <c:v>0.70313000000000003</c:v>
                </c:pt>
                <c:pt idx="1052">
                  <c:v>0.70189999999999997</c:v>
                </c:pt>
                <c:pt idx="1053">
                  <c:v>0.70189999999999997</c:v>
                </c:pt>
                <c:pt idx="1054">
                  <c:v>0.70067999999999997</c:v>
                </c:pt>
                <c:pt idx="1055">
                  <c:v>0.69823999999999997</c:v>
                </c:pt>
                <c:pt idx="1056">
                  <c:v>0.69579999999999997</c:v>
                </c:pt>
                <c:pt idx="1057">
                  <c:v>0.69213999999999998</c:v>
                </c:pt>
                <c:pt idx="1058">
                  <c:v>0.68969999999999998</c:v>
                </c:pt>
                <c:pt idx="1059">
                  <c:v>0.68603999999999998</c:v>
                </c:pt>
                <c:pt idx="1060">
                  <c:v>0.68237000000000003</c:v>
                </c:pt>
                <c:pt idx="1061">
                  <c:v>0.67871000000000004</c:v>
                </c:pt>
                <c:pt idx="1062">
                  <c:v>0.67383000000000004</c:v>
                </c:pt>
                <c:pt idx="1063">
                  <c:v>0.67017000000000004</c:v>
                </c:pt>
                <c:pt idx="1064">
                  <c:v>0.66771999999999998</c:v>
                </c:pt>
                <c:pt idx="1065">
                  <c:v>0.66527999999999998</c:v>
                </c:pt>
                <c:pt idx="1066">
                  <c:v>0.66405999999999998</c:v>
                </c:pt>
                <c:pt idx="1067">
                  <c:v>0.66283999999999998</c:v>
                </c:pt>
                <c:pt idx="1068">
                  <c:v>0.66283999999999998</c:v>
                </c:pt>
                <c:pt idx="1069">
                  <c:v>0.66283999999999998</c:v>
                </c:pt>
                <c:pt idx="1070">
                  <c:v>0.66283999999999998</c:v>
                </c:pt>
                <c:pt idx="1071">
                  <c:v>0.66039999999999999</c:v>
                </c:pt>
                <c:pt idx="1072">
                  <c:v>0.65917999999999999</c:v>
                </c:pt>
                <c:pt idx="1073">
                  <c:v>0.65673999999999999</c:v>
                </c:pt>
                <c:pt idx="1074">
                  <c:v>0.65429999999999999</c:v>
                </c:pt>
                <c:pt idx="1075">
                  <c:v>0.65185999999999999</c:v>
                </c:pt>
                <c:pt idx="1076">
                  <c:v>0.64941000000000004</c:v>
                </c:pt>
                <c:pt idx="1077">
                  <c:v>0.64697000000000005</c:v>
                </c:pt>
                <c:pt idx="1078">
                  <c:v>0.64331000000000005</c:v>
                </c:pt>
                <c:pt idx="1079">
                  <c:v>0.63965000000000005</c:v>
                </c:pt>
                <c:pt idx="1080">
                  <c:v>0.63721000000000005</c:v>
                </c:pt>
                <c:pt idx="1081">
                  <c:v>0.63353999999999999</c:v>
                </c:pt>
                <c:pt idx="1082">
                  <c:v>0.63109999999999999</c:v>
                </c:pt>
                <c:pt idx="1083">
                  <c:v>0.62866</c:v>
                </c:pt>
                <c:pt idx="1084">
                  <c:v>0.62622</c:v>
                </c:pt>
                <c:pt idx="1085">
                  <c:v>0.62256</c:v>
                </c:pt>
                <c:pt idx="1086">
                  <c:v>0.62134</c:v>
                </c:pt>
                <c:pt idx="1087">
                  <c:v>0.62012</c:v>
                </c:pt>
                <c:pt idx="1088">
                  <c:v>0.62012</c:v>
                </c:pt>
                <c:pt idx="1089">
                  <c:v>0.62012</c:v>
                </c:pt>
                <c:pt idx="1090">
                  <c:v>0.62012</c:v>
                </c:pt>
                <c:pt idx="1091">
                  <c:v>0.61890000000000001</c:v>
                </c:pt>
                <c:pt idx="1092">
                  <c:v>0.61768000000000001</c:v>
                </c:pt>
                <c:pt idx="1093">
                  <c:v>0.61646000000000001</c:v>
                </c:pt>
                <c:pt idx="1094">
                  <c:v>0.61523000000000005</c:v>
                </c:pt>
                <c:pt idx="1095">
                  <c:v>0.61523000000000005</c:v>
                </c:pt>
                <c:pt idx="1096">
                  <c:v>0.61278999999999995</c:v>
                </c:pt>
                <c:pt idx="1097">
                  <c:v>0.61156999999999995</c:v>
                </c:pt>
                <c:pt idx="1098">
                  <c:v>0.60912999999999995</c:v>
                </c:pt>
                <c:pt idx="1099">
                  <c:v>0.60668999999999995</c:v>
                </c:pt>
                <c:pt idx="1100">
                  <c:v>0.60424999999999995</c:v>
                </c:pt>
                <c:pt idx="1101">
                  <c:v>0.60302999999999995</c:v>
                </c:pt>
                <c:pt idx="1102">
                  <c:v>0.60180999999999996</c:v>
                </c:pt>
                <c:pt idx="1103">
                  <c:v>0.60058999999999996</c:v>
                </c:pt>
                <c:pt idx="1104">
                  <c:v>0.59936999999999996</c:v>
                </c:pt>
                <c:pt idx="1105">
                  <c:v>0.59814000000000001</c:v>
                </c:pt>
                <c:pt idx="1106">
                  <c:v>0.59814000000000001</c:v>
                </c:pt>
                <c:pt idx="1107">
                  <c:v>0.59814000000000001</c:v>
                </c:pt>
                <c:pt idx="1108">
                  <c:v>0.59814000000000001</c:v>
                </c:pt>
                <c:pt idx="1109">
                  <c:v>0.59814000000000001</c:v>
                </c:pt>
                <c:pt idx="1110">
                  <c:v>0.59936999999999996</c:v>
                </c:pt>
                <c:pt idx="1111">
                  <c:v>0.59936999999999996</c:v>
                </c:pt>
                <c:pt idx="1112">
                  <c:v>0.59936999999999996</c:v>
                </c:pt>
                <c:pt idx="1113">
                  <c:v>0.59936999999999996</c:v>
                </c:pt>
                <c:pt idx="1114">
                  <c:v>0.60058999999999996</c:v>
                </c:pt>
                <c:pt idx="1115">
                  <c:v>0.60180999999999996</c:v>
                </c:pt>
                <c:pt idx="1116">
                  <c:v>0.60180999999999996</c:v>
                </c:pt>
                <c:pt idx="1117">
                  <c:v>0.60302999999999995</c:v>
                </c:pt>
                <c:pt idx="1118">
                  <c:v>0.60302999999999995</c:v>
                </c:pt>
                <c:pt idx="1119">
                  <c:v>0.60546999999999995</c:v>
                </c:pt>
                <c:pt idx="1120">
                  <c:v>0.60546999999999995</c:v>
                </c:pt>
                <c:pt idx="1121">
                  <c:v>0.60668999999999995</c:v>
                </c:pt>
                <c:pt idx="1122">
                  <c:v>0.60790999999999995</c:v>
                </c:pt>
                <c:pt idx="1123">
                  <c:v>0.60912999999999995</c:v>
                </c:pt>
                <c:pt idx="1124">
                  <c:v>0.61034999999999995</c:v>
                </c:pt>
                <c:pt idx="1125">
                  <c:v>0.61156999999999995</c:v>
                </c:pt>
                <c:pt idx="1126">
                  <c:v>0.61400999999999994</c:v>
                </c:pt>
                <c:pt idx="1127">
                  <c:v>0.61523000000000005</c:v>
                </c:pt>
                <c:pt idx="1128">
                  <c:v>0.61646000000000001</c:v>
                </c:pt>
                <c:pt idx="1129">
                  <c:v>0.61890000000000001</c:v>
                </c:pt>
                <c:pt idx="1130">
                  <c:v>0.62012</c:v>
                </c:pt>
                <c:pt idx="1131">
                  <c:v>0.62134</c:v>
                </c:pt>
                <c:pt idx="1132">
                  <c:v>0.62134</c:v>
                </c:pt>
                <c:pt idx="1133">
                  <c:v>0.62134</c:v>
                </c:pt>
                <c:pt idx="1134">
                  <c:v>0.62256</c:v>
                </c:pt>
                <c:pt idx="1135">
                  <c:v>0.62256</c:v>
                </c:pt>
                <c:pt idx="1136">
                  <c:v>0.62378</c:v>
                </c:pt>
                <c:pt idx="1137">
                  <c:v>0.625</c:v>
                </c:pt>
                <c:pt idx="1138">
                  <c:v>0.62744</c:v>
                </c:pt>
                <c:pt idx="1139">
                  <c:v>0.62866</c:v>
                </c:pt>
                <c:pt idx="1140">
                  <c:v>0.63109999999999999</c:v>
                </c:pt>
                <c:pt idx="1141">
                  <c:v>0.63231999999999999</c:v>
                </c:pt>
                <c:pt idx="1142">
                  <c:v>0.63231999999999999</c:v>
                </c:pt>
                <c:pt idx="1143">
                  <c:v>0.63476999999999995</c:v>
                </c:pt>
                <c:pt idx="1144">
                  <c:v>0.63599000000000006</c:v>
                </c:pt>
                <c:pt idx="1145">
                  <c:v>0.63599000000000006</c:v>
                </c:pt>
                <c:pt idx="1146">
                  <c:v>0.63721000000000005</c:v>
                </c:pt>
                <c:pt idx="1147">
                  <c:v>0.63721000000000005</c:v>
                </c:pt>
                <c:pt idx="1148">
                  <c:v>0.63843000000000005</c:v>
                </c:pt>
                <c:pt idx="1149">
                  <c:v>0.63965000000000005</c:v>
                </c:pt>
                <c:pt idx="1150">
                  <c:v>0.63965000000000005</c:v>
                </c:pt>
                <c:pt idx="1151">
                  <c:v>0.63965000000000005</c:v>
                </c:pt>
                <c:pt idx="1152">
                  <c:v>0.64087000000000005</c:v>
                </c:pt>
                <c:pt idx="1153">
                  <c:v>0.63965000000000005</c:v>
                </c:pt>
                <c:pt idx="1154">
                  <c:v>0.63965000000000005</c:v>
                </c:pt>
                <c:pt idx="1155">
                  <c:v>0.63965000000000005</c:v>
                </c:pt>
                <c:pt idx="1156">
                  <c:v>0.63965000000000005</c:v>
                </c:pt>
                <c:pt idx="1157">
                  <c:v>0.63965000000000005</c:v>
                </c:pt>
                <c:pt idx="1158">
                  <c:v>0.63965000000000005</c:v>
                </c:pt>
                <c:pt idx="1159">
                  <c:v>0.63965000000000005</c:v>
                </c:pt>
                <c:pt idx="1160">
                  <c:v>0.63843000000000005</c:v>
                </c:pt>
                <c:pt idx="1161">
                  <c:v>0.63843000000000005</c:v>
                </c:pt>
                <c:pt idx="1162">
                  <c:v>0.63721000000000005</c:v>
                </c:pt>
                <c:pt idx="1163">
                  <c:v>0.63599000000000006</c:v>
                </c:pt>
                <c:pt idx="1164">
                  <c:v>0.63353999999999999</c:v>
                </c:pt>
                <c:pt idx="1165">
                  <c:v>0.63231999999999999</c:v>
                </c:pt>
                <c:pt idx="1166">
                  <c:v>0.63109999999999999</c:v>
                </c:pt>
                <c:pt idx="1167">
                  <c:v>0.62866</c:v>
                </c:pt>
                <c:pt idx="1168">
                  <c:v>0.62744</c:v>
                </c:pt>
                <c:pt idx="1169">
                  <c:v>0.625</c:v>
                </c:pt>
                <c:pt idx="1170">
                  <c:v>0.62256</c:v>
                </c:pt>
                <c:pt idx="1171">
                  <c:v>0.62134</c:v>
                </c:pt>
                <c:pt idx="1172">
                  <c:v>0.61890000000000001</c:v>
                </c:pt>
                <c:pt idx="1173">
                  <c:v>0.61768000000000001</c:v>
                </c:pt>
                <c:pt idx="1174">
                  <c:v>0.61646000000000001</c:v>
                </c:pt>
                <c:pt idx="1175">
                  <c:v>0.61646000000000001</c:v>
                </c:pt>
                <c:pt idx="1176">
                  <c:v>0.61523000000000005</c:v>
                </c:pt>
                <c:pt idx="1177">
                  <c:v>0.61523000000000005</c:v>
                </c:pt>
                <c:pt idx="1178">
                  <c:v>0.61400999999999994</c:v>
                </c:pt>
                <c:pt idx="1179">
                  <c:v>0.61278999999999995</c:v>
                </c:pt>
                <c:pt idx="1180">
                  <c:v>0.61156999999999995</c:v>
                </c:pt>
                <c:pt idx="1181">
                  <c:v>0.61034999999999995</c:v>
                </c:pt>
                <c:pt idx="1182">
                  <c:v>0.60912999999999995</c:v>
                </c:pt>
                <c:pt idx="1183">
                  <c:v>0.60668999999999995</c:v>
                </c:pt>
                <c:pt idx="1184">
                  <c:v>0.60424999999999995</c:v>
                </c:pt>
                <c:pt idx="1185">
                  <c:v>0.60180999999999996</c:v>
                </c:pt>
                <c:pt idx="1186">
                  <c:v>0.59814000000000001</c:v>
                </c:pt>
                <c:pt idx="1187">
                  <c:v>0.59570000000000001</c:v>
                </c:pt>
                <c:pt idx="1188">
                  <c:v>0.59448000000000001</c:v>
                </c:pt>
                <c:pt idx="1189">
                  <c:v>0.59082000000000001</c:v>
                </c:pt>
                <c:pt idx="1190">
                  <c:v>0.58838000000000001</c:v>
                </c:pt>
                <c:pt idx="1191">
                  <c:v>0.58594000000000002</c:v>
                </c:pt>
                <c:pt idx="1192">
                  <c:v>0.58350000000000002</c:v>
                </c:pt>
                <c:pt idx="1193">
                  <c:v>0.58104999999999996</c:v>
                </c:pt>
                <c:pt idx="1194">
                  <c:v>0.58104999999999996</c:v>
                </c:pt>
                <c:pt idx="1195">
                  <c:v>0.57982999999999996</c:v>
                </c:pt>
                <c:pt idx="1196">
                  <c:v>0.57982999999999996</c:v>
                </c:pt>
                <c:pt idx="1197">
                  <c:v>0.57860999999999996</c:v>
                </c:pt>
                <c:pt idx="1198">
                  <c:v>0.57860999999999996</c:v>
                </c:pt>
                <c:pt idx="1199">
                  <c:v>0.57738999999999996</c:v>
                </c:pt>
                <c:pt idx="1200">
                  <c:v>0.57738999999999996</c:v>
                </c:pt>
                <c:pt idx="1201">
                  <c:v>0.57616999999999996</c:v>
                </c:pt>
                <c:pt idx="1202">
                  <c:v>0.57616999999999996</c:v>
                </c:pt>
                <c:pt idx="1203">
                  <c:v>0.57494999999999996</c:v>
                </c:pt>
                <c:pt idx="1204">
                  <c:v>0.57372999999999996</c:v>
                </c:pt>
                <c:pt idx="1205">
                  <c:v>0.57372999999999996</c:v>
                </c:pt>
                <c:pt idx="1206">
                  <c:v>0.57128999999999996</c:v>
                </c:pt>
                <c:pt idx="1207">
                  <c:v>0.57006999999999997</c:v>
                </c:pt>
                <c:pt idx="1208">
                  <c:v>0.56884999999999997</c:v>
                </c:pt>
                <c:pt idx="1209">
                  <c:v>0.56640999999999997</c:v>
                </c:pt>
                <c:pt idx="1210">
                  <c:v>0.56396000000000002</c:v>
                </c:pt>
                <c:pt idx="1211">
                  <c:v>0.56274000000000002</c:v>
                </c:pt>
                <c:pt idx="1212">
                  <c:v>0.56152000000000002</c:v>
                </c:pt>
                <c:pt idx="1213">
                  <c:v>0.55908000000000002</c:v>
                </c:pt>
                <c:pt idx="1214">
                  <c:v>0.55664000000000002</c:v>
                </c:pt>
                <c:pt idx="1215">
                  <c:v>0.55542000000000002</c:v>
                </c:pt>
                <c:pt idx="1216">
                  <c:v>0.55420000000000003</c:v>
                </c:pt>
                <c:pt idx="1217">
                  <c:v>0.55298000000000003</c:v>
                </c:pt>
                <c:pt idx="1218">
                  <c:v>0.55176000000000003</c:v>
                </c:pt>
                <c:pt idx="1219">
                  <c:v>0.55054000000000003</c:v>
                </c:pt>
                <c:pt idx="1220">
                  <c:v>0.55054000000000003</c:v>
                </c:pt>
                <c:pt idx="1221">
                  <c:v>0.55054000000000003</c:v>
                </c:pt>
                <c:pt idx="1222">
                  <c:v>0.54932000000000003</c:v>
                </c:pt>
                <c:pt idx="1223">
                  <c:v>0.54810000000000003</c:v>
                </c:pt>
                <c:pt idx="1224">
                  <c:v>0.54688000000000003</c:v>
                </c:pt>
                <c:pt idx="1225">
                  <c:v>0.54688000000000003</c:v>
                </c:pt>
                <c:pt idx="1226">
                  <c:v>0.54564999999999997</c:v>
                </c:pt>
                <c:pt idx="1227">
                  <c:v>0.54442999999999997</c:v>
                </c:pt>
                <c:pt idx="1228">
                  <c:v>0.54320999999999997</c:v>
                </c:pt>
                <c:pt idx="1229">
                  <c:v>0.54076999999999997</c:v>
                </c:pt>
                <c:pt idx="1230">
                  <c:v>0.53954999999999997</c:v>
                </c:pt>
                <c:pt idx="1231">
                  <c:v>0.53710999999999998</c:v>
                </c:pt>
                <c:pt idx="1232">
                  <c:v>0.53588999999999998</c:v>
                </c:pt>
                <c:pt idx="1233">
                  <c:v>0.53466999999999998</c:v>
                </c:pt>
                <c:pt idx="1234">
                  <c:v>0.53344999999999998</c:v>
                </c:pt>
                <c:pt idx="1235">
                  <c:v>0.53344999999999998</c:v>
                </c:pt>
                <c:pt idx="1236">
                  <c:v>0.53100999999999998</c:v>
                </c:pt>
                <c:pt idx="1237">
                  <c:v>0.53100999999999998</c:v>
                </c:pt>
                <c:pt idx="1238">
                  <c:v>0.53100999999999998</c:v>
                </c:pt>
                <c:pt idx="1239">
                  <c:v>0.53222999999999998</c:v>
                </c:pt>
                <c:pt idx="1240">
                  <c:v>0.53222999999999998</c:v>
                </c:pt>
                <c:pt idx="1241">
                  <c:v>0.53222999999999998</c:v>
                </c:pt>
                <c:pt idx="1242">
                  <c:v>0.53222999999999998</c:v>
                </c:pt>
                <c:pt idx="1243">
                  <c:v>0.53344999999999998</c:v>
                </c:pt>
                <c:pt idx="1244">
                  <c:v>0.53344999999999998</c:v>
                </c:pt>
                <c:pt idx="1245">
                  <c:v>0.53466999999999998</c:v>
                </c:pt>
                <c:pt idx="1246">
                  <c:v>0.53466999999999998</c:v>
                </c:pt>
                <c:pt idx="1247">
                  <c:v>0.53466999999999998</c:v>
                </c:pt>
                <c:pt idx="1248">
                  <c:v>0.53466999999999998</c:v>
                </c:pt>
                <c:pt idx="1249">
                  <c:v>0.53588999999999998</c:v>
                </c:pt>
                <c:pt idx="1250">
                  <c:v>0.53832999999999998</c:v>
                </c:pt>
                <c:pt idx="1251">
                  <c:v>0.54198999999999997</c:v>
                </c:pt>
                <c:pt idx="1252">
                  <c:v>0.54688000000000003</c:v>
                </c:pt>
                <c:pt idx="1253">
                  <c:v>0.55054000000000003</c:v>
                </c:pt>
                <c:pt idx="1254">
                  <c:v>0.55786000000000002</c:v>
                </c:pt>
                <c:pt idx="1255">
                  <c:v>0.56396000000000002</c:v>
                </c:pt>
                <c:pt idx="1256">
                  <c:v>0.57006999999999997</c:v>
                </c:pt>
                <c:pt idx="1257">
                  <c:v>0.57738999999999996</c:v>
                </c:pt>
                <c:pt idx="1258">
                  <c:v>0.58228000000000002</c:v>
                </c:pt>
                <c:pt idx="1259">
                  <c:v>0.58716000000000002</c:v>
                </c:pt>
                <c:pt idx="1260">
                  <c:v>0.58960000000000001</c:v>
                </c:pt>
                <c:pt idx="1261">
                  <c:v>0.59204000000000001</c:v>
                </c:pt>
                <c:pt idx="1262">
                  <c:v>0.59448000000000001</c:v>
                </c:pt>
                <c:pt idx="1263">
                  <c:v>0.59570000000000001</c:v>
                </c:pt>
                <c:pt idx="1264">
                  <c:v>0.59936999999999996</c:v>
                </c:pt>
                <c:pt idx="1265">
                  <c:v>0.60424999999999995</c:v>
                </c:pt>
                <c:pt idx="1266">
                  <c:v>0.60912999999999995</c:v>
                </c:pt>
                <c:pt idx="1267">
                  <c:v>0.61523000000000005</c:v>
                </c:pt>
                <c:pt idx="1268">
                  <c:v>0.62012</c:v>
                </c:pt>
                <c:pt idx="1269">
                  <c:v>0.625</c:v>
                </c:pt>
                <c:pt idx="1270">
                  <c:v>0.63109999999999999</c:v>
                </c:pt>
                <c:pt idx="1271">
                  <c:v>0.63721000000000005</c:v>
                </c:pt>
                <c:pt idx="1272">
                  <c:v>0.64209000000000005</c:v>
                </c:pt>
                <c:pt idx="1273">
                  <c:v>0.64697000000000005</c:v>
                </c:pt>
                <c:pt idx="1274">
                  <c:v>0.65063000000000004</c:v>
                </c:pt>
                <c:pt idx="1275">
                  <c:v>0.65429999999999999</c:v>
                </c:pt>
                <c:pt idx="1276">
                  <c:v>0.65917999999999999</c:v>
                </c:pt>
                <c:pt idx="1277">
                  <c:v>0.66161999999999999</c:v>
                </c:pt>
                <c:pt idx="1278">
                  <c:v>0.66283999999999998</c:v>
                </c:pt>
                <c:pt idx="1279">
                  <c:v>0.66283999999999998</c:v>
                </c:pt>
                <c:pt idx="1280">
                  <c:v>0.66283999999999998</c:v>
                </c:pt>
                <c:pt idx="1281">
                  <c:v>0.66283999999999998</c:v>
                </c:pt>
                <c:pt idx="1282">
                  <c:v>0.66283999999999998</c:v>
                </c:pt>
                <c:pt idx="1283">
                  <c:v>0.66283999999999998</c:v>
                </c:pt>
                <c:pt idx="1284">
                  <c:v>0.66283999999999998</c:v>
                </c:pt>
                <c:pt idx="1285">
                  <c:v>0.66405999999999998</c:v>
                </c:pt>
                <c:pt idx="1286">
                  <c:v>0.66405999999999998</c:v>
                </c:pt>
                <c:pt idx="1287">
                  <c:v>0.66527999999999998</c:v>
                </c:pt>
                <c:pt idx="1288">
                  <c:v>0.66527999999999998</c:v>
                </c:pt>
                <c:pt idx="1289">
                  <c:v>0.66527999999999998</c:v>
                </c:pt>
                <c:pt idx="1290">
                  <c:v>0.66405999999999998</c:v>
                </c:pt>
                <c:pt idx="1291">
                  <c:v>0.66405999999999998</c:v>
                </c:pt>
                <c:pt idx="1292">
                  <c:v>0.66283999999999998</c:v>
                </c:pt>
                <c:pt idx="1293">
                  <c:v>0.66161999999999999</c:v>
                </c:pt>
                <c:pt idx="1294">
                  <c:v>0.66039999999999999</c:v>
                </c:pt>
                <c:pt idx="1295">
                  <c:v>0.65673999999999999</c:v>
                </c:pt>
                <c:pt idx="1296">
                  <c:v>0.65307999999999999</c:v>
                </c:pt>
                <c:pt idx="1297">
                  <c:v>0.64941000000000004</c:v>
                </c:pt>
                <c:pt idx="1298">
                  <c:v>0.64575000000000005</c:v>
                </c:pt>
                <c:pt idx="1299">
                  <c:v>0.64087000000000005</c:v>
                </c:pt>
                <c:pt idx="1300">
                  <c:v>0.63843000000000005</c:v>
                </c:pt>
                <c:pt idx="1301">
                  <c:v>0.63353999999999999</c:v>
                </c:pt>
                <c:pt idx="1302">
                  <c:v>0.63721000000000005</c:v>
                </c:pt>
                <c:pt idx="1303">
                  <c:v>0.69945999999999997</c:v>
                </c:pt>
                <c:pt idx="1304">
                  <c:v>0.75927999999999995</c:v>
                </c:pt>
                <c:pt idx="1305">
                  <c:v>0.76781999999999995</c:v>
                </c:pt>
                <c:pt idx="1306">
                  <c:v>0.76293999999999995</c:v>
                </c:pt>
                <c:pt idx="1307">
                  <c:v>0.73241999999999996</c:v>
                </c:pt>
                <c:pt idx="1308">
                  <c:v>0.69823999999999997</c:v>
                </c:pt>
                <c:pt idx="1309">
                  <c:v>0.67383000000000004</c:v>
                </c:pt>
                <c:pt idx="1310">
                  <c:v>0.65917999999999999</c:v>
                </c:pt>
                <c:pt idx="1311">
                  <c:v>0.65063000000000004</c:v>
                </c:pt>
                <c:pt idx="1312">
                  <c:v>0.64575000000000005</c:v>
                </c:pt>
                <c:pt idx="1313">
                  <c:v>0.64209000000000005</c:v>
                </c:pt>
                <c:pt idx="1314">
                  <c:v>0.63721000000000005</c:v>
                </c:pt>
                <c:pt idx="1315">
                  <c:v>0.63231999999999999</c:v>
                </c:pt>
                <c:pt idx="1316">
                  <c:v>0.62622</c:v>
                </c:pt>
                <c:pt idx="1317">
                  <c:v>0.61646000000000001</c:v>
                </c:pt>
                <c:pt idx="1318">
                  <c:v>0.60668999999999995</c:v>
                </c:pt>
                <c:pt idx="1319">
                  <c:v>0.60058999999999996</c:v>
                </c:pt>
                <c:pt idx="1320">
                  <c:v>0.59692000000000001</c:v>
                </c:pt>
                <c:pt idx="1321">
                  <c:v>0.59326000000000001</c:v>
                </c:pt>
                <c:pt idx="1322">
                  <c:v>0.58960000000000001</c:v>
                </c:pt>
                <c:pt idx="1323">
                  <c:v>0.58594000000000002</c:v>
                </c:pt>
                <c:pt idx="1324">
                  <c:v>0.58472000000000002</c:v>
                </c:pt>
                <c:pt idx="1325">
                  <c:v>0.58228000000000002</c:v>
                </c:pt>
                <c:pt idx="1326">
                  <c:v>0.58228000000000002</c:v>
                </c:pt>
                <c:pt idx="1327">
                  <c:v>0.57982999999999996</c:v>
                </c:pt>
                <c:pt idx="1328">
                  <c:v>0.57982999999999996</c:v>
                </c:pt>
                <c:pt idx="1329">
                  <c:v>0.57860999999999996</c:v>
                </c:pt>
                <c:pt idx="1330">
                  <c:v>0.57738999999999996</c:v>
                </c:pt>
                <c:pt idx="1331">
                  <c:v>0.57738999999999996</c:v>
                </c:pt>
                <c:pt idx="1332">
                  <c:v>0.57616999999999996</c:v>
                </c:pt>
                <c:pt idx="1333">
                  <c:v>0.57616999999999996</c:v>
                </c:pt>
                <c:pt idx="1334">
                  <c:v>0.57494999999999996</c:v>
                </c:pt>
                <c:pt idx="1335">
                  <c:v>0.57372999999999996</c:v>
                </c:pt>
                <c:pt idx="1336">
                  <c:v>0.57250999999999996</c:v>
                </c:pt>
                <c:pt idx="1337">
                  <c:v>0.57250999999999996</c:v>
                </c:pt>
                <c:pt idx="1338">
                  <c:v>0.57372999999999996</c:v>
                </c:pt>
                <c:pt idx="1339">
                  <c:v>0.57372999999999996</c:v>
                </c:pt>
                <c:pt idx="1340">
                  <c:v>0.57250999999999996</c:v>
                </c:pt>
                <c:pt idx="1341">
                  <c:v>0.57006999999999997</c:v>
                </c:pt>
                <c:pt idx="1342">
                  <c:v>0.56884999999999997</c:v>
                </c:pt>
                <c:pt idx="1343">
                  <c:v>0.57128999999999996</c:v>
                </c:pt>
                <c:pt idx="1344">
                  <c:v>0.57250999999999996</c:v>
                </c:pt>
                <c:pt idx="1345">
                  <c:v>0.57494999999999996</c:v>
                </c:pt>
                <c:pt idx="1346">
                  <c:v>0.57494999999999996</c:v>
                </c:pt>
                <c:pt idx="1347">
                  <c:v>0.57616999999999996</c:v>
                </c:pt>
                <c:pt idx="1348">
                  <c:v>0.57616999999999996</c:v>
                </c:pt>
                <c:pt idx="1349">
                  <c:v>0.57616999999999996</c:v>
                </c:pt>
                <c:pt idx="1350">
                  <c:v>0.57860999999999996</c:v>
                </c:pt>
                <c:pt idx="1351">
                  <c:v>0.58104999999999996</c:v>
                </c:pt>
                <c:pt idx="1352">
                  <c:v>0.58472000000000002</c:v>
                </c:pt>
                <c:pt idx="1353">
                  <c:v>0.58838000000000001</c:v>
                </c:pt>
                <c:pt idx="1354">
                  <c:v>0.59204000000000001</c:v>
                </c:pt>
                <c:pt idx="1355">
                  <c:v>0.59570000000000001</c:v>
                </c:pt>
                <c:pt idx="1356">
                  <c:v>0.60302999999999995</c:v>
                </c:pt>
                <c:pt idx="1357">
                  <c:v>0.60790999999999995</c:v>
                </c:pt>
                <c:pt idx="1358">
                  <c:v>0.61523000000000005</c:v>
                </c:pt>
                <c:pt idx="1359">
                  <c:v>0.62012</c:v>
                </c:pt>
                <c:pt idx="1360">
                  <c:v>0.625</c:v>
                </c:pt>
                <c:pt idx="1361">
                  <c:v>0.62988</c:v>
                </c:pt>
                <c:pt idx="1362">
                  <c:v>0.63476999999999995</c:v>
                </c:pt>
                <c:pt idx="1363">
                  <c:v>0.64087000000000005</c:v>
                </c:pt>
                <c:pt idx="1364">
                  <c:v>0.64697000000000005</c:v>
                </c:pt>
                <c:pt idx="1365">
                  <c:v>0.65307999999999999</c:v>
                </c:pt>
                <c:pt idx="1366">
                  <c:v>0.65917999999999999</c:v>
                </c:pt>
                <c:pt idx="1367">
                  <c:v>0.66405999999999998</c:v>
                </c:pt>
                <c:pt idx="1368">
                  <c:v>0.66771999999999998</c:v>
                </c:pt>
                <c:pt idx="1369">
                  <c:v>0.67017000000000004</c:v>
                </c:pt>
                <c:pt idx="1370">
                  <c:v>0.67139000000000004</c:v>
                </c:pt>
                <c:pt idx="1371">
                  <c:v>0.67383000000000004</c:v>
                </c:pt>
                <c:pt idx="1372">
                  <c:v>0.67505000000000004</c:v>
                </c:pt>
                <c:pt idx="1373">
                  <c:v>0.67749000000000004</c:v>
                </c:pt>
                <c:pt idx="1374">
                  <c:v>0.67993000000000003</c:v>
                </c:pt>
                <c:pt idx="1375">
                  <c:v>0.68237000000000003</c:v>
                </c:pt>
                <c:pt idx="1376">
                  <c:v>0.68725999999999998</c:v>
                </c:pt>
                <c:pt idx="1377">
                  <c:v>0.69091999999999998</c:v>
                </c:pt>
                <c:pt idx="1378">
                  <c:v>0.69457999999999998</c:v>
                </c:pt>
                <c:pt idx="1379">
                  <c:v>0.69823999999999997</c:v>
                </c:pt>
                <c:pt idx="1380">
                  <c:v>0.69945999999999997</c:v>
                </c:pt>
                <c:pt idx="1381">
                  <c:v>0.70067999999999997</c:v>
                </c:pt>
                <c:pt idx="1382">
                  <c:v>0.70313000000000003</c:v>
                </c:pt>
                <c:pt idx="1383">
                  <c:v>0.70313000000000003</c:v>
                </c:pt>
                <c:pt idx="1384">
                  <c:v>0.70435000000000003</c:v>
                </c:pt>
                <c:pt idx="1385">
                  <c:v>0.70435000000000003</c:v>
                </c:pt>
                <c:pt idx="1386">
                  <c:v>0.70557000000000003</c:v>
                </c:pt>
                <c:pt idx="1387">
                  <c:v>0.70435000000000003</c:v>
                </c:pt>
                <c:pt idx="1388">
                  <c:v>0.70313000000000003</c:v>
                </c:pt>
                <c:pt idx="1389">
                  <c:v>0.70189999999999997</c:v>
                </c:pt>
                <c:pt idx="1390">
                  <c:v>0.70067999999999997</c:v>
                </c:pt>
                <c:pt idx="1391">
                  <c:v>0.69945999999999997</c:v>
                </c:pt>
                <c:pt idx="1392">
                  <c:v>0.69945999999999997</c:v>
                </c:pt>
                <c:pt idx="1393">
                  <c:v>0.69823999999999997</c:v>
                </c:pt>
                <c:pt idx="1394">
                  <c:v>0.69701999999999997</c:v>
                </c:pt>
                <c:pt idx="1395">
                  <c:v>0.69579999999999997</c:v>
                </c:pt>
                <c:pt idx="1396">
                  <c:v>0.69457999999999998</c:v>
                </c:pt>
                <c:pt idx="1397">
                  <c:v>0.69335999999999998</c:v>
                </c:pt>
                <c:pt idx="1398">
                  <c:v>0.68969999999999998</c:v>
                </c:pt>
                <c:pt idx="1399">
                  <c:v>0.68725999999999998</c:v>
                </c:pt>
                <c:pt idx="1400">
                  <c:v>0.68359000000000003</c:v>
                </c:pt>
                <c:pt idx="1401">
                  <c:v>0.67749000000000004</c:v>
                </c:pt>
                <c:pt idx="1402">
                  <c:v>0.67139000000000004</c:v>
                </c:pt>
                <c:pt idx="1403">
                  <c:v>0.66527999999999998</c:v>
                </c:pt>
                <c:pt idx="1404">
                  <c:v>0.65917999999999999</c:v>
                </c:pt>
                <c:pt idx="1405">
                  <c:v>0.65185999999999999</c:v>
                </c:pt>
                <c:pt idx="1406">
                  <c:v>0.64697000000000005</c:v>
                </c:pt>
                <c:pt idx="1407">
                  <c:v>0.64087000000000005</c:v>
                </c:pt>
                <c:pt idx="1408">
                  <c:v>0.63599000000000006</c:v>
                </c:pt>
                <c:pt idx="1409">
                  <c:v>0.63109999999999999</c:v>
                </c:pt>
                <c:pt idx="1410">
                  <c:v>0.62744</c:v>
                </c:pt>
                <c:pt idx="1411">
                  <c:v>0.625</c:v>
                </c:pt>
                <c:pt idx="1412">
                  <c:v>0.625</c:v>
                </c:pt>
                <c:pt idx="1413">
                  <c:v>0.62378</c:v>
                </c:pt>
                <c:pt idx="1414">
                  <c:v>0.62378</c:v>
                </c:pt>
                <c:pt idx="1415">
                  <c:v>0.62378</c:v>
                </c:pt>
                <c:pt idx="1416">
                  <c:v>0.62256</c:v>
                </c:pt>
                <c:pt idx="1417">
                  <c:v>0.62012</c:v>
                </c:pt>
                <c:pt idx="1418">
                  <c:v>0.62012</c:v>
                </c:pt>
                <c:pt idx="1419">
                  <c:v>0.61890000000000001</c:v>
                </c:pt>
                <c:pt idx="1420">
                  <c:v>0.61768000000000001</c:v>
                </c:pt>
                <c:pt idx="1421">
                  <c:v>0.61768000000000001</c:v>
                </c:pt>
                <c:pt idx="1422">
                  <c:v>0.61646000000000001</c:v>
                </c:pt>
                <c:pt idx="1423">
                  <c:v>0.61278999999999995</c:v>
                </c:pt>
                <c:pt idx="1424">
                  <c:v>0.61278999999999995</c:v>
                </c:pt>
                <c:pt idx="1425">
                  <c:v>0.61278999999999995</c:v>
                </c:pt>
                <c:pt idx="1426">
                  <c:v>0.61523000000000005</c:v>
                </c:pt>
                <c:pt idx="1427">
                  <c:v>0.61768000000000001</c:v>
                </c:pt>
                <c:pt idx="1428">
                  <c:v>0.62378</c:v>
                </c:pt>
                <c:pt idx="1429">
                  <c:v>0.62744</c:v>
                </c:pt>
                <c:pt idx="1430">
                  <c:v>0.63231999999999999</c:v>
                </c:pt>
                <c:pt idx="1431">
                  <c:v>0.63476999999999995</c:v>
                </c:pt>
                <c:pt idx="1432">
                  <c:v>0.63721000000000005</c:v>
                </c:pt>
                <c:pt idx="1433">
                  <c:v>0.63843000000000005</c:v>
                </c:pt>
                <c:pt idx="1434">
                  <c:v>0.63965000000000005</c:v>
                </c:pt>
                <c:pt idx="1435">
                  <c:v>0.64087000000000005</c:v>
                </c:pt>
                <c:pt idx="1436">
                  <c:v>0.64331000000000005</c:v>
                </c:pt>
                <c:pt idx="1437">
                  <c:v>0.64453000000000005</c:v>
                </c:pt>
                <c:pt idx="1438">
                  <c:v>0.64697000000000005</c:v>
                </c:pt>
                <c:pt idx="1439">
                  <c:v>0.65063000000000004</c:v>
                </c:pt>
                <c:pt idx="1440">
                  <c:v>0.65551999999999999</c:v>
                </c:pt>
                <c:pt idx="1441">
                  <c:v>0.66161999999999999</c:v>
                </c:pt>
                <c:pt idx="1442">
                  <c:v>0.66771999999999998</c:v>
                </c:pt>
                <c:pt idx="1443">
                  <c:v>0.67383000000000004</c:v>
                </c:pt>
                <c:pt idx="1444">
                  <c:v>0.68237000000000003</c:v>
                </c:pt>
                <c:pt idx="1445">
                  <c:v>0.69213999999999998</c:v>
                </c:pt>
                <c:pt idx="1446">
                  <c:v>0.70067999999999997</c:v>
                </c:pt>
                <c:pt idx="1447">
                  <c:v>0.70923000000000003</c:v>
                </c:pt>
                <c:pt idx="1448">
                  <c:v>0.71655000000000002</c:v>
                </c:pt>
                <c:pt idx="1449">
                  <c:v>0.72387999999999997</c:v>
                </c:pt>
                <c:pt idx="1450">
                  <c:v>0.72875999999999996</c:v>
                </c:pt>
                <c:pt idx="1451">
                  <c:v>0.73363999999999996</c:v>
                </c:pt>
                <c:pt idx="1452">
                  <c:v>0.73607999999999996</c:v>
                </c:pt>
                <c:pt idx="1453">
                  <c:v>0.73853000000000002</c:v>
                </c:pt>
                <c:pt idx="1454">
                  <c:v>0.73853000000000002</c:v>
                </c:pt>
                <c:pt idx="1455">
                  <c:v>0.73975000000000002</c:v>
                </c:pt>
                <c:pt idx="1456">
                  <c:v>0.74097000000000002</c:v>
                </c:pt>
                <c:pt idx="1457">
                  <c:v>0.74219000000000002</c:v>
                </c:pt>
                <c:pt idx="1458">
                  <c:v>0.74219000000000002</c:v>
                </c:pt>
                <c:pt idx="1459">
                  <c:v>0.74097000000000002</c:v>
                </c:pt>
                <c:pt idx="1460">
                  <c:v>0.74097000000000002</c:v>
                </c:pt>
                <c:pt idx="1461">
                  <c:v>0.73975000000000002</c:v>
                </c:pt>
                <c:pt idx="1462">
                  <c:v>0.73853000000000002</c:v>
                </c:pt>
                <c:pt idx="1463">
                  <c:v>0.73607999999999996</c:v>
                </c:pt>
                <c:pt idx="1464">
                  <c:v>0.73363999999999996</c:v>
                </c:pt>
                <c:pt idx="1465">
                  <c:v>0.72997999999999996</c:v>
                </c:pt>
                <c:pt idx="1466">
                  <c:v>0.72509999999999997</c:v>
                </c:pt>
                <c:pt idx="1467">
                  <c:v>0.72021000000000002</c:v>
                </c:pt>
                <c:pt idx="1468">
                  <c:v>0.71289000000000002</c:v>
                </c:pt>
                <c:pt idx="1469">
                  <c:v>0.70679000000000003</c:v>
                </c:pt>
                <c:pt idx="1470">
                  <c:v>0.69945999999999997</c:v>
                </c:pt>
                <c:pt idx="1471">
                  <c:v>0.69213999999999998</c:v>
                </c:pt>
                <c:pt idx="1472">
                  <c:v>0.68481000000000003</c:v>
                </c:pt>
                <c:pt idx="1473">
                  <c:v>0.67749000000000004</c:v>
                </c:pt>
                <c:pt idx="1474">
                  <c:v>0.67261000000000004</c:v>
                </c:pt>
                <c:pt idx="1475">
                  <c:v>0.66895000000000004</c:v>
                </c:pt>
                <c:pt idx="1476">
                  <c:v>0.66649999999999998</c:v>
                </c:pt>
                <c:pt idx="1477">
                  <c:v>0.66527999999999998</c:v>
                </c:pt>
                <c:pt idx="1478">
                  <c:v>0.66405999999999998</c:v>
                </c:pt>
                <c:pt idx="1479">
                  <c:v>0.66283999999999998</c:v>
                </c:pt>
                <c:pt idx="1480">
                  <c:v>0.66161999999999999</c:v>
                </c:pt>
                <c:pt idx="1481">
                  <c:v>0.66039999999999999</c:v>
                </c:pt>
                <c:pt idx="1482">
                  <c:v>0.66039999999999999</c:v>
                </c:pt>
                <c:pt idx="1483">
                  <c:v>0.66283999999999998</c:v>
                </c:pt>
                <c:pt idx="1484">
                  <c:v>0.66283999999999998</c:v>
                </c:pt>
                <c:pt idx="1485">
                  <c:v>0.66161999999999999</c:v>
                </c:pt>
                <c:pt idx="1486">
                  <c:v>0.65917999999999999</c:v>
                </c:pt>
                <c:pt idx="1487">
                  <c:v>0.65917999999999999</c:v>
                </c:pt>
                <c:pt idx="1488">
                  <c:v>0.66161999999999999</c:v>
                </c:pt>
                <c:pt idx="1489">
                  <c:v>0.66649999999999998</c:v>
                </c:pt>
                <c:pt idx="1490">
                  <c:v>0.67383000000000004</c:v>
                </c:pt>
                <c:pt idx="1491">
                  <c:v>0.67993000000000003</c:v>
                </c:pt>
                <c:pt idx="1492">
                  <c:v>0.68725999999999998</c:v>
                </c:pt>
                <c:pt idx="1493">
                  <c:v>0.69579999999999997</c:v>
                </c:pt>
                <c:pt idx="1494">
                  <c:v>0.70435000000000003</c:v>
                </c:pt>
                <c:pt idx="1495">
                  <c:v>0.71289000000000002</c:v>
                </c:pt>
                <c:pt idx="1496">
                  <c:v>0.72143999999999997</c:v>
                </c:pt>
                <c:pt idx="1497">
                  <c:v>0.72875999999999996</c:v>
                </c:pt>
                <c:pt idx="1498">
                  <c:v>0.73119999999999996</c:v>
                </c:pt>
                <c:pt idx="1499">
                  <c:v>0.73119999999999996</c:v>
                </c:pt>
                <c:pt idx="1500">
                  <c:v>0.73119999999999996</c:v>
                </c:pt>
                <c:pt idx="1501">
                  <c:v>0.73119999999999996</c:v>
                </c:pt>
                <c:pt idx="1502">
                  <c:v>0.73363999999999996</c:v>
                </c:pt>
                <c:pt idx="1503">
                  <c:v>0.73729999999999996</c:v>
                </c:pt>
                <c:pt idx="1504">
                  <c:v>0.73975000000000002</c:v>
                </c:pt>
                <c:pt idx="1505">
                  <c:v>0.74219000000000002</c:v>
                </c:pt>
                <c:pt idx="1506">
                  <c:v>0.74463000000000001</c:v>
                </c:pt>
                <c:pt idx="1507">
                  <c:v>0.74707000000000001</c:v>
                </c:pt>
                <c:pt idx="1508">
                  <c:v>0.74951000000000001</c:v>
                </c:pt>
                <c:pt idx="1509">
                  <c:v>0.75195000000000001</c:v>
                </c:pt>
                <c:pt idx="1510">
                  <c:v>0.75683999999999996</c:v>
                </c:pt>
                <c:pt idx="1511">
                  <c:v>0.76049999999999995</c:v>
                </c:pt>
                <c:pt idx="1512">
                  <c:v>0.76415999999999995</c:v>
                </c:pt>
                <c:pt idx="1513">
                  <c:v>0.76781999999999995</c:v>
                </c:pt>
                <c:pt idx="1514">
                  <c:v>0.77025999999999994</c:v>
                </c:pt>
                <c:pt idx="1515">
                  <c:v>0.77148000000000005</c:v>
                </c:pt>
                <c:pt idx="1516">
                  <c:v>0.77393000000000001</c:v>
                </c:pt>
                <c:pt idx="1517">
                  <c:v>0.77393000000000001</c:v>
                </c:pt>
                <c:pt idx="1518">
                  <c:v>0.77393000000000001</c:v>
                </c:pt>
                <c:pt idx="1519">
                  <c:v>0.77393000000000001</c:v>
                </c:pt>
                <c:pt idx="1520">
                  <c:v>0.77393000000000001</c:v>
                </c:pt>
                <c:pt idx="1521">
                  <c:v>0.77271000000000001</c:v>
                </c:pt>
                <c:pt idx="1522">
                  <c:v>0.77148000000000005</c:v>
                </c:pt>
                <c:pt idx="1523">
                  <c:v>0.77148000000000005</c:v>
                </c:pt>
                <c:pt idx="1524">
                  <c:v>0.77148000000000005</c:v>
                </c:pt>
                <c:pt idx="1525">
                  <c:v>0.77148000000000005</c:v>
                </c:pt>
                <c:pt idx="1526">
                  <c:v>0.77271000000000001</c:v>
                </c:pt>
                <c:pt idx="1527">
                  <c:v>0.77271000000000001</c:v>
                </c:pt>
                <c:pt idx="1528">
                  <c:v>0.77271000000000001</c:v>
                </c:pt>
                <c:pt idx="1529">
                  <c:v>0.77148000000000005</c:v>
                </c:pt>
                <c:pt idx="1530">
                  <c:v>0.77025999999999994</c:v>
                </c:pt>
                <c:pt idx="1531">
                  <c:v>0.77025999999999994</c:v>
                </c:pt>
                <c:pt idx="1532">
                  <c:v>0.76903999999999995</c:v>
                </c:pt>
                <c:pt idx="1533">
                  <c:v>0.76903999999999995</c:v>
                </c:pt>
                <c:pt idx="1534">
                  <c:v>0.76903999999999995</c:v>
                </c:pt>
                <c:pt idx="1535">
                  <c:v>0.77025999999999994</c:v>
                </c:pt>
                <c:pt idx="1536">
                  <c:v>0.77148000000000005</c:v>
                </c:pt>
                <c:pt idx="1537">
                  <c:v>0.77148000000000005</c:v>
                </c:pt>
                <c:pt idx="1538">
                  <c:v>0.77271000000000001</c:v>
                </c:pt>
                <c:pt idx="1539">
                  <c:v>0.77271000000000001</c:v>
                </c:pt>
                <c:pt idx="1540">
                  <c:v>0.77271000000000001</c:v>
                </c:pt>
                <c:pt idx="1541">
                  <c:v>0.77271000000000001</c:v>
                </c:pt>
                <c:pt idx="1542">
                  <c:v>0.77393000000000001</c:v>
                </c:pt>
                <c:pt idx="1543">
                  <c:v>0.77393000000000001</c:v>
                </c:pt>
                <c:pt idx="1544">
                  <c:v>0.77393000000000001</c:v>
                </c:pt>
                <c:pt idx="1545">
                  <c:v>0.77271000000000001</c:v>
                </c:pt>
                <c:pt idx="1546">
                  <c:v>0.77271000000000001</c:v>
                </c:pt>
                <c:pt idx="1547">
                  <c:v>0.77148000000000005</c:v>
                </c:pt>
                <c:pt idx="1548">
                  <c:v>0.77148000000000005</c:v>
                </c:pt>
                <c:pt idx="1549">
                  <c:v>0.77025999999999994</c:v>
                </c:pt>
                <c:pt idx="1550">
                  <c:v>0.76903999999999995</c:v>
                </c:pt>
                <c:pt idx="1551">
                  <c:v>0.76903999999999995</c:v>
                </c:pt>
                <c:pt idx="1552">
                  <c:v>0.76903999999999995</c:v>
                </c:pt>
                <c:pt idx="1553">
                  <c:v>0.77025999999999994</c:v>
                </c:pt>
                <c:pt idx="1554">
                  <c:v>0.77515000000000001</c:v>
                </c:pt>
                <c:pt idx="1555">
                  <c:v>0.77881</c:v>
                </c:pt>
                <c:pt idx="1556">
                  <c:v>0.78613</c:v>
                </c:pt>
                <c:pt idx="1557">
                  <c:v>0.79224000000000006</c:v>
                </c:pt>
                <c:pt idx="1558">
                  <c:v>0.80078000000000005</c:v>
                </c:pt>
                <c:pt idx="1559">
                  <c:v>0.80810999999999999</c:v>
                </c:pt>
                <c:pt idx="1560">
                  <c:v>0.83130000000000004</c:v>
                </c:pt>
                <c:pt idx="1561">
                  <c:v>0.87524000000000002</c:v>
                </c:pt>
                <c:pt idx="1562">
                  <c:v>0.93140000000000001</c:v>
                </c:pt>
                <c:pt idx="1563">
                  <c:v>0.98999000000000004</c:v>
                </c:pt>
                <c:pt idx="1564">
                  <c:v>1.0351999999999999</c:v>
                </c:pt>
                <c:pt idx="1565">
                  <c:v>1.0486</c:v>
                </c:pt>
                <c:pt idx="1566">
                  <c:v>1.0437000000000001</c:v>
                </c:pt>
                <c:pt idx="1567">
                  <c:v>0.98633000000000004</c:v>
                </c:pt>
                <c:pt idx="1568">
                  <c:v>0.86548000000000003</c:v>
                </c:pt>
                <c:pt idx="1569">
                  <c:v>0.73241999999999996</c:v>
                </c:pt>
                <c:pt idx="1570">
                  <c:v>0.62988</c:v>
                </c:pt>
                <c:pt idx="1571">
                  <c:v>0.55786000000000002</c:v>
                </c:pt>
                <c:pt idx="1572">
                  <c:v>0.51392000000000004</c:v>
                </c:pt>
                <c:pt idx="1573">
                  <c:v>0.48827999999999999</c:v>
                </c:pt>
                <c:pt idx="1574">
                  <c:v>0.47363</c:v>
                </c:pt>
                <c:pt idx="1575">
                  <c:v>0.46631</c:v>
                </c:pt>
                <c:pt idx="1576">
                  <c:v>0.45898</c:v>
                </c:pt>
                <c:pt idx="1577">
                  <c:v>0.4541</c:v>
                </c:pt>
                <c:pt idx="1578">
                  <c:v>0.45166000000000001</c:v>
                </c:pt>
                <c:pt idx="1579">
                  <c:v>0.44678000000000001</c:v>
                </c:pt>
                <c:pt idx="1580">
                  <c:v>0.44434000000000001</c:v>
                </c:pt>
                <c:pt idx="1581">
                  <c:v>0.44312000000000001</c:v>
                </c:pt>
                <c:pt idx="1582">
                  <c:v>0.44067000000000001</c:v>
                </c:pt>
                <c:pt idx="1583">
                  <c:v>0.43945000000000001</c:v>
                </c:pt>
                <c:pt idx="1584">
                  <c:v>0.43945000000000001</c:v>
                </c:pt>
                <c:pt idx="1585">
                  <c:v>0.43823000000000001</c:v>
                </c:pt>
                <c:pt idx="1586">
                  <c:v>0.43701000000000001</c:v>
                </c:pt>
                <c:pt idx="1587">
                  <c:v>0.43457000000000001</c:v>
                </c:pt>
                <c:pt idx="1588">
                  <c:v>0.43213000000000001</c:v>
                </c:pt>
                <c:pt idx="1589">
                  <c:v>0.43091000000000002</c:v>
                </c:pt>
                <c:pt idx="1590">
                  <c:v>0.42969000000000002</c:v>
                </c:pt>
                <c:pt idx="1591">
                  <c:v>0.42847000000000002</c:v>
                </c:pt>
                <c:pt idx="1592">
                  <c:v>0.42603000000000002</c:v>
                </c:pt>
                <c:pt idx="1593">
                  <c:v>0.42603000000000002</c:v>
                </c:pt>
                <c:pt idx="1594">
                  <c:v>0.42603000000000002</c:v>
                </c:pt>
                <c:pt idx="1595">
                  <c:v>0.42603000000000002</c:v>
                </c:pt>
                <c:pt idx="1596">
                  <c:v>0.42603000000000002</c:v>
                </c:pt>
                <c:pt idx="1597">
                  <c:v>0.42603000000000002</c:v>
                </c:pt>
                <c:pt idx="1598">
                  <c:v>0.42480000000000001</c:v>
                </c:pt>
                <c:pt idx="1599">
                  <c:v>0.42480000000000001</c:v>
                </c:pt>
                <c:pt idx="1600">
                  <c:v>0.42358000000000001</c:v>
                </c:pt>
                <c:pt idx="1601">
                  <c:v>0.42236000000000001</c:v>
                </c:pt>
                <c:pt idx="1602">
                  <c:v>0.42114000000000001</c:v>
                </c:pt>
                <c:pt idx="1603">
                  <c:v>0.42114000000000001</c:v>
                </c:pt>
                <c:pt idx="1604">
                  <c:v>0.42114000000000001</c:v>
                </c:pt>
                <c:pt idx="1605">
                  <c:v>0.42114000000000001</c:v>
                </c:pt>
                <c:pt idx="1606">
                  <c:v>0.42114000000000001</c:v>
                </c:pt>
                <c:pt idx="1607">
                  <c:v>0.42236000000000001</c:v>
                </c:pt>
                <c:pt idx="1608">
                  <c:v>0.42236000000000001</c:v>
                </c:pt>
                <c:pt idx="1609">
                  <c:v>0.42236000000000001</c:v>
                </c:pt>
                <c:pt idx="1610">
                  <c:v>0.42236000000000001</c:v>
                </c:pt>
                <c:pt idx="1611">
                  <c:v>0.41992000000000002</c:v>
                </c:pt>
                <c:pt idx="1612">
                  <c:v>0.41992000000000002</c:v>
                </c:pt>
                <c:pt idx="1613">
                  <c:v>0.41870000000000002</c:v>
                </c:pt>
                <c:pt idx="1614">
                  <c:v>0.41870000000000002</c:v>
                </c:pt>
                <c:pt idx="1615">
                  <c:v>0.41748000000000002</c:v>
                </c:pt>
                <c:pt idx="1616">
                  <c:v>0.41748000000000002</c:v>
                </c:pt>
                <c:pt idx="1617">
                  <c:v>0.41748000000000002</c:v>
                </c:pt>
                <c:pt idx="1618">
                  <c:v>0.41626000000000002</c:v>
                </c:pt>
                <c:pt idx="1619">
                  <c:v>0.41504000000000002</c:v>
                </c:pt>
                <c:pt idx="1620">
                  <c:v>0.41504000000000002</c:v>
                </c:pt>
                <c:pt idx="1621">
                  <c:v>0.41504000000000002</c:v>
                </c:pt>
                <c:pt idx="1622">
                  <c:v>0.41382000000000002</c:v>
                </c:pt>
                <c:pt idx="1623">
                  <c:v>0.41504000000000002</c:v>
                </c:pt>
                <c:pt idx="1624">
                  <c:v>0.41382000000000002</c:v>
                </c:pt>
                <c:pt idx="1625">
                  <c:v>0.41382000000000002</c:v>
                </c:pt>
                <c:pt idx="1626">
                  <c:v>0.41504000000000002</c:v>
                </c:pt>
                <c:pt idx="1627">
                  <c:v>0.41504000000000002</c:v>
                </c:pt>
                <c:pt idx="1628">
                  <c:v>0.41504000000000002</c:v>
                </c:pt>
                <c:pt idx="1629">
                  <c:v>0.41504000000000002</c:v>
                </c:pt>
                <c:pt idx="1630">
                  <c:v>0.41504000000000002</c:v>
                </c:pt>
                <c:pt idx="1631">
                  <c:v>0.41382000000000002</c:v>
                </c:pt>
                <c:pt idx="1632">
                  <c:v>0.41382000000000002</c:v>
                </c:pt>
                <c:pt idx="1633">
                  <c:v>0.41382000000000002</c:v>
                </c:pt>
                <c:pt idx="1634">
                  <c:v>0.41138000000000002</c:v>
                </c:pt>
                <c:pt idx="1635">
                  <c:v>0.41260000000000002</c:v>
                </c:pt>
                <c:pt idx="1636">
                  <c:v>0.41138000000000002</c:v>
                </c:pt>
                <c:pt idx="1637">
                  <c:v>0.41016000000000002</c:v>
                </c:pt>
                <c:pt idx="1638">
                  <c:v>0.41016000000000002</c:v>
                </c:pt>
                <c:pt idx="1639">
                  <c:v>0.41016000000000002</c:v>
                </c:pt>
                <c:pt idx="1640">
                  <c:v>0.41016000000000002</c:v>
                </c:pt>
                <c:pt idx="1641">
                  <c:v>0.41016000000000002</c:v>
                </c:pt>
                <c:pt idx="1642">
                  <c:v>0.41016000000000002</c:v>
                </c:pt>
                <c:pt idx="1643">
                  <c:v>0.41016000000000002</c:v>
                </c:pt>
                <c:pt idx="1644">
                  <c:v>0.40894000000000003</c:v>
                </c:pt>
                <c:pt idx="1645">
                  <c:v>0.41016000000000002</c:v>
                </c:pt>
                <c:pt idx="1646">
                  <c:v>0.41016000000000002</c:v>
                </c:pt>
                <c:pt idx="1647">
                  <c:v>0.41016000000000002</c:v>
                </c:pt>
                <c:pt idx="1648">
                  <c:v>0.41138000000000002</c:v>
                </c:pt>
                <c:pt idx="1649">
                  <c:v>0.41138000000000002</c:v>
                </c:pt>
                <c:pt idx="1650">
                  <c:v>0.41138000000000002</c:v>
                </c:pt>
                <c:pt idx="1651">
                  <c:v>0.41138000000000002</c:v>
                </c:pt>
                <c:pt idx="1652">
                  <c:v>0.41138000000000002</c:v>
                </c:pt>
                <c:pt idx="1653">
                  <c:v>0.41016000000000002</c:v>
                </c:pt>
                <c:pt idx="1654">
                  <c:v>0.41016000000000002</c:v>
                </c:pt>
                <c:pt idx="1655">
                  <c:v>0.40894000000000003</c:v>
                </c:pt>
                <c:pt idx="1656">
                  <c:v>0.40894000000000003</c:v>
                </c:pt>
                <c:pt idx="1657">
                  <c:v>0.40771000000000002</c:v>
                </c:pt>
                <c:pt idx="1658">
                  <c:v>0.40771000000000002</c:v>
                </c:pt>
                <c:pt idx="1659">
                  <c:v>0.40771000000000002</c:v>
                </c:pt>
                <c:pt idx="1660">
                  <c:v>0.40771000000000002</c:v>
                </c:pt>
                <c:pt idx="1661">
                  <c:v>0.40771000000000002</c:v>
                </c:pt>
                <c:pt idx="1662">
                  <c:v>0.40771000000000002</c:v>
                </c:pt>
                <c:pt idx="1663">
                  <c:v>0.40771000000000002</c:v>
                </c:pt>
                <c:pt idx="1664">
                  <c:v>0.40771000000000002</c:v>
                </c:pt>
                <c:pt idx="1665">
                  <c:v>0.40771000000000002</c:v>
                </c:pt>
                <c:pt idx="1666">
                  <c:v>0.40771000000000002</c:v>
                </c:pt>
                <c:pt idx="1667">
                  <c:v>0.40771000000000002</c:v>
                </c:pt>
                <c:pt idx="1668">
                  <c:v>0.40894000000000003</c:v>
                </c:pt>
                <c:pt idx="1669">
                  <c:v>0.40894000000000003</c:v>
                </c:pt>
                <c:pt idx="1670">
                  <c:v>0.40894000000000003</c:v>
                </c:pt>
                <c:pt idx="1671">
                  <c:v>0.40894000000000003</c:v>
                </c:pt>
                <c:pt idx="1672">
                  <c:v>0.40894000000000003</c:v>
                </c:pt>
                <c:pt idx="1673">
                  <c:v>0.40894000000000003</c:v>
                </c:pt>
                <c:pt idx="1674">
                  <c:v>0.40894000000000003</c:v>
                </c:pt>
                <c:pt idx="1675">
                  <c:v>0.40894000000000003</c:v>
                </c:pt>
                <c:pt idx="1676">
                  <c:v>0.40894000000000003</c:v>
                </c:pt>
                <c:pt idx="1677">
                  <c:v>0.40771000000000002</c:v>
                </c:pt>
                <c:pt idx="1678">
                  <c:v>0.40771000000000002</c:v>
                </c:pt>
                <c:pt idx="1679">
                  <c:v>0.40771000000000002</c:v>
                </c:pt>
                <c:pt idx="1680">
                  <c:v>0.40771000000000002</c:v>
                </c:pt>
                <c:pt idx="1681">
                  <c:v>0.40649000000000002</c:v>
                </c:pt>
                <c:pt idx="1682">
                  <c:v>0.40649000000000002</c:v>
                </c:pt>
                <c:pt idx="1683">
                  <c:v>0.40649000000000002</c:v>
                </c:pt>
                <c:pt idx="1684">
                  <c:v>0.40527000000000002</c:v>
                </c:pt>
                <c:pt idx="1685">
                  <c:v>0.40527000000000002</c:v>
                </c:pt>
                <c:pt idx="1686">
                  <c:v>0.40527000000000002</c:v>
                </c:pt>
                <c:pt idx="1687">
                  <c:v>0.40527000000000002</c:v>
                </c:pt>
                <c:pt idx="1688">
                  <c:v>0.40527000000000002</c:v>
                </c:pt>
                <c:pt idx="1689">
                  <c:v>0.40527000000000002</c:v>
                </c:pt>
                <c:pt idx="1690">
                  <c:v>0.40527000000000002</c:v>
                </c:pt>
                <c:pt idx="1691">
                  <c:v>0.40649000000000002</c:v>
                </c:pt>
                <c:pt idx="1692">
                  <c:v>0.40771000000000002</c:v>
                </c:pt>
                <c:pt idx="1693">
                  <c:v>0.40771000000000002</c:v>
                </c:pt>
                <c:pt idx="1694">
                  <c:v>0.40771000000000002</c:v>
                </c:pt>
                <c:pt idx="1695">
                  <c:v>0.40771000000000002</c:v>
                </c:pt>
                <c:pt idx="1696">
                  <c:v>0.40771000000000002</c:v>
                </c:pt>
                <c:pt idx="1697">
                  <c:v>0.40771000000000002</c:v>
                </c:pt>
                <c:pt idx="1698">
                  <c:v>0.40649000000000002</c:v>
                </c:pt>
                <c:pt idx="1699">
                  <c:v>0.40649000000000002</c:v>
                </c:pt>
                <c:pt idx="1700">
                  <c:v>0.40649000000000002</c:v>
                </c:pt>
                <c:pt idx="1701">
                  <c:v>0.40527000000000002</c:v>
                </c:pt>
                <c:pt idx="1702">
                  <c:v>0.40527000000000002</c:v>
                </c:pt>
                <c:pt idx="1703">
                  <c:v>0.40527000000000002</c:v>
                </c:pt>
                <c:pt idx="1704">
                  <c:v>0.40527000000000002</c:v>
                </c:pt>
                <c:pt idx="1705">
                  <c:v>0.40527000000000002</c:v>
                </c:pt>
                <c:pt idx="1706">
                  <c:v>0.40405000000000002</c:v>
                </c:pt>
                <c:pt idx="1707">
                  <c:v>0.40527000000000002</c:v>
                </c:pt>
                <c:pt idx="1708">
                  <c:v>0.40405000000000002</c:v>
                </c:pt>
                <c:pt idx="1709">
                  <c:v>0.40527000000000002</c:v>
                </c:pt>
                <c:pt idx="1710">
                  <c:v>0.40527000000000002</c:v>
                </c:pt>
                <c:pt idx="1711">
                  <c:v>0.40527000000000002</c:v>
                </c:pt>
                <c:pt idx="1712">
                  <c:v>0.40527000000000002</c:v>
                </c:pt>
                <c:pt idx="1713">
                  <c:v>0.40649000000000002</c:v>
                </c:pt>
                <c:pt idx="1714">
                  <c:v>0.40649000000000002</c:v>
                </c:pt>
                <c:pt idx="1715">
                  <c:v>0.40649000000000002</c:v>
                </c:pt>
                <c:pt idx="1716">
                  <c:v>0.40771000000000002</c:v>
                </c:pt>
                <c:pt idx="1717">
                  <c:v>0.40649000000000002</c:v>
                </c:pt>
                <c:pt idx="1718">
                  <c:v>0.40527000000000002</c:v>
                </c:pt>
                <c:pt idx="1719">
                  <c:v>0.40527000000000002</c:v>
                </c:pt>
                <c:pt idx="1720">
                  <c:v>0.40527000000000002</c:v>
                </c:pt>
                <c:pt idx="1721">
                  <c:v>0.40405000000000002</c:v>
                </c:pt>
                <c:pt idx="1722">
                  <c:v>0.40527000000000002</c:v>
                </c:pt>
                <c:pt idx="1723">
                  <c:v>0.40405000000000002</c:v>
                </c:pt>
                <c:pt idx="1724">
                  <c:v>0.40405000000000002</c:v>
                </c:pt>
                <c:pt idx="1725">
                  <c:v>0.40405000000000002</c:v>
                </c:pt>
                <c:pt idx="1726">
                  <c:v>0.40405000000000002</c:v>
                </c:pt>
                <c:pt idx="1727">
                  <c:v>0.40405000000000002</c:v>
                </c:pt>
                <c:pt idx="1728">
                  <c:v>0.40405000000000002</c:v>
                </c:pt>
                <c:pt idx="1729">
                  <c:v>0.40405000000000002</c:v>
                </c:pt>
                <c:pt idx="1730">
                  <c:v>0.40405000000000002</c:v>
                </c:pt>
                <c:pt idx="1731">
                  <c:v>0.40405000000000002</c:v>
                </c:pt>
                <c:pt idx="1732">
                  <c:v>0.40405000000000002</c:v>
                </c:pt>
                <c:pt idx="1733">
                  <c:v>0.40405000000000002</c:v>
                </c:pt>
                <c:pt idx="1734">
                  <c:v>0.40527000000000002</c:v>
                </c:pt>
                <c:pt idx="1735">
                  <c:v>0.40649000000000002</c:v>
                </c:pt>
                <c:pt idx="1736">
                  <c:v>0.40649000000000002</c:v>
                </c:pt>
                <c:pt idx="1737">
                  <c:v>0.40527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7B9-41DC-99AD-7E807C8A9F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00059280"/>
        <c:axId val="-2000599680"/>
      </c:scatterChart>
      <c:valAx>
        <c:axId val="-20000592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00599680"/>
        <c:crosses val="autoZero"/>
        <c:crossBetween val="midCat"/>
      </c:valAx>
      <c:valAx>
        <c:axId val="-2000599680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E+00" sourceLinked="1"/>
        <c:majorTickMark val="none"/>
        <c:minorTickMark val="none"/>
        <c:tickLblPos val="nextTo"/>
        <c:crossAx val="-200005928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2181863341398101"/>
          <c:y val="0.92829453862908695"/>
          <c:w val="0.15636251942187401"/>
          <c:h val="7.17054613709135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ysomal</a:t>
            </a:r>
            <a:r>
              <a:rPr lang="en-US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NA</a:t>
            </a:r>
            <a:endParaRPr 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AD$53</c:f>
              <c:strCache>
                <c:ptCount val="1"/>
                <c:pt idx="0">
                  <c:v>Uninduced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F$54:$AF$58</c:f>
                <c:numCache>
                  <c:formatCode>General</c:formatCode>
                  <c:ptCount val="5"/>
                  <c:pt idx="0">
                    <c:v>3.9679411345037101E-4</c:v>
                  </c:pt>
                  <c:pt idx="1">
                    <c:v>1.3586549133953651E-4</c:v>
                  </c:pt>
                  <c:pt idx="2">
                    <c:v>4.4779607669080364E-5</c:v>
                  </c:pt>
                  <c:pt idx="3">
                    <c:v>5.664953407385412E-4</c:v>
                  </c:pt>
                  <c:pt idx="4">
                    <c:v>3.2438895019844293E-4</c:v>
                  </c:pt>
                </c:numCache>
              </c:numRef>
            </c:plus>
            <c:minus>
              <c:numRef>
                <c:f>'0'!$AF$54:$AF$58</c:f>
                <c:numCache>
                  <c:formatCode>General</c:formatCode>
                  <c:ptCount val="5"/>
                  <c:pt idx="0">
                    <c:v>3.9679411345037101E-4</c:v>
                  </c:pt>
                  <c:pt idx="1">
                    <c:v>1.3586549133953651E-4</c:v>
                  </c:pt>
                  <c:pt idx="2">
                    <c:v>4.4779607669080364E-5</c:v>
                  </c:pt>
                  <c:pt idx="3">
                    <c:v>5.664953407385412E-4</c:v>
                  </c:pt>
                  <c:pt idx="4">
                    <c:v>3.2438895019844293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AC$54:$AC$58</c:f>
              <c:strCache>
                <c:ptCount val="5"/>
                <c:pt idx="0">
                  <c:v>EIF3A</c:v>
                </c:pt>
                <c:pt idx="1">
                  <c:v>CDK6</c:v>
                </c:pt>
                <c:pt idx="2">
                  <c:v>NAFT</c:v>
                </c:pt>
                <c:pt idx="3">
                  <c:v>MBNL1</c:v>
                </c:pt>
                <c:pt idx="4">
                  <c:v>MSI</c:v>
                </c:pt>
              </c:strCache>
            </c:strRef>
          </c:cat>
          <c:val>
            <c:numRef>
              <c:f>'0'!$AD$54:$AD$58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62-3D4F-BDC7-E1ED60A78E1D}"/>
            </c:ext>
          </c:extLst>
        </c:ser>
        <c:ser>
          <c:idx val="1"/>
          <c:order val="1"/>
          <c:tx>
            <c:strRef>
              <c:f>'0'!$AE$53</c:f>
              <c:strCache>
                <c:ptCount val="1"/>
                <c:pt idx="0">
                  <c:v>Induc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G$54:$AG$58</c:f>
                <c:numCache>
                  <c:formatCode>General</c:formatCode>
                  <c:ptCount val="5"/>
                  <c:pt idx="0">
                    <c:v>4.611137833771015E-4</c:v>
                  </c:pt>
                  <c:pt idx="1">
                    <c:v>2.9990995678061486E-4</c:v>
                  </c:pt>
                  <c:pt idx="2">
                    <c:v>5.7066386066948293E-5</c:v>
                  </c:pt>
                  <c:pt idx="3">
                    <c:v>1.0043099545596009E-4</c:v>
                  </c:pt>
                  <c:pt idx="4">
                    <c:v>4.7342009299368799E-5</c:v>
                  </c:pt>
                </c:numCache>
              </c:numRef>
            </c:plus>
            <c:minus>
              <c:numRef>
                <c:f>'0'!$AG$54:$AG$58</c:f>
                <c:numCache>
                  <c:formatCode>General</c:formatCode>
                  <c:ptCount val="5"/>
                  <c:pt idx="0">
                    <c:v>4.611137833771015E-4</c:v>
                  </c:pt>
                  <c:pt idx="1">
                    <c:v>2.9990995678061486E-4</c:v>
                  </c:pt>
                  <c:pt idx="2">
                    <c:v>5.7066386066948293E-5</c:v>
                  </c:pt>
                  <c:pt idx="3">
                    <c:v>1.0043099545596009E-4</c:v>
                  </c:pt>
                  <c:pt idx="4">
                    <c:v>4.7342009299368799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AC$54:$AC$58</c:f>
              <c:strCache>
                <c:ptCount val="5"/>
                <c:pt idx="0">
                  <c:v>EIF3A</c:v>
                </c:pt>
                <c:pt idx="1">
                  <c:v>CDK6</c:v>
                </c:pt>
                <c:pt idx="2">
                  <c:v>NAFT</c:v>
                </c:pt>
                <c:pt idx="3">
                  <c:v>MBNL1</c:v>
                </c:pt>
                <c:pt idx="4">
                  <c:v>MSI</c:v>
                </c:pt>
              </c:strCache>
            </c:strRef>
          </c:cat>
          <c:val>
            <c:numRef>
              <c:f>'0'!$AE$54:$AE$58</c:f>
              <c:numCache>
                <c:formatCode>General</c:formatCode>
                <c:ptCount val="5"/>
                <c:pt idx="0">
                  <c:v>1.42721524239741</c:v>
                </c:pt>
                <c:pt idx="1">
                  <c:v>1.5834326671237677</c:v>
                </c:pt>
                <c:pt idx="2">
                  <c:v>1.5164714250833728</c:v>
                </c:pt>
                <c:pt idx="3">
                  <c:v>1.119961334745309</c:v>
                </c:pt>
                <c:pt idx="4">
                  <c:v>0.235716663484412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162-3D4F-BDC7-E1ED60A78E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08895680"/>
        <c:axId val="2008349024"/>
      </c:barChart>
      <c:catAx>
        <c:axId val="2008895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08349024"/>
        <c:crosses val="autoZero"/>
        <c:auto val="1"/>
        <c:lblAlgn val="ctr"/>
        <c:lblOffset val="100"/>
        <c:noMultiLvlLbl val="0"/>
      </c:catAx>
      <c:valAx>
        <c:axId val="200834902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088956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750421351537465"/>
          <c:y val="0.18040579591693764"/>
          <c:w val="0.29092546361536453"/>
          <c:h val="7.8174531358549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r>
              <a:rPr lang="en-US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NA</a:t>
            </a:r>
            <a:endParaRPr 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AS$10</c:f>
              <c:strCache>
                <c:ptCount val="1"/>
                <c:pt idx="0">
                  <c:v>Uninduced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U$11:$AU$15</c:f>
                <c:numCache>
                  <c:formatCode>General</c:formatCode>
                  <c:ptCount val="5"/>
                  <c:pt idx="0">
                    <c:v>1.4911119211920715E-3</c:v>
                  </c:pt>
                  <c:pt idx="1">
                    <c:v>2.5543416338579248E-3</c:v>
                  </c:pt>
                  <c:pt idx="2">
                    <c:v>5.4726466939502246E-5</c:v>
                  </c:pt>
                  <c:pt idx="3">
                    <c:v>8.039524626280057E-4</c:v>
                  </c:pt>
                  <c:pt idx="4">
                    <c:v>1.4093118779363466E-3</c:v>
                  </c:pt>
                </c:numCache>
              </c:numRef>
            </c:plus>
            <c:minus>
              <c:numRef>
                <c:f>'0'!$AU$11:$AU$15</c:f>
                <c:numCache>
                  <c:formatCode>General</c:formatCode>
                  <c:ptCount val="5"/>
                  <c:pt idx="0">
                    <c:v>1.4911119211920715E-3</c:v>
                  </c:pt>
                  <c:pt idx="1">
                    <c:v>2.5543416338579248E-3</c:v>
                  </c:pt>
                  <c:pt idx="2">
                    <c:v>5.4726466939502246E-5</c:v>
                  </c:pt>
                  <c:pt idx="3">
                    <c:v>8.039524626280057E-4</c:v>
                  </c:pt>
                  <c:pt idx="4">
                    <c:v>1.409311877936346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AR$11:$AR$15</c:f>
              <c:strCache>
                <c:ptCount val="5"/>
                <c:pt idx="0">
                  <c:v>EIF3A</c:v>
                </c:pt>
                <c:pt idx="1">
                  <c:v>CDK6</c:v>
                </c:pt>
                <c:pt idx="2">
                  <c:v>NAFT</c:v>
                </c:pt>
                <c:pt idx="3">
                  <c:v>MBLN</c:v>
                </c:pt>
                <c:pt idx="4">
                  <c:v>MSI2</c:v>
                </c:pt>
              </c:strCache>
            </c:strRef>
          </c:cat>
          <c:val>
            <c:numRef>
              <c:f>'0'!$AS$11:$AS$15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145-DA42-A073-FEBC8EAF880A}"/>
            </c:ext>
          </c:extLst>
        </c:ser>
        <c:ser>
          <c:idx val="1"/>
          <c:order val="1"/>
          <c:tx>
            <c:strRef>
              <c:f>'0'!$AT$10</c:f>
              <c:strCache>
                <c:ptCount val="1"/>
                <c:pt idx="0">
                  <c:v>Induced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V$11:$AV$15</c:f>
                <c:numCache>
                  <c:formatCode>General</c:formatCode>
                  <c:ptCount val="5"/>
                  <c:pt idx="0">
                    <c:v>6.1923876248126649E-3</c:v>
                  </c:pt>
                  <c:pt idx="1">
                    <c:v>8.3782541943485736E-2</c:v>
                  </c:pt>
                  <c:pt idx="2">
                    <c:v>0.39274836826096687</c:v>
                  </c:pt>
                  <c:pt idx="3">
                    <c:v>0.12301990376674142</c:v>
                  </c:pt>
                  <c:pt idx="4">
                    <c:v>0.27716083012147058</c:v>
                  </c:pt>
                </c:numCache>
              </c:numRef>
            </c:plus>
            <c:minus>
              <c:numRef>
                <c:f>'0'!$AV$11:$AV$15</c:f>
                <c:numCache>
                  <c:formatCode>General</c:formatCode>
                  <c:ptCount val="5"/>
                  <c:pt idx="0">
                    <c:v>6.1923876248126649E-3</c:v>
                  </c:pt>
                  <c:pt idx="1">
                    <c:v>8.3782541943485736E-2</c:v>
                  </c:pt>
                  <c:pt idx="2">
                    <c:v>0.39274836826096687</c:v>
                  </c:pt>
                  <c:pt idx="3">
                    <c:v>0.12301990376674142</c:v>
                  </c:pt>
                  <c:pt idx="4">
                    <c:v>0.277160830121470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AR$11:$AR$15</c:f>
              <c:strCache>
                <c:ptCount val="5"/>
                <c:pt idx="0">
                  <c:v>EIF3A</c:v>
                </c:pt>
                <c:pt idx="1">
                  <c:v>CDK6</c:v>
                </c:pt>
                <c:pt idx="2">
                  <c:v>NAFT</c:v>
                </c:pt>
                <c:pt idx="3">
                  <c:v>MBLN</c:v>
                </c:pt>
                <c:pt idx="4">
                  <c:v>MSI2</c:v>
                </c:pt>
              </c:strCache>
            </c:strRef>
          </c:cat>
          <c:val>
            <c:numRef>
              <c:f>'0'!$AT$11:$AT$15</c:f>
              <c:numCache>
                <c:formatCode>General</c:formatCode>
                <c:ptCount val="5"/>
                <c:pt idx="0">
                  <c:v>1.0087573585624814</c:v>
                </c:pt>
                <c:pt idx="1">
                  <c:v>0.88151359289342979</c:v>
                </c:pt>
                <c:pt idx="2">
                  <c:v>1.555430068994563</c:v>
                </c:pt>
                <c:pt idx="3">
                  <c:v>1.1739764163487587</c:v>
                </c:pt>
                <c:pt idx="4">
                  <c:v>0.608035395083630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145-DA42-A073-FEBC8EAF88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675952"/>
        <c:axId val="1566447552"/>
      </c:barChart>
      <c:catAx>
        <c:axId val="1565675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66447552"/>
        <c:crosses val="autoZero"/>
        <c:auto val="1"/>
        <c:lblAlgn val="ctr"/>
        <c:lblOffset val="100"/>
        <c:noMultiLvlLbl val="0"/>
      </c:catAx>
      <c:valAx>
        <c:axId val="15664475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656759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164282589676291"/>
          <c:y val="0.2413414989792943"/>
          <c:w val="0.29671412948381454"/>
          <c:h val="7.810294546515018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</a:rPr>
              <a:t>Acute MSI2 KD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X$63</c:f>
              <c:strCache>
                <c:ptCount val="1"/>
                <c:pt idx="0">
                  <c:v>EIF3A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X$49:$X$52</c:f>
                <c:numCache>
                  <c:formatCode>General</c:formatCode>
                  <c:ptCount val="4"/>
                  <c:pt idx="0">
                    <c:v>3.3519839514075734E-4</c:v>
                  </c:pt>
                  <c:pt idx="1">
                    <c:v>0</c:v>
                  </c:pt>
                  <c:pt idx="2">
                    <c:v>1.1486066830871217E-4</c:v>
                  </c:pt>
                  <c:pt idx="3">
                    <c:v>4.6350128034157037E-3</c:v>
                  </c:pt>
                </c:numCache>
              </c:numRef>
            </c:plus>
            <c:minus>
              <c:numRef>
                <c:f>'0'!$X$49:$X$52</c:f>
                <c:numCache>
                  <c:formatCode>General</c:formatCode>
                  <c:ptCount val="4"/>
                  <c:pt idx="0">
                    <c:v>3.3519839514075734E-4</c:v>
                  </c:pt>
                  <c:pt idx="1">
                    <c:v>0</c:v>
                  </c:pt>
                  <c:pt idx="2">
                    <c:v>1.1486066830871217E-4</c:v>
                  </c:pt>
                  <c:pt idx="3">
                    <c:v>4.635012803415703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Y$62:$AA$62</c:f>
              <c:strCache>
                <c:ptCount val="3"/>
                <c:pt idx="0">
                  <c:v>Uninduced</c:v>
                </c:pt>
                <c:pt idx="1">
                  <c:v>sh-Control</c:v>
                </c:pt>
                <c:pt idx="2">
                  <c:v>sh-MSI2</c:v>
                </c:pt>
              </c:strCache>
            </c:strRef>
          </c:cat>
          <c:val>
            <c:numRef>
              <c:f>'0'!$Y$63:$AA$63</c:f>
              <c:numCache>
                <c:formatCode>General</c:formatCode>
                <c:ptCount val="3"/>
                <c:pt idx="0">
                  <c:v>8.9093355021218866E-3</c:v>
                </c:pt>
                <c:pt idx="1">
                  <c:v>1.0879436792435727E-2</c:v>
                </c:pt>
                <c:pt idx="2">
                  <c:v>1.044309394133223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1A-684D-A322-E15DDDF3E395}"/>
            </c:ext>
          </c:extLst>
        </c:ser>
        <c:ser>
          <c:idx val="1"/>
          <c:order val="1"/>
          <c:tx>
            <c:strRef>
              <c:f>'0'!$X$64</c:f>
              <c:strCache>
                <c:ptCount val="1"/>
                <c:pt idx="0">
                  <c:v>MSI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D$49:$AD$52</c:f>
                <c:numCache>
                  <c:formatCode>General</c:formatCode>
                  <c:ptCount val="4"/>
                  <c:pt idx="0">
                    <c:v>2.9500589521298988E-4</c:v>
                  </c:pt>
                  <c:pt idx="1">
                    <c:v>0</c:v>
                  </c:pt>
                  <c:pt idx="2">
                    <c:v>9.6268287416556708E-5</c:v>
                  </c:pt>
                  <c:pt idx="3">
                    <c:v>7.6800690396801221E-5</c:v>
                  </c:pt>
                </c:numCache>
              </c:numRef>
            </c:plus>
            <c:minus>
              <c:numRef>
                <c:f>'0'!$AD$49:$AD$52</c:f>
                <c:numCache>
                  <c:formatCode>General</c:formatCode>
                  <c:ptCount val="4"/>
                  <c:pt idx="0">
                    <c:v>2.9500589521298988E-4</c:v>
                  </c:pt>
                  <c:pt idx="1">
                    <c:v>0</c:v>
                  </c:pt>
                  <c:pt idx="2">
                    <c:v>9.6268287416556708E-5</c:v>
                  </c:pt>
                  <c:pt idx="3">
                    <c:v>7.6800690396801221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Y$62:$AA$62</c:f>
              <c:strCache>
                <c:ptCount val="3"/>
                <c:pt idx="0">
                  <c:v>Uninduced</c:v>
                </c:pt>
                <c:pt idx="1">
                  <c:v>sh-Control</c:v>
                </c:pt>
                <c:pt idx="2">
                  <c:v>sh-MSI2</c:v>
                </c:pt>
              </c:strCache>
            </c:strRef>
          </c:cat>
          <c:val>
            <c:numRef>
              <c:f>'0'!$Y$64:$AA$64</c:f>
              <c:numCache>
                <c:formatCode>General</c:formatCode>
                <c:ptCount val="3"/>
                <c:pt idx="0">
                  <c:v>3.5538270292405794E-3</c:v>
                </c:pt>
                <c:pt idx="1">
                  <c:v>3.0834990661352366E-3</c:v>
                </c:pt>
                <c:pt idx="2">
                  <c:v>1.607341704919013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E1A-684D-A322-E15DDDF3E3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3524927"/>
        <c:axId val="1566170111"/>
      </c:barChart>
      <c:catAx>
        <c:axId val="15635249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66170111"/>
        <c:crosses val="autoZero"/>
        <c:auto val="1"/>
        <c:lblAlgn val="ctr"/>
        <c:lblOffset val="100"/>
        <c:noMultiLvlLbl val="0"/>
      </c:catAx>
      <c:valAx>
        <c:axId val="156617011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solidFill>
                      <a:schemeClr val="tx1"/>
                    </a:solidFill>
                  </a:rPr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3.4722222222222224E-2"/>
              <c:y val="0.167166666666666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63524927"/>
        <c:crosses val="autoZero"/>
        <c:crossBetween val="between"/>
        <c:majorUnit val="4.000000000000001E-3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028874824251947"/>
          <c:y val="0.1579065105460514"/>
          <c:w val="0.24791633415892522"/>
          <c:h val="8.34484792906185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ble</a:t>
            </a:r>
            <a:r>
              <a:rPr lang="en-US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SI2 KD</a:t>
            </a:r>
            <a:endParaRPr 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Y$68</c:f>
              <c:strCache>
                <c:ptCount val="1"/>
                <c:pt idx="0">
                  <c:v>EIF3A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X$56:$X$58</c:f>
                <c:numCache>
                  <c:formatCode>General</c:formatCode>
                  <c:ptCount val="3"/>
                  <c:pt idx="0">
                    <c:v>6.5362769277852616E-5</c:v>
                  </c:pt>
                  <c:pt idx="1">
                    <c:v>5.4561980291563015E-4</c:v>
                  </c:pt>
                  <c:pt idx="2">
                    <c:v>7.3197836999749129E-4</c:v>
                  </c:pt>
                </c:numCache>
              </c:numRef>
            </c:plus>
            <c:minus>
              <c:numRef>
                <c:f>'0'!$X$56:$X$58</c:f>
                <c:numCache>
                  <c:formatCode>General</c:formatCode>
                  <c:ptCount val="3"/>
                  <c:pt idx="0">
                    <c:v>6.5362769277852616E-5</c:v>
                  </c:pt>
                  <c:pt idx="1">
                    <c:v>5.4561980291563015E-4</c:v>
                  </c:pt>
                  <c:pt idx="2">
                    <c:v>7.3197836999749129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Z$67:$AB$67</c:f>
              <c:strCache>
                <c:ptCount val="3"/>
                <c:pt idx="0">
                  <c:v>sh-Control</c:v>
                </c:pt>
                <c:pt idx="1">
                  <c:v>sh-MSI2-1</c:v>
                </c:pt>
                <c:pt idx="2">
                  <c:v>sh-MSI2-2</c:v>
                </c:pt>
              </c:strCache>
            </c:strRef>
          </c:cat>
          <c:val>
            <c:numRef>
              <c:f>'0'!$Z$68:$AB$68</c:f>
              <c:numCache>
                <c:formatCode>General</c:formatCode>
                <c:ptCount val="3"/>
                <c:pt idx="0">
                  <c:v>8.4120358445921792E-3</c:v>
                </c:pt>
                <c:pt idx="1">
                  <c:v>8.4861282843089018E-3</c:v>
                </c:pt>
                <c:pt idx="2">
                  <c:v>7.088630235451568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BA-B04B-8A96-C0F5A4CE70B7}"/>
            </c:ext>
          </c:extLst>
        </c:ser>
        <c:ser>
          <c:idx val="1"/>
          <c:order val="1"/>
          <c:tx>
            <c:strRef>
              <c:f>'0'!$Y$69</c:f>
              <c:strCache>
                <c:ptCount val="1"/>
                <c:pt idx="0">
                  <c:v>MSI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D$56:$AD$58</c:f>
                <c:numCache>
                  <c:formatCode>General</c:formatCode>
                  <c:ptCount val="3"/>
                  <c:pt idx="0">
                    <c:v>1.4685731190891733E-4</c:v>
                  </c:pt>
                  <c:pt idx="1">
                    <c:v>3.0576568313367151E-5</c:v>
                  </c:pt>
                  <c:pt idx="2">
                    <c:v>3.5283314701021008E-5</c:v>
                  </c:pt>
                </c:numCache>
              </c:numRef>
            </c:plus>
            <c:minus>
              <c:numRef>
                <c:f>'0'!$AD$56:$AD$58</c:f>
                <c:numCache>
                  <c:formatCode>General</c:formatCode>
                  <c:ptCount val="3"/>
                  <c:pt idx="0">
                    <c:v>1.4685731190891733E-4</c:v>
                  </c:pt>
                  <c:pt idx="1">
                    <c:v>3.0576568313367151E-5</c:v>
                  </c:pt>
                  <c:pt idx="2">
                    <c:v>3.5283314701021008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Z$67:$AB$67</c:f>
              <c:strCache>
                <c:ptCount val="3"/>
                <c:pt idx="0">
                  <c:v>sh-Control</c:v>
                </c:pt>
                <c:pt idx="1">
                  <c:v>sh-MSI2-1</c:v>
                </c:pt>
                <c:pt idx="2">
                  <c:v>sh-MSI2-2</c:v>
                </c:pt>
              </c:strCache>
            </c:strRef>
          </c:cat>
          <c:val>
            <c:numRef>
              <c:f>'0'!$Z$69:$AB$69</c:f>
              <c:numCache>
                <c:formatCode>General</c:formatCode>
                <c:ptCount val="3"/>
                <c:pt idx="0">
                  <c:v>2.7367358283810041E-3</c:v>
                </c:pt>
                <c:pt idx="1">
                  <c:v>1.0644951957391609E-3</c:v>
                </c:pt>
                <c:pt idx="2">
                  <c:v>6.1845756188919879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1BA-B04B-8A96-C0F5A4CE70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2880719"/>
        <c:axId val="1502780671"/>
      </c:barChart>
      <c:catAx>
        <c:axId val="10928807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02780671"/>
        <c:crosses val="autoZero"/>
        <c:auto val="1"/>
        <c:lblAlgn val="ctr"/>
        <c:lblOffset val="100"/>
        <c:noMultiLvlLbl val="0"/>
      </c:catAx>
      <c:valAx>
        <c:axId val="150278067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altive</a:t>
                </a:r>
                <a:r>
                  <a:rPr lang="en-US" sz="12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expresssion</a:t>
                </a:r>
                <a:endParaRPr lang="en-US" sz="1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125E-2"/>
              <c:y val="0.1282777777777777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92880719"/>
        <c:crosses val="autoZero"/>
        <c:crossBetween val="between"/>
        <c:majorUnit val="2.0000000000000005E-3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6175172302107088"/>
          <c:y val="0.18660150183178723"/>
          <c:w val="0.23559864647755821"/>
          <c:h val="7.586778837811940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</a:rPr>
              <a:t>INPU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B$22:$AB$25</c:f>
                <c:numCache>
                  <c:formatCode>General</c:formatCode>
                  <c:ptCount val="4"/>
                  <c:pt idx="0">
                    <c:v>0.82038541360799144</c:v>
                  </c:pt>
                  <c:pt idx="1">
                    <c:v>8.2721446920970651E-2</c:v>
                  </c:pt>
                  <c:pt idx="2">
                    <c:v>0.10164454216254191</c:v>
                  </c:pt>
                  <c:pt idx="3">
                    <c:v>0.32372430105615613</c:v>
                  </c:pt>
                </c:numCache>
              </c:numRef>
            </c:plus>
            <c:minus>
              <c:numRef>
                <c:f>'0'!$AB$22:$AB$25</c:f>
                <c:numCache>
                  <c:formatCode>General</c:formatCode>
                  <c:ptCount val="4"/>
                  <c:pt idx="0">
                    <c:v>0.82038541360799144</c:v>
                  </c:pt>
                  <c:pt idx="1">
                    <c:v>8.2721446920970651E-2</c:v>
                  </c:pt>
                  <c:pt idx="2">
                    <c:v>0.10164454216254191</c:v>
                  </c:pt>
                  <c:pt idx="3">
                    <c:v>0.323724301056156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W$28:$W$31</c:f>
              <c:strCache>
                <c:ptCount val="4"/>
                <c:pt idx="0">
                  <c:v>wt</c:v>
                </c:pt>
                <c:pt idx="1">
                  <c:v>acta1</c:v>
                </c:pt>
                <c:pt idx="2">
                  <c:v>cdk6</c:v>
                </c:pt>
                <c:pt idx="3">
                  <c:v>mt</c:v>
                </c:pt>
              </c:strCache>
            </c:strRef>
          </c:cat>
          <c:val>
            <c:numRef>
              <c:f>'0'!$X$28:$X$31</c:f>
              <c:numCache>
                <c:formatCode>General</c:formatCode>
                <c:ptCount val="4"/>
                <c:pt idx="0">
                  <c:v>5.107727560458188</c:v>
                </c:pt>
                <c:pt idx="1">
                  <c:v>4.9197416470661741</c:v>
                </c:pt>
                <c:pt idx="2">
                  <c:v>3.5514100540594429</c:v>
                </c:pt>
                <c:pt idx="3">
                  <c:v>4.86385816354308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B2-004C-96C2-E16CFBFB65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08420927"/>
        <c:axId val="1508425199"/>
      </c:barChart>
      <c:catAx>
        <c:axId val="15084209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08425199"/>
        <c:crosses val="autoZero"/>
        <c:auto val="1"/>
        <c:lblAlgn val="ctr"/>
        <c:lblOffset val="100"/>
        <c:noMultiLvlLbl val="0"/>
      </c:catAx>
      <c:valAx>
        <c:axId val="150842519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Luciferase expression </a:t>
                </a:r>
              </a:p>
              <a:p>
                <a:pPr>
                  <a:defRPr/>
                </a:pPr>
                <a:r>
                  <a:rPr lang="en-US" dirty="0"/>
                  <a:t>relative to MS2</a:t>
                </a:r>
              </a:p>
            </c:rich>
          </c:tx>
          <c:layout>
            <c:manualLayout>
              <c:xMode val="edge"/>
              <c:yMode val="edge"/>
              <c:x val="3.6700323078434662E-2"/>
              <c:y val="0.20012664964531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0842092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0935</cdr:x>
      <cdr:y>0.0255</cdr:y>
    </cdr:from>
    <cdr:to>
      <cdr:x>0.85479</cdr:x>
      <cdr:y>0.05883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3700345" y="69955"/>
          <a:ext cx="207749" cy="91440"/>
        </a:xfrm>
        <a:prstGeom xmlns:a="http://schemas.openxmlformats.org/drawingml/2006/main" prst="rect">
          <a:avLst/>
        </a:prstGeom>
        <a:solidFill xmlns:a="http://schemas.openxmlformats.org/drawingml/2006/main">
          <a:schemeClr val="bg2">
            <a:lumMod val="75000"/>
          </a:schemeClr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81395</cdr:x>
      <cdr:y>0.09023</cdr:y>
    </cdr:from>
    <cdr:to>
      <cdr:x>0.85995</cdr:x>
      <cdr:y>0.12356</cdr:y>
    </cdr:to>
    <cdr:sp macro="" textlink="">
      <cdr:nvSpPr>
        <cdr:cNvPr id="3" name="Rectangle 2"/>
        <cdr:cNvSpPr/>
      </cdr:nvSpPr>
      <cdr:spPr>
        <a:xfrm xmlns:a="http://schemas.openxmlformats.org/drawingml/2006/main">
          <a:off x="3721364" y="247523"/>
          <a:ext cx="210312" cy="91440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>
            <a:lumMod val="75000"/>
            <a:lumOff val="25000"/>
          </a:schemeClr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D9F823-A7B4-4360-BA6F-80E5261E8FDC}" type="datetimeFigureOut">
              <a:rPr lang="en-US" smtClean="0"/>
              <a:t>3/1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9E0A14-0CA1-499A-A9D2-5FCA79FCDB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0828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7. Probability</a:t>
            </a:r>
            <a:r>
              <a:rPr lang="en-US" baseline="0" dirty="0"/>
              <a:t> of secondary structural conformations of sequence stretches around cross-link clusters in the 3’UTR of three groups of transcripts (unchanged, upregulated and downregulated) at the level of translation upon MSI2 knockdown. A region 20 </a:t>
            </a:r>
            <a:r>
              <a:rPr lang="en-US" baseline="0" dirty="0" err="1"/>
              <a:t>bp</a:t>
            </a:r>
            <a:r>
              <a:rPr lang="en-US" baseline="0" dirty="0"/>
              <a:t> upstream or downstream of the cross-link site was selected and sequence extracted. A random set of 1000 regions analyzed for each group. </a:t>
            </a:r>
            <a:r>
              <a:rPr lang="en-US" baseline="0" dirty="0" err="1"/>
              <a:t>CapR</a:t>
            </a:r>
            <a:r>
              <a:rPr lang="en-US" baseline="0" dirty="0"/>
              <a:t> predicts probability of each </a:t>
            </a:r>
            <a:r>
              <a:rPr lang="en-US" baseline="0" dirty="0" err="1"/>
              <a:t>basepair</a:t>
            </a:r>
            <a:r>
              <a:rPr lang="en-US" baseline="0" dirty="0"/>
              <a:t> to be part of 6 secondary structure conformations Bulge, Exterior, Hairpin, Internal, Multibranch or Stem ( listed in panel headings A-F). Plotted are the average probabilities for each position ( cross-link site is at position 20). The distribution of probabilities were  not different for the three groups plotted for any of the conformations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25061B-6E81-7F45-AE9E-2B9485F4DEB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2238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926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963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366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190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110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648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485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099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166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649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896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9C7AAB-AAD0-455B-87D3-7C2A220C7208}" type="datetimeFigureOut">
              <a:rPr lang="en-US" smtClean="0"/>
              <a:t>3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1F61C-0795-4772-A639-A456EF0F0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539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3" Type="http://schemas.openxmlformats.org/officeDocument/2006/relationships/image" Target="../media/image14.tiff"/><Relationship Id="rId7" Type="http://schemas.openxmlformats.org/officeDocument/2006/relationships/image" Target="../media/image18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10" Type="http://schemas.openxmlformats.org/officeDocument/2006/relationships/image" Target="../media/image21.tiff"/><Relationship Id="rId4" Type="http://schemas.openxmlformats.org/officeDocument/2006/relationships/image" Target="../media/image15.tiff"/><Relationship Id="rId9" Type="http://schemas.openxmlformats.org/officeDocument/2006/relationships/image" Target="../media/image20.jpeg"/></Relationships>
</file>

<file path=ppt/slides/_rels/slide5.xml.rels><?xml version="1.0" encoding="UTF-8" standalone="yes"?>
<Relationships xmlns="http://schemas.openxmlformats.org/package/2006/relationships"><Relationship Id="rId18" Type="http://schemas.openxmlformats.org/officeDocument/2006/relationships/chart" Target="../charts/chart3.xml"/><Relationship Id="rId8" Type="http://schemas.openxmlformats.org/officeDocument/2006/relationships/image" Target="../media/image370.png"/><Relationship Id="rId3" Type="http://schemas.openxmlformats.org/officeDocument/2006/relationships/image" Target="../media/image23.tiff"/><Relationship Id="rId7" Type="http://schemas.openxmlformats.org/officeDocument/2006/relationships/chart" Target="../charts/chart2.xml"/><Relationship Id="rId17" Type="http://schemas.openxmlformats.org/officeDocument/2006/relationships/chart" Target="../charts/chart3.xml"/><Relationship Id="rId2" Type="http://schemas.openxmlformats.org/officeDocument/2006/relationships/image" Target="../media/image22.tiff"/><Relationship Id="rId16" Type="http://schemas.openxmlformats.org/officeDocument/2006/relationships/image" Target="../media/image4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image" Target="../media/image25.jpeg"/><Relationship Id="rId15" Type="http://schemas.openxmlformats.org/officeDocument/2006/relationships/image" Target="../media/image39.png"/><Relationship Id="rId10" Type="http://schemas.openxmlformats.org/officeDocument/2006/relationships/image" Target="../media/image391.png"/><Relationship Id="rId19" Type="http://schemas.openxmlformats.org/officeDocument/2006/relationships/chart" Target="../charts/chart4.xml"/><Relationship Id="rId4" Type="http://schemas.openxmlformats.org/officeDocument/2006/relationships/image" Target="../media/image24.jpeg"/><Relationship Id="rId9" Type="http://schemas.openxmlformats.org/officeDocument/2006/relationships/image" Target="../media/image4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chart" Target="../charts/chart10.xml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9.xml"/><Relationship Id="rId5" Type="http://schemas.microsoft.com/office/2007/relationships/hdphoto" Target="../media/hdphoto2.wdp"/><Relationship Id="rId4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tiff"/><Relationship Id="rId4" Type="http://schemas.openxmlformats.org/officeDocument/2006/relationships/image" Target="../media/image28.tif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tiff"/><Relationship Id="rId3" Type="http://schemas.openxmlformats.org/officeDocument/2006/relationships/image" Target="../media/image31.jpeg"/><Relationship Id="rId7" Type="http://schemas.openxmlformats.org/officeDocument/2006/relationships/image" Target="../media/image35.jpeg"/><Relationship Id="rId2" Type="http://schemas.openxmlformats.org/officeDocument/2006/relationships/image" Target="../media/image3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tiff"/><Relationship Id="rId5" Type="http://schemas.openxmlformats.org/officeDocument/2006/relationships/image" Target="../media/image33.tiff"/><Relationship Id="rId4" Type="http://schemas.openxmlformats.org/officeDocument/2006/relationships/image" Target="../media/image32.jpeg"/><Relationship Id="rId9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1726A79-965D-44B5-83D1-0E00CD2CE307}"/>
              </a:ext>
            </a:extLst>
          </p:cNvPr>
          <p:cNvSpPr txBox="1"/>
          <p:nvPr/>
        </p:nvSpPr>
        <p:spPr>
          <a:xfrm>
            <a:off x="13591" y="1314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ure 1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3F496A62-C758-4639-BB41-3D7F30898458}"/>
              </a:ext>
            </a:extLst>
          </p:cNvPr>
          <p:cNvGrpSpPr/>
          <p:nvPr/>
        </p:nvGrpSpPr>
        <p:grpSpPr>
          <a:xfrm>
            <a:off x="5380011" y="1043130"/>
            <a:ext cx="2938474" cy="1900219"/>
            <a:chOff x="592860" y="853614"/>
            <a:chExt cx="2435054" cy="1521999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ADAAA79D-43EE-4D71-BD03-F9656338BB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33359" y="1070784"/>
              <a:ext cx="1037660" cy="1304828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5C25918-F19B-4C40-9260-D829F4E5D1A9}"/>
                </a:ext>
              </a:extLst>
            </p:cNvPr>
            <p:cNvSpPr txBox="1"/>
            <p:nvPr/>
          </p:nvSpPr>
          <p:spPr>
            <a:xfrm>
              <a:off x="1069978" y="853614"/>
              <a:ext cx="336345" cy="2218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charset="0"/>
                  <a:ea typeface="Arial" charset="0"/>
                  <a:cs typeface="Arial" charset="0"/>
                </a:rPr>
                <a:t>1: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4FF526A-77BA-4EB1-8D35-FE797FDCCFE3}"/>
                </a:ext>
              </a:extLst>
            </p:cNvPr>
            <p:cNvSpPr txBox="1"/>
            <p:nvPr/>
          </p:nvSpPr>
          <p:spPr>
            <a:xfrm>
              <a:off x="1425437" y="853615"/>
              <a:ext cx="336345" cy="2218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charset="0"/>
                  <a:ea typeface="Arial" charset="0"/>
                  <a:cs typeface="Arial" charset="0"/>
                </a:rPr>
                <a:t>1: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BF2B22E-2A4C-40F0-9E5E-645BE46AECCB}"/>
                </a:ext>
              </a:extLst>
            </p:cNvPr>
            <p:cNvSpPr txBox="1"/>
            <p:nvPr/>
          </p:nvSpPr>
          <p:spPr>
            <a:xfrm>
              <a:off x="1748509" y="853615"/>
              <a:ext cx="406749" cy="2218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charset="0"/>
                  <a:ea typeface="Arial" charset="0"/>
                  <a:cs typeface="Arial" charset="0"/>
                </a:rPr>
                <a:t>1:1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33D4F8C-8958-4155-A060-B60AA7234954}"/>
                </a:ext>
              </a:extLst>
            </p:cNvPr>
            <p:cNvSpPr txBox="1"/>
            <p:nvPr/>
          </p:nvSpPr>
          <p:spPr>
            <a:xfrm>
              <a:off x="2110685" y="853615"/>
              <a:ext cx="406749" cy="2218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charset="0"/>
                  <a:ea typeface="Arial" charset="0"/>
                  <a:cs typeface="Arial" charset="0"/>
                </a:rPr>
                <a:t>1:3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13686ED-ED9F-4587-A18C-E9E498266330}"/>
                </a:ext>
              </a:extLst>
            </p:cNvPr>
            <p:cNvSpPr txBox="1"/>
            <p:nvPr/>
          </p:nvSpPr>
          <p:spPr>
            <a:xfrm>
              <a:off x="2442376" y="853615"/>
              <a:ext cx="406749" cy="2218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charset="0"/>
                  <a:ea typeface="Arial" charset="0"/>
                  <a:cs typeface="Arial" charset="0"/>
                </a:rPr>
                <a:t>1:50</a:t>
              </a:r>
            </a:p>
          </p:txBody>
        </p:sp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669DD715-E826-47C4-A759-A436893221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73872" y="1070785"/>
              <a:ext cx="719359" cy="1304828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3ED2127B-E3CD-483F-B423-3B1DAE86BA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493231" y="1070784"/>
              <a:ext cx="377420" cy="1304829"/>
            </a:xfrm>
            <a:prstGeom prst="rect">
              <a:avLst/>
            </a:prstGeom>
          </p:spPr>
        </p:pic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AD6C7450-7384-4D35-BEE6-97C08D6D0A23}"/>
                </a:ext>
              </a:extLst>
            </p:cNvPr>
            <p:cNvCxnSpPr/>
            <p:nvPr/>
          </p:nvCxnSpPr>
          <p:spPr>
            <a:xfrm>
              <a:off x="963022" y="2065360"/>
              <a:ext cx="14038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17AF405-3890-4F6C-A59F-DB3A8CD47A09}"/>
                </a:ext>
              </a:extLst>
            </p:cNvPr>
            <p:cNvSpPr txBox="1"/>
            <p:nvPr/>
          </p:nvSpPr>
          <p:spPr>
            <a:xfrm>
              <a:off x="688420" y="1899602"/>
              <a:ext cx="425346" cy="2095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charset="0"/>
                  <a:ea typeface="Arial" charset="0"/>
                  <a:cs typeface="Arial" charset="0"/>
                </a:rPr>
                <a:t>MSI2</a:t>
              </a:r>
            </a:p>
          </p:txBody>
        </p:sp>
        <p:sp>
          <p:nvSpPr>
            <p:cNvPr id="42" name="Right Brace 41">
              <a:extLst>
                <a:ext uri="{FF2B5EF4-FFF2-40B4-BE49-F238E27FC236}">
                  <a16:creationId xmlns:a16="http://schemas.microsoft.com/office/drawing/2014/main" id="{459056DB-1F2F-43BC-AAE4-0E8D8C920E71}"/>
                </a:ext>
              </a:extLst>
            </p:cNvPr>
            <p:cNvSpPr/>
            <p:nvPr/>
          </p:nvSpPr>
          <p:spPr>
            <a:xfrm>
              <a:off x="2747005" y="1385012"/>
              <a:ext cx="90837" cy="585788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b="1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E87143D9-6D8C-4E37-8AED-15401A12181E}"/>
                </a:ext>
              </a:extLst>
            </p:cNvPr>
            <p:cNvSpPr txBox="1"/>
            <p:nvPr/>
          </p:nvSpPr>
          <p:spPr>
            <a:xfrm rot="5400000">
              <a:off x="2541955" y="1561319"/>
              <a:ext cx="742375" cy="2295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charset="0"/>
                  <a:ea typeface="Arial" charset="0"/>
                  <a:cs typeface="Arial" charset="0"/>
                </a:rPr>
                <a:t>RNA-MSI2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FCF57B2-BB2C-4400-96CC-AFEFE09BD9A9}"/>
                </a:ext>
              </a:extLst>
            </p:cNvPr>
            <p:cNvSpPr txBox="1"/>
            <p:nvPr/>
          </p:nvSpPr>
          <p:spPr>
            <a:xfrm>
              <a:off x="592860" y="874609"/>
              <a:ext cx="568811" cy="2218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charset="0"/>
                  <a:ea typeface="Arial" charset="0"/>
                  <a:cs typeface="Arial" charset="0"/>
                </a:rPr>
                <a:t>RNAse</a:t>
              </a:r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CA66F5D6-46DF-465F-86F1-D059CE1B44F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20236" y="1430473"/>
            <a:ext cx="706621" cy="138558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47E156D-A93C-4FDE-AEA5-481362C51B01}"/>
              </a:ext>
            </a:extLst>
          </p:cNvPr>
          <p:cNvSpPr txBox="1"/>
          <p:nvPr/>
        </p:nvSpPr>
        <p:spPr>
          <a:xfrm>
            <a:off x="3636633" y="115757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UV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454714A-7108-405E-A0D2-7A61A97CD064}"/>
              </a:ext>
            </a:extLst>
          </p:cNvPr>
          <p:cNvSpPr txBox="1"/>
          <p:nvPr/>
        </p:nvSpPr>
        <p:spPr>
          <a:xfrm>
            <a:off x="4020236" y="1069342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7925630-9985-4234-8855-5052BB2C7F50}"/>
              </a:ext>
            </a:extLst>
          </p:cNvPr>
          <p:cNvSpPr txBox="1"/>
          <p:nvPr/>
        </p:nvSpPr>
        <p:spPr>
          <a:xfrm>
            <a:off x="4437344" y="1069342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5BA828B-497B-487C-9608-871211131A30}"/>
              </a:ext>
            </a:extLst>
          </p:cNvPr>
          <p:cNvSpPr txBox="1"/>
          <p:nvPr/>
        </p:nvSpPr>
        <p:spPr>
          <a:xfrm>
            <a:off x="834043" y="717745"/>
            <a:ext cx="4316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 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E77A9E6-B71A-4DF9-8DB6-802FB125E62F}"/>
              </a:ext>
            </a:extLst>
          </p:cNvPr>
          <p:cNvSpPr txBox="1"/>
          <p:nvPr/>
        </p:nvSpPr>
        <p:spPr>
          <a:xfrm>
            <a:off x="3404906" y="717745"/>
            <a:ext cx="3384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B  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32731A0-6CC0-48DA-A265-A15365849998}"/>
              </a:ext>
            </a:extLst>
          </p:cNvPr>
          <p:cNvSpPr txBox="1"/>
          <p:nvPr/>
        </p:nvSpPr>
        <p:spPr>
          <a:xfrm>
            <a:off x="5200739" y="717745"/>
            <a:ext cx="3384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0A83344-BAA1-4A9A-88FF-FB6BB57B1C23}"/>
              </a:ext>
            </a:extLst>
          </p:cNvPr>
          <p:cNvSpPr txBox="1"/>
          <p:nvPr/>
        </p:nvSpPr>
        <p:spPr>
          <a:xfrm>
            <a:off x="725242" y="3168824"/>
            <a:ext cx="3513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D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CD33905A-F476-4BDD-8362-9FBF66588C44}"/>
              </a:ext>
            </a:extLst>
          </p:cNvPr>
          <p:cNvCxnSpPr/>
          <p:nvPr/>
        </p:nvCxnSpPr>
        <p:spPr>
          <a:xfrm>
            <a:off x="4726857" y="2503767"/>
            <a:ext cx="209574" cy="0"/>
          </a:xfrm>
          <a:prstGeom prst="straightConnector1">
            <a:avLst/>
          </a:prstGeom>
          <a:ln w="19050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AFF94DA2-43AB-49A2-B5F6-E05361AFBF5A}"/>
              </a:ext>
            </a:extLst>
          </p:cNvPr>
          <p:cNvSpPr txBox="1"/>
          <p:nvPr/>
        </p:nvSpPr>
        <p:spPr>
          <a:xfrm>
            <a:off x="4654301" y="2494140"/>
            <a:ext cx="6512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37kDa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249BF9DF-DB8C-4E03-8C26-F695DC10CCC6}"/>
              </a:ext>
            </a:extLst>
          </p:cNvPr>
          <p:cNvGrpSpPr/>
          <p:nvPr/>
        </p:nvGrpSpPr>
        <p:grpSpPr>
          <a:xfrm>
            <a:off x="1414352" y="3429000"/>
            <a:ext cx="2733322" cy="2613449"/>
            <a:chOff x="1095513" y="3514728"/>
            <a:chExt cx="2733322" cy="2613449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02884D2-40C9-4A76-B7C9-ECE8F0FE9BF2}"/>
                </a:ext>
              </a:extLst>
            </p:cNvPr>
            <p:cNvSpPr txBox="1"/>
            <p:nvPr/>
          </p:nvSpPr>
          <p:spPr>
            <a:xfrm>
              <a:off x="1912022" y="5828095"/>
              <a:ext cx="1037528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b="1" dirty="0" err="1">
                  <a:latin typeface="Arial"/>
                  <a:cs typeface="Arial"/>
                </a:rPr>
                <a:t>iCLIP</a:t>
              </a:r>
              <a:r>
                <a:rPr lang="en-US" sz="1350" b="1" dirty="0">
                  <a:latin typeface="Arial"/>
                  <a:cs typeface="Arial"/>
                </a:rPr>
                <a:t> PCR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21C1972-3699-412C-B05E-A9AA85CD5D55}"/>
                </a:ext>
              </a:extLst>
            </p:cNvPr>
            <p:cNvSpPr txBox="1"/>
            <p:nvPr/>
          </p:nvSpPr>
          <p:spPr>
            <a:xfrm>
              <a:off x="1499506" y="3514728"/>
              <a:ext cx="9316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/>
                  <a:cs typeface="Arial"/>
                </a:rPr>
                <a:t>20 cycles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34C0E87-39B8-4EDD-8EC8-9806BEE9BC3E}"/>
                </a:ext>
              </a:extLst>
            </p:cNvPr>
            <p:cNvSpPr txBox="1"/>
            <p:nvPr/>
          </p:nvSpPr>
          <p:spPr>
            <a:xfrm>
              <a:off x="2551722" y="3543304"/>
              <a:ext cx="9316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/>
                  <a:cs typeface="Arial"/>
                </a:rPr>
                <a:t>22 cycles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2A4C8F2D-7FDA-4822-9592-11D97AF3499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95513" y="3841715"/>
              <a:ext cx="2733322" cy="1929138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E0C74AB-54DA-4ABE-ACFA-4CD9A64FBCF0}"/>
                </a:ext>
              </a:extLst>
            </p:cNvPr>
            <p:cNvSpPr txBox="1"/>
            <p:nvPr/>
          </p:nvSpPr>
          <p:spPr>
            <a:xfrm>
              <a:off x="1556902" y="3925216"/>
              <a:ext cx="28084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>
                  <a:latin typeface="Arial"/>
                  <a:cs typeface="Arial"/>
                </a:rPr>
                <a:t>L</a:t>
              </a:r>
              <a:endParaRPr lang="en-US" sz="1350" dirty="0">
                <a:latin typeface="Arial"/>
                <a:cs typeface="Arial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0DACF9B-F3B5-4EEF-AA58-D8048CBA5A9E}"/>
                </a:ext>
              </a:extLst>
            </p:cNvPr>
            <p:cNvSpPr txBox="1"/>
            <p:nvPr/>
          </p:nvSpPr>
          <p:spPr>
            <a:xfrm>
              <a:off x="1731821" y="3925216"/>
              <a:ext cx="32893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dirty="0">
                  <a:latin typeface="Arial"/>
                  <a:cs typeface="Arial"/>
                </a:rPr>
                <a:t>M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6183DA8-115C-43E8-A0BF-83F2B53FC964}"/>
                </a:ext>
              </a:extLst>
            </p:cNvPr>
            <p:cNvSpPr txBox="1"/>
            <p:nvPr/>
          </p:nvSpPr>
          <p:spPr>
            <a:xfrm>
              <a:off x="1997694" y="3925216"/>
              <a:ext cx="30970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>
                  <a:latin typeface="Arial"/>
                  <a:cs typeface="Arial"/>
                </a:rPr>
                <a:t>H</a:t>
              </a:r>
              <a:endParaRPr lang="en-US" sz="1350" dirty="0">
                <a:latin typeface="Arial"/>
                <a:cs typeface="Arial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2504B51-81A6-4B85-BFC6-90DBD631A74F}"/>
                </a:ext>
              </a:extLst>
            </p:cNvPr>
            <p:cNvSpPr txBox="1"/>
            <p:nvPr/>
          </p:nvSpPr>
          <p:spPr>
            <a:xfrm>
              <a:off x="2627281" y="3942823"/>
              <a:ext cx="28084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>
                  <a:latin typeface="Arial"/>
                  <a:cs typeface="Arial"/>
                </a:rPr>
                <a:t>L</a:t>
              </a:r>
              <a:endParaRPr lang="en-US" sz="1350" dirty="0">
                <a:latin typeface="Arial"/>
                <a:cs typeface="Arial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AC56C12-BC69-4297-A592-4EFA53C02C78}"/>
                </a:ext>
              </a:extLst>
            </p:cNvPr>
            <p:cNvSpPr txBox="1"/>
            <p:nvPr/>
          </p:nvSpPr>
          <p:spPr>
            <a:xfrm>
              <a:off x="2802200" y="3942823"/>
              <a:ext cx="32893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>
                  <a:latin typeface="Arial"/>
                  <a:cs typeface="Arial"/>
                </a:rPr>
                <a:t>M</a:t>
              </a:r>
              <a:endParaRPr lang="en-US" sz="1350" dirty="0">
                <a:latin typeface="Arial"/>
                <a:cs typeface="Arial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68CE84A-C449-46AE-B37F-7D8688A7DD1D}"/>
                </a:ext>
              </a:extLst>
            </p:cNvPr>
            <p:cNvSpPr txBox="1"/>
            <p:nvPr/>
          </p:nvSpPr>
          <p:spPr>
            <a:xfrm>
              <a:off x="3082361" y="3942823"/>
              <a:ext cx="30970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>
                  <a:latin typeface="Arial"/>
                  <a:cs typeface="Arial"/>
                </a:rPr>
                <a:t>H</a:t>
              </a:r>
              <a:endParaRPr lang="en-US" sz="1350" dirty="0">
                <a:latin typeface="Arial"/>
                <a:cs typeface="Arial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D547EAD-200E-4E0E-A256-FEBEB72B7C4C}"/>
                </a:ext>
              </a:extLst>
            </p:cNvPr>
            <p:cNvSpPr txBox="1"/>
            <p:nvPr/>
          </p:nvSpPr>
          <p:spPr>
            <a:xfrm rot="16200000">
              <a:off x="3257745" y="3983662"/>
              <a:ext cx="502061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dirty="0">
                  <a:latin typeface="Arial"/>
                  <a:cs typeface="Arial"/>
                </a:rPr>
                <a:t>H20</a:t>
              </a:r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33E02C92-EEF4-42A5-B828-887FB18F3CE8}"/>
                </a:ext>
              </a:extLst>
            </p:cNvPr>
            <p:cNvCxnSpPr/>
            <p:nvPr/>
          </p:nvCxnSpPr>
          <p:spPr>
            <a:xfrm>
              <a:off x="1670327" y="3814810"/>
              <a:ext cx="6370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2E288950-C08D-4A43-87CF-A30E68D95DB9}"/>
                </a:ext>
              </a:extLst>
            </p:cNvPr>
            <p:cNvCxnSpPr/>
            <p:nvPr/>
          </p:nvCxnSpPr>
          <p:spPr>
            <a:xfrm>
              <a:off x="2631016" y="3814810"/>
              <a:ext cx="6370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8C2B7C6-52D0-914D-9C5F-000171457A6D}"/>
              </a:ext>
            </a:extLst>
          </p:cNvPr>
          <p:cNvSpPr txBox="1"/>
          <p:nvPr/>
        </p:nvSpPr>
        <p:spPr>
          <a:xfrm>
            <a:off x="1084648" y="4008802"/>
            <a:ext cx="338554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500</a:t>
            </a:r>
          </a:p>
          <a:p>
            <a:r>
              <a:rPr lang="en-US" sz="800" dirty="0"/>
              <a:t>400</a:t>
            </a:r>
          </a:p>
          <a:p>
            <a:r>
              <a:rPr lang="en-US" sz="800" dirty="0"/>
              <a:t>300</a:t>
            </a:r>
          </a:p>
          <a:p>
            <a:r>
              <a:rPr lang="en-US" sz="800" dirty="0"/>
              <a:t>250</a:t>
            </a:r>
          </a:p>
          <a:p>
            <a:r>
              <a:rPr lang="en-US" sz="800" dirty="0"/>
              <a:t>200</a:t>
            </a:r>
          </a:p>
          <a:p>
            <a:r>
              <a:rPr lang="en-US" sz="800" dirty="0"/>
              <a:t>150</a:t>
            </a:r>
          </a:p>
          <a:p>
            <a:r>
              <a:rPr lang="en-US" sz="800" dirty="0"/>
              <a:t>100</a:t>
            </a:r>
          </a:p>
          <a:p>
            <a:endParaRPr lang="en-US" sz="800" dirty="0"/>
          </a:p>
          <a:p>
            <a:endParaRPr lang="en-US" sz="800" dirty="0"/>
          </a:p>
          <a:p>
            <a:r>
              <a:rPr lang="en-US" sz="800" dirty="0"/>
              <a:t>5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45F2B98-E484-D74D-995D-F7C8907AE71B}"/>
              </a:ext>
            </a:extLst>
          </p:cNvPr>
          <p:cNvSpPr txBox="1"/>
          <p:nvPr/>
        </p:nvSpPr>
        <p:spPr>
          <a:xfrm>
            <a:off x="1506876" y="3412914"/>
            <a:ext cx="381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F8DF6B1-D02E-F945-8859-650571ED682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35232" y="1777406"/>
            <a:ext cx="2401161" cy="600669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5994EFE2-19CA-5C42-8CBE-FB64001DBE3D}"/>
              </a:ext>
            </a:extLst>
          </p:cNvPr>
          <p:cNvSpPr txBox="1"/>
          <p:nvPr/>
        </p:nvSpPr>
        <p:spPr>
          <a:xfrm>
            <a:off x="1066938" y="149368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#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5D9827F-519E-9348-9D69-03FB66462F6B}"/>
              </a:ext>
            </a:extLst>
          </p:cNvPr>
          <p:cNvSpPr txBox="1"/>
          <p:nvPr/>
        </p:nvSpPr>
        <p:spPr>
          <a:xfrm>
            <a:off x="1696076" y="149368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#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8F47941-C332-134E-A202-A7C6EBD075A0}"/>
              </a:ext>
            </a:extLst>
          </p:cNvPr>
          <p:cNvSpPr txBox="1"/>
          <p:nvPr/>
        </p:nvSpPr>
        <p:spPr>
          <a:xfrm>
            <a:off x="2395041" y="149368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#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B1C61F4-B264-194E-ADF3-B2CB1C943AE4}"/>
              </a:ext>
            </a:extLst>
          </p:cNvPr>
          <p:cNvSpPr txBox="1"/>
          <p:nvPr/>
        </p:nvSpPr>
        <p:spPr>
          <a:xfrm>
            <a:off x="2833280" y="1493681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Control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868E05D-4BC8-7F47-8859-6AA665C64048}"/>
              </a:ext>
            </a:extLst>
          </p:cNvPr>
          <p:cNvSpPr txBox="1"/>
          <p:nvPr/>
        </p:nvSpPr>
        <p:spPr>
          <a:xfrm>
            <a:off x="121482" y="1826434"/>
            <a:ext cx="8755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FLAG-MSI2</a:t>
            </a:r>
          </a:p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38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kD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87473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865709" y="2206708"/>
            <a:ext cx="12923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I2/GAPDH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1271280"/>
              </p:ext>
            </p:extLst>
          </p:nvPr>
        </p:nvGraphicFramePr>
        <p:xfrm>
          <a:off x="1632183" y="1018792"/>
          <a:ext cx="3962122" cy="2435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287514" y="2711566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084951" y="275061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882388" y="2804770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86E5AA6-FABD-4B61-B774-26AA4BB2C67F}"/>
                  </a:ext>
                </a:extLst>
              </p:cNvPr>
              <p:cNvSpPr txBox="1"/>
              <p:nvPr/>
            </p:nvSpPr>
            <p:spPr>
              <a:xfrm>
                <a:off x="4994444" y="2628447"/>
                <a:ext cx="45719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i="1">
                          <a:latin typeface="Cambria Math" panose="02040503050406030204" pitchFamily="18" charset="0"/>
                        </a:rPr>
                        <m:t>↓</m:t>
                      </m:r>
                    </m:oMath>
                  </m:oMathPara>
                </a14:m>
                <a:endParaRPr lang="en-US" dirty="0"/>
              </a:p>
            </p:txBody>
          </p:sp>
        </mc:Choice>
        <mc:Fallback xmlns="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86E5AA6-FABD-4B61-B774-26AA4BB2C67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994444" y="2628447"/>
                <a:ext cx="45719" cy="276999"/>
              </a:xfrm>
              <a:prstGeom prst="rect">
                <a:avLst/>
              </a:prstGeom>
              <a:blipFill>
                <a:blip r:embed="rId3"/>
                <a:stretch>
                  <a:fillRect l="-175000" r="-300000" b="-6522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86E5AA6-FABD-4B61-B774-26AA4BB2C67F}"/>
                  </a:ext>
                </a:extLst>
              </p:cNvPr>
              <p:cNvSpPr txBox="1"/>
              <p:nvPr/>
            </p:nvSpPr>
            <p:spPr>
              <a:xfrm>
                <a:off x="4185895" y="2601748"/>
                <a:ext cx="46929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i="1">
                          <a:latin typeface="Cambria Math" panose="02040503050406030204" pitchFamily="18" charset="0"/>
                        </a:rPr>
                        <m:t>↓</m:t>
                      </m:r>
                    </m:oMath>
                  </m:oMathPara>
                </a14:m>
                <a:endParaRPr lang="en-US" dirty="0"/>
              </a:p>
            </p:txBody>
          </p:sp>
        </mc:Choice>
        <mc:Fallback xmlns=""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86E5AA6-FABD-4B61-B774-26AA4BB2C67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185895" y="2601748"/>
                <a:ext cx="46929" cy="276999"/>
              </a:xfrm>
              <a:prstGeom prst="rect">
                <a:avLst/>
              </a:prstGeom>
              <a:blipFill>
                <a:blip r:embed="rId4"/>
                <a:stretch>
                  <a:fillRect l="-200000" r="-357143" b="-8889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86E5AA6-FABD-4B61-B774-26AA4BB2C67F}"/>
                  </a:ext>
                </a:extLst>
              </p:cNvPr>
              <p:cNvSpPr txBox="1"/>
              <p:nvPr/>
            </p:nvSpPr>
            <p:spPr>
              <a:xfrm>
                <a:off x="3393670" y="2572780"/>
                <a:ext cx="46929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i="1">
                          <a:latin typeface="Cambria Math" panose="02040503050406030204" pitchFamily="18" charset="0"/>
                        </a:rPr>
                        <m:t>↓</m:t>
                      </m:r>
                    </m:oMath>
                  </m:oMathPara>
                </a14:m>
                <a:endParaRPr lang="en-US" dirty="0"/>
              </a:p>
            </p:txBody>
          </p:sp>
        </mc:Choice>
        <mc:Fallback xmlns=""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86E5AA6-FABD-4B61-B774-26AA4BB2C67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393670" y="2572780"/>
                <a:ext cx="46929" cy="276999"/>
              </a:xfrm>
              <a:prstGeom prst="rect">
                <a:avLst/>
              </a:prstGeom>
              <a:blipFill>
                <a:blip r:embed="rId5"/>
                <a:stretch>
                  <a:fillRect l="-200000" r="-357143" b="-8889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2" name="TextBox 11"/>
          <p:cNvSpPr txBox="1"/>
          <p:nvPr/>
        </p:nvSpPr>
        <p:spPr>
          <a:xfrm>
            <a:off x="4807963" y="2421346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90%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264065" y="2360596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2%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026179" y="239918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6%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E9377B1-311D-4FB7-BC6B-2009FDC9C7F4}"/>
              </a:ext>
            </a:extLst>
          </p:cNvPr>
          <p:cNvSpPr txBox="1"/>
          <p:nvPr/>
        </p:nvSpPr>
        <p:spPr>
          <a:xfrm>
            <a:off x="14986" y="1573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12501037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32B09DE-815A-D846-8D4C-5C3C685B5727}"/>
              </a:ext>
            </a:extLst>
          </p:cNvPr>
          <p:cNvGrpSpPr/>
          <p:nvPr/>
        </p:nvGrpSpPr>
        <p:grpSpPr>
          <a:xfrm>
            <a:off x="409917" y="175891"/>
            <a:ext cx="7511571" cy="6405973"/>
            <a:chOff x="-401049" y="-141800"/>
            <a:chExt cx="8034669" cy="8773286"/>
          </a:xfrm>
        </p:grpSpPr>
        <p:sp>
          <p:nvSpPr>
            <p:cNvPr id="17" name="TextBox 16"/>
            <p:cNvSpPr txBox="1"/>
            <p:nvPr/>
          </p:nvSpPr>
          <p:spPr>
            <a:xfrm>
              <a:off x="-401049" y="-141800"/>
              <a:ext cx="2073336" cy="379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Supplementary Figure 3</a:t>
              </a: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6687" y="600109"/>
              <a:ext cx="3480385" cy="2638357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152896" y="545231"/>
              <a:ext cx="3386147" cy="269323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65612" y="361364"/>
              <a:ext cx="655334" cy="379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Bulge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426624" y="284088"/>
              <a:ext cx="818224" cy="379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Exterior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7487" y="3454758"/>
              <a:ext cx="3530300" cy="245356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179732" y="3429000"/>
              <a:ext cx="3383280" cy="2472571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1755461" y="3227444"/>
              <a:ext cx="885870" cy="379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Hairpin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441051" y="3188806"/>
              <a:ext cx="792504" cy="379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Internal</a:t>
              </a: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36165" y="6254046"/>
              <a:ext cx="3620109" cy="237744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1615543" y="6013286"/>
              <a:ext cx="1132002" cy="379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Multibranch</a:t>
              </a:r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05292" y="6254046"/>
              <a:ext cx="3428328" cy="237744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5542040" y="5991557"/>
              <a:ext cx="598751" cy="379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Stem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3143" y="374780"/>
              <a:ext cx="234888" cy="379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A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880904" y="374780"/>
              <a:ext cx="234888" cy="379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16022" y="3178977"/>
              <a:ext cx="234888" cy="379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C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918132" y="3185803"/>
              <a:ext cx="234888" cy="379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D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94491" y="5994492"/>
              <a:ext cx="234888" cy="379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E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964012" y="5980203"/>
              <a:ext cx="234888" cy="379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069603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8A913387-DA15-4A59-B617-5140B17512CA}"/>
              </a:ext>
            </a:extLst>
          </p:cNvPr>
          <p:cNvSpPr txBox="1"/>
          <p:nvPr/>
        </p:nvSpPr>
        <p:spPr>
          <a:xfrm>
            <a:off x="1839301" y="454155"/>
            <a:ext cx="246574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I2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:    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        +         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63F1F2FF-3759-45CF-A8C4-3A987AD3538D}"/>
              </a:ext>
            </a:extLst>
          </p:cNvPr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561413" y="3075669"/>
            <a:ext cx="1399032" cy="484632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03B8C1ED-54FB-42EE-A615-94737387E4DE}"/>
              </a:ext>
            </a:extLst>
          </p:cNvPr>
          <p:cNvSpPr txBox="1"/>
          <p:nvPr/>
        </p:nvSpPr>
        <p:spPr>
          <a:xfrm>
            <a:off x="1537736" y="3199152"/>
            <a:ext cx="10325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 ACTI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7B09502-460E-483A-9DE0-C58081E929DA}"/>
              </a:ext>
            </a:extLst>
          </p:cNvPr>
          <p:cNvSpPr txBox="1"/>
          <p:nvPr/>
        </p:nvSpPr>
        <p:spPr>
          <a:xfrm>
            <a:off x="5704327" y="987407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USP2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F278F0B-33E9-441B-9C67-67043E5CC0C4}"/>
              </a:ext>
            </a:extLst>
          </p:cNvPr>
          <p:cNvSpPr txBox="1"/>
          <p:nvPr/>
        </p:nvSpPr>
        <p:spPr>
          <a:xfrm>
            <a:off x="5554256" y="1539850"/>
            <a:ext cx="9249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ACTIN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C7ADAEAA-9A4F-45D3-855B-A5C8F6CD1B51}"/>
              </a:ext>
            </a:extLst>
          </p:cNvPr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57357" y="906503"/>
            <a:ext cx="1399032" cy="48463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D0988E44-95D3-44AB-B116-B718A2415F0E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55505" y="1414186"/>
            <a:ext cx="1399032" cy="484632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FC9E55D1-0304-4786-9F5A-C31129E8F6BC}"/>
              </a:ext>
            </a:extLst>
          </p:cNvPr>
          <p:cNvSpPr txBox="1"/>
          <p:nvPr/>
        </p:nvSpPr>
        <p:spPr>
          <a:xfrm>
            <a:off x="13591" y="1314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ure 4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1469945F-4CDB-9347-A129-0641696B4BD5}"/>
              </a:ext>
            </a:extLst>
          </p:cNvPr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57357" y="1934801"/>
            <a:ext cx="1399032" cy="48463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AA372FA-7B06-5644-92F1-92CF95D44B0F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59157" y="2445368"/>
            <a:ext cx="1399032" cy="484632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D7A2F27B-939F-9E4C-B60B-3BA49D6E1F1D}"/>
              </a:ext>
            </a:extLst>
          </p:cNvPr>
          <p:cNvSpPr txBox="1"/>
          <p:nvPr/>
        </p:nvSpPr>
        <p:spPr>
          <a:xfrm>
            <a:off x="5748267" y="2008533"/>
            <a:ext cx="7156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B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AFD6364-CDCE-7E4A-899E-D1162417D187}"/>
              </a:ext>
            </a:extLst>
          </p:cNvPr>
          <p:cNvSpPr txBox="1"/>
          <p:nvPr/>
        </p:nvSpPr>
        <p:spPr>
          <a:xfrm>
            <a:off x="5536598" y="2516882"/>
            <a:ext cx="9249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ACTI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3EE6A50-EA92-FD49-92C1-32F161F76F05}"/>
              </a:ext>
            </a:extLst>
          </p:cNvPr>
          <p:cNvSpPr txBox="1"/>
          <p:nvPr/>
        </p:nvSpPr>
        <p:spPr>
          <a:xfrm>
            <a:off x="5548663" y="320917"/>
            <a:ext cx="256833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I2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      -          +       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95F14956-DD9C-E74F-8A82-7F08C088FA19}"/>
              </a:ext>
            </a:extLst>
          </p:cNvPr>
          <p:cNvGrpSpPr/>
          <p:nvPr/>
        </p:nvGrpSpPr>
        <p:grpSpPr>
          <a:xfrm>
            <a:off x="2059624" y="1513517"/>
            <a:ext cx="2282580" cy="479802"/>
            <a:chOff x="2040373" y="2014266"/>
            <a:chExt cx="2282580" cy="479802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EDD92AC5-DF2D-4AE6-A0F9-A101274E95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50356" y="2014266"/>
              <a:ext cx="1395038" cy="479802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31CB912-F2D8-4E53-843B-3974D5C72342}"/>
                </a:ext>
              </a:extLst>
            </p:cNvPr>
            <p:cNvSpPr txBox="1"/>
            <p:nvPr/>
          </p:nvSpPr>
          <p:spPr>
            <a:xfrm>
              <a:off x="2040373" y="2128238"/>
              <a:ext cx="5245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P1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B120411-30F1-AC4A-9314-F45D835A5E46}"/>
                </a:ext>
              </a:extLst>
            </p:cNvPr>
            <p:cNvSpPr txBox="1"/>
            <p:nvPr/>
          </p:nvSpPr>
          <p:spPr>
            <a:xfrm>
              <a:off x="3910661" y="2092380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45E163C8-ED9B-974D-843D-14B1A750DA37}"/>
              </a:ext>
            </a:extLst>
          </p:cNvPr>
          <p:cNvGrpSpPr/>
          <p:nvPr/>
        </p:nvGrpSpPr>
        <p:grpSpPr>
          <a:xfrm>
            <a:off x="1804433" y="2035735"/>
            <a:ext cx="2554620" cy="484632"/>
            <a:chOff x="1785182" y="2546549"/>
            <a:chExt cx="2554620" cy="484632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7F48724-B05F-4FB2-A20D-52AA14F0500C}"/>
                </a:ext>
              </a:extLst>
            </p:cNvPr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50358" y="2546549"/>
              <a:ext cx="1399032" cy="484632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7893D9A-3809-4810-A1E3-B2561076AE63}"/>
                </a:ext>
              </a:extLst>
            </p:cNvPr>
            <p:cNvSpPr txBox="1"/>
            <p:nvPr/>
          </p:nvSpPr>
          <p:spPr>
            <a:xfrm>
              <a:off x="1785182" y="2650801"/>
              <a:ext cx="7729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-MYC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DE9A740-9FA4-6B49-9DB7-008AF9AC910A}"/>
                </a:ext>
              </a:extLst>
            </p:cNvPr>
            <p:cNvSpPr txBox="1"/>
            <p:nvPr/>
          </p:nvSpPr>
          <p:spPr>
            <a:xfrm>
              <a:off x="3927510" y="2639218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57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5AE4A4E8-8631-4344-8A5C-D79D7353069A}"/>
              </a:ext>
            </a:extLst>
          </p:cNvPr>
          <p:cNvGrpSpPr/>
          <p:nvPr/>
        </p:nvGrpSpPr>
        <p:grpSpPr>
          <a:xfrm>
            <a:off x="1707786" y="988300"/>
            <a:ext cx="2739248" cy="484632"/>
            <a:chOff x="1687478" y="3074111"/>
            <a:chExt cx="2739248" cy="484632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871B3222-9F75-46AD-9170-B88D90B59B63}"/>
                </a:ext>
              </a:extLst>
            </p:cNvPr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36088" y="3074111"/>
              <a:ext cx="1399032" cy="484632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2EBAB03-604A-4836-A07B-B1B32178067A}"/>
                </a:ext>
              </a:extLst>
            </p:cNvPr>
            <p:cNvSpPr txBox="1"/>
            <p:nvPr/>
          </p:nvSpPr>
          <p:spPr>
            <a:xfrm>
              <a:off x="1687478" y="3134752"/>
              <a:ext cx="8435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RAD21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D82C1B9-42F7-BD42-9876-6E246F74C1C5}"/>
                </a:ext>
              </a:extLst>
            </p:cNvPr>
            <p:cNvSpPr txBox="1"/>
            <p:nvPr/>
          </p:nvSpPr>
          <p:spPr>
            <a:xfrm>
              <a:off x="3900620" y="3186061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D2B7B635-9579-5F46-B82B-192CA6010E62}"/>
              </a:ext>
            </a:extLst>
          </p:cNvPr>
          <p:cNvSpPr txBox="1"/>
          <p:nvPr/>
        </p:nvSpPr>
        <p:spPr>
          <a:xfrm>
            <a:off x="3932086" y="319863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CBD3634-6E3E-3743-97EF-0F1AE5B3F58A}"/>
              </a:ext>
            </a:extLst>
          </p:cNvPr>
          <p:cNvSpPr txBox="1"/>
          <p:nvPr/>
        </p:nvSpPr>
        <p:spPr>
          <a:xfrm>
            <a:off x="3887280" y="718189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F9B7E71-C263-E044-BA21-1CEA918FC1AC}"/>
              </a:ext>
            </a:extLst>
          </p:cNvPr>
          <p:cNvSpPr txBox="1"/>
          <p:nvPr/>
        </p:nvSpPr>
        <p:spPr>
          <a:xfrm>
            <a:off x="7823798" y="984655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DC1A274-A6E1-504F-8B58-C17F787DBA25}"/>
              </a:ext>
            </a:extLst>
          </p:cNvPr>
          <p:cNvSpPr txBox="1"/>
          <p:nvPr/>
        </p:nvSpPr>
        <p:spPr>
          <a:xfrm>
            <a:off x="7822089" y="560456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0781AA0-43CC-EE47-9329-6803FCA243F6}"/>
              </a:ext>
            </a:extLst>
          </p:cNvPr>
          <p:cNvSpPr txBox="1"/>
          <p:nvPr/>
        </p:nvSpPr>
        <p:spPr>
          <a:xfrm>
            <a:off x="7812041" y="2019749"/>
            <a:ext cx="5108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B353EB3-93B1-774B-9787-11611AD55426}"/>
              </a:ext>
            </a:extLst>
          </p:cNvPr>
          <p:cNvSpPr txBox="1"/>
          <p:nvPr/>
        </p:nvSpPr>
        <p:spPr>
          <a:xfrm>
            <a:off x="7807891" y="253675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3D198B9-C75B-074E-93F5-E0851F0983AD}"/>
              </a:ext>
            </a:extLst>
          </p:cNvPr>
          <p:cNvSpPr txBox="1"/>
          <p:nvPr/>
        </p:nvSpPr>
        <p:spPr>
          <a:xfrm>
            <a:off x="7832137" y="147730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F8DF9FB-D530-DE46-9E14-14001AA6AF6B}"/>
              </a:ext>
            </a:extLst>
          </p:cNvPr>
          <p:cNvSpPr txBox="1"/>
          <p:nvPr/>
        </p:nvSpPr>
        <p:spPr>
          <a:xfrm>
            <a:off x="7756401" y="1935255"/>
            <a:ext cx="5245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]   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D5C09092-E28B-DD41-99C9-9A80A4062E55}"/>
              </a:ext>
            </a:extLst>
          </p:cNvPr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561413" y="2552187"/>
            <a:ext cx="1399032" cy="484632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A76D2D73-951B-634F-9122-C1B617AF96C8}"/>
              </a:ext>
            </a:extLst>
          </p:cNvPr>
          <p:cNvSpPr txBox="1"/>
          <p:nvPr/>
        </p:nvSpPr>
        <p:spPr>
          <a:xfrm>
            <a:off x="1985654" y="2640614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I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6F8932A-F177-994D-8E97-43B038395F1A}"/>
              </a:ext>
            </a:extLst>
          </p:cNvPr>
          <p:cNvSpPr txBox="1"/>
          <p:nvPr/>
        </p:nvSpPr>
        <p:spPr>
          <a:xfrm>
            <a:off x="3950232" y="262932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</p:spTree>
    <p:extLst>
      <p:ext uri="{BB962C8B-B14F-4D97-AF65-F5344CB8AC3E}">
        <p14:creationId xmlns:p14="http://schemas.microsoft.com/office/powerpoint/2010/main" val="17256723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00381" y="1076390"/>
            <a:ext cx="1076755" cy="36576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8946" y="1490806"/>
            <a:ext cx="1078992" cy="369633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925320" y="766850"/>
            <a:ext cx="28793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i2-sh9      Msi2-sh12                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11610" y="1854412"/>
            <a:ext cx="32159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ox:        -      +          -        +              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03220" y="1103683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I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6930" y="1490847"/>
            <a:ext cx="8851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20" name="Picture 19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20294" y="1060608"/>
            <a:ext cx="1078992" cy="365760"/>
          </a:xfrm>
          <a:prstGeom prst="rect">
            <a:avLst/>
          </a:prstGeom>
        </p:spPr>
      </p:pic>
      <p:pic>
        <p:nvPicPr>
          <p:cNvPr id="21" name="Picture 20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10246" y="1480759"/>
            <a:ext cx="1078992" cy="36576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5E81321-9441-4086-9B28-008C692CDE46}"/>
              </a:ext>
            </a:extLst>
          </p:cNvPr>
          <p:cNvSpPr txBox="1"/>
          <p:nvPr/>
        </p:nvSpPr>
        <p:spPr>
          <a:xfrm>
            <a:off x="9158" y="12207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ure 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09088FB-B958-45F4-84C9-67D2C65585F1}"/>
              </a:ext>
            </a:extLst>
          </p:cNvPr>
          <p:cNvSpPr txBox="1"/>
          <p:nvPr/>
        </p:nvSpPr>
        <p:spPr>
          <a:xfrm>
            <a:off x="225287" y="479757"/>
            <a:ext cx="457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A7EBFD44-F9EB-45C4-B4CA-4D94D21B43AF}"/>
              </a:ext>
            </a:extLst>
          </p:cNvPr>
          <p:cNvGrpSpPr/>
          <p:nvPr/>
        </p:nvGrpSpPr>
        <p:grpSpPr>
          <a:xfrm>
            <a:off x="110215" y="3249751"/>
            <a:ext cx="3829405" cy="2745193"/>
            <a:chOff x="173509" y="243810"/>
            <a:chExt cx="4312469" cy="3635924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3795172-0589-4367-8B24-890FEBB8EE42}"/>
                </a:ext>
              </a:extLst>
            </p:cNvPr>
            <p:cNvSpPr txBox="1"/>
            <p:nvPr/>
          </p:nvSpPr>
          <p:spPr>
            <a:xfrm rot="16200000">
              <a:off x="-494006" y="2379822"/>
              <a:ext cx="1797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FC6CD1B-3F88-4305-B365-C504CF7B471A}"/>
                </a:ext>
              </a:extLst>
            </p:cNvPr>
            <p:cNvSpPr txBox="1"/>
            <p:nvPr/>
          </p:nvSpPr>
          <p:spPr>
            <a:xfrm>
              <a:off x="2593494" y="2812274"/>
              <a:ext cx="507121" cy="373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92%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428910E-EDD9-4DC2-AA01-1E3FA2637BDD}"/>
                </a:ext>
              </a:extLst>
            </p:cNvPr>
            <p:cNvSpPr txBox="1"/>
            <p:nvPr/>
          </p:nvSpPr>
          <p:spPr>
            <a:xfrm>
              <a:off x="3740116" y="2703465"/>
              <a:ext cx="507121" cy="373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82%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graphicFrame>
              <p:nvGraphicFramePr>
                <p:cNvPr id="26" name="Chart 25">
                  <a:extLst>
                    <a:ext uri="{FF2B5EF4-FFF2-40B4-BE49-F238E27FC236}">
                      <a16:creationId xmlns:a16="http://schemas.microsoft.com/office/drawing/2014/main" id="{082C8FC5-7D41-48DC-BA0E-D5DBEE2D42FF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75320132"/>
                    </p:ext>
                  </p:extLst>
                </p:nvPr>
              </p:nvGraphicFramePr>
              <p:xfrm>
                <a:off x="514581" y="1101926"/>
                <a:ext cx="3971397" cy="277780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</mc:Choice>
          <mc:Fallback xmlns="">
            <p:graphicFrame>
              <p:nvGraphicFramePr>
                <p:cNvPr id="26" name="Chart 25">
                  <a:extLst>
                    <a:ext uri="{FF2B5EF4-FFF2-40B4-BE49-F238E27FC236}">
                      <a16:creationId xmlns:a16="http://schemas.microsoft.com/office/drawing/2014/main" xmlns:a14="http://schemas.microsoft.com/office/drawing/2010/main" xmlns="" id="{082C8FC5-7D41-48DC-BA0E-D5DBEE2D42FF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75320132"/>
                    </p:ext>
                  </p:extLst>
                </p:nvPr>
              </p:nvGraphicFramePr>
              <p:xfrm>
                <a:off x="514581" y="1101926"/>
                <a:ext cx="3971397" cy="277780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</mc:Fallback>
        </mc:AlternateContent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152B879-50C8-4CCB-B154-82DA3AD7B7DD}"/>
                </a:ext>
              </a:extLst>
            </p:cNvPr>
            <p:cNvSpPr txBox="1"/>
            <p:nvPr/>
          </p:nvSpPr>
          <p:spPr>
            <a:xfrm>
              <a:off x="2222327" y="1566157"/>
              <a:ext cx="461171" cy="3376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*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6F6900B-39EE-45C6-ACAB-E266E63316F2}"/>
                </a:ext>
              </a:extLst>
            </p:cNvPr>
            <p:cNvSpPr txBox="1"/>
            <p:nvPr/>
          </p:nvSpPr>
          <p:spPr>
            <a:xfrm>
              <a:off x="3354785" y="1540568"/>
              <a:ext cx="461171" cy="3376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*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8D3A8A46-9CEE-4FFA-A96E-2F01993C0FB5}"/>
                    </a:ext>
                  </a:extLst>
                </p:cNvPr>
                <p:cNvSpPr txBox="1"/>
                <p:nvPr/>
              </p:nvSpPr>
              <p:spPr>
                <a:xfrm>
                  <a:off x="3885215" y="2543426"/>
                  <a:ext cx="75058" cy="25197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i="1">
                            <a:latin typeface="Cambria Math" panose="02040503050406030204" pitchFamily="18" charset="0"/>
                          </a:rPr>
                          <m:t>↓</m:t>
                        </m:r>
                      </m:oMath>
                    </m:oMathPara>
                  </a14:m>
                  <a:endParaRPr lang="en-US" dirty="0"/>
                </a:p>
              </p:txBody>
            </p:sp>
          </mc:Choice>
          <mc:Fallback xmlns=""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4B2B7524-F4AA-41AF-9456-6B8BF75666F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885215" y="2543426"/>
                  <a:ext cx="75058" cy="251970"/>
                </a:xfrm>
                <a:prstGeom prst="rect">
                  <a:avLst/>
                </a:prstGeom>
                <a:blipFill>
                  <a:blip r:embed="rId15"/>
                  <a:stretch>
                    <a:fillRect l="-107692" r="-146154" b="-16667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771F00CA-9A33-435D-A04B-1FF504D8A26E}"/>
                    </a:ext>
                  </a:extLst>
                </p:cNvPr>
                <p:cNvSpPr txBox="1"/>
                <p:nvPr/>
              </p:nvSpPr>
              <p:spPr>
                <a:xfrm>
                  <a:off x="2745557" y="2637248"/>
                  <a:ext cx="39713" cy="25321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i="1">
                            <a:latin typeface="Cambria Math" panose="02040503050406030204" pitchFamily="18" charset="0"/>
                          </a:rPr>
                          <m:t>↓</m:t>
                        </m:r>
                      </m:oMath>
                    </m:oMathPara>
                  </a14:m>
                  <a:endParaRPr lang="en-US" dirty="0"/>
                </a:p>
              </p:txBody>
            </p:sp>
          </mc:Choice>
          <mc:Fallback xmlns=""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F14589E4-EB2B-49D2-8E96-E85D2669887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745557" y="2637248"/>
                  <a:ext cx="39713" cy="253213"/>
                </a:xfrm>
                <a:prstGeom prst="rect">
                  <a:avLst/>
                </a:prstGeom>
                <a:blipFill>
                  <a:blip r:embed="rId16"/>
                  <a:stretch>
                    <a:fillRect l="-200000" r="-357143" b="-19512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CC4A496-F738-4BCD-B005-4CF61867AEB7}"/>
                </a:ext>
              </a:extLst>
            </p:cNvPr>
            <p:cNvSpPr txBox="1"/>
            <p:nvPr/>
          </p:nvSpPr>
          <p:spPr>
            <a:xfrm>
              <a:off x="173509" y="243810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0A613786-9C68-44E5-9CBF-E3A6E5F80629}"/>
              </a:ext>
            </a:extLst>
          </p:cNvPr>
          <p:cNvGrpSpPr/>
          <p:nvPr/>
        </p:nvGrpSpPr>
        <p:grpSpPr>
          <a:xfrm>
            <a:off x="3727622" y="319984"/>
            <a:ext cx="4916812" cy="2743200"/>
            <a:chOff x="3886882" y="3820679"/>
            <a:chExt cx="4916812" cy="2743200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1CB54B4-4375-434C-938D-E10524C3E681}"/>
                </a:ext>
              </a:extLst>
            </p:cNvPr>
            <p:cNvSpPr txBox="1"/>
            <p:nvPr/>
          </p:nvSpPr>
          <p:spPr>
            <a:xfrm>
              <a:off x="5708631" y="4326460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*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FABB7AD-DE71-41FE-9236-5FAE5559408D}"/>
                </a:ext>
              </a:extLst>
            </p:cNvPr>
            <p:cNvSpPr txBox="1"/>
            <p:nvPr/>
          </p:nvSpPr>
          <p:spPr>
            <a:xfrm>
              <a:off x="6767282" y="4326460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*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FFAE3A4-6403-4702-B31E-B600D21C2819}"/>
                </a:ext>
              </a:extLst>
            </p:cNvPr>
            <p:cNvSpPr txBox="1"/>
            <p:nvPr/>
          </p:nvSpPr>
          <p:spPr>
            <a:xfrm>
              <a:off x="7780453" y="4318768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graphicFrame>
              <p:nvGraphicFramePr>
                <p:cNvPr id="45" name="Chart 44">
                  <a:extLst>
                    <a:ext uri="{FF2B5EF4-FFF2-40B4-BE49-F238E27FC236}">
                      <a16:creationId xmlns:a16="http://schemas.microsoft.com/office/drawing/2014/main" id="{80B525A9-09EF-45F3-9B59-F562251F0898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216412180"/>
                    </p:ext>
                  </p:extLst>
                </p:nvPr>
              </p:nvGraphicFramePr>
              <p:xfrm>
                <a:off x="4231694" y="3820679"/>
                <a:ext cx="457200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7"/>
                </a:graphicData>
              </a:graphic>
            </p:graphicFrame>
          </mc:Choice>
          <mc:Fallback xmlns="">
            <p:graphicFrame>
              <p:nvGraphicFramePr>
                <p:cNvPr id="45" name="Chart 44">
                  <a:extLst>
                    <a:ext uri="{FF2B5EF4-FFF2-40B4-BE49-F238E27FC236}">
                      <a16:creationId xmlns:a16="http://schemas.microsoft.com/office/drawing/2014/main" xmlns:a14="http://schemas.microsoft.com/office/drawing/2010/main" xmlns="" id="{80B525A9-09EF-45F3-9B59-F562251F0898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24007917"/>
                    </p:ext>
                  </p:extLst>
                </p:nvPr>
              </p:nvGraphicFramePr>
              <p:xfrm>
                <a:off x="4231694" y="3820679"/>
                <a:ext cx="457200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8"/>
                </a:graphicData>
              </a:graphic>
            </p:graphicFrame>
          </mc:Fallback>
        </mc:AlternateContent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C0962BB-00DC-41BA-80F1-DA12C107DE59}"/>
                </a:ext>
              </a:extLst>
            </p:cNvPr>
            <p:cNvSpPr txBox="1"/>
            <p:nvPr/>
          </p:nvSpPr>
          <p:spPr>
            <a:xfrm rot="16200000">
              <a:off x="3142127" y="5038679"/>
              <a:ext cx="17972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6A786238-38F1-4978-90C7-810B6533BD23}"/>
                    </a:ext>
                  </a:extLst>
                </p:cNvPr>
                <p:cNvSpPr txBox="1"/>
                <p:nvPr/>
              </p:nvSpPr>
              <p:spPr>
                <a:xfrm>
                  <a:off x="6239545" y="5162202"/>
                  <a:ext cx="46929" cy="2769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i="1">
                            <a:latin typeface="Cambria Math" panose="02040503050406030204" pitchFamily="18" charset="0"/>
                          </a:rPr>
                          <m:t>↓</m:t>
                        </m:r>
                      </m:oMath>
                    </m:oMathPara>
                  </a14:m>
                  <a:endParaRPr lang="en-US" dirty="0"/>
                </a:p>
              </p:txBody>
            </p:sp>
          </mc:Choice>
          <mc:Fallback xmlns=""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D86E5AA6-FABD-4B61-B774-26AA4BB2C67F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239545" y="5162202"/>
                  <a:ext cx="46929" cy="276999"/>
                </a:xfrm>
                <a:prstGeom prst="rect">
                  <a:avLst/>
                </a:prstGeom>
                <a:blipFill>
                  <a:blip r:embed="rId8"/>
                  <a:stretch>
                    <a:fillRect l="-175000" r="-300000" b="-6522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0794F90E-25E0-4BDB-88E7-3E7CA738F2EB}"/>
                    </a:ext>
                  </a:extLst>
                </p:cNvPr>
                <p:cNvSpPr txBox="1"/>
                <p:nvPr/>
              </p:nvSpPr>
              <p:spPr>
                <a:xfrm>
                  <a:off x="7273134" y="5358171"/>
                  <a:ext cx="84966" cy="2769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i="1">
                            <a:latin typeface="Cambria Math" panose="02040503050406030204" pitchFamily="18" charset="0"/>
                          </a:rPr>
                          <m:t>↓</m:t>
                        </m:r>
                      </m:oMath>
                    </m:oMathPara>
                  </a14:m>
                  <a:endParaRPr lang="en-US" dirty="0"/>
                </a:p>
              </p:txBody>
            </p:sp>
          </mc:Choice>
          <mc:Fallback xmlns=""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D4B03A80-E41C-4B7F-9406-2586506E0B5F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7273134" y="5358171"/>
                  <a:ext cx="84966" cy="276999"/>
                </a:xfrm>
                <a:prstGeom prst="rect">
                  <a:avLst/>
                </a:prstGeom>
                <a:blipFill>
                  <a:blip r:embed="rId9"/>
                  <a:stretch>
                    <a:fillRect l="-100000" r="-128571" b="-6522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66C50233-694C-49EF-B648-FA2C155378C0}"/>
                    </a:ext>
                  </a:extLst>
                </p:cNvPr>
                <p:cNvSpPr txBox="1"/>
                <p:nvPr/>
              </p:nvSpPr>
              <p:spPr>
                <a:xfrm>
                  <a:off x="8264775" y="5373230"/>
                  <a:ext cx="84966" cy="2769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i="1">
                            <a:latin typeface="Cambria Math" panose="02040503050406030204" pitchFamily="18" charset="0"/>
                          </a:rPr>
                          <m:t>↓</m:t>
                        </m:r>
                      </m:oMath>
                    </m:oMathPara>
                  </a14:m>
                  <a:endParaRPr lang="en-US" dirty="0"/>
                </a:p>
              </p:txBody>
            </p:sp>
          </mc:Choice>
          <mc:Fallback xmlns=""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17C72A4E-9771-48EF-A375-AE65945ED92D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8264775" y="5373230"/>
                  <a:ext cx="84966" cy="276999"/>
                </a:xfrm>
                <a:prstGeom prst="rect">
                  <a:avLst/>
                </a:prstGeom>
                <a:blipFill>
                  <a:blip r:embed="rId10"/>
                  <a:stretch>
                    <a:fillRect l="-100000" r="-128571" b="-8889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5080C84D-9C2F-48C0-BB4D-68CD6EDA1ADF}"/>
              </a:ext>
            </a:extLst>
          </p:cNvPr>
          <p:cNvSpPr txBox="1"/>
          <p:nvPr/>
        </p:nvSpPr>
        <p:spPr>
          <a:xfrm>
            <a:off x="5960338" y="1834181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2%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4F89811-A6C9-4D85-976F-72E98BA1138F}"/>
              </a:ext>
            </a:extLst>
          </p:cNvPr>
          <p:cNvSpPr txBox="1"/>
          <p:nvPr/>
        </p:nvSpPr>
        <p:spPr>
          <a:xfrm>
            <a:off x="6992428" y="2015333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8%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29D5A6D-342F-4D88-928C-1D592A3100A5}"/>
              </a:ext>
            </a:extLst>
          </p:cNvPr>
          <p:cNvSpPr txBox="1"/>
          <p:nvPr/>
        </p:nvSpPr>
        <p:spPr>
          <a:xfrm>
            <a:off x="7987094" y="2022061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5%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0288028"/>
              </p:ext>
            </p:extLst>
          </p:nvPr>
        </p:nvGraphicFramePr>
        <p:xfrm>
          <a:off x="4177719" y="3202520"/>
          <a:ext cx="4678359" cy="29888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6516898" y="3740647"/>
            <a:ext cx="17572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olysom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Fractions</a:t>
            </a:r>
          </a:p>
        </p:txBody>
      </p:sp>
      <p:sp>
        <p:nvSpPr>
          <p:cNvPr id="8" name="Left Bracket 7"/>
          <p:cNvSpPr/>
          <p:nvPr/>
        </p:nvSpPr>
        <p:spPr>
          <a:xfrm rot="5400000">
            <a:off x="7413614" y="3764773"/>
            <a:ext cx="145691" cy="821060"/>
          </a:xfrm>
          <a:prstGeom prst="leftBracket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" name="Group 8"/>
          <p:cNvGrpSpPr/>
          <p:nvPr/>
        </p:nvGrpSpPr>
        <p:grpSpPr>
          <a:xfrm>
            <a:off x="5964950" y="5307373"/>
            <a:ext cx="1110979" cy="513724"/>
            <a:chOff x="8467073" y="825286"/>
            <a:chExt cx="1110979" cy="513724"/>
          </a:xfrm>
        </p:grpSpPr>
        <p:sp>
          <p:nvSpPr>
            <p:cNvPr id="10" name="Rectangle 9"/>
            <p:cNvSpPr/>
            <p:nvPr/>
          </p:nvSpPr>
          <p:spPr>
            <a:xfrm>
              <a:off x="8467073" y="922728"/>
              <a:ext cx="116378" cy="108066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8469839" y="1117992"/>
              <a:ext cx="116378" cy="108066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537382" y="825286"/>
              <a:ext cx="1040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Uninduced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536708" y="1031233"/>
              <a:ext cx="8210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nduced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577AC300-6903-4512-BCC4-E5FE5A05A2DA}"/>
              </a:ext>
            </a:extLst>
          </p:cNvPr>
          <p:cNvSpPr txBox="1"/>
          <p:nvPr/>
        </p:nvSpPr>
        <p:spPr>
          <a:xfrm flipH="1">
            <a:off x="3803515" y="3262998"/>
            <a:ext cx="4140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AC447F2-236B-4802-8CFF-DD56ED325189}"/>
              </a:ext>
            </a:extLst>
          </p:cNvPr>
          <p:cNvSpPr txBox="1"/>
          <p:nvPr/>
        </p:nvSpPr>
        <p:spPr>
          <a:xfrm>
            <a:off x="3735597" y="49980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931198" y="289533"/>
            <a:ext cx="1040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charset="0"/>
                <a:ea typeface="Arial" charset="0"/>
                <a:cs typeface="Arial" charset="0"/>
              </a:rPr>
              <a:t>Uninduced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955006" y="470509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charset="0"/>
                <a:ea typeface="Arial" charset="0"/>
                <a:cs typeface="Arial" charset="0"/>
              </a:rPr>
              <a:t>Induced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2611915" y="3670637"/>
            <a:ext cx="182880" cy="91440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/>
          <p:cNvSpPr txBox="1"/>
          <p:nvPr/>
        </p:nvSpPr>
        <p:spPr>
          <a:xfrm>
            <a:off x="2734203" y="3533483"/>
            <a:ext cx="1040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Uninduced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758011" y="3743035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charset="0"/>
                <a:ea typeface="Arial" charset="0"/>
                <a:cs typeface="Arial" charset="0"/>
              </a:rPr>
              <a:t>Induced</a:t>
            </a:r>
          </a:p>
        </p:txBody>
      </p:sp>
      <p:sp>
        <p:nvSpPr>
          <p:cNvPr id="38" name="Rectangle 37"/>
          <p:cNvSpPr/>
          <p:nvPr/>
        </p:nvSpPr>
        <p:spPr>
          <a:xfrm>
            <a:off x="2629091" y="3841260"/>
            <a:ext cx="182880" cy="91440"/>
          </a:xfrm>
          <a:prstGeom prst="rect">
            <a:avLst/>
          </a:prstGeom>
          <a:solidFill>
            <a:schemeClr val="bg2">
              <a:lumMod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415F7F2-7DBF-7C45-B840-141F9318B32F}"/>
              </a:ext>
            </a:extLst>
          </p:cNvPr>
          <p:cNvSpPr txBox="1"/>
          <p:nvPr/>
        </p:nvSpPr>
        <p:spPr>
          <a:xfrm>
            <a:off x="3057484" y="149197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EDA404C-4321-5242-8528-9445F6A480E3}"/>
              </a:ext>
            </a:extLst>
          </p:cNvPr>
          <p:cNvSpPr txBox="1"/>
          <p:nvPr/>
        </p:nvSpPr>
        <p:spPr>
          <a:xfrm>
            <a:off x="3059164" y="107162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E651818-D75C-E240-802D-6E0BFEEA2100}"/>
              </a:ext>
            </a:extLst>
          </p:cNvPr>
          <p:cNvSpPr txBox="1"/>
          <p:nvPr/>
        </p:nvSpPr>
        <p:spPr>
          <a:xfrm>
            <a:off x="2999818" y="789101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3355406-4BBC-FD41-A454-2F2720D321C5}"/>
              </a:ext>
            </a:extLst>
          </p:cNvPr>
          <p:cNvSpPr txBox="1"/>
          <p:nvPr/>
        </p:nvSpPr>
        <p:spPr>
          <a:xfrm>
            <a:off x="4447089" y="566069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881794F-4047-1447-8583-0A4EDFB5D666}"/>
              </a:ext>
            </a:extLst>
          </p:cNvPr>
          <p:cNvSpPr txBox="1"/>
          <p:nvPr/>
        </p:nvSpPr>
        <p:spPr>
          <a:xfrm>
            <a:off x="4435874" y="5232584"/>
            <a:ext cx="284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528A13A-085D-AE46-A7AD-3D48B150B1D8}"/>
              </a:ext>
            </a:extLst>
          </p:cNvPr>
          <p:cNvSpPr txBox="1"/>
          <p:nvPr/>
        </p:nvSpPr>
        <p:spPr>
          <a:xfrm>
            <a:off x="4437274" y="543318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3753E72-EC16-324F-9241-4676BB823C47}"/>
              </a:ext>
            </a:extLst>
          </p:cNvPr>
          <p:cNvSpPr txBox="1"/>
          <p:nvPr/>
        </p:nvSpPr>
        <p:spPr>
          <a:xfrm>
            <a:off x="4438200" y="502239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82CAA99-1DFF-1A42-9E87-643F6912DD5B}"/>
              </a:ext>
            </a:extLst>
          </p:cNvPr>
          <p:cNvSpPr txBox="1"/>
          <p:nvPr/>
        </p:nvSpPr>
        <p:spPr>
          <a:xfrm>
            <a:off x="4426993" y="481104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592C186-C9B7-6749-9DE7-44CA03EF2D63}"/>
              </a:ext>
            </a:extLst>
          </p:cNvPr>
          <p:cNvSpPr txBox="1"/>
          <p:nvPr/>
        </p:nvSpPr>
        <p:spPr>
          <a:xfrm>
            <a:off x="4348289" y="459166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4B2E2D6-A62D-EB47-B07B-AC6DD4357A24}"/>
              </a:ext>
            </a:extLst>
          </p:cNvPr>
          <p:cNvSpPr txBox="1"/>
          <p:nvPr/>
        </p:nvSpPr>
        <p:spPr>
          <a:xfrm>
            <a:off x="4340749" y="435154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5B7D0B2D-773B-5C49-9909-3AE9FE5629B7}"/>
              </a:ext>
            </a:extLst>
          </p:cNvPr>
          <p:cNvSpPr txBox="1"/>
          <p:nvPr/>
        </p:nvSpPr>
        <p:spPr>
          <a:xfrm>
            <a:off x="4345056" y="415087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21B5120-9B22-154D-84FD-C384E1645547}"/>
              </a:ext>
            </a:extLst>
          </p:cNvPr>
          <p:cNvSpPr txBox="1"/>
          <p:nvPr/>
        </p:nvSpPr>
        <p:spPr>
          <a:xfrm>
            <a:off x="4339324" y="394090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074DA26-495C-064D-AA20-FF53DFDF294E}"/>
              </a:ext>
            </a:extLst>
          </p:cNvPr>
          <p:cNvSpPr txBox="1"/>
          <p:nvPr/>
        </p:nvSpPr>
        <p:spPr>
          <a:xfrm>
            <a:off x="4342327" y="371600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F3EB3D0C-9B08-4343-BCF2-7FA865FE9F46}"/>
              </a:ext>
            </a:extLst>
          </p:cNvPr>
          <p:cNvSpPr txBox="1"/>
          <p:nvPr/>
        </p:nvSpPr>
        <p:spPr>
          <a:xfrm>
            <a:off x="4353426" y="351674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ED514A3-5EB1-F140-899B-580957F22E95}"/>
              </a:ext>
            </a:extLst>
          </p:cNvPr>
          <p:cNvSpPr txBox="1"/>
          <p:nvPr/>
        </p:nvSpPr>
        <p:spPr>
          <a:xfrm rot="16200000">
            <a:off x="3599992" y="4481044"/>
            <a:ext cx="12698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254nm(AU) </a:t>
            </a:r>
          </a:p>
        </p:txBody>
      </p:sp>
    </p:spTree>
    <p:extLst>
      <p:ext uri="{BB962C8B-B14F-4D97-AF65-F5344CB8AC3E}">
        <p14:creationId xmlns:p14="http://schemas.microsoft.com/office/powerpoint/2010/main" val="11797416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3B3F17D5-F75F-1A45-B40D-75B8542AB6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8939132"/>
              </p:ext>
            </p:extLst>
          </p:nvPr>
        </p:nvGraphicFramePr>
        <p:xfrm>
          <a:off x="4926566" y="670541"/>
          <a:ext cx="4206240" cy="24722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D3496E5-8C33-BB47-A1C0-02BB5D8C0A40}"/>
              </a:ext>
            </a:extLst>
          </p:cNvPr>
          <p:cNvSpPr txBox="1"/>
          <p:nvPr/>
        </p:nvSpPr>
        <p:spPr>
          <a:xfrm rot="16200000">
            <a:off x="-626558" y="1806429"/>
            <a:ext cx="1747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124FB52-B0EB-7041-899C-05B7C2686E0F}"/>
              </a:ext>
            </a:extLst>
          </p:cNvPr>
          <p:cNvSpPr txBox="1"/>
          <p:nvPr/>
        </p:nvSpPr>
        <p:spPr>
          <a:xfrm rot="16200000">
            <a:off x="3931634" y="1683142"/>
            <a:ext cx="1800167" cy="3202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2B1144-E4BD-A741-B8C6-C9AF24C7EF8B}"/>
              </a:ext>
            </a:extLst>
          </p:cNvPr>
          <p:cNvSpPr txBox="1"/>
          <p:nvPr/>
        </p:nvSpPr>
        <p:spPr>
          <a:xfrm>
            <a:off x="6537" y="13655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ure 6</a:t>
            </a:r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D42646B3-7004-4144-BBAF-EA405BC872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5288430"/>
              </p:ext>
            </p:extLst>
          </p:nvPr>
        </p:nvGraphicFramePr>
        <p:xfrm>
          <a:off x="340059" y="668981"/>
          <a:ext cx="4114800" cy="2468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F1F9E44-AF4C-8D44-9C4D-FEB121B0D27C}"/>
              </a:ext>
            </a:extLst>
          </p:cNvPr>
          <p:cNvSpPr txBox="1"/>
          <p:nvPr/>
        </p:nvSpPr>
        <p:spPr>
          <a:xfrm>
            <a:off x="1432047" y="2738606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E463D46-CAB1-8B40-AA41-6BF85B71318A}"/>
              </a:ext>
            </a:extLst>
          </p:cNvPr>
          <p:cNvSpPr txBox="1"/>
          <p:nvPr/>
        </p:nvSpPr>
        <p:spPr>
          <a:xfrm>
            <a:off x="2899039" y="2738606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BNL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28C48F-BC86-6B4C-BF62-F0520717A23E}"/>
              </a:ext>
            </a:extLst>
          </p:cNvPr>
          <p:cNvSpPr txBox="1"/>
          <p:nvPr/>
        </p:nvSpPr>
        <p:spPr>
          <a:xfrm>
            <a:off x="3681626" y="2738606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I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054C25E-8CB8-3E43-8B24-C3AD11354643}"/>
              </a:ext>
            </a:extLst>
          </p:cNvPr>
          <p:cNvSpPr txBox="1"/>
          <p:nvPr/>
        </p:nvSpPr>
        <p:spPr>
          <a:xfrm>
            <a:off x="2295848" y="2738606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AF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D08B929-1B63-D841-9E42-A264CFAE6F00}"/>
              </a:ext>
            </a:extLst>
          </p:cNvPr>
          <p:cNvSpPr txBox="1"/>
          <p:nvPr/>
        </p:nvSpPr>
        <p:spPr>
          <a:xfrm>
            <a:off x="777986" y="2738606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IF3A</a:t>
            </a:r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914FC7BB-A582-104B-9A54-45E5182F76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3670113"/>
              </p:ext>
            </p:extLst>
          </p:nvPr>
        </p:nvGraphicFramePr>
        <p:xfrm>
          <a:off x="325551" y="4062298"/>
          <a:ext cx="36576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F4C01B11-FF74-3144-A8C1-9932D35AD7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9838601"/>
              </p:ext>
            </p:extLst>
          </p:nvPr>
        </p:nvGraphicFramePr>
        <p:xfrm>
          <a:off x="4991843" y="3989281"/>
          <a:ext cx="36576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A6BF5E20-C4BA-E74D-AB07-5594182584E1}"/>
              </a:ext>
            </a:extLst>
          </p:cNvPr>
          <p:cNvSpPr txBox="1"/>
          <p:nvPr/>
        </p:nvSpPr>
        <p:spPr>
          <a:xfrm>
            <a:off x="4285412" y="609596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5D4952-1B44-B747-B8A8-3DEFF112441F}"/>
              </a:ext>
            </a:extLst>
          </p:cNvPr>
          <p:cNvSpPr txBox="1"/>
          <p:nvPr/>
        </p:nvSpPr>
        <p:spPr>
          <a:xfrm>
            <a:off x="93318" y="375855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E5DD3C-A104-EE4E-8AD9-B7EB3C06EA7B}"/>
              </a:ext>
            </a:extLst>
          </p:cNvPr>
          <p:cNvSpPr txBox="1"/>
          <p:nvPr/>
        </p:nvSpPr>
        <p:spPr>
          <a:xfrm>
            <a:off x="93318" y="582719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611031B-A0E1-CB40-929B-1D5D7E737840}"/>
              </a:ext>
            </a:extLst>
          </p:cNvPr>
          <p:cNvSpPr txBox="1"/>
          <p:nvPr/>
        </p:nvSpPr>
        <p:spPr>
          <a:xfrm>
            <a:off x="4285412" y="375855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5FE2C06-B7B5-2143-966C-AFC40971EE4C}"/>
              </a:ext>
            </a:extLst>
          </p:cNvPr>
          <p:cNvSpPr txBox="1"/>
          <p:nvPr/>
        </p:nvSpPr>
        <p:spPr>
          <a:xfrm>
            <a:off x="6098339" y="2743351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3FEA899-9718-684E-9677-F3EFFCFC9B41}"/>
              </a:ext>
            </a:extLst>
          </p:cNvPr>
          <p:cNvSpPr txBox="1"/>
          <p:nvPr/>
        </p:nvSpPr>
        <p:spPr>
          <a:xfrm>
            <a:off x="7565331" y="2743351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BNL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D1C474B-3773-BB46-94FF-11787E31009E}"/>
              </a:ext>
            </a:extLst>
          </p:cNvPr>
          <p:cNvSpPr txBox="1"/>
          <p:nvPr/>
        </p:nvSpPr>
        <p:spPr>
          <a:xfrm>
            <a:off x="8347918" y="2743351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I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BDF7272-2D68-B747-8A6C-B7D3CB86F757}"/>
              </a:ext>
            </a:extLst>
          </p:cNvPr>
          <p:cNvSpPr txBox="1"/>
          <p:nvPr/>
        </p:nvSpPr>
        <p:spPr>
          <a:xfrm>
            <a:off x="6962140" y="2743351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AF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FBF563D-BE79-444F-8F70-EBFDB8F55762}"/>
              </a:ext>
            </a:extLst>
          </p:cNvPr>
          <p:cNvSpPr txBox="1"/>
          <p:nvPr/>
        </p:nvSpPr>
        <p:spPr>
          <a:xfrm>
            <a:off x="5444278" y="2743351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IF3A</a:t>
            </a:r>
          </a:p>
        </p:txBody>
      </p:sp>
    </p:spTree>
    <p:extLst>
      <p:ext uri="{BB962C8B-B14F-4D97-AF65-F5344CB8AC3E}">
        <p14:creationId xmlns:p14="http://schemas.microsoft.com/office/powerpoint/2010/main" val="8870072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1F257D0-0787-8C4B-986C-0E700A168A02}"/>
              </a:ext>
            </a:extLst>
          </p:cNvPr>
          <p:cNvPicPr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06828" y="1305586"/>
            <a:ext cx="5486400" cy="6400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F008D0B-20CC-FF41-9D87-B03BE35C2D77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09867" y="1998554"/>
            <a:ext cx="5486400" cy="64008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ED58900-1344-D04B-B370-F07140FC0FA9}"/>
              </a:ext>
            </a:extLst>
          </p:cNvPr>
          <p:cNvSpPr txBox="1"/>
          <p:nvPr/>
        </p:nvSpPr>
        <p:spPr>
          <a:xfrm rot="18078174">
            <a:off x="2209009" y="581304"/>
            <a:ext cx="1298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6D3B096-C642-5046-9BE1-DADB902E1EA4}"/>
              </a:ext>
            </a:extLst>
          </p:cNvPr>
          <p:cNvSpPr txBox="1"/>
          <p:nvPr/>
        </p:nvSpPr>
        <p:spPr>
          <a:xfrm rot="18078174">
            <a:off x="3347714" y="599990"/>
            <a:ext cx="11877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IF3A-w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227EEE-1248-3145-AB7C-0D6727F6BFA4}"/>
              </a:ext>
            </a:extLst>
          </p:cNvPr>
          <p:cNvSpPr txBox="1"/>
          <p:nvPr/>
        </p:nvSpPr>
        <p:spPr>
          <a:xfrm rot="18078174">
            <a:off x="6483969" y="588366"/>
            <a:ext cx="1216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IF3A-m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EDD726-915A-4A40-8E92-03247157C753}"/>
              </a:ext>
            </a:extLst>
          </p:cNvPr>
          <p:cNvSpPr txBox="1"/>
          <p:nvPr/>
        </p:nvSpPr>
        <p:spPr>
          <a:xfrm rot="18078174">
            <a:off x="5461853" y="619744"/>
            <a:ext cx="11261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F3042E-470A-C745-9DEF-7B5FFE8197B3}"/>
              </a:ext>
            </a:extLst>
          </p:cNvPr>
          <p:cNvSpPr txBox="1"/>
          <p:nvPr/>
        </p:nvSpPr>
        <p:spPr>
          <a:xfrm rot="18078174">
            <a:off x="4325913" y="576764"/>
            <a:ext cx="1265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CTA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4D99305-4F39-6943-BD99-7B2F4A66AFEB}"/>
              </a:ext>
            </a:extLst>
          </p:cNvPr>
          <p:cNvSpPr txBox="1"/>
          <p:nvPr/>
        </p:nvSpPr>
        <p:spPr>
          <a:xfrm>
            <a:off x="764074" y="1524183"/>
            <a:ext cx="109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uciferas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B7A640-D112-BE43-8238-36133373E7B2}"/>
              </a:ext>
            </a:extLst>
          </p:cNvPr>
          <p:cNvSpPr txBox="1"/>
          <p:nvPr/>
        </p:nvSpPr>
        <p:spPr>
          <a:xfrm>
            <a:off x="1329322" y="2180087"/>
            <a:ext cx="109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I2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5AC7D36-516A-3D4B-9899-2AFC0AE523FD}"/>
              </a:ext>
            </a:extLst>
          </p:cNvPr>
          <p:cNvSpPr txBox="1"/>
          <p:nvPr/>
        </p:nvSpPr>
        <p:spPr>
          <a:xfrm>
            <a:off x="0" y="12032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ure 7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2F07ACB-0EE7-F94F-9425-CB3ECDAF9D79}"/>
              </a:ext>
            </a:extLst>
          </p:cNvPr>
          <p:cNvSpPr txBox="1"/>
          <p:nvPr/>
        </p:nvSpPr>
        <p:spPr>
          <a:xfrm>
            <a:off x="7300453" y="1033492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F0F2ED7-6E8B-164F-A5B6-6D12AC309EC0}"/>
              </a:ext>
            </a:extLst>
          </p:cNvPr>
          <p:cNvSpPr txBox="1"/>
          <p:nvPr/>
        </p:nvSpPr>
        <p:spPr>
          <a:xfrm>
            <a:off x="7236994" y="1471737"/>
            <a:ext cx="109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3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733A534-9B47-F546-B92F-6B1755BC4425}"/>
              </a:ext>
            </a:extLst>
          </p:cNvPr>
          <p:cNvSpPr txBox="1"/>
          <p:nvPr/>
        </p:nvSpPr>
        <p:spPr>
          <a:xfrm>
            <a:off x="7431402" y="2229397"/>
            <a:ext cx="109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A177EC6-9F4F-1542-873E-0E021C762AB3}"/>
              </a:ext>
            </a:extLst>
          </p:cNvPr>
          <p:cNvSpPr txBox="1"/>
          <p:nvPr/>
        </p:nvSpPr>
        <p:spPr>
          <a:xfrm>
            <a:off x="552877" y="49680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52" name="Chart 51">
            <a:extLst>
              <a:ext uri="{FF2B5EF4-FFF2-40B4-BE49-F238E27FC236}">
                <a16:creationId xmlns:a16="http://schemas.microsoft.com/office/drawing/2014/main" id="{9843FCB5-51CE-A14A-A079-926363EC70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1363908"/>
              </p:ext>
            </p:extLst>
          </p:nvPr>
        </p:nvGraphicFramePr>
        <p:xfrm>
          <a:off x="854264" y="3260846"/>
          <a:ext cx="3460460" cy="2226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3" name="Chart 52">
            <a:extLst>
              <a:ext uri="{FF2B5EF4-FFF2-40B4-BE49-F238E27FC236}">
                <a16:creationId xmlns:a16="http://schemas.microsoft.com/office/drawing/2014/main" id="{3E3B1151-CCD0-B34E-B886-DC345DA65B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7015356"/>
              </p:ext>
            </p:extLst>
          </p:nvPr>
        </p:nvGraphicFramePr>
        <p:xfrm>
          <a:off x="4756480" y="3368785"/>
          <a:ext cx="3399806" cy="20726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54" name="TextBox 53">
            <a:extLst>
              <a:ext uri="{FF2B5EF4-FFF2-40B4-BE49-F238E27FC236}">
                <a16:creationId xmlns:a16="http://schemas.microsoft.com/office/drawing/2014/main" id="{1A8B136E-CAAE-364D-9B65-D5E61C0F9018}"/>
              </a:ext>
            </a:extLst>
          </p:cNvPr>
          <p:cNvSpPr txBox="1"/>
          <p:nvPr/>
        </p:nvSpPr>
        <p:spPr>
          <a:xfrm>
            <a:off x="478646" y="316873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C7E3AB0-7DC6-A04F-9B10-C9B8BFD8637B}"/>
              </a:ext>
            </a:extLst>
          </p:cNvPr>
          <p:cNvSpPr txBox="1"/>
          <p:nvPr/>
        </p:nvSpPr>
        <p:spPr>
          <a:xfrm>
            <a:off x="4588203" y="316873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57387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rot="16200000">
            <a:off x="-26893" y="1742374"/>
            <a:ext cx="1797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</a:t>
            </a:r>
          </a:p>
        </p:txBody>
      </p: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9549323"/>
              </p:ext>
            </p:extLst>
          </p:nvPr>
        </p:nvGraphicFramePr>
        <p:xfrm>
          <a:off x="958904" y="876615"/>
          <a:ext cx="3688667" cy="22659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2960380" y="231492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959044" y="2263680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4265010"/>
              </p:ext>
            </p:extLst>
          </p:nvPr>
        </p:nvGraphicFramePr>
        <p:xfrm>
          <a:off x="4937507" y="1043785"/>
          <a:ext cx="3462360" cy="2166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2" name="TextBox 21"/>
          <p:cNvSpPr txBox="1"/>
          <p:nvPr/>
        </p:nvSpPr>
        <p:spPr>
          <a:xfrm rot="16200000">
            <a:off x="3984878" y="1788541"/>
            <a:ext cx="1797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116702" y="248900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831240" y="248900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33187" y="50180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625834" y="468687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423689" y="2497392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977C2F6-71EF-4C93-A9EE-CC155EA26F43}"/>
              </a:ext>
            </a:extLst>
          </p:cNvPr>
          <p:cNvSpPr txBox="1"/>
          <p:nvPr/>
        </p:nvSpPr>
        <p:spPr>
          <a:xfrm>
            <a:off x="-3511" y="13655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ure 8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3BD4225A-4911-4AEE-A7FF-2B9B07D27432}"/>
              </a:ext>
            </a:extLst>
          </p:cNvPr>
          <p:cNvGrpSpPr/>
          <p:nvPr/>
        </p:nvGrpSpPr>
        <p:grpSpPr>
          <a:xfrm>
            <a:off x="1094510" y="3837705"/>
            <a:ext cx="3289302" cy="2127163"/>
            <a:chOff x="1002561" y="4338326"/>
            <a:chExt cx="3289302" cy="2127163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52488F37-05BF-4CBB-94B3-247DAD60585E}"/>
                </a:ext>
              </a:extLst>
            </p:cNvPr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03226" y="4667071"/>
              <a:ext cx="2388637" cy="731520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673615A9-43F6-4795-A48D-A945539AC421}"/>
                </a:ext>
              </a:extLst>
            </p:cNvPr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03943" y="5449406"/>
              <a:ext cx="2386584" cy="727786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8A34E6F-F612-4F58-86DA-F60824A611E9}"/>
                </a:ext>
              </a:extLst>
            </p:cNvPr>
            <p:cNvSpPr txBox="1"/>
            <p:nvPr/>
          </p:nvSpPr>
          <p:spPr>
            <a:xfrm>
              <a:off x="3018086" y="4348670"/>
              <a:ext cx="1130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IF3A-sh27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E024953-B0AC-423C-9D49-2388AEC95CCB}"/>
                </a:ext>
              </a:extLst>
            </p:cNvPr>
            <p:cNvSpPr txBox="1"/>
            <p:nvPr/>
          </p:nvSpPr>
          <p:spPr>
            <a:xfrm>
              <a:off x="1893192" y="4338326"/>
              <a:ext cx="10310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IF3A-sh7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8875943-10F2-4DEA-ADEB-62DE08BACBF4}"/>
                </a:ext>
              </a:extLst>
            </p:cNvPr>
            <p:cNvSpPr txBox="1"/>
            <p:nvPr/>
          </p:nvSpPr>
          <p:spPr>
            <a:xfrm>
              <a:off x="1203097" y="4930275"/>
              <a:ext cx="683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IF3A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987E02B-98A0-44CE-9926-FD3B9561B2D6}"/>
                </a:ext>
              </a:extLst>
            </p:cNvPr>
            <p:cNvSpPr txBox="1"/>
            <p:nvPr/>
          </p:nvSpPr>
          <p:spPr>
            <a:xfrm>
              <a:off x="1002561" y="5623220"/>
              <a:ext cx="8851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4DE1AE6-20AE-4B79-9B46-4161A0DDB93A}"/>
                </a:ext>
              </a:extLst>
            </p:cNvPr>
            <p:cNvSpPr txBox="1"/>
            <p:nvPr/>
          </p:nvSpPr>
          <p:spPr>
            <a:xfrm>
              <a:off x="1437066" y="6157712"/>
              <a:ext cx="27687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ox:    -          +          -         +     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3915AB28-8F4C-4DA8-AF50-10AFC4E91A6E}"/>
              </a:ext>
            </a:extLst>
          </p:cNvPr>
          <p:cNvSpPr txBox="1"/>
          <p:nvPr/>
        </p:nvSpPr>
        <p:spPr>
          <a:xfrm>
            <a:off x="822864" y="363734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Rectangle 3"/>
          <p:cNvSpPr/>
          <p:nvPr/>
        </p:nvSpPr>
        <p:spPr>
          <a:xfrm>
            <a:off x="3401817" y="798887"/>
            <a:ext cx="182880" cy="91440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3400350" y="930106"/>
            <a:ext cx="182880" cy="91440"/>
          </a:xfrm>
          <a:prstGeom prst="rect">
            <a:avLst/>
          </a:prstGeom>
          <a:solidFill>
            <a:schemeClr val="bg2">
              <a:lumMod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7200643" y="1033285"/>
            <a:ext cx="182880" cy="91440"/>
          </a:xfrm>
          <a:prstGeom prst="rect">
            <a:avLst/>
          </a:prstGeom>
          <a:solidFill>
            <a:schemeClr val="bg2">
              <a:lumMod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/>
          <p:cNvSpPr/>
          <p:nvPr/>
        </p:nvSpPr>
        <p:spPr>
          <a:xfrm>
            <a:off x="7200643" y="882175"/>
            <a:ext cx="182880" cy="91440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3545247" y="642604"/>
            <a:ext cx="1040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charset="0"/>
                <a:ea typeface="Arial" charset="0"/>
                <a:cs typeface="Arial" charset="0"/>
              </a:rPr>
              <a:t>Uninduced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569055" y="809292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charset="0"/>
                <a:ea typeface="Arial" charset="0"/>
                <a:cs typeface="Arial" charset="0"/>
              </a:rPr>
              <a:t>Induced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7326684" y="780716"/>
            <a:ext cx="1040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charset="0"/>
                <a:ea typeface="Arial" charset="0"/>
                <a:cs typeface="Arial" charset="0"/>
              </a:rPr>
              <a:t>Uninduced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7350492" y="933116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charset="0"/>
                <a:ea typeface="Arial" charset="0"/>
                <a:cs typeface="Arial" charset="0"/>
              </a:rPr>
              <a:t>Induced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FC86E6B-F36F-3D4B-A09E-6627FAD9225D}"/>
              </a:ext>
            </a:extLst>
          </p:cNvPr>
          <p:cNvSpPr txBox="1"/>
          <p:nvPr/>
        </p:nvSpPr>
        <p:spPr>
          <a:xfrm>
            <a:off x="4347485" y="514340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25E2F6D-7244-5E4F-8160-54B1539E7739}"/>
              </a:ext>
            </a:extLst>
          </p:cNvPr>
          <p:cNvSpPr txBox="1"/>
          <p:nvPr/>
        </p:nvSpPr>
        <p:spPr>
          <a:xfrm>
            <a:off x="4337437" y="432814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66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DECB14B-5AA8-B34E-8B8D-BBE2E06593A2}"/>
              </a:ext>
            </a:extLst>
          </p:cNvPr>
          <p:cNvSpPr txBox="1"/>
          <p:nvPr/>
        </p:nvSpPr>
        <p:spPr>
          <a:xfrm>
            <a:off x="4330897" y="3867539"/>
            <a:ext cx="548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99191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5FC16A63-3C1D-48C1-A1A9-B5DEACC42F90}"/>
              </a:ext>
            </a:extLst>
          </p:cNvPr>
          <p:cNvSpPr txBox="1"/>
          <p:nvPr/>
        </p:nvSpPr>
        <p:spPr>
          <a:xfrm>
            <a:off x="0" y="12032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upplementary Figure 9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A81C2115-7977-6740-986E-D183C1267340}"/>
              </a:ext>
            </a:extLst>
          </p:cNvPr>
          <p:cNvGrpSpPr/>
          <p:nvPr/>
        </p:nvGrpSpPr>
        <p:grpSpPr>
          <a:xfrm>
            <a:off x="437659" y="2166485"/>
            <a:ext cx="3021216" cy="3265030"/>
            <a:chOff x="2869035" y="943905"/>
            <a:chExt cx="3021216" cy="3265030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52170ABC-7E81-2248-8961-0EE6CBD767D3}"/>
                </a:ext>
              </a:extLst>
            </p:cNvPr>
            <p:cNvGrpSpPr/>
            <p:nvPr/>
          </p:nvGrpSpPr>
          <p:grpSpPr>
            <a:xfrm>
              <a:off x="2869035" y="3852319"/>
              <a:ext cx="2931145" cy="356616"/>
              <a:chOff x="2869035" y="3852319"/>
              <a:chExt cx="2931145" cy="356616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22276942-4650-4452-AF64-13789C68DBED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790918" y="3852319"/>
                <a:ext cx="1645920" cy="356616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60082AB-6800-441F-A04A-D6E385AC7A0B}"/>
                  </a:ext>
                </a:extLst>
              </p:cNvPr>
              <p:cNvSpPr txBox="1"/>
              <p:nvPr/>
            </p:nvSpPr>
            <p:spPr>
              <a:xfrm>
                <a:off x="2869035" y="3856679"/>
                <a:ext cx="9249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 ACTIN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C4019AF0-3711-B646-8AF9-1617CEF448A5}"/>
                  </a:ext>
                </a:extLst>
              </p:cNvPr>
              <p:cNvSpPr txBox="1"/>
              <p:nvPr/>
            </p:nvSpPr>
            <p:spPr>
              <a:xfrm>
                <a:off x="5416742" y="3852319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2</a:t>
                </a: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A89D71E3-0046-5043-8AFD-D1E135C5FAC4}"/>
                </a:ext>
              </a:extLst>
            </p:cNvPr>
            <p:cNvGrpSpPr/>
            <p:nvPr/>
          </p:nvGrpSpPr>
          <p:grpSpPr>
            <a:xfrm>
              <a:off x="3044727" y="3065922"/>
              <a:ext cx="2755453" cy="356616"/>
              <a:chOff x="3044727" y="2674042"/>
              <a:chExt cx="2755453" cy="356616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EA7C7AB2-6206-4D9C-A793-6A3356542E7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11639" y="2674042"/>
                <a:ext cx="1645920" cy="356616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CCA7852-A826-4019-ACFB-A8804B7DF9F4}"/>
                  </a:ext>
                </a:extLst>
              </p:cNvPr>
              <p:cNvSpPr txBox="1"/>
              <p:nvPr/>
            </p:nvSpPr>
            <p:spPr>
              <a:xfrm>
                <a:off x="3044727" y="2696639"/>
                <a:ext cx="77296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-MYC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581D319-5807-F241-AFF0-D82FCC117AB8}"/>
                  </a:ext>
                </a:extLst>
              </p:cNvPr>
              <p:cNvSpPr txBox="1"/>
              <p:nvPr/>
            </p:nvSpPr>
            <p:spPr>
              <a:xfrm>
                <a:off x="5416742" y="2696639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7</a:t>
                </a: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229910FC-C12E-3242-B3E6-25AEFE17C365}"/>
                </a:ext>
              </a:extLst>
            </p:cNvPr>
            <p:cNvGrpSpPr/>
            <p:nvPr/>
          </p:nvGrpSpPr>
          <p:grpSpPr>
            <a:xfrm>
              <a:off x="3281187" y="2672204"/>
              <a:ext cx="2529665" cy="373319"/>
              <a:chOff x="3271139" y="2270275"/>
              <a:chExt cx="2529665" cy="373319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27E66875-8D29-457F-9B0F-550A1E7EC01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01590" y="2270275"/>
                <a:ext cx="1645920" cy="356616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CD6A7E6E-6C7C-4AEB-AF70-DB99E4DC22EA}"/>
                  </a:ext>
                </a:extLst>
              </p:cNvPr>
              <p:cNvSpPr txBox="1"/>
              <p:nvPr/>
            </p:nvSpPr>
            <p:spPr>
              <a:xfrm>
                <a:off x="3271139" y="2335817"/>
                <a:ext cx="52450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P1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0AD1E40-B715-214F-8001-851C3B4FB81D}"/>
                  </a:ext>
                </a:extLst>
              </p:cNvPr>
              <p:cNvSpPr txBox="1"/>
              <p:nvPr/>
            </p:nvSpPr>
            <p:spPr>
              <a:xfrm>
                <a:off x="5417366" y="2305294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C09E1ADA-FC3C-F04F-95A7-EE4B04938F9A}"/>
                </a:ext>
              </a:extLst>
            </p:cNvPr>
            <p:cNvGrpSpPr/>
            <p:nvPr/>
          </p:nvGrpSpPr>
          <p:grpSpPr>
            <a:xfrm>
              <a:off x="3157567" y="3460378"/>
              <a:ext cx="2642613" cy="355716"/>
              <a:chOff x="3157567" y="1872499"/>
              <a:chExt cx="2642613" cy="355716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B274837F-0D37-4D29-A693-4F3C14ADD8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05566" y="1872499"/>
                <a:ext cx="1647108" cy="355716"/>
              </a:xfrm>
              <a:prstGeom prst="rect">
                <a:avLst/>
              </a:prstGeom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5F760A0-83C7-4D41-BDD6-C123DE4DE41E}"/>
                  </a:ext>
                </a:extLst>
              </p:cNvPr>
              <p:cNvSpPr txBox="1"/>
              <p:nvPr/>
            </p:nvSpPr>
            <p:spPr>
              <a:xfrm>
                <a:off x="3157567" y="1892594"/>
                <a:ext cx="6639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K6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ABE0865-935A-BB4E-A766-10828230300C}"/>
                  </a:ext>
                </a:extLst>
              </p:cNvPr>
              <p:cNvSpPr txBox="1"/>
              <p:nvPr/>
            </p:nvSpPr>
            <p:spPr>
              <a:xfrm>
                <a:off x="5416742" y="191463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6</a:t>
                </a: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00B46AB9-415F-BD4D-88D0-53BB72514330}"/>
                </a:ext>
              </a:extLst>
            </p:cNvPr>
            <p:cNvGrpSpPr/>
            <p:nvPr/>
          </p:nvGrpSpPr>
          <p:grpSpPr>
            <a:xfrm>
              <a:off x="3051934" y="2260372"/>
              <a:ext cx="2838317" cy="356616"/>
              <a:chOff x="3041153" y="3065983"/>
              <a:chExt cx="2838317" cy="356616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952198D7-B768-4696-B721-C3604ABE7AD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05566" y="3065983"/>
                <a:ext cx="1645920" cy="356616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253D5B5C-2850-4A3E-8869-781CEA560E8A}"/>
                  </a:ext>
                </a:extLst>
              </p:cNvPr>
              <p:cNvSpPr txBox="1"/>
              <p:nvPr/>
            </p:nvSpPr>
            <p:spPr>
              <a:xfrm>
                <a:off x="3041153" y="3103504"/>
                <a:ext cx="7633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AD21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D9B30447-56A5-9F42-89EA-12EC5E71F838}"/>
                  </a:ext>
                </a:extLst>
              </p:cNvPr>
              <p:cNvSpPr txBox="1"/>
              <p:nvPr/>
            </p:nvSpPr>
            <p:spPr>
              <a:xfrm>
                <a:off x="5396646" y="3067205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8C0B7DC1-B5CA-DB46-9C30-65C65E311DC4}"/>
                </a:ext>
              </a:extLst>
            </p:cNvPr>
            <p:cNvGrpSpPr/>
            <p:nvPr/>
          </p:nvGrpSpPr>
          <p:grpSpPr>
            <a:xfrm>
              <a:off x="3057087" y="1861048"/>
              <a:ext cx="2831766" cy="378567"/>
              <a:chOff x="3056754" y="3442306"/>
              <a:chExt cx="2831766" cy="378567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39932A20-9B60-48FA-BD46-8B926F0C93D4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11361" y="3452515"/>
                <a:ext cx="1645920" cy="356617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13C8DDB9-9D35-4336-A524-3CE66D09315A}"/>
                  </a:ext>
                </a:extLst>
              </p:cNvPr>
              <p:cNvSpPr txBox="1"/>
              <p:nvPr/>
            </p:nvSpPr>
            <p:spPr>
              <a:xfrm>
                <a:off x="3056754" y="3513096"/>
                <a:ext cx="7537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USP28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513BF13-9618-5B4E-B60B-6DCBAC702D19}"/>
                  </a:ext>
                </a:extLst>
              </p:cNvPr>
              <p:cNvSpPr txBox="1"/>
              <p:nvPr/>
            </p:nvSpPr>
            <p:spPr>
              <a:xfrm>
                <a:off x="5405696" y="3442306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D502AD67-984C-644F-AC56-692DC461946C}"/>
                </a:ext>
              </a:extLst>
            </p:cNvPr>
            <p:cNvGrpSpPr/>
            <p:nvPr/>
          </p:nvGrpSpPr>
          <p:grpSpPr>
            <a:xfrm>
              <a:off x="3086447" y="943905"/>
              <a:ext cx="2767881" cy="523220"/>
              <a:chOff x="3107327" y="1419791"/>
              <a:chExt cx="2767881" cy="523220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774451D6-D1CA-4793-9A5B-4C289C9902B1}"/>
                  </a:ext>
                </a:extLst>
              </p:cNvPr>
              <p:cNvSpPr txBox="1"/>
              <p:nvPr/>
            </p:nvSpPr>
            <p:spPr>
              <a:xfrm>
                <a:off x="3622407" y="1550031"/>
                <a:ext cx="16433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-             +</a:t>
                </a:r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08BC56F8-3CFD-4741-8BDF-6A1128748709}"/>
                  </a:ext>
                </a:extLst>
              </p:cNvPr>
              <p:cNvSpPr txBox="1"/>
              <p:nvPr/>
            </p:nvSpPr>
            <p:spPr>
              <a:xfrm>
                <a:off x="3107327" y="1419791"/>
                <a:ext cx="156089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EIF3A </a:t>
                </a:r>
              </a:p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hRNA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0CC08729-5A75-524F-9445-B80FC83DEF79}"/>
                  </a:ext>
                </a:extLst>
              </p:cNvPr>
              <p:cNvSpPr txBox="1"/>
              <p:nvPr/>
            </p:nvSpPr>
            <p:spPr>
              <a:xfrm>
                <a:off x="5371544" y="1596466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F630C092-590C-4740-B136-B3FD3F8E6A07}"/>
                </a:ext>
              </a:extLst>
            </p:cNvPr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06754" y="1449361"/>
              <a:ext cx="1645920" cy="36576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DA56EC3-E9B6-5245-9D49-31CFAD6BFEA3}"/>
                </a:ext>
              </a:extLst>
            </p:cNvPr>
            <p:cNvSpPr txBox="1"/>
            <p:nvPr/>
          </p:nvSpPr>
          <p:spPr>
            <a:xfrm>
              <a:off x="5391714" y="1494750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B259D15-4089-F443-975D-E7E227B0E17C}"/>
                </a:ext>
              </a:extLst>
            </p:cNvPr>
            <p:cNvSpPr txBox="1"/>
            <p:nvPr/>
          </p:nvSpPr>
          <p:spPr>
            <a:xfrm>
              <a:off x="3137247" y="1473520"/>
              <a:ext cx="683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IF3A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448165B3-3023-F44F-9837-D0024B33DC9B}"/>
              </a:ext>
            </a:extLst>
          </p:cNvPr>
          <p:cNvGrpSpPr/>
          <p:nvPr/>
        </p:nvGrpSpPr>
        <p:grpSpPr>
          <a:xfrm>
            <a:off x="4023152" y="1803514"/>
            <a:ext cx="4813969" cy="3675923"/>
            <a:chOff x="4072334" y="1272074"/>
            <a:chExt cx="4813969" cy="3675923"/>
          </a:xfrm>
        </p:grpSpPr>
        <p:graphicFrame>
          <p:nvGraphicFramePr>
            <p:cNvPr id="37" name="Chart 36">
              <a:extLst>
                <a:ext uri="{FF2B5EF4-FFF2-40B4-BE49-F238E27FC236}">
                  <a16:creationId xmlns:a16="http://schemas.microsoft.com/office/drawing/2014/main" id="{A851F004-75EE-2548-9591-25D2F5C59C9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33299050"/>
                </p:ext>
              </p:extLst>
            </p:nvPr>
          </p:nvGraphicFramePr>
          <p:xfrm>
            <a:off x="4314303" y="2204797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3147D57-EFE5-9746-94E0-DE359158D0D6}"/>
                </a:ext>
              </a:extLst>
            </p:cNvPr>
            <p:cNvSpPr txBox="1"/>
            <p:nvPr/>
          </p:nvSpPr>
          <p:spPr>
            <a:xfrm rot="16200000">
              <a:off x="3327579" y="3335183"/>
              <a:ext cx="17972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9DF3159-ACED-0849-B710-618E36B272D8}"/>
                </a:ext>
              </a:extLst>
            </p:cNvPr>
            <p:cNvSpPr txBox="1"/>
            <p:nvPr/>
          </p:nvSpPr>
          <p:spPr>
            <a:xfrm>
              <a:off x="7824756" y="1993072"/>
              <a:ext cx="1040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charset="0"/>
                  <a:ea typeface="Arial" charset="0"/>
                  <a:cs typeface="Arial" charset="0"/>
                </a:rPr>
                <a:t>Uninduced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CD631A9-14F3-1045-8E09-179B3F447AFC}"/>
                </a:ext>
              </a:extLst>
            </p:cNvPr>
            <p:cNvSpPr txBox="1"/>
            <p:nvPr/>
          </p:nvSpPr>
          <p:spPr>
            <a:xfrm>
              <a:off x="7848564" y="2174048"/>
              <a:ext cx="8210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charset="0"/>
                  <a:ea typeface="Arial" charset="0"/>
                  <a:cs typeface="Arial" charset="0"/>
                </a:rPr>
                <a:t>Induced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A91D9D5C-632A-1B46-9134-44B23FB75DE6}"/>
                </a:ext>
              </a:extLst>
            </p:cNvPr>
            <p:cNvSpPr/>
            <p:nvPr/>
          </p:nvSpPr>
          <p:spPr>
            <a:xfrm>
              <a:off x="7605132" y="2118732"/>
              <a:ext cx="243432" cy="9999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9441A62A-CE4A-9948-ABD3-D3379EF01544}"/>
                </a:ext>
              </a:extLst>
            </p:cNvPr>
            <p:cNvSpPr/>
            <p:nvPr/>
          </p:nvSpPr>
          <p:spPr>
            <a:xfrm>
              <a:off x="7612072" y="2290350"/>
              <a:ext cx="243432" cy="99994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E257347-DA7A-1640-B725-407CEA3596BE}"/>
                </a:ext>
              </a:extLst>
            </p:cNvPr>
            <p:cNvSpPr txBox="1"/>
            <p:nvPr/>
          </p:nvSpPr>
          <p:spPr>
            <a:xfrm>
              <a:off x="4314303" y="1272074"/>
              <a:ext cx="23488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/>
                  <a:cs typeface="Arial"/>
                </a:rPr>
                <a:t>B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26B7FC04-4FFA-B143-A877-671BBE2CB2C1}"/>
              </a:ext>
            </a:extLst>
          </p:cNvPr>
          <p:cNvSpPr txBox="1"/>
          <p:nvPr/>
        </p:nvSpPr>
        <p:spPr>
          <a:xfrm>
            <a:off x="378463" y="1826193"/>
            <a:ext cx="2348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91606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96</TotalTime>
  <Words>462</Words>
  <Application>Microsoft Macintosh PowerPoint</Application>
  <PresentationFormat>On-screen Show (4:3)</PresentationFormat>
  <Paragraphs>235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Shilpayon</dc:creator>
  <cp:keywords/>
  <dc:description/>
  <cp:lastModifiedBy>Pillai, Manoj</cp:lastModifiedBy>
  <cp:revision>154</cp:revision>
  <dcterms:created xsi:type="dcterms:W3CDTF">2020-07-21T15:00:29Z</dcterms:created>
  <dcterms:modified xsi:type="dcterms:W3CDTF">2022-03-15T03:14:52Z</dcterms:modified>
  <cp:category/>
</cp:coreProperties>
</file>